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wdp" ContentType="image/vnd.ms-photo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theme/theme2.xml" ContentType="application/vnd.openxmlformats-officedocument.theme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theme/theme3.xml" ContentType="application/vnd.openxmlformats-officedocument.theme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  <p:sldMasterId id="2147483685" r:id="rId6"/>
    <p:sldMasterId id="2147483706" r:id="rId7"/>
  </p:sldMasterIdLst>
  <p:notesMasterIdLst>
    <p:notesMasterId r:id="rId13"/>
  </p:notesMasterIdLst>
  <p:sldIdLst>
    <p:sldId id="256" r:id="rId8"/>
    <p:sldId id="2147376804" r:id="rId9"/>
    <p:sldId id="2147472072" r:id="rId10"/>
    <p:sldId id="2147472074" r:id="rId11"/>
    <p:sldId id="2147474252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1E8E0C03-236A-4CD5-8452-3D8CACBF2172}">
          <p14:sldIdLst>
            <p14:sldId id="256"/>
            <p14:sldId id="2147376804"/>
            <p14:sldId id="2147472072"/>
            <p14:sldId id="2147472074"/>
            <p14:sldId id="214747425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033951A-6A04-09DA-35DE-355C56F241BE}" name="Marilisa Valtazanou" initials="MV" userId="b3650d8458ab4eb8" providerId="Windows Live"/>
  <p188:author id="{81E4C14C-3F8C-EBC9-6CEC-C431DE082B62}" name="Ekert Jason" initials="EJ" userId="S::jason.ekert@ucb.com::86a6f4d0-8b36-4ee5-80c7-fa72ee7df86f" providerId="AD"/>
  <p188:author id="{02A3DB59-1674-5FEB-F573-7204B8E61222}" name="Wang Jianguo" initials="WJ" userId="S::jianguo.wang@ucb.com::2282b57a-268d-4813-9881-20d216428ee8" providerId="AD"/>
  <p188:author id="{7010D28C-BEF3-5E54-9AC6-CC6FC674269E}" name="Rachel Price" initials="RP" userId="Rachel Price" providerId="None"/>
  <p188:author id="{DA7BB299-7C95-5C6C-CC30-C77A199E6062}" name="Ogilvy Health" initials="OH" userId="Ogilvy Health" providerId="None"/>
  <p188:author id="{0D9F65A7-8A62-91A5-BFC8-3E2C00B96448}" name="Roshnnie Manoj" initials="RM" userId="S::roshnnie.manoj@darwinhc.com::e3860bbe-1dc9-4365-b2ca-47c40c16ac7d" providerId="AD"/>
  <p188:author id="{EB82A3B5-D226-D45B-A6BC-4E1F8232B96D}" name="Wang Monica" initials="WM" userId="S::Monica.Wang@ucb.com::296ccb8d-352d-4bb2-b28c-37e086caa076" providerId="AD"/>
  <p188:author id="{80A6C1DA-1202-35C5-8945-3D37FA212A57}" name="Shin Baehyun" initials="BS" userId="S::Baehyun.Shin@ucb.com::5c8ccd08-ef57-482c-bed9-c623d9f5d053" providerId="AD"/>
  <p188:author id="{1A46F7DD-0D3D-5ACF-7DA0-2E616BB2CF76}" name="Ekert Jason" initials="EJ" userId="S::Jason.Ekert@ucb.com::86a6f4d0-8b36-4ee5-80c7-fa72ee7df86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6E1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247" autoAdjust="0"/>
  </p:normalViewPr>
  <p:slideViewPr>
    <p:cSldViewPr snapToGrid="0">
      <p:cViewPr varScale="1">
        <p:scale>
          <a:sx n="60" d="100"/>
          <a:sy n="60" d="100"/>
        </p:scale>
        <p:origin x="81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Master" Target="slideMasters/slideMaster4.xml"/><Relationship Id="rId12" Type="http://schemas.openxmlformats.org/officeDocument/2006/relationships/slide" Target="slides/slide5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slide" Target="slides/slide4.xml"/><Relationship Id="rId5" Type="http://schemas.openxmlformats.org/officeDocument/2006/relationships/slideMaster" Target="slideMasters/slideMaster2.xml"/><Relationship Id="rId15" Type="http://schemas.openxmlformats.org/officeDocument/2006/relationships/viewProps" Target="viewProps.xml"/><Relationship Id="rId10" Type="http://schemas.openxmlformats.org/officeDocument/2006/relationships/slide" Target="slides/slide3.xml"/><Relationship Id="rId19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2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chel Price" userId="70c015ba-33cc-471a-a8bc-8f6e7c4888db" providerId="ADAL" clId="{B81562F5-B252-4110-AC48-F216CF799C5D}"/>
    <pc:docChg chg="undo custSel modSld">
      <pc:chgData name="Rachel Price" userId="70c015ba-33cc-471a-a8bc-8f6e7c4888db" providerId="ADAL" clId="{B81562F5-B252-4110-AC48-F216CF799C5D}" dt="2025-07-16T08:29:15.458" v="140"/>
      <pc:docMkLst>
        <pc:docMk/>
      </pc:docMkLst>
      <pc:sldChg chg="addSp modSp mod">
        <pc:chgData name="Rachel Price" userId="70c015ba-33cc-471a-a8bc-8f6e7c4888db" providerId="ADAL" clId="{B81562F5-B252-4110-AC48-F216CF799C5D}" dt="2025-07-16T08:27:27.046" v="102" actId="20577"/>
        <pc:sldMkLst>
          <pc:docMk/>
          <pc:sldMk cId="1647982551" sldId="257"/>
        </pc:sldMkLst>
      </pc:sldChg>
      <pc:sldChg chg="addSp delSp modSp mod">
        <pc:chgData name="Rachel Price" userId="70c015ba-33cc-471a-a8bc-8f6e7c4888db" providerId="ADAL" clId="{B81562F5-B252-4110-AC48-F216CF799C5D}" dt="2025-07-16T08:28:11.891" v="119" actId="20577"/>
        <pc:sldMkLst>
          <pc:docMk/>
          <pc:sldMk cId="2480476468" sldId="258"/>
        </pc:sldMkLst>
      </pc:sldChg>
      <pc:sldChg chg="modSp mod">
        <pc:chgData name="Rachel Price" userId="70c015ba-33cc-471a-a8bc-8f6e7c4888db" providerId="ADAL" clId="{B81562F5-B252-4110-AC48-F216CF799C5D}" dt="2025-07-16T08:28:24.916" v="123" actId="20577"/>
        <pc:sldMkLst>
          <pc:docMk/>
          <pc:sldMk cId="3503260071" sldId="259"/>
        </pc:sldMkLst>
      </pc:sldChg>
      <pc:sldChg chg="modSp mod">
        <pc:chgData name="Rachel Price" userId="70c015ba-33cc-471a-a8bc-8f6e7c4888db" providerId="ADAL" clId="{B81562F5-B252-4110-AC48-F216CF799C5D}" dt="2025-07-16T08:29:15.458" v="140"/>
        <pc:sldMkLst>
          <pc:docMk/>
          <pc:sldMk cId="2179662931" sldId="261"/>
        </pc:sldMkLst>
      </pc:sldChg>
      <pc:sldChg chg="addSp modSp mod">
        <pc:chgData name="Rachel Price" userId="70c015ba-33cc-471a-a8bc-8f6e7c4888db" providerId="ADAL" clId="{B81562F5-B252-4110-AC48-F216CF799C5D}" dt="2025-07-16T08:27:05.942" v="95" actId="20577"/>
        <pc:sldMkLst>
          <pc:docMk/>
          <pc:sldMk cId="3640074834" sldId="2147472070"/>
        </pc:sldMkLst>
      </pc:sldChg>
      <pc:sldChg chg="addSp delSp modSp mod">
        <pc:chgData name="Rachel Price" userId="70c015ba-33cc-471a-a8bc-8f6e7c4888db" providerId="ADAL" clId="{B81562F5-B252-4110-AC48-F216CF799C5D}" dt="2025-07-16T08:28:21.924" v="121" actId="20577"/>
        <pc:sldMkLst>
          <pc:docMk/>
          <pc:sldMk cId="1516774897" sldId="2147472075"/>
        </pc:sldMkLst>
      </pc:sldChg>
      <pc:sldChg chg="addSp delSp modSp mod">
        <pc:chgData name="Rachel Price" userId="70c015ba-33cc-471a-a8bc-8f6e7c4888db" providerId="ADAL" clId="{B81562F5-B252-4110-AC48-F216CF799C5D}" dt="2025-07-16T08:27:41.132" v="107" actId="20577"/>
        <pc:sldMkLst>
          <pc:docMk/>
          <pc:sldMk cId="2467075336" sldId="2147472078"/>
        </pc:sldMkLst>
      </pc:sldChg>
      <pc:sldChg chg="modSp mod">
        <pc:chgData name="Rachel Price" userId="70c015ba-33cc-471a-a8bc-8f6e7c4888db" providerId="ADAL" clId="{B81562F5-B252-4110-AC48-F216CF799C5D}" dt="2025-07-16T08:27:53.308" v="110" actId="20577"/>
        <pc:sldMkLst>
          <pc:docMk/>
          <pc:sldMk cId="3813158804" sldId="2147474250"/>
        </pc:sldMkLst>
      </pc:sldChg>
    </pc:docChg>
  </pc:docChgLst>
  <pc:docChgLst>
    <pc:chgData name="Qudsia Ehsan" userId="02ea72e0-5f6c-4d02-9212-382f7d089142" providerId="ADAL" clId="{1E8A07F2-7A18-40E5-BC3E-06345C2A2621}"/>
    <pc:docChg chg="delSld delSection modSection">
      <pc:chgData name="Qudsia Ehsan" userId="02ea72e0-5f6c-4d02-9212-382f7d089142" providerId="ADAL" clId="{1E8A07F2-7A18-40E5-BC3E-06345C2A2621}" dt="2025-08-21T13:55:23.384" v="0" actId="18676"/>
      <pc:docMkLst>
        <pc:docMk/>
      </pc:docMkLst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1647982551" sldId="257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2480476468" sldId="258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3503260071" sldId="259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2179662931" sldId="261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3640074834" sldId="2147472070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1516774897" sldId="2147472075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2467075336" sldId="2147472078"/>
        </pc:sldMkLst>
      </pc:sldChg>
      <pc:sldChg chg="del">
        <pc:chgData name="Qudsia Ehsan" userId="02ea72e0-5f6c-4d02-9212-382f7d089142" providerId="ADAL" clId="{1E8A07F2-7A18-40E5-BC3E-06345C2A2621}" dt="2025-08-21T13:55:23.384" v="0" actId="18676"/>
        <pc:sldMkLst>
          <pc:docMk/>
          <pc:sldMk cId="3813158804" sldId="214747425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DA8403-8AE1-4A50-8B5E-491E75CED904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FFEEFA-CCFE-4435-919C-A5F111F8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7387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3.xml"/></Relationships>
</file>

<file path=ppt/slideLayouts/_rels/slideLayout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3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3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4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4.xml"/></Relationships>
</file>

<file path=ppt/slideLayouts/_rels/slideLayout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4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7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4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9A15F-0BAE-44F7-9A8A-5D19986EF8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638493-CE5E-4ACA-AE7F-B6F4869AE6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1B449-70C2-46BE-BD76-E74567FFC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B23135-F326-4F1F-ACAC-1217FFB35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28B30-A195-4C6F-B460-6015E9674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481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5D9AA-29F5-47F8-8369-DE1B8EF0A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E21E56-338E-46BC-BAB6-4A7AF8DEEB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AAC7AB-BA69-4AA6-BE90-7FB52113E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031DC-23C8-4E0E-8583-8FC02A841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021CDC-9675-4713-A20D-47A28107E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633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F694EB-BE9E-452B-94AE-AE73E08688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CB9946-F013-4CBA-8F15-F463E4E93A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091C46-E847-4E23-BAD0-281E6F79A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307AAA-8669-43D6-95AD-1A8019657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74987-AB4A-4672-84C1-55D5E6C60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17398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ub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2350924" y="6547006"/>
            <a:ext cx="8829521" cy="123111"/>
          </a:xfrm>
          <a:prstGeom prst="rect">
            <a:avLst/>
          </a:prstGeom>
        </p:spPr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8" name="Text Placeholder 5">
            <a:extLst>
              <a:ext uri="{FF2B5EF4-FFF2-40B4-BE49-F238E27FC236}">
                <a16:creationId xmlns:a16="http://schemas.microsoft.com/office/drawing/2014/main" id="{BA88B5C9-2C55-6B42-9831-C9301B5999C7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393857"/>
            <a:ext cx="8829521" cy="123111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4" name="Text Placeholder 5">
            <a:extLst>
              <a:ext uri="{FF2B5EF4-FFF2-40B4-BE49-F238E27FC236}">
                <a16:creationId xmlns:a16="http://schemas.microsoft.com/office/drawing/2014/main" id="{07D7B128-E903-1D55-B07E-BE31A84E4145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6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6006739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with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6103131" y="1"/>
            <a:ext cx="1495876" cy="5815263"/>
          </a:xfrm>
          <a:prstGeom prst="rect">
            <a:avLst/>
          </a:prstGeom>
          <a:solidFill>
            <a:srgbClr val="8760A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11" name="Rectangle 10"/>
          <p:cNvSpPr/>
          <p:nvPr userDrawn="1"/>
        </p:nvSpPr>
        <p:spPr>
          <a:xfrm>
            <a:off x="7589700" y="1"/>
            <a:ext cx="476088" cy="5815263"/>
          </a:xfrm>
          <a:prstGeom prst="rect">
            <a:avLst/>
          </a:prstGeom>
          <a:solidFill>
            <a:srgbClr val="512C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9" name="Rectangle 8"/>
          <p:cNvSpPr/>
          <p:nvPr userDrawn="1"/>
        </p:nvSpPr>
        <p:spPr>
          <a:xfrm>
            <a:off x="5846460" y="1"/>
            <a:ext cx="267873" cy="5815263"/>
          </a:xfrm>
          <a:prstGeom prst="rect">
            <a:avLst/>
          </a:prstGeom>
          <a:solidFill>
            <a:srgbClr val="512C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8" name="Rectangle 7"/>
          <p:cNvSpPr/>
          <p:nvPr userDrawn="1"/>
        </p:nvSpPr>
        <p:spPr>
          <a:xfrm>
            <a:off x="1" y="1"/>
            <a:ext cx="5847152" cy="581526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>
              <a:solidFill>
                <a:schemeClr val="accent1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22" name="Espace réservé pour une image  21"/>
          <p:cNvSpPr>
            <a:spLocks noGrp="1"/>
          </p:cNvSpPr>
          <p:nvPr>
            <p:ph type="pic" sz="quarter" idx="12" hasCustomPrompt="1"/>
          </p:nvPr>
        </p:nvSpPr>
        <p:spPr>
          <a:xfrm>
            <a:off x="8138088" y="1"/>
            <a:ext cx="4056000" cy="5815263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noProof="0"/>
              <a:t>Picture</a:t>
            </a:r>
          </a:p>
        </p:txBody>
      </p:sp>
      <p:sp>
        <p:nvSpPr>
          <p:cNvPr id="2" name="Titre 1"/>
          <p:cNvSpPr>
            <a:spLocks noGrp="1"/>
          </p:cNvSpPr>
          <p:nvPr>
            <p:ph type="ctrTitle" hasCustomPrompt="1"/>
          </p:nvPr>
        </p:nvSpPr>
        <p:spPr>
          <a:xfrm>
            <a:off x="576227" y="967619"/>
            <a:ext cx="5519773" cy="2410207"/>
          </a:xfrm>
        </p:spPr>
        <p:txBody>
          <a:bodyPr/>
          <a:lstStyle>
            <a:lvl1pPr>
              <a:lnSpc>
                <a:spcPct val="90000"/>
              </a:lnSpc>
              <a:defRPr sz="5333">
                <a:solidFill>
                  <a:schemeClr val="bg1"/>
                </a:solidFill>
              </a:defRPr>
            </a:lvl1pPr>
          </a:lstStyle>
          <a:p>
            <a:r>
              <a:rPr lang="en-US" noProof="0"/>
              <a:t>Click to </a:t>
            </a:r>
            <a:br>
              <a:rPr lang="en-US" noProof="0"/>
            </a:br>
            <a:r>
              <a:rPr lang="en-US" noProof="0"/>
              <a:t>add </a:t>
            </a:r>
            <a:br>
              <a:rPr lang="en-US" noProof="0"/>
            </a:br>
            <a:r>
              <a:rPr lang="en-US" noProof="0"/>
              <a:t>title</a:t>
            </a:r>
          </a:p>
        </p:txBody>
      </p:sp>
      <p:pic>
        <p:nvPicPr>
          <p:cNvPr id="7" name="Image 6"/>
          <p:cNvPicPr>
            <a:picLocks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7419" y="6138863"/>
            <a:ext cx="2144684" cy="399288"/>
          </a:xfrm>
          <a:prstGeom prst="rect">
            <a:avLst/>
          </a:prstGeom>
        </p:spPr>
      </p:pic>
      <p:sp>
        <p:nvSpPr>
          <p:cNvPr id="5" name="Espace réservé du texte 4"/>
          <p:cNvSpPr>
            <a:spLocks noGrp="1"/>
          </p:cNvSpPr>
          <p:nvPr>
            <p:ph type="body" sz="quarter" idx="13" hasCustomPrompt="1"/>
          </p:nvPr>
        </p:nvSpPr>
        <p:spPr>
          <a:xfrm>
            <a:off x="588180" y="4067178"/>
            <a:ext cx="3937000" cy="328295"/>
          </a:xfrm>
        </p:spPr>
        <p:txBody>
          <a:bodyPr>
            <a:spAutoFit/>
          </a:bodyPr>
          <a:lstStyle>
            <a:lvl1pPr>
              <a:defRPr sz="2133" b="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noProof="0" err="1"/>
              <a:t>dd.mm.yyyy</a:t>
            </a:r>
            <a:endParaRPr lang="en-US" noProof="0"/>
          </a:p>
        </p:txBody>
      </p:sp>
      <p:sp>
        <p:nvSpPr>
          <p:cNvPr id="13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588180" y="3642837"/>
            <a:ext cx="3937000" cy="328231"/>
          </a:xfrm>
        </p:spPr>
        <p:txBody>
          <a:bodyPr anchor="ctr">
            <a:spAutoFit/>
          </a:bodyPr>
          <a:lstStyle>
            <a:lvl1pPr>
              <a:defRPr lang="en-US" sz="2133" b="0" i="0" u="none" strike="noStrike" baseline="0" smtClean="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sz="2133" b="0" i="0" u="none" strike="noStrike" baseline="0">
                <a:solidFill>
                  <a:srgbClr val="FFFFFF"/>
                </a:solidFill>
                <a:latin typeface="ArialMT"/>
              </a:rPr>
              <a:t>Subhead</a:t>
            </a:r>
            <a:endParaRPr lang="en-US" noProof="0"/>
          </a:p>
        </p:txBody>
      </p:sp>
      <p:sp>
        <p:nvSpPr>
          <p:cNvPr id="12" name="Espace réservé pour une image  14"/>
          <p:cNvSpPr>
            <a:spLocks noGrp="1"/>
          </p:cNvSpPr>
          <p:nvPr>
            <p:ph type="pic" sz="quarter" idx="15" hasCustomPrompt="1"/>
          </p:nvPr>
        </p:nvSpPr>
        <p:spPr>
          <a:xfrm>
            <a:off x="9583060" y="6118292"/>
            <a:ext cx="2160000" cy="396000"/>
          </a:xfrm>
        </p:spPr>
        <p:txBody>
          <a:bodyPr anchor="ctr" anchorCtr="0">
            <a:noAutofit/>
          </a:bodyPr>
          <a:lstStyle>
            <a:lvl1pPr algn="ctr">
              <a:defRPr sz="1067">
                <a:solidFill>
                  <a:schemeClr val="tx1"/>
                </a:solidFill>
              </a:defRPr>
            </a:lvl1pPr>
          </a:lstStyle>
          <a:p>
            <a:r>
              <a:rPr lang="en-US" noProof="0"/>
              <a:t>Co-branding logo</a:t>
            </a:r>
          </a:p>
        </p:txBody>
      </p:sp>
    </p:spTree>
    <p:extLst>
      <p:ext uri="{BB962C8B-B14F-4D97-AF65-F5344CB8AC3E}">
        <p14:creationId xmlns:p14="http://schemas.microsoft.com/office/powerpoint/2010/main" val="11286290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 hasCustomPrompt="1"/>
          </p:nvPr>
        </p:nvSpPr>
        <p:spPr>
          <a:xfrm>
            <a:off x="561601" y="1126067"/>
            <a:ext cx="10665201" cy="4654020"/>
          </a:xfrm>
        </p:spPr>
        <p:txBody>
          <a:bodyPr/>
          <a:lstStyle>
            <a:lvl1pPr marL="380990" indent="-380990">
              <a:lnSpc>
                <a:spcPct val="100000"/>
              </a:lnSpc>
              <a:spcBef>
                <a:spcPts val="2667"/>
              </a:spcBef>
              <a:buClr>
                <a:schemeClr val="tx1">
                  <a:lumMod val="60000"/>
                  <a:lumOff val="40000"/>
                </a:schemeClr>
              </a:buClr>
              <a:buSzPct val="180000"/>
              <a:buFont typeface="Arial" pitchFamily="34" charset="0"/>
              <a:buChar char="ן"/>
              <a:defRPr sz="2400" baseline="0">
                <a:solidFill>
                  <a:schemeClr val="tx2"/>
                </a:solidFill>
                <a:latin typeface="+mn-lt"/>
              </a:defRPr>
            </a:lvl1pPr>
            <a:lvl2pPr marL="586303" marR="0" indent="-287859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tx1"/>
              </a:buClr>
              <a:buSzTx/>
              <a:buFont typeface="Arial" pitchFamily="34" charset="0"/>
              <a:buChar char="•"/>
              <a:tabLst/>
              <a:defRPr b="0"/>
            </a:lvl2pPr>
            <a:lvl3pPr marL="479988" indent="-143996" algn="l" defTabSz="1219170" rtl="0" eaLnBrk="1" latinLnBrk="0" hangingPunct="1">
              <a:spcBef>
                <a:spcPts val="400"/>
              </a:spcBef>
              <a:buClr>
                <a:schemeClr val="tx2"/>
              </a:buClr>
              <a:buSzPct val="100000"/>
              <a:buFont typeface="Arial" pitchFamily="34" charset="0"/>
              <a:buChar char="•"/>
              <a:defRPr lang="en-US" sz="1400" kern="1200" noProof="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</a:lstStyle>
          <a:p>
            <a:pPr lvl="0"/>
            <a:r>
              <a:rPr lang="en-US" noProof="0"/>
              <a:t>Click to add text</a:t>
            </a:r>
          </a:p>
          <a:p>
            <a:pPr lvl="1"/>
            <a:r>
              <a:rPr lang="en-US" noProof="0"/>
              <a:t>Second level</a:t>
            </a:r>
          </a:p>
          <a:p>
            <a:pPr lvl="3"/>
            <a:endParaRPr lang="en-US" noProof="0"/>
          </a:p>
        </p:txBody>
      </p:sp>
      <p:sp>
        <p:nvSpPr>
          <p:cNvPr id="4" name="Titre 3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/>
              <a:t>Click to add title</a:t>
            </a:r>
          </a:p>
        </p:txBody>
      </p:sp>
      <p:sp>
        <p:nvSpPr>
          <p:cNvPr id="13" name="Espace réservé pour une image  14"/>
          <p:cNvSpPr>
            <a:spLocks noGrp="1"/>
          </p:cNvSpPr>
          <p:nvPr>
            <p:ph type="pic" sz="quarter" idx="13" hasCustomPrompt="1"/>
          </p:nvPr>
        </p:nvSpPr>
        <p:spPr>
          <a:xfrm>
            <a:off x="9583060" y="6376707"/>
            <a:ext cx="2160000" cy="396000"/>
          </a:xfrm>
        </p:spPr>
        <p:txBody>
          <a:bodyPr anchor="ctr" anchorCtr="0">
            <a:noAutofit/>
          </a:bodyPr>
          <a:lstStyle>
            <a:lvl1pPr algn="ctr">
              <a:defRPr sz="1067">
                <a:solidFill>
                  <a:schemeClr val="tx1"/>
                </a:solidFill>
              </a:defRPr>
            </a:lvl1pPr>
          </a:lstStyle>
          <a:p>
            <a:r>
              <a:rPr lang="en-US" noProof="0"/>
              <a:t>Co-branding logo</a:t>
            </a: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2186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vi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grpSp>
        <p:nvGrpSpPr>
          <p:cNvPr id="5" name="Group 4"/>
          <p:cNvGrpSpPr/>
          <p:nvPr userDrawn="1"/>
        </p:nvGrpSpPr>
        <p:grpSpPr>
          <a:xfrm>
            <a:off x="4351979" y="0"/>
            <a:ext cx="7849267" cy="6260339"/>
            <a:chOff x="-1" y="0"/>
            <a:chExt cx="9150935" cy="4695254"/>
          </a:xfrm>
        </p:grpSpPr>
        <p:sp>
          <p:nvSpPr>
            <p:cNvPr id="6" name="Rectangle 5"/>
            <p:cNvSpPr/>
            <p:nvPr userDrawn="1"/>
          </p:nvSpPr>
          <p:spPr>
            <a:xfrm>
              <a:off x="6601492" y="0"/>
              <a:ext cx="1932908" cy="4695254"/>
            </a:xfrm>
            <a:prstGeom prst="rect">
              <a:avLst/>
            </a:prstGeom>
            <a:solidFill>
              <a:srgbClr val="8760A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2400" noProof="0"/>
            </a:p>
          </p:txBody>
        </p:sp>
        <p:sp>
          <p:nvSpPr>
            <p:cNvPr id="7" name="Rectangle 6"/>
            <p:cNvSpPr/>
            <p:nvPr userDrawn="1"/>
          </p:nvSpPr>
          <p:spPr>
            <a:xfrm>
              <a:off x="8534400" y="0"/>
              <a:ext cx="616534" cy="4695254"/>
            </a:xfrm>
            <a:prstGeom prst="rect">
              <a:avLst/>
            </a:prstGeom>
            <a:solidFill>
              <a:srgbClr val="522C7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2400" noProof="0"/>
            </a:p>
          </p:txBody>
        </p:sp>
        <p:sp>
          <p:nvSpPr>
            <p:cNvPr id="8" name="Rectangle 7"/>
            <p:cNvSpPr/>
            <p:nvPr userDrawn="1"/>
          </p:nvSpPr>
          <p:spPr>
            <a:xfrm>
              <a:off x="6238876" y="0"/>
              <a:ext cx="362616" cy="4695254"/>
            </a:xfrm>
            <a:prstGeom prst="rect">
              <a:avLst/>
            </a:prstGeom>
            <a:solidFill>
              <a:srgbClr val="522C7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2400" noProof="0"/>
            </a:p>
          </p:txBody>
        </p:sp>
        <p:sp>
          <p:nvSpPr>
            <p:cNvPr id="9" name="Rectangle 8"/>
            <p:cNvSpPr/>
            <p:nvPr userDrawn="1"/>
          </p:nvSpPr>
          <p:spPr>
            <a:xfrm>
              <a:off x="-1" y="0"/>
              <a:ext cx="6238877" cy="4695254"/>
            </a:xfrm>
            <a:prstGeom prst="rect">
              <a:avLst/>
            </a:prstGeom>
            <a:solidFill>
              <a:srgbClr val="5E366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2400" noProof="0">
                <a:solidFill>
                  <a:schemeClr val="accent1">
                    <a:lumMod val="20000"/>
                    <a:lumOff val="80000"/>
                  </a:schemeClr>
                </a:solidFill>
              </a:endParaRPr>
            </a:p>
          </p:txBody>
        </p:sp>
      </p:grpSp>
      <p:sp>
        <p:nvSpPr>
          <p:cNvPr id="12" name="Picture Placeholder 11"/>
          <p:cNvSpPr>
            <a:spLocks noGrp="1"/>
          </p:cNvSpPr>
          <p:nvPr>
            <p:ph type="pic" sz="quarter" idx="11"/>
          </p:nvPr>
        </p:nvSpPr>
        <p:spPr>
          <a:xfrm>
            <a:off x="-1" y="1"/>
            <a:ext cx="4275551" cy="6261100"/>
          </a:xfrm>
        </p:spPr>
        <p:txBody>
          <a:bodyPr/>
          <a:lstStyle/>
          <a:p>
            <a:r>
              <a:rPr lang="en-US"/>
              <a:t>Click icon to add picture</a:t>
            </a:r>
          </a:p>
        </p:txBody>
      </p:sp>
      <p:pic>
        <p:nvPicPr>
          <p:cNvPr id="13" name="Image 12"/>
          <p:cNvPicPr>
            <a:picLocks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2575" y="6412641"/>
            <a:ext cx="297484" cy="295875"/>
          </a:xfrm>
          <a:prstGeom prst="rect">
            <a:avLst/>
          </a:prstGeom>
        </p:spPr>
      </p:pic>
      <p:sp>
        <p:nvSpPr>
          <p:cNvPr id="4" name="Text Placeholder 3"/>
          <p:cNvSpPr>
            <a:spLocks noGrp="1"/>
          </p:cNvSpPr>
          <p:nvPr>
            <p:ph type="body" sz="quarter" idx="12" hasCustomPrompt="1"/>
          </p:nvPr>
        </p:nvSpPr>
        <p:spPr>
          <a:xfrm>
            <a:off x="4351867" y="1378879"/>
            <a:ext cx="7773328" cy="2078567"/>
          </a:xfrm>
        </p:spPr>
        <p:txBody>
          <a:bodyPr/>
          <a:lstStyle>
            <a:lvl1pPr algn="r">
              <a:defRPr sz="4267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Section title appears</a:t>
            </a:r>
            <a:br>
              <a:rPr lang="en-US"/>
            </a:br>
            <a:r>
              <a:rPr lang="en-US"/>
              <a:t>in this size and font</a:t>
            </a:r>
          </a:p>
        </p:txBody>
      </p:sp>
    </p:spTree>
    <p:extLst>
      <p:ext uri="{BB962C8B-B14F-4D97-AF65-F5344CB8AC3E}">
        <p14:creationId xmlns:p14="http://schemas.microsoft.com/office/powerpoint/2010/main" val="427240208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without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 userDrawn="1"/>
        </p:nvSpPr>
        <p:spPr>
          <a:xfrm>
            <a:off x="10229343" y="-2"/>
            <a:ext cx="1495876" cy="6275295"/>
          </a:xfrm>
          <a:prstGeom prst="rect">
            <a:avLst/>
          </a:prstGeom>
          <a:solidFill>
            <a:srgbClr val="8760A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26" name="Rectangle 25"/>
          <p:cNvSpPr/>
          <p:nvPr userDrawn="1"/>
        </p:nvSpPr>
        <p:spPr>
          <a:xfrm>
            <a:off x="11715912" y="-2"/>
            <a:ext cx="476088" cy="6275295"/>
          </a:xfrm>
          <a:prstGeom prst="rect">
            <a:avLst/>
          </a:prstGeom>
          <a:solidFill>
            <a:srgbClr val="512C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27" name="Rectangle 26"/>
          <p:cNvSpPr/>
          <p:nvPr userDrawn="1"/>
        </p:nvSpPr>
        <p:spPr>
          <a:xfrm>
            <a:off x="9972672" y="-2"/>
            <a:ext cx="267873" cy="6275295"/>
          </a:xfrm>
          <a:prstGeom prst="rect">
            <a:avLst/>
          </a:prstGeom>
          <a:solidFill>
            <a:srgbClr val="512C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28" name="Rectangle 27"/>
          <p:cNvSpPr/>
          <p:nvPr userDrawn="1"/>
        </p:nvSpPr>
        <p:spPr>
          <a:xfrm>
            <a:off x="5019482" y="-2"/>
            <a:ext cx="4953189" cy="627529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>
              <a:solidFill>
                <a:schemeClr val="accent1">
                  <a:lumMod val="20000"/>
                  <a:lumOff val="80000"/>
                </a:schemeClr>
              </a:solidFill>
            </a:endParaRPr>
          </a:p>
        </p:txBody>
      </p:sp>
      <p:pic>
        <p:nvPicPr>
          <p:cNvPr id="13" name="Image 12"/>
          <p:cNvPicPr>
            <a:picLocks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2575" y="6412641"/>
            <a:ext cx="297484" cy="295875"/>
          </a:xfrm>
          <a:prstGeom prst="rect">
            <a:avLst/>
          </a:prstGeom>
        </p:spPr>
      </p:pic>
      <p:sp>
        <p:nvSpPr>
          <p:cNvPr id="12" name="Rectangle 11"/>
          <p:cNvSpPr/>
          <p:nvPr userDrawn="1"/>
        </p:nvSpPr>
        <p:spPr>
          <a:xfrm>
            <a:off x="4125341" y="-2"/>
            <a:ext cx="819193" cy="6275295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14" name="Rectangle 13"/>
          <p:cNvSpPr/>
          <p:nvPr userDrawn="1"/>
        </p:nvSpPr>
        <p:spPr>
          <a:xfrm>
            <a:off x="3693540" y="-2"/>
            <a:ext cx="431800" cy="627529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15" name="Rectangle 14"/>
          <p:cNvSpPr/>
          <p:nvPr userDrawn="1"/>
        </p:nvSpPr>
        <p:spPr>
          <a:xfrm>
            <a:off x="571502" y="-2"/>
            <a:ext cx="3122039" cy="6275295"/>
          </a:xfrm>
          <a:prstGeom prst="rect">
            <a:avLst/>
          </a:prstGeom>
          <a:solidFill>
            <a:srgbClr val="ECECE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17" name="Titre 1"/>
          <p:cNvSpPr>
            <a:spLocks noGrp="1"/>
          </p:cNvSpPr>
          <p:nvPr>
            <p:ph type="ctrTitle" hasCustomPrompt="1"/>
          </p:nvPr>
        </p:nvSpPr>
        <p:spPr>
          <a:xfrm>
            <a:off x="6052287" y="1503308"/>
            <a:ext cx="6085955" cy="1817369"/>
          </a:xfrm>
        </p:spPr>
        <p:txBody>
          <a:bodyPr/>
          <a:lstStyle>
            <a:lvl1pPr algn="r">
              <a:lnSpc>
                <a:spcPct val="110000"/>
              </a:lnSpc>
              <a:defRPr sz="4267">
                <a:solidFill>
                  <a:schemeClr val="bg1"/>
                </a:solidFill>
              </a:defRPr>
            </a:lvl1pPr>
          </a:lstStyle>
          <a:p>
            <a:r>
              <a:rPr lang="fr-FR" noProof="0"/>
              <a:t>Click </a:t>
            </a:r>
            <a:r>
              <a:rPr lang="fr-FR" noProof="0" err="1"/>
              <a:t>here</a:t>
            </a:r>
            <a:r>
              <a:rPr lang="fr-FR" noProof="0"/>
              <a:t> to </a:t>
            </a:r>
            <a:r>
              <a:rPr lang="fr-FR" noProof="0" err="1"/>
              <a:t>add</a:t>
            </a:r>
            <a:r>
              <a:rPr lang="fr-FR" noProof="0"/>
              <a:t> </a:t>
            </a:r>
            <a:r>
              <a:rPr lang="fr-FR" noProof="0" err="1"/>
              <a:t>text</a:t>
            </a:r>
            <a:endParaRPr lang="en-US" noProof="0"/>
          </a:p>
        </p:txBody>
      </p:sp>
    </p:spTree>
    <p:extLst>
      <p:ext uri="{BB962C8B-B14F-4D97-AF65-F5344CB8AC3E}">
        <p14:creationId xmlns:p14="http://schemas.microsoft.com/office/powerpoint/2010/main" val="294539098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>
          <a:xfrm>
            <a:off x="561601" y="188641"/>
            <a:ext cx="10651591" cy="459664"/>
          </a:xfrm>
        </p:spPr>
        <p:txBody>
          <a:bodyPr/>
          <a:lstStyle/>
          <a:p>
            <a:r>
              <a:rPr lang="en-US" noProof="0"/>
              <a:t>Click to add title</a:t>
            </a:r>
            <a:endParaRPr lang="en-US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4" name="Espace réservé du texte 4"/>
          <p:cNvSpPr>
            <a:spLocks noGrp="1"/>
          </p:cNvSpPr>
          <p:nvPr>
            <p:ph type="body" sz="quarter" idx="17" hasCustomPrompt="1"/>
          </p:nvPr>
        </p:nvSpPr>
        <p:spPr>
          <a:xfrm>
            <a:off x="2060347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2" y="1652400"/>
            <a:ext cx="10641300" cy="43200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fr-FR" noProof="0"/>
              <a:t>First </a:t>
            </a:r>
            <a:r>
              <a:rPr lang="fr-FR" noProof="0" err="1"/>
              <a:t>level</a:t>
            </a:r>
            <a:endParaRPr lang="en-US" noProof="0"/>
          </a:p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cxnSp>
        <p:nvCxnSpPr>
          <p:cNvPr id="9" name="Connecteur droit 8"/>
          <p:cNvCxnSpPr/>
          <p:nvPr userDrawn="1"/>
        </p:nvCxnSpPr>
        <p:spPr>
          <a:xfrm>
            <a:off x="1928529" y="797857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67308325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/>
              <a:t>Click to add title</a:t>
            </a:r>
            <a:endParaRPr lang="en-US"/>
          </a:p>
        </p:txBody>
      </p:sp>
      <p:sp>
        <p:nvSpPr>
          <p:cNvPr id="3" name="Espace réservé du numéro de diapositive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2" y="1652400"/>
            <a:ext cx="10641300" cy="4320000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fr-FR" noProof="0"/>
              <a:t>First </a:t>
            </a:r>
            <a:r>
              <a:rPr lang="fr-FR" noProof="0" err="1"/>
              <a:t>level</a:t>
            </a:r>
            <a:endParaRPr lang="en-US" noProof="0"/>
          </a:p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7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116159755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1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19" hasCustomPrompt="1"/>
          </p:nvPr>
        </p:nvSpPr>
        <p:spPr>
          <a:xfrm>
            <a:off x="571502" y="1693863"/>
            <a:ext cx="10655300" cy="304800"/>
          </a:xfrm>
        </p:spPr>
        <p:txBody>
          <a:bodyPr/>
          <a:lstStyle>
            <a:lvl1pPr>
              <a:lnSpc>
                <a:spcPct val="80000"/>
              </a:lnSpc>
              <a:defRPr baseline="0"/>
            </a:lvl1pPr>
          </a:lstStyle>
          <a:p>
            <a:pPr lvl="0"/>
            <a:r>
              <a:rPr lang="fr-FR"/>
              <a:t>First level</a:t>
            </a:r>
            <a:endParaRPr lang="en-US"/>
          </a:p>
        </p:txBody>
      </p:sp>
      <p:sp>
        <p:nvSpPr>
          <p:cNvPr id="15" name="Espace réservé du texte 5"/>
          <p:cNvSpPr>
            <a:spLocks noGrp="1"/>
          </p:cNvSpPr>
          <p:nvPr>
            <p:ph type="body" sz="quarter" idx="20" hasCustomPrompt="1"/>
          </p:nvPr>
        </p:nvSpPr>
        <p:spPr>
          <a:xfrm>
            <a:off x="5979887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16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  <p:sp>
        <p:nvSpPr>
          <p:cNvPr id="11" name="Espace réservé du texte 4"/>
          <p:cNvSpPr>
            <a:spLocks noGrp="1"/>
          </p:cNvSpPr>
          <p:nvPr>
            <p:ph type="body" sz="quarter" idx="21" hasCustomPrompt="1"/>
          </p:nvPr>
        </p:nvSpPr>
        <p:spPr>
          <a:xfrm>
            <a:off x="2060347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cxnSp>
        <p:nvCxnSpPr>
          <p:cNvPr id="14" name="Connecteur droit 13"/>
          <p:cNvCxnSpPr/>
          <p:nvPr userDrawn="1"/>
        </p:nvCxnSpPr>
        <p:spPr>
          <a:xfrm>
            <a:off x="1928529" y="797857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itre 1"/>
          <p:cNvSpPr>
            <a:spLocks noGrp="1"/>
          </p:cNvSpPr>
          <p:nvPr>
            <p:ph type="title" hasCustomPrompt="1"/>
          </p:nvPr>
        </p:nvSpPr>
        <p:spPr>
          <a:xfrm>
            <a:off x="561601" y="188642"/>
            <a:ext cx="10651591" cy="488692"/>
          </a:xfrm>
        </p:spPr>
        <p:txBody>
          <a:bodyPr/>
          <a:lstStyle/>
          <a:p>
            <a:r>
              <a:rPr lang="en-US" noProof="0"/>
              <a:t>Click to add tit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579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A7F16C-D482-4989-BD5E-3E2CDD968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219C7F-450D-4B91-B9C9-68F6E9D129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0D381B-3530-4251-AF03-019FDEC5E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7E3AE8-D77E-4FD9-874C-F4E5D24DB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3EB180-EEB4-427A-B813-9A35C84E4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83594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s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1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19" hasCustomPrompt="1"/>
          </p:nvPr>
        </p:nvSpPr>
        <p:spPr>
          <a:xfrm>
            <a:off x="571502" y="1693863"/>
            <a:ext cx="10655300" cy="304800"/>
          </a:xfrm>
        </p:spPr>
        <p:txBody>
          <a:bodyPr/>
          <a:lstStyle>
            <a:lvl1pPr>
              <a:lnSpc>
                <a:spcPct val="80000"/>
              </a:lnSpc>
              <a:defRPr baseline="0"/>
            </a:lvl1pPr>
          </a:lstStyle>
          <a:p>
            <a:pPr lvl="0"/>
            <a:r>
              <a:rPr lang="fr-FR"/>
              <a:t>First level</a:t>
            </a:r>
            <a:endParaRPr lang="en-US"/>
          </a:p>
        </p:txBody>
      </p:sp>
      <p:sp>
        <p:nvSpPr>
          <p:cNvPr id="15" name="Espace réservé du texte 5"/>
          <p:cNvSpPr>
            <a:spLocks noGrp="1"/>
          </p:cNvSpPr>
          <p:nvPr>
            <p:ph type="body" sz="quarter" idx="20" hasCustomPrompt="1"/>
          </p:nvPr>
        </p:nvSpPr>
        <p:spPr>
          <a:xfrm>
            <a:off x="5979887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16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  <p:sp>
        <p:nvSpPr>
          <p:cNvPr id="10" name="Titre 1"/>
          <p:cNvSpPr>
            <a:spLocks noGrp="1"/>
          </p:cNvSpPr>
          <p:nvPr>
            <p:ph type="title" hasCustomPrompt="1"/>
          </p:nvPr>
        </p:nvSpPr>
        <p:spPr>
          <a:xfrm>
            <a:off x="561601" y="188642"/>
            <a:ext cx="10651591" cy="488692"/>
          </a:xfrm>
        </p:spPr>
        <p:txBody>
          <a:bodyPr/>
          <a:lstStyle/>
          <a:p>
            <a:r>
              <a:rPr lang="en-US" noProof="0"/>
              <a:t>Click to add tit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26370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s + call-out box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Espace réservé du texte 5"/>
          <p:cNvSpPr>
            <a:spLocks noGrp="1"/>
          </p:cNvSpPr>
          <p:nvPr>
            <p:ph type="body" sz="quarter" idx="22" hasCustomPrompt="1"/>
          </p:nvPr>
        </p:nvSpPr>
        <p:spPr>
          <a:xfrm>
            <a:off x="5979887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/>
              <a:t>Click to add title</a:t>
            </a: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19" hasCustomPrompt="1"/>
          </p:nvPr>
        </p:nvSpPr>
        <p:spPr>
          <a:xfrm>
            <a:off x="571502" y="1693863"/>
            <a:ext cx="10655300" cy="304800"/>
          </a:xfrm>
        </p:spPr>
        <p:txBody>
          <a:bodyPr/>
          <a:lstStyle>
            <a:lvl1pPr>
              <a:lnSpc>
                <a:spcPct val="80000"/>
              </a:lnSpc>
              <a:defRPr baseline="0"/>
            </a:lvl1pPr>
          </a:lstStyle>
          <a:p>
            <a:pPr lvl="0"/>
            <a:r>
              <a:rPr lang="fr-FR"/>
              <a:t>First level</a:t>
            </a:r>
            <a:endParaRPr lang="en-US"/>
          </a:p>
        </p:txBody>
      </p:sp>
      <p:sp>
        <p:nvSpPr>
          <p:cNvPr id="10" name="Espace réservé du texte 7"/>
          <p:cNvSpPr>
            <a:spLocks noGrp="1"/>
          </p:cNvSpPr>
          <p:nvPr>
            <p:ph type="body" sz="quarter" idx="20" hasCustomPrompt="1"/>
          </p:nvPr>
        </p:nvSpPr>
        <p:spPr>
          <a:xfrm>
            <a:off x="6161663" y="4034846"/>
            <a:ext cx="4430139" cy="1605199"/>
          </a:xfrm>
          <a:solidFill>
            <a:schemeClr val="accent1"/>
          </a:solidFill>
          <a:effectLst>
            <a:outerShdw dist="355600" algn="ctr" rotWithShape="0">
              <a:srgbClr val="8760A2"/>
            </a:outerShdw>
          </a:effectLst>
        </p:spPr>
        <p:txBody>
          <a:bodyPr anchor="ctr"/>
          <a:lstStyle>
            <a:lvl1pPr marL="232828" indent="0">
              <a:buFont typeface="+mj-lt"/>
              <a:buNone/>
              <a:defRPr b="0">
                <a:solidFill>
                  <a:schemeClr val="bg1"/>
                </a:solidFill>
              </a:defRPr>
            </a:lvl1pPr>
          </a:lstStyle>
          <a:p>
            <a:pPr lvl="0"/>
            <a:r>
              <a:rPr lang="fr-FR"/>
              <a:t>Click to </a:t>
            </a:r>
            <a:r>
              <a:rPr lang="fr-FR" err="1"/>
              <a:t>add</a:t>
            </a:r>
            <a:r>
              <a:rPr lang="fr-FR"/>
              <a:t> </a:t>
            </a:r>
            <a:r>
              <a:rPr lang="fr-FR" err="1"/>
              <a:t>text</a:t>
            </a:r>
            <a:endParaRPr lang="fr-FR"/>
          </a:p>
        </p:txBody>
      </p:sp>
      <p:sp>
        <p:nvSpPr>
          <p:cNvPr id="13" name="Espace réservé du texte 4"/>
          <p:cNvSpPr>
            <a:spLocks noGrp="1"/>
          </p:cNvSpPr>
          <p:nvPr>
            <p:ph type="body" sz="quarter" idx="17" hasCustomPrompt="1"/>
          </p:nvPr>
        </p:nvSpPr>
        <p:spPr>
          <a:xfrm>
            <a:off x="2060357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cxnSp>
        <p:nvCxnSpPr>
          <p:cNvPr id="14" name="Connecteur droit 13"/>
          <p:cNvCxnSpPr/>
          <p:nvPr userDrawn="1"/>
        </p:nvCxnSpPr>
        <p:spPr>
          <a:xfrm>
            <a:off x="1928537" y="797857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Espace réservé du texte 5"/>
          <p:cNvSpPr>
            <a:spLocks noGrp="1"/>
          </p:cNvSpPr>
          <p:nvPr>
            <p:ph type="body" sz="quarter" idx="21" hasCustomPrompt="1"/>
          </p:nvPr>
        </p:nvSpPr>
        <p:spPr>
          <a:xfrm>
            <a:off x="571501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18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428411859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columns + call-out box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Espace réservé du texte 5"/>
          <p:cNvSpPr>
            <a:spLocks noGrp="1"/>
          </p:cNvSpPr>
          <p:nvPr>
            <p:ph type="body" sz="quarter" idx="22" hasCustomPrompt="1"/>
          </p:nvPr>
        </p:nvSpPr>
        <p:spPr>
          <a:xfrm>
            <a:off x="5979887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/>
              <a:t>Click to add title</a:t>
            </a: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19" hasCustomPrompt="1"/>
          </p:nvPr>
        </p:nvSpPr>
        <p:spPr>
          <a:xfrm>
            <a:off x="571502" y="1693863"/>
            <a:ext cx="10655300" cy="304800"/>
          </a:xfrm>
        </p:spPr>
        <p:txBody>
          <a:bodyPr/>
          <a:lstStyle>
            <a:lvl1pPr>
              <a:lnSpc>
                <a:spcPct val="80000"/>
              </a:lnSpc>
              <a:defRPr baseline="0"/>
            </a:lvl1pPr>
          </a:lstStyle>
          <a:p>
            <a:pPr lvl="0"/>
            <a:r>
              <a:rPr lang="fr-FR"/>
              <a:t>First level</a:t>
            </a:r>
            <a:endParaRPr lang="en-US"/>
          </a:p>
        </p:txBody>
      </p:sp>
      <p:sp>
        <p:nvSpPr>
          <p:cNvPr id="10" name="Espace réservé du texte 7"/>
          <p:cNvSpPr>
            <a:spLocks noGrp="1"/>
          </p:cNvSpPr>
          <p:nvPr>
            <p:ph type="body" sz="quarter" idx="20" hasCustomPrompt="1"/>
          </p:nvPr>
        </p:nvSpPr>
        <p:spPr>
          <a:xfrm>
            <a:off x="6161663" y="4034846"/>
            <a:ext cx="4430139" cy="1605199"/>
          </a:xfrm>
          <a:solidFill>
            <a:schemeClr val="accent1"/>
          </a:solidFill>
          <a:effectLst>
            <a:outerShdw dist="355600" algn="ctr" rotWithShape="0">
              <a:srgbClr val="8760A2"/>
            </a:outerShdw>
          </a:effectLst>
        </p:spPr>
        <p:txBody>
          <a:bodyPr anchor="ctr"/>
          <a:lstStyle>
            <a:lvl1pPr marL="232828" indent="0">
              <a:buFont typeface="+mj-lt"/>
              <a:buNone/>
              <a:defRPr b="0">
                <a:solidFill>
                  <a:schemeClr val="bg1"/>
                </a:solidFill>
              </a:defRPr>
            </a:lvl1pPr>
          </a:lstStyle>
          <a:p>
            <a:pPr lvl="0"/>
            <a:r>
              <a:rPr lang="fr-FR"/>
              <a:t>Click to add text</a:t>
            </a:r>
          </a:p>
        </p:txBody>
      </p:sp>
      <p:sp>
        <p:nvSpPr>
          <p:cNvPr id="16" name="Espace réservé du texte 5"/>
          <p:cNvSpPr>
            <a:spLocks noGrp="1"/>
          </p:cNvSpPr>
          <p:nvPr>
            <p:ph type="body" sz="quarter" idx="21" hasCustomPrompt="1"/>
          </p:nvPr>
        </p:nvSpPr>
        <p:spPr>
          <a:xfrm>
            <a:off x="571501" y="2209800"/>
            <a:ext cx="5232952" cy="3796467"/>
          </a:xfrm>
        </p:spPr>
        <p:txBody>
          <a:bodyPr numCol="1" spcCol="180000"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18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180602912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 + graphi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noProof="0"/>
              <a:t>Click to add title</a:t>
            </a:r>
            <a:endParaRPr lang="en-US"/>
          </a:p>
        </p:txBody>
      </p:sp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2" y="1652400"/>
            <a:ext cx="4914900" cy="4320000"/>
          </a:xfrm>
        </p:spPr>
        <p:txBody>
          <a:bodyPr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0"/>
            <a:r>
              <a:rPr lang="fr-FR" noProof="0"/>
              <a:t>First </a:t>
            </a:r>
            <a:r>
              <a:rPr lang="fr-FR" noProof="0" err="1"/>
              <a:t>level</a:t>
            </a:r>
            <a:endParaRPr lang="en-US" noProof="0"/>
          </a:p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7" name="Espace réservé du texte 7"/>
          <p:cNvSpPr>
            <a:spLocks noGrp="1"/>
          </p:cNvSpPr>
          <p:nvPr>
            <p:ph type="body" sz="quarter" idx="19" hasCustomPrompt="1"/>
          </p:nvPr>
        </p:nvSpPr>
        <p:spPr>
          <a:xfrm>
            <a:off x="6161663" y="5186127"/>
            <a:ext cx="4916023" cy="576499"/>
          </a:xfrm>
          <a:solidFill>
            <a:schemeClr val="accent1"/>
          </a:solidFill>
          <a:effectLst/>
        </p:spPr>
        <p:txBody>
          <a:bodyPr lIns="72000" tIns="72000" rIns="72000" bIns="72000" anchor="ctr"/>
          <a:lstStyle>
            <a:lvl1pPr marL="4233" indent="0" algn="ctr">
              <a:buFont typeface="+mj-lt"/>
              <a:buNone/>
              <a:defRPr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fr-FR"/>
              <a:t>Click to add text</a:t>
            </a:r>
          </a:p>
        </p:txBody>
      </p:sp>
      <p:sp>
        <p:nvSpPr>
          <p:cNvPr id="8" name="Espace réservé du graphique 6"/>
          <p:cNvSpPr>
            <a:spLocks noGrp="1"/>
          </p:cNvSpPr>
          <p:nvPr>
            <p:ph type="chart" sz="quarter" idx="20" hasCustomPrompt="1"/>
          </p:nvPr>
        </p:nvSpPr>
        <p:spPr>
          <a:xfrm>
            <a:off x="6161661" y="1990726"/>
            <a:ext cx="4916024" cy="3000375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Graphic</a:t>
            </a:r>
            <a:endParaRPr lang="en-US"/>
          </a:p>
        </p:txBody>
      </p:sp>
      <p:sp>
        <p:nvSpPr>
          <p:cNvPr id="11" name="Espace réservé du texte 10"/>
          <p:cNvSpPr>
            <a:spLocks noGrp="1"/>
          </p:cNvSpPr>
          <p:nvPr>
            <p:ph type="body" sz="quarter" idx="21" hasCustomPrompt="1"/>
          </p:nvPr>
        </p:nvSpPr>
        <p:spPr>
          <a:xfrm>
            <a:off x="6161663" y="1652589"/>
            <a:ext cx="4916972" cy="338137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Title of graphic</a:t>
            </a:r>
          </a:p>
        </p:txBody>
      </p:sp>
      <p:sp>
        <p:nvSpPr>
          <p:cNvPr id="13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5" name="Espace réservé du texte 4"/>
          <p:cNvSpPr>
            <a:spLocks noGrp="1"/>
          </p:cNvSpPr>
          <p:nvPr>
            <p:ph type="body" sz="quarter" idx="17" hasCustomPrompt="1"/>
          </p:nvPr>
        </p:nvSpPr>
        <p:spPr>
          <a:xfrm>
            <a:off x="2060350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cxnSp>
        <p:nvCxnSpPr>
          <p:cNvPr id="16" name="Connecteur droit 15"/>
          <p:cNvCxnSpPr/>
          <p:nvPr userDrawn="1"/>
        </p:nvCxnSpPr>
        <p:spPr>
          <a:xfrm>
            <a:off x="1928531" y="797857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159449531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 + graphic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noProof="0"/>
              <a:t>Click to add title</a:t>
            </a:r>
            <a:endParaRPr lang="en-US"/>
          </a:p>
        </p:txBody>
      </p:sp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2" y="1652400"/>
            <a:ext cx="4914900" cy="4320000"/>
          </a:xfrm>
        </p:spPr>
        <p:txBody>
          <a:bodyPr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0"/>
            <a:r>
              <a:rPr lang="fr-FR" noProof="0"/>
              <a:t>First </a:t>
            </a:r>
            <a:r>
              <a:rPr lang="fr-FR" noProof="0" err="1"/>
              <a:t>level</a:t>
            </a:r>
            <a:endParaRPr lang="en-US" noProof="0"/>
          </a:p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7" name="Espace réservé du texte 7"/>
          <p:cNvSpPr>
            <a:spLocks noGrp="1"/>
          </p:cNvSpPr>
          <p:nvPr>
            <p:ph type="body" sz="quarter" idx="19" hasCustomPrompt="1"/>
          </p:nvPr>
        </p:nvSpPr>
        <p:spPr>
          <a:xfrm>
            <a:off x="6161663" y="5186127"/>
            <a:ext cx="4916023" cy="576499"/>
          </a:xfrm>
          <a:solidFill>
            <a:schemeClr val="accent1"/>
          </a:solidFill>
          <a:effectLst/>
        </p:spPr>
        <p:txBody>
          <a:bodyPr lIns="72000" tIns="72000" rIns="72000" bIns="72000" anchor="ctr"/>
          <a:lstStyle>
            <a:lvl1pPr marL="4233" indent="0" algn="ctr">
              <a:buFont typeface="+mj-lt"/>
              <a:buNone/>
              <a:defRPr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fr-FR"/>
              <a:t>Click to add text</a:t>
            </a:r>
          </a:p>
        </p:txBody>
      </p:sp>
      <p:sp>
        <p:nvSpPr>
          <p:cNvPr id="8" name="Espace réservé du graphique 6"/>
          <p:cNvSpPr>
            <a:spLocks noGrp="1"/>
          </p:cNvSpPr>
          <p:nvPr>
            <p:ph type="chart" sz="quarter" idx="20" hasCustomPrompt="1"/>
          </p:nvPr>
        </p:nvSpPr>
        <p:spPr>
          <a:xfrm>
            <a:off x="6161661" y="1990726"/>
            <a:ext cx="4916024" cy="3000375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Graphic</a:t>
            </a:r>
            <a:endParaRPr lang="en-US"/>
          </a:p>
        </p:txBody>
      </p:sp>
      <p:sp>
        <p:nvSpPr>
          <p:cNvPr id="11" name="Espace réservé du texte 10"/>
          <p:cNvSpPr>
            <a:spLocks noGrp="1"/>
          </p:cNvSpPr>
          <p:nvPr>
            <p:ph type="body" sz="quarter" idx="21" hasCustomPrompt="1"/>
          </p:nvPr>
        </p:nvSpPr>
        <p:spPr>
          <a:xfrm>
            <a:off x="6161663" y="1652589"/>
            <a:ext cx="4916972" cy="338137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fr-FR"/>
              <a:t>Title of graphic</a:t>
            </a:r>
          </a:p>
        </p:txBody>
      </p:sp>
      <p:sp>
        <p:nvSpPr>
          <p:cNvPr id="13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7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3918731588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 +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ck to add title</a:t>
            </a:r>
            <a:endParaRPr lang="en-US"/>
          </a:p>
        </p:txBody>
      </p:sp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6016028" y="1652400"/>
            <a:ext cx="5197520" cy="4320000"/>
          </a:xfrm>
        </p:spPr>
        <p:txBody>
          <a:bodyPr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0"/>
            <a:r>
              <a:rPr lang="fr-FR" noProof="0"/>
              <a:t>First </a:t>
            </a:r>
            <a:r>
              <a:rPr lang="fr-FR" noProof="0" err="1"/>
              <a:t>level</a:t>
            </a:r>
            <a:endParaRPr lang="en-US" noProof="0"/>
          </a:p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9" name="Espace réservé pour une image  8"/>
          <p:cNvSpPr>
            <a:spLocks noGrp="1"/>
          </p:cNvSpPr>
          <p:nvPr>
            <p:ph type="pic" sz="quarter" idx="19" hasCustomPrompt="1"/>
          </p:nvPr>
        </p:nvSpPr>
        <p:spPr>
          <a:xfrm>
            <a:off x="571500" y="1652589"/>
            <a:ext cx="5181600" cy="4319587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Picture</a:t>
            </a:r>
          </a:p>
        </p:txBody>
      </p:sp>
      <p:sp>
        <p:nvSpPr>
          <p:cNvPr id="12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4" name="Espace réservé du texte 4"/>
          <p:cNvSpPr>
            <a:spLocks noGrp="1"/>
          </p:cNvSpPr>
          <p:nvPr>
            <p:ph type="body" sz="quarter" idx="17" hasCustomPrompt="1"/>
          </p:nvPr>
        </p:nvSpPr>
        <p:spPr>
          <a:xfrm>
            <a:off x="2060357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cxnSp>
        <p:nvCxnSpPr>
          <p:cNvPr id="15" name="Connecteur droit 14"/>
          <p:cNvCxnSpPr/>
          <p:nvPr userDrawn="1"/>
        </p:nvCxnSpPr>
        <p:spPr>
          <a:xfrm>
            <a:off x="1928537" y="797857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162125274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 column + picture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ck to add title</a:t>
            </a:r>
            <a:endParaRPr lang="en-US"/>
          </a:p>
        </p:txBody>
      </p:sp>
      <p:sp>
        <p:nvSpPr>
          <p:cNvPr id="6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6016028" y="1652400"/>
            <a:ext cx="5197520" cy="4320000"/>
          </a:xfrm>
        </p:spPr>
        <p:txBody>
          <a:bodyPr/>
          <a:lstStyle>
            <a:lvl2pPr>
              <a:defRPr/>
            </a:lvl2pPr>
            <a:lvl4pPr>
              <a:defRPr/>
            </a:lvl4pPr>
            <a:lvl5pPr>
              <a:defRPr/>
            </a:lvl5pPr>
          </a:lstStyle>
          <a:p>
            <a:pPr lvl="0"/>
            <a:r>
              <a:rPr lang="fr-FR" noProof="0"/>
              <a:t>First </a:t>
            </a:r>
            <a:r>
              <a:rPr lang="fr-FR" noProof="0" err="1"/>
              <a:t>level</a:t>
            </a:r>
            <a:endParaRPr lang="en-US" noProof="0"/>
          </a:p>
          <a:p>
            <a:pPr lvl="1"/>
            <a:r>
              <a:rPr lang="fr-FR"/>
              <a:t>Second </a:t>
            </a:r>
            <a:r>
              <a:rPr lang="fr-FR" err="1"/>
              <a:t>level</a:t>
            </a:r>
            <a:endParaRPr lang="fr-FR"/>
          </a:p>
          <a:p>
            <a:pPr lvl="2"/>
            <a:r>
              <a:rPr lang="fr-FR" err="1"/>
              <a:t>Third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3"/>
            <a:r>
              <a:rPr lang="fr-FR" err="1"/>
              <a:t>Fourth</a:t>
            </a:r>
            <a:r>
              <a:rPr lang="fr-FR"/>
              <a:t> </a:t>
            </a:r>
            <a:r>
              <a:rPr lang="fr-FR" err="1"/>
              <a:t>level</a:t>
            </a:r>
            <a:endParaRPr lang="fr-FR"/>
          </a:p>
          <a:p>
            <a:pPr lvl="4"/>
            <a:r>
              <a:rPr lang="fr-FR" err="1"/>
              <a:t>Fifth</a:t>
            </a:r>
            <a:r>
              <a:rPr lang="fr-FR"/>
              <a:t> </a:t>
            </a:r>
            <a:r>
              <a:rPr lang="fr-FR" err="1"/>
              <a:t>level</a:t>
            </a:r>
            <a:endParaRPr lang="en-US"/>
          </a:p>
        </p:txBody>
      </p:sp>
      <p:sp>
        <p:nvSpPr>
          <p:cNvPr id="9" name="Espace réservé pour une image  8"/>
          <p:cNvSpPr>
            <a:spLocks noGrp="1"/>
          </p:cNvSpPr>
          <p:nvPr>
            <p:ph type="pic" sz="quarter" idx="19" hasCustomPrompt="1"/>
          </p:nvPr>
        </p:nvSpPr>
        <p:spPr>
          <a:xfrm>
            <a:off x="571500" y="1652589"/>
            <a:ext cx="5181600" cy="4319587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Picture</a:t>
            </a:r>
          </a:p>
        </p:txBody>
      </p:sp>
      <p:sp>
        <p:nvSpPr>
          <p:cNvPr id="12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3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25040104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fr-FR"/>
              <a:t>Click to add title</a:t>
            </a:r>
            <a:endParaRPr lang="en-US"/>
          </a:p>
        </p:txBody>
      </p:sp>
      <p:sp>
        <p:nvSpPr>
          <p:cNvPr id="7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1" y="1660700"/>
            <a:ext cx="10803467" cy="399875"/>
          </a:xfrm>
        </p:spPr>
        <p:txBody>
          <a:bodyPr/>
          <a:lstStyle>
            <a:lvl1pPr>
              <a:defRPr sz="2133" b="1">
                <a:solidFill>
                  <a:schemeClr val="tx2"/>
                </a:solidFill>
              </a:defRPr>
            </a:lvl1pPr>
          </a:lstStyle>
          <a:p>
            <a:pPr lvl="0"/>
            <a:r>
              <a:rPr lang="en-US" noProof="0"/>
              <a:t>Chart title</a:t>
            </a:r>
          </a:p>
        </p:txBody>
      </p:sp>
      <p:sp>
        <p:nvSpPr>
          <p:cNvPr id="8" name="Espace réservé du graphique 14"/>
          <p:cNvSpPr>
            <a:spLocks noGrp="1"/>
          </p:cNvSpPr>
          <p:nvPr>
            <p:ph type="chart" sz="quarter" idx="19" hasCustomPrompt="1"/>
          </p:nvPr>
        </p:nvSpPr>
        <p:spPr>
          <a:xfrm>
            <a:off x="571501" y="2060576"/>
            <a:ext cx="10803467" cy="3719513"/>
          </a:xfrm>
        </p:spPr>
        <p:txBody>
          <a:bodyPr/>
          <a:lstStyle>
            <a:lvl1pPr>
              <a:defRPr lang="en-US" sz="2133" b="1" kern="1200" baseline="0" noProof="0" dirty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lang="en-US" noProof="0"/>
              <a:t>Chart</a:t>
            </a:r>
          </a:p>
        </p:txBody>
      </p:sp>
      <p:sp>
        <p:nvSpPr>
          <p:cNvPr id="12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3" name="Espace réservé du texte 4"/>
          <p:cNvSpPr>
            <a:spLocks noGrp="1"/>
          </p:cNvSpPr>
          <p:nvPr>
            <p:ph type="body" sz="quarter" idx="17" hasCustomPrompt="1"/>
          </p:nvPr>
        </p:nvSpPr>
        <p:spPr>
          <a:xfrm>
            <a:off x="2060347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cxnSp>
        <p:nvCxnSpPr>
          <p:cNvPr id="14" name="Connecteur droit 13"/>
          <p:cNvCxnSpPr/>
          <p:nvPr userDrawn="1"/>
        </p:nvCxnSpPr>
        <p:spPr>
          <a:xfrm>
            <a:off x="1928529" y="797857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211027744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fr-FR"/>
              <a:t>Click to add title</a:t>
            </a:r>
            <a:endParaRPr lang="en-US"/>
          </a:p>
        </p:txBody>
      </p:sp>
      <p:sp>
        <p:nvSpPr>
          <p:cNvPr id="7" name="Espace réservé du texte 5"/>
          <p:cNvSpPr>
            <a:spLocks noGrp="1"/>
          </p:cNvSpPr>
          <p:nvPr>
            <p:ph type="body" sz="quarter" idx="18" hasCustomPrompt="1"/>
          </p:nvPr>
        </p:nvSpPr>
        <p:spPr>
          <a:xfrm>
            <a:off x="571501" y="1660700"/>
            <a:ext cx="10803467" cy="399875"/>
          </a:xfrm>
        </p:spPr>
        <p:txBody>
          <a:bodyPr/>
          <a:lstStyle>
            <a:lvl1pPr>
              <a:defRPr sz="2133" b="1">
                <a:solidFill>
                  <a:schemeClr val="tx2"/>
                </a:solidFill>
              </a:defRPr>
            </a:lvl1pPr>
          </a:lstStyle>
          <a:p>
            <a:pPr lvl="0"/>
            <a:r>
              <a:rPr lang="en-US" noProof="0"/>
              <a:t>Chart title</a:t>
            </a:r>
          </a:p>
        </p:txBody>
      </p:sp>
      <p:sp>
        <p:nvSpPr>
          <p:cNvPr id="8" name="Espace réservé du graphique 14"/>
          <p:cNvSpPr>
            <a:spLocks noGrp="1"/>
          </p:cNvSpPr>
          <p:nvPr>
            <p:ph type="chart" sz="quarter" idx="19" hasCustomPrompt="1"/>
          </p:nvPr>
        </p:nvSpPr>
        <p:spPr>
          <a:xfrm>
            <a:off x="571501" y="2060576"/>
            <a:ext cx="10803467" cy="3719513"/>
          </a:xfrm>
        </p:spPr>
        <p:txBody>
          <a:bodyPr/>
          <a:lstStyle>
            <a:lvl1pPr>
              <a:defRPr lang="en-US" sz="2133" b="1" kern="1200" baseline="0" noProof="0" dirty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lang="en-US" noProof="0"/>
              <a:t>Chart</a:t>
            </a:r>
          </a:p>
        </p:txBody>
      </p:sp>
      <p:sp>
        <p:nvSpPr>
          <p:cNvPr id="12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5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236398256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3"/>
          <p:cNvSpPr>
            <a:spLocks noGrp="1"/>
          </p:cNvSpPr>
          <p:nvPr>
            <p:ph type="title" hasCustomPrompt="1"/>
          </p:nvPr>
        </p:nvSpPr>
        <p:spPr>
          <a:xfrm>
            <a:off x="1573097" y="1616330"/>
            <a:ext cx="10558688" cy="2146047"/>
          </a:xfrm>
        </p:spPr>
        <p:txBody>
          <a:bodyPr/>
          <a:lstStyle>
            <a:lvl1pPr algn="r">
              <a:lnSpc>
                <a:spcPct val="92000"/>
              </a:lnSpc>
              <a:defRPr sz="5333"/>
            </a:lvl1pPr>
          </a:lstStyle>
          <a:p>
            <a:r>
              <a:rPr lang="en-US" noProof="0"/>
              <a:t>Click to add text</a:t>
            </a:r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1114426" y="6415089"/>
            <a:ext cx="4902061" cy="297656"/>
          </a:xfrm>
        </p:spPr>
        <p:txBody>
          <a:bodyPr/>
          <a:lstStyle>
            <a:lvl1pPr>
              <a:spcBef>
                <a:spcPts val="133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fr-FR" sz="800"/>
              <a:t>Footer</a:t>
            </a:r>
          </a:p>
        </p:txBody>
      </p:sp>
    </p:spTree>
    <p:extLst>
      <p:ext uri="{BB962C8B-B14F-4D97-AF65-F5344CB8AC3E}">
        <p14:creationId xmlns:p14="http://schemas.microsoft.com/office/powerpoint/2010/main" val="583405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B06D1D-21AA-4811-948B-D2BFC5947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85A5A8-8D51-4841-A97A-4EF804878B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B68DB5-B47A-440D-BEE3-1A8B6E0B4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16756F-E0D9-4500-89BF-8879C6A66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914EFC-FBCC-42F9-8AE4-C6456EEE0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632673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estio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 userDrawn="1"/>
        </p:nvSpPr>
        <p:spPr>
          <a:xfrm>
            <a:off x="1810069" y="943943"/>
            <a:ext cx="10457991" cy="2359557"/>
          </a:xfrm>
          <a:prstGeom prst="rect">
            <a:avLst/>
          </a:prstGeom>
        </p:spPr>
        <p:txBody>
          <a:bodyPr vert="horz" wrap="none" lIns="0" tIns="0" rIns="0" bIns="0" rtlCol="0">
            <a:spAutoFit/>
          </a:bodyPr>
          <a:lstStyle/>
          <a:p>
            <a:pPr algn="r"/>
            <a:r>
              <a:rPr lang="fr-FR" sz="15333" b="0" spc="400" baseline="0">
                <a:solidFill>
                  <a:schemeClr val="tx2"/>
                </a:solidFill>
              </a:rPr>
              <a:t>Questions?</a:t>
            </a:r>
            <a:endParaRPr lang="en-US" sz="15333" b="0" spc="400" baseline="0">
              <a:solidFill>
                <a:schemeClr val="tx2"/>
              </a:solidFill>
            </a:endParaRPr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78417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hank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8801989" y="0"/>
            <a:ext cx="2577211" cy="6260339"/>
          </a:xfrm>
          <a:prstGeom prst="rect">
            <a:avLst/>
          </a:prstGeom>
          <a:solidFill>
            <a:srgbClr val="8760A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9" name="Rectangle 8"/>
          <p:cNvSpPr/>
          <p:nvPr userDrawn="1"/>
        </p:nvSpPr>
        <p:spPr>
          <a:xfrm>
            <a:off x="11379200" y="0"/>
            <a:ext cx="822045" cy="6260339"/>
          </a:xfrm>
          <a:prstGeom prst="rect">
            <a:avLst/>
          </a:prstGeom>
          <a:solidFill>
            <a:srgbClr val="512C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10" name="Rectangle 9"/>
          <p:cNvSpPr/>
          <p:nvPr userDrawn="1"/>
        </p:nvSpPr>
        <p:spPr>
          <a:xfrm>
            <a:off x="8318501" y="0"/>
            <a:ext cx="483488" cy="6260339"/>
          </a:xfrm>
          <a:prstGeom prst="rect">
            <a:avLst/>
          </a:prstGeom>
          <a:solidFill>
            <a:srgbClr val="512C7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/>
          </a:p>
        </p:txBody>
      </p:sp>
      <p:sp>
        <p:nvSpPr>
          <p:cNvPr id="11" name="Rectangle 10"/>
          <p:cNvSpPr/>
          <p:nvPr userDrawn="1"/>
        </p:nvSpPr>
        <p:spPr>
          <a:xfrm>
            <a:off x="-1" y="0"/>
            <a:ext cx="8318503" cy="626033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 noProof="0">
              <a:solidFill>
                <a:schemeClr val="accent1">
                  <a:lumMod val="20000"/>
                  <a:lumOff val="80000"/>
                </a:schemeClr>
              </a:solidFill>
            </a:endParaRPr>
          </a:p>
        </p:txBody>
      </p:sp>
      <p:pic>
        <p:nvPicPr>
          <p:cNvPr id="13" name="Image 12"/>
          <p:cNvPicPr>
            <a:picLocks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2575" y="6412641"/>
            <a:ext cx="297484" cy="295875"/>
          </a:xfrm>
          <a:prstGeom prst="rect">
            <a:avLst/>
          </a:prstGeom>
        </p:spPr>
      </p:pic>
      <p:sp>
        <p:nvSpPr>
          <p:cNvPr id="14" name="Titre 3"/>
          <p:cNvSpPr>
            <a:spLocks noGrp="1"/>
          </p:cNvSpPr>
          <p:nvPr>
            <p:ph type="title" hasCustomPrompt="1"/>
          </p:nvPr>
        </p:nvSpPr>
        <p:spPr>
          <a:xfrm>
            <a:off x="395111" y="1091399"/>
            <a:ext cx="11736675" cy="2146047"/>
          </a:xfrm>
        </p:spPr>
        <p:txBody>
          <a:bodyPr/>
          <a:lstStyle>
            <a:lvl1pPr marL="0" algn="r" defTabSz="1219170" rtl="0" eaLnBrk="1" latinLnBrk="0" hangingPunct="1">
              <a:lnSpc>
                <a:spcPct val="92000"/>
              </a:lnSpc>
              <a:defRPr lang="en-US" sz="15333" b="0" kern="1200" spc="400" baseline="0" noProof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</a:lstStyle>
          <a:p>
            <a:r>
              <a:rPr lang="en-US" noProof="0"/>
              <a:t>Click text</a:t>
            </a:r>
          </a:p>
        </p:txBody>
      </p:sp>
    </p:spTree>
    <p:extLst>
      <p:ext uri="{BB962C8B-B14F-4D97-AF65-F5344CB8AC3E}">
        <p14:creationId xmlns:p14="http://schemas.microsoft.com/office/powerpoint/2010/main" val="3981140140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-Paste slide without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8819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-Paste slide with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Espace réservé du texte 4"/>
          <p:cNvSpPr>
            <a:spLocks noGrp="1"/>
          </p:cNvSpPr>
          <p:nvPr>
            <p:ph type="body" sz="quarter" idx="17" hasCustomPrompt="1"/>
          </p:nvPr>
        </p:nvSpPr>
        <p:spPr>
          <a:xfrm>
            <a:off x="2053997" y="723432"/>
            <a:ext cx="6931620" cy="615553"/>
          </a:xfrm>
        </p:spPr>
        <p:txBody>
          <a:bodyPr anchor="ctr">
            <a:noAutofit/>
          </a:bodyPr>
          <a:lstStyle>
            <a:lvl1pPr>
              <a:spcBef>
                <a:spcPts val="0"/>
              </a:spcBef>
              <a:defRPr sz="24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subtitle</a:t>
            </a:r>
          </a:p>
        </p:txBody>
      </p:sp>
      <p:cxnSp>
        <p:nvCxnSpPr>
          <p:cNvPr id="7" name="Connecteur droit 6"/>
          <p:cNvCxnSpPr/>
          <p:nvPr userDrawn="1"/>
        </p:nvCxnSpPr>
        <p:spPr>
          <a:xfrm>
            <a:off x="1930527" y="840055"/>
            <a:ext cx="0" cy="459443"/>
          </a:xfrm>
          <a:prstGeom prst="line">
            <a:avLst/>
          </a:prstGeom>
          <a:ln w="38100">
            <a:solidFill>
              <a:schemeClr val="tx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52366554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, Content &amp; Foo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13">
            <a:extLst>
              <a:ext uri="{FF2B5EF4-FFF2-40B4-BE49-F238E27FC236}">
                <a16:creationId xmlns:a16="http://schemas.microsoft.com/office/drawing/2014/main" id="{9E53DD18-5A49-47B7-B46C-80352C64AE29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23316" y="1179773"/>
            <a:ext cx="10945368" cy="5084064"/>
          </a:xfrm>
        </p:spPr>
        <p:txBody>
          <a:bodyPr>
            <a:no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12" name="Title Placeholder 1">
            <a:extLst>
              <a:ext uri="{FF2B5EF4-FFF2-40B4-BE49-F238E27FC236}">
                <a16:creationId xmlns:a16="http://schemas.microsoft.com/office/drawing/2014/main" id="{F8251BDC-1AC3-4254-B4BD-37C6AC6B7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316" y="132251"/>
            <a:ext cx="10945368" cy="731520"/>
          </a:xfrm>
          <a:prstGeom prst="rect">
            <a:avLst/>
          </a:prstGeom>
        </p:spPr>
        <p:txBody>
          <a:bodyPr vert="horz" lIns="0" tIns="0" rIns="0" bIns="0" rtlCol="0" anchor="b">
            <a:no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13" name="Footer Placeholder 3">
            <a:extLst>
              <a:ext uri="{FF2B5EF4-FFF2-40B4-BE49-F238E27FC236}">
                <a16:creationId xmlns:a16="http://schemas.microsoft.com/office/drawing/2014/main" id="{75D4C91B-4945-4DF8-A0A7-99F83EC6AF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018923" y="6329639"/>
            <a:ext cx="9345168" cy="228600"/>
          </a:xfrm>
          <a:prstGeom prst="rect">
            <a:avLst/>
          </a:prstGeom>
        </p:spPr>
        <p:txBody>
          <a:bodyPr vert="horz" lIns="0" tIns="0" rIns="0" bIns="0" rtlCol="0" anchor="b">
            <a:noAutofit/>
          </a:bodyPr>
          <a:lstStyle>
            <a:lvl1pPr algn="l">
              <a:defRPr sz="800">
                <a:solidFill>
                  <a:srgbClr val="414042"/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8AE97515-581B-4C46-A57A-05C497ADAC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520728" y="6384427"/>
            <a:ext cx="457200" cy="182880"/>
          </a:xfrm>
          <a:prstGeom prst="rect">
            <a:avLst/>
          </a:prstGeom>
        </p:spPr>
        <p:txBody>
          <a:bodyPr vert="horz" lIns="0" tIns="0" rIns="0" bIns="0" rtlCol="0" anchor="b">
            <a:noAutofit/>
          </a:bodyPr>
          <a:lstStyle>
            <a:lvl1pPr algn="r">
              <a:defRPr sz="1000">
                <a:solidFill>
                  <a:schemeClr val="tx2"/>
                </a:solidFill>
              </a:defRPr>
            </a:lvl1pPr>
          </a:lstStyle>
          <a:p>
            <a:fld id="{2EF7994B-2F41-4DA7-80CE-1AD3EA3D5345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8064139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&amp;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ontent Placeholder 13">
            <a:extLst>
              <a:ext uri="{FF2B5EF4-FFF2-40B4-BE49-F238E27FC236}">
                <a16:creationId xmlns:a16="http://schemas.microsoft.com/office/drawing/2014/main" id="{B24D8683-0333-43E1-A407-CEA1192D2252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23316" y="1180392"/>
            <a:ext cx="10945368" cy="5084064"/>
          </a:xfrm>
        </p:spPr>
        <p:txBody>
          <a:bodyPr>
            <a:noAutofit/>
          </a:bodyPr>
          <a:lstStyle>
            <a:lvl1pPr marL="274306">
              <a:defRPr/>
            </a:lvl1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12" name="Title Placeholder 1">
            <a:extLst>
              <a:ext uri="{FF2B5EF4-FFF2-40B4-BE49-F238E27FC236}">
                <a16:creationId xmlns:a16="http://schemas.microsoft.com/office/drawing/2014/main" id="{26E33ECE-0206-48D7-A6B4-F7A407F991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316" y="132251"/>
            <a:ext cx="10945368" cy="731520"/>
          </a:xfrm>
          <a:prstGeom prst="rect">
            <a:avLst/>
          </a:prstGeom>
        </p:spPr>
        <p:txBody>
          <a:bodyPr vert="horz" lIns="0" tIns="0" rIns="0" bIns="0" rtlCol="0" anchor="b">
            <a:no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39B04B03-ECAF-429D-9FE3-F0F443F10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520728" y="6384427"/>
            <a:ext cx="457200" cy="182880"/>
          </a:xfrm>
          <a:prstGeom prst="rect">
            <a:avLst/>
          </a:prstGeom>
        </p:spPr>
        <p:txBody>
          <a:bodyPr vert="horz" lIns="0" tIns="0" rIns="0" bIns="0" rtlCol="0" anchor="b">
            <a:noAutofit/>
          </a:bodyPr>
          <a:lstStyle>
            <a:lvl1pPr algn="r">
              <a:defRPr sz="1000">
                <a:solidFill>
                  <a:schemeClr val="tx2"/>
                </a:solidFill>
              </a:defRPr>
            </a:lvl1pPr>
          </a:lstStyle>
          <a:p>
            <a:fld id="{2EF7994B-2F41-4DA7-80CE-1AD3EA3D5345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37060694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icture Placeholder 64">
            <a:extLst>
              <a:ext uri="{FF2B5EF4-FFF2-40B4-BE49-F238E27FC236}">
                <a16:creationId xmlns:a16="http://schemas.microsoft.com/office/drawing/2014/main" id="{B8D670EA-1E47-EE44-9859-BF14C627EA3B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8" y="4"/>
            <a:ext cx="12191993" cy="6857996"/>
          </a:xfrm>
          <a:custGeom>
            <a:avLst/>
            <a:gdLst>
              <a:gd name="connsiteX0" fmla="*/ 3578903 w 12191993"/>
              <a:gd name="connsiteY0" fmla="*/ 6416506 h 6857996"/>
              <a:gd name="connsiteX1" fmla="*/ 3578903 w 12191993"/>
              <a:gd name="connsiteY1" fmla="*/ 6449909 h 6857996"/>
              <a:gd name="connsiteX2" fmla="*/ 3611987 w 12191993"/>
              <a:gd name="connsiteY2" fmla="*/ 6449909 h 6857996"/>
              <a:gd name="connsiteX3" fmla="*/ 3611987 w 12191993"/>
              <a:gd name="connsiteY3" fmla="*/ 6416506 h 6857996"/>
              <a:gd name="connsiteX4" fmla="*/ 3481994 w 12191993"/>
              <a:gd name="connsiteY4" fmla="*/ 6306894 h 6857996"/>
              <a:gd name="connsiteX5" fmla="*/ 3521564 w 12191993"/>
              <a:gd name="connsiteY5" fmla="*/ 6348729 h 6857996"/>
              <a:gd name="connsiteX6" fmla="*/ 3433990 w 12191993"/>
              <a:gd name="connsiteY6" fmla="*/ 6348729 h 6857996"/>
              <a:gd name="connsiteX7" fmla="*/ 3481994 w 12191993"/>
              <a:gd name="connsiteY7" fmla="*/ 6306894 h 6857996"/>
              <a:gd name="connsiteX8" fmla="*/ 2971631 w 12191993"/>
              <a:gd name="connsiteY8" fmla="*/ 6306894 h 6857996"/>
              <a:gd name="connsiteX9" fmla="*/ 3011201 w 12191993"/>
              <a:gd name="connsiteY9" fmla="*/ 6348729 h 6857996"/>
              <a:gd name="connsiteX10" fmla="*/ 2923627 w 12191993"/>
              <a:gd name="connsiteY10" fmla="*/ 6348729 h 6857996"/>
              <a:gd name="connsiteX11" fmla="*/ 2971631 w 12191993"/>
              <a:gd name="connsiteY11" fmla="*/ 6306894 h 6857996"/>
              <a:gd name="connsiteX12" fmla="*/ 2218851 w 12191993"/>
              <a:gd name="connsiteY12" fmla="*/ 6297163 h 6857996"/>
              <a:gd name="connsiteX13" fmla="*/ 2275288 w 12191993"/>
              <a:gd name="connsiteY13" fmla="*/ 6368835 h 6857996"/>
              <a:gd name="connsiteX14" fmla="*/ 2217552 w 12191993"/>
              <a:gd name="connsiteY14" fmla="*/ 6440507 h 6857996"/>
              <a:gd name="connsiteX15" fmla="*/ 2161116 w 12191993"/>
              <a:gd name="connsiteY15" fmla="*/ 6369160 h 6857996"/>
              <a:gd name="connsiteX16" fmla="*/ 2218851 w 12191993"/>
              <a:gd name="connsiteY16" fmla="*/ 6297163 h 6857996"/>
              <a:gd name="connsiteX17" fmla="*/ 1782667 w 12191993"/>
              <a:gd name="connsiteY17" fmla="*/ 6296514 h 6857996"/>
              <a:gd name="connsiteX18" fmla="*/ 1834887 w 12191993"/>
              <a:gd name="connsiteY18" fmla="*/ 6353915 h 6857996"/>
              <a:gd name="connsiteX19" fmla="*/ 1719416 w 12191993"/>
              <a:gd name="connsiteY19" fmla="*/ 6353915 h 6857996"/>
              <a:gd name="connsiteX20" fmla="*/ 1782667 w 12191993"/>
              <a:gd name="connsiteY20" fmla="*/ 6296514 h 6857996"/>
              <a:gd name="connsiteX21" fmla="*/ 2293320 w 12191993"/>
              <a:gd name="connsiteY21" fmla="*/ 6287757 h 6857996"/>
              <a:gd name="connsiteX22" fmla="*/ 2360462 w 12191993"/>
              <a:gd name="connsiteY22" fmla="*/ 6448936 h 6857996"/>
              <a:gd name="connsiteX23" fmla="*/ 2348783 w 12191993"/>
              <a:gd name="connsiteY23" fmla="*/ 6475855 h 6857996"/>
              <a:gd name="connsiteX24" fmla="*/ 2316996 w 12191993"/>
              <a:gd name="connsiteY24" fmla="*/ 6505042 h 6857996"/>
              <a:gd name="connsiteX25" fmla="*/ 2296883 w 12191993"/>
              <a:gd name="connsiteY25" fmla="*/ 6497259 h 6857996"/>
              <a:gd name="connsiteX26" fmla="*/ 2290722 w 12191993"/>
              <a:gd name="connsiteY26" fmla="*/ 6508934 h 6857996"/>
              <a:gd name="connsiteX27" fmla="*/ 2316996 w 12191993"/>
              <a:gd name="connsiteY27" fmla="*/ 6518015 h 6857996"/>
              <a:gd name="connsiteX28" fmla="*/ 2358190 w 12191993"/>
              <a:gd name="connsiteY28" fmla="*/ 6487853 h 6857996"/>
              <a:gd name="connsiteX29" fmla="*/ 2441550 w 12191993"/>
              <a:gd name="connsiteY29" fmla="*/ 6287757 h 6857996"/>
              <a:gd name="connsiteX30" fmla="*/ 2426956 w 12191993"/>
              <a:gd name="connsiteY30" fmla="*/ 6287757 h 6857996"/>
              <a:gd name="connsiteX31" fmla="*/ 2373434 w 12191993"/>
              <a:gd name="connsiteY31" fmla="*/ 6417155 h 6857996"/>
              <a:gd name="connsiteX32" fmla="*/ 2367922 w 12191993"/>
              <a:gd name="connsiteY32" fmla="*/ 6432396 h 6857996"/>
              <a:gd name="connsiteX33" fmla="*/ 2367272 w 12191993"/>
              <a:gd name="connsiteY33" fmla="*/ 6432396 h 6857996"/>
              <a:gd name="connsiteX34" fmla="*/ 2361429 w 12191993"/>
              <a:gd name="connsiteY34" fmla="*/ 6417155 h 6857996"/>
              <a:gd name="connsiteX35" fmla="*/ 2307914 w 12191993"/>
              <a:gd name="connsiteY35" fmla="*/ 6287757 h 6857996"/>
              <a:gd name="connsiteX36" fmla="*/ 1560161 w 12191993"/>
              <a:gd name="connsiteY36" fmla="*/ 6287757 h 6857996"/>
              <a:gd name="connsiteX37" fmla="*/ 1624058 w 12191993"/>
              <a:gd name="connsiteY37" fmla="*/ 6449909 h 6857996"/>
              <a:gd name="connsiteX38" fmla="*/ 1637032 w 12191993"/>
              <a:gd name="connsiteY38" fmla="*/ 6449909 h 6857996"/>
              <a:gd name="connsiteX39" fmla="*/ 1700608 w 12191993"/>
              <a:gd name="connsiteY39" fmla="*/ 6287757 h 6857996"/>
              <a:gd name="connsiteX40" fmla="*/ 1686334 w 12191993"/>
              <a:gd name="connsiteY40" fmla="*/ 6287757 h 6857996"/>
              <a:gd name="connsiteX41" fmla="*/ 1636383 w 12191993"/>
              <a:gd name="connsiteY41" fmla="*/ 6414887 h 6857996"/>
              <a:gd name="connsiteX42" fmla="*/ 1630868 w 12191993"/>
              <a:gd name="connsiteY42" fmla="*/ 6432396 h 6857996"/>
              <a:gd name="connsiteX43" fmla="*/ 1630218 w 12191993"/>
              <a:gd name="connsiteY43" fmla="*/ 6432396 h 6857996"/>
              <a:gd name="connsiteX44" fmla="*/ 1624707 w 12191993"/>
              <a:gd name="connsiteY44" fmla="*/ 6414887 h 6857996"/>
              <a:gd name="connsiteX45" fmla="*/ 1574755 w 12191993"/>
              <a:gd name="connsiteY45" fmla="*/ 6287757 h 6857996"/>
              <a:gd name="connsiteX46" fmla="*/ 1526463 w 12191993"/>
              <a:gd name="connsiteY46" fmla="*/ 6287757 h 6857996"/>
              <a:gd name="connsiteX47" fmla="*/ 1526463 w 12191993"/>
              <a:gd name="connsiteY47" fmla="*/ 6449909 h 6857996"/>
              <a:gd name="connsiteX48" fmla="*/ 1540087 w 12191993"/>
              <a:gd name="connsiteY48" fmla="*/ 6449909 h 6857996"/>
              <a:gd name="connsiteX49" fmla="*/ 1540087 w 12191993"/>
              <a:gd name="connsiteY49" fmla="*/ 6287757 h 6857996"/>
              <a:gd name="connsiteX50" fmla="*/ 1496207 w 12191993"/>
              <a:gd name="connsiteY50" fmla="*/ 6286463 h 6857996"/>
              <a:gd name="connsiteX51" fmla="*/ 1444311 w 12191993"/>
              <a:gd name="connsiteY51" fmla="*/ 6331866 h 6857996"/>
              <a:gd name="connsiteX52" fmla="*/ 1443661 w 12191993"/>
              <a:gd name="connsiteY52" fmla="*/ 6331866 h 6857996"/>
              <a:gd name="connsiteX53" fmla="*/ 1444960 w 12191993"/>
              <a:gd name="connsiteY53" fmla="*/ 6318568 h 6857996"/>
              <a:gd name="connsiteX54" fmla="*/ 1444960 w 12191993"/>
              <a:gd name="connsiteY54" fmla="*/ 6287757 h 6857996"/>
              <a:gd name="connsiteX55" fmla="*/ 1431332 w 12191993"/>
              <a:gd name="connsiteY55" fmla="*/ 6287757 h 6857996"/>
              <a:gd name="connsiteX56" fmla="*/ 1431332 w 12191993"/>
              <a:gd name="connsiteY56" fmla="*/ 6449910 h 6857996"/>
              <a:gd name="connsiteX57" fmla="*/ 1444960 w 12191993"/>
              <a:gd name="connsiteY57" fmla="*/ 6449910 h 6857996"/>
              <a:gd name="connsiteX58" fmla="*/ 1444960 w 12191993"/>
              <a:gd name="connsiteY58" fmla="*/ 6379861 h 6857996"/>
              <a:gd name="connsiteX59" fmla="*/ 1449821 w 12191993"/>
              <a:gd name="connsiteY59" fmla="*/ 6345808 h 6857996"/>
              <a:gd name="connsiteX60" fmla="*/ 1498150 w 12191993"/>
              <a:gd name="connsiteY60" fmla="*/ 6300406 h 6857996"/>
              <a:gd name="connsiteX61" fmla="*/ 1505609 w 12191993"/>
              <a:gd name="connsiteY61" fmla="*/ 6301055 h 6857996"/>
              <a:gd name="connsiteX62" fmla="*/ 1505609 w 12191993"/>
              <a:gd name="connsiteY62" fmla="*/ 6287433 h 6857996"/>
              <a:gd name="connsiteX63" fmla="*/ 1496207 w 12191993"/>
              <a:gd name="connsiteY63" fmla="*/ 6286463 h 6857996"/>
              <a:gd name="connsiteX64" fmla="*/ 2833876 w 12191993"/>
              <a:gd name="connsiteY64" fmla="*/ 6285815 h 6857996"/>
              <a:gd name="connsiteX65" fmla="*/ 2833876 w 12191993"/>
              <a:gd name="connsiteY65" fmla="*/ 6449910 h 6857996"/>
              <a:gd name="connsiteX66" fmla="*/ 2865337 w 12191993"/>
              <a:gd name="connsiteY66" fmla="*/ 6449910 h 6857996"/>
              <a:gd name="connsiteX67" fmla="*/ 2865337 w 12191993"/>
              <a:gd name="connsiteY67" fmla="*/ 6285815 h 6857996"/>
              <a:gd name="connsiteX68" fmla="*/ 1962617 w 12191993"/>
              <a:gd name="connsiteY68" fmla="*/ 6283866 h 6857996"/>
              <a:gd name="connsiteX69" fmla="*/ 1893850 w 12191993"/>
              <a:gd name="connsiteY69" fmla="*/ 6329593 h 6857996"/>
              <a:gd name="connsiteX70" fmla="*/ 1893201 w 12191993"/>
              <a:gd name="connsiteY70" fmla="*/ 6329593 h 6857996"/>
              <a:gd name="connsiteX71" fmla="*/ 1894499 w 12191993"/>
              <a:gd name="connsiteY71" fmla="*/ 6316296 h 6857996"/>
              <a:gd name="connsiteX72" fmla="*/ 1894499 w 12191993"/>
              <a:gd name="connsiteY72" fmla="*/ 6287757 h 6857996"/>
              <a:gd name="connsiteX73" fmla="*/ 1880875 w 12191993"/>
              <a:gd name="connsiteY73" fmla="*/ 6287757 h 6857996"/>
              <a:gd name="connsiteX74" fmla="*/ 1880875 w 12191993"/>
              <a:gd name="connsiteY74" fmla="*/ 6449909 h 6857996"/>
              <a:gd name="connsiteX75" fmla="*/ 1894500 w 12191993"/>
              <a:gd name="connsiteY75" fmla="*/ 6449909 h 6857996"/>
              <a:gd name="connsiteX76" fmla="*/ 1894500 w 12191993"/>
              <a:gd name="connsiteY76" fmla="*/ 6370779 h 6857996"/>
              <a:gd name="connsiteX77" fmla="*/ 1897093 w 12191993"/>
              <a:gd name="connsiteY77" fmla="*/ 6348730 h 6857996"/>
              <a:gd name="connsiteX78" fmla="*/ 1962617 w 12191993"/>
              <a:gd name="connsiteY78" fmla="*/ 6297163 h 6857996"/>
              <a:gd name="connsiteX79" fmla="*/ 2002511 w 12191993"/>
              <a:gd name="connsiteY79" fmla="*/ 6351972 h 6857996"/>
              <a:gd name="connsiteX80" fmla="*/ 2002511 w 12191993"/>
              <a:gd name="connsiteY80" fmla="*/ 6449909 h 6857996"/>
              <a:gd name="connsiteX81" fmla="*/ 2016132 w 12191993"/>
              <a:gd name="connsiteY81" fmla="*/ 6449909 h 6857996"/>
              <a:gd name="connsiteX82" fmla="*/ 2016132 w 12191993"/>
              <a:gd name="connsiteY82" fmla="*/ 6347107 h 6857996"/>
              <a:gd name="connsiteX83" fmla="*/ 1962617 w 12191993"/>
              <a:gd name="connsiteY83" fmla="*/ 6283866 h 6857996"/>
              <a:gd name="connsiteX84" fmla="*/ 1782992 w 12191993"/>
              <a:gd name="connsiteY84" fmla="*/ 6283866 h 6857996"/>
              <a:gd name="connsiteX85" fmla="*/ 1704172 w 12191993"/>
              <a:gd name="connsiteY85" fmla="*/ 6369160 h 6857996"/>
              <a:gd name="connsiteX86" fmla="*/ 1787858 w 12191993"/>
              <a:gd name="connsiteY86" fmla="*/ 6453801 h 6857996"/>
              <a:gd name="connsiteX87" fmla="*/ 1845593 w 12191993"/>
              <a:gd name="connsiteY87" fmla="*/ 6431427 h 6857996"/>
              <a:gd name="connsiteX88" fmla="*/ 1838134 w 12191993"/>
              <a:gd name="connsiteY88" fmla="*/ 6420073 h 6857996"/>
              <a:gd name="connsiteX89" fmla="*/ 1787858 w 12191993"/>
              <a:gd name="connsiteY89" fmla="*/ 6440508 h 6857996"/>
              <a:gd name="connsiteX90" fmla="*/ 1718442 w 12191993"/>
              <a:gd name="connsiteY90" fmla="*/ 6366563 h 6857996"/>
              <a:gd name="connsiteX91" fmla="*/ 1848511 w 12191993"/>
              <a:gd name="connsiteY91" fmla="*/ 6366563 h 6857996"/>
              <a:gd name="connsiteX92" fmla="*/ 1849161 w 12191993"/>
              <a:gd name="connsiteY92" fmla="*/ 6357807 h 6857996"/>
              <a:gd name="connsiteX93" fmla="*/ 1782992 w 12191993"/>
              <a:gd name="connsiteY93" fmla="*/ 6283866 h 6857996"/>
              <a:gd name="connsiteX94" fmla="*/ 3482643 w 12191993"/>
              <a:gd name="connsiteY94" fmla="*/ 6281922 h 6857996"/>
              <a:gd name="connsiteX95" fmla="*/ 3400581 w 12191993"/>
              <a:gd name="connsiteY95" fmla="*/ 6367862 h 6857996"/>
              <a:gd name="connsiteX96" fmla="*/ 3487504 w 12191993"/>
              <a:gd name="connsiteY96" fmla="*/ 6453801 h 6857996"/>
              <a:gd name="connsiteX97" fmla="*/ 3551085 w 12191993"/>
              <a:gd name="connsiteY97" fmla="*/ 6430452 h 6857996"/>
              <a:gd name="connsiteX98" fmla="*/ 3538105 w 12191993"/>
              <a:gd name="connsiteY98" fmla="*/ 6407425 h 6857996"/>
              <a:gd name="connsiteX99" fmla="*/ 3489453 w 12191993"/>
              <a:gd name="connsiteY99" fmla="*/ 6426561 h 6857996"/>
              <a:gd name="connsiteX100" fmla="*/ 3433015 w 12191993"/>
              <a:gd name="connsiteY100" fmla="*/ 6372402 h 6857996"/>
              <a:gd name="connsiteX101" fmla="*/ 3552700 w 12191993"/>
              <a:gd name="connsiteY101" fmla="*/ 6372402 h 6857996"/>
              <a:gd name="connsiteX102" fmla="*/ 3553673 w 12191993"/>
              <a:gd name="connsiteY102" fmla="*/ 6358780 h 6857996"/>
              <a:gd name="connsiteX103" fmla="*/ 3482643 w 12191993"/>
              <a:gd name="connsiteY103" fmla="*/ 6281922 h 6857996"/>
              <a:gd name="connsiteX104" fmla="*/ 3328545 w 12191993"/>
              <a:gd name="connsiteY104" fmla="*/ 6281922 h 6857996"/>
              <a:gd name="connsiteX105" fmla="*/ 3240639 w 12191993"/>
              <a:gd name="connsiteY105" fmla="*/ 6367862 h 6857996"/>
              <a:gd name="connsiteX106" fmla="*/ 3328545 w 12191993"/>
              <a:gd name="connsiteY106" fmla="*/ 6453801 h 6857996"/>
              <a:gd name="connsiteX107" fmla="*/ 3394065 w 12191993"/>
              <a:gd name="connsiteY107" fmla="*/ 6427535 h 6857996"/>
              <a:gd name="connsiteX108" fmla="*/ 3381411 w 12191993"/>
              <a:gd name="connsiteY108" fmla="*/ 6404507 h 6857996"/>
              <a:gd name="connsiteX109" fmla="*/ 3330810 w 12191993"/>
              <a:gd name="connsiteY109" fmla="*/ 6426561 h 6857996"/>
              <a:gd name="connsiteX110" fmla="*/ 3272749 w 12191993"/>
              <a:gd name="connsiteY110" fmla="*/ 6367536 h 6857996"/>
              <a:gd name="connsiteX111" fmla="*/ 3329836 w 12191993"/>
              <a:gd name="connsiteY111" fmla="*/ 6309162 h 6857996"/>
              <a:gd name="connsiteX112" fmla="*/ 3375250 w 12191993"/>
              <a:gd name="connsiteY112" fmla="*/ 6327973 h 6857996"/>
              <a:gd name="connsiteX113" fmla="*/ 3390169 w 12191993"/>
              <a:gd name="connsiteY113" fmla="*/ 6305919 h 6857996"/>
              <a:gd name="connsiteX114" fmla="*/ 3328545 w 12191993"/>
              <a:gd name="connsiteY114" fmla="*/ 6281922 h 6857996"/>
              <a:gd name="connsiteX115" fmla="*/ 3161340 w 12191993"/>
              <a:gd name="connsiteY115" fmla="*/ 6281922 h 6857996"/>
              <a:gd name="connsiteX116" fmla="*/ 3099708 w 12191993"/>
              <a:gd name="connsiteY116" fmla="*/ 6319542 h 6857996"/>
              <a:gd name="connsiteX117" fmla="*/ 3099059 w 12191993"/>
              <a:gd name="connsiteY117" fmla="*/ 6319542 h 6857996"/>
              <a:gd name="connsiteX118" fmla="*/ 3099708 w 12191993"/>
              <a:gd name="connsiteY118" fmla="*/ 6307543 h 6857996"/>
              <a:gd name="connsiteX119" fmla="*/ 3099708 w 12191993"/>
              <a:gd name="connsiteY119" fmla="*/ 6285814 h 6857996"/>
              <a:gd name="connsiteX120" fmla="*/ 3069221 w 12191993"/>
              <a:gd name="connsiteY120" fmla="*/ 6285814 h 6857996"/>
              <a:gd name="connsiteX121" fmla="*/ 3069221 w 12191993"/>
              <a:gd name="connsiteY121" fmla="*/ 6449909 h 6857996"/>
              <a:gd name="connsiteX122" fmla="*/ 3100682 w 12191993"/>
              <a:gd name="connsiteY122" fmla="*/ 6449909 h 6857996"/>
              <a:gd name="connsiteX123" fmla="*/ 3100682 w 12191993"/>
              <a:gd name="connsiteY123" fmla="*/ 6373051 h 6857996"/>
              <a:gd name="connsiteX124" fmla="*/ 3103280 w 12191993"/>
              <a:gd name="connsiteY124" fmla="*/ 6350997 h 6857996"/>
              <a:gd name="connsiteX125" fmla="*/ 3155171 w 12191993"/>
              <a:gd name="connsiteY125" fmla="*/ 6310785 h 6857996"/>
              <a:gd name="connsiteX126" fmla="*/ 3186316 w 12191993"/>
              <a:gd name="connsiteY126" fmla="*/ 6351971 h 6857996"/>
              <a:gd name="connsiteX127" fmla="*/ 3186316 w 12191993"/>
              <a:gd name="connsiteY127" fmla="*/ 6449909 h 6857996"/>
              <a:gd name="connsiteX128" fmla="*/ 3217777 w 12191993"/>
              <a:gd name="connsiteY128" fmla="*/ 6449909 h 6857996"/>
              <a:gd name="connsiteX129" fmla="*/ 3217777 w 12191993"/>
              <a:gd name="connsiteY129" fmla="*/ 6344838 h 6857996"/>
              <a:gd name="connsiteX130" fmla="*/ 3161340 w 12191993"/>
              <a:gd name="connsiteY130" fmla="*/ 6281922 h 6857996"/>
              <a:gd name="connsiteX131" fmla="*/ 2972280 w 12191993"/>
              <a:gd name="connsiteY131" fmla="*/ 6281922 h 6857996"/>
              <a:gd name="connsiteX132" fmla="*/ 2890218 w 12191993"/>
              <a:gd name="connsiteY132" fmla="*/ 6367862 h 6857996"/>
              <a:gd name="connsiteX133" fmla="*/ 2977142 w 12191993"/>
              <a:gd name="connsiteY133" fmla="*/ 6453801 h 6857996"/>
              <a:gd name="connsiteX134" fmla="*/ 3040722 w 12191993"/>
              <a:gd name="connsiteY134" fmla="*/ 6430452 h 6857996"/>
              <a:gd name="connsiteX135" fmla="*/ 3027743 w 12191993"/>
              <a:gd name="connsiteY135" fmla="*/ 6407425 h 6857996"/>
              <a:gd name="connsiteX136" fmla="*/ 2979090 w 12191993"/>
              <a:gd name="connsiteY136" fmla="*/ 6426561 h 6857996"/>
              <a:gd name="connsiteX137" fmla="*/ 2922653 w 12191993"/>
              <a:gd name="connsiteY137" fmla="*/ 6372402 h 6857996"/>
              <a:gd name="connsiteX138" fmla="*/ 3042338 w 12191993"/>
              <a:gd name="connsiteY138" fmla="*/ 6372402 h 6857996"/>
              <a:gd name="connsiteX139" fmla="*/ 3043311 w 12191993"/>
              <a:gd name="connsiteY139" fmla="*/ 6358780 h 6857996"/>
              <a:gd name="connsiteX140" fmla="*/ 2972280 w 12191993"/>
              <a:gd name="connsiteY140" fmla="*/ 6281922 h 6857996"/>
              <a:gd name="connsiteX141" fmla="*/ 2748837 w 12191993"/>
              <a:gd name="connsiteY141" fmla="*/ 6281922 h 6857996"/>
              <a:gd name="connsiteX142" fmla="*/ 2660931 w 12191993"/>
              <a:gd name="connsiteY142" fmla="*/ 6367862 h 6857996"/>
              <a:gd name="connsiteX143" fmla="*/ 2748837 w 12191993"/>
              <a:gd name="connsiteY143" fmla="*/ 6453801 h 6857996"/>
              <a:gd name="connsiteX144" fmla="*/ 2814356 w 12191993"/>
              <a:gd name="connsiteY144" fmla="*/ 6427535 h 6857996"/>
              <a:gd name="connsiteX145" fmla="*/ 2801703 w 12191993"/>
              <a:gd name="connsiteY145" fmla="*/ 6404507 h 6857996"/>
              <a:gd name="connsiteX146" fmla="*/ 2751101 w 12191993"/>
              <a:gd name="connsiteY146" fmla="*/ 6426561 h 6857996"/>
              <a:gd name="connsiteX147" fmla="*/ 2693040 w 12191993"/>
              <a:gd name="connsiteY147" fmla="*/ 6367536 h 6857996"/>
              <a:gd name="connsiteX148" fmla="*/ 2750128 w 12191993"/>
              <a:gd name="connsiteY148" fmla="*/ 6309162 h 6857996"/>
              <a:gd name="connsiteX149" fmla="*/ 2795541 w 12191993"/>
              <a:gd name="connsiteY149" fmla="*/ 6327973 h 6857996"/>
              <a:gd name="connsiteX150" fmla="*/ 2810461 w 12191993"/>
              <a:gd name="connsiteY150" fmla="*/ 6305919 h 6857996"/>
              <a:gd name="connsiteX151" fmla="*/ 2748837 w 12191993"/>
              <a:gd name="connsiteY151" fmla="*/ 6281922 h 6857996"/>
              <a:gd name="connsiteX152" fmla="*/ 2593020 w 12191993"/>
              <a:gd name="connsiteY152" fmla="*/ 6281922 h 6857996"/>
              <a:gd name="connsiteX153" fmla="*/ 2533661 w 12191993"/>
              <a:gd name="connsiteY153" fmla="*/ 6328619 h 6857996"/>
              <a:gd name="connsiteX154" fmla="*/ 2617996 w 12191993"/>
              <a:gd name="connsiteY154" fmla="*/ 6406130 h 6857996"/>
              <a:gd name="connsiteX155" fmla="*/ 2590747 w 12191993"/>
              <a:gd name="connsiteY155" fmla="*/ 6426561 h 6857996"/>
              <a:gd name="connsiteX156" fmla="*/ 2543718 w 12191993"/>
              <a:gd name="connsiteY156" fmla="*/ 6407425 h 6857996"/>
              <a:gd name="connsiteX157" fmla="*/ 2528466 w 12191993"/>
              <a:gd name="connsiteY157" fmla="*/ 6429803 h 6857996"/>
              <a:gd name="connsiteX158" fmla="*/ 2590747 w 12191993"/>
              <a:gd name="connsiteY158" fmla="*/ 6453801 h 6857996"/>
              <a:gd name="connsiteX159" fmla="*/ 2650106 w 12191993"/>
              <a:gd name="connsiteY159" fmla="*/ 6406130 h 6857996"/>
              <a:gd name="connsiteX160" fmla="*/ 2565771 w 12191993"/>
              <a:gd name="connsiteY160" fmla="*/ 6329268 h 6857996"/>
              <a:gd name="connsiteX161" fmla="*/ 2592695 w 12191993"/>
              <a:gd name="connsiteY161" fmla="*/ 6309162 h 6857996"/>
              <a:gd name="connsiteX162" fmla="*/ 2633239 w 12191993"/>
              <a:gd name="connsiteY162" fmla="*/ 6323757 h 6857996"/>
              <a:gd name="connsiteX163" fmla="*/ 2645885 w 12191993"/>
              <a:gd name="connsiteY163" fmla="*/ 6300081 h 6857996"/>
              <a:gd name="connsiteX164" fmla="*/ 2593020 w 12191993"/>
              <a:gd name="connsiteY164" fmla="*/ 6281922 h 6857996"/>
              <a:gd name="connsiteX165" fmla="*/ 1223619 w 12191993"/>
              <a:gd name="connsiteY165" fmla="*/ 6235871 h 6857996"/>
              <a:gd name="connsiteX166" fmla="*/ 1278761 w 12191993"/>
              <a:gd name="connsiteY166" fmla="*/ 6235871 h 6857996"/>
              <a:gd name="connsiteX167" fmla="*/ 1379638 w 12191993"/>
              <a:gd name="connsiteY167" fmla="*/ 6336406 h 6857996"/>
              <a:gd name="connsiteX168" fmla="*/ 1278761 w 12191993"/>
              <a:gd name="connsiteY168" fmla="*/ 6436937 h 6857996"/>
              <a:gd name="connsiteX169" fmla="*/ 1223619 w 12191993"/>
              <a:gd name="connsiteY169" fmla="*/ 6436937 h 6857996"/>
              <a:gd name="connsiteX170" fmla="*/ 2147812 w 12191993"/>
              <a:gd name="connsiteY170" fmla="*/ 6222898 h 6857996"/>
              <a:gd name="connsiteX171" fmla="*/ 2147812 w 12191993"/>
              <a:gd name="connsiteY171" fmla="*/ 6449909 h 6857996"/>
              <a:gd name="connsiteX172" fmla="*/ 2161440 w 12191993"/>
              <a:gd name="connsiteY172" fmla="*/ 6449909 h 6857996"/>
              <a:gd name="connsiteX173" fmla="*/ 2161440 w 12191993"/>
              <a:gd name="connsiteY173" fmla="*/ 6431426 h 6857996"/>
              <a:gd name="connsiteX174" fmla="*/ 2160141 w 12191993"/>
              <a:gd name="connsiteY174" fmla="*/ 6417155 h 6857996"/>
              <a:gd name="connsiteX175" fmla="*/ 2160791 w 12191993"/>
              <a:gd name="connsiteY175" fmla="*/ 6417155 h 6857996"/>
              <a:gd name="connsiteX176" fmla="*/ 2216903 w 12191993"/>
              <a:gd name="connsiteY176" fmla="*/ 6453801 h 6857996"/>
              <a:gd name="connsiteX177" fmla="*/ 2289558 w 12191993"/>
              <a:gd name="connsiteY177" fmla="*/ 6368835 h 6857996"/>
              <a:gd name="connsiteX178" fmla="*/ 2219501 w 12191993"/>
              <a:gd name="connsiteY178" fmla="*/ 6283866 h 6857996"/>
              <a:gd name="connsiteX179" fmla="*/ 2160791 w 12191993"/>
              <a:gd name="connsiteY179" fmla="*/ 6320511 h 6857996"/>
              <a:gd name="connsiteX180" fmla="*/ 2160141 w 12191993"/>
              <a:gd name="connsiteY180" fmla="*/ 6320511 h 6857996"/>
              <a:gd name="connsiteX181" fmla="*/ 2161440 w 12191993"/>
              <a:gd name="connsiteY181" fmla="*/ 6307218 h 6857996"/>
              <a:gd name="connsiteX182" fmla="*/ 2161440 w 12191993"/>
              <a:gd name="connsiteY182" fmla="*/ 6222898 h 6857996"/>
              <a:gd name="connsiteX183" fmla="*/ 1525168 w 12191993"/>
              <a:gd name="connsiteY183" fmla="*/ 6222898 h 6857996"/>
              <a:gd name="connsiteX184" fmla="*/ 1525168 w 12191993"/>
              <a:gd name="connsiteY184" fmla="*/ 6246571 h 6857996"/>
              <a:gd name="connsiteX185" fmla="*/ 1541386 w 12191993"/>
              <a:gd name="connsiteY185" fmla="*/ 6246571 h 6857996"/>
              <a:gd name="connsiteX186" fmla="*/ 1541386 w 12191993"/>
              <a:gd name="connsiteY186" fmla="*/ 6222898 h 6857996"/>
              <a:gd name="connsiteX187" fmla="*/ 1209670 w 12191993"/>
              <a:gd name="connsiteY187" fmla="*/ 6222898 h 6857996"/>
              <a:gd name="connsiteX188" fmla="*/ 1209670 w 12191993"/>
              <a:gd name="connsiteY188" fmla="*/ 6449909 h 6857996"/>
              <a:gd name="connsiteX189" fmla="*/ 1281034 w 12191993"/>
              <a:gd name="connsiteY189" fmla="*/ 6449909 h 6857996"/>
              <a:gd name="connsiteX190" fmla="*/ 1394232 w 12191993"/>
              <a:gd name="connsiteY190" fmla="*/ 6336406 h 6857996"/>
              <a:gd name="connsiteX191" fmla="*/ 1281034 w 12191993"/>
              <a:gd name="connsiteY191" fmla="*/ 6222898 h 6857996"/>
              <a:gd name="connsiteX192" fmla="*/ 2833551 w 12191993"/>
              <a:gd name="connsiteY192" fmla="*/ 6220951 h 6857996"/>
              <a:gd name="connsiteX193" fmla="*/ 2833551 w 12191993"/>
              <a:gd name="connsiteY193" fmla="*/ 6253060 h 6857996"/>
              <a:gd name="connsiteX194" fmla="*/ 2865337 w 12191993"/>
              <a:gd name="connsiteY194" fmla="*/ 6253060 h 6857996"/>
              <a:gd name="connsiteX195" fmla="*/ 2865337 w 12191993"/>
              <a:gd name="connsiteY195" fmla="*/ 6220951 h 6857996"/>
              <a:gd name="connsiteX196" fmla="*/ 982628 w 12191993"/>
              <a:gd name="connsiteY196" fmla="*/ 6207360 h 6857996"/>
              <a:gd name="connsiteX197" fmla="*/ 740053 w 12191993"/>
              <a:gd name="connsiteY197" fmla="*/ 6449905 h 6857996"/>
              <a:gd name="connsiteX198" fmla="*/ 982628 w 12191993"/>
              <a:gd name="connsiteY198" fmla="*/ 6449909 h 6857996"/>
              <a:gd name="connsiteX199" fmla="*/ 407989 w 12191993"/>
              <a:gd name="connsiteY199" fmla="*/ 6207356 h 6857996"/>
              <a:gd name="connsiteX200" fmla="*/ 407989 w 12191993"/>
              <a:gd name="connsiteY200" fmla="*/ 6449905 h 6857996"/>
              <a:gd name="connsiteX201" fmla="*/ 650564 w 12191993"/>
              <a:gd name="connsiteY201" fmla="*/ 6449905 h 6857996"/>
              <a:gd name="connsiteX202" fmla="*/ 407989 w 12191993"/>
              <a:gd name="connsiteY202" fmla="*/ 6207356 h 6857996"/>
              <a:gd name="connsiteX203" fmla="*/ 883619 w 12191993"/>
              <a:gd name="connsiteY203" fmla="*/ 6147250 h 6857996"/>
              <a:gd name="connsiteX204" fmla="*/ 915428 w 12191993"/>
              <a:gd name="connsiteY204" fmla="*/ 6147250 h 6857996"/>
              <a:gd name="connsiteX205" fmla="*/ 915428 w 12191993"/>
              <a:gd name="connsiteY205" fmla="*/ 6178023 h 6857996"/>
              <a:gd name="connsiteX206" fmla="*/ 883619 w 12191993"/>
              <a:gd name="connsiteY206" fmla="*/ 6178023 h 6857996"/>
              <a:gd name="connsiteX207" fmla="*/ 739956 w 12191993"/>
              <a:gd name="connsiteY207" fmla="*/ 6106213 h 6857996"/>
              <a:gd name="connsiteX208" fmla="*/ 739956 w 12191993"/>
              <a:gd name="connsiteY208" fmla="*/ 6219065 h 6857996"/>
              <a:gd name="connsiteX209" fmla="*/ 830261 w 12191993"/>
              <a:gd name="connsiteY209" fmla="*/ 6219065 h 6857996"/>
              <a:gd name="connsiteX210" fmla="*/ 830261 w 12191993"/>
              <a:gd name="connsiteY210" fmla="*/ 6178031 h 6857996"/>
              <a:gd name="connsiteX211" fmla="*/ 781009 w 12191993"/>
              <a:gd name="connsiteY211" fmla="*/ 6178031 h 6857996"/>
              <a:gd name="connsiteX212" fmla="*/ 781009 w 12191993"/>
              <a:gd name="connsiteY212" fmla="*/ 6147251 h 6857996"/>
              <a:gd name="connsiteX213" fmla="*/ 830261 w 12191993"/>
              <a:gd name="connsiteY213" fmla="*/ 6147251 h 6857996"/>
              <a:gd name="connsiteX214" fmla="*/ 830261 w 12191993"/>
              <a:gd name="connsiteY214" fmla="*/ 6106213 h 6857996"/>
              <a:gd name="connsiteX215" fmla="*/ 3802396 w 12191993"/>
              <a:gd name="connsiteY215" fmla="*/ 6068975 h 6857996"/>
              <a:gd name="connsiteX216" fmla="*/ 3802396 w 12191993"/>
              <a:gd name="connsiteY216" fmla="*/ 6102379 h 6857996"/>
              <a:gd name="connsiteX217" fmla="*/ 3835481 w 12191993"/>
              <a:gd name="connsiteY217" fmla="*/ 6102379 h 6857996"/>
              <a:gd name="connsiteX218" fmla="*/ 3835481 w 12191993"/>
              <a:gd name="connsiteY218" fmla="*/ 6068975 h 6857996"/>
              <a:gd name="connsiteX219" fmla="*/ 842572 w 12191993"/>
              <a:gd name="connsiteY219" fmla="*/ 6042596 h 6857996"/>
              <a:gd name="connsiteX220" fmla="*/ 842572 w 12191993"/>
              <a:gd name="connsiteY220" fmla="*/ 6219054 h 6857996"/>
              <a:gd name="connsiteX221" fmla="*/ 953399 w 12191993"/>
              <a:gd name="connsiteY221" fmla="*/ 6219054 h 6857996"/>
              <a:gd name="connsiteX222" fmla="*/ 953399 w 12191993"/>
              <a:gd name="connsiteY222" fmla="*/ 6106202 h 6857996"/>
              <a:gd name="connsiteX223" fmla="*/ 883619 w 12191993"/>
              <a:gd name="connsiteY223" fmla="*/ 6106202 h 6857996"/>
              <a:gd name="connsiteX224" fmla="*/ 883619 w 12191993"/>
              <a:gd name="connsiteY224" fmla="*/ 6042596 h 6857996"/>
              <a:gd name="connsiteX225" fmla="*/ 2979149 w 12191993"/>
              <a:gd name="connsiteY225" fmla="*/ 6023573 h 6857996"/>
              <a:gd name="connsiteX226" fmla="*/ 2987258 w 12191993"/>
              <a:gd name="connsiteY226" fmla="*/ 6023573 h 6857996"/>
              <a:gd name="connsiteX227" fmla="*/ 2987258 w 12191993"/>
              <a:gd name="connsiteY227" fmla="*/ 6028762 h 6857996"/>
              <a:gd name="connsiteX228" fmla="*/ 2943468 w 12191993"/>
              <a:gd name="connsiteY228" fmla="*/ 6080974 h 6857996"/>
              <a:gd name="connsiteX229" fmla="*/ 2912656 w 12191993"/>
              <a:gd name="connsiteY229" fmla="*/ 6054708 h 6857996"/>
              <a:gd name="connsiteX230" fmla="*/ 2979149 w 12191993"/>
              <a:gd name="connsiteY230" fmla="*/ 6023573 h 6857996"/>
              <a:gd name="connsiteX231" fmla="*/ 2790699 w 12191993"/>
              <a:gd name="connsiteY231" fmla="*/ 5961955 h 6857996"/>
              <a:gd name="connsiteX232" fmla="*/ 2837087 w 12191993"/>
              <a:gd name="connsiteY232" fmla="*/ 6020654 h 6857996"/>
              <a:gd name="connsiteX233" fmla="*/ 2789732 w 12191993"/>
              <a:gd name="connsiteY233" fmla="*/ 6079354 h 6857996"/>
              <a:gd name="connsiteX234" fmla="*/ 2743344 w 12191993"/>
              <a:gd name="connsiteY234" fmla="*/ 6020979 h 6857996"/>
              <a:gd name="connsiteX235" fmla="*/ 2790699 w 12191993"/>
              <a:gd name="connsiteY235" fmla="*/ 5961955 h 6857996"/>
              <a:gd name="connsiteX236" fmla="*/ 3285066 w 12191993"/>
              <a:gd name="connsiteY236" fmla="*/ 5959362 h 6857996"/>
              <a:gd name="connsiteX237" fmla="*/ 3324644 w 12191993"/>
              <a:gd name="connsiteY237" fmla="*/ 6001198 h 6857996"/>
              <a:gd name="connsiteX238" fmla="*/ 3237062 w 12191993"/>
              <a:gd name="connsiteY238" fmla="*/ 6001198 h 6857996"/>
              <a:gd name="connsiteX239" fmla="*/ 3285066 w 12191993"/>
              <a:gd name="connsiteY239" fmla="*/ 5959362 h 6857996"/>
              <a:gd name="connsiteX240" fmla="*/ 2389939 w 12191993"/>
              <a:gd name="connsiteY240" fmla="*/ 5949632 h 6857996"/>
              <a:gd name="connsiteX241" fmla="*/ 2446377 w 12191993"/>
              <a:gd name="connsiteY241" fmla="*/ 6021305 h 6857996"/>
              <a:gd name="connsiteX242" fmla="*/ 2388641 w 12191993"/>
              <a:gd name="connsiteY242" fmla="*/ 6092976 h 6857996"/>
              <a:gd name="connsiteX243" fmla="*/ 2332204 w 12191993"/>
              <a:gd name="connsiteY243" fmla="*/ 6021629 h 6857996"/>
              <a:gd name="connsiteX244" fmla="*/ 2389939 w 12191993"/>
              <a:gd name="connsiteY244" fmla="*/ 5949632 h 6857996"/>
              <a:gd name="connsiteX245" fmla="*/ 2115219 w 12191993"/>
              <a:gd name="connsiteY245" fmla="*/ 5949632 h 6857996"/>
              <a:gd name="connsiteX246" fmla="*/ 2171660 w 12191993"/>
              <a:gd name="connsiteY246" fmla="*/ 6020980 h 6857996"/>
              <a:gd name="connsiteX247" fmla="*/ 2113920 w 12191993"/>
              <a:gd name="connsiteY247" fmla="*/ 6092976 h 6857996"/>
              <a:gd name="connsiteX248" fmla="*/ 2057481 w 12191993"/>
              <a:gd name="connsiteY248" fmla="*/ 6021305 h 6857996"/>
              <a:gd name="connsiteX249" fmla="*/ 2115219 w 12191993"/>
              <a:gd name="connsiteY249" fmla="*/ 5949632 h 6857996"/>
              <a:gd name="connsiteX250" fmla="*/ 1641577 w 12191993"/>
              <a:gd name="connsiteY250" fmla="*/ 5949632 h 6857996"/>
              <a:gd name="connsiteX251" fmla="*/ 1698014 w 12191993"/>
              <a:gd name="connsiteY251" fmla="*/ 6021304 h 6857996"/>
              <a:gd name="connsiteX252" fmla="*/ 1640278 w 12191993"/>
              <a:gd name="connsiteY252" fmla="*/ 6092976 h 6857996"/>
              <a:gd name="connsiteX253" fmla="*/ 1583842 w 12191993"/>
              <a:gd name="connsiteY253" fmla="*/ 6021628 h 6857996"/>
              <a:gd name="connsiteX254" fmla="*/ 1641577 w 12191993"/>
              <a:gd name="connsiteY254" fmla="*/ 5949632 h 6857996"/>
              <a:gd name="connsiteX255" fmla="*/ 1954957 w 12191993"/>
              <a:gd name="connsiteY255" fmla="*/ 5948983 h 6857996"/>
              <a:gd name="connsiteX256" fmla="*/ 2007177 w 12191993"/>
              <a:gd name="connsiteY256" fmla="*/ 6006384 h 6857996"/>
              <a:gd name="connsiteX257" fmla="*/ 1891706 w 12191993"/>
              <a:gd name="connsiteY257" fmla="*/ 6006384 h 6857996"/>
              <a:gd name="connsiteX258" fmla="*/ 1954957 w 12191993"/>
              <a:gd name="connsiteY258" fmla="*/ 5948983 h 6857996"/>
              <a:gd name="connsiteX259" fmla="*/ 2464407 w 12191993"/>
              <a:gd name="connsiteY259" fmla="*/ 5940226 h 6857996"/>
              <a:gd name="connsiteX260" fmla="*/ 2531550 w 12191993"/>
              <a:gd name="connsiteY260" fmla="*/ 6101405 h 6857996"/>
              <a:gd name="connsiteX261" fmla="*/ 2519870 w 12191993"/>
              <a:gd name="connsiteY261" fmla="*/ 6128324 h 6857996"/>
              <a:gd name="connsiteX262" fmla="*/ 2488084 w 12191993"/>
              <a:gd name="connsiteY262" fmla="*/ 6157511 h 6857996"/>
              <a:gd name="connsiteX263" fmla="*/ 2467970 w 12191993"/>
              <a:gd name="connsiteY263" fmla="*/ 6149728 h 6857996"/>
              <a:gd name="connsiteX264" fmla="*/ 2461809 w 12191993"/>
              <a:gd name="connsiteY264" fmla="*/ 6161402 h 6857996"/>
              <a:gd name="connsiteX265" fmla="*/ 2488084 w 12191993"/>
              <a:gd name="connsiteY265" fmla="*/ 6170485 h 6857996"/>
              <a:gd name="connsiteX266" fmla="*/ 2529277 w 12191993"/>
              <a:gd name="connsiteY266" fmla="*/ 6140322 h 6857996"/>
              <a:gd name="connsiteX267" fmla="*/ 2612638 w 12191993"/>
              <a:gd name="connsiteY267" fmla="*/ 5940226 h 6857996"/>
              <a:gd name="connsiteX268" fmla="*/ 2598044 w 12191993"/>
              <a:gd name="connsiteY268" fmla="*/ 5940226 h 6857996"/>
              <a:gd name="connsiteX269" fmla="*/ 2544521 w 12191993"/>
              <a:gd name="connsiteY269" fmla="*/ 6069624 h 6857996"/>
              <a:gd name="connsiteX270" fmla="*/ 2539009 w 12191993"/>
              <a:gd name="connsiteY270" fmla="*/ 6084865 h 6857996"/>
              <a:gd name="connsiteX271" fmla="*/ 2538360 w 12191993"/>
              <a:gd name="connsiteY271" fmla="*/ 6084865 h 6857996"/>
              <a:gd name="connsiteX272" fmla="*/ 2532516 w 12191993"/>
              <a:gd name="connsiteY272" fmla="*/ 6069624 h 6857996"/>
              <a:gd name="connsiteX273" fmla="*/ 2479001 w 12191993"/>
              <a:gd name="connsiteY273" fmla="*/ 5940226 h 6857996"/>
              <a:gd name="connsiteX274" fmla="*/ 1744846 w 12191993"/>
              <a:gd name="connsiteY274" fmla="*/ 5940226 h 6857996"/>
              <a:gd name="connsiteX275" fmla="*/ 1744846 w 12191993"/>
              <a:gd name="connsiteY275" fmla="*/ 6102378 h 6857996"/>
              <a:gd name="connsiteX276" fmla="*/ 1758470 w 12191993"/>
              <a:gd name="connsiteY276" fmla="*/ 6102378 h 6857996"/>
              <a:gd name="connsiteX277" fmla="*/ 1758470 w 12191993"/>
              <a:gd name="connsiteY277" fmla="*/ 5940226 h 6857996"/>
              <a:gd name="connsiteX278" fmla="*/ 1864854 w 12191993"/>
              <a:gd name="connsiteY278" fmla="*/ 5938932 h 6857996"/>
              <a:gd name="connsiteX279" fmla="*/ 1812955 w 12191993"/>
              <a:gd name="connsiteY279" fmla="*/ 5984334 h 6857996"/>
              <a:gd name="connsiteX280" fmla="*/ 1812306 w 12191993"/>
              <a:gd name="connsiteY280" fmla="*/ 5984334 h 6857996"/>
              <a:gd name="connsiteX281" fmla="*/ 1813604 w 12191993"/>
              <a:gd name="connsiteY281" fmla="*/ 5971037 h 6857996"/>
              <a:gd name="connsiteX282" fmla="*/ 1813604 w 12191993"/>
              <a:gd name="connsiteY282" fmla="*/ 5940226 h 6857996"/>
              <a:gd name="connsiteX283" fmla="*/ 1799984 w 12191993"/>
              <a:gd name="connsiteY283" fmla="*/ 5940226 h 6857996"/>
              <a:gd name="connsiteX284" fmla="*/ 1799984 w 12191993"/>
              <a:gd name="connsiteY284" fmla="*/ 6102378 h 6857996"/>
              <a:gd name="connsiteX285" fmla="*/ 1813604 w 12191993"/>
              <a:gd name="connsiteY285" fmla="*/ 6102378 h 6857996"/>
              <a:gd name="connsiteX286" fmla="*/ 1813604 w 12191993"/>
              <a:gd name="connsiteY286" fmla="*/ 6032329 h 6857996"/>
              <a:gd name="connsiteX287" fmla="*/ 1818470 w 12191993"/>
              <a:gd name="connsiteY287" fmla="*/ 5998276 h 6857996"/>
              <a:gd name="connsiteX288" fmla="*/ 1866802 w 12191993"/>
              <a:gd name="connsiteY288" fmla="*/ 5952874 h 6857996"/>
              <a:gd name="connsiteX289" fmla="*/ 1874262 w 12191993"/>
              <a:gd name="connsiteY289" fmla="*/ 5953523 h 6857996"/>
              <a:gd name="connsiteX290" fmla="*/ 1874262 w 12191993"/>
              <a:gd name="connsiteY290" fmla="*/ 5939902 h 6857996"/>
              <a:gd name="connsiteX291" fmla="*/ 1864854 w 12191993"/>
              <a:gd name="connsiteY291" fmla="*/ 5938932 h 6857996"/>
              <a:gd name="connsiteX292" fmla="*/ 3147319 w 12191993"/>
              <a:gd name="connsiteY292" fmla="*/ 5938282 h 6857996"/>
              <a:gd name="connsiteX293" fmla="*/ 3147319 w 12191993"/>
              <a:gd name="connsiteY293" fmla="*/ 6102378 h 6857996"/>
              <a:gd name="connsiteX294" fmla="*/ 3178780 w 12191993"/>
              <a:gd name="connsiteY294" fmla="*/ 6102378 h 6857996"/>
              <a:gd name="connsiteX295" fmla="*/ 3178780 w 12191993"/>
              <a:gd name="connsiteY295" fmla="*/ 5938282 h 6857996"/>
              <a:gd name="connsiteX296" fmla="*/ 1955281 w 12191993"/>
              <a:gd name="connsiteY296" fmla="*/ 5936335 h 6857996"/>
              <a:gd name="connsiteX297" fmla="*/ 1876463 w 12191993"/>
              <a:gd name="connsiteY297" fmla="*/ 6021629 h 6857996"/>
              <a:gd name="connsiteX298" fmla="*/ 1960147 w 12191993"/>
              <a:gd name="connsiteY298" fmla="*/ 6106269 h 6857996"/>
              <a:gd name="connsiteX299" fmla="*/ 2017884 w 12191993"/>
              <a:gd name="connsiteY299" fmla="*/ 6083895 h 6857996"/>
              <a:gd name="connsiteX300" fmla="*/ 2010424 w 12191993"/>
              <a:gd name="connsiteY300" fmla="*/ 6072541 h 6857996"/>
              <a:gd name="connsiteX301" fmla="*/ 1960147 w 12191993"/>
              <a:gd name="connsiteY301" fmla="*/ 6092976 h 6857996"/>
              <a:gd name="connsiteX302" fmla="*/ 1890731 w 12191993"/>
              <a:gd name="connsiteY302" fmla="*/ 6019031 h 6857996"/>
              <a:gd name="connsiteX303" fmla="*/ 2020802 w 12191993"/>
              <a:gd name="connsiteY303" fmla="*/ 6019031 h 6857996"/>
              <a:gd name="connsiteX304" fmla="*/ 2021451 w 12191993"/>
              <a:gd name="connsiteY304" fmla="*/ 6010275 h 6857996"/>
              <a:gd name="connsiteX305" fmla="*/ 1955281 w 12191993"/>
              <a:gd name="connsiteY305" fmla="*/ 5936335 h 6857996"/>
              <a:gd name="connsiteX306" fmla="*/ 1642226 w 12191993"/>
              <a:gd name="connsiteY306" fmla="*/ 5936335 h 6857996"/>
              <a:gd name="connsiteX307" fmla="*/ 1583842 w 12191993"/>
              <a:gd name="connsiteY307" fmla="*/ 5972656 h 6857996"/>
              <a:gd name="connsiteX308" fmla="*/ 1583192 w 12191993"/>
              <a:gd name="connsiteY308" fmla="*/ 5972655 h 6857996"/>
              <a:gd name="connsiteX309" fmla="*/ 1584166 w 12191993"/>
              <a:gd name="connsiteY309" fmla="*/ 5959687 h 6857996"/>
              <a:gd name="connsiteX310" fmla="*/ 1584166 w 12191993"/>
              <a:gd name="connsiteY310" fmla="*/ 5940226 h 6857996"/>
              <a:gd name="connsiteX311" fmla="*/ 1570538 w 12191993"/>
              <a:gd name="connsiteY311" fmla="*/ 5940226 h 6857996"/>
              <a:gd name="connsiteX312" fmla="*/ 1570538 w 12191993"/>
              <a:gd name="connsiteY312" fmla="*/ 6167243 h 6857996"/>
              <a:gd name="connsiteX313" fmla="*/ 1584166 w 12191993"/>
              <a:gd name="connsiteY313" fmla="*/ 6167243 h 6857996"/>
              <a:gd name="connsiteX314" fmla="*/ 1584166 w 12191993"/>
              <a:gd name="connsiteY314" fmla="*/ 6083895 h 6857996"/>
              <a:gd name="connsiteX315" fmla="*/ 1582867 w 12191993"/>
              <a:gd name="connsiteY315" fmla="*/ 6069624 h 6857996"/>
              <a:gd name="connsiteX316" fmla="*/ 1583517 w 12191993"/>
              <a:gd name="connsiteY316" fmla="*/ 6069624 h 6857996"/>
              <a:gd name="connsiteX317" fmla="*/ 1640279 w 12191993"/>
              <a:gd name="connsiteY317" fmla="*/ 6106269 h 6857996"/>
              <a:gd name="connsiteX318" fmla="*/ 1712284 w 12191993"/>
              <a:gd name="connsiteY318" fmla="*/ 6021304 h 6857996"/>
              <a:gd name="connsiteX319" fmla="*/ 1642226 w 12191993"/>
              <a:gd name="connsiteY319" fmla="*/ 5936335 h 6857996"/>
              <a:gd name="connsiteX320" fmla="*/ 1489846 w 12191993"/>
              <a:gd name="connsiteY320" fmla="*/ 5936335 h 6857996"/>
              <a:gd name="connsiteX321" fmla="*/ 1437951 w 12191993"/>
              <a:gd name="connsiteY321" fmla="*/ 5980118 h 6857996"/>
              <a:gd name="connsiteX322" fmla="*/ 1527151 w 12191993"/>
              <a:gd name="connsiteY322" fmla="*/ 6062490 h 6857996"/>
              <a:gd name="connsiteX323" fmla="*/ 1489846 w 12191993"/>
              <a:gd name="connsiteY323" fmla="*/ 6092977 h 6857996"/>
              <a:gd name="connsiteX324" fmla="*/ 1439570 w 12191993"/>
              <a:gd name="connsiteY324" fmla="*/ 6072541 h 6857996"/>
              <a:gd name="connsiteX325" fmla="*/ 1430812 w 12191993"/>
              <a:gd name="connsiteY325" fmla="*/ 6082921 h 6857996"/>
              <a:gd name="connsiteX326" fmla="*/ 1489522 w 12191993"/>
              <a:gd name="connsiteY326" fmla="*/ 6106269 h 6857996"/>
              <a:gd name="connsiteX327" fmla="*/ 1541421 w 12191993"/>
              <a:gd name="connsiteY327" fmla="*/ 6062490 h 6857996"/>
              <a:gd name="connsiteX328" fmla="*/ 1452224 w 12191993"/>
              <a:gd name="connsiteY328" fmla="*/ 5979144 h 6857996"/>
              <a:gd name="connsiteX329" fmla="*/ 1488872 w 12191993"/>
              <a:gd name="connsiteY329" fmla="*/ 5949632 h 6857996"/>
              <a:gd name="connsiteX330" fmla="*/ 1529741 w 12191993"/>
              <a:gd name="connsiteY330" fmla="*/ 5964873 h 6857996"/>
              <a:gd name="connsiteX331" fmla="*/ 1537850 w 12191993"/>
              <a:gd name="connsiteY331" fmla="*/ 5953848 h 6857996"/>
              <a:gd name="connsiteX332" fmla="*/ 1489846 w 12191993"/>
              <a:gd name="connsiteY332" fmla="*/ 5936335 h 6857996"/>
              <a:gd name="connsiteX333" fmla="*/ 1352909 w 12191993"/>
              <a:gd name="connsiteY333" fmla="*/ 5936335 h 6857996"/>
              <a:gd name="connsiteX334" fmla="*/ 1284142 w 12191993"/>
              <a:gd name="connsiteY334" fmla="*/ 5982062 h 6857996"/>
              <a:gd name="connsiteX335" fmla="*/ 1283493 w 12191993"/>
              <a:gd name="connsiteY335" fmla="*/ 5982062 h 6857996"/>
              <a:gd name="connsiteX336" fmla="*/ 1284791 w 12191993"/>
              <a:gd name="connsiteY336" fmla="*/ 5968765 h 6857996"/>
              <a:gd name="connsiteX337" fmla="*/ 1284791 w 12191993"/>
              <a:gd name="connsiteY337" fmla="*/ 5940226 h 6857996"/>
              <a:gd name="connsiteX338" fmla="*/ 1271171 w 12191993"/>
              <a:gd name="connsiteY338" fmla="*/ 5940226 h 6857996"/>
              <a:gd name="connsiteX339" fmla="*/ 1271171 w 12191993"/>
              <a:gd name="connsiteY339" fmla="*/ 6102378 h 6857996"/>
              <a:gd name="connsiteX340" fmla="*/ 1284791 w 12191993"/>
              <a:gd name="connsiteY340" fmla="*/ 6102378 h 6857996"/>
              <a:gd name="connsiteX341" fmla="*/ 1284791 w 12191993"/>
              <a:gd name="connsiteY341" fmla="*/ 6023248 h 6857996"/>
              <a:gd name="connsiteX342" fmla="*/ 1287389 w 12191993"/>
              <a:gd name="connsiteY342" fmla="*/ 6001199 h 6857996"/>
              <a:gd name="connsiteX343" fmla="*/ 1352909 w 12191993"/>
              <a:gd name="connsiteY343" fmla="*/ 5949632 h 6857996"/>
              <a:gd name="connsiteX344" fmla="*/ 1392802 w 12191993"/>
              <a:gd name="connsiteY344" fmla="*/ 6004440 h 6857996"/>
              <a:gd name="connsiteX345" fmla="*/ 1392802 w 12191993"/>
              <a:gd name="connsiteY345" fmla="*/ 6102379 h 6857996"/>
              <a:gd name="connsiteX346" fmla="*/ 1406426 w 12191993"/>
              <a:gd name="connsiteY346" fmla="*/ 6102379 h 6857996"/>
              <a:gd name="connsiteX347" fmla="*/ 1406426 w 12191993"/>
              <a:gd name="connsiteY347" fmla="*/ 5999575 h 6857996"/>
              <a:gd name="connsiteX348" fmla="*/ 1352909 w 12191993"/>
              <a:gd name="connsiteY348" fmla="*/ 5936335 h 6857996"/>
              <a:gd name="connsiteX349" fmla="*/ 3474783 w 12191993"/>
              <a:gd name="connsiteY349" fmla="*/ 5934392 h 6857996"/>
              <a:gd name="connsiteX350" fmla="*/ 3413151 w 12191993"/>
              <a:gd name="connsiteY350" fmla="*/ 5972011 h 6857996"/>
              <a:gd name="connsiteX351" fmla="*/ 3412502 w 12191993"/>
              <a:gd name="connsiteY351" fmla="*/ 5972011 h 6857996"/>
              <a:gd name="connsiteX352" fmla="*/ 3413151 w 12191993"/>
              <a:gd name="connsiteY352" fmla="*/ 5960012 h 6857996"/>
              <a:gd name="connsiteX353" fmla="*/ 3413151 w 12191993"/>
              <a:gd name="connsiteY353" fmla="*/ 5938282 h 6857996"/>
              <a:gd name="connsiteX354" fmla="*/ 3382664 w 12191993"/>
              <a:gd name="connsiteY354" fmla="*/ 5938282 h 6857996"/>
              <a:gd name="connsiteX355" fmla="*/ 3382664 w 12191993"/>
              <a:gd name="connsiteY355" fmla="*/ 6102378 h 6857996"/>
              <a:gd name="connsiteX356" fmla="*/ 3414125 w 12191993"/>
              <a:gd name="connsiteY356" fmla="*/ 6102378 h 6857996"/>
              <a:gd name="connsiteX357" fmla="*/ 3414125 w 12191993"/>
              <a:gd name="connsiteY357" fmla="*/ 6025520 h 6857996"/>
              <a:gd name="connsiteX358" fmla="*/ 3416723 w 12191993"/>
              <a:gd name="connsiteY358" fmla="*/ 6003466 h 6857996"/>
              <a:gd name="connsiteX359" fmla="*/ 3468615 w 12191993"/>
              <a:gd name="connsiteY359" fmla="*/ 5963254 h 6857996"/>
              <a:gd name="connsiteX360" fmla="*/ 3499759 w 12191993"/>
              <a:gd name="connsiteY360" fmla="*/ 6004440 h 6857996"/>
              <a:gd name="connsiteX361" fmla="*/ 3499759 w 12191993"/>
              <a:gd name="connsiteY361" fmla="*/ 6102378 h 6857996"/>
              <a:gd name="connsiteX362" fmla="*/ 3531220 w 12191993"/>
              <a:gd name="connsiteY362" fmla="*/ 6102378 h 6857996"/>
              <a:gd name="connsiteX363" fmla="*/ 3531220 w 12191993"/>
              <a:gd name="connsiteY363" fmla="*/ 5997307 h 6857996"/>
              <a:gd name="connsiteX364" fmla="*/ 3474783 w 12191993"/>
              <a:gd name="connsiteY364" fmla="*/ 5934392 h 6857996"/>
              <a:gd name="connsiteX365" fmla="*/ 3717650 w 12191993"/>
              <a:gd name="connsiteY365" fmla="*/ 5934391 h 6857996"/>
              <a:gd name="connsiteX366" fmla="*/ 3658292 w 12191993"/>
              <a:gd name="connsiteY366" fmla="*/ 5981088 h 6857996"/>
              <a:gd name="connsiteX367" fmla="*/ 3742624 w 12191993"/>
              <a:gd name="connsiteY367" fmla="*/ 6058599 h 6857996"/>
              <a:gd name="connsiteX368" fmla="*/ 3715378 w 12191993"/>
              <a:gd name="connsiteY368" fmla="*/ 6079030 h 6857996"/>
              <a:gd name="connsiteX369" fmla="*/ 3668348 w 12191993"/>
              <a:gd name="connsiteY369" fmla="*/ 6059893 h 6857996"/>
              <a:gd name="connsiteX370" fmla="*/ 3653097 w 12191993"/>
              <a:gd name="connsiteY370" fmla="*/ 6082272 h 6857996"/>
              <a:gd name="connsiteX371" fmla="*/ 3715378 w 12191993"/>
              <a:gd name="connsiteY371" fmla="*/ 6106270 h 6857996"/>
              <a:gd name="connsiteX372" fmla="*/ 3774736 w 12191993"/>
              <a:gd name="connsiteY372" fmla="*/ 6058599 h 6857996"/>
              <a:gd name="connsiteX373" fmla="*/ 3690402 w 12191993"/>
              <a:gd name="connsiteY373" fmla="*/ 5981737 h 6857996"/>
              <a:gd name="connsiteX374" fmla="*/ 3717325 w 12191993"/>
              <a:gd name="connsiteY374" fmla="*/ 5961631 h 6857996"/>
              <a:gd name="connsiteX375" fmla="*/ 3757869 w 12191993"/>
              <a:gd name="connsiteY375" fmla="*/ 5976226 h 6857996"/>
              <a:gd name="connsiteX376" fmla="*/ 3770514 w 12191993"/>
              <a:gd name="connsiteY376" fmla="*/ 5952550 h 6857996"/>
              <a:gd name="connsiteX377" fmla="*/ 3717650 w 12191993"/>
              <a:gd name="connsiteY377" fmla="*/ 5934391 h 6857996"/>
              <a:gd name="connsiteX378" fmla="*/ 3285715 w 12191993"/>
              <a:gd name="connsiteY378" fmla="*/ 5934391 h 6857996"/>
              <a:gd name="connsiteX379" fmla="*/ 3203653 w 12191993"/>
              <a:gd name="connsiteY379" fmla="*/ 6020331 h 6857996"/>
              <a:gd name="connsiteX380" fmla="*/ 3290585 w 12191993"/>
              <a:gd name="connsiteY380" fmla="*/ 6106270 h 6857996"/>
              <a:gd name="connsiteX381" fmla="*/ 3354158 w 12191993"/>
              <a:gd name="connsiteY381" fmla="*/ 6082921 h 6857996"/>
              <a:gd name="connsiteX382" fmla="*/ 3341187 w 12191993"/>
              <a:gd name="connsiteY382" fmla="*/ 6059893 h 6857996"/>
              <a:gd name="connsiteX383" fmla="*/ 3292526 w 12191993"/>
              <a:gd name="connsiteY383" fmla="*/ 6079030 h 6857996"/>
              <a:gd name="connsiteX384" fmla="*/ 3236088 w 12191993"/>
              <a:gd name="connsiteY384" fmla="*/ 6024871 h 6857996"/>
              <a:gd name="connsiteX385" fmla="*/ 3355781 w 12191993"/>
              <a:gd name="connsiteY385" fmla="*/ 6024871 h 6857996"/>
              <a:gd name="connsiteX386" fmla="*/ 3356754 w 12191993"/>
              <a:gd name="connsiteY386" fmla="*/ 6011249 h 6857996"/>
              <a:gd name="connsiteX387" fmla="*/ 3285715 w 12191993"/>
              <a:gd name="connsiteY387" fmla="*/ 5934391 h 6857996"/>
              <a:gd name="connsiteX388" fmla="*/ 2953524 w 12191993"/>
              <a:gd name="connsiteY388" fmla="*/ 5934391 h 6857996"/>
              <a:gd name="connsiteX389" fmla="*/ 2892217 w 12191993"/>
              <a:gd name="connsiteY389" fmla="*/ 5953848 h 6857996"/>
              <a:gd name="connsiteX390" fmla="*/ 2905189 w 12191993"/>
              <a:gd name="connsiteY390" fmla="*/ 5976872 h 6857996"/>
              <a:gd name="connsiteX391" fmla="*/ 2950927 w 12191993"/>
              <a:gd name="connsiteY391" fmla="*/ 5960982 h 6857996"/>
              <a:gd name="connsiteX392" fmla="*/ 2986934 w 12191993"/>
              <a:gd name="connsiteY392" fmla="*/ 5996982 h 6857996"/>
              <a:gd name="connsiteX393" fmla="*/ 2986934 w 12191993"/>
              <a:gd name="connsiteY393" fmla="*/ 5999900 h 6857996"/>
              <a:gd name="connsiteX394" fmla="*/ 2979791 w 12191993"/>
              <a:gd name="connsiteY394" fmla="*/ 5999900 h 6857996"/>
              <a:gd name="connsiteX395" fmla="*/ 2880862 w 12191993"/>
              <a:gd name="connsiteY395" fmla="*/ 6056327 h 6857996"/>
              <a:gd name="connsiteX396" fmla="*/ 2936658 w 12191993"/>
              <a:gd name="connsiteY396" fmla="*/ 6106270 h 6857996"/>
              <a:gd name="connsiteX397" fmla="*/ 2989199 w 12191993"/>
              <a:gd name="connsiteY397" fmla="*/ 6073840 h 6857996"/>
              <a:gd name="connsiteX398" fmla="*/ 2989847 w 12191993"/>
              <a:gd name="connsiteY398" fmla="*/ 6073840 h 6857996"/>
              <a:gd name="connsiteX399" fmla="*/ 2989199 w 12191993"/>
              <a:gd name="connsiteY399" fmla="*/ 6086813 h 6857996"/>
              <a:gd name="connsiteX400" fmla="*/ 2989199 w 12191993"/>
              <a:gd name="connsiteY400" fmla="*/ 6102379 h 6857996"/>
              <a:gd name="connsiteX401" fmla="*/ 3018394 w 12191993"/>
              <a:gd name="connsiteY401" fmla="*/ 6102379 h 6857996"/>
              <a:gd name="connsiteX402" fmla="*/ 3018394 w 12191993"/>
              <a:gd name="connsiteY402" fmla="*/ 5998601 h 6857996"/>
              <a:gd name="connsiteX403" fmla="*/ 2953524 w 12191993"/>
              <a:gd name="connsiteY403" fmla="*/ 5934391 h 6857996"/>
              <a:gd name="connsiteX404" fmla="*/ 2796867 w 12191993"/>
              <a:gd name="connsiteY404" fmla="*/ 5934391 h 6857996"/>
              <a:gd name="connsiteX405" fmla="*/ 2741721 w 12191993"/>
              <a:gd name="connsiteY405" fmla="*/ 5964227 h 6857996"/>
              <a:gd name="connsiteX406" fmla="*/ 2741072 w 12191993"/>
              <a:gd name="connsiteY406" fmla="*/ 5964227 h 6857996"/>
              <a:gd name="connsiteX407" fmla="*/ 2741721 w 12191993"/>
              <a:gd name="connsiteY407" fmla="*/ 5952224 h 6857996"/>
              <a:gd name="connsiteX408" fmla="*/ 2741721 w 12191993"/>
              <a:gd name="connsiteY408" fmla="*/ 5938282 h 6857996"/>
              <a:gd name="connsiteX409" fmla="*/ 2712857 w 12191993"/>
              <a:gd name="connsiteY409" fmla="*/ 5938282 h 6857996"/>
              <a:gd name="connsiteX410" fmla="*/ 2712857 w 12191993"/>
              <a:gd name="connsiteY410" fmla="*/ 6167243 h 6857996"/>
              <a:gd name="connsiteX411" fmla="*/ 2744318 w 12191993"/>
              <a:gd name="connsiteY411" fmla="*/ 6167243 h 6857996"/>
              <a:gd name="connsiteX412" fmla="*/ 2744318 w 12191993"/>
              <a:gd name="connsiteY412" fmla="*/ 6093620 h 6857996"/>
              <a:gd name="connsiteX413" fmla="*/ 2743669 w 12191993"/>
              <a:gd name="connsiteY413" fmla="*/ 6079354 h 6857996"/>
              <a:gd name="connsiteX414" fmla="*/ 2744318 w 12191993"/>
              <a:gd name="connsiteY414" fmla="*/ 6079354 h 6857996"/>
              <a:gd name="connsiteX415" fmla="*/ 2794595 w 12191993"/>
              <a:gd name="connsiteY415" fmla="*/ 6106269 h 6857996"/>
              <a:gd name="connsiteX416" fmla="*/ 2868873 w 12191993"/>
              <a:gd name="connsiteY416" fmla="*/ 6020330 h 6857996"/>
              <a:gd name="connsiteX417" fmla="*/ 2796867 w 12191993"/>
              <a:gd name="connsiteY417" fmla="*/ 5934391 h 6857996"/>
              <a:gd name="connsiteX418" fmla="*/ 3568802 w 12191993"/>
              <a:gd name="connsiteY418" fmla="*/ 5893205 h 6857996"/>
              <a:gd name="connsiteX419" fmla="*/ 3568802 w 12191993"/>
              <a:gd name="connsiteY419" fmla="*/ 5940551 h 6857996"/>
              <a:gd name="connsiteX420" fmla="*/ 3546424 w 12191993"/>
              <a:gd name="connsiteY420" fmla="*/ 5940551 h 6857996"/>
              <a:gd name="connsiteX421" fmla="*/ 3546424 w 12191993"/>
              <a:gd name="connsiteY421" fmla="*/ 5965847 h 6857996"/>
              <a:gd name="connsiteX422" fmla="*/ 3567829 w 12191993"/>
              <a:gd name="connsiteY422" fmla="*/ 5965847 h 6857996"/>
              <a:gd name="connsiteX423" fmla="*/ 3567829 w 12191993"/>
              <a:gd name="connsiteY423" fmla="*/ 6042385 h 6857996"/>
              <a:gd name="connsiteX424" fmla="*/ 3630758 w 12191993"/>
              <a:gd name="connsiteY424" fmla="*/ 6103676 h 6857996"/>
              <a:gd name="connsiteX425" fmla="*/ 3641789 w 12191993"/>
              <a:gd name="connsiteY425" fmla="*/ 6103027 h 6857996"/>
              <a:gd name="connsiteX426" fmla="*/ 3641789 w 12191993"/>
              <a:gd name="connsiteY426" fmla="*/ 6075138 h 6857996"/>
              <a:gd name="connsiteX427" fmla="*/ 3634322 w 12191993"/>
              <a:gd name="connsiteY427" fmla="*/ 6075788 h 6857996"/>
              <a:gd name="connsiteX428" fmla="*/ 3599298 w 12191993"/>
              <a:gd name="connsiteY428" fmla="*/ 6038817 h 6857996"/>
              <a:gd name="connsiteX429" fmla="*/ 3599298 w 12191993"/>
              <a:gd name="connsiteY429" fmla="*/ 5965847 h 6857996"/>
              <a:gd name="connsiteX430" fmla="*/ 3638867 w 12191993"/>
              <a:gd name="connsiteY430" fmla="*/ 5965847 h 6857996"/>
              <a:gd name="connsiteX431" fmla="*/ 3638867 w 12191993"/>
              <a:gd name="connsiteY431" fmla="*/ 5940551 h 6857996"/>
              <a:gd name="connsiteX432" fmla="*/ 3599298 w 12191993"/>
              <a:gd name="connsiteY432" fmla="*/ 5940551 h 6857996"/>
              <a:gd name="connsiteX433" fmla="*/ 3599298 w 12191993"/>
              <a:gd name="connsiteY433" fmla="*/ 5893205 h 6857996"/>
              <a:gd name="connsiteX434" fmla="*/ 3055985 w 12191993"/>
              <a:gd name="connsiteY434" fmla="*/ 5893205 h 6857996"/>
              <a:gd name="connsiteX435" fmla="*/ 3055985 w 12191993"/>
              <a:gd name="connsiteY435" fmla="*/ 5940551 h 6857996"/>
              <a:gd name="connsiteX436" fmla="*/ 3033606 w 12191993"/>
              <a:gd name="connsiteY436" fmla="*/ 5940551 h 6857996"/>
              <a:gd name="connsiteX437" fmla="*/ 3033606 w 12191993"/>
              <a:gd name="connsiteY437" fmla="*/ 5965847 h 6857996"/>
              <a:gd name="connsiteX438" fmla="*/ 3055012 w 12191993"/>
              <a:gd name="connsiteY438" fmla="*/ 5965847 h 6857996"/>
              <a:gd name="connsiteX439" fmla="*/ 3055012 w 12191993"/>
              <a:gd name="connsiteY439" fmla="*/ 6042385 h 6857996"/>
              <a:gd name="connsiteX440" fmla="*/ 3117934 w 12191993"/>
              <a:gd name="connsiteY440" fmla="*/ 6103676 h 6857996"/>
              <a:gd name="connsiteX441" fmla="*/ 3128964 w 12191993"/>
              <a:gd name="connsiteY441" fmla="*/ 6103027 h 6857996"/>
              <a:gd name="connsiteX442" fmla="*/ 3128964 w 12191993"/>
              <a:gd name="connsiteY442" fmla="*/ 6075138 h 6857996"/>
              <a:gd name="connsiteX443" fmla="*/ 3121505 w 12191993"/>
              <a:gd name="connsiteY443" fmla="*/ 6075788 h 6857996"/>
              <a:gd name="connsiteX444" fmla="*/ 3086473 w 12191993"/>
              <a:gd name="connsiteY444" fmla="*/ 6038817 h 6857996"/>
              <a:gd name="connsiteX445" fmla="*/ 3086473 w 12191993"/>
              <a:gd name="connsiteY445" fmla="*/ 5965847 h 6857996"/>
              <a:gd name="connsiteX446" fmla="*/ 3126043 w 12191993"/>
              <a:gd name="connsiteY446" fmla="*/ 5965847 h 6857996"/>
              <a:gd name="connsiteX447" fmla="*/ 3126043 w 12191993"/>
              <a:gd name="connsiteY447" fmla="*/ 5940551 h 6857996"/>
              <a:gd name="connsiteX448" fmla="*/ 3086473 w 12191993"/>
              <a:gd name="connsiteY448" fmla="*/ 5940551 h 6857996"/>
              <a:gd name="connsiteX449" fmla="*/ 3086473 w 12191993"/>
              <a:gd name="connsiteY449" fmla="*/ 5893205 h 6857996"/>
              <a:gd name="connsiteX450" fmla="*/ 2318901 w 12191993"/>
              <a:gd name="connsiteY450" fmla="*/ 5875367 h 6857996"/>
              <a:gd name="connsiteX451" fmla="*/ 2318901 w 12191993"/>
              <a:gd name="connsiteY451" fmla="*/ 6102378 h 6857996"/>
              <a:gd name="connsiteX452" fmla="*/ 2332529 w 12191993"/>
              <a:gd name="connsiteY452" fmla="*/ 6102378 h 6857996"/>
              <a:gd name="connsiteX453" fmla="*/ 2332529 w 12191993"/>
              <a:gd name="connsiteY453" fmla="*/ 6083895 h 6857996"/>
              <a:gd name="connsiteX454" fmla="*/ 2331230 w 12191993"/>
              <a:gd name="connsiteY454" fmla="*/ 6069624 h 6857996"/>
              <a:gd name="connsiteX455" fmla="*/ 2331880 w 12191993"/>
              <a:gd name="connsiteY455" fmla="*/ 6069624 h 6857996"/>
              <a:gd name="connsiteX456" fmla="*/ 2387992 w 12191993"/>
              <a:gd name="connsiteY456" fmla="*/ 6106270 h 6857996"/>
              <a:gd name="connsiteX457" fmla="*/ 2460646 w 12191993"/>
              <a:gd name="connsiteY457" fmla="*/ 6021305 h 6857996"/>
              <a:gd name="connsiteX458" fmla="*/ 2390589 w 12191993"/>
              <a:gd name="connsiteY458" fmla="*/ 5936335 h 6857996"/>
              <a:gd name="connsiteX459" fmla="*/ 2331880 w 12191993"/>
              <a:gd name="connsiteY459" fmla="*/ 5972980 h 6857996"/>
              <a:gd name="connsiteX460" fmla="*/ 2331230 w 12191993"/>
              <a:gd name="connsiteY460" fmla="*/ 5972980 h 6857996"/>
              <a:gd name="connsiteX461" fmla="*/ 2332529 w 12191993"/>
              <a:gd name="connsiteY461" fmla="*/ 5959687 h 6857996"/>
              <a:gd name="connsiteX462" fmla="*/ 2332529 w 12191993"/>
              <a:gd name="connsiteY462" fmla="*/ 5875367 h 6857996"/>
              <a:gd name="connsiteX463" fmla="*/ 2171335 w 12191993"/>
              <a:gd name="connsiteY463" fmla="*/ 5875367 h 6857996"/>
              <a:gd name="connsiteX464" fmla="*/ 2171335 w 12191993"/>
              <a:gd name="connsiteY464" fmla="*/ 5959687 h 6857996"/>
              <a:gd name="connsiteX465" fmla="*/ 2172633 w 12191993"/>
              <a:gd name="connsiteY465" fmla="*/ 5972980 h 6857996"/>
              <a:gd name="connsiteX466" fmla="*/ 2171984 w 12191993"/>
              <a:gd name="connsiteY466" fmla="*/ 5972980 h 6857996"/>
              <a:gd name="connsiteX467" fmla="*/ 2115863 w 12191993"/>
              <a:gd name="connsiteY467" fmla="*/ 5936335 h 6857996"/>
              <a:gd name="connsiteX468" fmla="*/ 2043207 w 12191993"/>
              <a:gd name="connsiteY468" fmla="*/ 6021305 h 6857996"/>
              <a:gd name="connsiteX469" fmla="*/ 2113275 w 12191993"/>
              <a:gd name="connsiteY469" fmla="*/ 6106270 h 6857996"/>
              <a:gd name="connsiteX470" fmla="*/ 2171984 w 12191993"/>
              <a:gd name="connsiteY470" fmla="*/ 6069624 h 6857996"/>
              <a:gd name="connsiteX471" fmla="*/ 2172633 w 12191993"/>
              <a:gd name="connsiteY471" fmla="*/ 6069624 h 6857996"/>
              <a:gd name="connsiteX472" fmla="*/ 2171335 w 12191993"/>
              <a:gd name="connsiteY472" fmla="*/ 6081948 h 6857996"/>
              <a:gd name="connsiteX473" fmla="*/ 2171335 w 12191993"/>
              <a:gd name="connsiteY473" fmla="*/ 6102378 h 6857996"/>
              <a:gd name="connsiteX474" fmla="*/ 2184955 w 12191993"/>
              <a:gd name="connsiteY474" fmla="*/ 6102378 h 6857996"/>
              <a:gd name="connsiteX475" fmla="*/ 2184955 w 12191993"/>
              <a:gd name="connsiteY475" fmla="*/ 5875367 h 6857996"/>
              <a:gd name="connsiteX476" fmla="*/ 1743547 w 12191993"/>
              <a:gd name="connsiteY476" fmla="*/ 5875367 h 6857996"/>
              <a:gd name="connsiteX477" fmla="*/ 1743547 w 12191993"/>
              <a:gd name="connsiteY477" fmla="*/ 5899040 h 6857996"/>
              <a:gd name="connsiteX478" fmla="*/ 1759765 w 12191993"/>
              <a:gd name="connsiteY478" fmla="*/ 5899040 h 6857996"/>
              <a:gd name="connsiteX479" fmla="*/ 1759765 w 12191993"/>
              <a:gd name="connsiteY479" fmla="*/ 5875367 h 6857996"/>
              <a:gd name="connsiteX480" fmla="*/ 1209673 w 12191993"/>
              <a:gd name="connsiteY480" fmla="*/ 5875367 h 6857996"/>
              <a:gd name="connsiteX481" fmla="*/ 1209673 w 12191993"/>
              <a:gd name="connsiteY481" fmla="*/ 6102378 h 6857996"/>
              <a:gd name="connsiteX482" fmla="*/ 1223622 w 12191993"/>
              <a:gd name="connsiteY482" fmla="*/ 6102378 h 6857996"/>
              <a:gd name="connsiteX483" fmla="*/ 1223622 w 12191993"/>
              <a:gd name="connsiteY483" fmla="*/ 5875367 h 6857996"/>
              <a:gd name="connsiteX484" fmla="*/ 740045 w 12191993"/>
              <a:gd name="connsiteY484" fmla="*/ 5875367 h 6857996"/>
              <a:gd name="connsiteX485" fmla="*/ 982628 w 12191993"/>
              <a:gd name="connsiteY485" fmla="*/ 6117904 h 6857996"/>
              <a:gd name="connsiteX486" fmla="*/ 982620 w 12191993"/>
              <a:gd name="connsiteY486" fmla="*/ 5875367 h 6857996"/>
              <a:gd name="connsiteX487" fmla="*/ 407989 w 12191993"/>
              <a:gd name="connsiteY487" fmla="*/ 5875366 h 6857996"/>
              <a:gd name="connsiteX488" fmla="*/ 407989 w 12191993"/>
              <a:gd name="connsiteY488" fmla="*/ 6117901 h 6857996"/>
              <a:gd name="connsiteX489" fmla="*/ 650560 w 12191993"/>
              <a:gd name="connsiteY489" fmla="*/ 5875366 h 6857996"/>
              <a:gd name="connsiteX490" fmla="*/ 693449 w 12191993"/>
              <a:gd name="connsiteY490" fmla="*/ 5875365 h 6857996"/>
              <a:gd name="connsiteX491" fmla="*/ 693449 w 12191993"/>
              <a:gd name="connsiteY491" fmla="*/ 6106201 h 6857996"/>
              <a:gd name="connsiteX492" fmla="*/ 685251 w 12191993"/>
              <a:gd name="connsiteY492" fmla="*/ 6106201 h 6857996"/>
              <a:gd name="connsiteX493" fmla="*/ 685251 w 12191993"/>
              <a:gd name="connsiteY493" fmla="*/ 6178022 h 6857996"/>
              <a:gd name="connsiteX494" fmla="*/ 655495 w 12191993"/>
              <a:gd name="connsiteY494" fmla="*/ 6178022 h 6857996"/>
              <a:gd name="connsiteX495" fmla="*/ 655495 w 12191993"/>
              <a:gd name="connsiteY495" fmla="*/ 6106201 h 6857996"/>
              <a:gd name="connsiteX496" fmla="*/ 617524 w 12191993"/>
              <a:gd name="connsiteY496" fmla="*/ 6106201 h 6857996"/>
              <a:gd name="connsiteX497" fmla="*/ 617524 w 12191993"/>
              <a:gd name="connsiteY497" fmla="*/ 6219053 h 6857996"/>
              <a:gd name="connsiteX498" fmla="*/ 693449 w 12191993"/>
              <a:gd name="connsiteY498" fmla="*/ 6219053 h 6857996"/>
              <a:gd name="connsiteX499" fmla="*/ 693449 w 12191993"/>
              <a:gd name="connsiteY499" fmla="*/ 6449904 h 6857996"/>
              <a:gd name="connsiteX500" fmla="*/ 697158 w 12191993"/>
              <a:gd name="connsiteY500" fmla="*/ 6449904 h 6857996"/>
              <a:gd name="connsiteX501" fmla="*/ 697158 w 12191993"/>
              <a:gd name="connsiteY501" fmla="*/ 6219053 h 6857996"/>
              <a:gd name="connsiteX502" fmla="*/ 726288 w 12191993"/>
              <a:gd name="connsiteY502" fmla="*/ 6219053 h 6857996"/>
              <a:gd name="connsiteX503" fmla="*/ 726288 w 12191993"/>
              <a:gd name="connsiteY503" fmla="*/ 6106201 h 6857996"/>
              <a:gd name="connsiteX504" fmla="*/ 697158 w 12191993"/>
              <a:gd name="connsiteY504" fmla="*/ 6106201 h 6857996"/>
              <a:gd name="connsiteX505" fmla="*/ 697154 w 12191993"/>
              <a:gd name="connsiteY505" fmla="*/ 5875365 h 6857996"/>
              <a:gd name="connsiteX506" fmla="*/ 3146995 w 12191993"/>
              <a:gd name="connsiteY506" fmla="*/ 5873419 h 6857996"/>
              <a:gd name="connsiteX507" fmla="*/ 3146995 w 12191993"/>
              <a:gd name="connsiteY507" fmla="*/ 5905528 h 6857996"/>
              <a:gd name="connsiteX508" fmla="*/ 3178780 w 12191993"/>
              <a:gd name="connsiteY508" fmla="*/ 5905528 h 6857996"/>
              <a:gd name="connsiteX509" fmla="*/ 3178780 w 12191993"/>
              <a:gd name="connsiteY509" fmla="*/ 5873419 h 6857996"/>
              <a:gd name="connsiteX510" fmla="*/ 5074981 w 12191993"/>
              <a:gd name="connsiteY510" fmla="*/ 3974428 h 6857996"/>
              <a:gd name="connsiteX511" fmla="*/ 7530588 w 12191993"/>
              <a:gd name="connsiteY511" fmla="*/ 6429546 h 6857996"/>
              <a:gd name="connsiteX512" fmla="*/ 5074981 w 12191993"/>
              <a:gd name="connsiteY512" fmla="*/ 6429546 h 6857996"/>
              <a:gd name="connsiteX513" fmla="*/ 11122964 w 12191993"/>
              <a:gd name="connsiteY513" fmla="*/ 3974190 h 6857996"/>
              <a:gd name="connsiteX514" fmla="*/ 11122964 w 12191993"/>
              <a:gd name="connsiteY514" fmla="*/ 6429463 h 6857996"/>
              <a:gd name="connsiteX515" fmla="*/ 8666920 w 12191993"/>
              <a:gd name="connsiteY515" fmla="*/ 6429463 h 6857996"/>
              <a:gd name="connsiteX516" fmla="*/ 11122964 w 12191993"/>
              <a:gd name="connsiteY516" fmla="*/ 3974190 h 6857996"/>
              <a:gd name="connsiteX517" fmla="*/ 5074885 w 12191993"/>
              <a:gd name="connsiteY517" fmla="*/ 3877086 h 6857996"/>
              <a:gd name="connsiteX518" fmla="*/ 5058713 w 12191993"/>
              <a:gd name="connsiteY518" fmla="*/ 3878325 h 6857996"/>
              <a:gd name="connsiteX519" fmla="*/ 5058713 w 12191993"/>
              <a:gd name="connsiteY519" fmla="*/ 6445810 h 6857996"/>
              <a:gd name="connsiteX520" fmla="*/ 7626641 w 12191993"/>
              <a:gd name="connsiteY520" fmla="*/ 6445810 h 6857996"/>
              <a:gd name="connsiteX521" fmla="*/ 7627884 w 12191993"/>
              <a:gd name="connsiteY521" fmla="*/ 6429641 h 6857996"/>
              <a:gd name="connsiteX522" fmla="*/ 5074885 w 12191993"/>
              <a:gd name="connsiteY522" fmla="*/ 3877086 h 6857996"/>
              <a:gd name="connsiteX523" fmla="*/ 11123059 w 12191993"/>
              <a:gd name="connsiteY523" fmla="*/ 3876995 h 6857996"/>
              <a:gd name="connsiteX524" fmla="*/ 8569625 w 12191993"/>
              <a:gd name="connsiteY524" fmla="*/ 6429558 h 6857996"/>
              <a:gd name="connsiteX525" fmla="*/ 8570868 w 12191993"/>
              <a:gd name="connsiteY525" fmla="*/ 6445727 h 6857996"/>
              <a:gd name="connsiteX526" fmla="*/ 11139231 w 12191993"/>
              <a:gd name="connsiteY526" fmla="*/ 6445727 h 6857996"/>
              <a:gd name="connsiteX527" fmla="*/ 11139231 w 12191993"/>
              <a:gd name="connsiteY527" fmla="*/ 3878238 h 6857996"/>
              <a:gd name="connsiteX528" fmla="*/ 5074862 w 12191993"/>
              <a:gd name="connsiteY528" fmla="*/ 382592 h 6857996"/>
              <a:gd name="connsiteX529" fmla="*/ 7530485 w 12191993"/>
              <a:gd name="connsiteY529" fmla="*/ 382592 h 6857996"/>
              <a:gd name="connsiteX530" fmla="*/ 5074862 w 12191993"/>
              <a:gd name="connsiteY530" fmla="*/ 2838143 h 6857996"/>
              <a:gd name="connsiteX531" fmla="*/ 8666781 w 12191993"/>
              <a:gd name="connsiteY531" fmla="*/ 382485 h 6857996"/>
              <a:gd name="connsiteX532" fmla="*/ 11122821 w 12191993"/>
              <a:gd name="connsiteY532" fmla="*/ 382485 h 6857996"/>
              <a:gd name="connsiteX533" fmla="*/ 11122821 w 12191993"/>
              <a:gd name="connsiteY533" fmla="*/ 2838196 h 6857996"/>
              <a:gd name="connsiteX534" fmla="*/ 8666781 w 12191993"/>
              <a:gd name="connsiteY534" fmla="*/ 382485 h 6857996"/>
              <a:gd name="connsiteX535" fmla="*/ 5058594 w 12191993"/>
              <a:gd name="connsiteY535" fmla="*/ 366328 h 6857996"/>
              <a:gd name="connsiteX536" fmla="*/ 5058594 w 12191993"/>
              <a:gd name="connsiteY536" fmla="*/ 2934247 h 6857996"/>
              <a:gd name="connsiteX537" fmla="*/ 5074766 w 12191993"/>
              <a:gd name="connsiteY537" fmla="*/ 2935488 h 6857996"/>
              <a:gd name="connsiteX538" fmla="*/ 7627761 w 12191993"/>
              <a:gd name="connsiteY538" fmla="*/ 382497 h 6857996"/>
              <a:gd name="connsiteX539" fmla="*/ 7626518 w 12191993"/>
              <a:gd name="connsiteY539" fmla="*/ 366328 h 6857996"/>
              <a:gd name="connsiteX540" fmla="*/ 8570721 w 12191993"/>
              <a:gd name="connsiteY540" fmla="*/ 366221 h 6857996"/>
              <a:gd name="connsiteX541" fmla="*/ 8569478 w 12191993"/>
              <a:gd name="connsiteY541" fmla="*/ 382390 h 6857996"/>
              <a:gd name="connsiteX542" fmla="*/ 11122916 w 12191993"/>
              <a:gd name="connsiteY542" fmla="*/ 2935381 h 6857996"/>
              <a:gd name="connsiteX543" fmla="*/ 11139088 w 12191993"/>
              <a:gd name="connsiteY543" fmla="*/ 2934139 h 6857996"/>
              <a:gd name="connsiteX544" fmla="*/ 11139088 w 12191993"/>
              <a:gd name="connsiteY544" fmla="*/ 366221 h 6857996"/>
              <a:gd name="connsiteX545" fmla="*/ 0 w 12191993"/>
              <a:gd name="connsiteY545" fmla="*/ 0 h 6857996"/>
              <a:gd name="connsiteX546" fmla="*/ 12191993 w 12191993"/>
              <a:gd name="connsiteY546" fmla="*/ 0 h 6857996"/>
              <a:gd name="connsiteX547" fmla="*/ 12191993 w 12191993"/>
              <a:gd name="connsiteY547" fmla="*/ 6857996 h 6857996"/>
              <a:gd name="connsiteX548" fmla="*/ 0 w 12191993"/>
              <a:gd name="connsiteY548" fmla="*/ 6857996 h 68579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</a:cxnLst>
            <a:rect l="l" t="t" r="r" b="b"/>
            <a:pathLst>
              <a:path w="12191993" h="6857996">
                <a:moveTo>
                  <a:pt x="3578903" y="6416506"/>
                </a:moveTo>
                <a:lnTo>
                  <a:pt x="3578903" y="6449909"/>
                </a:lnTo>
                <a:lnTo>
                  <a:pt x="3611987" y="6449909"/>
                </a:lnTo>
                <a:lnTo>
                  <a:pt x="3611987" y="6416506"/>
                </a:lnTo>
                <a:close/>
                <a:moveTo>
                  <a:pt x="3481994" y="6306894"/>
                </a:moveTo>
                <a:cubicBezTo>
                  <a:pt x="3503073" y="6306894"/>
                  <a:pt x="3520589" y="6320511"/>
                  <a:pt x="3521564" y="6348729"/>
                </a:cubicBezTo>
                <a:lnTo>
                  <a:pt x="3433990" y="6348729"/>
                </a:lnTo>
                <a:cubicBezTo>
                  <a:pt x="3438527" y="6321810"/>
                  <a:pt x="3457992" y="6306894"/>
                  <a:pt x="3481994" y="6306894"/>
                </a:cubicBezTo>
                <a:close/>
                <a:moveTo>
                  <a:pt x="2971631" y="6306894"/>
                </a:moveTo>
                <a:cubicBezTo>
                  <a:pt x="2992711" y="6306894"/>
                  <a:pt x="3010227" y="6320511"/>
                  <a:pt x="3011201" y="6348729"/>
                </a:cubicBezTo>
                <a:lnTo>
                  <a:pt x="2923627" y="6348729"/>
                </a:lnTo>
                <a:cubicBezTo>
                  <a:pt x="2928165" y="6321810"/>
                  <a:pt x="2947629" y="6306894"/>
                  <a:pt x="2971631" y="6306894"/>
                </a:cubicBezTo>
                <a:close/>
                <a:moveTo>
                  <a:pt x="2218851" y="6297163"/>
                </a:moveTo>
                <a:cubicBezTo>
                  <a:pt x="2251936" y="6297163"/>
                  <a:pt x="2275288" y="6325052"/>
                  <a:pt x="2275288" y="6368835"/>
                </a:cubicBezTo>
                <a:cubicBezTo>
                  <a:pt x="2275288" y="6414238"/>
                  <a:pt x="2249338" y="6440507"/>
                  <a:pt x="2217552" y="6440507"/>
                </a:cubicBezTo>
                <a:cubicBezTo>
                  <a:pt x="2179598" y="6440507"/>
                  <a:pt x="2161116" y="6405156"/>
                  <a:pt x="2161116" y="6369160"/>
                </a:cubicBezTo>
                <a:cubicBezTo>
                  <a:pt x="2161116" y="6318243"/>
                  <a:pt x="2189006" y="6297163"/>
                  <a:pt x="2218851" y="6297163"/>
                </a:cubicBezTo>
                <a:close/>
                <a:moveTo>
                  <a:pt x="1782667" y="6296514"/>
                </a:moveTo>
                <a:cubicBezTo>
                  <a:pt x="1809586" y="6296514"/>
                  <a:pt x="1833268" y="6314352"/>
                  <a:pt x="1834887" y="6353915"/>
                </a:cubicBezTo>
                <a:lnTo>
                  <a:pt x="1719416" y="6353915"/>
                </a:lnTo>
                <a:cubicBezTo>
                  <a:pt x="1725256" y="6315975"/>
                  <a:pt x="1752825" y="6296514"/>
                  <a:pt x="1782667" y="6296514"/>
                </a:cubicBezTo>
                <a:close/>
                <a:moveTo>
                  <a:pt x="2293320" y="6287757"/>
                </a:moveTo>
                <a:lnTo>
                  <a:pt x="2360462" y="6448936"/>
                </a:lnTo>
                <a:lnTo>
                  <a:pt x="2348783" y="6475855"/>
                </a:lnTo>
                <a:cubicBezTo>
                  <a:pt x="2342297" y="6491096"/>
                  <a:pt x="2332565" y="6505042"/>
                  <a:pt x="2316996" y="6505042"/>
                </a:cubicBezTo>
                <a:cubicBezTo>
                  <a:pt x="2309639" y="6504634"/>
                  <a:pt x="2302598" y="6501910"/>
                  <a:pt x="2296883" y="6497259"/>
                </a:cubicBezTo>
                <a:lnTo>
                  <a:pt x="2290722" y="6508934"/>
                </a:lnTo>
                <a:cubicBezTo>
                  <a:pt x="2298267" y="6514722"/>
                  <a:pt x="2307487" y="6517908"/>
                  <a:pt x="2316996" y="6518015"/>
                </a:cubicBezTo>
                <a:cubicBezTo>
                  <a:pt x="2337427" y="6518015"/>
                  <a:pt x="2351055" y="6504717"/>
                  <a:pt x="2358190" y="6487853"/>
                </a:cubicBezTo>
                <a:lnTo>
                  <a:pt x="2441550" y="6287757"/>
                </a:lnTo>
                <a:lnTo>
                  <a:pt x="2426956" y="6287757"/>
                </a:lnTo>
                <a:lnTo>
                  <a:pt x="2373434" y="6417155"/>
                </a:lnTo>
                <a:cubicBezTo>
                  <a:pt x="2370187" y="6424938"/>
                  <a:pt x="2367922" y="6432396"/>
                  <a:pt x="2367922" y="6432396"/>
                </a:cubicBezTo>
                <a:lnTo>
                  <a:pt x="2367272" y="6432396"/>
                </a:lnTo>
                <a:cubicBezTo>
                  <a:pt x="2367272" y="6432396"/>
                  <a:pt x="2364675" y="6424938"/>
                  <a:pt x="2361429" y="6417155"/>
                </a:cubicBezTo>
                <a:lnTo>
                  <a:pt x="2307914" y="6287757"/>
                </a:lnTo>
                <a:close/>
                <a:moveTo>
                  <a:pt x="1560161" y="6287757"/>
                </a:moveTo>
                <a:lnTo>
                  <a:pt x="1624058" y="6449909"/>
                </a:lnTo>
                <a:lnTo>
                  <a:pt x="1637032" y="6449909"/>
                </a:lnTo>
                <a:lnTo>
                  <a:pt x="1700608" y="6287757"/>
                </a:lnTo>
                <a:lnTo>
                  <a:pt x="1686334" y="6287757"/>
                </a:lnTo>
                <a:lnTo>
                  <a:pt x="1636383" y="6414887"/>
                </a:lnTo>
                <a:cubicBezTo>
                  <a:pt x="1633465" y="6422669"/>
                  <a:pt x="1630868" y="6432396"/>
                  <a:pt x="1630868" y="6432396"/>
                </a:cubicBezTo>
                <a:lnTo>
                  <a:pt x="1630218" y="6432396"/>
                </a:lnTo>
                <a:cubicBezTo>
                  <a:pt x="1630218" y="6432396"/>
                  <a:pt x="1627629" y="6422669"/>
                  <a:pt x="1624707" y="6414887"/>
                </a:cubicBezTo>
                <a:lnTo>
                  <a:pt x="1574755" y="6287757"/>
                </a:lnTo>
                <a:close/>
                <a:moveTo>
                  <a:pt x="1526463" y="6287757"/>
                </a:moveTo>
                <a:lnTo>
                  <a:pt x="1526463" y="6449909"/>
                </a:lnTo>
                <a:lnTo>
                  <a:pt x="1540087" y="6449909"/>
                </a:lnTo>
                <a:lnTo>
                  <a:pt x="1540087" y="6287757"/>
                </a:lnTo>
                <a:close/>
                <a:moveTo>
                  <a:pt x="1496207" y="6286463"/>
                </a:moveTo>
                <a:cubicBezTo>
                  <a:pt x="1470580" y="6286463"/>
                  <a:pt x="1452419" y="6306894"/>
                  <a:pt x="1444311" y="6331866"/>
                </a:cubicBezTo>
                <a:lnTo>
                  <a:pt x="1443661" y="6331866"/>
                </a:lnTo>
                <a:cubicBezTo>
                  <a:pt x="1444529" y="6327486"/>
                  <a:pt x="1444964" y="6323032"/>
                  <a:pt x="1444960" y="6318568"/>
                </a:cubicBezTo>
                <a:lnTo>
                  <a:pt x="1444960" y="6287757"/>
                </a:lnTo>
                <a:lnTo>
                  <a:pt x="1431332" y="6287757"/>
                </a:lnTo>
                <a:lnTo>
                  <a:pt x="1431332" y="6449910"/>
                </a:lnTo>
                <a:lnTo>
                  <a:pt x="1444960" y="6449910"/>
                </a:lnTo>
                <a:lnTo>
                  <a:pt x="1444960" y="6379861"/>
                </a:lnTo>
                <a:cubicBezTo>
                  <a:pt x="1444867" y="6368331"/>
                  <a:pt x="1446506" y="6356852"/>
                  <a:pt x="1449821" y="6345808"/>
                </a:cubicBezTo>
                <a:cubicBezTo>
                  <a:pt x="1456956" y="6321810"/>
                  <a:pt x="1472850" y="6300406"/>
                  <a:pt x="1498150" y="6300406"/>
                </a:cubicBezTo>
                <a:cubicBezTo>
                  <a:pt x="1500648" y="6300445"/>
                  <a:pt x="1503141" y="6300662"/>
                  <a:pt x="1505609" y="6301055"/>
                </a:cubicBezTo>
                <a:lnTo>
                  <a:pt x="1505609" y="6287433"/>
                </a:lnTo>
                <a:cubicBezTo>
                  <a:pt x="1502511" y="6286819"/>
                  <a:pt x="1499364" y="6286494"/>
                  <a:pt x="1496207" y="6286463"/>
                </a:cubicBezTo>
                <a:close/>
                <a:moveTo>
                  <a:pt x="2833876" y="6285815"/>
                </a:moveTo>
                <a:lnTo>
                  <a:pt x="2833876" y="6449910"/>
                </a:lnTo>
                <a:lnTo>
                  <a:pt x="2865337" y="6449910"/>
                </a:lnTo>
                <a:lnTo>
                  <a:pt x="2865337" y="6285815"/>
                </a:lnTo>
                <a:close/>
                <a:moveTo>
                  <a:pt x="1962617" y="6283866"/>
                </a:moveTo>
                <a:cubicBezTo>
                  <a:pt x="1932589" y="6283915"/>
                  <a:pt x="1905505" y="6301924"/>
                  <a:pt x="1893850" y="6329593"/>
                </a:cubicBezTo>
                <a:lnTo>
                  <a:pt x="1893201" y="6329593"/>
                </a:lnTo>
                <a:cubicBezTo>
                  <a:pt x="1894069" y="6325214"/>
                  <a:pt x="1894504" y="6320760"/>
                  <a:pt x="1894499" y="6316296"/>
                </a:cubicBezTo>
                <a:lnTo>
                  <a:pt x="1894499" y="6287757"/>
                </a:lnTo>
                <a:lnTo>
                  <a:pt x="1880875" y="6287757"/>
                </a:lnTo>
                <a:lnTo>
                  <a:pt x="1880875" y="6449909"/>
                </a:lnTo>
                <a:lnTo>
                  <a:pt x="1894500" y="6449909"/>
                </a:lnTo>
                <a:lnTo>
                  <a:pt x="1894500" y="6370779"/>
                </a:lnTo>
                <a:cubicBezTo>
                  <a:pt x="1894344" y="6363345"/>
                  <a:pt x="1895217" y="6355925"/>
                  <a:pt x="1897093" y="6348730"/>
                </a:cubicBezTo>
                <a:cubicBezTo>
                  <a:pt x="1904831" y="6318751"/>
                  <a:pt x="1931655" y="6297641"/>
                  <a:pt x="1962617" y="6297163"/>
                </a:cubicBezTo>
                <a:cubicBezTo>
                  <a:pt x="1998940" y="6297163"/>
                  <a:pt x="2002511" y="6323758"/>
                  <a:pt x="2002511" y="6351972"/>
                </a:cubicBezTo>
                <a:lnTo>
                  <a:pt x="2002511" y="6449909"/>
                </a:lnTo>
                <a:lnTo>
                  <a:pt x="2016132" y="6449909"/>
                </a:lnTo>
                <a:lnTo>
                  <a:pt x="2016132" y="6347107"/>
                </a:lnTo>
                <a:cubicBezTo>
                  <a:pt x="2016132" y="6308837"/>
                  <a:pt x="2004784" y="6283866"/>
                  <a:pt x="1962617" y="6283866"/>
                </a:cubicBezTo>
                <a:close/>
                <a:moveTo>
                  <a:pt x="1782992" y="6283866"/>
                </a:moveTo>
                <a:cubicBezTo>
                  <a:pt x="1741473" y="6283866"/>
                  <a:pt x="1704172" y="6314352"/>
                  <a:pt x="1704172" y="6369160"/>
                </a:cubicBezTo>
                <a:cubicBezTo>
                  <a:pt x="1704172" y="6420722"/>
                  <a:pt x="1742119" y="6453801"/>
                  <a:pt x="1787858" y="6453801"/>
                </a:cubicBezTo>
                <a:cubicBezTo>
                  <a:pt x="1809172" y="6453549"/>
                  <a:pt x="1829677" y="6445602"/>
                  <a:pt x="1845593" y="6431427"/>
                </a:cubicBezTo>
                <a:lnTo>
                  <a:pt x="1838134" y="6420073"/>
                </a:lnTo>
                <a:cubicBezTo>
                  <a:pt x="1824600" y="6433054"/>
                  <a:pt x="1806612" y="6440366"/>
                  <a:pt x="1787858" y="6440508"/>
                </a:cubicBezTo>
                <a:cubicBezTo>
                  <a:pt x="1750232" y="6440508"/>
                  <a:pt x="1718442" y="6413589"/>
                  <a:pt x="1718442" y="6366563"/>
                </a:cubicBezTo>
                <a:lnTo>
                  <a:pt x="1848511" y="6366563"/>
                </a:lnTo>
                <a:cubicBezTo>
                  <a:pt x="1848511" y="6366563"/>
                  <a:pt x="1849161" y="6361377"/>
                  <a:pt x="1849161" y="6357807"/>
                </a:cubicBezTo>
                <a:cubicBezTo>
                  <a:pt x="1849161" y="6318568"/>
                  <a:pt x="1827103" y="6283866"/>
                  <a:pt x="1782992" y="6283866"/>
                </a:cubicBezTo>
                <a:close/>
                <a:moveTo>
                  <a:pt x="3482643" y="6281922"/>
                </a:moveTo>
                <a:cubicBezTo>
                  <a:pt x="3435929" y="6281922"/>
                  <a:pt x="3400581" y="6315650"/>
                  <a:pt x="3400581" y="6367862"/>
                </a:cubicBezTo>
                <a:cubicBezTo>
                  <a:pt x="3400581" y="6416506"/>
                  <a:pt x="3435929" y="6453801"/>
                  <a:pt x="3487504" y="6453801"/>
                </a:cubicBezTo>
                <a:cubicBezTo>
                  <a:pt x="3510804" y="6453844"/>
                  <a:pt x="3533352" y="6445564"/>
                  <a:pt x="3551085" y="6430452"/>
                </a:cubicBezTo>
                <a:lnTo>
                  <a:pt x="3538105" y="6407425"/>
                </a:lnTo>
                <a:cubicBezTo>
                  <a:pt x="3524564" y="6419193"/>
                  <a:pt x="3507385" y="6425950"/>
                  <a:pt x="3489453" y="6426561"/>
                </a:cubicBezTo>
                <a:cubicBezTo>
                  <a:pt x="3460256" y="6426561"/>
                  <a:pt x="3434638" y="6408398"/>
                  <a:pt x="3433015" y="6372402"/>
                </a:cubicBezTo>
                <a:lnTo>
                  <a:pt x="3552700" y="6372402"/>
                </a:lnTo>
                <a:cubicBezTo>
                  <a:pt x="3552700" y="6372402"/>
                  <a:pt x="3553673" y="6362996"/>
                  <a:pt x="3553673" y="6358780"/>
                </a:cubicBezTo>
                <a:cubicBezTo>
                  <a:pt x="3553673" y="6316295"/>
                  <a:pt x="3529023" y="6281922"/>
                  <a:pt x="3482643" y="6281922"/>
                </a:cubicBezTo>
                <a:close/>
                <a:moveTo>
                  <a:pt x="3328545" y="6281922"/>
                </a:moveTo>
                <a:cubicBezTo>
                  <a:pt x="3276969" y="6281922"/>
                  <a:pt x="3240639" y="6319217"/>
                  <a:pt x="3240639" y="6367862"/>
                </a:cubicBezTo>
                <a:cubicBezTo>
                  <a:pt x="3240639" y="6417155"/>
                  <a:pt x="3276969" y="6453801"/>
                  <a:pt x="3328545" y="6453801"/>
                </a:cubicBezTo>
                <a:cubicBezTo>
                  <a:pt x="3353053" y="6454342"/>
                  <a:pt x="3376720" y="6444855"/>
                  <a:pt x="3394065" y="6427535"/>
                </a:cubicBezTo>
                <a:lnTo>
                  <a:pt x="3381411" y="6404507"/>
                </a:lnTo>
                <a:cubicBezTo>
                  <a:pt x="3367999" y="6418078"/>
                  <a:pt x="3349882" y="6425974"/>
                  <a:pt x="3330810" y="6426561"/>
                </a:cubicBezTo>
                <a:cubicBezTo>
                  <a:pt x="3296751" y="6426561"/>
                  <a:pt x="3272749" y="6400940"/>
                  <a:pt x="3272749" y="6367536"/>
                </a:cubicBezTo>
                <a:cubicBezTo>
                  <a:pt x="3272749" y="6333809"/>
                  <a:pt x="3296751" y="6309162"/>
                  <a:pt x="3329836" y="6309162"/>
                </a:cubicBezTo>
                <a:cubicBezTo>
                  <a:pt x="3346822" y="6309400"/>
                  <a:pt x="3363072" y="6316132"/>
                  <a:pt x="3375250" y="6327973"/>
                </a:cubicBezTo>
                <a:lnTo>
                  <a:pt x="3390169" y="6305919"/>
                </a:lnTo>
                <a:cubicBezTo>
                  <a:pt x="3390169" y="6305919"/>
                  <a:pt x="3369738" y="6281922"/>
                  <a:pt x="3328545" y="6281922"/>
                </a:cubicBezTo>
                <a:close/>
                <a:moveTo>
                  <a:pt x="3161340" y="6281922"/>
                </a:moveTo>
                <a:cubicBezTo>
                  <a:pt x="3135204" y="6281326"/>
                  <a:pt x="3111121" y="6296026"/>
                  <a:pt x="3099708" y="6319542"/>
                </a:cubicBezTo>
                <a:lnTo>
                  <a:pt x="3099059" y="6319542"/>
                </a:lnTo>
                <a:cubicBezTo>
                  <a:pt x="3099484" y="6315556"/>
                  <a:pt x="3099701" y="6311551"/>
                  <a:pt x="3099708" y="6307543"/>
                </a:cubicBezTo>
                <a:lnTo>
                  <a:pt x="3099708" y="6285814"/>
                </a:lnTo>
                <a:lnTo>
                  <a:pt x="3069221" y="6285814"/>
                </a:lnTo>
                <a:lnTo>
                  <a:pt x="3069221" y="6449909"/>
                </a:lnTo>
                <a:lnTo>
                  <a:pt x="3100682" y="6449909"/>
                </a:lnTo>
                <a:lnTo>
                  <a:pt x="3100682" y="6373051"/>
                </a:lnTo>
                <a:cubicBezTo>
                  <a:pt x="3100487" y="6365614"/>
                  <a:pt x="3101362" y="6358186"/>
                  <a:pt x="3103280" y="6350997"/>
                </a:cubicBezTo>
                <a:cubicBezTo>
                  <a:pt x="3109426" y="6327359"/>
                  <a:pt x="3130744" y="6310840"/>
                  <a:pt x="3155171" y="6310785"/>
                </a:cubicBezTo>
                <a:cubicBezTo>
                  <a:pt x="3181446" y="6310785"/>
                  <a:pt x="3186316" y="6328944"/>
                  <a:pt x="3186316" y="6351971"/>
                </a:cubicBezTo>
                <a:lnTo>
                  <a:pt x="3186316" y="6449909"/>
                </a:lnTo>
                <a:lnTo>
                  <a:pt x="3217777" y="6449909"/>
                </a:lnTo>
                <a:lnTo>
                  <a:pt x="3217777" y="6344838"/>
                </a:lnTo>
                <a:cubicBezTo>
                  <a:pt x="3217777" y="6303003"/>
                  <a:pt x="3199936" y="6281922"/>
                  <a:pt x="3161340" y="6281922"/>
                </a:cubicBezTo>
                <a:close/>
                <a:moveTo>
                  <a:pt x="2972280" y="6281922"/>
                </a:moveTo>
                <a:cubicBezTo>
                  <a:pt x="2925568" y="6281922"/>
                  <a:pt x="2890218" y="6315650"/>
                  <a:pt x="2890218" y="6367862"/>
                </a:cubicBezTo>
                <a:cubicBezTo>
                  <a:pt x="2890218" y="6416506"/>
                  <a:pt x="2925568" y="6453801"/>
                  <a:pt x="2977142" y="6453801"/>
                </a:cubicBezTo>
                <a:cubicBezTo>
                  <a:pt x="3000442" y="6453844"/>
                  <a:pt x="3022990" y="6445564"/>
                  <a:pt x="3040722" y="6430452"/>
                </a:cubicBezTo>
                <a:lnTo>
                  <a:pt x="3027743" y="6407425"/>
                </a:lnTo>
                <a:cubicBezTo>
                  <a:pt x="3014201" y="6419193"/>
                  <a:pt x="2997023" y="6425950"/>
                  <a:pt x="2979090" y="6426561"/>
                </a:cubicBezTo>
                <a:cubicBezTo>
                  <a:pt x="2949894" y="6426561"/>
                  <a:pt x="2924277" y="6408398"/>
                  <a:pt x="2922653" y="6372402"/>
                </a:cubicBezTo>
                <a:lnTo>
                  <a:pt x="3042338" y="6372402"/>
                </a:lnTo>
                <a:cubicBezTo>
                  <a:pt x="3042338" y="6372402"/>
                  <a:pt x="3043311" y="6362996"/>
                  <a:pt x="3043311" y="6358780"/>
                </a:cubicBezTo>
                <a:cubicBezTo>
                  <a:pt x="3043311" y="6316295"/>
                  <a:pt x="3018660" y="6281922"/>
                  <a:pt x="2972280" y="6281922"/>
                </a:cubicBezTo>
                <a:close/>
                <a:moveTo>
                  <a:pt x="2748837" y="6281922"/>
                </a:moveTo>
                <a:cubicBezTo>
                  <a:pt x="2697262" y="6281922"/>
                  <a:pt x="2660931" y="6319217"/>
                  <a:pt x="2660931" y="6367862"/>
                </a:cubicBezTo>
                <a:cubicBezTo>
                  <a:pt x="2660931" y="6417155"/>
                  <a:pt x="2697262" y="6453801"/>
                  <a:pt x="2748837" y="6453801"/>
                </a:cubicBezTo>
                <a:cubicBezTo>
                  <a:pt x="2773344" y="6454342"/>
                  <a:pt x="2797011" y="6444855"/>
                  <a:pt x="2814356" y="6427535"/>
                </a:cubicBezTo>
                <a:lnTo>
                  <a:pt x="2801703" y="6404507"/>
                </a:lnTo>
                <a:cubicBezTo>
                  <a:pt x="2788291" y="6418078"/>
                  <a:pt x="2770174" y="6425974"/>
                  <a:pt x="2751101" y="6426561"/>
                </a:cubicBezTo>
                <a:cubicBezTo>
                  <a:pt x="2717043" y="6426561"/>
                  <a:pt x="2693040" y="6400940"/>
                  <a:pt x="2693040" y="6367536"/>
                </a:cubicBezTo>
                <a:cubicBezTo>
                  <a:pt x="2693040" y="6333809"/>
                  <a:pt x="2717043" y="6309162"/>
                  <a:pt x="2750128" y="6309162"/>
                </a:cubicBezTo>
                <a:cubicBezTo>
                  <a:pt x="2767113" y="6309400"/>
                  <a:pt x="2783363" y="6316132"/>
                  <a:pt x="2795541" y="6327973"/>
                </a:cubicBezTo>
                <a:lnTo>
                  <a:pt x="2810461" y="6305919"/>
                </a:lnTo>
                <a:cubicBezTo>
                  <a:pt x="2810461" y="6305919"/>
                  <a:pt x="2790029" y="6281922"/>
                  <a:pt x="2748837" y="6281922"/>
                </a:cubicBezTo>
                <a:close/>
                <a:moveTo>
                  <a:pt x="2593020" y="6281922"/>
                </a:moveTo>
                <a:cubicBezTo>
                  <a:pt x="2560260" y="6281922"/>
                  <a:pt x="2533661" y="6298787"/>
                  <a:pt x="2533661" y="6328619"/>
                </a:cubicBezTo>
                <a:cubicBezTo>
                  <a:pt x="2533661" y="6382132"/>
                  <a:pt x="2617996" y="6375969"/>
                  <a:pt x="2617996" y="6406130"/>
                </a:cubicBezTo>
                <a:cubicBezTo>
                  <a:pt x="2617996" y="6419427"/>
                  <a:pt x="2604367" y="6426561"/>
                  <a:pt x="2590747" y="6426561"/>
                </a:cubicBezTo>
                <a:cubicBezTo>
                  <a:pt x="2573236" y="6426254"/>
                  <a:pt x="2556467" y="6419431"/>
                  <a:pt x="2543718" y="6407425"/>
                </a:cubicBezTo>
                <a:lnTo>
                  <a:pt x="2528466" y="6429803"/>
                </a:lnTo>
                <a:cubicBezTo>
                  <a:pt x="2545284" y="6445645"/>
                  <a:pt x="2567645" y="6454261"/>
                  <a:pt x="2590747" y="6453801"/>
                </a:cubicBezTo>
                <a:cubicBezTo>
                  <a:pt x="2626753" y="6453801"/>
                  <a:pt x="2650106" y="6433369"/>
                  <a:pt x="2650106" y="6406130"/>
                </a:cubicBezTo>
                <a:cubicBezTo>
                  <a:pt x="2650106" y="6352295"/>
                  <a:pt x="2565771" y="6358780"/>
                  <a:pt x="2565771" y="6329268"/>
                </a:cubicBezTo>
                <a:cubicBezTo>
                  <a:pt x="2565771" y="6315001"/>
                  <a:pt x="2579067" y="6309162"/>
                  <a:pt x="2592695" y="6309162"/>
                </a:cubicBezTo>
                <a:cubicBezTo>
                  <a:pt x="2607550" y="6308844"/>
                  <a:pt x="2621996" y="6314044"/>
                  <a:pt x="2633239" y="6323757"/>
                </a:cubicBezTo>
                <a:lnTo>
                  <a:pt x="2645885" y="6300081"/>
                </a:lnTo>
                <a:cubicBezTo>
                  <a:pt x="2645885" y="6300081"/>
                  <a:pt x="2629018" y="6281922"/>
                  <a:pt x="2593020" y="6281922"/>
                </a:cubicBezTo>
                <a:close/>
                <a:moveTo>
                  <a:pt x="1223619" y="6235871"/>
                </a:moveTo>
                <a:lnTo>
                  <a:pt x="1278761" y="6235871"/>
                </a:lnTo>
                <a:cubicBezTo>
                  <a:pt x="1339094" y="6235871"/>
                  <a:pt x="1379638" y="6271542"/>
                  <a:pt x="1379638" y="6336406"/>
                </a:cubicBezTo>
                <a:cubicBezTo>
                  <a:pt x="1379638" y="6401589"/>
                  <a:pt x="1339094" y="6436937"/>
                  <a:pt x="1278761" y="6436937"/>
                </a:cubicBezTo>
                <a:lnTo>
                  <a:pt x="1223619" y="6436937"/>
                </a:lnTo>
                <a:close/>
                <a:moveTo>
                  <a:pt x="2147812" y="6222898"/>
                </a:moveTo>
                <a:lnTo>
                  <a:pt x="2147812" y="6449909"/>
                </a:lnTo>
                <a:lnTo>
                  <a:pt x="2161440" y="6449909"/>
                </a:lnTo>
                <a:lnTo>
                  <a:pt x="2161440" y="6431426"/>
                </a:lnTo>
                <a:cubicBezTo>
                  <a:pt x="2161480" y="6426638"/>
                  <a:pt x="2161045" y="6421858"/>
                  <a:pt x="2160141" y="6417155"/>
                </a:cubicBezTo>
                <a:lnTo>
                  <a:pt x="2160791" y="6417155"/>
                </a:lnTo>
                <a:cubicBezTo>
                  <a:pt x="2160791" y="6417155"/>
                  <a:pt x="2176035" y="6453801"/>
                  <a:pt x="2216903" y="6453801"/>
                </a:cubicBezTo>
                <a:cubicBezTo>
                  <a:pt x="2259395" y="6453801"/>
                  <a:pt x="2289558" y="6420397"/>
                  <a:pt x="2289558" y="6368835"/>
                </a:cubicBezTo>
                <a:cubicBezTo>
                  <a:pt x="2289558" y="6318568"/>
                  <a:pt x="2262959" y="6283866"/>
                  <a:pt x="2219501" y="6283866"/>
                </a:cubicBezTo>
                <a:cubicBezTo>
                  <a:pt x="2194302" y="6283022"/>
                  <a:pt x="2171097" y="6297505"/>
                  <a:pt x="2160791" y="6320511"/>
                </a:cubicBezTo>
                <a:lnTo>
                  <a:pt x="2160141" y="6320511"/>
                </a:lnTo>
                <a:cubicBezTo>
                  <a:pt x="2161010" y="6316134"/>
                  <a:pt x="2161445" y="6311681"/>
                  <a:pt x="2161440" y="6307218"/>
                </a:cubicBezTo>
                <a:lnTo>
                  <a:pt x="2161440" y="6222898"/>
                </a:lnTo>
                <a:close/>
                <a:moveTo>
                  <a:pt x="1525168" y="6222898"/>
                </a:moveTo>
                <a:lnTo>
                  <a:pt x="1525168" y="6246571"/>
                </a:lnTo>
                <a:lnTo>
                  <a:pt x="1541386" y="6246571"/>
                </a:lnTo>
                <a:lnTo>
                  <a:pt x="1541386" y="6222898"/>
                </a:lnTo>
                <a:close/>
                <a:moveTo>
                  <a:pt x="1209670" y="6222898"/>
                </a:moveTo>
                <a:lnTo>
                  <a:pt x="1209670" y="6449909"/>
                </a:lnTo>
                <a:lnTo>
                  <a:pt x="1281034" y="6449909"/>
                </a:lnTo>
                <a:cubicBezTo>
                  <a:pt x="1348498" y="6449909"/>
                  <a:pt x="1394232" y="6408723"/>
                  <a:pt x="1394232" y="6336406"/>
                </a:cubicBezTo>
                <a:cubicBezTo>
                  <a:pt x="1394232" y="6264409"/>
                  <a:pt x="1348498" y="6222898"/>
                  <a:pt x="1281034" y="6222898"/>
                </a:cubicBezTo>
                <a:close/>
                <a:moveTo>
                  <a:pt x="2833551" y="6220951"/>
                </a:moveTo>
                <a:lnTo>
                  <a:pt x="2833551" y="6253060"/>
                </a:lnTo>
                <a:lnTo>
                  <a:pt x="2865337" y="6253060"/>
                </a:lnTo>
                <a:lnTo>
                  <a:pt x="2865337" y="6220951"/>
                </a:lnTo>
                <a:close/>
                <a:moveTo>
                  <a:pt x="982628" y="6207360"/>
                </a:moveTo>
                <a:cubicBezTo>
                  <a:pt x="963105" y="6332337"/>
                  <a:pt x="865050" y="6430379"/>
                  <a:pt x="740053" y="6449905"/>
                </a:cubicBezTo>
                <a:lnTo>
                  <a:pt x="982628" y="6449909"/>
                </a:lnTo>
                <a:close/>
                <a:moveTo>
                  <a:pt x="407989" y="6207356"/>
                </a:moveTo>
                <a:lnTo>
                  <a:pt x="407989" y="6449905"/>
                </a:lnTo>
                <a:lnTo>
                  <a:pt x="650564" y="6449905"/>
                </a:lnTo>
                <a:cubicBezTo>
                  <a:pt x="525562" y="6430384"/>
                  <a:pt x="427505" y="6332337"/>
                  <a:pt x="407989" y="6207356"/>
                </a:cubicBezTo>
                <a:close/>
                <a:moveTo>
                  <a:pt x="883619" y="6147250"/>
                </a:moveTo>
                <a:lnTo>
                  <a:pt x="915428" y="6147250"/>
                </a:lnTo>
                <a:lnTo>
                  <a:pt x="915428" y="6178023"/>
                </a:lnTo>
                <a:lnTo>
                  <a:pt x="883619" y="6178023"/>
                </a:lnTo>
                <a:close/>
                <a:moveTo>
                  <a:pt x="739956" y="6106213"/>
                </a:moveTo>
                <a:lnTo>
                  <a:pt x="739956" y="6219065"/>
                </a:lnTo>
                <a:lnTo>
                  <a:pt x="830261" y="6219065"/>
                </a:lnTo>
                <a:lnTo>
                  <a:pt x="830261" y="6178031"/>
                </a:lnTo>
                <a:lnTo>
                  <a:pt x="781009" y="6178031"/>
                </a:lnTo>
                <a:lnTo>
                  <a:pt x="781009" y="6147251"/>
                </a:lnTo>
                <a:lnTo>
                  <a:pt x="830261" y="6147251"/>
                </a:lnTo>
                <a:lnTo>
                  <a:pt x="830261" y="6106213"/>
                </a:lnTo>
                <a:close/>
                <a:moveTo>
                  <a:pt x="3802396" y="6068975"/>
                </a:moveTo>
                <a:lnTo>
                  <a:pt x="3802396" y="6102379"/>
                </a:lnTo>
                <a:lnTo>
                  <a:pt x="3835481" y="6102379"/>
                </a:lnTo>
                <a:lnTo>
                  <a:pt x="3835481" y="6068975"/>
                </a:lnTo>
                <a:close/>
                <a:moveTo>
                  <a:pt x="842572" y="6042596"/>
                </a:moveTo>
                <a:lnTo>
                  <a:pt x="842572" y="6219054"/>
                </a:lnTo>
                <a:lnTo>
                  <a:pt x="953399" y="6219054"/>
                </a:lnTo>
                <a:lnTo>
                  <a:pt x="953399" y="6106202"/>
                </a:lnTo>
                <a:lnTo>
                  <a:pt x="883619" y="6106202"/>
                </a:lnTo>
                <a:lnTo>
                  <a:pt x="883619" y="6042596"/>
                </a:lnTo>
                <a:close/>
                <a:moveTo>
                  <a:pt x="2979149" y="6023573"/>
                </a:moveTo>
                <a:lnTo>
                  <a:pt x="2987258" y="6023573"/>
                </a:lnTo>
                <a:lnTo>
                  <a:pt x="2987258" y="6028762"/>
                </a:lnTo>
                <a:cubicBezTo>
                  <a:pt x="2987258" y="6053085"/>
                  <a:pt x="2970067" y="6080974"/>
                  <a:pt x="2943468" y="6080974"/>
                </a:cubicBezTo>
                <a:cubicBezTo>
                  <a:pt x="2923029" y="6080974"/>
                  <a:pt x="2912656" y="6068005"/>
                  <a:pt x="2912656" y="6054708"/>
                </a:cubicBezTo>
                <a:cubicBezTo>
                  <a:pt x="2912656" y="6025196"/>
                  <a:pt x="2955464" y="6023573"/>
                  <a:pt x="2979149" y="6023573"/>
                </a:cubicBezTo>
                <a:close/>
                <a:moveTo>
                  <a:pt x="2790699" y="5961955"/>
                </a:moveTo>
                <a:cubicBezTo>
                  <a:pt x="2817947" y="5961955"/>
                  <a:pt x="2837087" y="5984982"/>
                  <a:pt x="2837087" y="6020654"/>
                </a:cubicBezTo>
                <a:cubicBezTo>
                  <a:pt x="2837087" y="6057949"/>
                  <a:pt x="2815674" y="6079354"/>
                  <a:pt x="2789732" y="6079354"/>
                </a:cubicBezTo>
                <a:cubicBezTo>
                  <a:pt x="2759562" y="6079354"/>
                  <a:pt x="2743344" y="6050166"/>
                  <a:pt x="2743344" y="6020979"/>
                </a:cubicBezTo>
                <a:cubicBezTo>
                  <a:pt x="2743344" y="5979143"/>
                  <a:pt x="2766047" y="5961955"/>
                  <a:pt x="2790699" y="5961955"/>
                </a:cubicBezTo>
                <a:close/>
                <a:moveTo>
                  <a:pt x="3285066" y="5959362"/>
                </a:moveTo>
                <a:cubicBezTo>
                  <a:pt x="3306153" y="5959362"/>
                  <a:pt x="3323671" y="5972980"/>
                  <a:pt x="3324644" y="6001198"/>
                </a:cubicBezTo>
                <a:lnTo>
                  <a:pt x="3237062" y="6001198"/>
                </a:lnTo>
                <a:cubicBezTo>
                  <a:pt x="3241608" y="5974279"/>
                  <a:pt x="3261065" y="5959362"/>
                  <a:pt x="3285066" y="5959362"/>
                </a:cubicBezTo>
                <a:close/>
                <a:moveTo>
                  <a:pt x="2389939" y="5949632"/>
                </a:moveTo>
                <a:cubicBezTo>
                  <a:pt x="2423024" y="5949632"/>
                  <a:pt x="2446377" y="5977521"/>
                  <a:pt x="2446377" y="6021305"/>
                </a:cubicBezTo>
                <a:cubicBezTo>
                  <a:pt x="2446377" y="6066707"/>
                  <a:pt x="2420427" y="6092976"/>
                  <a:pt x="2388641" y="6092976"/>
                </a:cubicBezTo>
                <a:cubicBezTo>
                  <a:pt x="2350687" y="6092976"/>
                  <a:pt x="2332204" y="6057626"/>
                  <a:pt x="2332204" y="6021629"/>
                </a:cubicBezTo>
                <a:cubicBezTo>
                  <a:pt x="2332204" y="5970712"/>
                  <a:pt x="2360094" y="5949632"/>
                  <a:pt x="2389939" y="5949632"/>
                </a:cubicBezTo>
                <a:close/>
                <a:moveTo>
                  <a:pt x="2115219" y="5949632"/>
                </a:moveTo>
                <a:cubicBezTo>
                  <a:pt x="2153168" y="5949632"/>
                  <a:pt x="2171660" y="5984983"/>
                  <a:pt x="2171660" y="6020980"/>
                </a:cubicBezTo>
                <a:cubicBezTo>
                  <a:pt x="2171660" y="6071896"/>
                  <a:pt x="2143761" y="6092976"/>
                  <a:pt x="2113920" y="6092976"/>
                </a:cubicBezTo>
                <a:cubicBezTo>
                  <a:pt x="2080833" y="6092976"/>
                  <a:pt x="2057481" y="6065084"/>
                  <a:pt x="2057481" y="6021305"/>
                </a:cubicBezTo>
                <a:cubicBezTo>
                  <a:pt x="2057481" y="5975902"/>
                  <a:pt x="2083427" y="5949632"/>
                  <a:pt x="2115219" y="5949632"/>
                </a:cubicBezTo>
                <a:close/>
                <a:moveTo>
                  <a:pt x="1641577" y="5949632"/>
                </a:moveTo>
                <a:cubicBezTo>
                  <a:pt x="1674661" y="5949632"/>
                  <a:pt x="1698014" y="5977521"/>
                  <a:pt x="1698014" y="6021304"/>
                </a:cubicBezTo>
                <a:cubicBezTo>
                  <a:pt x="1698014" y="6066706"/>
                  <a:pt x="1672064" y="6092976"/>
                  <a:pt x="1640278" y="6092976"/>
                </a:cubicBezTo>
                <a:cubicBezTo>
                  <a:pt x="1603947" y="6092976"/>
                  <a:pt x="1583842" y="6057625"/>
                  <a:pt x="1583842" y="6021628"/>
                </a:cubicBezTo>
                <a:cubicBezTo>
                  <a:pt x="1583842" y="5970712"/>
                  <a:pt x="1611732" y="5949632"/>
                  <a:pt x="1641577" y="5949632"/>
                </a:cubicBezTo>
                <a:close/>
                <a:moveTo>
                  <a:pt x="1954957" y="5948983"/>
                </a:moveTo>
                <a:cubicBezTo>
                  <a:pt x="1981876" y="5948983"/>
                  <a:pt x="2005557" y="5966821"/>
                  <a:pt x="2007177" y="6006384"/>
                </a:cubicBezTo>
                <a:lnTo>
                  <a:pt x="1891706" y="6006384"/>
                </a:lnTo>
                <a:cubicBezTo>
                  <a:pt x="1897546" y="5968444"/>
                  <a:pt x="1925116" y="5948983"/>
                  <a:pt x="1954957" y="5948983"/>
                </a:cubicBezTo>
                <a:close/>
                <a:moveTo>
                  <a:pt x="2464407" y="5940226"/>
                </a:moveTo>
                <a:lnTo>
                  <a:pt x="2531550" y="6101405"/>
                </a:lnTo>
                <a:lnTo>
                  <a:pt x="2519870" y="6128324"/>
                </a:lnTo>
                <a:cubicBezTo>
                  <a:pt x="2513384" y="6143564"/>
                  <a:pt x="2503652" y="6157511"/>
                  <a:pt x="2488084" y="6157511"/>
                </a:cubicBezTo>
                <a:cubicBezTo>
                  <a:pt x="2480726" y="6157103"/>
                  <a:pt x="2473686" y="6154379"/>
                  <a:pt x="2467970" y="6149728"/>
                </a:cubicBezTo>
                <a:lnTo>
                  <a:pt x="2461809" y="6161402"/>
                </a:lnTo>
                <a:cubicBezTo>
                  <a:pt x="2469354" y="6167192"/>
                  <a:pt x="2478573" y="6170379"/>
                  <a:pt x="2488084" y="6170485"/>
                </a:cubicBezTo>
                <a:cubicBezTo>
                  <a:pt x="2508514" y="6170485"/>
                  <a:pt x="2522142" y="6157186"/>
                  <a:pt x="2529277" y="6140322"/>
                </a:cubicBezTo>
                <a:lnTo>
                  <a:pt x="2612638" y="5940226"/>
                </a:lnTo>
                <a:lnTo>
                  <a:pt x="2598044" y="5940226"/>
                </a:lnTo>
                <a:lnTo>
                  <a:pt x="2544521" y="6069624"/>
                </a:lnTo>
                <a:cubicBezTo>
                  <a:pt x="2541274" y="6077407"/>
                  <a:pt x="2539009" y="6084865"/>
                  <a:pt x="2539009" y="6084865"/>
                </a:cubicBezTo>
                <a:lnTo>
                  <a:pt x="2538360" y="6084865"/>
                </a:lnTo>
                <a:cubicBezTo>
                  <a:pt x="2538360" y="6084865"/>
                  <a:pt x="2535763" y="6077407"/>
                  <a:pt x="2532516" y="6069624"/>
                </a:cubicBezTo>
                <a:lnTo>
                  <a:pt x="2479001" y="5940226"/>
                </a:lnTo>
                <a:close/>
                <a:moveTo>
                  <a:pt x="1744846" y="5940226"/>
                </a:moveTo>
                <a:lnTo>
                  <a:pt x="1744846" y="6102378"/>
                </a:lnTo>
                <a:lnTo>
                  <a:pt x="1758470" y="6102378"/>
                </a:lnTo>
                <a:lnTo>
                  <a:pt x="1758470" y="5940226"/>
                </a:lnTo>
                <a:close/>
                <a:moveTo>
                  <a:pt x="1864854" y="5938932"/>
                </a:moveTo>
                <a:cubicBezTo>
                  <a:pt x="1839229" y="5938932"/>
                  <a:pt x="1821064" y="5959362"/>
                  <a:pt x="1812955" y="5984334"/>
                </a:cubicBezTo>
                <a:lnTo>
                  <a:pt x="1812306" y="5984334"/>
                </a:lnTo>
                <a:cubicBezTo>
                  <a:pt x="1813174" y="5979955"/>
                  <a:pt x="1813609" y="5975501"/>
                  <a:pt x="1813604" y="5971037"/>
                </a:cubicBezTo>
                <a:lnTo>
                  <a:pt x="1813604" y="5940226"/>
                </a:lnTo>
                <a:lnTo>
                  <a:pt x="1799984" y="5940226"/>
                </a:lnTo>
                <a:lnTo>
                  <a:pt x="1799984" y="6102378"/>
                </a:lnTo>
                <a:lnTo>
                  <a:pt x="1813604" y="6102378"/>
                </a:lnTo>
                <a:lnTo>
                  <a:pt x="1813604" y="6032329"/>
                </a:lnTo>
                <a:cubicBezTo>
                  <a:pt x="1813514" y="6020799"/>
                  <a:pt x="1815154" y="6009320"/>
                  <a:pt x="1818470" y="5998276"/>
                </a:cubicBezTo>
                <a:cubicBezTo>
                  <a:pt x="1825609" y="5974279"/>
                  <a:pt x="1841502" y="5952874"/>
                  <a:pt x="1866802" y="5952874"/>
                </a:cubicBezTo>
                <a:cubicBezTo>
                  <a:pt x="1869301" y="5952914"/>
                  <a:pt x="1871794" y="5953131"/>
                  <a:pt x="1874262" y="5953523"/>
                </a:cubicBezTo>
                <a:lnTo>
                  <a:pt x="1874262" y="5939902"/>
                </a:lnTo>
                <a:cubicBezTo>
                  <a:pt x="1871162" y="5939288"/>
                  <a:pt x="1868013" y="5938964"/>
                  <a:pt x="1864854" y="5938932"/>
                </a:cubicBezTo>
                <a:close/>
                <a:moveTo>
                  <a:pt x="3147319" y="5938282"/>
                </a:moveTo>
                <a:lnTo>
                  <a:pt x="3147319" y="6102378"/>
                </a:lnTo>
                <a:lnTo>
                  <a:pt x="3178780" y="6102378"/>
                </a:lnTo>
                <a:lnTo>
                  <a:pt x="3178780" y="5938282"/>
                </a:lnTo>
                <a:close/>
                <a:moveTo>
                  <a:pt x="1955281" y="5936335"/>
                </a:moveTo>
                <a:cubicBezTo>
                  <a:pt x="1913763" y="5936335"/>
                  <a:pt x="1876463" y="5966821"/>
                  <a:pt x="1876463" y="6021629"/>
                </a:cubicBezTo>
                <a:cubicBezTo>
                  <a:pt x="1876463" y="6073190"/>
                  <a:pt x="1914410" y="6106269"/>
                  <a:pt x="1960147" y="6106269"/>
                </a:cubicBezTo>
                <a:cubicBezTo>
                  <a:pt x="1981462" y="6106017"/>
                  <a:pt x="2001966" y="6098070"/>
                  <a:pt x="2017884" y="6083895"/>
                </a:cubicBezTo>
                <a:lnTo>
                  <a:pt x="2010424" y="6072541"/>
                </a:lnTo>
                <a:cubicBezTo>
                  <a:pt x="1996890" y="6085523"/>
                  <a:pt x="1978902" y="6092834"/>
                  <a:pt x="1960147" y="6092976"/>
                </a:cubicBezTo>
                <a:cubicBezTo>
                  <a:pt x="1922522" y="6092976"/>
                  <a:pt x="1890731" y="6066057"/>
                  <a:pt x="1890731" y="6019031"/>
                </a:cubicBezTo>
                <a:lnTo>
                  <a:pt x="2020802" y="6019031"/>
                </a:lnTo>
                <a:cubicBezTo>
                  <a:pt x="2020802" y="6019031"/>
                  <a:pt x="2021451" y="6013846"/>
                  <a:pt x="2021451" y="6010275"/>
                </a:cubicBezTo>
                <a:cubicBezTo>
                  <a:pt x="2021451" y="5971037"/>
                  <a:pt x="1999394" y="5936335"/>
                  <a:pt x="1955281" y="5936335"/>
                </a:cubicBezTo>
                <a:close/>
                <a:moveTo>
                  <a:pt x="1642226" y="5936335"/>
                </a:moveTo>
                <a:cubicBezTo>
                  <a:pt x="1597137" y="5936335"/>
                  <a:pt x="1583842" y="5972656"/>
                  <a:pt x="1583842" y="5972656"/>
                </a:cubicBezTo>
                <a:lnTo>
                  <a:pt x="1583192" y="5972655"/>
                </a:lnTo>
                <a:cubicBezTo>
                  <a:pt x="1583857" y="5968365"/>
                  <a:pt x="1584183" y="5964029"/>
                  <a:pt x="1584166" y="5959687"/>
                </a:cubicBezTo>
                <a:lnTo>
                  <a:pt x="1584166" y="5940226"/>
                </a:lnTo>
                <a:lnTo>
                  <a:pt x="1570538" y="5940226"/>
                </a:lnTo>
                <a:lnTo>
                  <a:pt x="1570538" y="6167243"/>
                </a:lnTo>
                <a:lnTo>
                  <a:pt x="1584166" y="6167243"/>
                </a:lnTo>
                <a:lnTo>
                  <a:pt x="1584166" y="6083895"/>
                </a:lnTo>
                <a:cubicBezTo>
                  <a:pt x="1584206" y="6079107"/>
                  <a:pt x="1583771" y="6074326"/>
                  <a:pt x="1582867" y="6069624"/>
                </a:cubicBezTo>
                <a:lnTo>
                  <a:pt x="1583517" y="6069624"/>
                </a:lnTo>
                <a:cubicBezTo>
                  <a:pt x="1593528" y="6091984"/>
                  <a:pt x="1615776" y="6106348"/>
                  <a:pt x="1640279" y="6106269"/>
                </a:cubicBezTo>
                <a:cubicBezTo>
                  <a:pt x="1682121" y="6106269"/>
                  <a:pt x="1712284" y="6072866"/>
                  <a:pt x="1712284" y="6021304"/>
                </a:cubicBezTo>
                <a:cubicBezTo>
                  <a:pt x="1712284" y="5971037"/>
                  <a:pt x="1685689" y="5936335"/>
                  <a:pt x="1642226" y="5936335"/>
                </a:cubicBezTo>
                <a:close/>
                <a:moveTo>
                  <a:pt x="1489846" y="5936335"/>
                </a:moveTo>
                <a:cubicBezTo>
                  <a:pt x="1462277" y="5936335"/>
                  <a:pt x="1437951" y="5951255"/>
                  <a:pt x="1437951" y="5980118"/>
                </a:cubicBezTo>
                <a:cubicBezTo>
                  <a:pt x="1437951" y="6032978"/>
                  <a:pt x="1527151" y="6021304"/>
                  <a:pt x="1527151" y="6062490"/>
                </a:cubicBezTo>
                <a:cubicBezTo>
                  <a:pt x="1527151" y="6082596"/>
                  <a:pt x="1509635" y="6092976"/>
                  <a:pt x="1489846" y="6092977"/>
                </a:cubicBezTo>
                <a:cubicBezTo>
                  <a:pt x="1471034" y="6093132"/>
                  <a:pt x="1452938" y="6085776"/>
                  <a:pt x="1439570" y="6072541"/>
                </a:cubicBezTo>
                <a:lnTo>
                  <a:pt x="1430812" y="6082921"/>
                </a:lnTo>
                <a:cubicBezTo>
                  <a:pt x="1430812" y="6082921"/>
                  <a:pt x="1450276" y="6106269"/>
                  <a:pt x="1489522" y="6106269"/>
                </a:cubicBezTo>
                <a:cubicBezTo>
                  <a:pt x="1519363" y="6106269"/>
                  <a:pt x="1541421" y="6088435"/>
                  <a:pt x="1541421" y="6062490"/>
                </a:cubicBezTo>
                <a:cubicBezTo>
                  <a:pt x="1541421" y="6008656"/>
                  <a:pt x="1452224" y="6021304"/>
                  <a:pt x="1452224" y="5979144"/>
                </a:cubicBezTo>
                <a:cubicBezTo>
                  <a:pt x="1452224" y="5958064"/>
                  <a:pt x="1470386" y="5949632"/>
                  <a:pt x="1488872" y="5949632"/>
                </a:cubicBezTo>
                <a:cubicBezTo>
                  <a:pt x="1516445" y="5949632"/>
                  <a:pt x="1529741" y="5964873"/>
                  <a:pt x="1529741" y="5964873"/>
                </a:cubicBezTo>
                <a:lnTo>
                  <a:pt x="1537850" y="5953848"/>
                </a:lnTo>
                <a:cubicBezTo>
                  <a:pt x="1537850" y="5953848"/>
                  <a:pt x="1522930" y="5936335"/>
                  <a:pt x="1489846" y="5936335"/>
                </a:cubicBezTo>
                <a:close/>
                <a:moveTo>
                  <a:pt x="1352909" y="5936335"/>
                </a:moveTo>
                <a:cubicBezTo>
                  <a:pt x="1322882" y="5936387"/>
                  <a:pt x="1295799" y="5954395"/>
                  <a:pt x="1284142" y="5982062"/>
                </a:cubicBezTo>
                <a:lnTo>
                  <a:pt x="1283493" y="5982062"/>
                </a:lnTo>
                <a:cubicBezTo>
                  <a:pt x="1284361" y="5977683"/>
                  <a:pt x="1284796" y="5973229"/>
                  <a:pt x="1284791" y="5968765"/>
                </a:cubicBezTo>
                <a:lnTo>
                  <a:pt x="1284791" y="5940226"/>
                </a:lnTo>
                <a:lnTo>
                  <a:pt x="1271171" y="5940226"/>
                </a:lnTo>
                <a:lnTo>
                  <a:pt x="1271171" y="6102378"/>
                </a:lnTo>
                <a:lnTo>
                  <a:pt x="1284791" y="6102378"/>
                </a:lnTo>
                <a:lnTo>
                  <a:pt x="1284791" y="6023248"/>
                </a:lnTo>
                <a:cubicBezTo>
                  <a:pt x="1284635" y="6015814"/>
                  <a:pt x="1285509" y="6008393"/>
                  <a:pt x="1287389" y="6001199"/>
                </a:cubicBezTo>
                <a:cubicBezTo>
                  <a:pt x="1295125" y="5971221"/>
                  <a:pt x="1321947" y="5950111"/>
                  <a:pt x="1352909" y="5949632"/>
                </a:cubicBezTo>
                <a:cubicBezTo>
                  <a:pt x="1389235" y="5949632"/>
                  <a:pt x="1392802" y="5976227"/>
                  <a:pt x="1392802" y="6004440"/>
                </a:cubicBezTo>
                <a:lnTo>
                  <a:pt x="1392802" y="6102379"/>
                </a:lnTo>
                <a:lnTo>
                  <a:pt x="1406426" y="6102379"/>
                </a:lnTo>
                <a:lnTo>
                  <a:pt x="1406426" y="5999575"/>
                </a:lnTo>
                <a:cubicBezTo>
                  <a:pt x="1406426" y="5961306"/>
                  <a:pt x="1395076" y="5936335"/>
                  <a:pt x="1352909" y="5936335"/>
                </a:cubicBezTo>
                <a:close/>
                <a:moveTo>
                  <a:pt x="3474783" y="5934392"/>
                </a:moveTo>
                <a:cubicBezTo>
                  <a:pt x="3448647" y="5933795"/>
                  <a:pt x="3424564" y="5948494"/>
                  <a:pt x="3413151" y="5972011"/>
                </a:cubicBezTo>
                <a:lnTo>
                  <a:pt x="3412502" y="5972011"/>
                </a:lnTo>
                <a:cubicBezTo>
                  <a:pt x="3412928" y="5968025"/>
                  <a:pt x="3413144" y="5964020"/>
                  <a:pt x="3413151" y="5960012"/>
                </a:cubicBezTo>
                <a:lnTo>
                  <a:pt x="3413151" y="5938282"/>
                </a:lnTo>
                <a:lnTo>
                  <a:pt x="3382664" y="5938282"/>
                </a:lnTo>
                <a:lnTo>
                  <a:pt x="3382664" y="6102378"/>
                </a:lnTo>
                <a:lnTo>
                  <a:pt x="3414125" y="6102378"/>
                </a:lnTo>
                <a:lnTo>
                  <a:pt x="3414125" y="6025520"/>
                </a:lnTo>
                <a:cubicBezTo>
                  <a:pt x="3413930" y="6018083"/>
                  <a:pt x="3414804" y="6010655"/>
                  <a:pt x="3416723" y="6003466"/>
                </a:cubicBezTo>
                <a:cubicBezTo>
                  <a:pt x="3422869" y="5979829"/>
                  <a:pt x="3444187" y="5963309"/>
                  <a:pt x="3468615" y="5963254"/>
                </a:cubicBezTo>
                <a:cubicBezTo>
                  <a:pt x="3494890" y="5963254"/>
                  <a:pt x="3499759" y="5981413"/>
                  <a:pt x="3499759" y="6004440"/>
                </a:cubicBezTo>
                <a:lnTo>
                  <a:pt x="3499759" y="6102378"/>
                </a:lnTo>
                <a:lnTo>
                  <a:pt x="3531220" y="6102378"/>
                </a:lnTo>
                <a:lnTo>
                  <a:pt x="3531220" y="5997307"/>
                </a:lnTo>
                <a:cubicBezTo>
                  <a:pt x="3531220" y="5955472"/>
                  <a:pt x="3513380" y="5934391"/>
                  <a:pt x="3474783" y="5934392"/>
                </a:cubicBezTo>
                <a:close/>
                <a:moveTo>
                  <a:pt x="3717650" y="5934391"/>
                </a:moveTo>
                <a:cubicBezTo>
                  <a:pt x="3684891" y="5934391"/>
                  <a:pt x="3658292" y="5951255"/>
                  <a:pt x="3658292" y="5981088"/>
                </a:cubicBezTo>
                <a:cubicBezTo>
                  <a:pt x="3658292" y="6034601"/>
                  <a:pt x="3742624" y="6028438"/>
                  <a:pt x="3742624" y="6058599"/>
                </a:cubicBezTo>
                <a:cubicBezTo>
                  <a:pt x="3742624" y="6071896"/>
                  <a:pt x="3728997" y="6079030"/>
                  <a:pt x="3715378" y="6079030"/>
                </a:cubicBezTo>
                <a:cubicBezTo>
                  <a:pt x="3697865" y="6078722"/>
                  <a:pt x="3681098" y="6071899"/>
                  <a:pt x="3668348" y="6059893"/>
                </a:cubicBezTo>
                <a:lnTo>
                  <a:pt x="3653097" y="6082272"/>
                </a:lnTo>
                <a:cubicBezTo>
                  <a:pt x="3669915" y="6098114"/>
                  <a:pt x="3692275" y="6106730"/>
                  <a:pt x="3715378" y="6106270"/>
                </a:cubicBezTo>
                <a:cubicBezTo>
                  <a:pt x="3751384" y="6106270"/>
                  <a:pt x="3774736" y="6085838"/>
                  <a:pt x="3774736" y="6058599"/>
                </a:cubicBezTo>
                <a:cubicBezTo>
                  <a:pt x="3774736" y="6004764"/>
                  <a:pt x="3690402" y="6011249"/>
                  <a:pt x="3690402" y="5981737"/>
                </a:cubicBezTo>
                <a:cubicBezTo>
                  <a:pt x="3690402" y="5967469"/>
                  <a:pt x="3703698" y="5961631"/>
                  <a:pt x="3717325" y="5961631"/>
                </a:cubicBezTo>
                <a:cubicBezTo>
                  <a:pt x="3732180" y="5961313"/>
                  <a:pt x="3746626" y="5966513"/>
                  <a:pt x="3757869" y="5976226"/>
                </a:cubicBezTo>
                <a:lnTo>
                  <a:pt x="3770514" y="5952550"/>
                </a:lnTo>
                <a:cubicBezTo>
                  <a:pt x="3770514" y="5952550"/>
                  <a:pt x="3753648" y="5934391"/>
                  <a:pt x="3717650" y="5934391"/>
                </a:cubicBezTo>
                <a:close/>
                <a:moveTo>
                  <a:pt x="3285715" y="5934391"/>
                </a:moveTo>
                <a:cubicBezTo>
                  <a:pt x="3239010" y="5934391"/>
                  <a:pt x="3203653" y="5968119"/>
                  <a:pt x="3203653" y="6020331"/>
                </a:cubicBezTo>
                <a:cubicBezTo>
                  <a:pt x="3203653" y="6068975"/>
                  <a:pt x="3239010" y="6106270"/>
                  <a:pt x="3290585" y="6106270"/>
                </a:cubicBezTo>
                <a:cubicBezTo>
                  <a:pt x="3313882" y="6106314"/>
                  <a:pt x="3336429" y="6098034"/>
                  <a:pt x="3354158" y="6082921"/>
                </a:cubicBezTo>
                <a:lnTo>
                  <a:pt x="3341187" y="6059893"/>
                </a:lnTo>
                <a:cubicBezTo>
                  <a:pt x="3327640" y="6071661"/>
                  <a:pt x="3310460" y="6078417"/>
                  <a:pt x="3292526" y="6079030"/>
                </a:cubicBezTo>
                <a:cubicBezTo>
                  <a:pt x="3263337" y="6079030"/>
                  <a:pt x="3237712" y="6060868"/>
                  <a:pt x="3236088" y="6024871"/>
                </a:cubicBezTo>
                <a:lnTo>
                  <a:pt x="3355781" y="6024871"/>
                </a:lnTo>
                <a:cubicBezTo>
                  <a:pt x="3355781" y="6024871"/>
                  <a:pt x="3356754" y="6015465"/>
                  <a:pt x="3356754" y="6011249"/>
                </a:cubicBezTo>
                <a:cubicBezTo>
                  <a:pt x="3356754" y="5968764"/>
                  <a:pt x="3332103" y="5934391"/>
                  <a:pt x="3285715" y="5934391"/>
                </a:cubicBezTo>
                <a:close/>
                <a:moveTo>
                  <a:pt x="2953524" y="5934391"/>
                </a:moveTo>
                <a:cubicBezTo>
                  <a:pt x="2931535" y="5934165"/>
                  <a:pt x="2910051" y="5940983"/>
                  <a:pt x="2892217" y="5953848"/>
                </a:cubicBezTo>
                <a:lnTo>
                  <a:pt x="2905189" y="5976872"/>
                </a:lnTo>
                <a:cubicBezTo>
                  <a:pt x="2918524" y="5967162"/>
                  <a:pt x="2934443" y="5961631"/>
                  <a:pt x="2950927" y="5960982"/>
                </a:cubicBezTo>
                <a:cubicBezTo>
                  <a:pt x="2971682" y="5960982"/>
                  <a:pt x="2986934" y="5970063"/>
                  <a:pt x="2986934" y="5996982"/>
                </a:cubicBezTo>
                <a:lnTo>
                  <a:pt x="2986934" y="5999900"/>
                </a:lnTo>
                <a:lnTo>
                  <a:pt x="2979791" y="5999900"/>
                </a:lnTo>
                <a:cubicBezTo>
                  <a:pt x="2952226" y="5999900"/>
                  <a:pt x="2880862" y="6002169"/>
                  <a:pt x="2880862" y="6056327"/>
                </a:cubicBezTo>
                <a:cubicBezTo>
                  <a:pt x="2880862" y="6089081"/>
                  <a:pt x="2908435" y="6106270"/>
                  <a:pt x="2936658" y="6106270"/>
                </a:cubicBezTo>
                <a:cubicBezTo>
                  <a:pt x="2959034" y="6106761"/>
                  <a:pt x="2979611" y="6094061"/>
                  <a:pt x="2989199" y="6073840"/>
                </a:cubicBezTo>
                <a:lnTo>
                  <a:pt x="2989847" y="6073840"/>
                </a:lnTo>
                <a:cubicBezTo>
                  <a:pt x="2989403" y="6078150"/>
                  <a:pt x="2989187" y="6082480"/>
                  <a:pt x="2989199" y="6086813"/>
                </a:cubicBezTo>
                <a:lnTo>
                  <a:pt x="2989199" y="6102379"/>
                </a:lnTo>
                <a:lnTo>
                  <a:pt x="3018394" y="6102379"/>
                </a:lnTo>
                <a:lnTo>
                  <a:pt x="3018394" y="5998601"/>
                </a:lnTo>
                <a:cubicBezTo>
                  <a:pt x="3018394" y="5957091"/>
                  <a:pt x="2995043" y="5934391"/>
                  <a:pt x="2953524" y="5934391"/>
                </a:cubicBezTo>
                <a:close/>
                <a:moveTo>
                  <a:pt x="2796867" y="5934391"/>
                </a:moveTo>
                <a:cubicBezTo>
                  <a:pt x="2755674" y="5934391"/>
                  <a:pt x="2741721" y="5964227"/>
                  <a:pt x="2741721" y="5964227"/>
                </a:cubicBezTo>
                <a:lnTo>
                  <a:pt x="2741072" y="5964227"/>
                </a:lnTo>
                <a:cubicBezTo>
                  <a:pt x="2741497" y="5960240"/>
                  <a:pt x="2741714" y="5956234"/>
                  <a:pt x="2741721" y="5952224"/>
                </a:cubicBezTo>
                <a:lnTo>
                  <a:pt x="2741721" y="5938282"/>
                </a:lnTo>
                <a:lnTo>
                  <a:pt x="2712857" y="5938282"/>
                </a:lnTo>
                <a:lnTo>
                  <a:pt x="2712857" y="6167243"/>
                </a:lnTo>
                <a:lnTo>
                  <a:pt x="2744318" y="6167243"/>
                </a:lnTo>
                <a:lnTo>
                  <a:pt x="2744318" y="6093620"/>
                </a:lnTo>
                <a:cubicBezTo>
                  <a:pt x="2744318" y="6085189"/>
                  <a:pt x="2743669" y="6079354"/>
                  <a:pt x="2743669" y="6079354"/>
                </a:cubicBezTo>
                <a:lnTo>
                  <a:pt x="2744318" y="6079354"/>
                </a:lnTo>
                <a:cubicBezTo>
                  <a:pt x="2755077" y="6096648"/>
                  <a:pt x="2774234" y="6106904"/>
                  <a:pt x="2794595" y="6106269"/>
                </a:cubicBezTo>
                <a:cubicBezTo>
                  <a:pt x="2837411" y="6106269"/>
                  <a:pt x="2868873" y="6072541"/>
                  <a:pt x="2868873" y="6020330"/>
                </a:cubicBezTo>
                <a:cubicBezTo>
                  <a:pt x="2868873" y="5969413"/>
                  <a:pt x="2840975" y="5934391"/>
                  <a:pt x="2796867" y="5934391"/>
                </a:cubicBezTo>
                <a:close/>
                <a:moveTo>
                  <a:pt x="3568802" y="5893205"/>
                </a:moveTo>
                <a:lnTo>
                  <a:pt x="3568802" y="5940551"/>
                </a:lnTo>
                <a:lnTo>
                  <a:pt x="3546424" y="5940551"/>
                </a:lnTo>
                <a:lnTo>
                  <a:pt x="3546424" y="5965847"/>
                </a:lnTo>
                <a:lnTo>
                  <a:pt x="3567829" y="5965847"/>
                </a:lnTo>
                <a:lnTo>
                  <a:pt x="3567829" y="6042385"/>
                </a:lnTo>
                <a:cubicBezTo>
                  <a:pt x="3567829" y="6097188"/>
                  <a:pt x="3609671" y="6103677"/>
                  <a:pt x="3630758" y="6103676"/>
                </a:cubicBezTo>
                <a:cubicBezTo>
                  <a:pt x="3634446" y="6103696"/>
                  <a:pt x="3638131" y="6103479"/>
                  <a:pt x="3641789" y="6103027"/>
                </a:cubicBezTo>
                <a:lnTo>
                  <a:pt x="3641789" y="6075138"/>
                </a:lnTo>
                <a:cubicBezTo>
                  <a:pt x="3639327" y="6075601"/>
                  <a:pt x="3636826" y="6075818"/>
                  <a:pt x="3634322" y="6075788"/>
                </a:cubicBezTo>
                <a:cubicBezTo>
                  <a:pt x="3622324" y="6075788"/>
                  <a:pt x="3599298" y="6071572"/>
                  <a:pt x="3599298" y="6038817"/>
                </a:cubicBezTo>
                <a:lnTo>
                  <a:pt x="3599298" y="5965847"/>
                </a:lnTo>
                <a:lnTo>
                  <a:pt x="3638867" y="5965847"/>
                </a:lnTo>
                <a:lnTo>
                  <a:pt x="3638867" y="5940551"/>
                </a:lnTo>
                <a:lnTo>
                  <a:pt x="3599298" y="5940551"/>
                </a:lnTo>
                <a:lnTo>
                  <a:pt x="3599298" y="5893205"/>
                </a:lnTo>
                <a:close/>
                <a:moveTo>
                  <a:pt x="3055985" y="5893205"/>
                </a:moveTo>
                <a:lnTo>
                  <a:pt x="3055985" y="5940551"/>
                </a:lnTo>
                <a:lnTo>
                  <a:pt x="3033606" y="5940551"/>
                </a:lnTo>
                <a:lnTo>
                  <a:pt x="3033606" y="5965847"/>
                </a:lnTo>
                <a:lnTo>
                  <a:pt x="3055012" y="5965847"/>
                </a:lnTo>
                <a:lnTo>
                  <a:pt x="3055012" y="6042385"/>
                </a:lnTo>
                <a:cubicBezTo>
                  <a:pt x="3055012" y="6097188"/>
                  <a:pt x="3096854" y="6103677"/>
                  <a:pt x="3117934" y="6103676"/>
                </a:cubicBezTo>
                <a:cubicBezTo>
                  <a:pt x="3121620" y="6103697"/>
                  <a:pt x="3125305" y="6103480"/>
                  <a:pt x="3128964" y="6103027"/>
                </a:cubicBezTo>
                <a:lnTo>
                  <a:pt x="3128964" y="6075138"/>
                </a:lnTo>
                <a:cubicBezTo>
                  <a:pt x="3126505" y="6075601"/>
                  <a:pt x="3124007" y="6075818"/>
                  <a:pt x="3121505" y="6075788"/>
                </a:cubicBezTo>
                <a:cubicBezTo>
                  <a:pt x="3109500" y="6075788"/>
                  <a:pt x="3086473" y="6071572"/>
                  <a:pt x="3086473" y="6038817"/>
                </a:cubicBezTo>
                <a:lnTo>
                  <a:pt x="3086473" y="5965847"/>
                </a:lnTo>
                <a:lnTo>
                  <a:pt x="3126043" y="5965847"/>
                </a:lnTo>
                <a:lnTo>
                  <a:pt x="3126043" y="5940551"/>
                </a:lnTo>
                <a:lnTo>
                  <a:pt x="3086473" y="5940551"/>
                </a:lnTo>
                <a:lnTo>
                  <a:pt x="3086473" y="5893205"/>
                </a:lnTo>
                <a:close/>
                <a:moveTo>
                  <a:pt x="2318901" y="5875367"/>
                </a:moveTo>
                <a:lnTo>
                  <a:pt x="2318901" y="6102378"/>
                </a:lnTo>
                <a:lnTo>
                  <a:pt x="2332529" y="6102378"/>
                </a:lnTo>
                <a:lnTo>
                  <a:pt x="2332529" y="6083895"/>
                </a:lnTo>
                <a:cubicBezTo>
                  <a:pt x="2332569" y="6079107"/>
                  <a:pt x="2332134" y="6074326"/>
                  <a:pt x="2331230" y="6069624"/>
                </a:cubicBezTo>
                <a:lnTo>
                  <a:pt x="2331880" y="6069624"/>
                </a:lnTo>
                <a:cubicBezTo>
                  <a:pt x="2331880" y="6069624"/>
                  <a:pt x="2347123" y="6106270"/>
                  <a:pt x="2387992" y="6106270"/>
                </a:cubicBezTo>
                <a:cubicBezTo>
                  <a:pt x="2430484" y="6106270"/>
                  <a:pt x="2460646" y="6072866"/>
                  <a:pt x="2460646" y="6021305"/>
                </a:cubicBezTo>
                <a:cubicBezTo>
                  <a:pt x="2460646" y="5971037"/>
                  <a:pt x="2434048" y="5936335"/>
                  <a:pt x="2390589" y="5936335"/>
                </a:cubicBezTo>
                <a:cubicBezTo>
                  <a:pt x="2365391" y="5935491"/>
                  <a:pt x="2342186" y="5949974"/>
                  <a:pt x="2331880" y="5972980"/>
                </a:cubicBezTo>
                <a:lnTo>
                  <a:pt x="2331230" y="5972980"/>
                </a:lnTo>
                <a:cubicBezTo>
                  <a:pt x="2332099" y="5968603"/>
                  <a:pt x="2332534" y="5964150"/>
                  <a:pt x="2332529" y="5959687"/>
                </a:cubicBezTo>
                <a:lnTo>
                  <a:pt x="2332529" y="5875367"/>
                </a:lnTo>
                <a:close/>
                <a:moveTo>
                  <a:pt x="2171335" y="5875367"/>
                </a:moveTo>
                <a:lnTo>
                  <a:pt x="2171335" y="5959687"/>
                </a:lnTo>
                <a:cubicBezTo>
                  <a:pt x="2171330" y="5964150"/>
                  <a:pt x="2171765" y="5968603"/>
                  <a:pt x="2172633" y="5972980"/>
                </a:cubicBezTo>
                <a:lnTo>
                  <a:pt x="2171984" y="5972980"/>
                </a:lnTo>
                <a:cubicBezTo>
                  <a:pt x="2171984" y="5972980"/>
                  <a:pt x="2156732" y="5936335"/>
                  <a:pt x="2115863" y="5936335"/>
                </a:cubicBezTo>
                <a:cubicBezTo>
                  <a:pt x="2073374" y="5936335"/>
                  <a:pt x="2043207" y="5969738"/>
                  <a:pt x="2043207" y="6021305"/>
                </a:cubicBezTo>
                <a:cubicBezTo>
                  <a:pt x="2043207" y="6071572"/>
                  <a:pt x="2069806" y="6106270"/>
                  <a:pt x="2113275" y="6106270"/>
                </a:cubicBezTo>
                <a:cubicBezTo>
                  <a:pt x="2138472" y="6107111"/>
                  <a:pt x="2161675" y="6092628"/>
                  <a:pt x="2171984" y="6069624"/>
                </a:cubicBezTo>
                <a:lnTo>
                  <a:pt x="2172633" y="6069624"/>
                </a:lnTo>
                <a:cubicBezTo>
                  <a:pt x="2171715" y="6073666"/>
                  <a:pt x="2171280" y="6077803"/>
                  <a:pt x="2171335" y="6081948"/>
                </a:cubicBezTo>
                <a:lnTo>
                  <a:pt x="2171335" y="6102378"/>
                </a:lnTo>
                <a:lnTo>
                  <a:pt x="2184955" y="6102378"/>
                </a:lnTo>
                <a:lnTo>
                  <a:pt x="2184955" y="5875367"/>
                </a:lnTo>
                <a:close/>
                <a:moveTo>
                  <a:pt x="1743547" y="5875367"/>
                </a:moveTo>
                <a:lnTo>
                  <a:pt x="1743547" y="5899040"/>
                </a:lnTo>
                <a:lnTo>
                  <a:pt x="1759765" y="5899040"/>
                </a:lnTo>
                <a:lnTo>
                  <a:pt x="1759765" y="5875367"/>
                </a:lnTo>
                <a:close/>
                <a:moveTo>
                  <a:pt x="1209673" y="5875367"/>
                </a:moveTo>
                <a:lnTo>
                  <a:pt x="1209673" y="6102378"/>
                </a:lnTo>
                <a:lnTo>
                  <a:pt x="1223622" y="6102378"/>
                </a:lnTo>
                <a:lnTo>
                  <a:pt x="1223622" y="5875367"/>
                </a:lnTo>
                <a:close/>
                <a:moveTo>
                  <a:pt x="740045" y="5875367"/>
                </a:moveTo>
                <a:cubicBezTo>
                  <a:pt x="865045" y="5894885"/>
                  <a:pt x="963105" y="5992926"/>
                  <a:pt x="982628" y="6117904"/>
                </a:cubicBezTo>
                <a:lnTo>
                  <a:pt x="982620" y="5875367"/>
                </a:lnTo>
                <a:close/>
                <a:moveTo>
                  <a:pt x="407989" y="5875366"/>
                </a:moveTo>
                <a:lnTo>
                  <a:pt x="407989" y="6117901"/>
                </a:lnTo>
                <a:cubicBezTo>
                  <a:pt x="427506" y="5992925"/>
                  <a:pt x="525563" y="5894884"/>
                  <a:pt x="650560" y="5875366"/>
                </a:cubicBezTo>
                <a:close/>
                <a:moveTo>
                  <a:pt x="693449" y="5875365"/>
                </a:moveTo>
                <a:lnTo>
                  <a:pt x="693449" y="6106201"/>
                </a:lnTo>
                <a:lnTo>
                  <a:pt x="685251" y="6106201"/>
                </a:lnTo>
                <a:lnTo>
                  <a:pt x="685251" y="6178022"/>
                </a:lnTo>
                <a:lnTo>
                  <a:pt x="655495" y="6178022"/>
                </a:lnTo>
                <a:lnTo>
                  <a:pt x="655495" y="6106201"/>
                </a:lnTo>
                <a:lnTo>
                  <a:pt x="617524" y="6106201"/>
                </a:lnTo>
                <a:lnTo>
                  <a:pt x="617524" y="6219053"/>
                </a:lnTo>
                <a:lnTo>
                  <a:pt x="693449" y="6219053"/>
                </a:lnTo>
                <a:lnTo>
                  <a:pt x="693449" y="6449904"/>
                </a:lnTo>
                <a:lnTo>
                  <a:pt x="697158" y="6449904"/>
                </a:lnTo>
                <a:lnTo>
                  <a:pt x="697158" y="6219053"/>
                </a:lnTo>
                <a:lnTo>
                  <a:pt x="726288" y="6219053"/>
                </a:lnTo>
                <a:lnTo>
                  <a:pt x="726288" y="6106201"/>
                </a:lnTo>
                <a:lnTo>
                  <a:pt x="697158" y="6106201"/>
                </a:lnTo>
                <a:lnTo>
                  <a:pt x="697154" y="5875365"/>
                </a:lnTo>
                <a:close/>
                <a:moveTo>
                  <a:pt x="3146995" y="5873419"/>
                </a:moveTo>
                <a:lnTo>
                  <a:pt x="3146995" y="5905528"/>
                </a:lnTo>
                <a:lnTo>
                  <a:pt x="3178780" y="5905528"/>
                </a:lnTo>
                <a:lnTo>
                  <a:pt x="3178780" y="5873419"/>
                </a:lnTo>
                <a:close/>
                <a:moveTo>
                  <a:pt x="5074981" y="3974428"/>
                </a:moveTo>
                <a:cubicBezTo>
                  <a:pt x="5308980" y="5220716"/>
                  <a:pt x="6284078" y="6195621"/>
                  <a:pt x="7530588" y="6429546"/>
                </a:cubicBezTo>
                <a:lnTo>
                  <a:pt x="5074981" y="6429546"/>
                </a:lnTo>
                <a:close/>
                <a:moveTo>
                  <a:pt x="11122964" y="3974190"/>
                </a:moveTo>
                <a:lnTo>
                  <a:pt x="11122964" y="6429463"/>
                </a:lnTo>
                <a:lnTo>
                  <a:pt x="8666920" y="6429463"/>
                </a:lnTo>
                <a:cubicBezTo>
                  <a:pt x="9913518" y="6195441"/>
                  <a:pt x="10888727" y="5220539"/>
                  <a:pt x="11122964" y="3974190"/>
                </a:cubicBezTo>
                <a:close/>
                <a:moveTo>
                  <a:pt x="5074885" y="3877086"/>
                </a:moveTo>
                <a:lnTo>
                  <a:pt x="5058713" y="3878325"/>
                </a:lnTo>
                <a:lnTo>
                  <a:pt x="5058713" y="6445810"/>
                </a:lnTo>
                <a:lnTo>
                  <a:pt x="7626641" y="6445810"/>
                </a:lnTo>
                <a:lnTo>
                  <a:pt x="7627884" y="6429641"/>
                </a:lnTo>
                <a:cubicBezTo>
                  <a:pt x="6311888" y="6225121"/>
                  <a:pt x="5279443" y="5192853"/>
                  <a:pt x="5074885" y="3877086"/>
                </a:cubicBezTo>
                <a:close/>
                <a:moveTo>
                  <a:pt x="11123059" y="3876995"/>
                </a:moveTo>
                <a:cubicBezTo>
                  <a:pt x="10918269" y="5192805"/>
                  <a:pt x="9885698" y="6225024"/>
                  <a:pt x="8569625" y="6429558"/>
                </a:cubicBezTo>
                <a:lnTo>
                  <a:pt x="8570868" y="6445727"/>
                </a:lnTo>
                <a:lnTo>
                  <a:pt x="11139231" y="6445727"/>
                </a:lnTo>
                <a:lnTo>
                  <a:pt x="11139231" y="3878238"/>
                </a:lnTo>
                <a:close/>
                <a:moveTo>
                  <a:pt x="5074862" y="382592"/>
                </a:moveTo>
                <a:lnTo>
                  <a:pt x="7530485" y="382592"/>
                </a:lnTo>
                <a:cubicBezTo>
                  <a:pt x="6283949" y="616774"/>
                  <a:pt x="5308909" y="1591792"/>
                  <a:pt x="5074862" y="2838143"/>
                </a:cubicBezTo>
                <a:close/>
                <a:moveTo>
                  <a:pt x="8666781" y="382485"/>
                </a:moveTo>
                <a:lnTo>
                  <a:pt x="11122821" y="382485"/>
                </a:lnTo>
                <a:lnTo>
                  <a:pt x="11122821" y="2838196"/>
                </a:lnTo>
                <a:cubicBezTo>
                  <a:pt x="10888566" y="1591774"/>
                  <a:pt x="9913411" y="616748"/>
                  <a:pt x="8666781" y="382485"/>
                </a:cubicBezTo>
                <a:close/>
                <a:moveTo>
                  <a:pt x="5058594" y="366328"/>
                </a:moveTo>
                <a:lnTo>
                  <a:pt x="5058594" y="2934247"/>
                </a:lnTo>
                <a:lnTo>
                  <a:pt x="5074766" y="2935488"/>
                </a:lnTo>
                <a:cubicBezTo>
                  <a:pt x="5279296" y="1619627"/>
                  <a:pt x="6311705" y="587215"/>
                  <a:pt x="7627761" y="382497"/>
                </a:cubicBezTo>
                <a:lnTo>
                  <a:pt x="7626518" y="366328"/>
                </a:lnTo>
                <a:close/>
                <a:moveTo>
                  <a:pt x="8570721" y="366221"/>
                </a:moveTo>
                <a:lnTo>
                  <a:pt x="8569478" y="382390"/>
                </a:lnTo>
                <a:cubicBezTo>
                  <a:pt x="9885660" y="587019"/>
                  <a:pt x="10918248" y="1619427"/>
                  <a:pt x="11122916" y="2935381"/>
                </a:cubicBezTo>
                <a:lnTo>
                  <a:pt x="11139088" y="2934139"/>
                </a:lnTo>
                <a:lnTo>
                  <a:pt x="11139088" y="366221"/>
                </a:lnTo>
                <a:close/>
                <a:moveTo>
                  <a:pt x="0" y="0"/>
                </a:moveTo>
                <a:lnTo>
                  <a:pt x="12191993" y="0"/>
                </a:lnTo>
                <a:lnTo>
                  <a:pt x="12191993" y="6857996"/>
                </a:lnTo>
                <a:lnTo>
                  <a:pt x="0" y="6857996"/>
                </a:lnTo>
                <a:close/>
              </a:path>
            </a:pathLst>
          </a:custGeom>
          <a:solidFill>
            <a:schemeClr val="tx1"/>
          </a:solidFill>
        </p:spPr>
        <p:txBody>
          <a:bodyPr wrap="square">
            <a:noAutofit/>
          </a:bodyPr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BE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1ED276C-6DB4-C248-B8F8-A80AC7FEE4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88" y="2636534"/>
            <a:ext cx="4656381" cy="867930"/>
          </a:xfrm>
        </p:spPr>
        <p:txBody>
          <a:bodyPr wrap="square" rIns="36000" anchor="b">
            <a:spAutoFit/>
          </a:bodyPr>
          <a:lstStyle>
            <a:lvl1pPr algn="l">
              <a:defRPr sz="280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3290F0-62FD-6446-BD33-1B3A80AD04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07988" y="3596539"/>
            <a:ext cx="4656381" cy="313932"/>
          </a:xfrm>
        </p:spPr>
        <p:txBody>
          <a:bodyPr wrap="square" rIns="36000">
            <a:spAutoFit/>
          </a:bodyPr>
          <a:lstStyle>
            <a:lvl1pPr marL="0" indent="0" algn="l">
              <a:buNone/>
              <a:defRPr sz="160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10" name="Footer Placeholder 4">
            <a:extLst>
              <a:ext uri="{FF2B5EF4-FFF2-40B4-BE49-F238E27FC236}">
                <a16:creationId xmlns:a16="http://schemas.microsoft.com/office/drawing/2014/main" id="{F3DF0697-75B6-104D-AADC-B7E50CA194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538445" y="6547006"/>
            <a:ext cx="7127920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lvl1pPr algn="ctr">
              <a:defRPr sz="800">
                <a:solidFill>
                  <a:schemeClr val="bg1"/>
                </a:solidFill>
              </a:defRPr>
            </a:lvl1pPr>
          </a:lstStyle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7068485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ullet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t">
            <a:sp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412875"/>
            <a:ext cx="11339946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0608166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ulleted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412875"/>
            <a:ext cx="11339946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6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6266868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26027" y="2948087"/>
            <a:ext cx="1924897" cy="480131"/>
          </a:xfrm>
        </p:spPr>
        <p:txBody>
          <a:bodyPr wrap="square" anchor="ctr">
            <a:spAutoFit/>
          </a:bodyPr>
          <a:lstStyle/>
          <a:p>
            <a:r>
              <a:rPr lang="en-GB"/>
              <a:t>Agenda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2350924" y="1072444"/>
            <a:ext cx="9415049" cy="4231418"/>
          </a:xfrm>
        </p:spPr>
        <p:txBody>
          <a:bodyPr rIns="72000" anchor="ctr">
            <a:normAutofit/>
          </a:bodyPr>
          <a:lstStyle>
            <a:lvl1pPr marL="342900" indent="-342900">
              <a:buFont typeface="+mj-lt"/>
              <a:buAutoNum type="arabicPeriod"/>
              <a:defRPr sz="1800"/>
            </a:lvl1pPr>
            <a:lvl2pPr marL="800100" indent="-342900">
              <a:buFont typeface="+mj-lt"/>
              <a:buAutoNum type="arabicPeriod"/>
              <a:defRPr sz="1600"/>
            </a:lvl2pPr>
            <a:lvl3pPr>
              <a:buFont typeface="+mj-lt"/>
              <a:buAutoNum type="arabicPeriod"/>
              <a:defRPr sz="1400"/>
            </a:lvl3pPr>
            <a:lvl4pPr>
              <a:buFont typeface="+mj-lt"/>
              <a:buAutoNum type="arabicPeriod"/>
              <a:defRPr sz="1200"/>
            </a:lvl4pPr>
            <a:lvl5pPr>
              <a:buFont typeface="+mj-lt"/>
              <a:buAutoNum type="arabicPeriod"/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6BAC6D8C-4CD7-404E-803B-9C1856B74D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6"/>
            <a:ext cx="731603" cy="749022"/>
          </a:xfrm>
          <a:prstGeom prst="rect">
            <a:avLst/>
          </a:prstGeom>
        </p:spPr>
      </p:pic>
      <p:sp>
        <p:nvSpPr>
          <p:cNvPr id="57" name="Freeform 5">
            <a:extLst>
              <a:ext uri="{FF2B5EF4-FFF2-40B4-BE49-F238E27FC236}">
                <a16:creationId xmlns:a16="http://schemas.microsoft.com/office/drawing/2014/main" id="{34A1DC10-00A7-8F4E-B794-229E5F875B78}"/>
              </a:ext>
            </a:extLst>
          </p:cNvPr>
          <p:cNvSpPr>
            <a:spLocks/>
          </p:cNvSpPr>
          <p:nvPr/>
        </p:nvSpPr>
        <p:spPr bwMode="auto">
          <a:xfrm rot="5400000" flipH="1">
            <a:off x="414951" y="390169"/>
            <a:ext cx="737003" cy="731602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9" name="Graphic 8">
            <a:extLst>
              <a:ext uri="{FF2B5EF4-FFF2-40B4-BE49-F238E27FC236}">
                <a16:creationId xmlns:a16="http://schemas.microsoft.com/office/drawing/2014/main" id="{99F642E9-70FA-1247-BA86-AF1A80340FD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6"/>
            <a:ext cx="731603" cy="749022"/>
          </a:xfrm>
          <a:prstGeom prst="rect">
            <a:avLst/>
          </a:prstGeom>
        </p:spPr>
      </p:pic>
      <p:sp>
        <p:nvSpPr>
          <p:cNvPr id="10" name="Freeform 5">
            <a:extLst>
              <a:ext uri="{FF2B5EF4-FFF2-40B4-BE49-F238E27FC236}">
                <a16:creationId xmlns:a16="http://schemas.microsoft.com/office/drawing/2014/main" id="{B9E80466-0F67-B749-B46F-1A7900249BBA}"/>
              </a:ext>
            </a:extLst>
          </p:cNvPr>
          <p:cNvSpPr>
            <a:spLocks/>
          </p:cNvSpPr>
          <p:nvPr userDrawn="1"/>
        </p:nvSpPr>
        <p:spPr bwMode="auto">
          <a:xfrm rot="5400000" flipH="1">
            <a:off x="414951" y="390169"/>
            <a:ext cx="737003" cy="731602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61206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4362C-8F8F-438B-AF19-3B8AC04D0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2894FE-A64F-427D-8489-89A71FBA06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F165C4-D14F-4639-BE62-61EE7974A6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07B6AE-B387-4D36-943F-0A3EDDEB1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689DF9-3F76-4721-81D9-B1B72779A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85CA41-B6D1-497A-8F2B-14876B66D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977611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t">
            <a:sp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6107575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sldNum="0" hdr="0" dt="0"/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ub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790385"/>
            <a:ext cx="11339946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592405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Grey background">
    <p:bg>
      <p:bgPr>
        <a:solidFill>
          <a:schemeClr val="bg1">
            <a:lumMod val="95000"/>
            <a:alpha val="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6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5545127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oubl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412875"/>
            <a:ext cx="5572101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6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193874" y="1412875"/>
            <a:ext cx="5572101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5304389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ouble content w titl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925053"/>
            <a:ext cx="5572101" cy="41836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6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193874" y="1925053"/>
            <a:ext cx="5572101" cy="41836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727D5C-5A0E-0846-8C0F-CCCCCECE26EA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25450" y="1432917"/>
            <a:ext cx="5572101" cy="369332"/>
          </a:xfrm>
        </p:spPr>
        <p:txBody>
          <a:bodyPr wrap="square" anchor="b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="1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F3272EEB-918D-1E46-8C24-CD246EDC6A16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6193872" y="1432917"/>
            <a:ext cx="5572101" cy="369332"/>
          </a:xfrm>
        </p:spPr>
        <p:txBody>
          <a:bodyPr wrap="square" anchor="b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="1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89662836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ingle content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412875"/>
            <a:ext cx="5572101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6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0245905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98246" y="264598"/>
            <a:ext cx="5399548" cy="4801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5598246" y="805774"/>
            <a:ext cx="5399548" cy="400110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Picture Placeholder 47">
            <a:extLst>
              <a:ext uri="{FF2B5EF4-FFF2-40B4-BE49-F238E27FC236}">
                <a16:creationId xmlns:a16="http://schemas.microsoft.com/office/drawing/2014/main" id="{C6681D1E-D330-9E42-B1B1-C48A4D7629F0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407988" y="336265"/>
            <a:ext cx="4980976" cy="5772435"/>
          </a:xfrm>
          <a:custGeom>
            <a:avLst/>
            <a:gdLst>
              <a:gd name="connsiteX0" fmla="*/ 195256 w 5084529"/>
              <a:gd name="connsiteY0" fmla="*/ 200195 h 5940425"/>
              <a:gd name="connsiteX1" fmla="*/ 830029 w 5084529"/>
              <a:gd name="connsiteY1" fmla="*/ 200195 h 5940425"/>
              <a:gd name="connsiteX2" fmla="*/ 422378 w 5084529"/>
              <a:gd name="connsiteY2" fmla="*/ 432030 h 5940425"/>
              <a:gd name="connsiteX3" fmla="*/ 195383 w 5084529"/>
              <a:gd name="connsiteY3" fmla="*/ 846590 h 5940425"/>
              <a:gd name="connsiteX4" fmla="*/ 182624 w 5084529"/>
              <a:gd name="connsiteY4" fmla="*/ 187362 h 5940425"/>
              <a:gd name="connsiteX5" fmla="*/ 182624 w 5084529"/>
              <a:gd name="connsiteY5" fmla="*/ 913936 h 5940425"/>
              <a:gd name="connsiteX6" fmla="*/ 195320 w 5084529"/>
              <a:gd name="connsiteY6" fmla="*/ 914889 h 5940425"/>
              <a:gd name="connsiteX7" fmla="*/ 431645 w 5084529"/>
              <a:gd name="connsiteY7" fmla="*/ 440799 h 5940425"/>
              <a:gd name="connsiteX8" fmla="*/ 896045 w 5084529"/>
              <a:gd name="connsiteY8" fmla="*/ 200068 h 5940425"/>
              <a:gd name="connsiteX9" fmla="*/ 895029 w 5084529"/>
              <a:gd name="connsiteY9" fmla="*/ 187362 h 5940425"/>
              <a:gd name="connsiteX10" fmla="*/ 0 w 5084529"/>
              <a:gd name="connsiteY10" fmla="*/ 0 h 5940425"/>
              <a:gd name="connsiteX11" fmla="*/ 5084529 w 5084529"/>
              <a:gd name="connsiteY11" fmla="*/ 0 h 5940425"/>
              <a:gd name="connsiteX12" fmla="*/ 5084529 w 5084529"/>
              <a:gd name="connsiteY12" fmla="*/ 5940425 h 5940425"/>
              <a:gd name="connsiteX13" fmla="*/ 0 w 5084529"/>
              <a:gd name="connsiteY13" fmla="*/ 5940425 h 5940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5084529" h="5940425">
                <a:moveTo>
                  <a:pt x="195256" y="200195"/>
                </a:moveTo>
                <a:lnTo>
                  <a:pt x="830029" y="200195"/>
                </a:lnTo>
                <a:cubicBezTo>
                  <a:pt x="674944" y="237256"/>
                  <a:pt x="533572" y="317656"/>
                  <a:pt x="422378" y="432030"/>
                </a:cubicBezTo>
                <a:cubicBezTo>
                  <a:pt x="309817" y="546511"/>
                  <a:pt x="231233" y="690030"/>
                  <a:pt x="195383" y="846590"/>
                </a:cubicBezTo>
                <a:close/>
                <a:moveTo>
                  <a:pt x="182624" y="187362"/>
                </a:moveTo>
                <a:lnTo>
                  <a:pt x="182624" y="913936"/>
                </a:lnTo>
                <a:lnTo>
                  <a:pt x="195320" y="914889"/>
                </a:lnTo>
                <a:cubicBezTo>
                  <a:pt x="222003" y="735815"/>
                  <a:pt x="304745" y="569827"/>
                  <a:pt x="431645" y="440799"/>
                </a:cubicBezTo>
                <a:cubicBezTo>
                  <a:pt x="556385" y="312431"/>
                  <a:pt x="719320" y="227970"/>
                  <a:pt x="896045" y="200068"/>
                </a:cubicBezTo>
                <a:lnTo>
                  <a:pt x="895029" y="187362"/>
                </a:lnTo>
                <a:close/>
                <a:moveTo>
                  <a:pt x="0" y="0"/>
                </a:moveTo>
                <a:lnTo>
                  <a:pt x="5084529" y="0"/>
                </a:lnTo>
                <a:lnTo>
                  <a:pt x="5084529" y="5940425"/>
                </a:lnTo>
                <a:lnTo>
                  <a:pt x="0" y="5940425"/>
                </a:lnTo>
                <a:close/>
              </a:path>
            </a:pathLst>
          </a:custGeom>
          <a:solidFill>
            <a:schemeClr val="bg2"/>
          </a:solidFill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en-GB"/>
          </a:p>
        </p:txBody>
      </p:sp>
      <p:sp>
        <p:nvSpPr>
          <p:cNvPr id="11" name="Freeform 5">
            <a:extLst>
              <a:ext uri="{FF2B5EF4-FFF2-40B4-BE49-F238E27FC236}">
                <a16:creationId xmlns:a16="http://schemas.microsoft.com/office/drawing/2014/main" id="{9DBD75DD-0082-5D47-BDDB-BF00387E98E6}"/>
              </a:ext>
            </a:extLst>
          </p:cNvPr>
          <p:cNvSpPr>
            <a:spLocks/>
          </p:cNvSpPr>
          <p:nvPr/>
        </p:nvSpPr>
        <p:spPr bwMode="auto">
          <a:xfrm rot="16200000" flipH="1">
            <a:off x="11248024" y="5405188"/>
            <a:ext cx="737003" cy="731602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" name="Content Placeholder 7">
            <a:extLst>
              <a:ext uri="{FF2B5EF4-FFF2-40B4-BE49-F238E27FC236}">
                <a16:creationId xmlns:a16="http://schemas.microsoft.com/office/drawing/2014/main" id="{0190FF4E-3BF7-B64B-A048-4A7F0F929204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5580749" y="1476531"/>
            <a:ext cx="5417045" cy="4632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9" name="Freeform 5">
            <a:extLst>
              <a:ext uri="{FF2B5EF4-FFF2-40B4-BE49-F238E27FC236}">
                <a16:creationId xmlns:a16="http://schemas.microsoft.com/office/drawing/2014/main" id="{F789CB9A-7CAB-ED4F-8023-756B4C589680}"/>
              </a:ext>
            </a:extLst>
          </p:cNvPr>
          <p:cNvSpPr>
            <a:spLocks/>
          </p:cNvSpPr>
          <p:nvPr userDrawn="1"/>
        </p:nvSpPr>
        <p:spPr bwMode="auto">
          <a:xfrm rot="16200000" flipH="1">
            <a:off x="11248024" y="5405188"/>
            <a:ext cx="737003" cy="731602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510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ouble content blue corne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6288" y="973983"/>
            <a:ext cx="5399548" cy="4801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776288" y="1521489"/>
            <a:ext cx="5399548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509971" y="973983"/>
            <a:ext cx="4939908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581192B2-F45A-B845-80ED-C263E992FB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6"/>
            <a:ext cx="731603" cy="749022"/>
          </a:xfrm>
          <a:prstGeom prst="rect">
            <a:avLst/>
          </a:prstGeom>
        </p:spPr>
      </p:pic>
      <p:sp>
        <p:nvSpPr>
          <p:cNvPr id="13" name="Freeform 5">
            <a:extLst>
              <a:ext uri="{FF2B5EF4-FFF2-40B4-BE49-F238E27FC236}">
                <a16:creationId xmlns:a16="http://schemas.microsoft.com/office/drawing/2014/main" id="{8FB8FAAA-F7C9-494E-B088-EDFF247E0C50}"/>
              </a:ext>
            </a:extLst>
          </p:cNvPr>
          <p:cNvSpPr>
            <a:spLocks/>
          </p:cNvSpPr>
          <p:nvPr/>
        </p:nvSpPr>
        <p:spPr bwMode="auto">
          <a:xfrm rot="5400000" flipH="1">
            <a:off x="414951" y="390169"/>
            <a:ext cx="737003" cy="731602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" name="Content Placeholder 7">
            <a:extLst>
              <a:ext uri="{FF2B5EF4-FFF2-40B4-BE49-F238E27FC236}">
                <a16:creationId xmlns:a16="http://schemas.microsoft.com/office/drawing/2014/main" id="{C0F03F8C-A030-9A44-8698-81FC663C2FDD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776288" y="2040629"/>
            <a:ext cx="5399548" cy="36291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111FA9B9-CFAD-7D46-92AE-7285C14C8BC4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6"/>
            <a:ext cx="731603" cy="749022"/>
          </a:xfrm>
          <a:prstGeom prst="rect">
            <a:avLst/>
          </a:prstGeom>
        </p:spPr>
      </p:pic>
      <p:sp>
        <p:nvSpPr>
          <p:cNvPr id="14" name="Freeform 5">
            <a:extLst>
              <a:ext uri="{FF2B5EF4-FFF2-40B4-BE49-F238E27FC236}">
                <a16:creationId xmlns:a16="http://schemas.microsoft.com/office/drawing/2014/main" id="{859D98E4-9191-0345-AD56-18E972C0A1F4}"/>
              </a:ext>
            </a:extLst>
          </p:cNvPr>
          <p:cNvSpPr>
            <a:spLocks/>
          </p:cNvSpPr>
          <p:nvPr userDrawn="1"/>
        </p:nvSpPr>
        <p:spPr bwMode="auto">
          <a:xfrm rot="5400000" flipH="1">
            <a:off x="414951" y="390169"/>
            <a:ext cx="737003" cy="731602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19461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Double content grey corn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Freeform 5">
            <a:extLst>
              <a:ext uri="{FF2B5EF4-FFF2-40B4-BE49-F238E27FC236}">
                <a16:creationId xmlns:a16="http://schemas.microsoft.com/office/drawing/2014/main" id="{21EFE6BB-2ABE-CD4B-8929-B51CE9BB66BF}"/>
              </a:ext>
            </a:extLst>
          </p:cNvPr>
          <p:cNvSpPr>
            <a:spLocks/>
          </p:cNvSpPr>
          <p:nvPr/>
        </p:nvSpPr>
        <p:spPr bwMode="auto">
          <a:xfrm flipH="1">
            <a:off x="1393" y="2234871"/>
            <a:ext cx="4578350" cy="4622935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6288" y="973983"/>
            <a:ext cx="5399548" cy="4801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4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776288" y="1521489"/>
            <a:ext cx="5399548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509971" y="973983"/>
            <a:ext cx="4939908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854BDDB-5BC7-D04A-8AD4-10F6106E5870}"/>
              </a:ext>
            </a:extLst>
          </p:cNvPr>
          <p:cNvSpPr txBox="1"/>
          <p:nvPr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6AF053E2-0ACA-F648-9DD6-CF48A635D4F8}"/>
              </a:ext>
            </a:extLst>
          </p:cNvPr>
          <p:cNvGrpSpPr/>
          <p:nvPr/>
        </p:nvGrpSpPr>
        <p:grpSpPr>
          <a:xfrm>
            <a:off x="417651" y="6383294"/>
            <a:ext cx="1579562" cy="304766"/>
            <a:chOff x="769938" y="419101"/>
            <a:chExt cx="12193588" cy="2352675"/>
          </a:xfrm>
          <a:solidFill>
            <a:schemeClr val="accent1"/>
          </a:solidFill>
        </p:grpSpPr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8877EFD0-1E53-4A47-80F7-A926D2F1CA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6276" y="419101"/>
              <a:ext cx="858838" cy="889000"/>
            </a:xfrm>
            <a:custGeom>
              <a:avLst/>
              <a:gdLst>
                <a:gd name="T0" fmla="*/ 452 w 452"/>
                <a:gd name="T1" fmla="*/ 467 h 467"/>
                <a:gd name="T2" fmla="*/ 452 w 452"/>
                <a:gd name="T3" fmla="*/ 0 h 467"/>
                <a:gd name="T4" fmla="*/ 0 w 452"/>
                <a:gd name="T5" fmla="*/ 0 h 467"/>
                <a:gd name="T6" fmla="*/ 452 w 452"/>
                <a:gd name="T7" fmla="*/ 467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452" y="467"/>
                  </a:moveTo>
                  <a:cubicBezTo>
                    <a:pt x="452" y="0"/>
                    <a:pt x="452" y="0"/>
                    <a:pt x="45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233" y="37"/>
                    <a:pt x="416" y="227"/>
                    <a:pt x="452" y="467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05B94AA3-7F1D-AA44-9A34-46345ACC0575}"/>
                </a:ext>
              </a:extLst>
            </p:cNvPr>
            <p:cNvSpPr>
              <a:spLocks/>
            </p:cNvSpPr>
            <p:nvPr/>
          </p:nvSpPr>
          <p:spPr bwMode="auto">
            <a:xfrm>
              <a:off x="769938" y="419101"/>
              <a:ext cx="858838" cy="889000"/>
            </a:xfrm>
            <a:custGeom>
              <a:avLst/>
              <a:gdLst>
                <a:gd name="T0" fmla="*/ 452 w 452"/>
                <a:gd name="T1" fmla="*/ 0 h 467"/>
                <a:gd name="T2" fmla="*/ 0 w 452"/>
                <a:gd name="T3" fmla="*/ 0 h 467"/>
                <a:gd name="T4" fmla="*/ 0 w 452"/>
                <a:gd name="T5" fmla="*/ 467 h 467"/>
                <a:gd name="T6" fmla="*/ 452 w 452"/>
                <a:gd name="T7" fmla="*/ 0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452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467"/>
                    <a:pt x="0" y="467"/>
                    <a:pt x="0" y="467"/>
                  </a:cubicBezTo>
                  <a:cubicBezTo>
                    <a:pt x="36" y="227"/>
                    <a:pt x="220" y="37"/>
                    <a:pt x="452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60433023-A4F2-924A-890E-B0DF6E382DBD}"/>
                </a:ext>
              </a:extLst>
            </p:cNvPr>
            <p:cNvSpPr>
              <a:spLocks/>
            </p:cNvSpPr>
            <p:nvPr/>
          </p:nvSpPr>
          <p:spPr bwMode="auto">
            <a:xfrm>
              <a:off x="769938" y="1635126"/>
              <a:ext cx="858838" cy="890588"/>
            </a:xfrm>
            <a:custGeom>
              <a:avLst/>
              <a:gdLst>
                <a:gd name="T0" fmla="*/ 0 w 452"/>
                <a:gd name="T1" fmla="*/ 0 h 467"/>
                <a:gd name="T2" fmla="*/ 0 w 452"/>
                <a:gd name="T3" fmla="*/ 467 h 467"/>
                <a:gd name="T4" fmla="*/ 452 w 452"/>
                <a:gd name="T5" fmla="*/ 467 h 467"/>
                <a:gd name="T6" fmla="*/ 0 w 452"/>
                <a:gd name="T7" fmla="*/ 0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0" y="0"/>
                  </a:moveTo>
                  <a:cubicBezTo>
                    <a:pt x="0" y="467"/>
                    <a:pt x="0" y="467"/>
                    <a:pt x="0" y="467"/>
                  </a:cubicBezTo>
                  <a:cubicBezTo>
                    <a:pt x="452" y="467"/>
                    <a:pt x="452" y="467"/>
                    <a:pt x="452" y="467"/>
                  </a:cubicBezTo>
                  <a:cubicBezTo>
                    <a:pt x="220" y="430"/>
                    <a:pt x="36" y="240"/>
                    <a:pt x="0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19B12731-D2DD-1E44-937C-7C9945B25F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6276" y="1635126"/>
              <a:ext cx="858838" cy="890588"/>
            </a:xfrm>
            <a:custGeom>
              <a:avLst/>
              <a:gdLst>
                <a:gd name="T0" fmla="*/ 0 w 452"/>
                <a:gd name="T1" fmla="*/ 467 h 467"/>
                <a:gd name="T2" fmla="*/ 452 w 452"/>
                <a:gd name="T3" fmla="*/ 467 h 467"/>
                <a:gd name="T4" fmla="*/ 452 w 452"/>
                <a:gd name="T5" fmla="*/ 0 h 467"/>
                <a:gd name="T6" fmla="*/ 0 w 452"/>
                <a:gd name="T7" fmla="*/ 467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0" y="467"/>
                  </a:moveTo>
                  <a:cubicBezTo>
                    <a:pt x="452" y="467"/>
                    <a:pt x="452" y="467"/>
                    <a:pt x="452" y="467"/>
                  </a:cubicBezTo>
                  <a:cubicBezTo>
                    <a:pt x="452" y="0"/>
                    <a:pt x="452" y="0"/>
                    <a:pt x="452" y="0"/>
                  </a:cubicBezTo>
                  <a:cubicBezTo>
                    <a:pt x="416" y="240"/>
                    <a:pt x="233" y="430"/>
                    <a:pt x="0" y="467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35105EED-6F42-6D4A-A12A-2F6B7FB8E4C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6276" y="1265238"/>
              <a:ext cx="319088" cy="414338"/>
            </a:xfrm>
            <a:custGeom>
              <a:avLst/>
              <a:gdLst>
                <a:gd name="T0" fmla="*/ 201 w 201"/>
                <a:gd name="T1" fmla="*/ 166 h 261"/>
                <a:gd name="T2" fmla="*/ 91 w 201"/>
                <a:gd name="T3" fmla="*/ 166 h 261"/>
                <a:gd name="T4" fmla="*/ 91 w 201"/>
                <a:gd name="T5" fmla="*/ 94 h 261"/>
                <a:gd name="T6" fmla="*/ 201 w 201"/>
                <a:gd name="T7" fmla="*/ 94 h 261"/>
                <a:gd name="T8" fmla="*/ 201 w 201"/>
                <a:gd name="T9" fmla="*/ 0 h 261"/>
                <a:gd name="T10" fmla="*/ 0 w 201"/>
                <a:gd name="T11" fmla="*/ 0 h 261"/>
                <a:gd name="T12" fmla="*/ 0 w 201"/>
                <a:gd name="T13" fmla="*/ 261 h 261"/>
                <a:gd name="T14" fmla="*/ 201 w 201"/>
                <a:gd name="T15" fmla="*/ 261 h 261"/>
                <a:gd name="T16" fmla="*/ 201 w 201"/>
                <a:gd name="T17" fmla="*/ 166 h 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01" h="261">
                  <a:moveTo>
                    <a:pt x="201" y="166"/>
                  </a:moveTo>
                  <a:lnTo>
                    <a:pt x="91" y="166"/>
                  </a:lnTo>
                  <a:lnTo>
                    <a:pt x="91" y="94"/>
                  </a:lnTo>
                  <a:lnTo>
                    <a:pt x="201" y="94"/>
                  </a:lnTo>
                  <a:lnTo>
                    <a:pt x="201" y="0"/>
                  </a:lnTo>
                  <a:lnTo>
                    <a:pt x="0" y="0"/>
                  </a:lnTo>
                  <a:lnTo>
                    <a:pt x="0" y="261"/>
                  </a:lnTo>
                  <a:lnTo>
                    <a:pt x="201" y="261"/>
                  </a:lnTo>
                  <a:lnTo>
                    <a:pt x="201" y="166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B39AC0C7-99C2-9D4C-9756-78218D32D52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08226" y="1031876"/>
              <a:ext cx="393700" cy="647700"/>
            </a:xfrm>
            <a:custGeom>
              <a:avLst/>
              <a:gdLst>
                <a:gd name="T0" fmla="*/ 163 w 248"/>
                <a:gd name="T1" fmla="*/ 313 h 408"/>
                <a:gd name="T2" fmla="*/ 93 w 248"/>
                <a:gd name="T3" fmla="*/ 313 h 408"/>
                <a:gd name="T4" fmla="*/ 93 w 248"/>
                <a:gd name="T5" fmla="*/ 241 h 408"/>
                <a:gd name="T6" fmla="*/ 163 w 248"/>
                <a:gd name="T7" fmla="*/ 241 h 408"/>
                <a:gd name="T8" fmla="*/ 163 w 248"/>
                <a:gd name="T9" fmla="*/ 313 h 408"/>
                <a:gd name="T10" fmla="*/ 0 w 248"/>
                <a:gd name="T11" fmla="*/ 0 h 408"/>
                <a:gd name="T12" fmla="*/ 0 w 248"/>
                <a:gd name="T13" fmla="*/ 408 h 408"/>
                <a:gd name="T14" fmla="*/ 248 w 248"/>
                <a:gd name="T15" fmla="*/ 408 h 408"/>
                <a:gd name="T16" fmla="*/ 248 w 248"/>
                <a:gd name="T17" fmla="*/ 147 h 408"/>
                <a:gd name="T18" fmla="*/ 93 w 248"/>
                <a:gd name="T19" fmla="*/ 147 h 408"/>
                <a:gd name="T20" fmla="*/ 93 w 248"/>
                <a:gd name="T21" fmla="*/ 0 h 408"/>
                <a:gd name="T22" fmla="*/ 0 w 248"/>
                <a:gd name="T23" fmla="*/ 0 h 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8" h="408">
                  <a:moveTo>
                    <a:pt x="163" y="313"/>
                  </a:moveTo>
                  <a:lnTo>
                    <a:pt x="93" y="313"/>
                  </a:lnTo>
                  <a:lnTo>
                    <a:pt x="93" y="241"/>
                  </a:lnTo>
                  <a:lnTo>
                    <a:pt x="163" y="241"/>
                  </a:lnTo>
                  <a:lnTo>
                    <a:pt x="163" y="313"/>
                  </a:lnTo>
                  <a:close/>
                  <a:moveTo>
                    <a:pt x="0" y="0"/>
                  </a:moveTo>
                  <a:lnTo>
                    <a:pt x="0" y="408"/>
                  </a:lnTo>
                  <a:lnTo>
                    <a:pt x="248" y="408"/>
                  </a:lnTo>
                  <a:lnTo>
                    <a:pt x="248" y="147"/>
                  </a:lnTo>
                  <a:lnTo>
                    <a:pt x="93" y="147"/>
                  </a:lnTo>
                  <a:lnTo>
                    <a:pt x="93" y="0"/>
                  </a:ln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8D02B1E5-C05E-9844-BA33-9CB1289A79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12888" y="419101"/>
              <a:ext cx="384175" cy="2106613"/>
            </a:xfrm>
            <a:custGeom>
              <a:avLst/>
              <a:gdLst>
                <a:gd name="T0" fmla="*/ 177 w 242"/>
                <a:gd name="T1" fmla="*/ 0 h 1327"/>
                <a:gd name="T2" fmla="*/ 169 w 242"/>
                <a:gd name="T3" fmla="*/ 0 h 1327"/>
                <a:gd name="T4" fmla="*/ 169 w 242"/>
                <a:gd name="T5" fmla="*/ 533 h 1327"/>
                <a:gd name="T6" fmla="*/ 151 w 242"/>
                <a:gd name="T7" fmla="*/ 533 h 1327"/>
                <a:gd name="T8" fmla="*/ 151 w 242"/>
                <a:gd name="T9" fmla="*/ 699 h 1327"/>
                <a:gd name="T10" fmla="*/ 85 w 242"/>
                <a:gd name="T11" fmla="*/ 699 h 1327"/>
                <a:gd name="T12" fmla="*/ 85 w 242"/>
                <a:gd name="T13" fmla="*/ 533 h 1327"/>
                <a:gd name="T14" fmla="*/ 0 w 242"/>
                <a:gd name="T15" fmla="*/ 533 h 1327"/>
                <a:gd name="T16" fmla="*/ 0 w 242"/>
                <a:gd name="T17" fmla="*/ 794 h 1327"/>
                <a:gd name="T18" fmla="*/ 169 w 242"/>
                <a:gd name="T19" fmla="*/ 794 h 1327"/>
                <a:gd name="T20" fmla="*/ 169 w 242"/>
                <a:gd name="T21" fmla="*/ 1327 h 1327"/>
                <a:gd name="T22" fmla="*/ 177 w 242"/>
                <a:gd name="T23" fmla="*/ 1327 h 1327"/>
                <a:gd name="T24" fmla="*/ 177 w 242"/>
                <a:gd name="T25" fmla="*/ 794 h 1327"/>
                <a:gd name="T26" fmla="*/ 242 w 242"/>
                <a:gd name="T27" fmla="*/ 794 h 1327"/>
                <a:gd name="T28" fmla="*/ 242 w 242"/>
                <a:gd name="T29" fmla="*/ 533 h 1327"/>
                <a:gd name="T30" fmla="*/ 177 w 242"/>
                <a:gd name="T31" fmla="*/ 533 h 1327"/>
                <a:gd name="T32" fmla="*/ 177 w 242"/>
                <a:gd name="T33" fmla="*/ 0 h 1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2" h="1327">
                  <a:moveTo>
                    <a:pt x="177" y="0"/>
                  </a:moveTo>
                  <a:lnTo>
                    <a:pt x="169" y="0"/>
                  </a:lnTo>
                  <a:lnTo>
                    <a:pt x="169" y="533"/>
                  </a:lnTo>
                  <a:lnTo>
                    <a:pt x="151" y="533"/>
                  </a:lnTo>
                  <a:lnTo>
                    <a:pt x="151" y="699"/>
                  </a:lnTo>
                  <a:lnTo>
                    <a:pt x="85" y="699"/>
                  </a:lnTo>
                  <a:lnTo>
                    <a:pt x="85" y="533"/>
                  </a:lnTo>
                  <a:lnTo>
                    <a:pt x="0" y="533"/>
                  </a:lnTo>
                  <a:lnTo>
                    <a:pt x="0" y="794"/>
                  </a:lnTo>
                  <a:lnTo>
                    <a:pt x="169" y="794"/>
                  </a:lnTo>
                  <a:lnTo>
                    <a:pt x="169" y="1327"/>
                  </a:lnTo>
                  <a:lnTo>
                    <a:pt x="177" y="1327"/>
                  </a:lnTo>
                  <a:lnTo>
                    <a:pt x="177" y="794"/>
                  </a:lnTo>
                  <a:lnTo>
                    <a:pt x="242" y="794"/>
                  </a:lnTo>
                  <a:lnTo>
                    <a:pt x="242" y="533"/>
                  </a:lnTo>
                  <a:lnTo>
                    <a:pt x="177" y="533"/>
                  </a:lnTo>
                  <a:lnTo>
                    <a:pt x="177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34331F41-0221-F24B-884E-C791B382D8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9976" y="427038"/>
              <a:ext cx="49213" cy="833438"/>
            </a:xfrm>
            <a:prstGeom prst="rect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44110B3C-1344-D044-AD41-560B8A2B1DC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0638" y="649288"/>
              <a:ext cx="481013" cy="611188"/>
            </a:xfrm>
            <a:custGeom>
              <a:avLst/>
              <a:gdLst>
                <a:gd name="T0" fmla="*/ 0 w 253"/>
                <a:gd name="T1" fmla="*/ 8 h 321"/>
                <a:gd name="T2" fmla="*/ 26 w 253"/>
                <a:gd name="T3" fmla="*/ 8 h 321"/>
                <a:gd name="T4" fmla="*/ 26 w 253"/>
                <a:gd name="T5" fmla="*/ 63 h 321"/>
                <a:gd name="T6" fmla="*/ 23 w 253"/>
                <a:gd name="T7" fmla="*/ 89 h 321"/>
                <a:gd name="T8" fmla="*/ 24 w 253"/>
                <a:gd name="T9" fmla="*/ 89 h 321"/>
                <a:gd name="T10" fmla="*/ 153 w 253"/>
                <a:gd name="T11" fmla="*/ 0 h 321"/>
                <a:gd name="T12" fmla="*/ 253 w 253"/>
                <a:gd name="T13" fmla="*/ 122 h 321"/>
                <a:gd name="T14" fmla="*/ 253 w 253"/>
                <a:gd name="T15" fmla="*/ 321 h 321"/>
                <a:gd name="T16" fmla="*/ 227 w 253"/>
                <a:gd name="T17" fmla="*/ 321 h 321"/>
                <a:gd name="T18" fmla="*/ 227 w 253"/>
                <a:gd name="T19" fmla="*/ 132 h 321"/>
                <a:gd name="T20" fmla="*/ 153 w 253"/>
                <a:gd name="T21" fmla="*/ 26 h 321"/>
                <a:gd name="T22" fmla="*/ 30 w 253"/>
                <a:gd name="T23" fmla="*/ 126 h 321"/>
                <a:gd name="T24" fmla="*/ 26 w 253"/>
                <a:gd name="T25" fmla="*/ 168 h 321"/>
                <a:gd name="T26" fmla="*/ 26 w 253"/>
                <a:gd name="T27" fmla="*/ 321 h 321"/>
                <a:gd name="T28" fmla="*/ 0 w 253"/>
                <a:gd name="T29" fmla="*/ 321 h 321"/>
                <a:gd name="T30" fmla="*/ 0 w 253"/>
                <a:gd name="T31" fmla="*/ 8 h 3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53" h="321">
                  <a:moveTo>
                    <a:pt x="0" y="8"/>
                  </a:moveTo>
                  <a:cubicBezTo>
                    <a:pt x="26" y="8"/>
                    <a:pt x="26" y="8"/>
                    <a:pt x="26" y="8"/>
                  </a:cubicBezTo>
                  <a:cubicBezTo>
                    <a:pt x="26" y="63"/>
                    <a:pt x="26" y="63"/>
                    <a:pt x="26" y="63"/>
                  </a:cubicBezTo>
                  <a:cubicBezTo>
                    <a:pt x="26" y="77"/>
                    <a:pt x="23" y="89"/>
                    <a:pt x="23" y="89"/>
                  </a:cubicBezTo>
                  <a:cubicBezTo>
                    <a:pt x="24" y="89"/>
                    <a:pt x="24" y="89"/>
                    <a:pt x="24" y="89"/>
                  </a:cubicBezTo>
                  <a:cubicBezTo>
                    <a:pt x="35" y="59"/>
                    <a:pt x="77" y="0"/>
                    <a:pt x="153" y="0"/>
                  </a:cubicBezTo>
                  <a:cubicBezTo>
                    <a:pt x="231" y="0"/>
                    <a:pt x="253" y="49"/>
                    <a:pt x="253" y="122"/>
                  </a:cubicBezTo>
                  <a:cubicBezTo>
                    <a:pt x="253" y="321"/>
                    <a:pt x="253" y="321"/>
                    <a:pt x="253" y="321"/>
                  </a:cubicBezTo>
                  <a:cubicBezTo>
                    <a:pt x="227" y="321"/>
                    <a:pt x="227" y="321"/>
                    <a:pt x="227" y="321"/>
                  </a:cubicBezTo>
                  <a:cubicBezTo>
                    <a:pt x="227" y="132"/>
                    <a:pt x="227" y="132"/>
                    <a:pt x="227" y="132"/>
                  </a:cubicBezTo>
                  <a:cubicBezTo>
                    <a:pt x="227" y="77"/>
                    <a:pt x="220" y="26"/>
                    <a:pt x="153" y="26"/>
                  </a:cubicBezTo>
                  <a:cubicBezTo>
                    <a:pt x="96" y="26"/>
                    <a:pt x="46" y="67"/>
                    <a:pt x="30" y="126"/>
                  </a:cubicBezTo>
                  <a:cubicBezTo>
                    <a:pt x="27" y="139"/>
                    <a:pt x="26" y="153"/>
                    <a:pt x="26" y="168"/>
                  </a:cubicBezTo>
                  <a:cubicBezTo>
                    <a:pt x="26" y="321"/>
                    <a:pt x="26" y="321"/>
                    <a:pt x="26" y="321"/>
                  </a:cubicBezTo>
                  <a:cubicBezTo>
                    <a:pt x="0" y="321"/>
                    <a:pt x="0" y="321"/>
                    <a:pt x="0" y="321"/>
                  </a:cubicBezTo>
                  <a:lnTo>
                    <a:pt x="0" y="8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6A976845-9570-C140-AEEF-0DBD4AA9CD8B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0551" y="652463"/>
              <a:ext cx="392113" cy="622300"/>
            </a:xfrm>
            <a:custGeom>
              <a:avLst/>
              <a:gdLst>
                <a:gd name="T0" fmla="*/ 16 w 206"/>
                <a:gd name="T1" fmla="*/ 262 h 327"/>
                <a:gd name="T2" fmla="*/ 110 w 206"/>
                <a:gd name="T3" fmla="*/ 302 h 327"/>
                <a:gd name="T4" fmla="*/ 179 w 206"/>
                <a:gd name="T5" fmla="*/ 243 h 327"/>
                <a:gd name="T6" fmla="*/ 13 w 206"/>
                <a:gd name="T7" fmla="*/ 84 h 327"/>
                <a:gd name="T8" fmla="*/ 110 w 206"/>
                <a:gd name="T9" fmla="*/ 0 h 327"/>
                <a:gd name="T10" fmla="*/ 199 w 206"/>
                <a:gd name="T11" fmla="*/ 33 h 327"/>
                <a:gd name="T12" fmla="*/ 184 w 206"/>
                <a:gd name="T13" fmla="*/ 55 h 327"/>
                <a:gd name="T14" fmla="*/ 108 w 206"/>
                <a:gd name="T15" fmla="*/ 25 h 327"/>
                <a:gd name="T16" fmla="*/ 40 w 206"/>
                <a:gd name="T17" fmla="*/ 82 h 327"/>
                <a:gd name="T18" fmla="*/ 206 w 206"/>
                <a:gd name="T19" fmla="*/ 243 h 327"/>
                <a:gd name="T20" fmla="*/ 109 w 206"/>
                <a:gd name="T21" fmla="*/ 327 h 327"/>
                <a:gd name="T22" fmla="*/ 0 w 206"/>
                <a:gd name="T23" fmla="*/ 282 h 327"/>
                <a:gd name="T24" fmla="*/ 16 w 206"/>
                <a:gd name="T25" fmla="*/ 262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06" h="327">
                  <a:moveTo>
                    <a:pt x="16" y="262"/>
                  </a:moveTo>
                  <a:cubicBezTo>
                    <a:pt x="16" y="262"/>
                    <a:pt x="50" y="302"/>
                    <a:pt x="110" y="302"/>
                  </a:cubicBezTo>
                  <a:cubicBezTo>
                    <a:pt x="147" y="302"/>
                    <a:pt x="179" y="281"/>
                    <a:pt x="179" y="243"/>
                  </a:cubicBezTo>
                  <a:cubicBezTo>
                    <a:pt x="179" y="163"/>
                    <a:pt x="13" y="186"/>
                    <a:pt x="13" y="84"/>
                  </a:cubicBezTo>
                  <a:cubicBezTo>
                    <a:pt x="13" y="28"/>
                    <a:pt x="58" y="0"/>
                    <a:pt x="110" y="0"/>
                  </a:cubicBezTo>
                  <a:cubicBezTo>
                    <a:pt x="171" y="0"/>
                    <a:pt x="199" y="33"/>
                    <a:pt x="199" y="33"/>
                  </a:cubicBezTo>
                  <a:cubicBezTo>
                    <a:pt x="184" y="55"/>
                    <a:pt x="184" y="55"/>
                    <a:pt x="184" y="55"/>
                  </a:cubicBezTo>
                  <a:cubicBezTo>
                    <a:pt x="184" y="55"/>
                    <a:pt x="159" y="25"/>
                    <a:pt x="108" y="25"/>
                  </a:cubicBezTo>
                  <a:cubicBezTo>
                    <a:pt x="73" y="25"/>
                    <a:pt x="40" y="41"/>
                    <a:pt x="40" y="82"/>
                  </a:cubicBezTo>
                  <a:cubicBezTo>
                    <a:pt x="40" y="163"/>
                    <a:pt x="206" y="139"/>
                    <a:pt x="206" y="243"/>
                  </a:cubicBezTo>
                  <a:cubicBezTo>
                    <a:pt x="206" y="293"/>
                    <a:pt x="165" y="327"/>
                    <a:pt x="109" y="327"/>
                  </a:cubicBezTo>
                  <a:cubicBezTo>
                    <a:pt x="36" y="327"/>
                    <a:pt x="0" y="282"/>
                    <a:pt x="0" y="282"/>
                  </a:cubicBezTo>
                  <a:lnTo>
                    <a:pt x="16" y="26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37E0DA62-90B9-7842-AB64-75D0584A67F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99026" y="649288"/>
              <a:ext cx="501650" cy="849313"/>
            </a:xfrm>
            <a:custGeom>
              <a:avLst/>
              <a:gdLst>
                <a:gd name="T0" fmla="*/ 130 w 264"/>
                <a:gd name="T1" fmla="*/ 303 h 446"/>
                <a:gd name="T2" fmla="*/ 238 w 264"/>
                <a:gd name="T3" fmla="*/ 164 h 446"/>
                <a:gd name="T4" fmla="*/ 132 w 264"/>
                <a:gd name="T5" fmla="*/ 26 h 446"/>
                <a:gd name="T6" fmla="*/ 25 w 264"/>
                <a:gd name="T7" fmla="*/ 165 h 446"/>
                <a:gd name="T8" fmla="*/ 130 w 264"/>
                <a:gd name="T9" fmla="*/ 303 h 446"/>
                <a:gd name="T10" fmla="*/ 0 w 264"/>
                <a:gd name="T11" fmla="*/ 8 h 446"/>
                <a:gd name="T12" fmla="*/ 25 w 264"/>
                <a:gd name="T13" fmla="*/ 8 h 446"/>
                <a:gd name="T14" fmla="*/ 25 w 264"/>
                <a:gd name="T15" fmla="*/ 46 h 446"/>
                <a:gd name="T16" fmla="*/ 23 w 264"/>
                <a:gd name="T17" fmla="*/ 71 h 446"/>
                <a:gd name="T18" fmla="*/ 25 w 264"/>
                <a:gd name="T19" fmla="*/ 71 h 446"/>
                <a:gd name="T20" fmla="*/ 134 w 264"/>
                <a:gd name="T21" fmla="*/ 0 h 446"/>
                <a:gd name="T22" fmla="*/ 264 w 264"/>
                <a:gd name="T23" fmla="*/ 164 h 446"/>
                <a:gd name="T24" fmla="*/ 130 w 264"/>
                <a:gd name="T25" fmla="*/ 328 h 446"/>
                <a:gd name="T26" fmla="*/ 24 w 264"/>
                <a:gd name="T27" fmla="*/ 257 h 446"/>
                <a:gd name="T28" fmla="*/ 23 w 264"/>
                <a:gd name="T29" fmla="*/ 257 h 446"/>
                <a:gd name="T30" fmla="*/ 25 w 264"/>
                <a:gd name="T31" fmla="*/ 285 h 446"/>
                <a:gd name="T32" fmla="*/ 25 w 264"/>
                <a:gd name="T33" fmla="*/ 446 h 446"/>
                <a:gd name="T34" fmla="*/ 0 w 264"/>
                <a:gd name="T35" fmla="*/ 446 h 446"/>
                <a:gd name="T36" fmla="*/ 0 w 264"/>
                <a:gd name="T37" fmla="*/ 8 h 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4" h="446">
                  <a:moveTo>
                    <a:pt x="130" y="303"/>
                  </a:moveTo>
                  <a:cubicBezTo>
                    <a:pt x="189" y="303"/>
                    <a:pt x="238" y="252"/>
                    <a:pt x="238" y="164"/>
                  </a:cubicBezTo>
                  <a:cubicBezTo>
                    <a:pt x="238" y="80"/>
                    <a:pt x="194" y="26"/>
                    <a:pt x="132" y="26"/>
                  </a:cubicBezTo>
                  <a:cubicBezTo>
                    <a:pt x="77" y="26"/>
                    <a:pt x="25" y="67"/>
                    <a:pt x="25" y="165"/>
                  </a:cubicBezTo>
                  <a:cubicBezTo>
                    <a:pt x="25" y="234"/>
                    <a:pt x="62" y="303"/>
                    <a:pt x="130" y="303"/>
                  </a:cubicBezTo>
                  <a:moveTo>
                    <a:pt x="0" y="8"/>
                  </a:moveTo>
                  <a:cubicBezTo>
                    <a:pt x="25" y="8"/>
                    <a:pt x="25" y="8"/>
                    <a:pt x="25" y="8"/>
                  </a:cubicBezTo>
                  <a:cubicBezTo>
                    <a:pt x="25" y="46"/>
                    <a:pt x="25" y="46"/>
                    <a:pt x="25" y="46"/>
                  </a:cubicBezTo>
                  <a:cubicBezTo>
                    <a:pt x="25" y="60"/>
                    <a:pt x="23" y="71"/>
                    <a:pt x="23" y="71"/>
                  </a:cubicBezTo>
                  <a:cubicBezTo>
                    <a:pt x="25" y="71"/>
                    <a:pt x="25" y="71"/>
                    <a:pt x="25" y="71"/>
                  </a:cubicBezTo>
                  <a:cubicBezTo>
                    <a:pt x="25" y="71"/>
                    <a:pt x="49" y="0"/>
                    <a:pt x="134" y="0"/>
                  </a:cubicBezTo>
                  <a:cubicBezTo>
                    <a:pt x="215" y="0"/>
                    <a:pt x="264" y="67"/>
                    <a:pt x="264" y="164"/>
                  </a:cubicBezTo>
                  <a:cubicBezTo>
                    <a:pt x="264" y="264"/>
                    <a:pt x="208" y="328"/>
                    <a:pt x="130" y="328"/>
                  </a:cubicBezTo>
                  <a:cubicBezTo>
                    <a:pt x="51" y="328"/>
                    <a:pt x="24" y="257"/>
                    <a:pt x="24" y="257"/>
                  </a:cubicBezTo>
                  <a:cubicBezTo>
                    <a:pt x="23" y="257"/>
                    <a:pt x="23" y="257"/>
                    <a:pt x="23" y="257"/>
                  </a:cubicBezTo>
                  <a:cubicBezTo>
                    <a:pt x="23" y="257"/>
                    <a:pt x="25" y="269"/>
                    <a:pt x="25" y="285"/>
                  </a:cubicBezTo>
                  <a:cubicBezTo>
                    <a:pt x="25" y="446"/>
                    <a:pt x="25" y="446"/>
                    <a:pt x="25" y="446"/>
                  </a:cubicBezTo>
                  <a:cubicBezTo>
                    <a:pt x="0" y="446"/>
                    <a:pt x="0" y="446"/>
                    <a:pt x="0" y="446"/>
                  </a:cubicBezTo>
                  <a:lnTo>
                    <a:pt x="0" y="8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id="{400545EC-F504-0541-A316-C3189AA9609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13388" y="427038"/>
              <a:ext cx="57150" cy="833438"/>
            </a:xfrm>
            <a:custGeom>
              <a:avLst/>
              <a:gdLst>
                <a:gd name="T0" fmla="*/ 3 w 36"/>
                <a:gd name="T1" fmla="*/ 525 h 525"/>
                <a:gd name="T2" fmla="*/ 34 w 36"/>
                <a:gd name="T3" fmla="*/ 525 h 525"/>
                <a:gd name="T4" fmla="*/ 34 w 36"/>
                <a:gd name="T5" fmla="*/ 150 h 525"/>
                <a:gd name="T6" fmla="*/ 3 w 36"/>
                <a:gd name="T7" fmla="*/ 150 h 525"/>
                <a:gd name="T8" fmla="*/ 3 w 36"/>
                <a:gd name="T9" fmla="*/ 525 h 525"/>
                <a:gd name="T10" fmla="*/ 0 w 36"/>
                <a:gd name="T11" fmla="*/ 55 h 525"/>
                <a:gd name="T12" fmla="*/ 36 w 36"/>
                <a:gd name="T13" fmla="*/ 55 h 525"/>
                <a:gd name="T14" fmla="*/ 36 w 36"/>
                <a:gd name="T15" fmla="*/ 0 h 525"/>
                <a:gd name="T16" fmla="*/ 0 w 36"/>
                <a:gd name="T17" fmla="*/ 0 h 525"/>
                <a:gd name="T18" fmla="*/ 0 w 36"/>
                <a:gd name="T19" fmla="*/ 55 h 5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525">
                  <a:moveTo>
                    <a:pt x="3" y="525"/>
                  </a:moveTo>
                  <a:lnTo>
                    <a:pt x="34" y="525"/>
                  </a:lnTo>
                  <a:lnTo>
                    <a:pt x="34" y="150"/>
                  </a:lnTo>
                  <a:lnTo>
                    <a:pt x="3" y="150"/>
                  </a:lnTo>
                  <a:lnTo>
                    <a:pt x="3" y="525"/>
                  </a:lnTo>
                  <a:close/>
                  <a:moveTo>
                    <a:pt x="0" y="55"/>
                  </a:moveTo>
                  <a:lnTo>
                    <a:pt x="36" y="55"/>
                  </a:lnTo>
                  <a:lnTo>
                    <a:pt x="36" y="0"/>
                  </a:lnTo>
                  <a:lnTo>
                    <a:pt x="0" y="0"/>
                  </a:lnTo>
                  <a:lnTo>
                    <a:pt x="0" y="55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D7613BB2-5704-A544-845A-5EE91F5F60E8}"/>
                </a:ext>
              </a:extLst>
            </p:cNvPr>
            <p:cNvSpPr>
              <a:spLocks/>
            </p:cNvSpPr>
            <p:nvPr/>
          </p:nvSpPr>
          <p:spPr bwMode="auto">
            <a:xfrm>
              <a:off x="5716588" y="660401"/>
              <a:ext cx="263525" cy="600075"/>
            </a:xfrm>
            <a:custGeom>
              <a:avLst/>
              <a:gdLst>
                <a:gd name="T0" fmla="*/ 0 w 138"/>
                <a:gd name="T1" fmla="*/ 2 h 315"/>
                <a:gd name="T2" fmla="*/ 25 w 138"/>
                <a:gd name="T3" fmla="*/ 2 h 315"/>
                <a:gd name="T4" fmla="*/ 25 w 138"/>
                <a:gd name="T5" fmla="*/ 61 h 315"/>
                <a:gd name="T6" fmla="*/ 23 w 138"/>
                <a:gd name="T7" fmla="*/ 87 h 315"/>
                <a:gd name="T8" fmla="*/ 24 w 138"/>
                <a:gd name="T9" fmla="*/ 87 h 315"/>
                <a:gd name="T10" fmla="*/ 121 w 138"/>
                <a:gd name="T11" fmla="*/ 0 h 315"/>
                <a:gd name="T12" fmla="*/ 138 w 138"/>
                <a:gd name="T13" fmla="*/ 1 h 315"/>
                <a:gd name="T14" fmla="*/ 138 w 138"/>
                <a:gd name="T15" fmla="*/ 28 h 315"/>
                <a:gd name="T16" fmla="*/ 125 w 138"/>
                <a:gd name="T17" fmla="*/ 26 h 315"/>
                <a:gd name="T18" fmla="*/ 34 w 138"/>
                <a:gd name="T19" fmla="*/ 114 h 315"/>
                <a:gd name="T20" fmla="*/ 25 w 138"/>
                <a:gd name="T21" fmla="*/ 180 h 315"/>
                <a:gd name="T22" fmla="*/ 25 w 138"/>
                <a:gd name="T23" fmla="*/ 315 h 315"/>
                <a:gd name="T24" fmla="*/ 0 w 138"/>
                <a:gd name="T25" fmla="*/ 315 h 315"/>
                <a:gd name="T26" fmla="*/ 0 w 138"/>
                <a:gd name="T27" fmla="*/ 2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38" h="315">
                  <a:moveTo>
                    <a:pt x="0" y="2"/>
                  </a:moveTo>
                  <a:cubicBezTo>
                    <a:pt x="25" y="2"/>
                    <a:pt x="25" y="2"/>
                    <a:pt x="25" y="2"/>
                  </a:cubicBezTo>
                  <a:cubicBezTo>
                    <a:pt x="25" y="61"/>
                    <a:pt x="25" y="61"/>
                    <a:pt x="25" y="61"/>
                  </a:cubicBezTo>
                  <a:cubicBezTo>
                    <a:pt x="25" y="76"/>
                    <a:pt x="23" y="87"/>
                    <a:pt x="23" y="87"/>
                  </a:cubicBezTo>
                  <a:cubicBezTo>
                    <a:pt x="24" y="87"/>
                    <a:pt x="24" y="87"/>
                    <a:pt x="24" y="87"/>
                  </a:cubicBezTo>
                  <a:cubicBezTo>
                    <a:pt x="39" y="39"/>
                    <a:pt x="73" y="0"/>
                    <a:pt x="121" y="0"/>
                  </a:cubicBezTo>
                  <a:cubicBezTo>
                    <a:pt x="130" y="0"/>
                    <a:pt x="138" y="1"/>
                    <a:pt x="138" y="1"/>
                  </a:cubicBezTo>
                  <a:cubicBezTo>
                    <a:pt x="138" y="28"/>
                    <a:pt x="138" y="28"/>
                    <a:pt x="138" y="28"/>
                  </a:cubicBezTo>
                  <a:cubicBezTo>
                    <a:pt x="138" y="28"/>
                    <a:pt x="131" y="26"/>
                    <a:pt x="125" y="26"/>
                  </a:cubicBezTo>
                  <a:cubicBezTo>
                    <a:pt x="77" y="26"/>
                    <a:pt x="48" y="68"/>
                    <a:pt x="34" y="114"/>
                  </a:cubicBezTo>
                  <a:cubicBezTo>
                    <a:pt x="28" y="136"/>
                    <a:pt x="25" y="159"/>
                    <a:pt x="25" y="180"/>
                  </a:cubicBezTo>
                  <a:cubicBezTo>
                    <a:pt x="25" y="315"/>
                    <a:pt x="25" y="315"/>
                    <a:pt x="25" y="315"/>
                  </a:cubicBezTo>
                  <a:cubicBezTo>
                    <a:pt x="0" y="315"/>
                    <a:pt x="0" y="315"/>
                    <a:pt x="0" y="315"/>
                  </a:cubicBezTo>
                  <a:lnTo>
                    <a:pt x="0" y="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F36C59A9-C00C-D440-A9AF-693C1680A10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991226" y="649288"/>
              <a:ext cx="514350" cy="625475"/>
            </a:xfrm>
            <a:custGeom>
              <a:avLst/>
              <a:gdLst>
                <a:gd name="T0" fmla="*/ 244 w 271"/>
                <a:gd name="T1" fmla="*/ 136 h 328"/>
                <a:gd name="T2" fmla="*/ 147 w 271"/>
                <a:gd name="T3" fmla="*/ 25 h 328"/>
                <a:gd name="T4" fmla="*/ 29 w 271"/>
                <a:gd name="T5" fmla="*/ 136 h 328"/>
                <a:gd name="T6" fmla="*/ 244 w 271"/>
                <a:gd name="T7" fmla="*/ 136 h 328"/>
                <a:gd name="T8" fmla="*/ 147 w 271"/>
                <a:gd name="T9" fmla="*/ 0 h 328"/>
                <a:gd name="T10" fmla="*/ 271 w 271"/>
                <a:gd name="T11" fmla="*/ 143 h 328"/>
                <a:gd name="T12" fmla="*/ 270 w 271"/>
                <a:gd name="T13" fmla="*/ 160 h 328"/>
                <a:gd name="T14" fmla="*/ 27 w 271"/>
                <a:gd name="T15" fmla="*/ 160 h 328"/>
                <a:gd name="T16" fmla="*/ 156 w 271"/>
                <a:gd name="T17" fmla="*/ 303 h 328"/>
                <a:gd name="T18" fmla="*/ 250 w 271"/>
                <a:gd name="T19" fmla="*/ 263 h 328"/>
                <a:gd name="T20" fmla="*/ 264 w 271"/>
                <a:gd name="T21" fmla="*/ 285 h 328"/>
                <a:gd name="T22" fmla="*/ 156 w 271"/>
                <a:gd name="T23" fmla="*/ 328 h 328"/>
                <a:gd name="T24" fmla="*/ 0 w 271"/>
                <a:gd name="T25" fmla="*/ 165 h 328"/>
                <a:gd name="T26" fmla="*/ 147 w 271"/>
                <a:gd name="T27" fmla="*/ 0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71" h="328">
                  <a:moveTo>
                    <a:pt x="244" y="136"/>
                  </a:moveTo>
                  <a:cubicBezTo>
                    <a:pt x="241" y="59"/>
                    <a:pt x="197" y="25"/>
                    <a:pt x="147" y="25"/>
                  </a:cubicBezTo>
                  <a:cubicBezTo>
                    <a:pt x="91" y="25"/>
                    <a:pt x="39" y="62"/>
                    <a:pt x="29" y="136"/>
                  </a:cubicBezTo>
                  <a:lnTo>
                    <a:pt x="244" y="136"/>
                  </a:lnTo>
                  <a:close/>
                  <a:moveTo>
                    <a:pt x="147" y="0"/>
                  </a:moveTo>
                  <a:cubicBezTo>
                    <a:pt x="230" y="0"/>
                    <a:pt x="271" y="67"/>
                    <a:pt x="271" y="143"/>
                  </a:cubicBezTo>
                  <a:cubicBezTo>
                    <a:pt x="271" y="150"/>
                    <a:pt x="270" y="160"/>
                    <a:pt x="270" y="160"/>
                  </a:cubicBezTo>
                  <a:cubicBezTo>
                    <a:pt x="27" y="160"/>
                    <a:pt x="27" y="160"/>
                    <a:pt x="27" y="160"/>
                  </a:cubicBezTo>
                  <a:cubicBezTo>
                    <a:pt x="27" y="251"/>
                    <a:pt x="86" y="303"/>
                    <a:pt x="156" y="303"/>
                  </a:cubicBezTo>
                  <a:cubicBezTo>
                    <a:pt x="214" y="303"/>
                    <a:pt x="250" y="263"/>
                    <a:pt x="250" y="263"/>
                  </a:cubicBezTo>
                  <a:cubicBezTo>
                    <a:pt x="264" y="285"/>
                    <a:pt x="264" y="285"/>
                    <a:pt x="264" y="285"/>
                  </a:cubicBezTo>
                  <a:cubicBezTo>
                    <a:pt x="264" y="285"/>
                    <a:pt x="222" y="328"/>
                    <a:pt x="156" y="328"/>
                  </a:cubicBezTo>
                  <a:cubicBezTo>
                    <a:pt x="71" y="328"/>
                    <a:pt x="0" y="264"/>
                    <a:pt x="0" y="165"/>
                  </a:cubicBezTo>
                  <a:cubicBezTo>
                    <a:pt x="0" y="59"/>
                    <a:pt x="70" y="0"/>
                    <a:pt x="147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FC901860-399C-AE4A-9485-33C49C83BDB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584951" y="427038"/>
              <a:ext cx="501650" cy="847725"/>
            </a:xfrm>
            <a:custGeom>
              <a:avLst/>
              <a:gdLst>
                <a:gd name="T0" fmla="*/ 132 w 264"/>
                <a:gd name="T1" fmla="*/ 420 h 445"/>
                <a:gd name="T2" fmla="*/ 239 w 264"/>
                <a:gd name="T3" fmla="*/ 281 h 445"/>
                <a:gd name="T4" fmla="*/ 134 w 264"/>
                <a:gd name="T5" fmla="*/ 143 h 445"/>
                <a:gd name="T6" fmla="*/ 26 w 264"/>
                <a:gd name="T7" fmla="*/ 281 h 445"/>
                <a:gd name="T8" fmla="*/ 132 w 264"/>
                <a:gd name="T9" fmla="*/ 420 h 445"/>
                <a:gd name="T10" fmla="*/ 135 w 264"/>
                <a:gd name="T11" fmla="*/ 117 h 445"/>
                <a:gd name="T12" fmla="*/ 240 w 264"/>
                <a:gd name="T13" fmla="*/ 188 h 445"/>
                <a:gd name="T14" fmla="*/ 241 w 264"/>
                <a:gd name="T15" fmla="*/ 188 h 445"/>
                <a:gd name="T16" fmla="*/ 239 w 264"/>
                <a:gd name="T17" fmla="*/ 162 h 445"/>
                <a:gd name="T18" fmla="*/ 239 w 264"/>
                <a:gd name="T19" fmla="*/ 0 h 445"/>
                <a:gd name="T20" fmla="*/ 264 w 264"/>
                <a:gd name="T21" fmla="*/ 0 h 445"/>
                <a:gd name="T22" fmla="*/ 264 w 264"/>
                <a:gd name="T23" fmla="*/ 438 h 445"/>
                <a:gd name="T24" fmla="*/ 239 w 264"/>
                <a:gd name="T25" fmla="*/ 438 h 445"/>
                <a:gd name="T26" fmla="*/ 239 w 264"/>
                <a:gd name="T27" fmla="*/ 398 h 445"/>
                <a:gd name="T28" fmla="*/ 241 w 264"/>
                <a:gd name="T29" fmla="*/ 374 h 445"/>
                <a:gd name="T30" fmla="*/ 240 w 264"/>
                <a:gd name="T31" fmla="*/ 374 h 445"/>
                <a:gd name="T32" fmla="*/ 131 w 264"/>
                <a:gd name="T33" fmla="*/ 445 h 445"/>
                <a:gd name="T34" fmla="*/ 0 w 264"/>
                <a:gd name="T35" fmla="*/ 281 h 445"/>
                <a:gd name="T36" fmla="*/ 135 w 264"/>
                <a:gd name="T37" fmla="*/ 117 h 4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4" h="445">
                  <a:moveTo>
                    <a:pt x="132" y="420"/>
                  </a:moveTo>
                  <a:cubicBezTo>
                    <a:pt x="187" y="420"/>
                    <a:pt x="239" y="379"/>
                    <a:pt x="239" y="281"/>
                  </a:cubicBezTo>
                  <a:cubicBezTo>
                    <a:pt x="239" y="211"/>
                    <a:pt x="205" y="143"/>
                    <a:pt x="134" y="143"/>
                  </a:cubicBezTo>
                  <a:cubicBezTo>
                    <a:pt x="75" y="143"/>
                    <a:pt x="26" y="194"/>
                    <a:pt x="26" y="281"/>
                  </a:cubicBezTo>
                  <a:cubicBezTo>
                    <a:pt x="26" y="366"/>
                    <a:pt x="70" y="420"/>
                    <a:pt x="132" y="420"/>
                  </a:cubicBezTo>
                  <a:moveTo>
                    <a:pt x="135" y="117"/>
                  </a:moveTo>
                  <a:cubicBezTo>
                    <a:pt x="212" y="117"/>
                    <a:pt x="240" y="188"/>
                    <a:pt x="240" y="188"/>
                  </a:cubicBezTo>
                  <a:cubicBezTo>
                    <a:pt x="241" y="188"/>
                    <a:pt x="241" y="188"/>
                    <a:pt x="241" y="188"/>
                  </a:cubicBezTo>
                  <a:cubicBezTo>
                    <a:pt x="241" y="188"/>
                    <a:pt x="239" y="177"/>
                    <a:pt x="239" y="162"/>
                  </a:cubicBezTo>
                  <a:cubicBezTo>
                    <a:pt x="239" y="0"/>
                    <a:pt x="239" y="0"/>
                    <a:pt x="239" y="0"/>
                  </a:cubicBezTo>
                  <a:cubicBezTo>
                    <a:pt x="264" y="0"/>
                    <a:pt x="264" y="0"/>
                    <a:pt x="264" y="0"/>
                  </a:cubicBezTo>
                  <a:cubicBezTo>
                    <a:pt x="264" y="438"/>
                    <a:pt x="264" y="438"/>
                    <a:pt x="264" y="438"/>
                  </a:cubicBezTo>
                  <a:cubicBezTo>
                    <a:pt x="239" y="438"/>
                    <a:pt x="239" y="438"/>
                    <a:pt x="239" y="438"/>
                  </a:cubicBezTo>
                  <a:cubicBezTo>
                    <a:pt x="239" y="398"/>
                    <a:pt x="239" y="398"/>
                    <a:pt x="239" y="398"/>
                  </a:cubicBezTo>
                  <a:cubicBezTo>
                    <a:pt x="239" y="384"/>
                    <a:pt x="241" y="374"/>
                    <a:pt x="241" y="374"/>
                  </a:cubicBezTo>
                  <a:cubicBezTo>
                    <a:pt x="240" y="374"/>
                    <a:pt x="240" y="374"/>
                    <a:pt x="240" y="374"/>
                  </a:cubicBezTo>
                  <a:cubicBezTo>
                    <a:pt x="240" y="374"/>
                    <a:pt x="214" y="445"/>
                    <a:pt x="131" y="445"/>
                  </a:cubicBezTo>
                  <a:cubicBezTo>
                    <a:pt x="49" y="445"/>
                    <a:pt x="0" y="378"/>
                    <a:pt x="0" y="281"/>
                  </a:cubicBezTo>
                  <a:cubicBezTo>
                    <a:pt x="0" y="182"/>
                    <a:pt x="56" y="117"/>
                    <a:pt x="135" y="117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1275DDBF-B86F-B045-BE1F-01830C38DCC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562851" y="427038"/>
              <a:ext cx="503238" cy="847725"/>
            </a:xfrm>
            <a:custGeom>
              <a:avLst/>
              <a:gdLst>
                <a:gd name="T0" fmla="*/ 130 w 265"/>
                <a:gd name="T1" fmla="*/ 420 h 445"/>
                <a:gd name="T2" fmla="*/ 238 w 265"/>
                <a:gd name="T3" fmla="*/ 281 h 445"/>
                <a:gd name="T4" fmla="*/ 133 w 265"/>
                <a:gd name="T5" fmla="*/ 143 h 445"/>
                <a:gd name="T6" fmla="*/ 25 w 265"/>
                <a:gd name="T7" fmla="*/ 282 h 445"/>
                <a:gd name="T8" fmla="*/ 130 w 265"/>
                <a:gd name="T9" fmla="*/ 420 h 445"/>
                <a:gd name="T10" fmla="*/ 0 w 265"/>
                <a:gd name="T11" fmla="*/ 0 h 445"/>
                <a:gd name="T12" fmla="*/ 26 w 265"/>
                <a:gd name="T13" fmla="*/ 0 h 445"/>
                <a:gd name="T14" fmla="*/ 26 w 265"/>
                <a:gd name="T15" fmla="*/ 163 h 445"/>
                <a:gd name="T16" fmla="*/ 23 w 265"/>
                <a:gd name="T17" fmla="*/ 188 h 445"/>
                <a:gd name="T18" fmla="*/ 24 w 265"/>
                <a:gd name="T19" fmla="*/ 188 h 445"/>
                <a:gd name="T20" fmla="*/ 134 w 265"/>
                <a:gd name="T21" fmla="*/ 117 h 445"/>
                <a:gd name="T22" fmla="*/ 265 w 265"/>
                <a:gd name="T23" fmla="*/ 281 h 445"/>
                <a:gd name="T24" fmla="*/ 129 w 265"/>
                <a:gd name="T25" fmla="*/ 445 h 445"/>
                <a:gd name="T26" fmla="*/ 24 w 265"/>
                <a:gd name="T27" fmla="*/ 374 h 445"/>
                <a:gd name="T28" fmla="*/ 23 w 265"/>
                <a:gd name="T29" fmla="*/ 374 h 445"/>
                <a:gd name="T30" fmla="*/ 26 w 265"/>
                <a:gd name="T31" fmla="*/ 402 h 445"/>
                <a:gd name="T32" fmla="*/ 26 w 265"/>
                <a:gd name="T33" fmla="*/ 438 h 445"/>
                <a:gd name="T34" fmla="*/ 0 w 265"/>
                <a:gd name="T35" fmla="*/ 438 h 445"/>
                <a:gd name="T36" fmla="*/ 0 w 265"/>
                <a:gd name="T37" fmla="*/ 0 h 4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5" h="445">
                  <a:moveTo>
                    <a:pt x="130" y="420"/>
                  </a:moveTo>
                  <a:cubicBezTo>
                    <a:pt x="190" y="420"/>
                    <a:pt x="238" y="369"/>
                    <a:pt x="238" y="281"/>
                  </a:cubicBezTo>
                  <a:cubicBezTo>
                    <a:pt x="238" y="197"/>
                    <a:pt x="194" y="143"/>
                    <a:pt x="133" y="143"/>
                  </a:cubicBezTo>
                  <a:cubicBezTo>
                    <a:pt x="77" y="143"/>
                    <a:pt x="25" y="184"/>
                    <a:pt x="25" y="282"/>
                  </a:cubicBezTo>
                  <a:cubicBezTo>
                    <a:pt x="25" y="351"/>
                    <a:pt x="59" y="420"/>
                    <a:pt x="130" y="420"/>
                  </a:cubicBezTo>
                  <a:moveTo>
                    <a:pt x="0" y="0"/>
                  </a:moveTo>
                  <a:cubicBezTo>
                    <a:pt x="26" y="0"/>
                    <a:pt x="26" y="0"/>
                    <a:pt x="26" y="0"/>
                  </a:cubicBezTo>
                  <a:cubicBezTo>
                    <a:pt x="26" y="163"/>
                    <a:pt x="26" y="163"/>
                    <a:pt x="26" y="163"/>
                  </a:cubicBezTo>
                  <a:cubicBezTo>
                    <a:pt x="26" y="177"/>
                    <a:pt x="23" y="188"/>
                    <a:pt x="23" y="188"/>
                  </a:cubicBezTo>
                  <a:cubicBezTo>
                    <a:pt x="24" y="188"/>
                    <a:pt x="24" y="188"/>
                    <a:pt x="24" y="188"/>
                  </a:cubicBezTo>
                  <a:cubicBezTo>
                    <a:pt x="24" y="188"/>
                    <a:pt x="50" y="117"/>
                    <a:pt x="134" y="117"/>
                  </a:cubicBezTo>
                  <a:cubicBezTo>
                    <a:pt x="215" y="117"/>
                    <a:pt x="265" y="185"/>
                    <a:pt x="265" y="281"/>
                  </a:cubicBezTo>
                  <a:cubicBezTo>
                    <a:pt x="265" y="381"/>
                    <a:pt x="208" y="445"/>
                    <a:pt x="129" y="445"/>
                  </a:cubicBezTo>
                  <a:cubicBezTo>
                    <a:pt x="53" y="445"/>
                    <a:pt x="24" y="374"/>
                    <a:pt x="24" y="374"/>
                  </a:cubicBezTo>
                  <a:cubicBezTo>
                    <a:pt x="23" y="374"/>
                    <a:pt x="23" y="374"/>
                    <a:pt x="23" y="374"/>
                  </a:cubicBezTo>
                  <a:cubicBezTo>
                    <a:pt x="23" y="374"/>
                    <a:pt x="26" y="386"/>
                    <a:pt x="26" y="402"/>
                  </a:cubicBezTo>
                  <a:cubicBezTo>
                    <a:pt x="26" y="438"/>
                    <a:pt x="26" y="438"/>
                    <a:pt x="26" y="438"/>
                  </a:cubicBezTo>
                  <a:cubicBezTo>
                    <a:pt x="0" y="438"/>
                    <a:pt x="0" y="438"/>
                    <a:pt x="0" y="438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8E6B1AD7-A0D0-5C48-BCEF-3DBAD8894A28}"/>
                </a:ext>
              </a:extLst>
            </p:cNvPr>
            <p:cNvSpPr>
              <a:spLocks/>
            </p:cNvSpPr>
            <p:nvPr/>
          </p:nvSpPr>
          <p:spPr bwMode="auto">
            <a:xfrm>
              <a:off x="8070851" y="665163"/>
              <a:ext cx="536575" cy="844550"/>
            </a:xfrm>
            <a:custGeom>
              <a:avLst/>
              <a:gdLst>
                <a:gd name="T0" fmla="*/ 12 w 282"/>
                <a:gd name="T1" fmla="*/ 404 h 444"/>
                <a:gd name="T2" fmla="*/ 49 w 282"/>
                <a:gd name="T3" fmla="*/ 419 h 444"/>
                <a:gd name="T4" fmla="*/ 109 w 282"/>
                <a:gd name="T5" fmla="*/ 363 h 444"/>
                <a:gd name="T6" fmla="*/ 131 w 282"/>
                <a:gd name="T7" fmla="*/ 311 h 444"/>
                <a:gd name="T8" fmla="*/ 5 w 282"/>
                <a:gd name="T9" fmla="*/ 0 h 444"/>
                <a:gd name="T10" fmla="*/ 32 w 282"/>
                <a:gd name="T11" fmla="*/ 0 h 444"/>
                <a:gd name="T12" fmla="*/ 132 w 282"/>
                <a:gd name="T13" fmla="*/ 250 h 444"/>
                <a:gd name="T14" fmla="*/ 143 w 282"/>
                <a:gd name="T15" fmla="*/ 279 h 444"/>
                <a:gd name="T16" fmla="*/ 144 w 282"/>
                <a:gd name="T17" fmla="*/ 279 h 444"/>
                <a:gd name="T18" fmla="*/ 155 w 282"/>
                <a:gd name="T19" fmla="*/ 250 h 444"/>
                <a:gd name="T20" fmla="*/ 255 w 282"/>
                <a:gd name="T21" fmla="*/ 0 h 444"/>
                <a:gd name="T22" fmla="*/ 282 w 282"/>
                <a:gd name="T23" fmla="*/ 0 h 444"/>
                <a:gd name="T24" fmla="*/ 126 w 282"/>
                <a:gd name="T25" fmla="*/ 386 h 444"/>
                <a:gd name="T26" fmla="*/ 49 w 282"/>
                <a:gd name="T27" fmla="*/ 444 h 444"/>
                <a:gd name="T28" fmla="*/ 0 w 282"/>
                <a:gd name="T29" fmla="*/ 426 h 444"/>
                <a:gd name="T30" fmla="*/ 12 w 282"/>
                <a:gd name="T31" fmla="*/ 404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82" h="444">
                  <a:moveTo>
                    <a:pt x="12" y="404"/>
                  </a:moveTo>
                  <a:cubicBezTo>
                    <a:pt x="12" y="404"/>
                    <a:pt x="29" y="419"/>
                    <a:pt x="49" y="419"/>
                  </a:cubicBezTo>
                  <a:cubicBezTo>
                    <a:pt x="78" y="419"/>
                    <a:pt x="97" y="392"/>
                    <a:pt x="109" y="363"/>
                  </a:cubicBezTo>
                  <a:cubicBezTo>
                    <a:pt x="131" y="311"/>
                    <a:pt x="131" y="311"/>
                    <a:pt x="131" y="311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2" y="0"/>
                    <a:pt x="32" y="0"/>
                    <a:pt x="32" y="0"/>
                  </a:cubicBezTo>
                  <a:cubicBezTo>
                    <a:pt x="132" y="250"/>
                    <a:pt x="132" y="250"/>
                    <a:pt x="132" y="250"/>
                  </a:cubicBezTo>
                  <a:cubicBezTo>
                    <a:pt x="138" y="264"/>
                    <a:pt x="143" y="279"/>
                    <a:pt x="143" y="279"/>
                  </a:cubicBezTo>
                  <a:cubicBezTo>
                    <a:pt x="144" y="279"/>
                    <a:pt x="144" y="279"/>
                    <a:pt x="144" y="279"/>
                  </a:cubicBezTo>
                  <a:cubicBezTo>
                    <a:pt x="144" y="279"/>
                    <a:pt x="149" y="264"/>
                    <a:pt x="155" y="25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82" y="0"/>
                    <a:pt x="282" y="0"/>
                    <a:pt x="282" y="0"/>
                  </a:cubicBezTo>
                  <a:cubicBezTo>
                    <a:pt x="126" y="386"/>
                    <a:pt x="126" y="386"/>
                    <a:pt x="126" y="386"/>
                  </a:cubicBezTo>
                  <a:cubicBezTo>
                    <a:pt x="113" y="418"/>
                    <a:pt x="88" y="444"/>
                    <a:pt x="49" y="444"/>
                  </a:cubicBezTo>
                  <a:cubicBezTo>
                    <a:pt x="20" y="444"/>
                    <a:pt x="0" y="426"/>
                    <a:pt x="0" y="426"/>
                  </a:cubicBezTo>
                  <a:lnTo>
                    <a:pt x="12" y="404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F91B1662-560F-784A-9FD6-EEEF6D1BDF4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963026" y="644526"/>
              <a:ext cx="552450" cy="854075"/>
            </a:xfrm>
            <a:custGeom>
              <a:avLst/>
              <a:gdLst>
                <a:gd name="T0" fmla="*/ 143 w 291"/>
                <a:gd name="T1" fmla="*/ 279 h 449"/>
                <a:gd name="T2" fmla="*/ 231 w 291"/>
                <a:gd name="T3" fmla="*/ 166 h 449"/>
                <a:gd name="T4" fmla="*/ 145 w 291"/>
                <a:gd name="T5" fmla="*/ 53 h 449"/>
                <a:gd name="T6" fmla="*/ 57 w 291"/>
                <a:gd name="T7" fmla="*/ 167 h 449"/>
                <a:gd name="T8" fmla="*/ 143 w 291"/>
                <a:gd name="T9" fmla="*/ 279 h 449"/>
                <a:gd name="T10" fmla="*/ 0 w 291"/>
                <a:gd name="T11" fmla="*/ 7 h 449"/>
                <a:gd name="T12" fmla="*/ 54 w 291"/>
                <a:gd name="T13" fmla="*/ 7 h 449"/>
                <a:gd name="T14" fmla="*/ 54 w 291"/>
                <a:gd name="T15" fmla="*/ 34 h 449"/>
                <a:gd name="T16" fmla="*/ 52 w 291"/>
                <a:gd name="T17" fmla="*/ 57 h 449"/>
                <a:gd name="T18" fmla="*/ 54 w 291"/>
                <a:gd name="T19" fmla="*/ 57 h 449"/>
                <a:gd name="T20" fmla="*/ 156 w 291"/>
                <a:gd name="T21" fmla="*/ 0 h 449"/>
                <a:gd name="T22" fmla="*/ 291 w 291"/>
                <a:gd name="T23" fmla="*/ 165 h 449"/>
                <a:gd name="T24" fmla="*/ 152 w 291"/>
                <a:gd name="T25" fmla="*/ 331 h 449"/>
                <a:gd name="T26" fmla="*/ 58 w 291"/>
                <a:gd name="T27" fmla="*/ 279 h 449"/>
                <a:gd name="T28" fmla="*/ 57 w 291"/>
                <a:gd name="T29" fmla="*/ 279 h 449"/>
                <a:gd name="T30" fmla="*/ 58 w 291"/>
                <a:gd name="T31" fmla="*/ 307 h 449"/>
                <a:gd name="T32" fmla="*/ 58 w 291"/>
                <a:gd name="T33" fmla="*/ 449 h 449"/>
                <a:gd name="T34" fmla="*/ 0 w 291"/>
                <a:gd name="T35" fmla="*/ 449 h 449"/>
                <a:gd name="T36" fmla="*/ 0 w 291"/>
                <a:gd name="T37" fmla="*/ 7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91" h="449">
                  <a:moveTo>
                    <a:pt x="143" y="279"/>
                  </a:moveTo>
                  <a:cubicBezTo>
                    <a:pt x="192" y="279"/>
                    <a:pt x="231" y="238"/>
                    <a:pt x="231" y="166"/>
                  </a:cubicBezTo>
                  <a:cubicBezTo>
                    <a:pt x="231" y="97"/>
                    <a:pt x="196" y="53"/>
                    <a:pt x="145" y="53"/>
                  </a:cubicBezTo>
                  <a:cubicBezTo>
                    <a:pt x="99" y="53"/>
                    <a:pt x="57" y="86"/>
                    <a:pt x="57" y="167"/>
                  </a:cubicBezTo>
                  <a:cubicBezTo>
                    <a:pt x="57" y="223"/>
                    <a:pt x="87" y="279"/>
                    <a:pt x="143" y="279"/>
                  </a:cubicBezTo>
                  <a:moveTo>
                    <a:pt x="0" y="7"/>
                  </a:moveTo>
                  <a:cubicBezTo>
                    <a:pt x="54" y="7"/>
                    <a:pt x="54" y="7"/>
                    <a:pt x="54" y="7"/>
                  </a:cubicBezTo>
                  <a:cubicBezTo>
                    <a:pt x="54" y="34"/>
                    <a:pt x="54" y="34"/>
                    <a:pt x="54" y="34"/>
                  </a:cubicBezTo>
                  <a:cubicBezTo>
                    <a:pt x="54" y="47"/>
                    <a:pt x="52" y="57"/>
                    <a:pt x="52" y="57"/>
                  </a:cubicBezTo>
                  <a:cubicBezTo>
                    <a:pt x="54" y="57"/>
                    <a:pt x="54" y="57"/>
                    <a:pt x="54" y="57"/>
                  </a:cubicBezTo>
                  <a:cubicBezTo>
                    <a:pt x="54" y="57"/>
                    <a:pt x="80" y="0"/>
                    <a:pt x="156" y="0"/>
                  </a:cubicBezTo>
                  <a:cubicBezTo>
                    <a:pt x="239" y="0"/>
                    <a:pt x="291" y="67"/>
                    <a:pt x="291" y="165"/>
                  </a:cubicBezTo>
                  <a:cubicBezTo>
                    <a:pt x="291" y="266"/>
                    <a:pt x="232" y="331"/>
                    <a:pt x="152" y="331"/>
                  </a:cubicBezTo>
                  <a:cubicBezTo>
                    <a:pt x="85" y="331"/>
                    <a:pt x="58" y="279"/>
                    <a:pt x="58" y="279"/>
                  </a:cubicBezTo>
                  <a:cubicBezTo>
                    <a:pt x="57" y="279"/>
                    <a:pt x="57" y="279"/>
                    <a:pt x="57" y="279"/>
                  </a:cubicBezTo>
                  <a:cubicBezTo>
                    <a:pt x="57" y="279"/>
                    <a:pt x="58" y="290"/>
                    <a:pt x="58" y="307"/>
                  </a:cubicBezTo>
                  <a:cubicBezTo>
                    <a:pt x="58" y="449"/>
                    <a:pt x="58" y="449"/>
                    <a:pt x="58" y="449"/>
                  </a:cubicBezTo>
                  <a:cubicBezTo>
                    <a:pt x="0" y="449"/>
                    <a:pt x="0" y="449"/>
                    <a:pt x="0" y="449"/>
                  </a:cubicBezTo>
                  <a:lnTo>
                    <a:pt x="0" y="7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731D26DC-F3E8-9E45-B015-D6F78AE1DF1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561513" y="644526"/>
              <a:ext cx="485775" cy="630238"/>
            </a:xfrm>
            <a:custGeom>
              <a:avLst/>
              <a:gdLst>
                <a:gd name="T0" fmla="*/ 116 w 256"/>
                <a:gd name="T1" fmla="*/ 282 h 331"/>
                <a:gd name="T2" fmla="*/ 198 w 256"/>
                <a:gd name="T3" fmla="*/ 182 h 331"/>
                <a:gd name="T4" fmla="*/ 198 w 256"/>
                <a:gd name="T5" fmla="*/ 172 h 331"/>
                <a:gd name="T6" fmla="*/ 183 w 256"/>
                <a:gd name="T7" fmla="*/ 172 h 331"/>
                <a:gd name="T8" fmla="*/ 59 w 256"/>
                <a:gd name="T9" fmla="*/ 232 h 331"/>
                <a:gd name="T10" fmla="*/ 116 w 256"/>
                <a:gd name="T11" fmla="*/ 282 h 331"/>
                <a:gd name="T12" fmla="*/ 184 w 256"/>
                <a:gd name="T13" fmla="*/ 126 h 331"/>
                <a:gd name="T14" fmla="*/ 198 w 256"/>
                <a:gd name="T15" fmla="*/ 126 h 331"/>
                <a:gd name="T16" fmla="*/ 198 w 256"/>
                <a:gd name="T17" fmla="*/ 120 h 331"/>
                <a:gd name="T18" fmla="*/ 130 w 256"/>
                <a:gd name="T19" fmla="*/ 51 h 331"/>
                <a:gd name="T20" fmla="*/ 45 w 256"/>
                <a:gd name="T21" fmla="*/ 82 h 331"/>
                <a:gd name="T22" fmla="*/ 21 w 256"/>
                <a:gd name="T23" fmla="*/ 37 h 331"/>
                <a:gd name="T24" fmla="*/ 135 w 256"/>
                <a:gd name="T25" fmla="*/ 0 h 331"/>
                <a:gd name="T26" fmla="*/ 256 w 256"/>
                <a:gd name="T27" fmla="*/ 124 h 331"/>
                <a:gd name="T28" fmla="*/ 256 w 256"/>
                <a:gd name="T29" fmla="*/ 324 h 331"/>
                <a:gd name="T30" fmla="*/ 202 w 256"/>
                <a:gd name="T31" fmla="*/ 324 h 331"/>
                <a:gd name="T32" fmla="*/ 202 w 256"/>
                <a:gd name="T33" fmla="*/ 294 h 331"/>
                <a:gd name="T34" fmla="*/ 203 w 256"/>
                <a:gd name="T35" fmla="*/ 269 h 331"/>
                <a:gd name="T36" fmla="*/ 202 w 256"/>
                <a:gd name="T37" fmla="*/ 269 h 331"/>
                <a:gd name="T38" fmla="*/ 104 w 256"/>
                <a:gd name="T39" fmla="*/ 331 h 331"/>
                <a:gd name="T40" fmla="*/ 0 w 256"/>
                <a:gd name="T41" fmla="*/ 235 h 331"/>
                <a:gd name="T42" fmla="*/ 184 w 256"/>
                <a:gd name="T43" fmla="*/ 126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56" h="331">
                  <a:moveTo>
                    <a:pt x="116" y="282"/>
                  </a:moveTo>
                  <a:cubicBezTo>
                    <a:pt x="166" y="282"/>
                    <a:pt x="198" y="229"/>
                    <a:pt x="198" y="182"/>
                  </a:cubicBezTo>
                  <a:cubicBezTo>
                    <a:pt x="198" y="172"/>
                    <a:pt x="198" y="172"/>
                    <a:pt x="198" y="172"/>
                  </a:cubicBezTo>
                  <a:cubicBezTo>
                    <a:pt x="183" y="172"/>
                    <a:pt x="183" y="172"/>
                    <a:pt x="183" y="172"/>
                  </a:cubicBezTo>
                  <a:cubicBezTo>
                    <a:pt x="139" y="172"/>
                    <a:pt x="59" y="175"/>
                    <a:pt x="59" y="232"/>
                  </a:cubicBezTo>
                  <a:cubicBezTo>
                    <a:pt x="59" y="257"/>
                    <a:pt x="78" y="282"/>
                    <a:pt x="116" y="282"/>
                  </a:cubicBezTo>
                  <a:moveTo>
                    <a:pt x="184" y="126"/>
                  </a:moveTo>
                  <a:cubicBezTo>
                    <a:pt x="198" y="126"/>
                    <a:pt x="198" y="126"/>
                    <a:pt x="198" y="126"/>
                  </a:cubicBezTo>
                  <a:cubicBezTo>
                    <a:pt x="198" y="120"/>
                    <a:pt x="198" y="120"/>
                    <a:pt x="198" y="120"/>
                  </a:cubicBezTo>
                  <a:cubicBezTo>
                    <a:pt x="198" y="68"/>
                    <a:pt x="169" y="51"/>
                    <a:pt x="130" y="51"/>
                  </a:cubicBezTo>
                  <a:cubicBezTo>
                    <a:pt x="83" y="51"/>
                    <a:pt x="45" y="82"/>
                    <a:pt x="45" y="82"/>
                  </a:cubicBezTo>
                  <a:cubicBezTo>
                    <a:pt x="21" y="37"/>
                    <a:pt x="21" y="37"/>
                    <a:pt x="21" y="37"/>
                  </a:cubicBezTo>
                  <a:cubicBezTo>
                    <a:pt x="21" y="37"/>
                    <a:pt x="65" y="0"/>
                    <a:pt x="135" y="0"/>
                  </a:cubicBezTo>
                  <a:cubicBezTo>
                    <a:pt x="213" y="0"/>
                    <a:pt x="256" y="44"/>
                    <a:pt x="256" y="124"/>
                  </a:cubicBezTo>
                  <a:cubicBezTo>
                    <a:pt x="256" y="324"/>
                    <a:pt x="256" y="324"/>
                    <a:pt x="256" y="324"/>
                  </a:cubicBezTo>
                  <a:cubicBezTo>
                    <a:pt x="202" y="324"/>
                    <a:pt x="202" y="324"/>
                    <a:pt x="202" y="324"/>
                  </a:cubicBezTo>
                  <a:cubicBezTo>
                    <a:pt x="202" y="294"/>
                    <a:pt x="202" y="294"/>
                    <a:pt x="202" y="294"/>
                  </a:cubicBezTo>
                  <a:cubicBezTo>
                    <a:pt x="202" y="279"/>
                    <a:pt x="203" y="269"/>
                    <a:pt x="203" y="269"/>
                  </a:cubicBezTo>
                  <a:cubicBezTo>
                    <a:pt x="202" y="269"/>
                    <a:pt x="202" y="269"/>
                    <a:pt x="202" y="269"/>
                  </a:cubicBezTo>
                  <a:cubicBezTo>
                    <a:pt x="202" y="269"/>
                    <a:pt x="177" y="331"/>
                    <a:pt x="104" y="331"/>
                  </a:cubicBezTo>
                  <a:cubicBezTo>
                    <a:pt x="51" y="331"/>
                    <a:pt x="0" y="298"/>
                    <a:pt x="0" y="235"/>
                  </a:cubicBezTo>
                  <a:cubicBezTo>
                    <a:pt x="0" y="130"/>
                    <a:pt x="133" y="126"/>
                    <a:pt x="184" y="126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8FAA521A-968C-CD4B-8A59-CAF7F55FA21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04438" y="492126"/>
              <a:ext cx="338138" cy="773113"/>
            </a:xfrm>
            <a:custGeom>
              <a:avLst/>
              <a:gdLst>
                <a:gd name="T0" fmla="*/ 40 w 178"/>
                <a:gd name="T1" fmla="*/ 140 h 406"/>
                <a:gd name="T2" fmla="*/ 0 w 178"/>
                <a:gd name="T3" fmla="*/ 140 h 406"/>
                <a:gd name="T4" fmla="*/ 0 w 178"/>
                <a:gd name="T5" fmla="*/ 92 h 406"/>
                <a:gd name="T6" fmla="*/ 42 w 178"/>
                <a:gd name="T7" fmla="*/ 92 h 406"/>
                <a:gd name="T8" fmla="*/ 42 w 178"/>
                <a:gd name="T9" fmla="*/ 0 h 406"/>
                <a:gd name="T10" fmla="*/ 99 w 178"/>
                <a:gd name="T11" fmla="*/ 0 h 406"/>
                <a:gd name="T12" fmla="*/ 99 w 178"/>
                <a:gd name="T13" fmla="*/ 92 h 406"/>
                <a:gd name="T14" fmla="*/ 173 w 178"/>
                <a:gd name="T15" fmla="*/ 92 h 406"/>
                <a:gd name="T16" fmla="*/ 173 w 178"/>
                <a:gd name="T17" fmla="*/ 140 h 406"/>
                <a:gd name="T18" fmla="*/ 99 w 178"/>
                <a:gd name="T19" fmla="*/ 140 h 406"/>
                <a:gd name="T20" fmla="*/ 99 w 178"/>
                <a:gd name="T21" fmla="*/ 281 h 406"/>
                <a:gd name="T22" fmla="*/ 164 w 178"/>
                <a:gd name="T23" fmla="*/ 352 h 406"/>
                <a:gd name="T24" fmla="*/ 178 w 178"/>
                <a:gd name="T25" fmla="*/ 351 h 406"/>
                <a:gd name="T26" fmla="*/ 178 w 178"/>
                <a:gd name="T27" fmla="*/ 405 h 406"/>
                <a:gd name="T28" fmla="*/ 158 w 178"/>
                <a:gd name="T29" fmla="*/ 406 h 406"/>
                <a:gd name="T30" fmla="*/ 40 w 178"/>
                <a:gd name="T31" fmla="*/ 288 h 406"/>
                <a:gd name="T32" fmla="*/ 40 w 178"/>
                <a:gd name="T33" fmla="*/ 140 h 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8" h="406">
                  <a:moveTo>
                    <a:pt x="40" y="140"/>
                  </a:moveTo>
                  <a:cubicBezTo>
                    <a:pt x="0" y="140"/>
                    <a:pt x="0" y="140"/>
                    <a:pt x="0" y="140"/>
                  </a:cubicBezTo>
                  <a:cubicBezTo>
                    <a:pt x="0" y="92"/>
                    <a:pt x="0" y="92"/>
                    <a:pt x="0" y="92"/>
                  </a:cubicBezTo>
                  <a:cubicBezTo>
                    <a:pt x="42" y="92"/>
                    <a:pt x="42" y="92"/>
                    <a:pt x="42" y="92"/>
                  </a:cubicBezTo>
                  <a:cubicBezTo>
                    <a:pt x="42" y="0"/>
                    <a:pt x="42" y="0"/>
                    <a:pt x="42" y="0"/>
                  </a:cubicBezTo>
                  <a:cubicBezTo>
                    <a:pt x="99" y="0"/>
                    <a:pt x="99" y="0"/>
                    <a:pt x="99" y="0"/>
                  </a:cubicBezTo>
                  <a:cubicBezTo>
                    <a:pt x="99" y="92"/>
                    <a:pt x="99" y="92"/>
                    <a:pt x="99" y="92"/>
                  </a:cubicBezTo>
                  <a:cubicBezTo>
                    <a:pt x="173" y="92"/>
                    <a:pt x="173" y="92"/>
                    <a:pt x="173" y="92"/>
                  </a:cubicBezTo>
                  <a:cubicBezTo>
                    <a:pt x="173" y="140"/>
                    <a:pt x="173" y="140"/>
                    <a:pt x="173" y="140"/>
                  </a:cubicBezTo>
                  <a:cubicBezTo>
                    <a:pt x="99" y="140"/>
                    <a:pt x="99" y="140"/>
                    <a:pt x="99" y="140"/>
                  </a:cubicBezTo>
                  <a:cubicBezTo>
                    <a:pt x="99" y="281"/>
                    <a:pt x="99" y="281"/>
                    <a:pt x="99" y="281"/>
                  </a:cubicBezTo>
                  <a:cubicBezTo>
                    <a:pt x="99" y="344"/>
                    <a:pt x="142" y="352"/>
                    <a:pt x="164" y="352"/>
                  </a:cubicBezTo>
                  <a:cubicBezTo>
                    <a:pt x="173" y="352"/>
                    <a:pt x="178" y="351"/>
                    <a:pt x="178" y="351"/>
                  </a:cubicBezTo>
                  <a:cubicBezTo>
                    <a:pt x="178" y="405"/>
                    <a:pt x="178" y="405"/>
                    <a:pt x="178" y="405"/>
                  </a:cubicBezTo>
                  <a:cubicBezTo>
                    <a:pt x="178" y="405"/>
                    <a:pt x="170" y="406"/>
                    <a:pt x="158" y="406"/>
                  </a:cubicBezTo>
                  <a:cubicBezTo>
                    <a:pt x="118" y="406"/>
                    <a:pt x="40" y="394"/>
                    <a:pt x="40" y="288"/>
                  </a:cubicBezTo>
                  <a:lnTo>
                    <a:pt x="40" y="14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13ED5A3D-4D5E-7346-8599-9BFFDD3FA12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509251" y="419101"/>
              <a:ext cx="111125" cy="841375"/>
            </a:xfrm>
            <a:custGeom>
              <a:avLst/>
              <a:gdLst>
                <a:gd name="T0" fmla="*/ 1 w 70"/>
                <a:gd name="T1" fmla="*/ 150 h 530"/>
                <a:gd name="T2" fmla="*/ 70 w 70"/>
                <a:gd name="T3" fmla="*/ 150 h 530"/>
                <a:gd name="T4" fmla="*/ 70 w 70"/>
                <a:gd name="T5" fmla="*/ 530 h 530"/>
                <a:gd name="T6" fmla="*/ 1 w 70"/>
                <a:gd name="T7" fmla="*/ 530 h 530"/>
                <a:gd name="T8" fmla="*/ 1 w 70"/>
                <a:gd name="T9" fmla="*/ 150 h 530"/>
                <a:gd name="T10" fmla="*/ 0 w 70"/>
                <a:gd name="T11" fmla="*/ 0 h 530"/>
                <a:gd name="T12" fmla="*/ 70 w 70"/>
                <a:gd name="T13" fmla="*/ 0 h 530"/>
                <a:gd name="T14" fmla="*/ 70 w 70"/>
                <a:gd name="T15" fmla="*/ 75 h 530"/>
                <a:gd name="T16" fmla="*/ 0 w 70"/>
                <a:gd name="T17" fmla="*/ 75 h 530"/>
                <a:gd name="T18" fmla="*/ 0 w 70"/>
                <a:gd name="T19" fmla="*/ 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70" h="530">
                  <a:moveTo>
                    <a:pt x="1" y="150"/>
                  </a:moveTo>
                  <a:lnTo>
                    <a:pt x="70" y="150"/>
                  </a:lnTo>
                  <a:lnTo>
                    <a:pt x="70" y="530"/>
                  </a:lnTo>
                  <a:lnTo>
                    <a:pt x="1" y="530"/>
                  </a:lnTo>
                  <a:lnTo>
                    <a:pt x="1" y="150"/>
                  </a:lnTo>
                  <a:close/>
                  <a:moveTo>
                    <a:pt x="0" y="0"/>
                  </a:moveTo>
                  <a:lnTo>
                    <a:pt x="70" y="0"/>
                  </a:lnTo>
                  <a:lnTo>
                    <a:pt x="70" y="75"/>
                  </a:lnTo>
                  <a:lnTo>
                    <a:pt x="0" y="75"/>
                  </a:ln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8C3D4942-1EFE-9541-BB74-62E866748C5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712451" y="644526"/>
              <a:ext cx="542925" cy="630238"/>
            </a:xfrm>
            <a:custGeom>
              <a:avLst/>
              <a:gdLst>
                <a:gd name="T0" fmla="*/ 226 w 286"/>
                <a:gd name="T1" fmla="*/ 129 h 331"/>
                <a:gd name="T2" fmla="*/ 152 w 286"/>
                <a:gd name="T3" fmla="*/ 48 h 331"/>
                <a:gd name="T4" fmla="*/ 63 w 286"/>
                <a:gd name="T5" fmla="*/ 129 h 331"/>
                <a:gd name="T6" fmla="*/ 226 w 286"/>
                <a:gd name="T7" fmla="*/ 129 h 331"/>
                <a:gd name="T8" fmla="*/ 153 w 286"/>
                <a:gd name="T9" fmla="*/ 0 h 331"/>
                <a:gd name="T10" fmla="*/ 286 w 286"/>
                <a:gd name="T11" fmla="*/ 148 h 331"/>
                <a:gd name="T12" fmla="*/ 284 w 286"/>
                <a:gd name="T13" fmla="*/ 174 h 331"/>
                <a:gd name="T14" fmla="*/ 61 w 286"/>
                <a:gd name="T15" fmla="*/ 174 h 331"/>
                <a:gd name="T16" fmla="*/ 166 w 286"/>
                <a:gd name="T17" fmla="*/ 279 h 331"/>
                <a:gd name="T18" fmla="*/ 257 w 286"/>
                <a:gd name="T19" fmla="*/ 242 h 331"/>
                <a:gd name="T20" fmla="*/ 281 w 286"/>
                <a:gd name="T21" fmla="*/ 286 h 331"/>
                <a:gd name="T22" fmla="*/ 162 w 286"/>
                <a:gd name="T23" fmla="*/ 331 h 331"/>
                <a:gd name="T24" fmla="*/ 0 w 286"/>
                <a:gd name="T25" fmla="*/ 165 h 331"/>
                <a:gd name="T26" fmla="*/ 153 w 286"/>
                <a:gd name="T27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86" h="331">
                  <a:moveTo>
                    <a:pt x="226" y="129"/>
                  </a:moveTo>
                  <a:cubicBezTo>
                    <a:pt x="224" y="74"/>
                    <a:pt x="192" y="48"/>
                    <a:pt x="152" y="48"/>
                  </a:cubicBezTo>
                  <a:cubicBezTo>
                    <a:pt x="107" y="48"/>
                    <a:pt x="71" y="77"/>
                    <a:pt x="63" y="129"/>
                  </a:cubicBezTo>
                  <a:lnTo>
                    <a:pt x="226" y="129"/>
                  </a:lnTo>
                  <a:close/>
                  <a:moveTo>
                    <a:pt x="153" y="0"/>
                  </a:moveTo>
                  <a:cubicBezTo>
                    <a:pt x="240" y="0"/>
                    <a:pt x="286" y="66"/>
                    <a:pt x="286" y="148"/>
                  </a:cubicBezTo>
                  <a:cubicBezTo>
                    <a:pt x="286" y="156"/>
                    <a:pt x="284" y="174"/>
                    <a:pt x="284" y="174"/>
                  </a:cubicBezTo>
                  <a:cubicBezTo>
                    <a:pt x="61" y="174"/>
                    <a:pt x="61" y="174"/>
                    <a:pt x="61" y="174"/>
                  </a:cubicBezTo>
                  <a:cubicBezTo>
                    <a:pt x="64" y="244"/>
                    <a:pt x="112" y="279"/>
                    <a:pt x="166" y="279"/>
                  </a:cubicBezTo>
                  <a:cubicBezTo>
                    <a:pt x="219" y="279"/>
                    <a:pt x="257" y="242"/>
                    <a:pt x="257" y="242"/>
                  </a:cubicBezTo>
                  <a:cubicBezTo>
                    <a:pt x="281" y="286"/>
                    <a:pt x="281" y="286"/>
                    <a:pt x="281" y="286"/>
                  </a:cubicBezTo>
                  <a:cubicBezTo>
                    <a:pt x="281" y="286"/>
                    <a:pt x="236" y="331"/>
                    <a:pt x="162" y="331"/>
                  </a:cubicBezTo>
                  <a:cubicBezTo>
                    <a:pt x="66" y="331"/>
                    <a:pt x="0" y="259"/>
                    <a:pt x="0" y="165"/>
                  </a:cubicBezTo>
                  <a:cubicBezTo>
                    <a:pt x="0" y="65"/>
                    <a:pt x="66" y="0"/>
                    <a:pt x="153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08097239-3B22-A84D-A6DF-2CD8DE9C63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0626" y="644526"/>
              <a:ext cx="527050" cy="615950"/>
            </a:xfrm>
            <a:custGeom>
              <a:avLst/>
              <a:gdLst>
                <a:gd name="T0" fmla="*/ 0 w 277"/>
                <a:gd name="T1" fmla="*/ 7 h 324"/>
                <a:gd name="T2" fmla="*/ 56 w 277"/>
                <a:gd name="T3" fmla="*/ 7 h 324"/>
                <a:gd name="T4" fmla="*/ 56 w 277"/>
                <a:gd name="T5" fmla="*/ 49 h 324"/>
                <a:gd name="T6" fmla="*/ 55 w 277"/>
                <a:gd name="T7" fmla="*/ 72 h 324"/>
                <a:gd name="T8" fmla="*/ 56 w 277"/>
                <a:gd name="T9" fmla="*/ 72 h 324"/>
                <a:gd name="T10" fmla="*/ 171 w 277"/>
                <a:gd name="T11" fmla="*/ 0 h 324"/>
                <a:gd name="T12" fmla="*/ 277 w 277"/>
                <a:gd name="T13" fmla="*/ 121 h 324"/>
                <a:gd name="T14" fmla="*/ 277 w 277"/>
                <a:gd name="T15" fmla="*/ 324 h 324"/>
                <a:gd name="T16" fmla="*/ 218 w 277"/>
                <a:gd name="T17" fmla="*/ 324 h 324"/>
                <a:gd name="T18" fmla="*/ 218 w 277"/>
                <a:gd name="T19" fmla="*/ 135 h 324"/>
                <a:gd name="T20" fmla="*/ 160 w 277"/>
                <a:gd name="T21" fmla="*/ 55 h 324"/>
                <a:gd name="T22" fmla="*/ 63 w 277"/>
                <a:gd name="T23" fmla="*/ 133 h 324"/>
                <a:gd name="T24" fmla="*/ 58 w 277"/>
                <a:gd name="T25" fmla="*/ 175 h 324"/>
                <a:gd name="T26" fmla="*/ 58 w 277"/>
                <a:gd name="T27" fmla="*/ 324 h 324"/>
                <a:gd name="T28" fmla="*/ 0 w 277"/>
                <a:gd name="T29" fmla="*/ 324 h 324"/>
                <a:gd name="T30" fmla="*/ 0 w 277"/>
                <a:gd name="T31" fmla="*/ 7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77" h="324">
                  <a:moveTo>
                    <a:pt x="0" y="7"/>
                  </a:moveTo>
                  <a:cubicBezTo>
                    <a:pt x="56" y="7"/>
                    <a:pt x="56" y="7"/>
                    <a:pt x="56" y="7"/>
                  </a:cubicBezTo>
                  <a:cubicBezTo>
                    <a:pt x="56" y="49"/>
                    <a:pt x="56" y="49"/>
                    <a:pt x="56" y="49"/>
                  </a:cubicBezTo>
                  <a:cubicBezTo>
                    <a:pt x="56" y="62"/>
                    <a:pt x="55" y="72"/>
                    <a:pt x="55" y="72"/>
                  </a:cubicBezTo>
                  <a:cubicBezTo>
                    <a:pt x="56" y="72"/>
                    <a:pt x="56" y="72"/>
                    <a:pt x="56" y="72"/>
                  </a:cubicBezTo>
                  <a:cubicBezTo>
                    <a:pt x="69" y="45"/>
                    <a:pt x="105" y="0"/>
                    <a:pt x="171" y="0"/>
                  </a:cubicBezTo>
                  <a:cubicBezTo>
                    <a:pt x="243" y="0"/>
                    <a:pt x="277" y="40"/>
                    <a:pt x="277" y="121"/>
                  </a:cubicBezTo>
                  <a:cubicBezTo>
                    <a:pt x="277" y="324"/>
                    <a:pt x="277" y="324"/>
                    <a:pt x="277" y="324"/>
                  </a:cubicBezTo>
                  <a:cubicBezTo>
                    <a:pt x="218" y="324"/>
                    <a:pt x="218" y="324"/>
                    <a:pt x="218" y="324"/>
                  </a:cubicBezTo>
                  <a:cubicBezTo>
                    <a:pt x="218" y="135"/>
                    <a:pt x="218" y="135"/>
                    <a:pt x="218" y="135"/>
                  </a:cubicBezTo>
                  <a:cubicBezTo>
                    <a:pt x="218" y="90"/>
                    <a:pt x="209" y="55"/>
                    <a:pt x="160" y="55"/>
                  </a:cubicBezTo>
                  <a:cubicBezTo>
                    <a:pt x="113" y="55"/>
                    <a:pt x="76" y="87"/>
                    <a:pt x="63" y="133"/>
                  </a:cubicBezTo>
                  <a:cubicBezTo>
                    <a:pt x="59" y="145"/>
                    <a:pt x="58" y="160"/>
                    <a:pt x="58" y="175"/>
                  </a:cubicBezTo>
                  <a:cubicBezTo>
                    <a:pt x="58" y="324"/>
                    <a:pt x="58" y="324"/>
                    <a:pt x="58" y="324"/>
                  </a:cubicBezTo>
                  <a:cubicBezTo>
                    <a:pt x="0" y="324"/>
                    <a:pt x="0" y="324"/>
                    <a:pt x="0" y="324"/>
                  </a:cubicBezTo>
                  <a:lnTo>
                    <a:pt x="0" y="7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BC1B8998-5FD2-5747-8943-5A87313043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33238" y="492126"/>
              <a:ext cx="339725" cy="773113"/>
            </a:xfrm>
            <a:custGeom>
              <a:avLst/>
              <a:gdLst>
                <a:gd name="T0" fmla="*/ 40 w 178"/>
                <a:gd name="T1" fmla="*/ 140 h 406"/>
                <a:gd name="T2" fmla="*/ 0 w 178"/>
                <a:gd name="T3" fmla="*/ 140 h 406"/>
                <a:gd name="T4" fmla="*/ 0 w 178"/>
                <a:gd name="T5" fmla="*/ 92 h 406"/>
                <a:gd name="T6" fmla="*/ 41 w 178"/>
                <a:gd name="T7" fmla="*/ 92 h 406"/>
                <a:gd name="T8" fmla="*/ 41 w 178"/>
                <a:gd name="T9" fmla="*/ 0 h 406"/>
                <a:gd name="T10" fmla="*/ 98 w 178"/>
                <a:gd name="T11" fmla="*/ 0 h 406"/>
                <a:gd name="T12" fmla="*/ 98 w 178"/>
                <a:gd name="T13" fmla="*/ 92 h 406"/>
                <a:gd name="T14" fmla="*/ 172 w 178"/>
                <a:gd name="T15" fmla="*/ 92 h 406"/>
                <a:gd name="T16" fmla="*/ 172 w 178"/>
                <a:gd name="T17" fmla="*/ 140 h 406"/>
                <a:gd name="T18" fmla="*/ 98 w 178"/>
                <a:gd name="T19" fmla="*/ 140 h 406"/>
                <a:gd name="T20" fmla="*/ 98 w 178"/>
                <a:gd name="T21" fmla="*/ 281 h 406"/>
                <a:gd name="T22" fmla="*/ 164 w 178"/>
                <a:gd name="T23" fmla="*/ 352 h 406"/>
                <a:gd name="T24" fmla="*/ 178 w 178"/>
                <a:gd name="T25" fmla="*/ 351 h 406"/>
                <a:gd name="T26" fmla="*/ 178 w 178"/>
                <a:gd name="T27" fmla="*/ 405 h 406"/>
                <a:gd name="T28" fmla="*/ 157 w 178"/>
                <a:gd name="T29" fmla="*/ 406 h 406"/>
                <a:gd name="T30" fmla="*/ 40 w 178"/>
                <a:gd name="T31" fmla="*/ 288 h 406"/>
                <a:gd name="T32" fmla="*/ 40 w 178"/>
                <a:gd name="T33" fmla="*/ 140 h 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8" h="406">
                  <a:moveTo>
                    <a:pt x="40" y="140"/>
                  </a:moveTo>
                  <a:cubicBezTo>
                    <a:pt x="0" y="140"/>
                    <a:pt x="0" y="140"/>
                    <a:pt x="0" y="140"/>
                  </a:cubicBezTo>
                  <a:cubicBezTo>
                    <a:pt x="0" y="92"/>
                    <a:pt x="0" y="92"/>
                    <a:pt x="0" y="92"/>
                  </a:cubicBezTo>
                  <a:cubicBezTo>
                    <a:pt x="41" y="92"/>
                    <a:pt x="41" y="92"/>
                    <a:pt x="41" y="92"/>
                  </a:cubicBezTo>
                  <a:cubicBezTo>
                    <a:pt x="41" y="0"/>
                    <a:pt x="41" y="0"/>
                    <a:pt x="41" y="0"/>
                  </a:cubicBezTo>
                  <a:cubicBezTo>
                    <a:pt x="98" y="0"/>
                    <a:pt x="98" y="0"/>
                    <a:pt x="98" y="0"/>
                  </a:cubicBezTo>
                  <a:cubicBezTo>
                    <a:pt x="98" y="92"/>
                    <a:pt x="98" y="92"/>
                    <a:pt x="98" y="92"/>
                  </a:cubicBezTo>
                  <a:cubicBezTo>
                    <a:pt x="172" y="92"/>
                    <a:pt x="172" y="92"/>
                    <a:pt x="172" y="92"/>
                  </a:cubicBezTo>
                  <a:cubicBezTo>
                    <a:pt x="172" y="140"/>
                    <a:pt x="172" y="140"/>
                    <a:pt x="172" y="140"/>
                  </a:cubicBezTo>
                  <a:cubicBezTo>
                    <a:pt x="98" y="140"/>
                    <a:pt x="98" y="140"/>
                    <a:pt x="98" y="140"/>
                  </a:cubicBezTo>
                  <a:cubicBezTo>
                    <a:pt x="98" y="281"/>
                    <a:pt x="98" y="281"/>
                    <a:pt x="98" y="281"/>
                  </a:cubicBezTo>
                  <a:cubicBezTo>
                    <a:pt x="98" y="344"/>
                    <a:pt x="141" y="352"/>
                    <a:pt x="164" y="352"/>
                  </a:cubicBezTo>
                  <a:cubicBezTo>
                    <a:pt x="172" y="352"/>
                    <a:pt x="178" y="351"/>
                    <a:pt x="178" y="351"/>
                  </a:cubicBezTo>
                  <a:cubicBezTo>
                    <a:pt x="178" y="405"/>
                    <a:pt x="178" y="405"/>
                    <a:pt x="178" y="405"/>
                  </a:cubicBezTo>
                  <a:cubicBezTo>
                    <a:pt x="178" y="405"/>
                    <a:pt x="169" y="406"/>
                    <a:pt x="157" y="406"/>
                  </a:cubicBezTo>
                  <a:cubicBezTo>
                    <a:pt x="118" y="406"/>
                    <a:pt x="40" y="394"/>
                    <a:pt x="40" y="288"/>
                  </a:cubicBezTo>
                  <a:lnTo>
                    <a:pt x="40" y="14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EAA25A28-653C-D14E-8678-1E37A45867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14238" y="644526"/>
              <a:ext cx="431800" cy="630238"/>
            </a:xfrm>
            <a:custGeom>
              <a:avLst/>
              <a:gdLst>
                <a:gd name="T0" fmla="*/ 28 w 227"/>
                <a:gd name="T1" fmla="*/ 242 h 331"/>
                <a:gd name="T2" fmla="*/ 116 w 227"/>
                <a:gd name="T3" fmla="*/ 279 h 331"/>
                <a:gd name="T4" fmla="*/ 167 w 227"/>
                <a:gd name="T5" fmla="*/ 239 h 331"/>
                <a:gd name="T6" fmla="*/ 10 w 227"/>
                <a:gd name="T7" fmla="*/ 90 h 331"/>
                <a:gd name="T8" fmla="*/ 120 w 227"/>
                <a:gd name="T9" fmla="*/ 0 h 331"/>
                <a:gd name="T10" fmla="*/ 219 w 227"/>
                <a:gd name="T11" fmla="*/ 35 h 331"/>
                <a:gd name="T12" fmla="*/ 195 w 227"/>
                <a:gd name="T13" fmla="*/ 80 h 331"/>
                <a:gd name="T14" fmla="*/ 120 w 227"/>
                <a:gd name="T15" fmla="*/ 52 h 331"/>
                <a:gd name="T16" fmla="*/ 70 w 227"/>
                <a:gd name="T17" fmla="*/ 91 h 331"/>
                <a:gd name="T18" fmla="*/ 227 w 227"/>
                <a:gd name="T19" fmla="*/ 239 h 331"/>
                <a:gd name="T20" fmla="*/ 116 w 227"/>
                <a:gd name="T21" fmla="*/ 331 h 331"/>
                <a:gd name="T22" fmla="*/ 0 w 227"/>
                <a:gd name="T23" fmla="*/ 285 h 331"/>
                <a:gd name="T24" fmla="*/ 28 w 227"/>
                <a:gd name="T25" fmla="*/ 242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27" h="331">
                  <a:moveTo>
                    <a:pt x="28" y="242"/>
                  </a:moveTo>
                  <a:cubicBezTo>
                    <a:pt x="28" y="242"/>
                    <a:pt x="63" y="279"/>
                    <a:pt x="116" y="279"/>
                  </a:cubicBezTo>
                  <a:cubicBezTo>
                    <a:pt x="142" y="279"/>
                    <a:pt x="167" y="265"/>
                    <a:pt x="167" y="239"/>
                  </a:cubicBezTo>
                  <a:cubicBezTo>
                    <a:pt x="167" y="181"/>
                    <a:pt x="10" y="193"/>
                    <a:pt x="10" y="90"/>
                  </a:cubicBezTo>
                  <a:cubicBezTo>
                    <a:pt x="10" y="32"/>
                    <a:pt x="59" y="0"/>
                    <a:pt x="120" y="0"/>
                  </a:cubicBezTo>
                  <a:cubicBezTo>
                    <a:pt x="188" y="0"/>
                    <a:pt x="219" y="35"/>
                    <a:pt x="219" y="35"/>
                  </a:cubicBezTo>
                  <a:cubicBezTo>
                    <a:pt x="195" y="80"/>
                    <a:pt x="195" y="80"/>
                    <a:pt x="195" y="80"/>
                  </a:cubicBezTo>
                  <a:cubicBezTo>
                    <a:pt x="195" y="80"/>
                    <a:pt x="168" y="52"/>
                    <a:pt x="120" y="52"/>
                  </a:cubicBezTo>
                  <a:cubicBezTo>
                    <a:pt x="94" y="52"/>
                    <a:pt x="70" y="63"/>
                    <a:pt x="70" y="91"/>
                  </a:cubicBezTo>
                  <a:cubicBezTo>
                    <a:pt x="70" y="148"/>
                    <a:pt x="227" y="135"/>
                    <a:pt x="227" y="239"/>
                  </a:cubicBezTo>
                  <a:cubicBezTo>
                    <a:pt x="227" y="292"/>
                    <a:pt x="183" y="331"/>
                    <a:pt x="116" y="331"/>
                  </a:cubicBezTo>
                  <a:cubicBezTo>
                    <a:pt x="41" y="331"/>
                    <a:pt x="0" y="285"/>
                    <a:pt x="0" y="285"/>
                  </a:cubicBezTo>
                  <a:lnTo>
                    <a:pt x="28" y="24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0537320-0AA8-104B-8445-D90BE3E22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46051" y="1136651"/>
              <a:ext cx="117475" cy="123825"/>
            </a:xfrm>
            <a:prstGeom prst="rect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EF1D6FE9-AA4A-BB4A-90A6-F37E2B7785D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609976" y="1689101"/>
              <a:ext cx="654050" cy="833438"/>
            </a:xfrm>
            <a:custGeom>
              <a:avLst/>
              <a:gdLst>
                <a:gd name="T0" fmla="*/ 129 w 344"/>
                <a:gd name="T1" fmla="*/ 413 h 438"/>
                <a:gd name="T2" fmla="*/ 317 w 344"/>
                <a:gd name="T3" fmla="*/ 219 h 438"/>
                <a:gd name="T4" fmla="*/ 129 w 344"/>
                <a:gd name="T5" fmla="*/ 25 h 438"/>
                <a:gd name="T6" fmla="*/ 26 w 344"/>
                <a:gd name="T7" fmla="*/ 25 h 438"/>
                <a:gd name="T8" fmla="*/ 26 w 344"/>
                <a:gd name="T9" fmla="*/ 413 h 438"/>
                <a:gd name="T10" fmla="*/ 129 w 344"/>
                <a:gd name="T11" fmla="*/ 413 h 438"/>
                <a:gd name="T12" fmla="*/ 0 w 344"/>
                <a:gd name="T13" fmla="*/ 0 h 438"/>
                <a:gd name="T14" fmla="*/ 133 w 344"/>
                <a:gd name="T15" fmla="*/ 0 h 438"/>
                <a:gd name="T16" fmla="*/ 344 w 344"/>
                <a:gd name="T17" fmla="*/ 219 h 438"/>
                <a:gd name="T18" fmla="*/ 133 w 344"/>
                <a:gd name="T19" fmla="*/ 438 h 438"/>
                <a:gd name="T20" fmla="*/ 0 w 344"/>
                <a:gd name="T21" fmla="*/ 438 h 438"/>
                <a:gd name="T22" fmla="*/ 0 w 344"/>
                <a:gd name="T23" fmla="*/ 0 h 4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44" h="438">
                  <a:moveTo>
                    <a:pt x="129" y="413"/>
                  </a:moveTo>
                  <a:cubicBezTo>
                    <a:pt x="241" y="413"/>
                    <a:pt x="317" y="345"/>
                    <a:pt x="317" y="219"/>
                  </a:cubicBezTo>
                  <a:cubicBezTo>
                    <a:pt x="317" y="94"/>
                    <a:pt x="241" y="25"/>
                    <a:pt x="129" y="25"/>
                  </a:cubicBezTo>
                  <a:cubicBezTo>
                    <a:pt x="26" y="25"/>
                    <a:pt x="26" y="25"/>
                    <a:pt x="26" y="25"/>
                  </a:cubicBezTo>
                  <a:cubicBezTo>
                    <a:pt x="26" y="413"/>
                    <a:pt x="26" y="413"/>
                    <a:pt x="26" y="413"/>
                  </a:cubicBezTo>
                  <a:lnTo>
                    <a:pt x="129" y="413"/>
                  </a:lnTo>
                  <a:close/>
                  <a:moveTo>
                    <a:pt x="0" y="0"/>
                  </a:moveTo>
                  <a:cubicBezTo>
                    <a:pt x="133" y="0"/>
                    <a:pt x="133" y="0"/>
                    <a:pt x="133" y="0"/>
                  </a:cubicBezTo>
                  <a:cubicBezTo>
                    <a:pt x="259" y="0"/>
                    <a:pt x="344" y="80"/>
                    <a:pt x="344" y="219"/>
                  </a:cubicBezTo>
                  <a:cubicBezTo>
                    <a:pt x="344" y="359"/>
                    <a:pt x="259" y="438"/>
                    <a:pt x="133" y="438"/>
                  </a:cubicBezTo>
                  <a:cubicBezTo>
                    <a:pt x="0" y="438"/>
                    <a:pt x="0" y="438"/>
                    <a:pt x="0" y="438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E0EEE209-5D15-4E41-BBED-CDEB11240C8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8963" y="1924051"/>
              <a:ext cx="263525" cy="598488"/>
            </a:xfrm>
            <a:custGeom>
              <a:avLst/>
              <a:gdLst>
                <a:gd name="T0" fmla="*/ 0 w 139"/>
                <a:gd name="T1" fmla="*/ 2 h 315"/>
                <a:gd name="T2" fmla="*/ 25 w 139"/>
                <a:gd name="T3" fmla="*/ 2 h 315"/>
                <a:gd name="T4" fmla="*/ 25 w 139"/>
                <a:gd name="T5" fmla="*/ 62 h 315"/>
                <a:gd name="T6" fmla="*/ 23 w 139"/>
                <a:gd name="T7" fmla="*/ 87 h 315"/>
                <a:gd name="T8" fmla="*/ 24 w 139"/>
                <a:gd name="T9" fmla="*/ 87 h 315"/>
                <a:gd name="T10" fmla="*/ 121 w 139"/>
                <a:gd name="T11" fmla="*/ 0 h 315"/>
                <a:gd name="T12" fmla="*/ 139 w 139"/>
                <a:gd name="T13" fmla="*/ 2 h 315"/>
                <a:gd name="T14" fmla="*/ 139 w 139"/>
                <a:gd name="T15" fmla="*/ 28 h 315"/>
                <a:gd name="T16" fmla="*/ 125 w 139"/>
                <a:gd name="T17" fmla="*/ 27 h 315"/>
                <a:gd name="T18" fmla="*/ 34 w 139"/>
                <a:gd name="T19" fmla="*/ 114 h 315"/>
                <a:gd name="T20" fmla="*/ 25 w 139"/>
                <a:gd name="T21" fmla="*/ 180 h 315"/>
                <a:gd name="T22" fmla="*/ 25 w 139"/>
                <a:gd name="T23" fmla="*/ 315 h 315"/>
                <a:gd name="T24" fmla="*/ 0 w 139"/>
                <a:gd name="T25" fmla="*/ 315 h 315"/>
                <a:gd name="T26" fmla="*/ 0 w 139"/>
                <a:gd name="T27" fmla="*/ 2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39" h="315">
                  <a:moveTo>
                    <a:pt x="0" y="2"/>
                  </a:moveTo>
                  <a:cubicBezTo>
                    <a:pt x="25" y="2"/>
                    <a:pt x="25" y="2"/>
                    <a:pt x="25" y="2"/>
                  </a:cubicBezTo>
                  <a:cubicBezTo>
                    <a:pt x="25" y="62"/>
                    <a:pt x="25" y="62"/>
                    <a:pt x="25" y="62"/>
                  </a:cubicBezTo>
                  <a:cubicBezTo>
                    <a:pt x="25" y="76"/>
                    <a:pt x="23" y="87"/>
                    <a:pt x="23" y="87"/>
                  </a:cubicBezTo>
                  <a:cubicBezTo>
                    <a:pt x="24" y="87"/>
                    <a:pt x="24" y="87"/>
                    <a:pt x="24" y="87"/>
                  </a:cubicBezTo>
                  <a:cubicBezTo>
                    <a:pt x="39" y="39"/>
                    <a:pt x="73" y="0"/>
                    <a:pt x="121" y="0"/>
                  </a:cubicBezTo>
                  <a:cubicBezTo>
                    <a:pt x="130" y="0"/>
                    <a:pt x="139" y="2"/>
                    <a:pt x="139" y="2"/>
                  </a:cubicBezTo>
                  <a:cubicBezTo>
                    <a:pt x="139" y="28"/>
                    <a:pt x="139" y="28"/>
                    <a:pt x="139" y="28"/>
                  </a:cubicBezTo>
                  <a:cubicBezTo>
                    <a:pt x="139" y="28"/>
                    <a:pt x="131" y="27"/>
                    <a:pt x="125" y="27"/>
                  </a:cubicBezTo>
                  <a:cubicBezTo>
                    <a:pt x="77" y="27"/>
                    <a:pt x="48" y="68"/>
                    <a:pt x="34" y="114"/>
                  </a:cubicBezTo>
                  <a:cubicBezTo>
                    <a:pt x="28" y="136"/>
                    <a:pt x="25" y="159"/>
                    <a:pt x="25" y="180"/>
                  </a:cubicBezTo>
                  <a:cubicBezTo>
                    <a:pt x="25" y="315"/>
                    <a:pt x="25" y="315"/>
                    <a:pt x="25" y="315"/>
                  </a:cubicBezTo>
                  <a:cubicBezTo>
                    <a:pt x="0" y="315"/>
                    <a:pt x="0" y="315"/>
                    <a:pt x="0" y="315"/>
                  </a:cubicBezTo>
                  <a:lnTo>
                    <a:pt x="0" y="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5FDFCE35-BE30-5A48-A449-F6BC896187D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35513" y="1689101"/>
              <a:ext cx="57150" cy="833438"/>
            </a:xfrm>
            <a:custGeom>
              <a:avLst/>
              <a:gdLst>
                <a:gd name="T0" fmla="*/ 2 w 36"/>
                <a:gd name="T1" fmla="*/ 525 h 525"/>
                <a:gd name="T2" fmla="*/ 32 w 36"/>
                <a:gd name="T3" fmla="*/ 525 h 525"/>
                <a:gd name="T4" fmla="*/ 32 w 36"/>
                <a:gd name="T5" fmla="*/ 150 h 525"/>
                <a:gd name="T6" fmla="*/ 2 w 36"/>
                <a:gd name="T7" fmla="*/ 150 h 525"/>
                <a:gd name="T8" fmla="*/ 2 w 36"/>
                <a:gd name="T9" fmla="*/ 525 h 525"/>
                <a:gd name="T10" fmla="*/ 0 w 36"/>
                <a:gd name="T11" fmla="*/ 55 h 525"/>
                <a:gd name="T12" fmla="*/ 36 w 36"/>
                <a:gd name="T13" fmla="*/ 55 h 525"/>
                <a:gd name="T14" fmla="*/ 36 w 36"/>
                <a:gd name="T15" fmla="*/ 0 h 525"/>
                <a:gd name="T16" fmla="*/ 0 w 36"/>
                <a:gd name="T17" fmla="*/ 0 h 525"/>
                <a:gd name="T18" fmla="*/ 0 w 36"/>
                <a:gd name="T19" fmla="*/ 55 h 5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525">
                  <a:moveTo>
                    <a:pt x="2" y="525"/>
                  </a:moveTo>
                  <a:lnTo>
                    <a:pt x="32" y="525"/>
                  </a:lnTo>
                  <a:lnTo>
                    <a:pt x="32" y="150"/>
                  </a:lnTo>
                  <a:lnTo>
                    <a:pt x="2" y="150"/>
                  </a:lnTo>
                  <a:lnTo>
                    <a:pt x="2" y="525"/>
                  </a:lnTo>
                  <a:close/>
                  <a:moveTo>
                    <a:pt x="0" y="55"/>
                  </a:moveTo>
                  <a:lnTo>
                    <a:pt x="36" y="55"/>
                  </a:lnTo>
                  <a:lnTo>
                    <a:pt x="36" y="0"/>
                  </a:lnTo>
                  <a:lnTo>
                    <a:pt x="0" y="0"/>
                  </a:lnTo>
                  <a:lnTo>
                    <a:pt x="0" y="55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A601DC36-C1A5-7A4E-BCBF-00813474D07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60926" y="1927226"/>
              <a:ext cx="496888" cy="595313"/>
            </a:xfrm>
            <a:custGeom>
              <a:avLst/>
              <a:gdLst>
                <a:gd name="T0" fmla="*/ 0 w 262"/>
                <a:gd name="T1" fmla="*/ 0 h 313"/>
                <a:gd name="T2" fmla="*/ 28 w 262"/>
                <a:gd name="T3" fmla="*/ 0 h 313"/>
                <a:gd name="T4" fmla="*/ 121 w 262"/>
                <a:gd name="T5" fmla="*/ 246 h 313"/>
                <a:gd name="T6" fmla="*/ 131 w 262"/>
                <a:gd name="T7" fmla="*/ 279 h 313"/>
                <a:gd name="T8" fmla="*/ 132 w 262"/>
                <a:gd name="T9" fmla="*/ 279 h 313"/>
                <a:gd name="T10" fmla="*/ 143 w 262"/>
                <a:gd name="T11" fmla="*/ 246 h 313"/>
                <a:gd name="T12" fmla="*/ 236 w 262"/>
                <a:gd name="T13" fmla="*/ 0 h 313"/>
                <a:gd name="T14" fmla="*/ 262 w 262"/>
                <a:gd name="T15" fmla="*/ 0 h 313"/>
                <a:gd name="T16" fmla="*/ 144 w 262"/>
                <a:gd name="T17" fmla="*/ 313 h 313"/>
                <a:gd name="T18" fmla="*/ 120 w 262"/>
                <a:gd name="T19" fmla="*/ 313 h 313"/>
                <a:gd name="T20" fmla="*/ 0 w 262"/>
                <a:gd name="T21" fmla="*/ 0 h 3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262" h="313">
                  <a:moveTo>
                    <a:pt x="0" y="0"/>
                  </a:moveTo>
                  <a:cubicBezTo>
                    <a:pt x="28" y="0"/>
                    <a:pt x="28" y="0"/>
                    <a:pt x="28" y="0"/>
                  </a:cubicBezTo>
                  <a:cubicBezTo>
                    <a:pt x="121" y="246"/>
                    <a:pt x="121" y="246"/>
                    <a:pt x="121" y="246"/>
                  </a:cubicBezTo>
                  <a:cubicBezTo>
                    <a:pt x="126" y="260"/>
                    <a:pt x="131" y="279"/>
                    <a:pt x="131" y="279"/>
                  </a:cubicBezTo>
                  <a:cubicBezTo>
                    <a:pt x="132" y="279"/>
                    <a:pt x="132" y="279"/>
                    <a:pt x="132" y="279"/>
                  </a:cubicBezTo>
                  <a:cubicBezTo>
                    <a:pt x="132" y="279"/>
                    <a:pt x="137" y="260"/>
                    <a:pt x="143" y="246"/>
                  </a:cubicBezTo>
                  <a:cubicBezTo>
                    <a:pt x="236" y="0"/>
                    <a:pt x="236" y="0"/>
                    <a:pt x="236" y="0"/>
                  </a:cubicBezTo>
                  <a:cubicBezTo>
                    <a:pt x="262" y="0"/>
                    <a:pt x="262" y="0"/>
                    <a:pt x="262" y="0"/>
                  </a:cubicBezTo>
                  <a:cubicBezTo>
                    <a:pt x="144" y="313"/>
                    <a:pt x="144" y="313"/>
                    <a:pt x="144" y="313"/>
                  </a:cubicBezTo>
                  <a:cubicBezTo>
                    <a:pt x="120" y="313"/>
                    <a:pt x="120" y="313"/>
                    <a:pt x="120" y="313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D54C74C1-1A4D-0746-9D8A-0C56B6D1687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75276" y="1914526"/>
              <a:ext cx="512763" cy="623888"/>
            </a:xfrm>
            <a:custGeom>
              <a:avLst/>
              <a:gdLst>
                <a:gd name="T0" fmla="*/ 243 w 270"/>
                <a:gd name="T1" fmla="*/ 135 h 328"/>
                <a:gd name="T2" fmla="*/ 146 w 270"/>
                <a:gd name="T3" fmla="*/ 24 h 328"/>
                <a:gd name="T4" fmla="*/ 28 w 270"/>
                <a:gd name="T5" fmla="*/ 135 h 328"/>
                <a:gd name="T6" fmla="*/ 243 w 270"/>
                <a:gd name="T7" fmla="*/ 135 h 328"/>
                <a:gd name="T8" fmla="*/ 147 w 270"/>
                <a:gd name="T9" fmla="*/ 0 h 328"/>
                <a:gd name="T10" fmla="*/ 270 w 270"/>
                <a:gd name="T11" fmla="*/ 142 h 328"/>
                <a:gd name="T12" fmla="*/ 269 w 270"/>
                <a:gd name="T13" fmla="*/ 159 h 328"/>
                <a:gd name="T14" fmla="*/ 26 w 270"/>
                <a:gd name="T15" fmla="*/ 159 h 328"/>
                <a:gd name="T16" fmla="*/ 156 w 270"/>
                <a:gd name="T17" fmla="*/ 302 h 328"/>
                <a:gd name="T18" fmla="*/ 249 w 270"/>
                <a:gd name="T19" fmla="*/ 263 h 328"/>
                <a:gd name="T20" fmla="*/ 263 w 270"/>
                <a:gd name="T21" fmla="*/ 284 h 328"/>
                <a:gd name="T22" fmla="*/ 156 w 270"/>
                <a:gd name="T23" fmla="*/ 328 h 328"/>
                <a:gd name="T24" fmla="*/ 0 w 270"/>
                <a:gd name="T25" fmla="*/ 164 h 328"/>
                <a:gd name="T26" fmla="*/ 147 w 270"/>
                <a:gd name="T27" fmla="*/ 0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70" h="328">
                  <a:moveTo>
                    <a:pt x="243" y="135"/>
                  </a:moveTo>
                  <a:cubicBezTo>
                    <a:pt x="240" y="59"/>
                    <a:pt x="196" y="24"/>
                    <a:pt x="146" y="24"/>
                  </a:cubicBezTo>
                  <a:cubicBezTo>
                    <a:pt x="90" y="24"/>
                    <a:pt x="39" y="62"/>
                    <a:pt x="28" y="135"/>
                  </a:cubicBezTo>
                  <a:lnTo>
                    <a:pt x="243" y="135"/>
                  </a:lnTo>
                  <a:close/>
                  <a:moveTo>
                    <a:pt x="147" y="0"/>
                  </a:moveTo>
                  <a:cubicBezTo>
                    <a:pt x="229" y="0"/>
                    <a:pt x="270" y="67"/>
                    <a:pt x="270" y="142"/>
                  </a:cubicBezTo>
                  <a:cubicBezTo>
                    <a:pt x="270" y="149"/>
                    <a:pt x="269" y="159"/>
                    <a:pt x="269" y="159"/>
                  </a:cubicBezTo>
                  <a:cubicBezTo>
                    <a:pt x="26" y="159"/>
                    <a:pt x="26" y="159"/>
                    <a:pt x="26" y="159"/>
                  </a:cubicBezTo>
                  <a:cubicBezTo>
                    <a:pt x="26" y="250"/>
                    <a:pt x="85" y="302"/>
                    <a:pt x="156" y="302"/>
                  </a:cubicBezTo>
                  <a:cubicBezTo>
                    <a:pt x="214" y="302"/>
                    <a:pt x="249" y="263"/>
                    <a:pt x="249" y="263"/>
                  </a:cubicBezTo>
                  <a:cubicBezTo>
                    <a:pt x="263" y="284"/>
                    <a:pt x="263" y="284"/>
                    <a:pt x="263" y="284"/>
                  </a:cubicBezTo>
                  <a:cubicBezTo>
                    <a:pt x="263" y="284"/>
                    <a:pt x="221" y="328"/>
                    <a:pt x="156" y="328"/>
                  </a:cubicBezTo>
                  <a:cubicBezTo>
                    <a:pt x="70" y="328"/>
                    <a:pt x="0" y="264"/>
                    <a:pt x="0" y="164"/>
                  </a:cubicBezTo>
                  <a:cubicBezTo>
                    <a:pt x="0" y="59"/>
                    <a:pt x="69" y="0"/>
                    <a:pt x="147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30FA9AF8-C3B9-E741-BC05-3856E817A1AC}"/>
                </a:ext>
              </a:extLst>
            </p:cNvPr>
            <p:cNvSpPr>
              <a:spLocks/>
            </p:cNvSpPr>
            <p:nvPr/>
          </p:nvSpPr>
          <p:spPr bwMode="auto">
            <a:xfrm>
              <a:off x="6003926" y="1914526"/>
              <a:ext cx="479425" cy="608013"/>
            </a:xfrm>
            <a:custGeom>
              <a:avLst/>
              <a:gdLst>
                <a:gd name="T0" fmla="*/ 0 w 252"/>
                <a:gd name="T1" fmla="*/ 7 h 320"/>
                <a:gd name="T2" fmla="*/ 25 w 252"/>
                <a:gd name="T3" fmla="*/ 7 h 320"/>
                <a:gd name="T4" fmla="*/ 25 w 252"/>
                <a:gd name="T5" fmla="*/ 62 h 320"/>
                <a:gd name="T6" fmla="*/ 23 w 252"/>
                <a:gd name="T7" fmla="*/ 88 h 320"/>
                <a:gd name="T8" fmla="*/ 24 w 252"/>
                <a:gd name="T9" fmla="*/ 88 h 320"/>
                <a:gd name="T10" fmla="*/ 152 w 252"/>
                <a:gd name="T11" fmla="*/ 0 h 320"/>
                <a:gd name="T12" fmla="*/ 252 w 252"/>
                <a:gd name="T13" fmla="*/ 122 h 320"/>
                <a:gd name="T14" fmla="*/ 252 w 252"/>
                <a:gd name="T15" fmla="*/ 320 h 320"/>
                <a:gd name="T16" fmla="*/ 227 w 252"/>
                <a:gd name="T17" fmla="*/ 320 h 320"/>
                <a:gd name="T18" fmla="*/ 227 w 252"/>
                <a:gd name="T19" fmla="*/ 131 h 320"/>
                <a:gd name="T20" fmla="*/ 152 w 252"/>
                <a:gd name="T21" fmla="*/ 26 h 320"/>
                <a:gd name="T22" fmla="*/ 30 w 252"/>
                <a:gd name="T23" fmla="*/ 125 h 320"/>
                <a:gd name="T24" fmla="*/ 25 w 252"/>
                <a:gd name="T25" fmla="*/ 168 h 320"/>
                <a:gd name="T26" fmla="*/ 25 w 252"/>
                <a:gd name="T27" fmla="*/ 320 h 320"/>
                <a:gd name="T28" fmla="*/ 0 w 252"/>
                <a:gd name="T29" fmla="*/ 320 h 320"/>
                <a:gd name="T30" fmla="*/ 0 w 252"/>
                <a:gd name="T31" fmla="*/ 7 h 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52" h="320">
                  <a:moveTo>
                    <a:pt x="0" y="7"/>
                  </a:moveTo>
                  <a:cubicBezTo>
                    <a:pt x="25" y="7"/>
                    <a:pt x="25" y="7"/>
                    <a:pt x="25" y="7"/>
                  </a:cubicBezTo>
                  <a:cubicBezTo>
                    <a:pt x="25" y="62"/>
                    <a:pt x="25" y="62"/>
                    <a:pt x="25" y="62"/>
                  </a:cubicBezTo>
                  <a:cubicBezTo>
                    <a:pt x="25" y="77"/>
                    <a:pt x="23" y="88"/>
                    <a:pt x="23" y="88"/>
                  </a:cubicBezTo>
                  <a:cubicBezTo>
                    <a:pt x="24" y="88"/>
                    <a:pt x="24" y="88"/>
                    <a:pt x="24" y="88"/>
                  </a:cubicBezTo>
                  <a:cubicBezTo>
                    <a:pt x="34" y="59"/>
                    <a:pt x="77" y="0"/>
                    <a:pt x="152" y="0"/>
                  </a:cubicBezTo>
                  <a:cubicBezTo>
                    <a:pt x="231" y="0"/>
                    <a:pt x="252" y="48"/>
                    <a:pt x="252" y="122"/>
                  </a:cubicBezTo>
                  <a:cubicBezTo>
                    <a:pt x="252" y="320"/>
                    <a:pt x="252" y="320"/>
                    <a:pt x="252" y="320"/>
                  </a:cubicBezTo>
                  <a:cubicBezTo>
                    <a:pt x="227" y="320"/>
                    <a:pt x="227" y="320"/>
                    <a:pt x="227" y="320"/>
                  </a:cubicBezTo>
                  <a:cubicBezTo>
                    <a:pt x="227" y="131"/>
                    <a:pt x="227" y="131"/>
                    <a:pt x="227" y="131"/>
                  </a:cubicBezTo>
                  <a:cubicBezTo>
                    <a:pt x="227" y="77"/>
                    <a:pt x="220" y="26"/>
                    <a:pt x="152" y="26"/>
                  </a:cubicBezTo>
                  <a:cubicBezTo>
                    <a:pt x="95" y="26"/>
                    <a:pt x="45" y="67"/>
                    <a:pt x="30" y="125"/>
                  </a:cubicBezTo>
                  <a:cubicBezTo>
                    <a:pt x="26" y="138"/>
                    <a:pt x="25" y="153"/>
                    <a:pt x="25" y="168"/>
                  </a:cubicBezTo>
                  <a:cubicBezTo>
                    <a:pt x="25" y="320"/>
                    <a:pt x="25" y="320"/>
                    <a:pt x="25" y="320"/>
                  </a:cubicBezTo>
                  <a:cubicBezTo>
                    <a:pt x="0" y="320"/>
                    <a:pt x="0" y="320"/>
                    <a:pt x="0" y="320"/>
                  </a:cubicBezTo>
                  <a:lnTo>
                    <a:pt x="0" y="7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04DD23BB-B2D3-A944-81B8-A2956E26363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50076" y="1689101"/>
              <a:ext cx="501650" cy="849313"/>
            </a:xfrm>
            <a:custGeom>
              <a:avLst/>
              <a:gdLst>
                <a:gd name="T0" fmla="*/ 130 w 264"/>
                <a:gd name="T1" fmla="*/ 420 h 446"/>
                <a:gd name="T2" fmla="*/ 237 w 264"/>
                <a:gd name="T3" fmla="*/ 282 h 446"/>
                <a:gd name="T4" fmla="*/ 132 w 264"/>
                <a:gd name="T5" fmla="*/ 144 h 446"/>
                <a:gd name="T6" fmla="*/ 24 w 264"/>
                <a:gd name="T7" fmla="*/ 282 h 446"/>
                <a:gd name="T8" fmla="*/ 130 w 264"/>
                <a:gd name="T9" fmla="*/ 420 h 446"/>
                <a:gd name="T10" fmla="*/ 0 w 264"/>
                <a:gd name="T11" fmla="*/ 0 h 446"/>
                <a:gd name="T12" fmla="*/ 25 w 264"/>
                <a:gd name="T13" fmla="*/ 0 h 446"/>
                <a:gd name="T14" fmla="*/ 25 w 264"/>
                <a:gd name="T15" fmla="*/ 163 h 446"/>
                <a:gd name="T16" fmla="*/ 23 w 264"/>
                <a:gd name="T17" fmla="*/ 189 h 446"/>
                <a:gd name="T18" fmla="*/ 24 w 264"/>
                <a:gd name="T19" fmla="*/ 189 h 446"/>
                <a:gd name="T20" fmla="*/ 133 w 264"/>
                <a:gd name="T21" fmla="*/ 118 h 446"/>
                <a:gd name="T22" fmla="*/ 264 w 264"/>
                <a:gd name="T23" fmla="*/ 282 h 446"/>
                <a:gd name="T24" fmla="*/ 129 w 264"/>
                <a:gd name="T25" fmla="*/ 446 h 446"/>
                <a:gd name="T26" fmla="*/ 24 w 264"/>
                <a:gd name="T27" fmla="*/ 375 h 446"/>
                <a:gd name="T28" fmla="*/ 23 w 264"/>
                <a:gd name="T29" fmla="*/ 375 h 446"/>
                <a:gd name="T30" fmla="*/ 25 w 264"/>
                <a:gd name="T31" fmla="*/ 402 h 446"/>
                <a:gd name="T32" fmla="*/ 25 w 264"/>
                <a:gd name="T33" fmla="*/ 438 h 446"/>
                <a:gd name="T34" fmla="*/ 0 w 264"/>
                <a:gd name="T35" fmla="*/ 438 h 446"/>
                <a:gd name="T36" fmla="*/ 0 w 264"/>
                <a:gd name="T37" fmla="*/ 0 h 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4" h="446">
                  <a:moveTo>
                    <a:pt x="130" y="420"/>
                  </a:moveTo>
                  <a:cubicBezTo>
                    <a:pt x="189" y="420"/>
                    <a:pt x="237" y="369"/>
                    <a:pt x="237" y="282"/>
                  </a:cubicBezTo>
                  <a:cubicBezTo>
                    <a:pt x="237" y="197"/>
                    <a:pt x="194" y="144"/>
                    <a:pt x="132" y="144"/>
                  </a:cubicBezTo>
                  <a:cubicBezTo>
                    <a:pt x="77" y="144"/>
                    <a:pt x="24" y="184"/>
                    <a:pt x="24" y="282"/>
                  </a:cubicBezTo>
                  <a:cubicBezTo>
                    <a:pt x="24" y="352"/>
                    <a:pt x="59" y="420"/>
                    <a:pt x="130" y="420"/>
                  </a:cubicBezTo>
                  <a:moveTo>
                    <a:pt x="0" y="0"/>
                  </a:moveTo>
                  <a:cubicBezTo>
                    <a:pt x="25" y="0"/>
                    <a:pt x="25" y="0"/>
                    <a:pt x="25" y="0"/>
                  </a:cubicBezTo>
                  <a:cubicBezTo>
                    <a:pt x="25" y="163"/>
                    <a:pt x="25" y="163"/>
                    <a:pt x="25" y="163"/>
                  </a:cubicBezTo>
                  <a:cubicBezTo>
                    <a:pt x="25" y="177"/>
                    <a:pt x="23" y="189"/>
                    <a:pt x="23" y="189"/>
                  </a:cubicBezTo>
                  <a:cubicBezTo>
                    <a:pt x="24" y="189"/>
                    <a:pt x="24" y="189"/>
                    <a:pt x="24" y="189"/>
                  </a:cubicBezTo>
                  <a:cubicBezTo>
                    <a:pt x="24" y="189"/>
                    <a:pt x="50" y="118"/>
                    <a:pt x="133" y="118"/>
                  </a:cubicBezTo>
                  <a:cubicBezTo>
                    <a:pt x="215" y="118"/>
                    <a:pt x="264" y="185"/>
                    <a:pt x="264" y="282"/>
                  </a:cubicBezTo>
                  <a:cubicBezTo>
                    <a:pt x="264" y="381"/>
                    <a:pt x="208" y="446"/>
                    <a:pt x="129" y="446"/>
                  </a:cubicBezTo>
                  <a:cubicBezTo>
                    <a:pt x="52" y="446"/>
                    <a:pt x="24" y="375"/>
                    <a:pt x="24" y="375"/>
                  </a:cubicBezTo>
                  <a:cubicBezTo>
                    <a:pt x="23" y="375"/>
                    <a:pt x="23" y="375"/>
                    <a:pt x="23" y="375"/>
                  </a:cubicBezTo>
                  <a:cubicBezTo>
                    <a:pt x="23" y="375"/>
                    <a:pt x="25" y="386"/>
                    <a:pt x="25" y="402"/>
                  </a:cubicBezTo>
                  <a:cubicBezTo>
                    <a:pt x="25" y="438"/>
                    <a:pt x="25" y="438"/>
                    <a:pt x="25" y="438"/>
                  </a:cubicBezTo>
                  <a:cubicBezTo>
                    <a:pt x="0" y="438"/>
                    <a:pt x="0" y="438"/>
                    <a:pt x="0" y="438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87BB2AA8-3A1B-3644-8599-4B7092E5E8AC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9663" y="1927226"/>
              <a:ext cx="533400" cy="844550"/>
            </a:xfrm>
            <a:custGeom>
              <a:avLst/>
              <a:gdLst>
                <a:gd name="T0" fmla="*/ 11 w 281"/>
                <a:gd name="T1" fmla="*/ 404 h 444"/>
                <a:gd name="T2" fmla="*/ 49 w 281"/>
                <a:gd name="T3" fmla="*/ 419 h 444"/>
                <a:gd name="T4" fmla="*/ 108 w 281"/>
                <a:gd name="T5" fmla="*/ 363 h 444"/>
                <a:gd name="T6" fmla="*/ 130 w 281"/>
                <a:gd name="T7" fmla="*/ 311 h 444"/>
                <a:gd name="T8" fmla="*/ 5 w 281"/>
                <a:gd name="T9" fmla="*/ 0 h 444"/>
                <a:gd name="T10" fmla="*/ 32 w 281"/>
                <a:gd name="T11" fmla="*/ 0 h 444"/>
                <a:gd name="T12" fmla="*/ 132 w 281"/>
                <a:gd name="T13" fmla="*/ 250 h 444"/>
                <a:gd name="T14" fmla="*/ 143 w 281"/>
                <a:gd name="T15" fmla="*/ 279 h 444"/>
                <a:gd name="T16" fmla="*/ 144 w 281"/>
                <a:gd name="T17" fmla="*/ 279 h 444"/>
                <a:gd name="T18" fmla="*/ 154 w 281"/>
                <a:gd name="T19" fmla="*/ 250 h 444"/>
                <a:gd name="T20" fmla="*/ 254 w 281"/>
                <a:gd name="T21" fmla="*/ 0 h 444"/>
                <a:gd name="T22" fmla="*/ 281 w 281"/>
                <a:gd name="T23" fmla="*/ 0 h 444"/>
                <a:gd name="T24" fmla="*/ 126 w 281"/>
                <a:gd name="T25" fmla="*/ 386 h 444"/>
                <a:gd name="T26" fmla="*/ 49 w 281"/>
                <a:gd name="T27" fmla="*/ 444 h 444"/>
                <a:gd name="T28" fmla="*/ 0 w 281"/>
                <a:gd name="T29" fmla="*/ 427 h 444"/>
                <a:gd name="T30" fmla="*/ 11 w 281"/>
                <a:gd name="T31" fmla="*/ 404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81" h="444">
                  <a:moveTo>
                    <a:pt x="11" y="404"/>
                  </a:moveTo>
                  <a:cubicBezTo>
                    <a:pt x="11" y="404"/>
                    <a:pt x="28" y="419"/>
                    <a:pt x="49" y="419"/>
                  </a:cubicBezTo>
                  <a:cubicBezTo>
                    <a:pt x="78" y="419"/>
                    <a:pt x="96" y="392"/>
                    <a:pt x="108" y="363"/>
                  </a:cubicBezTo>
                  <a:cubicBezTo>
                    <a:pt x="130" y="311"/>
                    <a:pt x="130" y="311"/>
                    <a:pt x="130" y="311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2" y="0"/>
                    <a:pt x="32" y="0"/>
                    <a:pt x="32" y="0"/>
                  </a:cubicBezTo>
                  <a:cubicBezTo>
                    <a:pt x="132" y="250"/>
                    <a:pt x="132" y="250"/>
                    <a:pt x="132" y="250"/>
                  </a:cubicBezTo>
                  <a:cubicBezTo>
                    <a:pt x="138" y="265"/>
                    <a:pt x="143" y="279"/>
                    <a:pt x="143" y="279"/>
                  </a:cubicBezTo>
                  <a:cubicBezTo>
                    <a:pt x="144" y="279"/>
                    <a:pt x="144" y="279"/>
                    <a:pt x="144" y="279"/>
                  </a:cubicBezTo>
                  <a:cubicBezTo>
                    <a:pt x="144" y="279"/>
                    <a:pt x="148" y="265"/>
                    <a:pt x="154" y="250"/>
                  </a:cubicBezTo>
                  <a:cubicBezTo>
                    <a:pt x="254" y="0"/>
                    <a:pt x="254" y="0"/>
                    <a:pt x="254" y="0"/>
                  </a:cubicBezTo>
                  <a:cubicBezTo>
                    <a:pt x="281" y="0"/>
                    <a:pt x="281" y="0"/>
                    <a:pt x="281" y="0"/>
                  </a:cubicBezTo>
                  <a:cubicBezTo>
                    <a:pt x="126" y="386"/>
                    <a:pt x="126" y="386"/>
                    <a:pt x="126" y="386"/>
                  </a:cubicBezTo>
                  <a:cubicBezTo>
                    <a:pt x="112" y="419"/>
                    <a:pt x="87" y="444"/>
                    <a:pt x="49" y="444"/>
                  </a:cubicBezTo>
                  <a:cubicBezTo>
                    <a:pt x="20" y="444"/>
                    <a:pt x="0" y="427"/>
                    <a:pt x="0" y="427"/>
                  </a:cubicBezTo>
                  <a:lnTo>
                    <a:pt x="11" y="404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8948E296-0FF2-F642-B3D1-B4ADCA612AC7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1038" y="1906588"/>
              <a:ext cx="431800" cy="631825"/>
            </a:xfrm>
            <a:custGeom>
              <a:avLst/>
              <a:gdLst>
                <a:gd name="T0" fmla="*/ 29 w 227"/>
                <a:gd name="T1" fmla="*/ 242 h 332"/>
                <a:gd name="T2" fmla="*/ 117 w 227"/>
                <a:gd name="T3" fmla="*/ 279 h 332"/>
                <a:gd name="T4" fmla="*/ 167 w 227"/>
                <a:gd name="T5" fmla="*/ 240 h 332"/>
                <a:gd name="T6" fmla="*/ 10 w 227"/>
                <a:gd name="T7" fmla="*/ 90 h 332"/>
                <a:gd name="T8" fmla="*/ 121 w 227"/>
                <a:gd name="T9" fmla="*/ 0 h 332"/>
                <a:gd name="T10" fmla="*/ 220 w 227"/>
                <a:gd name="T11" fmla="*/ 35 h 332"/>
                <a:gd name="T12" fmla="*/ 196 w 227"/>
                <a:gd name="T13" fmla="*/ 81 h 332"/>
                <a:gd name="T14" fmla="*/ 120 w 227"/>
                <a:gd name="T15" fmla="*/ 53 h 332"/>
                <a:gd name="T16" fmla="*/ 70 w 227"/>
                <a:gd name="T17" fmla="*/ 91 h 332"/>
                <a:gd name="T18" fmla="*/ 227 w 227"/>
                <a:gd name="T19" fmla="*/ 240 h 332"/>
                <a:gd name="T20" fmla="*/ 117 w 227"/>
                <a:gd name="T21" fmla="*/ 332 h 332"/>
                <a:gd name="T22" fmla="*/ 0 w 227"/>
                <a:gd name="T23" fmla="*/ 285 h 332"/>
                <a:gd name="T24" fmla="*/ 29 w 227"/>
                <a:gd name="T25" fmla="*/ 242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27" h="332">
                  <a:moveTo>
                    <a:pt x="29" y="242"/>
                  </a:moveTo>
                  <a:cubicBezTo>
                    <a:pt x="29" y="242"/>
                    <a:pt x="63" y="279"/>
                    <a:pt x="117" y="279"/>
                  </a:cubicBezTo>
                  <a:cubicBezTo>
                    <a:pt x="142" y="279"/>
                    <a:pt x="167" y="265"/>
                    <a:pt x="167" y="240"/>
                  </a:cubicBezTo>
                  <a:cubicBezTo>
                    <a:pt x="167" y="181"/>
                    <a:pt x="10" y="193"/>
                    <a:pt x="10" y="90"/>
                  </a:cubicBezTo>
                  <a:cubicBezTo>
                    <a:pt x="10" y="33"/>
                    <a:pt x="60" y="0"/>
                    <a:pt x="121" y="0"/>
                  </a:cubicBezTo>
                  <a:cubicBezTo>
                    <a:pt x="188" y="0"/>
                    <a:pt x="220" y="35"/>
                    <a:pt x="220" y="35"/>
                  </a:cubicBezTo>
                  <a:cubicBezTo>
                    <a:pt x="196" y="81"/>
                    <a:pt x="196" y="81"/>
                    <a:pt x="196" y="81"/>
                  </a:cubicBezTo>
                  <a:cubicBezTo>
                    <a:pt x="196" y="81"/>
                    <a:pt x="169" y="53"/>
                    <a:pt x="120" y="53"/>
                  </a:cubicBezTo>
                  <a:cubicBezTo>
                    <a:pt x="95" y="53"/>
                    <a:pt x="70" y="64"/>
                    <a:pt x="70" y="91"/>
                  </a:cubicBezTo>
                  <a:cubicBezTo>
                    <a:pt x="70" y="148"/>
                    <a:pt x="227" y="136"/>
                    <a:pt x="227" y="240"/>
                  </a:cubicBezTo>
                  <a:cubicBezTo>
                    <a:pt x="227" y="292"/>
                    <a:pt x="184" y="332"/>
                    <a:pt x="117" y="332"/>
                  </a:cubicBezTo>
                  <a:cubicBezTo>
                    <a:pt x="42" y="332"/>
                    <a:pt x="0" y="285"/>
                    <a:pt x="0" y="285"/>
                  </a:cubicBezTo>
                  <a:lnTo>
                    <a:pt x="29" y="24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7857EA7D-91C5-B24F-8F50-251B29756864}"/>
                </a:ext>
              </a:extLst>
            </p:cNvPr>
            <p:cNvSpPr>
              <a:spLocks/>
            </p:cNvSpPr>
            <p:nvPr/>
          </p:nvSpPr>
          <p:spPr bwMode="auto">
            <a:xfrm>
              <a:off x="8774113" y="1906588"/>
              <a:ext cx="542925" cy="631825"/>
            </a:xfrm>
            <a:custGeom>
              <a:avLst/>
              <a:gdLst>
                <a:gd name="T0" fmla="*/ 164 w 286"/>
                <a:gd name="T1" fmla="*/ 0 h 332"/>
                <a:gd name="T2" fmla="*/ 279 w 286"/>
                <a:gd name="T3" fmla="*/ 46 h 332"/>
                <a:gd name="T4" fmla="*/ 251 w 286"/>
                <a:gd name="T5" fmla="*/ 89 h 332"/>
                <a:gd name="T6" fmla="*/ 166 w 286"/>
                <a:gd name="T7" fmla="*/ 53 h 332"/>
                <a:gd name="T8" fmla="*/ 60 w 286"/>
                <a:gd name="T9" fmla="*/ 165 h 332"/>
                <a:gd name="T10" fmla="*/ 168 w 286"/>
                <a:gd name="T11" fmla="*/ 279 h 332"/>
                <a:gd name="T12" fmla="*/ 263 w 286"/>
                <a:gd name="T13" fmla="*/ 237 h 332"/>
                <a:gd name="T14" fmla="*/ 286 w 286"/>
                <a:gd name="T15" fmla="*/ 281 h 332"/>
                <a:gd name="T16" fmla="*/ 164 w 286"/>
                <a:gd name="T17" fmla="*/ 332 h 332"/>
                <a:gd name="T18" fmla="*/ 0 w 286"/>
                <a:gd name="T19" fmla="*/ 166 h 332"/>
                <a:gd name="T20" fmla="*/ 164 w 286"/>
                <a:gd name="T21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286" h="332">
                  <a:moveTo>
                    <a:pt x="164" y="0"/>
                  </a:moveTo>
                  <a:cubicBezTo>
                    <a:pt x="241" y="0"/>
                    <a:pt x="279" y="46"/>
                    <a:pt x="279" y="46"/>
                  </a:cubicBezTo>
                  <a:cubicBezTo>
                    <a:pt x="251" y="89"/>
                    <a:pt x="251" y="89"/>
                    <a:pt x="251" y="89"/>
                  </a:cubicBezTo>
                  <a:cubicBezTo>
                    <a:pt x="251" y="89"/>
                    <a:pt x="218" y="53"/>
                    <a:pt x="166" y="53"/>
                  </a:cubicBezTo>
                  <a:cubicBezTo>
                    <a:pt x="105" y="53"/>
                    <a:pt x="60" y="100"/>
                    <a:pt x="60" y="165"/>
                  </a:cubicBezTo>
                  <a:cubicBezTo>
                    <a:pt x="60" y="230"/>
                    <a:pt x="105" y="279"/>
                    <a:pt x="168" y="279"/>
                  </a:cubicBezTo>
                  <a:cubicBezTo>
                    <a:pt x="225" y="279"/>
                    <a:pt x="263" y="237"/>
                    <a:pt x="263" y="237"/>
                  </a:cubicBezTo>
                  <a:cubicBezTo>
                    <a:pt x="286" y="281"/>
                    <a:pt x="286" y="281"/>
                    <a:pt x="286" y="281"/>
                  </a:cubicBezTo>
                  <a:cubicBezTo>
                    <a:pt x="286" y="281"/>
                    <a:pt x="244" y="332"/>
                    <a:pt x="164" y="332"/>
                  </a:cubicBezTo>
                  <a:cubicBezTo>
                    <a:pt x="68" y="332"/>
                    <a:pt x="0" y="261"/>
                    <a:pt x="0" y="166"/>
                  </a:cubicBezTo>
                  <a:cubicBezTo>
                    <a:pt x="0" y="72"/>
                    <a:pt x="68" y="0"/>
                    <a:pt x="164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EA56B0C7-278A-A549-84B8-864480E9940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388476" y="1682751"/>
              <a:ext cx="114300" cy="839788"/>
            </a:xfrm>
            <a:custGeom>
              <a:avLst/>
              <a:gdLst>
                <a:gd name="T0" fmla="*/ 1 w 72"/>
                <a:gd name="T1" fmla="*/ 150 h 529"/>
                <a:gd name="T2" fmla="*/ 72 w 72"/>
                <a:gd name="T3" fmla="*/ 150 h 529"/>
                <a:gd name="T4" fmla="*/ 72 w 72"/>
                <a:gd name="T5" fmla="*/ 529 h 529"/>
                <a:gd name="T6" fmla="*/ 1 w 72"/>
                <a:gd name="T7" fmla="*/ 529 h 529"/>
                <a:gd name="T8" fmla="*/ 1 w 72"/>
                <a:gd name="T9" fmla="*/ 150 h 529"/>
                <a:gd name="T10" fmla="*/ 0 w 72"/>
                <a:gd name="T11" fmla="*/ 0 h 529"/>
                <a:gd name="T12" fmla="*/ 72 w 72"/>
                <a:gd name="T13" fmla="*/ 0 h 529"/>
                <a:gd name="T14" fmla="*/ 72 w 72"/>
                <a:gd name="T15" fmla="*/ 74 h 529"/>
                <a:gd name="T16" fmla="*/ 0 w 72"/>
                <a:gd name="T17" fmla="*/ 74 h 529"/>
                <a:gd name="T18" fmla="*/ 0 w 72"/>
                <a:gd name="T19" fmla="*/ 0 h 5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72" h="529">
                  <a:moveTo>
                    <a:pt x="1" y="150"/>
                  </a:moveTo>
                  <a:lnTo>
                    <a:pt x="72" y="150"/>
                  </a:lnTo>
                  <a:lnTo>
                    <a:pt x="72" y="529"/>
                  </a:lnTo>
                  <a:lnTo>
                    <a:pt x="1" y="529"/>
                  </a:lnTo>
                  <a:lnTo>
                    <a:pt x="1" y="150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72" y="74"/>
                  </a:lnTo>
                  <a:lnTo>
                    <a:pt x="0" y="74"/>
                  </a:ln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22F1BCF1-82B8-AA4A-8EEA-4982D0AB57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593263" y="1906588"/>
              <a:ext cx="541338" cy="631825"/>
            </a:xfrm>
            <a:custGeom>
              <a:avLst/>
              <a:gdLst>
                <a:gd name="T0" fmla="*/ 225 w 285"/>
                <a:gd name="T1" fmla="*/ 129 h 332"/>
                <a:gd name="T2" fmla="*/ 151 w 285"/>
                <a:gd name="T3" fmla="*/ 48 h 332"/>
                <a:gd name="T4" fmla="*/ 62 w 285"/>
                <a:gd name="T5" fmla="*/ 129 h 332"/>
                <a:gd name="T6" fmla="*/ 225 w 285"/>
                <a:gd name="T7" fmla="*/ 129 h 332"/>
                <a:gd name="T8" fmla="*/ 153 w 285"/>
                <a:gd name="T9" fmla="*/ 0 h 332"/>
                <a:gd name="T10" fmla="*/ 285 w 285"/>
                <a:gd name="T11" fmla="*/ 148 h 332"/>
                <a:gd name="T12" fmla="*/ 283 w 285"/>
                <a:gd name="T13" fmla="*/ 175 h 332"/>
                <a:gd name="T14" fmla="*/ 60 w 285"/>
                <a:gd name="T15" fmla="*/ 175 h 332"/>
                <a:gd name="T16" fmla="*/ 165 w 285"/>
                <a:gd name="T17" fmla="*/ 279 h 332"/>
                <a:gd name="T18" fmla="*/ 256 w 285"/>
                <a:gd name="T19" fmla="*/ 242 h 332"/>
                <a:gd name="T20" fmla="*/ 280 w 285"/>
                <a:gd name="T21" fmla="*/ 287 h 332"/>
                <a:gd name="T22" fmla="*/ 162 w 285"/>
                <a:gd name="T23" fmla="*/ 332 h 332"/>
                <a:gd name="T24" fmla="*/ 0 w 285"/>
                <a:gd name="T25" fmla="*/ 166 h 332"/>
                <a:gd name="T26" fmla="*/ 153 w 285"/>
                <a:gd name="T27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85" h="332">
                  <a:moveTo>
                    <a:pt x="225" y="129"/>
                  </a:moveTo>
                  <a:cubicBezTo>
                    <a:pt x="223" y="75"/>
                    <a:pt x="191" y="48"/>
                    <a:pt x="151" y="48"/>
                  </a:cubicBezTo>
                  <a:cubicBezTo>
                    <a:pt x="107" y="48"/>
                    <a:pt x="70" y="77"/>
                    <a:pt x="62" y="129"/>
                  </a:cubicBezTo>
                  <a:lnTo>
                    <a:pt x="225" y="129"/>
                  </a:lnTo>
                  <a:close/>
                  <a:moveTo>
                    <a:pt x="153" y="0"/>
                  </a:moveTo>
                  <a:cubicBezTo>
                    <a:pt x="239" y="0"/>
                    <a:pt x="285" y="66"/>
                    <a:pt x="285" y="148"/>
                  </a:cubicBezTo>
                  <a:cubicBezTo>
                    <a:pt x="285" y="156"/>
                    <a:pt x="283" y="175"/>
                    <a:pt x="283" y="175"/>
                  </a:cubicBezTo>
                  <a:cubicBezTo>
                    <a:pt x="60" y="175"/>
                    <a:pt x="60" y="175"/>
                    <a:pt x="60" y="175"/>
                  </a:cubicBezTo>
                  <a:cubicBezTo>
                    <a:pt x="63" y="244"/>
                    <a:pt x="111" y="279"/>
                    <a:pt x="165" y="279"/>
                  </a:cubicBezTo>
                  <a:cubicBezTo>
                    <a:pt x="218" y="279"/>
                    <a:pt x="256" y="242"/>
                    <a:pt x="256" y="242"/>
                  </a:cubicBezTo>
                  <a:cubicBezTo>
                    <a:pt x="280" y="287"/>
                    <a:pt x="280" y="287"/>
                    <a:pt x="280" y="287"/>
                  </a:cubicBezTo>
                  <a:cubicBezTo>
                    <a:pt x="280" y="287"/>
                    <a:pt x="235" y="332"/>
                    <a:pt x="162" y="332"/>
                  </a:cubicBezTo>
                  <a:cubicBezTo>
                    <a:pt x="65" y="332"/>
                    <a:pt x="0" y="260"/>
                    <a:pt x="0" y="166"/>
                  </a:cubicBezTo>
                  <a:cubicBezTo>
                    <a:pt x="0" y="65"/>
                    <a:pt x="65" y="0"/>
                    <a:pt x="153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50173989-5FDB-634F-A96D-F08DD912D7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29851" y="1906588"/>
              <a:ext cx="525463" cy="615950"/>
            </a:xfrm>
            <a:custGeom>
              <a:avLst/>
              <a:gdLst>
                <a:gd name="T0" fmla="*/ 0 w 277"/>
                <a:gd name="T1" fmla="*/ 8 h 324"/>
                <a:gd name="T2" fmla="*/ 57 w 277"/>
                <a:gd name="T3" fmla="*/ 8 h 324"/>
                <a:gd name="T4" fmla="*/ 57 w 277"/>
                <a:gd name="T5" fmla="*/ 50 h 324"/>
                <a:gd name="T6" fmla="*/ 56 w 277"/>
                <a:gd name="T7" fmla="*/ 73 h 324"/>
                <a:gd name="T8" fmla="*/ 57 w 277"/>
                <a:gd name="T9" fmla="*/ 73 h 324"/>
                <a:gd name="T10" fmla="*/ 172 w 277"/>
                <a:gd name="T11" fmla="*/ 0 h 324"/>
                <a:gd name="T12" fmla="*/ 277 w 277"/>
                <a:gd name="T13" fmla="*/ 122 h 324"/>
                <a:gd name="T14" fmla="*/ 277 w 277"/>
                <a:gd name="T15" fmla="*/ 324 h 324"/>
                <a:gd name="T16" fmla="*/ 218 w 277"/>
                <a:gd name="T17" fmla="*/ 324 h 324"/>
                <a:gd name="T18" fmla="*/ 218 w 277"/>
                <a:gd name="T19" fmla="*/ 135 h 324"/>
                <a:gd name="T20" fmla="*/ 160 w 277"/>
                <a:gd name="T21" fmla="*/ 56 h 324"/>
                <a:gd name="T22" fmla="*/ 63 w 277"/>
                <a:gd name="T23" fmla="*/ 133 h 324"/>
                <a:gd name="T24" fmla="*/ 59 w 277"/>
                <a:gd name="T25" fmla="*/ 176 h 324"/>
                <a:gd name="T26" fmla="*/ 59 w 277"/>
                <a:gd name="T27" fmla="*/ 324 h 324"/>
                <a:gd name="T28" fmla="*/ 0 w 277"/>
                <a:gd name="T29" fmla="*/ 324 h 324"/>
                <a:gd name="T30" fmla="*/ 0 w 277"/>
                <a:gd name="T31" fmla="*/ 8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77" h="324">
                  <a:moveTo>
                    <a:pt x="0" y="8"/>
                  </a:moveTo>
                  <a:cubicBezTo>
                    <a:pt x="57" y="8"/>
                    <a:pt x="57" y="8"/>
                    <a:pt x="57" y="8"/>
                  </a:cubicBezTo>
                  <a:cubicBezTo>
                    <a:pt x="57" y="50"/>
                    <a:pt x="57" y="50"/>
                    <a:pt x="57" y="50"/>
                  </a:cubicBezTo>
                  <a:cubicBezTo>
                    <a:pt x="57" y="62"/>
                    <a:pt x="56" y="73"/>
                    <a:pt x="56" y="73"/>
                  </a:cubicBezTo>
                  <a:cubicBezTo>
                    <a:pt x="57" y="73"/>
                    <a:pt x="57" y="73"/>
                    <a:pt x="57" y="73"/>
                  </a:cubicBezTo>
                  <a:cubicBezTo>
                    <a:pt x="69" y="45"/>
                    <a:pt x="105" y="0"/>
                    <a:pt x="172" y="0"/>
                  </a:cubicBezTo>
                  <a:cubicBezTo>
                    <a:pt x="244" y="0"/>
                    <a:pt x="277" y="41"/>
                    <a:pt x="277" y="122"/>
                  </a:cubicBezTo>
                  <a:cubicBezTo>
                    <a:pt x="277" y="324"/>
                    <a:pt x="277" y="324"/>
                    <a:pt x="277" y="324"/>
                  </a:cubicBezTo>
                  <a:cubicBezTo>
                    <a:pt x="218" y="324"/>
                    <a:pt x="218" y="324"/>
                    <a:pt x="218" y="324"/>
                  </a:cubicBezTo>
                  <a:cubicBezTo>
                    <a:pt x="218" y="135"/>
                    <a:pt x="218" y="135"/>
                    <a:pt x="218" y="135"/>
                  </a:cubicBezTo>
                  <a:cubicBezTo>
                    <a:pt x="218" y="91"/>
                    <a:pt x="209" y="56"/>
                    <a:pt x="160" y="56"/>
                  </a:cubicBezTo>
                  <a:cubicBezTo>
                    <a:pt x="114" y="56"/>
                    <a:pt x="76" y="88"/>
                    <a:pt x="63" y="133"/>
                  </a:cubicBezTo>
                  <a:cubicBezTo>
                    <a:pt x="60" y="146"/>
                    <a:pt x="59" y="160"/>
                    <a:pt x="59" y="176"/>
                  </a:cubicBezTo>
                  <a:cubicBezTo>
                    <a:pt x="59" y="324"/>
                    <a:pt x="59" y="324"/>
                    <a:pt x="59" y="324"/>
                  </a:cubicBezTo>
                  <a:cubicBezTo>
                    <a:pt x="0" y="324"/>
                    <a:pt x="0" y="324"/>
                    <a:pt x="0" y="324"/>
                  </a:cubicBezTo>
                  <a:lnTo>
                    <a:pt x="0" y="8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4CC31D51-26ED-D741-B326-C6F6C4B537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39451" y="1906588"/>
              <a:ext cx="542925" cy="631825"/>
            </a:xfrm>
            <a:custGeom>
              <a:avLst/>
              <a:gdLst>
                <a:gd name="T0" fmla="*/ 164 w 286"/>
                <a:gd name="T1" fmla="*/ 0 h 332"/>
                <a:gd name="T2" fmla="*/ 279 w 286"/>
                <a:gd name="T3" fmla="*/ 46 h 332"/>
                <a:gd name="T4" fmla="*/ 251 w 286"/>
                <a:gd name="T5" fmla="*/ 89 h 332"/>
                <a:gd name="T6" fmla="*/ 166 w 286"/>
                <a:gd name="T7" fmla="*/ 53 h 332"/>
                <a:gd name="T8" fmla="*/ 60 w 286"/>
                <a:gd name="T9" fmla="*/ 165 h 332"/>
                <a:gd name="T10" fmla="*/ 168 w 286"/>
                <a:gd name="T11" fmla="*/ 279 h 332"/>
                <a:gd name="T12" fmla="*/ 263 w 286"/>
                <a:gd name="T13" fmla="*/ 237 h 332"/>
                <a:gd name="T14" fmla="*/ 286 w 286"/>
                <a:gd name="T15" fmla="*/ 281 h 332"/>
                <a:gd name="T16" fmla="*/ 164 w 286"/>
                <a:gd name="T17" fmla="*/ 332 h 332"/>
                <a:gd name="T18" fmla="*/ 0 w 286"/>
                <a:gd name="T19" fmla="*/ 166 h 332"/>
                <a:gd name="T20" fmla="*/ 164 w 286"/>
                <a:gd name="T21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286" h="332">
                  <a:moveTo>
                    <a:pt x="164" y="0"/>
                  </a:moveTo>
                  <a:cubicBezTo>
                    <a:pt x="241" y="0"/>
                    <a:pt x="279" y="46"/>
                    <a:pt x="279" y="46"/>
                  </a:cubicBezTo>
                  <a:cubicBezTo>
                    <a:pt x="251" y="89"/>
                    <a:pt x="251" y="89"/>
                    <a:pt x="251" y="89"/>
                  </a:cubicBezTo>
                  <a:cubicBezTo>
                    <a:pt x="251" y="89"/>
                    <a:pt x="218" y="53"/>
                    <a:pt x="166" y="53"/>
                  </a:cubicBezTo>
                  <a:cubicBezTo>
                    <a:pt x="105" y="53"/>
                    <a:pt x="60" y="100"/>
                    <a:pt x="60" y="165"/>
                  </a:cubicBezTo>
                  <a:cubicBezTo>
                    <a:pt x="60" y="230"/>
                    <a:pt x="105" y="279"/>
                    <a:pt x="168" y="279"/>
                  </a:cubicBezTo>
                  <a:cubicBezTo>
                    <a:pt x="225" y="279"/>
                    <a:pt x="263" y="237"/>
                    <a:pt x="263" y="237"/>
                  </a:cubicBezTo>
                  <a:cubicBezTo>
                    <a:pt x="286" y="281"/>
                    <a:pt x="286" y="281"/>
                    <a:pt x="286" y="281"/>
                  </a:cubicBezTo>
                  <a:cubicBezTo>
                    <a:pt x="286" y="281"/>
                    <a:pt x="244" y="332"/>
                    <a:pt x="164" y="332"/>
                  </a:cubicBezTo>
                  <a:cubicBezTo>
                    <a:pt x="68" y="332"/>
                    <a:pt x="0" y="261"/>
                    <a:pt x="0" y="166"/>
                  </a:cubicBezTo>
                  <a:cubicBezTo>
                    <a:pt x="0" y="72"/>
                    <a:pt x="68" y="0"/>
                    <a:pt x="164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3E0F7171-006D-8341-8A15-A0D155D4DB2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409363" y="1906588"/>
              <a:ext cx="541338" cy="631825"/>
            </a:xfrm>
            <a:custGeom>
              <a:avLst/>
              <a:gdLst>
                <a:gd name="T0" fmla="*/ 225 w 285"/>
                <a:gd name="T1" fmla="*/ 129 h 332"/>
                <a:gd name="T2" fmla="*/ 152 w 285"/>
                <a:gd name="T3" fmla="*/ 48 h 332"/>
                <a:gd name="T4" fmla="*/ 62 w 285"/>
                <a:gd name="T5" fmla="*/ 129 h 332"/>
                <a:gd name="T6" fmla="*/ 225 w 285"/>
                <a:gd name="T7" fmla="*/ 129 h 332"/>
                <a:gd name="T8" fmla="*/ 153 w 285"/>
                <a:gd name="T9" fmla="*/ 0 h 332"/>
                <a:gd name="T10" fmla="*/ 285 w 285"/>
                <a:gd name="T11" fmla="*/ 148 h 332"/>
                <a:gd name="T12" fmla="*/ 284 w 285"/>
                <a:gd name="T13" fmla="*/ 175 h 332"/>
                <a:gd name="T14" fmla="*/ 60 w 285"/>
                <a:gd name="T15" fmla="*/ 175 h 332"/>
                <a:gd name="T16" fmla="*/ 166 w 285"/>
                <a:gd name="T17" fmla="*/ 279 h 332"/>
                <a:gd name="T18" fmla="*/ 256 w 285"/>
                <a:gd name="T19" fmla="*/ 242 h 332"/>
                <a:gd name="T20" fmla="*/ 281 w 285"/>
                <a:gd name="T21" fmla="*/ 287 h 332"/>
                <a:gd name="T22" fmla="*/ 162 w 285"/>
                <a:gd name="T23" fmla="*/ 332 h 332"/>
                <a:gd name="T24" fmla="*/ 0 w 285"/>
                <a:gd name="T25" fmla="*/ 166 h 332"/>
                <a:gd name="T26" fmla="*/ 153 w 285"/>
                <a:gd name="T27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85" h="332">
                  <a:moveTo>
                    <a:pt x="225" y="129"/>
                  </a:moveTo>
                  <a:cubicBezTo>
                    <a:pt x="224" y="75"/>
                    <a:pt x="191" y="48"/>
                    <a:pt x="152" y="48"/>
                  </a:cubicBezTo>
                  <a:cubicBezTo>
                    <a:pt x="107" y="48"/>
                    <a:pt x="71" y="77"/>
                    <a:pt x="62" y="129"/>
                  </a:cubicBezTo>
                  <a:lnTo>
                    <a:pt x="225" y="129"/>
                  </a:lnTo>
                  <a:close/>
                  <a:moveTo>
                    <a:pt x="153" y="0"/>
                  </a:moveTo>
                  <a:cubicBezTo>
                    <a:pt x="239" y="0"/>
                    <a:pt x="285" y="66"/>
                    <a:pt x="285" y="148"/>
                  </a:cubicBezTo>
                  <a:cubicBezTo>
                    <a:pt x="285" y="156"/>
                    <a:pt x="284" y="175"/>
                    <a:pt x="284" y="175"/>
                  </a:cubicBezTo>
                  <a:cubicBezTo>
                    <a:pt x="60" y="175"/>
                    <a:pt x="60" y="175"/>
                    <a:pt x="60" y="175"/>
                  </a:cubicBezTo>
                  <a:cubicBezTo>
                    <a:pt x="63" y="244"/>
                    <a:pt x="111" y="279"/>
                    <a:pt x="166" y="279"/>
                  </a:cubicBezTo>
                  <a:cubicBezTo>
                    <a:pt x="218" y="279"/>
                    <a:pt x="256" y="242"/>
                    <a:pt x="256" y="242"/>
                  </a:cubicBezTo>
                  <a:cubicBezTo>
                    <a:pt x="281" y="287"/>
                    <a:pt x="281" y="287"/>
                    <a:pt x="281" y="287"/>
                  </a:cubicBezTo>
                  <a:cubicBezTo>
                    <a:pt x="281" y="287"/>
                    <a:pt x="235" y="332"/>
                    <a:pt x="162" y="332"/>
                  </a:cubicBezTo>
                  <a:cubicBezTo>
                    <a:pt x="66" y="332"/>
                    <a:pt x="0" y="260"/>
                    <a:pt x="0" y="166"/>
                  </a:cubicBezTo>
                  <a:cubicBezTo>
                    <a:pt x="0" y="65"/>
                    <a:pt x="66" y="0"/>
                    <a:pt x="153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A0F74615-2584-7846-9F1F-D25B1552C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44363" y="2401888"/>
              <a:ext cx="117475" cy="120650"/>
            </a:xfrm>
            <a:prstGeom prst="rect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0"/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5CAA4F8F-E996-B147-87AD-875344BC224A}"/>
              </a:ext>
            </a:extLst>
          </p:cNvPr>
          <p:cNvGrpSpPr/>
          <p:nvPr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4BD0580-69B4-F34E-8311-1911C864A523}"/>
                </a:ext>
              </a:extLst>
            </p:cNvPr>
            <p:cNvSpPr txBox="1"/>
            <p:nvPr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5DC71938-0B18-FF49-AB6E-0A1E9E1936D2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E581B04C-6E0C-7646-907B-615E7E17093A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" name="Freeform 5">
            <a:extLst>
              <a:ext uri="{FF2B5EF4-FFF2-40B4-BE49-F238E27FC236}">
                <a16:creationId xmlns:a16="http://schemas.microsoft.com/office/drawing/2014/main" id="{D35013EA-8F1C-B648-8834-E618C821201D}"/>
              </a:ext>
            </a:extLst>
          </p:cNvPr>
          <p:cNvSpPr>
            <a:spLocks/>
          </p:cNvSpPr>
          <p:nvPr userDrawn="1"/>
        </p:nvSpPr>
        <p:spPr bwMode="auto">
          <a:xfrm flipH="1">
            <a:off x="1393" y="2234871"/>
            <a:ext cx="4578350" cy="4622935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C9B1E07-5CFC-E84C-BF61-CAD19D8A0185}"/>
              </a:ext>
            </a:extLst>
          </p:cNvPr>
          <p:cNvSpPr txBox="1"/>
          <p:nvPr userDrawn="1"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145A7A15-11D8-D142-A180-53697E13CFA8}"/>
              </a:ext>
            </a:extLst>
          </p:cNvPr>
          <p:cNvGrpSpPr/>
          <p:nvPr userDrawn="1"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617D4F3D-B2C7-4A45-A62F-012D39F40B45}"/>
                </a:ext>
              </a:extLst>
            </p:cNvPr>
            <p:cNvSpPr txBox="1"/>
            <p:nvPr userDrawn="1"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7C83294B-A11A-7D4D-9E0E-B05053C63C00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A3B427D0-EA25-0F41-862E-0E2FB898A5EF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2" name="Graphic 111">
            <a:extLst>
              <a:ext uri="{FF2B5EF4-FFF2-40B4-BE49-F238E27FC236}">
                <a16:creationId xmlns:a16="http://schemas.microsoft.com/office/drawing/2014/main" id="{27785070-3913-2E47-A65B-E287C1C0976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70163" y="6213912"/>
            <a:ext cx="1996068" cy="644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6758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vider w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50987" y="1666239"/>
            <a:ext cx="5114597" cy="867930"/>
          </a:xfrm>
        </p:spPr>
        <p:txBody>
          <a:bodyPr wrap="square" anchor="b">
            <a:sp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9EA25FCE-E0FB-6746-8D6E-F7317D200228}"/>
              </a:ext>
            </a:extLst>
          </p:cNvPr>
          <p:cNvGrpSpPr/>
          <p:nvPr/>
        </p:nvGrpSpPr>
        <p:grpSpPr>
          <a:xfrm>
            <a:off x="6057785" y="3509736"/>
            <a:ext cx="593202" cy="975172"/>
            <a:chOff x="6110794" y="3712667"/>
            <a:chExt cx="604094" cy="1022367"/>
          </a:xfrm>
        </p:grpSpPr>
        <p:sp>
          <p:nvSpPr>
            <p:cNvPr id="9" name="Freeform 5">
              <a:extLst>
                <a:ext uri="{FF2B5EF4-FFF2-40B4-BE49-F238E27FC236}">
                  <a16:creationId xmlns:a16="http://schemas.microsoft.com/office/drawing/2014/main" id="{C1D28AFC-691E-A84B-B253-C2E6EBA96530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Freeform 6">
              <a:extLst>
                <a:ext uri="{FF2B5EF4-FFF2-40B4-BE49-F238E27FC236}">
                  <a16:creationId xmlns:a16="http://schemas.microsoft.com/office/drawing/2014/main" id="{1E53D310-7F49-8844-B536-B5E23035A4A3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Freeform 7">
              <a:extLst>
                <a:ext uri="{FF2B5EF4-FFF2-40B4-BE49-F238E27FC236}">
                  <a16:creationId xmlns:a16="http://schemas.microsoft.com/office/drawing/2014/main" id="{B948D674-5FC9-6A41-9EBC-CBD09BFC8C4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Freeform 10">
              <a:extLst>
                <a:ext uri="{FF2B5EF4-FFF2-40B4-BE49-F238E27FC236}">
                  <a16:creationId xmlns:a16="http://schemas.microsoft.com/office/drawing/2014/main" id="{1E5203ED-D85F-4F49-9880-D662420577BD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Freeform 11">
              <a:extLst>
                <a:ext uri="{FF2B5EF4-FFF2-40B4-BE49-F238E27FC236}">
                  <a16:creationId xmlns:a16="http://schemas.microsoft.com/office/drawing/2014/main" id="{7C4A71DB-93FE-B249-B34A-606A82475D3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Freeform 12">
              <a:extLst>
                <a:ext uri="{FF2B5EF4-FFF2-40B4-BE49-F238E27FC236}">
                  <a16:creationId xmlns:a16="http://schemas.microsoft.com/office/drawing/2014/main" id="{2AE16C31-BDC5-E344-9877-FCA28EF4F5E3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Freeform 15">
              <a:extLst>
                <a:ext uri="{FF2B5EF4-FFF2-40B4-BE49-F238E27FC236}">
                  <a16:creationId xmlns:a16="http://schemas.microsoft.com/office/drawing/2014/main" id="{66503F38-0FFA-A04B-922D-26BE538F6E02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id="{DEA12EF2-91CC-8D42-9823-B16D528E2A03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F2D2D9EB-7B28-FF47-A08A-0B38EE5FA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Freeform 20">
              <a:extLst>
                <a:ext uri="{FF2B5EF4-FFF2-40B4-BE49-F238E27FC236}">
                  <a16:creationId xmlns:a16="http://schemas.microsoft.com/office/drawing/2014/main" id="{12031F8B-BF64-2B49-9A2C-56AC025F4A21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Freeform 21">
              <a:extLst>
                <a:ext uri="{FF2B5EF4-FFF2-40B4-BE49-F238E27FC236}">
                  <a16:creationId xmlns:a16="http://schemas.microsoft.com/office/drawing/2014/main" id="{6B3B3596-2B68-104A-B352-2C13698369CF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Freeform 22">
              <a:extLst>
                <a:ext uri="{FF2B5EF4-FFF2-40B4-BE49-F238E27FC236}">
                  <a16:creationId xmlns:a16="http://schemas.microsoft.com/office/drawing/2014/main" id="{869C5B73-3D9B-8347-8913-120A3BA9937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Freeform 25">
              <a:extLst>
                <a:ext uri="{FF2B5EF4-FFF2-40B4-BE49-F238E27FC236}">
                  <a16:creationId xmlns:a16="http://schemas.microsoft.com/office/drawing/2014/main" id="{31B97D44-E645-4647-9566-C5212128CF97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Freeform 26">
              <a:extLst>
                <a:ext uri="{FF2B5EF4-FFF2-40B4-BE49-F238E27FC236}">
                  <a16:creationId xmlns:a16="http://schemas.microsoft.com/office/drawing/2014/main" id="{2F2EA29D-1801-4B4D-9110-F5D4C9514F35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Freeform 27">
              <a:extLst>
                <a:ext uri="{FF2B5EF4-FFF2-40B4-BE49-F238E27FC236}">
                  <a16:creationId xmlns:a16="http://schemas.microsoft.com/office/drawing/2014/main" id="{4D01950D-2B09-2945-80E1-9A85F78BDE5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24" name="Picture Placeholder 38">
            <a:extLst>
              <a:ext uri="{FF2B5EF4-FFF2-40B4-BE49-F238E27FC236}">
                <a16:creationId xmlns:a16="http://schemas.microsoft.com/office/drawing/2014/main" id="{3AD6F89A-BE59-3D46-8D99-972CD940DFD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07988" y="341032"/>
            <a:ext cx="5640448" cy="5761038"/>
          </a:xfrm>
          <a:custGeom>
            <a:avLst/>
            <a:gdLst>
              <a:gd name="connsiteX0" fmla="*/ 5334786 w 5723503"/>
              <a:gd name="connsiteY0" fmla="*/ 4202324 h 6079105"/>
              <a:gd name="connsiteX1" fmla="*/ 5477176 w 5723503"/>
              <a:gd name="connsiteY1" fmla="*/ 4202324 h 6079105"/>
              <a:gd name="connsiteX2" fmla="*/ 5477176 w 5723503"/>
              <a:gd name="connsiteY2" fmla="*/ 4342372 h 6079105"/>
              <a:gd name="connsiteX3" fmla="*/ 5334786 w 5723503"/>
              <a:gd name="connsiteY3" fmla="*/ 4202324 h 6079105"/>
              <a:gd name="connsiteX4" fmla="*/ 5549767 w 5723503"/>
              <a:gd name="connsiteY4" fmla="*/ 4201562 h 6079105"/>
              <a:gd name="connsiteX5" fmla="*/ 5692157 w 5723503"/>
              <a:gd name="connsiteY5" fmla="*/ 4201562 h 6079105"/>
              <a:gd name="connsiteX6" fmla="*/ 5692157 w 5723503"/>
              <a:gd name="connsiteY6" fmla="*/ 4341546 h 6079105"/>
              <a:gd name="connsiteX7" fmla="*/ 5549767 w 5723503"/>
              <a:gd name="connsiteY7" fmla="*/ 4201562 h 6079105"/>
              <a:gd name="connsiteX8" fmla="*/ 5305408 w 5723503"/>
              <a:gd name="connsiteY8" fmla="*/ 4195979 h 6079105"/>
              <a:gd name="connsiteX9" fmla="*/ 5304901 w 5723503"/>
              <a:gd name="connsiteY9" fmla="*/ 4202324 h 6079105"/>
              <a:gd name="connsiteX10" fmla="*/ 5476923 w 5723503"/>
              <a:gd name="connsiteY10" fmla="*/ 4370991 h 6079105"/>
              <a:gd name="connsiteX11" fmla="*/ 5483269 w 5723503"/>
              <a:gd name="connsiteY11" fmla="*/ 4370483 h 6079105"/>
              <a:gd name="connsiteX12" fmla="*/ 5483078 w 5723503"/>
              <a:gd name="connsiteY12" fmla="*/ 4195979 h 6079105"/>
              <a:gd name="connsiteX13" fmla="*/ 5520960 w 5723503"/>
              <a:gd name="connsiteY13" fmla="*/ 4195154 h 6079105"/>
              <a:gd name="connsiteX14" fmla="*/ 5520452 w 5723503"/>
              <a:gd name="connsiteY14" fmla="*/ 4201499 h 6079105"/>
              <a:gd name="connsiteX15" fmla="*/ 5691904 w 5723503"/>
              <a:gd name="connsiteY15" fmla="*/ 4370230 h 6079105"/>
              <a:gd name="connsiteX16" fmla="*/ 5698249 w 5723503"/>
              <a:gd name="connsiteY16" fmla="*/ 4369785 h 6079105"/>
              <a:gd name="connsiteX17" fmla="*/ 5698630 w 5723503"/>
              <a:gd name="connsiteY17" fmla="*/ 4195154 h 6079105"/>
              <a:gd name="connsiteX18" fmla="*/ 5333264 w 5723503"/>
              <a:gd name="connsiteY18" fmla="*/ 3985811 h 6079105"/>
              <a:gd name="connsiteX19" fmla="*/ 5475654 w 5723503"/>
              <a:gd name="connsiteY19" fmla="*/ 3985811 h 6079105"/>
              <a:gd name="connsiteX20" fmla="*/ 5475654 w 5723503"/>
              <a:gd name="connsiteY20" fmla="*/ 4125795 h 6079105"/>
              <a:gd name="connsiteX21" fmla="*/ 5333264 w 5723503"/>
              <a:gd name="connsiteY21" fmla="*/ 3985811 h 6079105"/>
              <a:gd name="connsiteX22" fmla="*/ 5548181 w 5723503"/>
              <a:gd name="connsiteY22" fmla="*/ 3985050 h 6079105"/>
              <a:gd name="connsiteX23" fmla="*/ 5690571 w 5723503"/>
              <a:gd name="connsiteY23" fmla="*/ 3985050 h 6079105"/>
              <a:gd name="connsiteX24" fmla="*/ 5690571 w 5723503"/>
              <a:gd name="connsiteY24" fmla="*/ 4124971 h 6079105"/>
              <a:gd name="connsiteX25" fmla="*/ 5548181 w 5723503"/>
              <a:gd name="connsiteY25" fmla="*/ 3985050 h 6079105"/>
              <a:gd name="connsiteX26" fmla="*/ 5303885 w 5723503"/>
              <a:gd name="connsiteY26" fmla="*/ 3979466 h 6079105"/>
              <a:gd name="connsiteX27" fmla="*/ 5303251 w 5723503"/>
              <a:gd name="connsiteY27" fmla="*/ 3985748 h 6079105"/>
              <a:gd name="connsiteX28" fmla="*/ 5475210 w 5723503"/>
              <a:gd name="connsiteY28" fmla="*/ 4154415 h 6079105"/>
              <a:gd name="connsiteX29" fmla="*/ 5481555 w 5723503"/>
              <a:gd name="connsiteY29" fmla="*/ 4153971 h 6079105"/>
              <a:gd name="connsiteX30" fmla="*/ 5481555 w 5723503"/>
              <a:gd name="connsiteY30" fmla="*/ 3979466 h 6079105"/>
              <a:gd name="connsiteX31" fmla="*/ 5518866 w 5723503"/>
              <a:gd name="connsiteY31" fmla="*/ 3978705 h 6079105"/>
              <a:gd name="connsiteX32" fmla="*/ 5518612 w 5723503"/>
              <a:gd name="connsiteY32" fmla="*/ 3985050 h 6079105"/>
              <a:gd name="connsiteX33" fmla="*/ 5690190 w 5723503"/>
              <a:gd name="connsiteY33" fmla="*/ 4153717 h 6079105"/>
              <a:gd name="connsiteX34" fmla="*/ 5696536 w 5723503"/>
              <a:gd name="connsiteY34" fmla="*/ 4153209 h 6079105"/>
              <a:gd name="connsiteX35" fmla="*/ 5696536 w 5723503"/>
              <a:gd name="connsiteY35" fmla="*/ 3978705 h 6079105"/>
              <a:gd name="connsiteX36" fmla="*/ 5336436 w 5723503"/>
              <a:gd name="connsiteY36" fmla="*/ 3771646 h 6079105"/>
              <a:gd name="connsiteX37" fmla="*/ 5478762 w 5723503"/>
              <a:gd name="connsiteY37" fmla="*/ 3771646 h 6079105"/>
              <a:gd name="connsiteX38" fmla="*/ 5478762 w 5723503"/>
              <a:gd name="connsiteY38" fmla="*/ 3911694 h 6079105"/>
              <a:gd name="connsiteX39" fmla="*/ 5336436 w 5723503"/>
              <a:gd name="connsiteY39" fmla="*/ 3771646 h 6079105"/>
              <a:gd name="connsiteX40" fmla="*/ 5551353 w 5723503"/>
              <a:gd name="connsiteY40" fmla="*/ 3770821 h 6079105"/>
              <a:gd name="connsiteX41" fmla="*/ 5693743 w 5723503"/>
              <a:gd name="connsiteY41" fmla="*/ 3770821 h 6079105"/>
              <a:gd name="connsiteX42" fmla="*/ 5693743 w 5723503"/>
              <a:gd name="connsiteY42" fmla="*/ 3910869 h 6079105"/>
              <a:gd name="connsiteX43" fmla="*/ 5551353 w 5723503"/>
              <a:gd name="connsiteY43" fmla="*/ 3770821 h 6079105"/>
              <a:gd name="connsiteX44" fmla="*/ 5306995 w 5723503"/>
              <a:gd name="connsiteY44" fmla="*/ 3765301 h 6079105"/>
              <a:gd name="connsiteX45" fmla="*/ 5306487 w 5723503"/>
              <a:gd name="connsiteY45" fmla="*/ 3771647 h 6079105"/>
              <a:gd name="connsiteX46" fmla="*/ 5478509 w 5723503"/>
              <a:gd name="connsiteY46" fmla="*/ 3940314 h 6079105"/>
              <a:gd name="connsiteX47" fmla="*/ 5484855 w 5723503"/>
              <a:gd name="connsiteY47" fmla="*/ 3939806 h 6079105"/>
              <a:gd name="connsiteX48" fmla="*/ 5484664 w 5723503"/>
              <a:gd name="connsiteY48" fmla="*/ 3765301 h 6079105"/>
              <a:gd name="connsiteX49" fmla="*/ 5521975 w 5723503"/>
              <a:gd name="connsiteY49" fmla="*/ 3764540 h 6079105"/>
              <a:gd name="connsiteX50" fmla="*/ 5521531 w 5723503"/>
              <a:gd name="connsiteY50" fmla="*/ 3770885 h 6079105"/>
              <a:gd name="connsiteX51" fmla="*/ 5693490 w 5723503"/>
              <a:gd name="connsiteY51" fmla="*/ 3939552 h 6079105"/>
              <a:gd name="connsiteX52" fmla="*/ 5699835 w 5723503"/>
              <a:gd name="connsiteY52" fmla="*/ 3939044 h 6079105"/>
              <a:gd name="connsiteX53" fmla="*/ 5699645 w 5723503"/>
              <a:gd name="connsiteY53" fmla="*/ 3764540 h 6079105"/>
              <a:gd name="connsiteX54" fmla="*/ 5334786 w 5723503"/>
              <a:gd name="connsiteY54" fmla="*/ 3555070 h 6079105"/>
              <a:gd name="connsiteX55" fmla="*/ 5477176 w 5723503"/>
              <a:gd name="connsiteY55" fmla="*/ 3555070 h 6079105"/>
              <a:gd name="connsiteX56" fmla="*/ 5477176 w 5723503"/>
              <a:gd name="connsiteY56" fmla="*/ 3695118 h 6079105"/>
              <a:gd name="connsiteX57" fmla="*/ 5334786 w 5723503"/>
              <a:gd name="connsiteY57" fmla="*/ 3555070 h 6079105"/>
              <a:gd name="connsiteX58" fmla="*/ 5549767 w 5723503"/>
              <a:gd name="connsiteY58" fmla="*/ 3554309 h 6079105"/>
              <a:gd name="connsiteX59" fmla="*/ 5692157 w 5723503"/>
              <a:gd name="connsiteY59" fmla="*/ 3554309 h 6079105"/>
              <a:gd name="connsiteX60" fmla="*/ 5692157 w 5723503"/>
              <a:gd name="connsiteY60" fmla="*/ 3694293 h 6079105"/>
              <a:gd name="connsiteX61" fmla="*/ 5549767 w 5723503"/>
              <a:gd name="connsiteY61" fmla="*/ 3554309 h 6079105"/>
              <a:gd name="connsiteX62" fmla="*/ 5305472 w 5723503"/>
              <a:gd name="connsiteY62" fmla="*/ 3548725 h 6079105"/>
              <a:gd name="connsiteX63" fmla="*/ 5304774 w 5723503"/>
              <a:gd name="connsiteY63" fmla="*/ 3555071 h 6079105"/>
              <a:gd name="connsiteX64" fmla="*/ 5476796 w 5723503"/>
              <a:gd name="connsiteY64" fmla="*/ 3723738 h 6079105"/>
              <a:gd name="connsiteX65" fmla="*/ 5483141 w 5723503"/>
              <a:gd name="connsiteY65" fmla="*/ 3723230 h 6079105"/>
              <a:gd name="connsiteX66" fmla="*/ 5483141 w 5723503"/>
              <a:gd name="connsiteY66" fmla="*/ 3548725 h 6079105"/>
              <a:gd name="connsiteX67" fmla="*/ 5520452 w 5723503"/>
              <a:gd name="connsiteY67" fmla="*/ 3547964 h 6079105"/>
              <a:gd name="connsiteX68" fmla="*/ 5520452 w 5723503"/>
              <a:gd name="connsiteY68" fmla="*/ 3554246 h 6079105"/>
              <a:gd name="connsiteX69" fmla="*/ 5691777 w 5723503"/>
              <a:gd name="connsiteY69" fmla="*/ 3722913 h 6079105"/>
              <a:gd name="connsiteX70" fmla="*/ 5698122 w 5723503"/>
              <a:gd name="connsiteY70" fmla="*/ 3722468 h 6079105"/>
              <a:gd name="connsiteX71" fmla="*/ 5698122 w 5723503"/>
              <a:gd name="connsiteY71" fmla="*/ 3547964 h 6079105"/>
              <a:gd name="connsiteX72" fmla="*/ 5337959 w 5723503"/>
              <a:gd name="connsiteY72" fmla="*/ 3340969 h 6079105"/>
              <a:gd name="connsiteX73" fmla="*/ 5480349 w 5723503"/>
              <a:gd name="connsiteY73" fmla="*/ 3340969 h 6079105"/>
              <a:gd name="connsiteX74" fmla="*/ 5480349 w 5723503"/>
              <a:gd name="connsiteY74" fmla="*/ 3480953 h 6079105"/>
              <a:gd name="connsiteX75" fmla="*/ 5337959 w 5723503"/>
              <a:gd name="connsiteY75" fmla="*/ 3340969 h 6079105"/>
              <a:gd name="connsiteX76" fmla="*/ 5552876 w 5723503"/>
              <a:gd name="connsiteY76" fmla="*/ 3340144 h 6079105"/>
              <a:gd name="connsiteX77" fmla="*/ 5695266 w 5723503"/>
              <a:gd name="connsiteY77" fmla="*/ 3340144 h 6079105"/>
              <a:gd name="connsiteX78" fmla="*/ 5695266 w 5723503"/>
              <a:gd name="connsiteY78" fmla="*/ 3480192 h 6079105"/>
              <a:gd name="connsiteX79" fmla="*/ 5552876 w 5723503"/>
              <a:gd name="connsiteY79" fmla="*/ 3340144 h 6079105"/>
              <a:gd name="connsiteX80" fmla="*/ 5308581 w 5723503"/>
              <a:gd name="connsiteY80" fmla="*/ 3334560 h 6079105"/>
              <a:gd name="connsiteX81" fmla="*/ 5308137 w 5723503"/>
              <a:gd name="connsiteY81" fmla="*/ 3340906 h 6079105"/>
              <a:gd name="connsiteX82" fmla="*/ 5480096 w 5723503"/>
              <a:gd name="connsiteY82" fmla="*/ 3509636 h 6079105"/>
              <a:gd name="connsiteX83" fmla="*/ 5486441 w 5723503"/>
              <a:gd name="connsiteY83" fmla="*/ 3509129 h 6079105"/>
              <a:gd name="connsiteX84" fmla="*/ 5486251 w 5723503"/>
              <a:gd name="connsiteY84" fmla="*/ 3334560 h 6079105"/>
              <a:gd name="connsiteX85" fmla="*/ 5523498 w 5723503"/>
              <a:gd name="connsiteY85" fmla="*/ 3333863 h 6079105"/>
              <a:gd name="connsiteX86" fmla="*/ 5522990 w 5723503"/>
              <a:gd name="connsiteY86" fmla="*/ 3340208 h 6079105"/>
              <a:gd name="connsiteX87" fmla="*/ 5695013 w 5723503"/>
              <a:gd name="connsiteY87" fmla="*/ 3508875 h 6079105"/>
              <a:gd name="connsiteX88" fmla="*/ 5701358 w 5723503"/>
              <a:gd name="connsiteY88" fmla="*/ 3508367 h 6079105"/>
              <a:gd name="connsiteX89" fmla="*/ 5701168 w 5723503"/>
              <a:gd name="connsiteY89" fmla="*/ 3333863 h 6079105"/>
              <a:gd name="connsiteX90" fmla="*/ 0 w 5723503"/>
              <a:gd name="connsiteY90" fmla="*/ 0 h 6079105"/>
              <a:gd name="connsiteX91" fmla="*/ 5723503 w 5723503"/>
              <a:gd name="connsiteY91" fmla="*/ 0 h 6079105"/>
              <a:gd name="connsiteX92" fmla="*/ 5723503 w 5723503"/>
              <a:gd name="connsiteY92" fmla="*/ 6079105 h 6079105"/>
              <a:gd name="connsiteX93" fmla="*/ 0 w 5723503"/>
              <a:gd name="connsiteY93" fmla="*/ 6079105 h 60791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</a:cxnLst>
            <a:rect l="l" t="t" r="r" b="b"/>
            <a:pathLst>
              <a:path w="5723503" h="6079105">
                <a:moveTo>
                  <a:pt x="5334786" y="4202324"/>
                </a:moveTo>
                <a:lnTo>
                  <a:pt x="5477176" y="4202324"/>
                </a:lnTo>
                <a:lnTo>
                  <a:pt x="5477176" y="4342372"/>
                </a:lnTo>
                <a:cubicBezTo>
                  <a:pt x="5456465" y="4274603"/>
                  <a:pt x="5402887" y="4221906"/>
                  <a:pt x="5334786" y="4202324"/>
                </a:cubicBezTo>
                <a:close/>
                <a:moveTo>
                  <a:pt x="5549767" y="4201562"/>
                </a:moveTo>
                <a:lnTo>
                  <a:pt x="5692157" y="4201562"/>
                </a:lnTo>
                <a:lnTo>
                  <a:pt x="5692157" y="4341546"/>
                </a:lnTo>
                <a:cubicBezTo>
                  <a:pt x="5671489" y="4273764"/>
                  <a:pt x="5617889" y="4221069"/>
                  <a:pt x="5549767" y="4201562"/>
                </a:cubicBezTo>
                <a:close/>
                <a:moveTo>
                  <a:pt x="5305408" y="4195979"/>
                </a:moveTo>
                <a:lnTo>
                  <a:pt x="5304901" y="4202324"/>
                </a:lnTo>
                <a:cubicBezTo>
                  <a:pt x="5393001" y="4214782"/>
                  <a:pt x="5462729" y="4283150"/>
                  <a:pt x="5476923" y="4370991"/>
                </a:cubicBezTo>
                <a:lnTo>
                  <a:pt x="5483269" y="4370483"/>
                </a:lnTo>
                <a:lnTo>
                  <a:pt x="5483078" y="4195979"/>
                </a:lnTo>
                <a:close/>
                <a:moveTo>
                  <a:pt x="5520960" y="4195154"/>
                </a:moveTo>
                <a:lnTo>
                  <a:pt x="5520452" y="4201499"/>
                </a:lnTo>
                <a:cubicBezTo>
                  <a:pt x="5608351" y="4214194"/>
                  <a:pt x="5677801" y="4282542"/>
                  <a:pt x="5691904" y="4370230"/>
                </a:cubicBezTo>
                <a:lnTo>
                  <a:pt x="5698249" y="4369785"/>
                </a:lnTo>
                <a:lnTo>
                  <a:pt x="5698630" y="4195154"/>
                </a:lnTo>
                <a:close/>
                <a:moveTo>
                  <a:pt x="5333264" y="3985811"/>
                </a:moveTo>
                <a:lnTo>
                  <a:pt x="5475654" y="3985811"/>
                </a:lnTo>
                <a:lnTo>
                  <a:pt x="5475654" y="4125795"/>
                </a:lnTo>
                <a:cubicBezTo>
                  <a:pt x="5454986" y="4058013"/>
                  <a:pt x="5401386" y="4005318"/>
                  <a:pt x="5333264" y="3985811"/>
                </a:cubicBezTo>
                <a:close/>
                <a:moveTo>
                  <a:pt x="5548181" y="3985050"/>
                </a:moveTo>
                <a:lnTo>
                  <a:pt x="5690571" y="3985050"/>
                </a:lnTo>
                <a:lnTo>
                  <a:pt x="5690571" y="4124971"/>
                </a:lnTo>
                <a:cubicBezTo>
                  <a:pt x="5669824" y="4057251"/>
                  <a:pt x="5616252" y="4004608"/>
                  <a:pt x="5548181" y="3985050"/>
                </a:cubicBezTo>
                <a:close/>
                <a:moveTo>
                  <a:pt x="5303885" y="3979466"/>
                </a:moveTo>
                <a:lnTo>
                  <a:pt x="5303251" y="3985748"/>
                </a:lnTo>
                <a:cubicBezTo>
                  <a:pt x="5391327" y="3998232"/>
                  <a:pt x="5461023" y="4066593"/>
                  <a:pt x="5475210" y="4154415"/>
                </a:cubicBezTo>
                <a:lnTo>
                  <a:pt x="5481555" y="4153971"/>
                </a:lnTo>
                <a:lnTo>
                  <a:pt x="5481555" y="3979466"/>
                </a:lnTo>
                <a:close/>
                <a:moveTo>
                  <a:pt x="5518866" y="3978705"/>
                </a:moveTo>
                <a:lnTo>
                  <a:pt x="5518612" y="3985050"/>
                </a:lnTo>
                <a:cubicBezTo>
                  <a:pt x="5606540" y="3997687"/>
                  <a:pt x="5676048" y="4066015"/>
                  <a:pt x="5690190" y="4153717"/>
                </a:cubicBezTo>
                <a:lnTo>
                  <a:pt x="5696536" y="4153209"/>
                </a:lnTo>
                <a:lnTo>
                  <a:pt x="5696536" y="3978705"/>
                </a:lnTo>
                <a:close/>
                <a:moveTo>
                  <a:pt x="5336436" y="3771646"/>
                </a:moveTo>
                <a:lnTo>
                  <a:pt x="5478762" y="3771646"/>
                </a:lnTo>
                <a:lnTo>
                  <a:pt x="5478762" y="3911694"/>
                </a:lnTo>
                <a:cubicBezTo>
                  <a:pt x="5458064" y="3843940"/>
                  <a:pt x="5404513" y="3791246"/>
                  <a:pt x="5336436" y="3771646"/>
                </a:cubicBezTo>
                <a:close/>
                <a:moveTo>
                  <a:pt x="5551353" y="3770821"/>
                </a:moveTo>
                <a:lnTo>
                  <a:pt x="5693743" y="3770821"/>
                </a:lnTo>
                <a:lnTo>
                  <a:pt x="5693743" y="3910869"/>
                </a:lnTo>
                <a:cubicBezTo>
                  <a:pt x="5673032" y="3843100"/>
                  <a:pt x="5619454" y="3790403"/>
                  <a:pt x="5551353" y="3770821"/>
                </a:cubicBezTo>
                <a:close/>
                <a:moveTo>
                  <a:pt x="5306995" y="3765301"/>
                </a:moveTo>
                <a:lnTo>
                  <a:pt x="5306487" y="3771647"/>
                </a:lnTo>
                <a:cubicBezTo>
                  <a:pt x="5394588" y="3784105"/>
                  <a:pt x="5464315" y="3852472"/>
                  <a:pt x="5478509" y="3940314"/>
                </a:cubicBezTo>
                <a:lnTo>
                  <a:pt x="5484855" y="3939806"/>
                </a:lnTo>
                <a:lnTo>
                  <a:pt x="5484664" y="3765301"/>
                </a:lnTo>
                <a:close/>
                <a:moveTo>
                  <a:pt x="5521975" y="3764540"/>
                </a:moveTo>
                <a:lnTo>
                  <a:pt x="5521531" y="3770885"/>
                </a:lnTo>
                <a:cubicBezTo>
                  <a:pt x="5609607" y="3783369"/>
                  <a:pt x="5679303" y="3851731"/>
                  <a:pt x="5693490" y="3939552"/>
                </a:cubicBezTo>
                <a:lnTo>
                  <a:pt x="5699835" y="3939044"/>
                </a:lnTo>
                <a:lnTo>
                  <a:pt x="5699645" y="3764540"/>
                </a:lnTo>
                <a:close/>
                <a:moveTo>
                  <a:pt x="5334786" y="3555070"/>
                </a:moveTo>
                <a:lnTo>
                  <a:pt x="5477176" y="3555070"/>
                </a:lnTo>
                <a:lnTo>
                  <a:pt x="5477176" y="3695118"/>
                </a:lnTo>
                <a:cubicBezTo>
                  <a:pt x="5456465" y="3627349"/>
                  <a:pt x="5402887" y="3574652"/>
                  <a:pt x="5334786" y="3555070"/>
                </a:cubicBezTo>
                <a:close/>
                <a:moveTo>
                  <a:pt x="5549767" y="3554309"/>
                </a:moveTo>
                <a:lnTo>
                  <a:pt x="5692157" y="3554309"/>
                </a:lnTo>
                <a:lnTo>
                  <a:pt x="5692157" y="3694293"/>
                </a:lnTo>
                <a:cubicBezTo>
                  <a:pt x="5671489" y="3626511"/>
                  <a:pt x="5617889" y="3573816"/>
                  <a:pt x="5549767" y="3554309"/>
                </a:cubicBezTo>
                <a:close/>
                <a:moveTo>
                  <a:pt x="5305472" y="3548725"/>
                </a:moveTo>
                <a:lnTo>
                  <a:pt x="5304774" y="3555071"/>
                </a:lnTo>
                <a:cubicBezTo>
                  <a:pt x="5392874" y="3567529"/>
                  <a:pt x="5462602" y="3635896"/>
                  <a:pt x="5476796" y="3723738"/>
                </a:cubicBezTo>
                <a:lnTo>
                  <a:pt x="5483141" y="3723230"/>
                </a:lnTo>
                <a:lnTo>
                  <a:pt x="5483141" y="3548725"/>
                </a:lnTo>
                <a:close/>
                <a:moveTo>
                  <a:pt x="5520452" y="3547964"/>
                </a:moveTo>
                <a:lnTo>
                  <a:pt x="5520452" y="3554246"/>
                </a:lnTo>
                <a:cubicBezTo>
                  <a:pt x="5608282" y="3566984"/>
                  <a:pt x="5677664" y="3635289"/>
                  <a:pt x="5691777" y="3722913"/>
                </a:cubicBezTo>
                <a:lnTo>
                  <a:pt x="5698122" y="3722468"/>
                </a:lnTo>
                <a:lnTo>
                  <a:pt x="5698122" y="3547964"/>
                </a:lnTo>
                <a:close/>
                <a:moveTo>
                  <a:pt x="5337959" y="3340969"/>
                </a:moveTo>
                <a:lnTo>
                  <a:pt x="5480349" y="3340969"/>
                </a:lnTo>
                <a:lnTo>
                  <a:pt x="5480349" y="3480953"/>
                </a:lnTo>
                <a:cubicBezTo>
                  <a:pt x="5459620" y="3413209"/>
                  <a:pt x="5406045" y="3360539"/>
                  <a:pt x="5337959" y="3340969"/>
                </a:cubicBezTo>
                <a:close/>
                <a:moveTo>
                  <a:pt x="5552876" y="3340144"/>
                </a:moveTo>
                <a:lnTo>
                  <a:pt x="5695266" y="3340144"/>
                </a:lnTo>
                <a:lnTo>
                  <a:pt x="5695266" y="3480192"/>
                </a:lnTo>
                <a:cubicBezTo>
                  <a:pt x="5674555" y="3412423"/>
                  <a:pt x="5620977" y="3359726"/>
                  <a:pt x="5552876" y="3340144"/>
                </a:cubicBezTo>
                <a:close/>
                <a:moveTo>
                  <a:pt x="5308581" y="3334560"/>
                </a:moveTo>
                <a:lnTo>
                  <a:pt x="5308137" y="3340906"/>
                </a:lnTo>
                <a:cubicBezTo>
                  <a:pt x="5396233" y="3353397"/>
                  <a:pt x="5465934" y="3421790"/>
                  <a:pt x="5480096" y="3509636"/>
                </a:cubicBezTo>
                <a:lnTo>
                  <a:pt x="5486441" y="3509129"/>
                </a:lnTo>
                <a:lnTo>
                  <a:pt x="5486251" y="3334560"/>
                </a:lnTo>
                <a:close/>
                <a:moveTo>
                  <a:pt x="5523498" y="3333863"/>
                </a:moveTo>
                <a:lnTo>
                  <a:pt x="5522990" y="3340208"/>
                </a:lnTo>
                <a:cubicBezTo>
                  <a:pt x="5611091" y="3352666"/>
                  <a:pt x="5680819" y="3421034"/>
                  <a:pt x="5695013" y="3508875"/>
                </a:cubicBezTo>
                <a:lnTo>
                  <a:pt x="5701358" y="3508367"/>
                </a:lnTo>
                <a:lnTo>
                  <a:pt x="5701168" y="3333863"/>
                </a:lnTo>
                <a:close/>
                <a:moveTo>
                  <a:pt x="0" y="0"/>
                </a:moveTo>
                <a:lnTo>
                  <a:pt x="5723503" y="0"/>
                </a:lnTo>
                <a:lnTo>
                  <a:pt x="5723503" y="6079105"/>
                </a:lnTo>
                <a:lnTo>
                  <a:pt x="0" y="6079105"/>
                </a:lnTo>
                <a:close/>
              </a:path>
            </a:pathLst>
          </a:custGeom>
          <a:solidFill>
            <a:schemeClr val="bg2"/>
          </a:solidFill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en-GB"/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8E0DD39-24FC-AE4A-B94A-C42AB36CC1B7}"/>
              </a:ext>
            </a:extLst>
          </p:cNvPr>
          <p:cNvGrpSpPr/>
          <p:nvPr userDrawn="1"/>
        </p:nvGrpSpPr>
        <p:grpSpPr>
          <a:xfrm>
            <a:off x="6057785" y="3509736"/>
            <a:ext cx="593202" cy="975172"/>
            <a:chOff x="6110794" y="3712667"/>
            <a:chExt cx="604094" cy="1022367"/>
          </a:xfrm>
        </p:grpSpPr>
        <p:sp>
          <p:nvSpPr>
            <p:cNvPr id="26" name="Freeform 5">
              <a:extLst>
                <a:ext uri="{FF2B5EF4-FFF2-40B4-BE49-F238E27FC236}">
                  <a16:creationId xmlns:a16="http://schemas.microsoft.com/office/drawing/2014/main" id="{49978BDD-C6D6-E346-A9BF-0B2D9F39C175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" name="Freeform 6">
              <a:extLst>
                <a:ext uri="{FF2B5EF4-FFF2-40B4-BE49-F238E27FC236}">
                  <a16:creationId xmlns:a16="http://schemas.microsoft.com/office/drawing/2014/main" id="{A96E66DD-FA9B-E349-A02B-B02BD88A5B71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Freeform 7">
              <a:extLst>
                <a:ext uri="{FF2B5EF4-FFF2-40B4-BE49-F238E27FC236}">
                  <a16:creationId xmlns:a16="http://schemas.microsoft.com/office/drawing/2014/main" id="{0BED5851-F849-E24E-95C6-51A56A1EAAE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" name="Freeform 10">
              <a:extLst>
                <a:ext uri="{FF2B5EF4-FFF2-40B4-BE49-F238E27FC236}">
                  <a16:creationId xmlns:a16="http://schemas.microsoft.com/office/drawing/2014/main" id="{4E532B9F-6985-4441-A777-C3F92A34A1C6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Freeform 11">
              <a:extLst>
                <a:ext uri="{FF2B5EF4-FFF2-40B4-BE49-F238E27FC236}">
                  <a16:creationId xmlns:a16="http://schemas.microsoft.com/office/drawing/2014/main" id="{D0FECB11-A712-D749-8E29-7C09F9ABC2AC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" name="Freeform 12">
              <a:extLst>
                <a:ext uri="{FF2B5EF4-FFF2-40B4-BE49-F238E27FC236}">
                  <a16:creationId xmlns:a16="http://schemas.microsoft.com/office/drawing/2014/main" id="{7AFEB51D-BF86-0246-A2F2-F5C22BB18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" name="Freeform 15">
              <a:extLst>
                <a:ext uri="{FF2B5EF4-FFF2-40B4-BE49-F238E27FC236}">
                  <a16:creationId xmlns:a16="http://schemas.microsoft.com/office/drawing/2014/main" id="{3D1B6517-4291-0D49-865E-755AA0F3D0A0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59B0FCA4-8AFD-B642-906B-F5222B92BE36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EBDD0B13-0DE3-7146-98EA-91D20B7A1FB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" name="Freeform 20">
              <a:extLst>
                <a:ext uri="{FF2B5EF4-FFF2-40B4-BE49-F238E27FC236}">
                  <a16:creationId xmlns:a16="http://schemas.microsoft.com/office/drawing/2014/main" id="{9496EABF-F658-AC4D-AE40-621EDD04F1BC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" name="Freeform 21">
              <a:extLst>
                <a:ext uri="{FF2B5EF4-FFF2-40B4-BE49-F238E27FC236}">
                  <a16:creationId xmlns:a16="http://schemas.microsoft.com/office/drawing/2014/main" id="{41EEB260-02BE-7F4E-B46B-04B5A9453900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Freeform 22">
              <a:extLst>
                <a:ext uri="{FF2B5EF4-FFF2-40B4-BE49-F238E27FC236}">
                  <a16:creationId xmlns:a16="http://schemas.microsoft.com/office/drawing/2014/main" id="{95BDCD68-13DD-4649-9A16-558E7BD975C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" name="Freeform 25">
              <a:extLst>
                <a:ext uri="{FF2B5EF4-FFF2-40B4-BE49-F238E27FC236}">
                  <a16:creationId xmlns:a16="http://schemas.microsoft.com/office/drawing/2014/main" id="{9AC229A1-06B0-4846-ACB3-26E7B3FF7EE5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" name="Freeform 26">
              <a:extLst>
                <a:ext uri="{FF2B5EF4-FFF2-40B4-BE49-F238E27FC236}">
                  <a16:creationId xmlns:a16="http://schemas.microsoft.com/office/drawing/2014/main" id="{CE8EB986-BC20-D74F-A600-F58016D26EF7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" name="Freeform 27">
              <a:extLst>
                <a:ext uri="{FF2B5EF4-FFF2-40B4-BE49-F238E27FC236}">
                  <a16:creationId xmlns:a16="http://schemas.microsoft.com/office/drawing/2014/main" id="{E8904A61-0677-0E46-A571-C96981D7255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2318787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0C1FE-78ED-44D7-A2F8-34AF7483C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C4E27F-5356-419B-9F65-3D95E1F1A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62D5B7-E807-4F6E-BC7A-A8F1006198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17DABB-8566-47B4-8346-BD47871D25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74F952-327C-4672-9ECF-AE0FE64FF7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DDD6496-66A3-4AE1-9060-FA31F3242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A5BFF1-6B21-42E5-A053-A8536D49F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74C702-AEAB-46A5-9D18-C1624579A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922820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vider w/o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24" name="Title 1">
            <a:extLst>
              <a:ext uri="{FF2B5EF4-FFF2-40B4-BE49-F238E27FC236}">
                <a16:creationId xmlns:a16="http://schemas.microsoft.com/office/drawing/2014/main" id="{81B0651E-9135-824D-AF58-78D139479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41620" y="2907462"/>
            <a:ext cx="9512652" cy="480131"/>
          </a:xfrm>
        </p:spPr>
        <p:txBody>
          <a:bodyPr wrap="square" anchor="ctr">
            <a:spAutoFit/>
          </a:bodyPr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1" name="Freeform 5">
            <a:extLst>
              <a:ext uri="{FF2B5EF4-FFF2-40B4-BE49-F238E27FC236}">
                <a16:creationId xmlns:a16="http://schemas.microsoft.com/office/drawing/2014/main" id="{611D4F9B-925D-BC43-8260-F404EAE16834}"/>
              </a:ext>
            </a:extLst>
          </p:cNvPr>
          <p:cNvSpPr>
            <a:spLocks noChangeAspect="1"/>
          </p:cNvSpPr>
          <p:nvPr/>
        </p:nvSpPr>
        <p:spPr bwMode="auto">
          <a:xfrm rot="16200000" flipH="1">
            <a:off x="10176099" y="4530825"/>
            <a:ext cx="1613827" cy="1602000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noFill/>
          <a:ln w="12700" cap="flat">
            <a:solidFill>
              <a:schemeClr val="bg2"/>
            </a:solidFill>
            <a:prstDash val="solid"/>
            <a:miter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" name="Freeform 5">
            <a:extLst>
              <a:ext uri="{FF2B5EF4-FFF2-40B4-BE49-F238E27FC236}">
                <a16:creationId xmlns:a16="http://schemas.microsoft.com/office/drawing/2014/main" id="{F92E0807-C455-0743-B8C5-86D84226E6F7}"/>
              </a:ext>
            </a:extLst>
          </p:cNvPr>
          <p:cNvSpPr>
            <a:spLocks/>
          </p:cNvSpPr>
          <p:nvPr/>
        </p:nvSpPr>
        <p:spPr bwMode="auto">
          <a:xfrm rot="5400000" flipH="1">
            <a:off x="411759" y="393358"/>
            <a:ext cx="1608013" cy="1596229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8A9B772A-1FCC-5840-8809-70296571989A}"/>
              </a:ext>
            </a:extLst>
          </p:cNvPr>
          <p:cNvSpPr>
            <a:spLocks noChangeAspect="1"/>
          </p:cNvSpPr>
          <p:nvPr userDrawn="1"/>
        </p:nvSpPr>
        <p:spPr bwMode="auto">
          <a:xfrm rot="16200000" flipH="1">
            <a:off x="10176099" y="4530825"/>
            <a:ext cx="1613827" cy="1602000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noFill/>
          <a:ln w="12700" cap="flat">
            <a:solidFill>
              <a:schemeClr val="bg2"/>
            </a:solidFill>
            <a:prstDash val="solid"/>
            <a:miter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" name="Freeform 5">
            <a:extLst>
              <a:ext uri="{FF2B5EF4-FFF2-40B4-BE49-F238E27FC236}">
                <a16:creationId xmlns:a16="http://schemas.microsoft.com/office/drawing/2014/main" id="{916ADB33-3EE3-BC40-B2BB-6240F9D25656}"/>
              </a:ext>
            </a:extLst>
          </p:cNvPr>
          <p:cNvSpPr>
            <a:spLocks/>
          </p:cNvSpPr>
          <p:nvPr userDrawn="1"/>
        </p:nvSpPr>
        <p:spPr bwMode="auto">
          <a:xfrm rot="5400000" flipH="1">
            <a:off x="411759" y="393358"/>
            <a:ext cx="1608013" cy="1596229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56846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tatement 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 6">
            <a:extLst>
              <a:ext uri="{FF2B5EF4-FFF2-40B4-BE49-F238E27FC236}">
                <a16:creationId xmlns:a16="http://schemas.microsoft.com/office/drawing/2014/main" id="{9BE75F46-D81E-5447-B33A-EACD35F4465F}"/>
              </a:ext>
            </a:extLst>
          </p:cNvPr>
          <p:cNvSpPr/>
          <p:nvPr/>
        </p:nvSpPr>
        <p:spPr>
          <a:xfrm>
            <a:off x="2754754" y="0"/>
            <a:ext cx="9437246" cy="6858000"/>
          </a:xfrm>
          <a:custGeom>
            <a:avLst/>
            <a:gdLst>
              <a:gd name="connsiteX0" fmla="*/ 0 w 9437246"/>
              <a:gd name="connsiteY0" fmla="*/ 0 h 6833052"/>
              <a:gd name="connsiteX1" fmla="*/ 9437246 w 9437246"/>
              <a:gd name="connsiteY1" fmla="*/ 0 h 6833052"/>
              <a:gd name="connsiteX2" fmla="*/ 9437246 w 9437246"/>
              <a:gd name="connsiteY2" fmla="*/ 6833052 h 6833052"/>
              <a:gd name="connsiteX3" fmla="*/ 9221785 w 9437246"/>
              <a:gd name="connsiteY3" fmla="*/ 6819662 h 6833052"/>
              <a:gd name="connsiteX4" fmla="*/ 78869 w 9437246"/>
              <a:gd name="connsiteY4" fmla="*/ 252510 h 68330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437246" h="6833052">
                <a:moveTo>
                  <a:pt x="0" y="0"/>
                </a:moveTo>
                <a:lnTo>
                  <a:pt x="9437246" y="0"/>
                </a:lnTo>
                <a:lnTo>
                  <a:pt x="9437246" y="6833052"/>
                </a:lnTo>
                <a:lnTo>
                  <a:pt x="9221785" y="6819662"/>
                </a:lnTo>
                <a:cubicBezTo>
                  <a:pt x="4879604" y="6473211"/>
                  <a:pt x="1296735" y="3813340"/>
                  <a:pt x="78869" y="25251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BE" sz="1400">
              <a:solidFill>
                <a:schemeClr val="accent1"/>
              </a:solidFill>
            </a:endParaRPr>
          </a:p>
        </p:txBody>
      </p:sp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88" y="3561700"/>
            <a:ext cx="4401079" cy="867930"/>
          </a:xfrm>
        </p:spPr>
        <p:txBody>
          <a:bodyPr wrap="square" rIns="36000" anchor="b">
            <a:spAutoFit/>
          </a:bodyPr>
          <a:lstStyle>
            <a:lvl1pPr algn="l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03A404-0F09-EF45-8852-06F3E2AD4882}"/>
              </a:ext>
            </a:extLst>
          </p:cNvPr>
          <p:cNvSpPr txBox="1"/>
          <p:nvPr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FC533E8-0B08-D64D-8FCE-2D0B39A69DEC}"/>
              </a:ext>
            </a:extLst>
          </p:cNvPr>
          <p:cNvGrpSpPr/>
          <p:nvPr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3CA3DE5-6942-A749-A150-0E5FC8B1F6D8}"/>
                </a:ext>
              </a:extLst>
            </p:cNvPr>
            <p:cNvSpPr txBox="1"/>
            <p:nvPr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5BFB9D5E-1F4F-BD43-96B2-14BE29E6ACAB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24F16A9-2DDD-E64B-AEDC-9D691F0A36EC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Freeform 12">
            <a:extLst>
              <a:ext uri="{FF2B5EF4-FFF2-40B4-BE49-F238E27FC236}">
                <a16:creationId xmlns:a16="http://schemas.microsoft.com/office/drawing/2014/main" id="{7405B570-EC49-2E40-BBA3-BB0B3B4A3C3D}"/>
              </a:ext>
            </a:extLst>
          </p:cNvPr>
          <p:cNvSpPr/>
          <p:nvPr userDrawn="1"/>
        </p:nvSpPr>
        <p:spPr>
          <a:xfrm>
            <a:off x="2754754" y="0"/>
            <a:ext cx="9437246" cy="6858000"/>
          </a:xfrm>
          <a:custGeom>
            <a:avLst/>
            <a:gdLst>
              <a:gd name="connsiteX0" fmla="*/ 0 w 9437246"/>
              <a:gd name="connsiteY0" fmla="*/ 0 h 6833052"/>
              <a:gd name="connsiteX1" fmla="*/ 9437246 w 9437246"/>
              <a:gd name="connsiteY1" fmla="*/ 0 h 6833052"/>
              <a:gd name="connsiteX2" fmla="*/ 9437246 w 9437246"/>
              <a:gd name="connsiteY2" fmla="*/ 6833052 h 6833052"/>
              <a:gd name="connsiteX3" fmla="*/ 9221785 w 9437246"/>
              <a:gd name="connsiteY3" fmla="*/ 6819662 h 6833052"/>
              <a:gd name="connsiteX4" fmla="*/ 78869 w 9437246"/>
              <a:gd name="connsiteY4" fmla="*/ 252510 h 68330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437246" h="6833052">
                <a:moveTo>
                  <a:pt x="0" y="0"/>
                </a:moveTo>
                <a:lnTo>
                  <a:pt x="9437246" y="0"/>
                </a:lnTo>
                <a:lnTo>
                  <a:pt x="9437246" y="6833052"/>
                </a:lnTo>
                <a:lnTo>
                  <a:pt x="9221785" y="6819662"/>
                </a:lnTo>
                <a:cubicBezTo>
                  <a:pt x="4879604" y="6473211"/>
                  <a:pt x="1296735" y="3813340"/>
                  <a:pt x="78869" y="25251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BE" sz="1400">
              <a:solidFill>
                <a:schemeClr val="accent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6D093DF-9983-5846-8381-21EFC2ED42C0}"/>
              </a:ext>
            </a:extLst>
          </p:cNvPr>
          <p:cNvSpPr txBox="1"/>
          <p:nvPr userDrawn="1"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04A1A51-9814-4F49-9090-80D63DD82094}"/>
              </a:ext>
            </a:extLst>
          </p:cNvPr>
          <p:cNvGrpSpPr/>
          <p:nvPr userDrawn="1"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5E9D15B-3E97-FA45-B6C2-2EAAB2887DDB}"/>
                </a:ext>
              </a:extLst>
            </p:cNvPr>
            <p:cNvSpPr txBox="1"/>
            <p:nvPr userDrawn="1"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A1D66FE1-B512-FC44-B5CE-F154EBDED2C7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C0966C4C-B1F3-B24B-B96E-580B2F4F0468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124403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tatement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4">
            <a:extLst>
              <a:ext uri="{FF2B5EF4-FFF2-40B4-BE49-F238E27FC236}">
                <a16:creationId xmlns:a16="http://schemas.microsoft.com/office/drawing/2014/main" id="{0E266A10-7698-4D46-92BA-27C0C79F17B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406017" y="0"/>
            <a:ext cx="6792334" cy="6856413"/>
            <a:chOff x="4398" y="1002"/>
            <a:chExt cx="3286" cy="3317"/>
          </a:xfrm>
        </p:grpSpPr>
        <p:sp>
          <p:nvSpPr>
            <p:cNvPr id="11" name="AutoShape 3">
              <a:extLst>
                <a:ext uri="{FF2B5EF4-FFF2-40B4-BE49-F238E27FC236}">
                  <a16:creationId xmlns:a16="http://schemas.microsoft.com/office/drawing/2014/main" id="{0BE617A9-07A3-CC4C-9365-E1631F85F9F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4398" y="1002"/>
              <a:ext cx="3286" cy="3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Freeform 5">
              <a:extLst>
                <a:ext uri="{FF2B5EF4-FFF2-40B4-BE49-F238E27FC236}">
                  <a16:creationId xmlns:a16="http://schemas.microsoft.com/office/drawing/2014/main" id="{38728E5D-8F91-E54F-A979-AD7FAF48DD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7" y="1002"/>
              <a:ext cx="3286" cy="3318"/>
            </a:xfrm>
            <a:custGeom>
              <a:avLst/>
              <a:gdLst>
                <a:gd name="T0" fmla="*/ 2544 w 2544"/>
                <a:gd name="T1" fmla="*/ 0 h 2569"/>
                <a:gd name="T2" fmla="*/ 2544 w 2544"/>
                <a:gd name="T3" fmla="*/ 2569 h 2569"/>
                <a:gd name="T4" fmla="*/ 0 w 2544"/>
                <a:gd name="T5" fmla="*/ 2569 h 2569"/>
                <a:gd name="T6" fmla="*/ 2544 w 2544"/>
                <a:gd name="T7" fmla="*/ 0 h 25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44" h="2569">
                  <a:moveTo>
                    <a:pt x="2544" y="0"/>
                  </a:moveTo>
                  <a:cubicBezTo>
                    <a:pt x="2544" y="2569"/>
                    <a:pt x="2544" y="2569"/>
                    <a:pt x="2544" y="2569"/>
                  </a:cubicBezTo>
                  <a:cubicBezTo>
                    <a:pt x="0" y="2569"/>
                    <a:pt x="0" y="2569"/>
                    <a:pt x="0" y="2569"/>
                  </a:cubicBezTo>
                  <a:cubicBezTo>
                    <a:pt x="1308" y="2365"/>
                    <a:pt x="2342" y="1321"/>
                    <a:pt x="2544" y="0"/>
                  </a:cubicBezTo>
                </a:path>
              </a:pathLst>
            </a:custGeom>
            <a:solidFill>
              <a:schemeClr val="accent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88" y="3188935"/>
            <a:ext cx="8110369" cy="480131"/>
          </a:xfrm>
        </p:spPr>
        <p:txBody>
          <a:bodyPr wrap="square" rIns="36000" anchor="ctr">
            <a:spAutoFit/>
          </a:bodyPr>
          <a:lstStyle>
            <a:lvl1pPr algn="l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5F6C02A-E300-8E44-8EC3-A6F88D9E23D8}"/>
              </a:ext>
            </a:extLst>
          </p:cNvPr>
          <p:cNvSpPr txBox="1"/>
          <p:nvPr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bg1"/>
                </a:solidFill>
              </a:rPr>
              <a:pPr lvl="0" algn="ctr"/>
              <a:t>‹#›</a:t>
            </a:fld>
            <a:endParaRPr lang="en-US" sz="800">
              <a:solidFill>
                <a:schemeClr val="bg1"/>
              </a:solidFill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80B588B-769A-964C-B04A-A0A39F4A1B54}"/>
              </a:ext>
            </a:extLst>
          </p:cNvPr>
          <p:cNvGrpSpPr/>
          <p:nvPr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64AEB60-2887-4E4F-BABA-6F7DA040CBD2}"/>
                </a:ext>
              </a:extLst>
            </p:cNvPr>
            <p:cNvSpPr txBox="1"/>
            <p:nvPr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bg1"/>
                  </a:solidFill>
                </a:rPr>
                <a:t>Proprietary and Confidential Property of UCB</a:t>
              </a:r>
              <a:endParaRPr lang="en-BE" sz="900">
                <a:solidFill>
                  <a:schemeClr val="bg1"/>
                </a:solidFill>
              </a:endParaRP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EE612709-CECD-664B-BF5B-67A0B0C29783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2285A0B-2510-8548-8DA1-BF2F0AAAE870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4">
            <a:extLst>
              <a:ext uri="{FF2B5EF4-FFF2-40B4-BE49-F238E27FC236}">
                <a16:creationId xmlns:a16="http://schemas.microsoft.com/office/drawing/2014/main" id="{802F1EE5-42E6-5746-B0CD-42F46A5A0611}"/>
              </a:ext>
            </a:extLst>
          </p:cNvPr>
          <p:cNvGrpSpPr>
            <a:grpSpLocks noChangeAspect="1"/>
          </p:cNvGrpSpPr>
          <p:nvPr userDrawn="1"/>
        </p:nvGrpSpPr>
        <p:grpSpPr bwMode="auto">
          <a:xfrm>
            <a:off x="5406017" y="0"/>
            <a:ext cx="6792334" cy="6856413"/>
            <a:chOff x="4398" y="1002"/>
            <a:chExt cx="3286" cy="3317"/>
          </a:xfrm>
        </p:grpSpPr>
        <p:sp>
          <p:nvSpPr>
            <p:cNvPr id="14" name="AutoShape 3">
              <a:extLst>
                <a:ext uri="{FF2B5EF4-FFF2-40B4-BE49-F238E27FC236}">
                  <a16:creationId xmlns:a16="http://schemas.microsoft.com/office/drawing/2014/main" id="{8B80C5A6-2526-5249-97C0-C743314F8488}"/>
                </a:ext>
              </a:extLst>
            </p:cNvPr>
            <p:cNvSpPr>
              <a:spLocks noChangeAspect="1" noChangeArrowheads="1" noTextEdit="1"/>
            </p:cNvSpPr>
            <p:nvPr userDrawn="1"/>
          </p:nvSpPr>
          <p:spPr bwMode="auto">
            <a:xfrm>
              <a:off x="4398" y="1002"/>
              <a:ext cx="3286" cy="3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Freeform 5">
              <a:extLst>
                <a:ext uri="{FF2B5EF4-FFF2-40B4-BE49-F238E27FC236}">
                  <a16:creationId xmlns:a16="http://schemas.microsoft.com/office/drawing/2014/main" id="{0DFC4E2F-F685-F34F-97B1-6ABAA001EAE8}"/>
                </a:ext>
              </a:extLst>
            </p:cNvPr>
            <p:cNvSpPr>
              <a:spLocks/>
            </p:cNvSpPr>
            <p:nvPr userDrawn="1"/>
          </p:nvSpPr>
          <p:spPr bwMode="auto">
            <a:xfrm>
              <a:off x="4397" y="1002"/>
              <a:ext cx="3286" cy="3318"/>
            </a:xfrm>
            <a:custGeom>
              <a:avLst/>
              <a:gdLst>
                <a:gd name="T0" fmla="*/ 2544 w 2544"/>
                <a:gd name="T1" fmla="*/ 0 h 2569"/>
                <a:gd name="T2" fmla="*/ 2544 w 2544"/>
                <a:gd name="T3" fmla="*/ 2569 h 2569"/>
                <a:gd name="T4" fmla="*/ 0 w 2544"/>
                <a:gd name="T5" fmla="*/ 2569 h 2569"/>
                <a:gd name="T6" fmla="*/ 2544 w 2544"/>
                <a:gd name="T7" fmla="*/ 0 h 25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44" h="2569">
                  <a:moveTo>
                    <a:pt x="2544" y="0"/>
                  </a:moveTo>
                  <a:cubicBezTo>
                    <a:pt x="2544" y="2569"/>
                    <a:pt x="2544" y="2569"/>
                    <a:pt x="2544" y="2569"/>
                  </a:cubicBezTo>
                  <a:cubicBezTo>
                    <a:pt x="0" y="2569"/>
                    <a:pt x="0" y="2569"/>
                    <a:pt x="0" y="2569"/>
                  </a:cubicBezTo>
                  <a:cubicBezTo>
                    <a:pt x="1308" y="2365"/>
                    <a:pt x="2342" y="1321"/>
                    <a:pt x="2544" y="0"/>
                  </a:cubicBezTo>
                </a:path>
              </a:pathLst>
            </a:custGeom>
            <a:solidFill>
              <a:schemeClr val="accent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879C9E3-8642-7E41-B078-9D6810971079}"/>
              </a:ext>
            </a:extLst>
          </p:cNvPr>
          <p:cNvSpPr txBox="1"/>
          <p:nvPr userDrawn="1"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bg1"/>
                </a:solidFill>
              </a:rPr>
              <a:pPr lvl="0" algn="ctr"/>
              <a:t>‹#›</a:t>
            </a:fld>
            <a:endParaRPr lang="en-US" sz="800">
              <a:solidFill>
                <a:schemeClr val="bg1"/>
              </a:solidFill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4D28F05-7DD6-5641-A261-DA047E7E96FC}"/>
              </a:ext>
            </a:extLst>
          </p:cNvPr>
          <p:cNvGrpSpPr/>
          <p:nvPr userDrawn="1"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17DD44-1000-FB4A-8A5B-548BF0709366}"/>
                </a:ext>
              </a:extLst>
            </p:cNvPr>
            <p:cNvSpPr txBox="1"/>
            <p:nvPr userDrawn="1"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bg1"/>
                  </a:solidFill>
                </a:rPr>
                <a:t>Proprietary and Confidential Property of UCB</a:t>
              </a:r>
              <a:endParaRPr lang="en-BE" sz="900">
                <a:solidFill>
                  <a:schemeClr val="bg1"/>
                </a:solidFill>
              </a:endParaRP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79DE366-DE1A-3D4A-9169-7A39E1393D4B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70298EF5-07A8-0246-9E7D-DBA68C87E479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748560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End slide w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88" y="4058657"/>
            <a:ext cx="4401079" cy="867930"/>
          </a:xfrm>
        </p:spPr>
        <p:txBody>
          <a:bodyPr wrap="square" rIns="36000" anchor="b">
            <a:spAutoFit/>
          </a:bodyPr>
          <a:lstStyle>
            <a:lvl1pPr algn="l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59" name="Subtitle 2">
            <a:extLst>
              <a:ext uri="{FF2B5EF4-FFF2-40B4-BE49-F238E27FC236}">
                <a16:creationId xmlns:a16="http://schemas.microsoft.com/office/drawing/2014/main" id="{2182F8AD-1FB7-254D-B9E0-A4E8BB5B9E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07988" y="5018662"/>
            <a:ext cx="4401079" cy="338554"/>
          </a:xfrm>
        </p:spPr>
        <p:txBody>
          <a:bodyPr wrap="square" rIns="36000">
            <a:sp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600">
                <a:solidFill>
                  <a:schemeClr val="accent1"/>
                </a:solidFill>
                <a:latin typeface="+mn-lt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14" name="Picture Placeholder 13">
            <a:extLst>
              <a:ext uri="{FF2B5EF4-FFF2-40B4-BE49-F238E27FC236}">
                <a16:creationId xmlns:a16="http://schemas.microsoft.com/office/drawing/2014/main" id="{6AE4611C-9F5D-A942-8DF3-4440110899E0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2754754" y="0"/>
            <a:ext cx="9437246" cy="6858000"/>
          </a:xfrm>
          <a:custGeom>
            <a:avLst/>
            <a:gdLst>
              <a:gd name="connsiteX0" fmla="*/ 0 w 9437246"/>
              <a:gd name="connsiteY0" fmla="*/ 0 h 6833052"/>
              <a:gd name="connsiteX1" fmla="*/ 9437246 w 9437246"/>
              <a:gd name="connsiteY1" fmla="*/ 0 h 6833052"/>
              <a:gd name="connsiteX2" fmla="*/ 9437246 w 9437246"/>
              <a:gd name="connsiteY2" fmla="*/ 6833052 h 6833052"/>
              <a:gd name="connsiteX3" fmla="*/ 9221785 w 9437246"/>
              <a:gd name="connsiteY3" fmla="*/ 6819662 h 6833052"/>
              <a:gd name="connsiteX4" fmla="*/ 78869 w 9437246"/>
              <a:gd name="connsiteY4" fmla="*/ 252510 h 68330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437246" h="6833052">
                <a:moveTo>
                  <a:pt x="0" y="0"/>
                </a:moveTo>
                <a:lnTo>
                  <a:pt x="9437246" y="0"/>
                </a:lnTo>
                <a:lnTo>
                  <a:pt x="9437246" y="6833052"/>
                </a:lnTo>
                <a:lnTo>
                  <a:pt x="9221785" y="6819662"/>
                </a:lnTo>
                <a:cubicBezTo>
                  <a:pt x="4879604" y="6473211"/>
                  <a:pt x="1296735" y="3813340"/>
                  <a:pt x="78869" y="25251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</p:spPr>
        <p:txBody>
          <a:bodyPr wrap="square" rIns="180000" anchor="ctr">
            <a:noAutofit/>
          </a:bodyPr>
          <a:lstStyle>
            <a:lvl1pPr algn="r">
              <a:defRPr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BE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AC7B90F-A1C3-0C45-8761-4AC75DE2D92E}"/>
              </a:ext>
            </a:extLst>
          </p:cNvPr>
          <p:cNvGrpSpPr/>
          <p:nvPr userDrawn="1"/>
        </p:nvGrpSpPr>
        <p:grpSpPr>
          <a:xfrm rot="5400000">
            <a:off x="5980584" y="4768552"/>
            <a:ext cx="230832" cy="3501854"/>
            <a:chOff x="0" y="1980381"/>
            <a:chExt cx="230832" cy="350185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2ABC181-BB9B-8443-AFB9-3CEAF9B2A04E}"/>
                </a:ext>
              </a:extLst>
            </p:cNvPr>
            <p:cNvSpPr txBox="1"/>
            <p:nvPr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F6005F7B-9433-394D-8C2A-9AE3DB8C4A3C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79B9F0A8-3F16-874D-ACFB-DF31876D8D97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273BA04-2628-DF4D-925E-D3A419BC9379}"/>
              </a:ext>
            </a:extLst>
          </p:cNvPr>
          <p:cNvGrpSpPr/>
          <p:nvPr userDrawn="1"/>
        </p:nvGrpSpPr>
        <p:grpSpPr>
          <a:xfrm rot="5400000">
            <a:off x="5980584" y="4768552"/>
            <a:ext cx="230832" cy="3501854"/>
            <a:chOff x="0" y="1980381"/>
            <a:chExt cx="230832" cy="3501854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C8F8A42-3A50-064F-B98A-A1873E2098B4}"/>
                </a:ext>
              </a:extLst>
            </p:cNvPr>
            <p:cNvSpPr txBox="1"/>
            <p:nvPr userDrawn="1"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63CFF3F5-2232-9A41-BBA6-953E941A00F6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7303C5E9-A81C-9441-8561-447FAE9A9500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871957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End slide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95230" y="4370048"/>
            <a:ext cx="9401540" cy="480131"/>
          </a:xfrm>
        </p:spPr>
        <p:txBody>
          <a:bodyPr wrap="square" rIns="36000" anchor="b">
            <a:normAutofit/>
          </a:bodyPr>
          <a:lstStyle>
            <a:lvl1pPr algn="ctr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59" name="Subtitle 2">
            <a:extLst>
              <a:ext uri="{FF2B5EF4-FFF2-40B4-BE49-F238E27FC236}">
                <a16:creationId xmlns:a16="http://schemas.microsoft.com/office/drawing/2014/main" id="{2182F8AD-1FB7-254D-B9E0-A4E8BB5B9E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95230" y="4942254"/>
            <a:ext cx="9401540" cy="338554"/>
          </a:xfrm>
        </p:spPr>
        <p:txBody>
          <a:bodyPr wrap="square" rIns="36000" anchor="t">
            <a:sp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600">
                <a:solidFill>
                  <a:schemeClr val="accent1"/>
                </a:solidFill>
                <a:latin typeface="+mn-lt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551F790-BC07-EE40-85F4-EFC68DCF6426}"/>
              </a:ext>
            </a:extLst>
          </p:cNvPr>
          <p:cNvGrpSpPr/>
          <p:nvPr/>
        </p:nvGrpSpPr>
        <p:grpSpPr>
          <a:xfrm rot="5400000">
            <a:off x="5980584" y="4768552"/>
            <a:ext cx="230832" cy="3501854"/>
            <a:chOff x="0" y="1980381"/>
            <a:chExt cx="230832" cy="3501854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C170B76-1B60-8A47-8BF2-13B1F51C9FBB}"/>
                </a:ext>
              </a:extLst>
            </p:cNvPr>
            <p:cNvSpPr txBox="1"/>
            <p:nvPr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000FD983-1E0D-674B-B17D-0D7B767052EA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943A570F-F968-D440-962C-BE1ABFFB5395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280C577B-C23B-4044-9AF1-0EC1B899CAA0}"/>
              </a:ext>
            </a:extLst>
          </p:cNvPr>
          <p:cNvGrpSpPr/>
          <p:nvPr userDrawn="1"/>
        </p:nvGrpSpPr>
        <p:grpSpPr>
          <a:xfrm rot="5400000">
            <a:off x="5980584" y="4768552"/>
            <a:ext cx="230832" cy="3501854"/>
            <a:chOff x="0" y="1980381"/>
            <a:chExt cx="230832" cy="3501854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FD82AFBA-CE0D-8C43-A515-0029F8453B96}"/>
                </a:ext>
              </a:extLst>
            </p:cNvPr>
            <p:cNvSpPr txBox="1"/>
            <p:nvPr userDrawn="1"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643DD8CF-C116-E147-AC11-19A2AE974BE9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A3304225-C86A-D543-9594-11E50E87A943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6" name="Graphic 105">
            <a:extLst>
              <a:ext uri="{FF2B5EF4-FFF2-40B4-BE49-F238E27FC236}">
                <a16:creationId xmlns:a16="http://schemas.microsoft.com/office/drawing/2014/main" id="{0741A49E-26E7-0344-ABB9-6BCB6B3ED9D6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395230" y="1043297"/>
            <a:ext cx="9401540" cy="30336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1427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icture Placeholder 64">
            <a:extLst>
              <a:ext uri="{FF2B5EF4-FFF2-40B4-BE49-F238E27FC236}">
                <a16:creationId xmlns:a16="http://schemas.microsoft.com/office/drawing/2014/main" id="{B8D670EA-1E47-EE44-9859-BF14C627EA3B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9" y="5"/>
            <a:ext cx="12191993" cy="6857996"/>
          </a:xfrm>
          <a:custGeom>
            <a:avLst/>
            <a:gdLst>
              <a:gd name="connsiteX0" fmla="*/ 3578903 w 12191993"/>
              <a:gd name="connsiteY0" fmla="*/ 6416506 h 6857996"/>
              <a:gd name="connsiteX1" fmla="*/ 3578903 w 12191993"/>
              <a:gd name="connsiteY1" fmla="*/ 6449909 h 6857996"/>
              <a:gd name="connsiteX2" fmla="*/ 3611987 w 12191993"/>
              <a:gd name="connsiteY2" fmla="*/ 6449909 h 6857996"/>
              <a:gd name="connsiteX3" fmla="*/ 3611987 w 12191993"/>
              <a:gd name="connsiteY3" fmla="*/ 6416506 h 6857996"/>
              <a:gd name="connsiteX4" fmla="*/ 3481994 w 12191993"/>
              <a:gd name="connsiteY4" fmla="*/ 6306894 h 6857996"/>
              <a:gd name="connsiteX5" fmla="*/ 3521564 w 12191993"/>
              <a:gd name="connsiteY5" fmla="*/ 6348729 h 6857996"/>
              <a:gd name="connsiteX6" fmla="*/ 3433990 w 12191993"/>
              <a:gd name="connsiteY6" fmla="*/ 6348729 h 6857996"/>
              <a:gd name="connsiteX7" fmla="*/ 3481994 w 12191993"/>
              <a:gd name="connsiteY7" fmla="*/ 6306894 h 6857996"/>
              <a:gd name="connsiteX8" fmla="*/ 2971631 w 12191993"/>
              <a:gd name="connsiteY8" fmla="*/ 6306894 h 6857996"/>
              <a:gd name="connsiteX9" fmla="*/ 3011201 w 12191993"/>
              <a:gd name="connsiteY9" fmla="*/ 6348729 h 6857996"/>
              <a:gd name="connsiteX10" fmla="*/ 2923627 w 12191993"/>
              <a:gd name="connsiteY10" fmla="*/ 6348729 h 6857996"/>
              <a:gd name="connsiteX11" fmla="*/ 2971631 w 12191993"/>
              <a:gd name="connsiteY11" fmla="*/ 6306894 h 6857996"/>
              <a:gd name="connsiteX12" fmla="*/ 2218851 w 12191993"/>
              <a:gd name="connsiteY12" fmla="*/ 6297163 h 6857996"/>
              <a:gd name="connsiteX13" fmla="*/ 2275288 w 12191993"/>
              <a:gd name="connsiteY13" fmla="*/ 6368835 h 6857996"/>
              <a:gd name="connsiteX14" fmla="*/ 2217552 w 12191993"/>
              <a:gd name="connsiteY14" fmla="*/ 6440507 h 6857996"/>
              <a:gd name="connsiteX15" fmla="*/ 2161116 w 12191993"/>
              <a:gd name="connsiteY15" fmla="*/ 6369160 h 6857996"/>
              <a:gd name="connsiteX16" fmla="*/ 2218851 w 12191993"/>
              <a:gd name="connsiteY16" fmla="*/ 6297163 h 6857996"/>
              <a:gd name="connsiteX17" fmla="*/ 1782667 w 12191993"/>
              <a:gd name="connsiteY17" fmla="*/ 6296514 h 6857996"/>
              <a:gd name="connsiteX18" fmla="*/ 1834887 w 12191993"/>
              <a:gd name="connsiteY18" fmla="*/ 6353915 h 6857996"/>
              <a:gd name="connsiteX19" fmla="*/ 1719416 w 12191993"/>
              <a:gd name="connsiteY19" fmla="*/ 6353915 h 6857996"/>
              <a:gd name="connsiteX20" fmla="*/ 1782667 w 12191993"/>
              <a:gd name="connsiteY20" fmla="*/ 6296514 h 6857996"/>
              <a:gd name="connsiteX21" fmla="*/ 2293320 w 12191993"/>
              <a:gd name="connsiteY21" fmla="*/ 6287757 h 6857996"/>
              <a:gd name="connsiteX22" fmla="*/ 2360462 w 12191993"/>
              <a:gd name="connsiteY22" fmla="*/ 6448936 h 6857996"/>
              <a:gd name="connsiteX23" fmla="*/ 2348783 w 12191993"/>
              <a:gd name="connsiteY23" fmla="*/ 6475855 h 6857996"/>
              <a:gd name="connsiteX24" fmla="*/ 2316996 w 12191993"/>
              <a:gd name="connsiteY24" fmla="*/ 6505042 h 6857996"/>
              <a:gd name="connsiteX25" fmla="*/ 2296883 w 12191993"/>
              <a:gd name="connsiteY25" fmla="*/ 6497259 h 6857996"/>
              <a:gd name="connsiteX26" fmla="*/ 2290722 w 12191993"/>
              <a:gd name="connsiteY26" fmla="*/ 6508934 h 6857996"/>
              <a:gd name="connsiteX27" fmla="*/ 2316996 w 12191993"/>
              <a:gd name="connsiteY27" fmla="*/ 6518015 h 6857996"/>
              <a:gd name="connsiteX28" fmla="*/ 2358190 w 12191993"/>
              <a:gd name="connsiteY28" fmla="*/ 6487853 h 6857996"/>
              <a:gd name="connsiteX29" fmla="*/ 2441550 w 12191993"/>
              <a:gd name="connsiteY29" fmla="*/ 6287757 h 6857996"/>
              <a:gd name="connsiteX30" fmla="*/ 2426956 w 12191993"/>
              <a:gd name="connsiteY30" fmla="*/ 6287757 h 6857996"/>
              <a:gd name="connsiteX31" fmla="*/ 2373434 w 12191993"/>
              <a:gd name="connsiteY31" fmla="*/ 6417155 h 6857996"/>
              <a:gd name="connsiteX32" fmla="*/ 2367922 w 12191993"/>
              <a:gd name="connsiteY32" fmla="*/ 6432396 h 6857996"/>
              <a:gd name="connsiteX33" fmla="*/ 2367272 w 12191993"/>
              <a:gd name="connsiteY33" fmla="*/ 6432396 h 6857996"/>
              <a:gd name="connsiteX34" fmla="*/ 2361429 w 12191993"/>
              <a:gd name="connsiteY34" fmla="*/ 6417155 h 6857996"/>
              <a:gd name="connsiteX35" fmla="*/ 2307914 w 12191993"/>
              <a:gd name="connsiteY35" fmla="*/ 6287757 h 6857996"/>
              <a:gd name="connsiteX36" fmla="*/ 1560161 w 12191993"/>
              <a:gd name="connsiteY36" fmla="*/ 6287757 h 6857996"/>
              <a:gd name="connsiteX37" fmla="*/ 1624058 w 12191993"/>
              <a:gd name="connsiteY37" fmla="*/ 6449909 h 6857996"/>
              <a:gd name="connsiteX38" fmla="*/ 1637032 w 12191993"/>
              <a:gd name="connsiteY38" fmla="*/ 6449909 h 6857996"/>
              <a:gd name="connsiteX39" fmla="*/ 1700608 w 12191993"/>
              <a:gd name="connsiteY39" fmla="*/ 6287757 h 6857996"/>
              <a:gd name="connsiteX40" fmla="*/ 1686334 w 12191993"/>
              <a:gd name="connsiteY40" fmla="*/ 6287757 h 6857996"/>
              <a:gd name="connsiteX41" fmla="*/ 1636383 w 12191993"/>
              <a:gd name="connsiteY41" fmla="*/ 6414887 h 6857996"/>
              <a:gd name="connsiteX42" fmla="*/ 1630868 w 12191993"/>
              <a:gd name="connsiteY42" fmla="*/ 6432396 h 6857996"/>
              <a:gd name="connsiteX43" fmla="*/ 1630218 w 12191993"/>
              <a:gd name="connsiteY43" fmla="*/ 6432396 h 6857996"/>
              <a:gd name="connsiteX44" fmla="*/ 1624707 w 12191993"/>
              <a:gd name="connsiteY44" fmla="*/ 6414887 h 6857996"/>
              <a:gd name="connsiteX45" fmla="*/ 1574755 w 12191993"/>
              <a:gd name="connsiteY45" fmla="*/ 6287757 h 6857996"/>
              <a:gd name="connsiteX46" fmla="*/ 1526463 w 12191993"/>
              <a:gd name="connsiteY46" fmla="*/ 6287757 h 6857996"/>
              <a:gd name="connsiteX47" fmla="*/ 1526463 w 12191993"/>
              <a:gd name="connsiteY47" fmla="*/ 6449909 h 6857996"/>
              <a:gd name="connsiteX48" fmla="*/ 1540087 w 12191993"/>
              <a:gd name="connsiteY48" fmla="*/ 6449909 h 6857996"/>
              <a:gd name="connsiteX49" fmla="*/ 1540087 w 12191993"/>
              <a:gd name="connsiteY49" fmla="*/ 6287757 h 6857996"/>
              <a:gd name="connsiteX50" fmla="*/ 1496207 w 12191993"/>
              <a:gd name="connsiteY50" fmla="*/ 6286463 h 6857996"/>
              <a:gd name="connsiteX51" fmla="*/ 1444311 w 12191993"/>
              <a:gd name="connsiteY51" fmla="*/ 6331866 h 6857996"/>
              <a:gd name="connsiteX52" fmla="*/ 1443661 w 12191993"/>
              <a:gd name="connsiteY52" fmla="*/ 6331866 h 6857996"/>
              <a:gd name="connsiteX53" fmla="*/ 1444960 w 12191993"/>
              <a:gd name="connsiteY53" fmla="*/ 6318568 h 6857996"/>
              <a:gd name="connsiteX54" fmla="*/ 1444960 w 12191993"/>
              <a:gd name="connsiteY54" fmla="*/ 6287757 h 6857996"/>
              <a:gd name="connsiteX55" fmla="*/ 1431332 w 12191993"/>
              <a:gd name="connsiteY55" fmla="*/ 6287757 h 6857996"/>
              <a:gd name="connsiteX56" fmla="*/ 1431332 w 12191993"/>
              <a:gd name="connsiteY56" fmla="*/ 6449910 h 6857996"/>
              <a:gd name="connsiteX57" fmla="*/ 1444960 w 12191993"/>
              <a:gd name="connsiteY57" fmla="*/ 6449910 h 6857996"/>
              <a:gd name="connsiteX58" fmla="*/ 1444960 w 12191993"/>
              <a:gd name="connsiteY58" fmla="*/ 6379861 h 6857996"/>
              <a:gd name="connsiteX59" fmla="*/ 1449821 w 12191993"/>
              <a:gd name="connsiteY59" fmla="*/ 6345808 h 6857996"/>
              <a:gd name="connsiteX60" fmla="*/ 1498150 w 12191993"/>
              <a:gd name="connsiteY60" fmla="*/ 6300406 h 6857996"/>
              <a:gd name="connsiteX61" fmla="*/ 1505609 w 12191993"/>
              <a:gd name="connsiteY61" fmla="*/ 6301055 h 6857996"/>
              <a:gd name="connsiteX62" fmla="*/ 1505609 w 12191993"/>
              <a:gd name="connsiteY62" fmla="*/ 6287433 h 6857996"/>
              <a:gd name="connsiteX63" fmla="*/ 1496207 w 12191993"/>
              <a:gd name="connsiteY63" fmla="*/ 6286463 h 6857996"/>
              <a:gd name="connsiteX64" fmla="*/ 2833876 w 12191993"/>
              <a:gd name="connsiteY64" fmla="*/ 6285815 h 6857996"/>
              <a:gd name="connsiteX65" fmla="*/ 2833876 w 12191993"/>
              <a:gd name="connsiteY65" fmla="*/ 6449910 h 6857996"/>
              <a:gd name="connsiteX66" fmla="*/ 2865337 w 12191993"/>
              <a:gd name="connsiteY66" fmla="*/ 6449910 h 6857996"/>
              <a:gd name="connsiteX67" fmla="*/ 2865337 w 12191993"/>
              <a:gd name="connsiteY67" fmla="*/ 6285815 h 6857996"/>
              <a:gd name="connsiteX68" fmla="*/ 1962617 w 12191993"/>
              <a:gd name="connsiteY68" fmla="*/ 6283866 h 6857996"/>
              <a:gd name="connsiteX69" fmla="*/ 1893850 w 12191993"/>
              <a:gd name="connsiteY69" fmla="*/ 6329593 h 6857996"/>
              <a:gd name="connsiteX70" fmla="*/ 1893201 w 12191993"/>
              <a:gd name="connsiteY70" fmla="*/ 6329593 h 6857996"/>
              <a:gd name="connsiteX71" fmla="*/ 1894499 w 12191993"/>
              <a:gd name="connsiteY71" fmla="*/ 6316296 h 6857996"/>
              <a:gd name="connsiteX72" fmla="*/ 1894499 w 12191993"/>
              <a:gd name="connsiteY72" fmla="*/ 6287757 h 6857996"/>
              <a:gd name="connsiteX73" fmla="*/ 1880875 w 12191993"/>
              <a:gd name="connsiteY73" fmla="*/ 6287757 h 6857996"/>
              <a:gd name="connsiteX74" fmla="*/ 1880875 w 12191993"/>
              <a:gd name="connsiteY74" fmla="*/ 6449909 h 6857996"/>
              <a:gd name="connsiteX75" fmla="*/ 1894500 w 12191993"/>
              <a:gd name="connsiteY75" fmla="*/ 6449909 h 6857996"/>
              <a:gd name="connsiteX76" fmla="*/ 1894500 w 12191993"/>
              <a:gd name="connsiteY76" fmla="*/ 6370779 h 6857996"/>
              <a:gd name="connsiteX77" fmla="*/ 1897093 w 12191993"/>
              <a:gd name="connsiteY77" fmla="*/ 6348730 h 6857996"/>
              <a:gd name="connsiteX78" fmla="*/ 1962617 w 12191993"/>
              <a:gd name="connsiteY78" fmla="*/ 6297163 h 6857996"/>
              <a:gd name="connsiteX79" fmla="*/ 2002511 w 12191993"/>
              <a:gd name="connsiteY79" fmla="*/ 6351972 h 6857996"/>
              <a:gd name="connsiteX80" fmla="*/ 2002511 w 12191993"/>
              <a:gd name="connsiteY80" fmla="*/ 6449909 h 6857996"/>
              <a:gd name="connsiteX81" fmla="*/ 2016132 w 12191993"/>
              <a:gd name="connsiteY81" fmla="*/ 6449909 h 6857996"/>
              <a:gd name="connsiteX82" fmla="*/ 2016132 w 12191993"/>
              <a:gd name="connsiteY82" fmla="*/ 6347107 h 6857996"/>
              <a:gd name="connsiteX83" fmla="*/ 1962617 w 12191993"/>
              <a:gd name="connsiteY83" fmla="*/ 6283866 h 6857996"/>
              <a:gd name="connsiteX84" fmla="*/ 1782992 w 12191993"/>
              <a:gd name="connsiteY84" fmla="*/ 6283866 h 6857996"/>
              <a:gd name="connsiteX85" fmla="*/ 1704172 w 12191993"/>
              <a:gd name="connsiteY85" fmla="*/ 6369160 h 6857996"/>
              <a:gd name="connsiteX86" fmla="*/ 1787858 w 12191993"/>
              <a:gd name="connsiteY86" fmla="*/ 6453801 h 6857996"/>
              <a:gd name="connsiteX87" fmla="*/ 1845593 w 12191993"/>
              <a:gd name="connsiteY87" fmla="*/ 6431427 h 6857996"/>
              <a:gd name="connsiteX88" fmla="*/ 1838134 w 12191993"/>
              <a:gd name="connsiteY88" fmla="*/ 6420073 h 6857996"/>
              <a:gd name="connsiteX89" fmla="*/ 1787858 w 12191993"/>
              <a:gd name="connsiteY89" fmla="*/ 6440508 h 6857996"/>
              <a:gd name="connsiteX90" fmla="*/ 1718442 w 12191993"/>
              <a:gd name="connsiteY90" fmla="*/ 6366563 h 6857996"/>
              <a:gd name="connsiteX91" fmla="*/ 1848511 w 12191993"/>
              <a:gd name="connsiteY91" fmla="*/ 6366563 h 6857996"/>
              <a:gd name="connsiteX92" fmla="*/ 1849161 w 12191993"/>
              <a:gd name="connsiteY92" fmla="*/ 6357807 h 6857996"/>
              <a:gd name="connsiteX93" fmla="*/ 1782992 w 12191993"/>
              <a:gd name="connsiteY93" fmla="*/ 6283866 h 6857996"/>
              <a:gd name="connsiteX94" fmla="*/ 3482643 w 12191993"/>
              <a:gd name="connsiteY94" fmla="*/ 6281922 h 6857996"/>
              <a:gd name="connsiteX95" fmla="*/ 3400581 w 12191993"/>
              <a:gd name="connsiteY95" fmla="*/ 6367862 h 6857996"/>
              <a:gd name="connsiteX96" fmla="*/ 3487504 w 12191993"/>
              <a:gd name="connsiteY96" fmla="*/ 6453801 h 6857996"/>
              <a:gd name="connsiteX97" fmla="*/ 3551085 w 12191993"/>
              <a:gd name="connsiteY97" fmla="*/ 6430452 h 6857996"/>
              <a:gd name="connsiteX98" fmla="*/ 3538105 w 12191993"/>
              <a:gd name="connsiteY98" fmla="*/ 6407425 h 6857996"/>
              <a:gd name="connsiteX99" fmla="*/ 3489453 w 12191993"/>
              <a:gd name="connsiteY99" fmla="*/ 6426561 h 6857996"/>
              <a:gd name="connsiteX100" fmla="*/ 3433015 w 12191993"/>
              <a:gd name="connsiteY100" fmla="*/ 6372402 h 6857996"/>
              <a:gd name="connsiteX101" fmla="*/ 3552700 w 12191993"/>
              <a:gd name="connsiteY101" fmla="*/ 6372402 h 6857996"/>
              <a:gd name="connsiteX102" fmla="*/ 3553673 w 12191993"/>
              <a:gd name="connsiteY102" fmla="*/ 6358780 h 6857996"/>
              <a:gd name="connsiteX103" fmla="*/ 3482643 w 12191993"/>
              <a:gd name="connsiteY103" fmla="*/ 6281922 h 6857996"/>
              <a:gd name="connsiteX104" fmla="*/ 3328545 w 12191993"/>
              <a:gd name="connsiteY104" fmla="*/ 6281922 h 6857996"/>
              <a:gd name="connsiteX105" fmla="*/ 3240639 w 12191993"/>
              <a:gd name="connsiteY105" fmla="*/ 6367862 h 6857996"/>
              <a:gd name="connsiteX106" fmla="*/ 3328545 w 12191993"/>
              <a:gd name="connsiteY106" fmla="*/ 6453801 h 6857996"/>
              <a:gd name="connsiteX107" fmla="*/ 3394065 w 12191993"/>
              <a:gd name="connsiteY107" fmla="*/ 6427535 h 6857996"/>
              <a:gd name="connsiteX108" fmla="*/ 3381411 w 12191993"/>
              <a:gd name="connsiteY108" fmla="*/ 6404507 h 6857996"/>
              <a:gd name="connsiteX109" fmla="*/ 3330810 w 12191993"/>
              <a:gd name="connsiteY109" fmla="*/ 6426561 h 6857996"/>
              <a:gd name="connsiteX110" fmla="*/ 3272749 w 12191993"/>
              <a:gd name="connsiteY110" fmla="*/ 6367536 h 6857996"/>
              <a:gd name="connsiteX111" fmla="*/ 3329836 w 12191993"/>
              <a:gd name="connsiteY111" fmla="*/ 6309162 h 6857996"/>
              <a:gd name="connsiteX112" fmla="*/ 3375250 w 12191993"/>
              <a:gd name="connsiteY112" fmla="*/ 6327973 h 6857996"/>
              <a:gd name="connsiteX113" fmla="*/ 3390169 w 12191993"/>
              <a:gd name="connsiteY113" fmla="*/ 6305919 h 6857996"/>
              <a:gd name="connsiteX114" fmla="*/ 3328545 w 12191993"/>
              <a:gd name="connsiteY114" fmla="*/ 6281922 h 6857996"/>
              <a:gd name="connsiteX115" fmla="*/ 3161340 w 12191993"/>
              <a:gd name="connsiteY115" fmla="*/ 6281922 h 6857996"/>
              <a:gd name="connsiteX116" fmla="*/ 3099708 w 12191993"/>
              <a:gd name="connsiteY116" fmla="*/ 6319542 h 6857996"/>
              <a:gd name="connsiteX117" fmla="*/ 3099059 w 12191993"/>
              <a:gd name="connsiteY117" fmla="*/ 6319542 h 6857996"/>
              <a:gd name="connsiteX118" fmla="*/ 3099708 w 12191993"/>
              <a:gd name="connsiteY118" fmla="*/ 6307543 h 6857996"/>
              <a:gd name="connsiteX119" fmla="*/ 3099708 w 12191993"/>
              <a:gd name="connsiteY119" fmla="*/ 6285814 h 6857996"/>
              <a:gd name="connsiteX120" fmla="*/ 3069221 w 12191993"/>
              <a:gd name="connsiteY120" fmla="*/ 6285814 h 6857996"/>
              <a:gd name="connsiteX121" fmla="*/ 3069221 w 12191993"/>
              <a:gd name="connsiteY121" fmla="*/ 6449909 h 6857996"/>
              <a:gd name="connsiteX122" fmla="*/ 3100682 w 12191993"/>
              <a:gd name="connsiteY122" fmla="*/ 6449909 h 6857996"/>
              <a:gd name="connsiteX123" fmla="*/ 3100682 w 12191993"/>
              <a:gd name="connsiteY123" fmla="*/ 6373051 h 6857996"/>
              <a:gd name="connsiteX124" fmla="*/ 3103280 w 12191993"/>
              <a:gd name="connsiteY124" fmla="*/ 6350997 h 6857996"/>
              <a:gd name="connsiteX125" fmla="*/ 3155171 w 12191993"/>
              <a:gd name="connsiteY125" fmla="*/ 6310785 h 6857996"/>
              <a:gd name="connsiteX126" fmla="*/ 3186316 w 12191993"/>
              <a:gd name="connsiteY126" fmla="*/ 6351971 h 6857996"/>
              <a:gd name="connsiteX127" fmla="*/ 3186316 w 12191993"/>
              <a:gd name="connsiteY127" fmla="*/ 6449909 h 6857996"/>
              <a:gd name="connsiteX128" fmla="*/ 3217777 w 12191993"/>
              <a:gd name="connsiteY128" fmla="*/ 6449909 h 6857996"/>
              <a:gd name="connsiteX129" fmla="*/ 3217777 w 12191993"/>
              <a:gd name="connsiteY129" fmla="*/ 6344838 h 6857996"/>
              <a:gd name="connsiteX130" fmla="*/ 3161340 w 12191993"/>
              <a:gd name="connsiteY130" fmla="*/ 6281922 h 6857996"/>
              <a:gd name="connsiteX131" fmla="*/ 2972280 w 12191993"/>
              <a:gd name="connsiteY131" fmla="*/ 6281922 h 6857996"/>
              <a:gd name="connsiteX132" fmla="*/ 2890218 w 12191993"/>
              <a:gd name="connsiteY132" fmla="*/ 6367862 h 6857996"/>
              <a:gd name="connsiteX133" fmla="*/ 2977142 w 12191993"/>
              <a:gd name="connsiteY133" fmla="*/ 6453801 h 6857996"/>
              <a:gd name="connsiteX134" fmla="*/ 3040722 w 12191993"/>
              <a:gd name="connsiteY134" fmla="*/ 6430452 h 6857996"/>
              <a:gd name="connsiteX135" fmla="*/ 3027743 w 12191993"/>
              <a:gd name="connsiteY135" fmla="*/ 6407425 h 6857996"/>
              <a:gd name="connsiteX136" fmla="*/ 2979090 w 12191993"/>
              <a:gd name="connsiteY136" fmla="*/ 6426561 h 6857996"/>
              <a:gd name="connsiteX137" fmla="*/ 2922653 w 12191993"/>
              <a:gd name="connsiteY137" fmla="*/ 6372402 h 6857996"/>
              <a:gd name="connsiteX138" fmla="*/ 3042338 w 12191993"/>
              <a:gd name="connsiteY138" fmla="*/ 6372402 h 6857996"/>
              <a:gd name="connsiteX139" fmla="*/ 3043311 w 12191993"/>
              <a:gd name="connsiteY139" fmla="*/ 6358780 h 6857996"/>
              <a:gd name="connsiteX140" fmla="*/ 2972280 w 12191993"/>
              <a:gd name="connsiteY140" fmla="*/ 6281922 h 6857996"/>
              <a:gd name="connsiteX141" fmla="*/ 2748837 w 12191993"/>
              <a:gd name="connsiteY141" fmla="*/ 6281922 h 6857996"/>
              <a:gd name="connsiteX142" fmla="*/ 2660931 w 12191993"/>
              <a:gd name="connsiteY142" fmla="*/ 6367862 h 6857996"/>
              <a:gd name="connsiteX143" fmla="*/ 2748837 w 12191993"/>
              <a:gd name="connsiteY143" fmla="*/ 6453801 h 6857996"/>
              <a:gd name="connsiteX144" fmla="*/ 2814356 w 12191993"/>
              <a:gd name="connsiteY144" fmla="*/ 6427535 h 6857996"/>
              <a:gd name="connsiteX145" fmla="*/ 2801703 w 12191993"/>
              <a:gd name="connsiteY145" fmla="*/ 6404507 h 6857996"/>
              <a:gd name="connsiteX146" fmla="*/ 2751101 w 12191993"/>
              <a:gd name="connsiteY146" fmla="*/ 6426561 h 6857996"/>
              <a:gd name="connsiteX147" fmla="*/ 2693040 w 12191993"/>
              <a:gd name="connsiteY147" fmla="*/ 6367536 h 6857996"/>
              <a:gd name="connsiteX148" fmla="*/ 2750128 w 12191993"/>
              <a:gd name="connsiteY148" fmla="*/ 6309162 h 6857996"/>
              <a:gd name="connsiteX149" fmla="*/ 2795541 w 12191993"/>
              <a:gd name="connsiteY149" fmla="*/ 6327973 h 6857996"/>
              <a:gd name="connsiteX150" fmla="*/ 2810461 w 12191993"/>
              <a:gd name="connsiteY150" fmla="*/ 6305919 h 6857996"/>
              <a:gd name="connsiteX151" fmla="*/ 2748837 w 12191993"/>
              <a:gd name="connsiteY151" fmla="*/ 6281922 h 6857996"/>
              <a:gd name="connsiteX152" fmla="*/ 2593020 w 12191993"/>
              <a:gd name="connsiteY152" fmla="*/ 6281922 h 6857996"/>
              <a:gd name="connsiteX153" fmla="*/ 2533661 w 12191993"/>
              <a:gd name="connsiteY153" fmla="*/ 6328619 h 6857996"/>
              <a:gd name="connsiteX154" fmla="*/ 2617996 w 12191993"/>
              <a:gd name="connsiteY154" fmla="*/ 6406130 h 6857996"/>
              <a:gd name="connsiteX155" fmla="*/ 2590747 w 12191993"/>
              <a:gd name="connsiteY155" fmla="*/ 6426561 h 6857996"/>
              <a:gd name="connsiteX156" fmla="*/ 2543718 w 12191993"/>
              <a:gd name="connsiteY156" fmla="*/ 6407425 h 6857996"/>
              <a:gd name="connsiteX157" fmla="*/ 2528466 w 12191993"/>
              <a:gd name="connsiteY157" fmla="*/ 6429803 h 6857996"/>
              <a:gd name="connsiteX158" fmla="*/ 2590747 w 12191993"/>
              <a:gd name="connsiteY158" fmla="*/ 6453801 h 6857996"/>
              <a:gd name="connsiteX159" fmla="*/ 2650106 w 12191993"/>
              <a:gd name="connsiteY159" fmla="*/ 6406130 h 6857996"/>
              <a:gd name="connsiteX160" fmla="*/ 2565771 w 12191993"/>
              <a:gd name="connsiteY160" fmla="*/ 6329268 h 6857996"/>
              <a:gd name="connsiteX161" fmla="*/ 2592695 w 12191993"/>
              <a:gd name="connsiteY161" fmla="*/ 6309162 h 6857996"/>
              <a:gd name="connsiteX162" fmla="*/ 2633239 w 12191993"/>
              <a:gd name="connsiteY162" fmla="*/ 6323757 h 6857996"/>
              <a:gd name="connsiteX163" fmla="*/ 2645885 w 12191993"/>
              <a:gd name="connsiteY163" fmla="*/ 6300081 h 6857996"/>
              <a:gd name="connsiteX164" fmla="*/ 2593020 w 12191993"/>
              <a:gd name="connsiteY164" fmla="*/ 6281922 h 6857996"/>
              <a:gd name="connsiteX165" fmla="*/ 1223619 w 12191993"/>
              <a:gd name="connsiteY165" fmla="*/ 6235871 h 6857996"/>
              <a:gd name="connsiteX166" fmla="*/ 1278761 w 12191993"/>
              <a:gd name="connsiteY166" fmla="*/ 6235871 h 6857996"/>
              <a:gd name="connsiteX167" fmla="*/ 1379638 w 12191993"/>
              <a:gd name="connsiteY167" fmla="*/ 6336406 h 6857996"/>
              <a:gd name="connsiteX168" fmla="*/ 1278761 w 12191993"/>
              <a:gd name="connsiteY168" fmla="*/ 6436937 h 6857996"/>
              <a:gd name="connsiteX169" fmla="*/ 1223619 w 12191993"/>
              <a:gd name="connsiteY169" fmla="*/ 6436937 h 6857996"/>
              <a:gd name="connsiteX170" fmla="*/ 2147812 w 12191993"/>
              <a:gd name="connsiteY170" fmla="*/ 6222898 h 6857996"/>
              <a:gd name="connsiteX171" fmla="*/ 2147812 w 12191993"/>
              <a:gd name="connsiteY171" fmla="*/ 6449909 h 6857996"/>
              <a:gd name="connsiteX172" fmla="*/ 2161440 w 12191993"/>
              <a:gd name="connsiteY172" fmla="*/ 6449909 h 6857996"/>
              <a:gd name="connsiteX173" fmla="*/ 2161440 w 12191993"/>
              <a:gd name="connsiteY173" fmla="*/ 6431426 h 6857996"/>
              <a:gd name="connsiteX174" fmla="*/ 2160141 w 12191993"/>
              <a:gd name="connsiteY174" fmla="*/ 6417155 h 6857996"/>
              <a:gd name="connsiteX175" fmla="*/ 2160791 w 12191993"/>
              <a:gd name="connsiteY175" fmla="*/ 6417155 h 6857996"/>
              <a:gd name="connsiteX176" fmla="*/ 2216903 w 12191993"/>
              <a:gd name="connsiteY176" fmla="*/ 6453801 h 6857996"/>
              <a:gd name="connsiteX177" fmla="*/ 2289558 w 12191993"/>
              <a:gd name="connsiteY177" fmla="*/ 6368835 h 6857996"/>
              <a:gd name="connsiteX178" fmla="*/ 2219501 w 12191993"/>
              <a:gd name="connsiteY178" fmla="*/ 6283866 h 6857996"/>
              <a:gd name="connsiteX179" fmla="*/ 2160791 w 12191993"/>
              <a:gd name="connsiteY179" fmla="*/ 6320511 h 6857996"/>
              <a:gd name="connsiteX180" fmla="*/ 2160141 w 12191993"/>
              <a:gd name="connsiteY180" fmla="*/ 6320511 h 6857996"/>
              <a:gd name="connsiteX181" fmla="*/ 2161440 w 12191993"/>
              <a:gd name="connsiteY181" fmla="*/ 6307218 h 6857996"/>
              <a:gd name="connsiteX182" fmla="*/ 2161440 w 12191993"/>
              <a:gd name="connsiteY182" fmla="*/ 6222898 h 6857996"/>
              <a:gd name="connsiteX183" fmla="*/ 1525168 w 12191993"/>
              <a:gd name="connsiteY183" fmla="*/ 6222898 h 6857996"/>
              <a:gd name="connsiteX184" fmla="*/ 1525168 w 12191993"/>
              <a:gd name="connsiteY184" fmla="*/ 6246571 h 6857996"/>
              <a:gd name="connsiteX185" fmla="*/ 1541386 w 12191993"/>
              <a:gd name="connsiteY185" fmla="*/ 6246571 h 6857996"/>
              <a:gd name="connsiteX186" fmla="*/ 1541386 w 12191993"/>
              <a:gd name="connsiteY186" fmla="*/ 6222898 h 6857996"/>
              <a:gd name="connsiteX187" fmla="*/ 1209670 w 12191993"/>
              <a:gd name="connsiteY187" fmla="*/ 6222898 h 6857996"/>
              <a:gd name="connsiteX188" fmla="*/ 1209670 w 12191993"/>
              <a:gd name="connsiteY188" fmla="*/ 6449909 h 6857996"/>
              <a:gd name="connsiteX189" fmla="*/ 1281034 w 12191993"/>
              <a:gd name="connsiteY189" fmla="*/ 6449909 h 6857996"/>
              <a:gd name="connsiteX190" fmla="*/ 1394232 w 12191993"/>
              <a:gd name="connsiteY190" fmla="*/ 6336406 h 6857996"/>
              <a:gd name="connsiteX191" fmla="*/ 1281034 w 12191993"/>
              <a:gd name="connsiteY191" fmla="*/ 6222898 h 6857996"/>
              <a:gd name="connsiteX192" fmla="*/ 2833551 w 12191993"/>
              <a:gd name="connsiteY192" fmla="*/ 6220951 h 6857996"/>
              <a:gd name="connsiteX193" fmla="*/ 2833551 w 12191993"/>
              <a:gd name="connsiteY193" fmla="*/ 6253060 h 6857996"/>
              <a:gd name="connsiteX194" fmla="*/ 2865337 w 12191993"/>
              <a:gd name="connsiteY194" fmla="*/ 6253060 h 6857996"/>
              <a:gd name="connsiteX195" fmla="*/ 2865337 w 12191993"/>
              <a:gd name="connsiteY195" fmla="*/ 6220951 h 6857996"/>
              <a:gd name="connsiteX196" fmla="*/ 982628 w 12191993"/>
              <a:gd name="connsiteY196" fmla="*/ 6207360 h 6857996"/>
              <a:gd name="connsiteX197" fmla="*/ 740053 w 12191993"/>
              <a:gd name="connsiteY197" fmla="*/ 6449905 h 6857996"/>
              <a:gd name="connsiteX198" fmla="*/ 982628 w 12191993"/>
              <a:gd name="connsiteY198" fmla="*/ 6449909 h 6857996"/>
              <a:gd name="connsiteX199" fmla="*/ 407989 w 12191993"/>
              <a:gd name="connsiteY199" fmla="*/ 6207356 h 6857996"/>
              <a:gd name="connsiteX200" fmla="*/ 407989 w 12191993"/>
              <a:gd name="connsiteY200" fmla="*/ 6449905 h 6857996"/>
              <a:gd name="connsiteX201" fmla="*/ 650564 w 12191993"/>
              <a:gd name="connsiteY201" fmla="*/ 6449905 h 6857996"/>
              <a:gd name="connsiteX202" fmla="*/ 407989 w 12191993"/>
              <a:gd name="connsiteY202" fmla="*/ 6207356 h 6857996"/>
              <a:gd name="connsiteX203" fmla="*/ 883619 w 12191993"/>
              <a:gd name="connsiteY203" fmla="*/ 6147250 h 6857996"/>
              <a:gd name="connsiteX204" fmla="*/ 915428 w 12191993"/>
              <a:gd name="connsiteY204" fmla="*/ 6147250 h 6857996"/>
              <a:gd name="connsiteX205" fmla="*/ 915428 w 12191993"/>
              <a:gd name="connsiteY205" fmla="*/ 6178023 h 6857996"/>
              <a:gd name="connsiteX206" fmla="*/ 883619 w 12191993"/>
              <a:gd name="connsiteY206" fmla="*/ 6178023 h 6857996"/>
              <a:gd name="connsiteX207" fmla="*/ 739956 w 12191993"/>
              <a:gd name="connsiteY207" fmla="*/ 6106213 h 6857996"/>
              <a:gd name="connsiteX208" fmla="*/ 739956 w 12191993"/>
              <a:gd name="connsiteY208" fmla="*/ 6219065 h 6857996"/>
              <a:gd name="connsiteX209" fmla="*/ 830261 w 12191993"/>
              <a:gd name="connsiteY209" fmla="*/ 6219065 h 6857996"/>
              <a:gd name="connsiteX210" fmla="*/ 830261 w 12191993"/>
              <a:gd name="connsiteY210" fmla="*/ 6178031 h 6857996"/>
              <a:gd name="connsiteX211" fmla="*/ 781009 w 12191993"/>
              <a:gd name="connsiteY211" fmla="*/ 6178031 h 6857996"/>
              <a:gd name="connsiteX212" fmla="*/ 781009 w 12191993"/>
              <a:gd name="connsiteY212" fmla="*/ 6147251 h 6857996"/>
              <a:gd name="connsiteX213" fmla="*/ 830261 w 12191993"/>
              <a:gd name="connsiteY213" fmla="*/ 6147251 h 6857996"/>
              <a:gd name="connsiteX214" fmla="*/ 830261 w 12191993"/>
              <a:gd name="connsiteY214" fmla="*/ 6106213 h 6857996"/>
              <a:gd name="connsiteX215" fmla="*/ 3802396 w 12191993"/>
              <a:gd name="connsiteY215" fmla="*/ 6068975 h 6857996"/>
              <a:gd name="connsiteX216" fmla="*/ 3802396 w 12191993"/>
              <a:gd name="connsiteY216" fmla="*/ 6102379 h 6857996"/>
              <a:gd name="connsiteX217" fmla="*/ 3835481 w 12191993"/>
              <a:gd name="connsiteY217" fmla="*/ 6102379 h 6857996"/>
              <a:gd name="connsiteX218" fmla="*/ 3835481 w 12191993"/>
              <a:gd name="connsiteY218" fmla="*/ 6068975 h 6857996"/>
              <a:gd name="connsiteX219" fmla="*/ 842572 w 12191993"/>
              <a:gd name="connsiteY219" fmla="*/ 6042596 h 6857996"/>
              <a:gd name="connsiteX220" fmla="*/ 842572 w 12191993"/>
              <a:gd name="connsiteY220" fmla="*/ 6219054 h 6857996"/>
              <a:gd name="connsiteX221" fmla="*/ 953399 w 12191993"/>
              <a:gd name="connsiteY221" fmla="*/ 6219054 h 6857996"/>
              <a:gd name="connsiteX222" fmla="*/ 953399 w 12191993"/>
              <a:gd name="connsiteY222" fmla="*/ 6106202 h 6857996"/>
              <a:gd name="connsiteX223" fmla="*/ 883619 w 12191993"/>
              <a:gd name="connsiteY223" fmla="*/ 6106202 h 6857996"/>
              <a:gd name="connsiteX224" fmla="*/ 883619 w 12191993"/>
              <a:gd name="connsiteY224" fmla="*/ 6042596 h 6857996"/>
              <a:gd name="connsiteX225" fmla="*/ 2979149 w 12191993"/>
              <a:gd name="connsiteY225" fmla="*/ 6023573 h 6857996"/>
              <a:gd name="connsiteX226" fmla="*/ 2987258 w 12191993"/>
              <a:gd name="connsiteY226" fmla="*/ 6023573 h 6857996"/>
              <a:gd name="connsiteX227" fmla="*/ 2987258 w 12191993"/>
              <a:gd name="connsiteY227" fmla="*/ 6028762 h 6857996"/>
              <a:gd name="connsiteX228" fmla="*/ 2943468 w 12191993"/>
              <a:gd name="connsiteY228" fmla="*/ 6080974 h 6857996"/>
              <a:gd name="connsiteX229" fmla="*/ 2912656 w 12191993"/>
              <a:gd name="connsiteY229" fmla="*/ 6054708 h 6857996"/>
              <a:gd name="connsiteX230" fmla="*/ 2979149 w 12191993"/>
              <a:gd name="connsiteY230" fmla="*/ 6023573 h 6857996"/>
              <a:gd name="connsiteX231" fmla="*/ 2790699 w 12191993"/>
              <a:gd name="connsiteY231" fmla="*/ 5961955 h 6857996"/>
              <a:gd name="connsiteX232" fmla="*/ 2837087 w 12191993"/>
              <a:gd name="connsiteY232" fmla="*/ 6020654 h 6857996"/>
              <a:gd name="connsiteX233" fmla="*/ 2789732 w 12191993"/>
              <a:gd name="connsiteY233" fmla="*/ 6079354 h 6857996"/>
              <a:gd name="connsiteX234" fmla="*/ 2743344 w 12191993"/>
              <a:gd name="connsiteY234" fmla="*/ 6020979 h 6857996"/>
              <a:gd name="connsiteX235" fmla="*/ 2790699 w 12191993"/>
              <a:gd name="connsiteY235" fmla="*/ 5961955 h 6857996"/>
              <a:gd name="connsiteX236" fmla="*/ 3285066 w 12191993"/>
              <a:gd name="connsiteY236" fmla="*/ 5959362 h 6857996"/>
              <a:gd name="connsiteX237" fmla="*/ 3324644 w 12191993"/>
              <a:gd name="connsiteY237" fmla="*/ 6001198 h 6857996"/>
              <a:gd name="connsiteX238" fmla="*/ 3237062 w 12191993"/>
              <a:gd name="connsiteY238" fmla="*/ 6001198 h 6857996"/>
              <a:gd name="connsiteX239" fmla="*/ 3285066 w 12191993"/>
              <a:gd name="connsiteY239" fmla="*/ 5959362 h 6857996"/>
              <a:gd name="connsiteX240" fmla="*/ 2389939 w 12191993"/>
              <a:gd name="connsiteY240" fmla="*/ 5949632 h 6857996"/>
              <a:gd name="connsiteX241" fmla="*/ 2446377 w 12191993"/>
              <a:gd name="connsiteY241" fmla="*/ 6021305 h 6857996"/>
              <a:gd name="connsiteX242" fmla="*/ 2388641 w 12191993"/>
              <a:gd name="connsiteY242" fmla="*/ 6092976 h 6857996"/>
              <a:gd name="connsiteX243" fmla="*/ 2332204 w 12191993"/>
              <a:gd name="connsiteY243" fmla="*/ 6021629 h 6857996"/>
              <a:gd name="connsiteX244" fmla="*/ 2389939 w 12191993"/>
              <a:gd name="connsiteY244" fmla="*/ 5949632 h 6857996"/>
              <a:gd name="connsiteX245" fmla="*/ 2115219 w 12191993"/>
              <a:gd name="connsiteY245" fmla="*/ 5949632 h 6857996"/>
              <a:gd name="connsiteX246" fmla="*/ 2171660 w 12191993"/>
              <a:gd name="connsiteY246" fmla="*/ 6020980 h 6857996"/>
              <a:gd name="connsiteX247" fmla="*/ 2113920 w 12191993"/>
              <a:gd name="connsiteY247" fmla="*/ 6092976 h 6857996"/>
              <a:gd name="connsiteX248" fmla="*/ 2057481 w 12191993"/>
              <a:gd name="connsiteY248" fmla="*/ 6021305 h 6857996"/>
              <a:gd name="connsiteX249" fmla="*/ 2115219 w 12191993"/>
              <a:gd name="connsiteY249" fmla="*/ 5949632 h 6857996"/>
              <a:gd name="connsiteX250" fmla="*/ 1641577 w 12191993"/>
              <a:gd name="connsiteY250" fmla="*/ 5949632 h 6857996"/>
              <a:gd name="connsiteX251" fmla="*/ 1698014 w 12191993"/>
              <a:gd name="connsiteY251" fmla="*/ 6021304 h 6857996"/>
              <a:gd name="connsiteX252" fmla="*/ 1640278 w 12191993"/>
              <a:gd name="connsiteY252" fmla="*/ 6092976 h 6857996"/>
              <a:gd name="connsiteX253" fmla="*/ 1583842 w 12191993"/>
              <a:gd name="connsiteY253" fmla="*/ 6021628 h 6857996"/>
              <a:gd name="connsiteX254" fmla="*/ 1641577 w 12191993"/>
              <a:gd name="connsiteY254" fmla="*/ 5949632 h 6857996"/>
              <a:gd name="connsiteX255" fmla="*/ 1954957 w 12191993"/>
              <a:gd name="connsiteY255" fmla="*/ 5948983 h 6857996"/>
              <a:gd name="connsiteX256" fmla="*/ 2007177 w 12191993"/>
              <a:gd name="connsiteY256" fmla="*/ 6006384 h 6857996"/>
              <a:gd name="connsiteX257" fmla="*/ 1891706 w 12191993"/>
              <a:gd name="connsiteY257" fmla="*/ 6006384 h 6857996"/>
              <a:gd name="connsiteX258" fmla="*/ 1954957 w 12191993"/>
              <a:gd name="connsiteY258" fmla="*/ 5948983 h 6857996"/>
              <a:gd name="connsiteX259" fmla="*/ 2464407 w 12191993"/>
              <a:gd name="connsiteY259" fmla="*/ 5940226 h 6857996"/>
              <a:gd name="connsiteX260" fmla="*/ 2531550 w 12191993"/>
              <a:gd name="connsiteY260" fmla="*/ 6101405 h 6857996"/>
              <a:gd name="connsiteX261" fmla="*/ 2519870 w 12191993"/>
              <a:gd name="connsiteY261" fmla="*/ 6128324 h 6857996"/>
              <a:gd name="connsiteX262" fmla="*/ 2488084 w 12191993"/>
              <a:gd name="connsiteY262" fmla="*/ 6157511 h 6857996"/>
              <a:gd name="connsiteX263" fmla="*/ 2467970 w 12191993"/>
              <a:gd name="connsiteY263" fmla="*/ 6149728 h 6857996"/>
              <a:gd name="connsiteX264" fmla="*/ 2461809 w 12191993"/>
              <a:gd name="connsiteY264" fmla="*/ 6161402 h 6857996"/>
              <a:gd name="connsiteX265" fmla="*/ 2488084 w 12191993"/>
              <a:gd name="connsiteY265" fmla="*/ 6170485 h 6857996"/>
              <a:gd name="connsiteX266" fmla="*/ 2529277 w 12191993"/>
              <a:gd name="connsiteY266" fmla="*/ 6140322 h 6857996"/>
              <a:gd name="connsiteX267" fmla="*/ 2612638 w 12191993"/>
              <a:gd name="connsiteY267" fmla="*/ 5940226 h 6857996"/>
              <a:gd name="connsiteX268" fmla="*/ 2598044 w 12191993"/>
              <a:gd name="connsiteY268" fmla="*/ 5940226 h 6857996"/>
              <a:gd name="connsiteX269" fmla="*/ 2544521 w 12191993"/>
              <a:gd name="connsiteY269" fmla="*/ 6069624 h 6857996"/>
              <a:gd name="connsiteX270" fmla="*/ 2539009 w 12191993"/>
              <a:gd name="connsiteY270" fmla="*/ 6084865 h 6857996"/>
              <a:gd name="connsiteX271" fmla="*/ 2538360 w 12191993"/>
              <a:gd name="connsiteY271" fmla="*/ 6084865 h 6857996"/>
              <a:gd name="connsiteX272" fmla="*/ 2532516 w 12191993"/>
              <a:gd name="connsiteY272" fmla="*/ 6069624 h 6857996"/>
              <a:gd name="connsiteX273" fmla="*/ 2479001 w 12191993"/>
              <a:gd name="connsiteY273" fmla="*/ 5940226 h 6857996"/>
              <a:gd name="connsiteX274" fmla="*/ 1744846 w 12191993"/>
              <a:gd name="connsiteY274" fmla="*/ 5940226 h 6857996"/>
              <a:gd name="connsiteX275" fmla="*/ 1744846 w 12191993"/>
              <a:gd name="connsiteY275" fmla="*/ 6102378 h 6857996"/>
              <a:gd name="connsiteX276" fmla="*/ 1758470 w 12191993"/>
              <a:gd name="connsiteY276" fmla="*/ 6102378 h 6857996"/>
              <a:gd name="connsiteX277" fmla="*/ 1758470 w 12191993"/>
              <a:gd name="connsiteY277" fmla="*/ 5940226 h 6857996"/>
              <a:gd name="connsiteX278" fmla="*/ 1864854 w 12191993"/>
              <a:gd name="connsiteY278" fmla="*/ 5938932 h 6857996"/>
              <a:gd name="connsiteX279" fmla="*/ 1812955 w 12191993"/>
              <a:gd name="connsiteY279" fmla="*/ 5984334 h 6857996"/>
              <a:gd name="connsiteX280" fmla="*/ 1812306 w 12191993"/>
              <a:gd name="connsiteY280" fmla="*/ 5984334 h 6857996"/>
              <a:gd name="connsiteX281" fmla="*/ 1813604 w 12191993"/>
              <a:gd name="connsiteY281" fmla="*/ 5971037 h 6857996"/>
              <a:gd name="connsiteX282" fmla="*/ 1813604 w 12191993"/>
              <a:gd name="connsiteY282" fmla="*/ 5940226 h 6857996"/>
              <a:gd name="connsiteX283" fmla="*/ 1799984 w 12191993"/>
              <a:gd name="connsiteY283" fmla="*/ 5940226 h 6857996"/>
              <a:gd name="connsiteX284" fmla="*/ 1799984 w 12191993"/>
              <a:gd name="connsiteY284" fmla="*/ 6102378 h 6857996"/>
              <a:gd name="connsiteX285" fmla="*/ 1813604 w 12191993"/>
              <a:gd name="connsiteY285" fmla="*/ 6102378 h 6857996"/>
              <a:gd name="connsiteX286" fmla="*/ 1813604 w 12191993"/>
              <a:gd name="connsiteY286" fmla="*/ 6032329 h 6857996"/>
              <a:gd name="connsiteX287" fmla="*/ 1818470 w 12191993"/>
              <a:gd name="connsiteY287" fmla="*/ 5998276 h 6857996"/>
              <a:gd name="connsiteX288" fmla="*/ 1866802 w 12191993"/>
              <a:gd name="connsiteY288" fmla="*/ 5952874 h 6857996"/>
              <a:gd name="connsiteX289" fmla="*/ 1874262 w 12191993"/>
              <a:gd name="connsiteY289" fmla="*/ 5953523 h 6857996"/>
              <a:gd name="connsiteX290" fmla="*/ 1874262 w 12191993"/>
              <a:gd name="connsiteY290" fmla="*/ 5939902 h 6857996"/>
              <a:gd name="connsiteX291" fmla="*/ 1864854 w 12191993"/>
              <a:gd name="connsiteY291" fmla="*/ 5938932 h 6857996"/>
              <a:gd name="connsiteX292" fmla="*/ 3147319 w 12191993"/>
              <a:gd name="connsiteY292" fmla="*/ 5938282 h 6857996"/>
              <a:gd name="connsiteX293" fmla="*/ 3147319 w 12191993"/>
              <a:gd name="connsiteY293" fmla="*/ 6102378 h 6857996"/>
              <a:gd name="connsiteX294" fmla="*/ 3178780 w 12191993"/>
              <a:gd name="connsiteY294" fmla="*/ 6102378 h 6857996"/>
              <a:gd name="connsiteX295" fmla="*/ 3178780 w 12191993"/>
              <a:gd name="connsiteY295" fmla="*/ 5938282 h 6857996"/>
              <a:gd name="connsiteX296" fmla="*/ 1955281 w 12191993"/>
              <a:gd name="connsiteY296" fmla="*/ 5936335 h 6857996"/>
              <a:gd name="connsiteX297" fmla="*/ 1876463 w 12191993"/>
              <a:gd name="connsiteY297" fmla="*/ 6021629 h 6857996"/>
              <a:gd name="connsiteX298" fmla="*/ 1960147 w 12191993"/>
              <a:gd name="connsiteY298" fmla="*/ 6106269 h 6857996"/>
              <a:gd name="connsiteX299" fmla="*/ 2017884 w 12191993"/>
              <a:gd name="connsiteY299" fmla="*/ 6083895 h 6857996"/>
              <a:gd name="connsiteX300" fmla="*/ 2010424 w 12191993"/>
              <a:gd name="connsiteY300" fmla="*/ 6072541 h 6857996"/>
              <a:gd name="connsiteX301" fmla="*/ 1960147 w 12191993"/>
              <a:gd name="connsiteY301" fmla="*/ 6092976 h 6857996"/>
              <a:gd name="connsiteX302" fmla="*/ 1890731 w 12191993"/>
              <a:gd name="connsiteY302" fmla="*/ 6019031 h 6857996"/>
              <a:gd name="connsiteX303" fmla="*/ 2020802 w 12191993"/>
              <a:gd name="connsiteY303" fmla="*/ 6019031 h 6857996"/>
              <a:gd name="connsiteX304" fmla="*/ 2021451 w 12191993"/>
              <a:gd name="connsiteY304" fmla="*/ 6010275 h 6857996"/>
              <a:gd name="connsiteX305" fmla="*/ 1955281 w 12191993"/>
              <a:gd name="connsiteY305" fmla="*/ 5936335 h 6857996"/>
              <a:gd name="connsiteX306" fmla="*/ 1642226 w 12191993"/>
              <a:gd name="connsiteY306" fmla="*/ 5936335 h 6857996"/>
              <a:gd name="connsiteX307" fmla="*/ 1583842 w 12191993"/>
              <a:gd name="connsiteY307" fmla="*/ 5972656 h 6857996"/>
              <a:gd name="connsiteX308" fmla="*/ 1583192 w 12191993"/>
              <a:gd name="connsiteY308" fmla="*/ 5972655 h 6857996"/>
              <a:gd name="connsiteX309" fmla="*/ 1584166 w 12191993"/>
              <a:gd name="connsiteY309" fmla="*/ 5959687 h 6857996"/>
              <a:gd name="connsiteX310" fmla="*/ 1584166 w 12191993"/>
              <a:gd name="connsiteY310" fmla="*/ 5940226 h 6857996"/>
              <a:gd name="connsiteX311" fmla="*/ 1570538 w 12191993"/>
              <a:gd name="connsiteY311" fmla="*/ 5940226 h 6857996"/>
              <a:gd name="connsiteX312" fmla="*/ 1570538 w 12191993"/>
              <a:gd name="connsiteY312" fmla="*/ 6167243 h 6857996"/>
              <a:gd name="connsiteX313" fmla="*/ 1584166 w 12191993"/>
              <a:gd name="connsiteY313" fmla="*/ 6167243 h 6857996"/>
              <a:gd name="connsiteX314" fmla="*/ 1584166 w 12191993"/>
              <a:gd name="connsiteY314" fmla="*/ 6083895 h 6857996"/>
              <a:gd name="connsiteX315" fmla="*/ 1582867 w 12191993"/>
              <a:gd name="connsiteY315" fmla="*/ 6069624 h 6857996"/>
              <a:gd name="connsiteX316" fmla="*/ 1583517 w 12191993"/>
              <a:gd name="connsiteY316" fmla="*/ 6069624 h 6857996"/>
              <a:gd name="connsiteX317" fmla="*/ 1640279 w 12191993"/>
              <a:gd name="connsiteY317" fmla="*/ 6106269 h 6857996"/>
              <a:gd name="connsiteX318" fmla="*/ 1712284 w 12191993"/>
              <a:gd name="connsiteY318" fmla="*/ 6021304 h 6857996"/>
              <a:gd name="connsiteX319" fmla="*/ 1642226 w 12191993"/>
              <a:gd name="connsiteY319" fmla="*/ 5936335 h 6857996"/>
              <a:gd name="connsiteX320" fmla="*/ 1489846 w 12191993"/>
              <a:gd name="connsiteY320" fmla="*/ 5936335 h 6857996"/>
              <a:gd name="connsiteX321" fmla="*/ 1437951 w 12191993"/>
              <a:gd name="connsiteY321" fmla="*/ 5980118 h 6857996"/>
              <a:gd name="connsiteX322" fmla="*/ 1527151 w 12191993"/>
              <a:gd name="connsiteY322" fmla="*/ 6062490 h 6857996"/>
              <a:gd name="connsiteX323" fmla="*/ 1489846 w 12191993"/>
              <a:gd name="connsiteY323" fmla="*/ 6092977 h 6857996"/>
              <a:gd name="connsiteX324" fmla="*/ 1439570 w 12191993"/>
              <a:gd name="connsiteY324" fmla="*/ 6072541 h 6857996"/>
              <a:gd name="connsiteX325" fmla="*/ 1430812 w 12191993"/>
              <a:gd name="connsiteY325" fmla="*/ 6082921 h 6857996"/>
              <a:gd name="connsiteX326" fmla="*/ 1489522 w 12191993"/>
              <a:gd name="connsiteY326" fmla="*/ 6106269 h 6857996"/>
              <a:gd name="connsiteX327" fmla="*/ 1541421 w 12191993"/>
              <a:gd name="connsiteY327" fmla="*/ 6062490 h 6857996"/>
              <a:gd name="connsiteX328" fmla="*/ 1452224 w 12191993"/>
              <a:gd name="connsiteY328" fmla="*/ 5979144 h 6857996"/>
              <a:gd name="connsiteX329" fmla="*/ 1488872 w 12191993"/>
              <a:gd name="connsiteY329" fmla="*/ 5949632 h 6857996"/>
              <a:gd name="connsiteX330" fmla="*/ 1529741 w 12191993"/>
              <a:gd name="connsiteY330" fmla="*/ 5964873 h 6857996"/>
              <a:gd name="connsiteX331" fmla="*/ 1537850 w 12191993"/>
              <a:gd name="connsiteY331" fmla="*/ 5953848 h 6857996"/>
              <a:gd name="connsiteX332" fmla="*/ 1489846 w 12191993"/>
              <a:gd name="connsiteY332" fmla="*/ 5936335 h 6857996"/>
              <a:gd name="connsiteX333" fmla="*/ 1352909 w 12191993"/>
              <a:gd name="connsiteY333" fmla="*/ 5936335 h 6857996"/>
              <a:gd name="connsiteX334" fmla="*/ 1284142 w 12191993"/>
              <a:gd name="connsiteY334" fmla="*/ 5982062 h 6857996"/>
              <a:gd name="connsiteX335" fmla="*/ 1283493 w 12191993"/>
              <a:gd name="connsiteY335" fmla="*/ 5982062 h 6857996"/>
              <a:gd name="connsiteX336" fmla="*/ 1284791 w 12191993"/>
              <a:gd name="connsiteY336" fmla="*/ 5968765 h 6857996"/>
              <a:gd name="connsiteX337" fmla="*/ 1284791 w 12191993"/>
              <a:gd name="connsiteY337" fmla="*/ 5940226 h 6857996"/>
              <a:gd name="connsiteX338" fmla="*/ 1271171 w 12191993"/>
              <a:gd name="connsiteY338" fmla="*/ 5940226 h 6857996"/>
              <a:gd name="connsiteX339" fmla="*/ 1271171 w 12191993"/>
              <a:gd name="connsiteY339" fmla="*/ 6102378 h 6857996"/>
              <a:gd name="connsiteX340" fmla="*/ 1284791 w 12191993"/>
              <a:gd name="connsiteY340" fmla="*/ 6102378 h 6857996"/>
              <a:gd name="connsiteX341" fmla="*/ 1284791 w 12191993"/>
              <a:gd name="connsiteY341" fmla="*/ 6023248 h 6857996"/>
              <a:gd name="connsiteX342" fmla="*/ 1287389 w 12191993"/>
              <a:gd name="connsiteY342" fmla="*/ 6001199 h 6857996"/>
              <a:gd name="connsiteX343" fmla="*/ 1352909 w 12191993"/>
              <a:gd name="connsiteY343" fmla="*/ 5949632 h 6857996"/>
              <a:gd name="connsiteX344" fmla="*/ 1392802 w 12191993"/>
              <a:gd name="connsiteY344" fmla="*/ 6004440 h 6857996"/>
              <a:gd name="connsiteX345" fmla="*/ 1392802 w 12191993"/>
              <a:gd name="connsiteY345" fmla="*/ 6102379 h 6857996"/>
              <a:gd name="connsiteX346" fmla="*/ 1406426 w 12191993"/>
              <a:gd name="connsiteY346" fmla="*/ 6102379 h 6857996"/>
              <a:gd name="connsiteX347" fmla="*/ 1406426 w 12191993"/>
              <a:gd name="connsiteY347" fmla="*/ 5999575 h 6857996"/>
              <a:gd name="connsiteX348" fmla="*/ 1352909 w 12191993"/>
              <a:gd name="connsiteY348" fmla="*/ 5936335 h 6857996"/>
              <a:gd name="connsiteX349" fmla="*/ 3474783 w 12191993"/>
              <a:gd name="connsiteY349" fmla="*/ 5934392 h 6857996"/>
              <a:gd name="connsiteX350" fmla="*/ 3413151 w 12191993"/>
              <a:gd name="connsiteY350" fmla="*/ 5972011 h 6857996"/>
              <a:gd name="connsiteX351" fmla="*/ 3412502 w 12191993"/>
              <a:gd name="connsiteY351" fmla="*/ 5972011 h 6857996"/>
              <a:gd name="connsiteX352" fmla="*/ 3413151 w 12191993"/>
              <a:gd name="connsiteY352" fmla="*/ 5960012 h 6857996"/>
              <a:gd name="connsiteX353" fmla="*/ 3413151 w 12191993"/>
              <a:gd name="connsiteY353" fmla="*/ 5938282 h 6857996"/>
              <a:gd name="connsiteX354" fmla="*/ 3382664 w 12191993"/>
              <a:gd name="connsiteY354" fmla="*/ 5938282 h 6857996"/>
              <a:gd name="connsiteX355" fmla="*/ 3382664 w 12191993"/>
              <a:gd name="connsiteY355" fmla="*/ 6102378 h 6857996"/>
              <a:gd name="connsiteX356" fmla="*/ 3414125 w 12191993"/>
              <a:gd name="connsiteY356" fmla="*/ 6102378 h 6857996"/>
              <a:gd name="connsiteX357" fmla="*/ 3414125 w 12191993"/>
              <a:gd name="connsiteY357" fmla="*/ 6025520 h 6857996"/>
              <a:gd name="connsiteX358" fmla="*/ 3416723 w 12191993"/>
              <a:gd name="connsiteY358" fmla="*/ 6003466 h 6857996"/>
              <a:gd name="connsiteX359" fmla="*/ 3468615 w 12191993"/>
              <a:gd name="connsiteY359" fmla="*/ 5963254 h 6857996"/>
              <a:gd name="connsiteX360" fmla="*/ 3499759 w 12191993"/>
              <a:gd name="connsiteY360" fmla="*/ 6004440 h 6857996"/>
              <a:gd name="connsiteX361" fmla="*/ 3499759 w 12191993"/>
              <a:gd name="connsiteY361" fmla="*/ 6102378 h 6857996"/>
              <a:gd name="connsiteX362" fmla="*/ 3531220 w 12191993"/>
              <a:gd name="connsiteY362" fmla="*/ 6102378 h 6857996"/>
              <a:gd name="connsiteX363" fmla="*/ 3531220 w 12191993"/>
              <a:gd name="connsiteY363" fmla="*/ 5997307 h 6857996"/>
              <a:gd name="connsiteX364" fmla="*/ 3474783 w 12191993"/>
              <a:gd name="connsiteY364" fmla="*/ 5934392 h 6857996"/>
              <a:gd name="connsiteX365" fmla="*/ 3717650 w 12191993"/>
              <a:gd name="connsiteY365" fmla="*/ 5934391 h 6857996"/>
              <a:gd name="connsiteX366" fmla="*/ 3658292 w 12191993"/>
              <a:gd name="connsiteY366" fmla="*/ 5981088 h 6857996"/>
              <a:gd name="connsiteX367" fmla="*/ 3742624 w 12191993"/>
              <a:gd name="connsiteY367" fmla="*/ 6058599 h 6857996"/>
              <a:gd name="connsiteX368" fmla="*/ 3715378 w 12191993"/>
              <a:gd name="connsiteY368" fmla="*/ 6079030 h 6857996"/>
              <a:gd name="connsiteX369" fmla="*/ 3668348 w 12191993"/>
              <a:gd name="connsiteY369" fmla="*/ 6059893 h 6857996"/>
              <a:gd name="connsiteX370" fmla="*/ 3653097 w 12191993"/>
              <a:gd name="connsiteY370" fmla="*/ 6082272 h 6857996"/>
              <a:gd name="connsiteX371" fmla="*/ 3715378 w 12191993"/>
              <a:gd name="connsiteY371" fmla="*/ 6106270 h 6857996"/>
              <a:gd name="connsiteX372" fmla="*/ 3774736 w 12191993"/>
              <a:gd name="connsiteY372" fmla="*/ 6058599 h 6857996"/>
              <a:gd name="connsiteX373" fmla="*/ 3690402 w 12191993"/>
              <a:gd name="connsiteY373" fmla="*/ 5981737 h 6857996"/>
              <a:gd name="connsiteX374" fmla="*/ 3717325 w 12191993"/>
              <a:gd name="connsiteY374" fmla="*/ 5961631 h 6857996"/>
              <a:gd name="connsiteX375" fmla="*/ 3757869 w 12191993"/>
              <a:gd name="connsiteY375" fmla="*/ 5976226 h 6857996"/>
              <a:gd name="connsiteX376" fmla="*/ 3770514 w 12191993"/>
              <a:gd name="connsiteY376" fmla="*/ 5952550 h 6857996"/>
              <a:gd name="connsiteX377" fmla="*/ 3717650 w 12191993"/>
              <a:gd name="connsiteY377" fmla="*/ 5934391 h 6857996"/>
              <a:gd name="connsiteX378" fmla="*/ 3285715 w 12191993"/>
              <a:gd name="connsiteY378" fmla="*/ 5934391 h 6857996"/>
              <a:gd name="connsiteX379" fmla="*/ 3203653 w 12191993"/>
              <a:gd name="connsiteY379" fmla="*/ 6020331 h 6857996"/>
              <a:gd name="connsiteX380" fmla="*/ 3290585 w 12191993"/>
              <a:gd name="connsiteY380" fmla="*/ 6106270 h 6857996"/>
              <a:gd name="connsiteX381" fmla="*/ 3354158 w 12191993"/>
              <a:gd name="connsiteY381" fmla="*/ 6082921 h 6857996"/>
              <a:gd name="connsiteX382" fmla="*/ 3341187 w 12191993"/>
              <a:gd name="connsiteY382" fmla="*/ 6059893 h 6857996"/>
              <a:gd name="connsiteX383" fmla="*/ 3292526 w 12191993"/>
              <a:gd name="connsiteY383" fmla="*/ 6079030 h 6857996"/>
              <a:gd name="connsiteX384" fmla="*/ 3236088 w 12191993"/>
              <a:gd name="connsiteY384" fmla="*/ 6024871 h 6857996"/>
              <a:gd name="connsiteX385" fmla="*/ 3355781 w 12191993"/>
              <a:gd name="connsiteY385" fmla="*/ 6024871 h 6857996"/>
              <a:gd name="connsiteX386" fmla="*/ 3356754 w 12191993"/>
              <a:gd name="connsiteY386" fmla="*/ 6011249 h 6857996"/>
              <a:gd name="connsiteX387" fmla="*/ 3285715 w 12191993"/>
              <a:gd name="connsiteY387" fmla="*/ 5934391 h 6857996"/>
              <a:gd name="connsiteX388" fmla="*/ 2953524 w 12191993"/>
              <a:gd name="connsiteY388" fmla="*/ 5934391 h 6857996"/>
              <a:gd name="connsiteX389" fmla="*/ 2892217 w 12191993"/>
              <a:gd name="connsiteY389" fmla="*/ 5953848 h 6857996"/>
              <a:gd name="connsiteX390" fmla="*/ 2905189 w 12191993"/>
              <a:gd name="connsiteY390" fmla="*/ 5976872 h 6857996"/>
              <a:gd name="connsiteX391" fmla="*/ 2950927 w 12191993"/>
              <a:gd name="connsiteY391" fmla="*/ 5960982 h 6857996"/>
              <a:gd name="connsiteX392" fmla="*/ 2986934 w 12191993"/>
              <a:gd name="connsiteY392" fmla="*/ 5996982 h 6857996"/>
              <a:gd name="connsiteX393" fmla="*/ 2986934 w 12191993"/>
              <a:gd name="connsiteY393" fmla="*/ 5999900 h 6857996"/>
              <a:gd name="connsiteX394" fmla="*/ 2979791 w 12191993"/>
              <a:gd name="connsiteY394" fmla="*/ 5999900 h 6857996"/>
              <a:gd name="connsiteX395" fmla="*/ 2880862 w 12191993"/>
              <a:gd name="connsiteY395" fmla="*/ 6056327 h 6857996"/>
              <a:gd name="connsiteX396" fmla="*/ 2936658 w 12191993"/>
              <a:gd name="connsiteY396" fmla="*/ 6106270 h 6857996"/>
              <a:gd name="connsiteX397" fmla="*/ 2989199 w 12191993"/>
              <a:gd name="connsiteY397" fmla="*/ 6073840 h 6857996"/>
              <a:gd name="connsiteX398" fmla="*/ 2989847 w 12191993"/>
              <a:gd name="connsiteY398" fmla="*/ 6073840 h 6857996"/>
              <a:gd name="connsiteX399" fmla="*/ 2989199 w 12191993"/>
              <a:gd name="connsiteY399" fmla="*/ 6086813 h 6857996"/>
              <a:gd name="connsiteX400" fmla="*/ 2989199 w 12191993"/>
              <a:gd name="connsiteY400" fmla="*/ 6102379 h 6857996"/>
              <a:gd name="connsiteX401" fmla="*/ 3018394 w 12191993"/>
              <a:gd name="connsiteY401" fmla="*/ 6102379 h 6857996"/>
              <a:gd name="connsiteX402" fmla="*/ 3018394 w 12191993"/>
              <a:gd name="connsiteY402" fmla="*/ 5998601 h 6857996"/>
              <a:gd name="connsiteX403" fmla="*/ 2953524 w 12191993"/>
              <a:gd name="connsiteY403" fmla="*/ 5934391 h 6857996"/>
              <a:gd name="connsiteX404" fmla="*/ 2796867 w 12191993"/>
              <a:gd name="connsiteY404" fmla="*/ 5934391 h 6857996"/>
              <a:gd name="connsiteX405" fmla="*/ 2741721 w 12191993"/>
              <a:gd name="connsiteY405" fmla="*/ 5964227 h 6857996"/>
              <a:gd name="connsiteX406" fmla="*/ 2741072 w 12191993"/>
              <a:gd name="connsiteY406" fmla="*/ 5964227 h 6857996"/>
              <a:gd name="connsiteX407" fmla="*/ 2741721 w 12191993"/>
              <a:gd name="connsiteY407" fmla="*/ 5952224 h 6857996"/>
              <a:gd name="connsiteX408" fmla="*/ 2741721 w 12191993"/>
              <a:gd name="connsiteY408" fmla="*/ 5938282 h 6857996"/>
              <a:gd name="connsiteX409" fmla="*/ 2712857 w 12191993"/>
              <a:gd name="connsiteY409" fmla="*/ 5938282 h 6857996"/>
              <a:gd name="connsiteX410" fmla="*/ 2712857 w 12191993"/>
              <a:gd name="connsiteY410" fmla="*/ 6167243 h 6857996"/>
              <a:gd name="connsiteX411" fmla="*/ 2744318 w 12191993"/>
              <a:gd name="connsiteY411" fmla="*/ 6167243 h 6857996"/>
              <a:gd name="connsiteX412" fmla="*/ 2744318 w 12191993"/>
              <a:gd name="connsiteY412" fmla="*/ 6093620 h 6857996"/>
              <a:gd name="connsiteX413" fmla="*/ 2743669 w 12191993"/>
              <a:gd name="connsiteY413" fmla="*/ 6079354 h 6857996"/>
              <a:gd name="connsiteX414" fmla="*/ 2744318 w 12191993"/>
              <a:gd name="connsiteY414" fmla="*/ 6079354 h 6857996"/>
              <a:gd name="connsiteX415" fmla="*/ 2794595 w 12191993"/>
              <a:gd name="connsiteY415" fmla="*/ 6106269 h 6857996"/>
              <a:gd name="connsiteX416" fmla="*/ 2868873 w 12191993"/>
              <a:gd name="connsiteY416" fmla="*/ 6020330 h 6857996"/>
              <a:gd name="connsiteX417" fmla="*/ 2796867 w 12191993"/>
              <a:gd name="connsiteY417" fmla="*/ 5934391 h 6857996"/>
              <a:gd name="connsiteX418" fmla="*/ 3568802 w 12191993"/>
              <a:gd name="connsiteY418" fmla="*/ 5893205 h 6857996"/>
              <a:gd name="connsiteX419" fmla="*/ 3568802 w 12191993"/>
              <a:gd name="connsiteY419" fmla="*/ 5940551 h 6857996"/>
              <a:gd name="connsiteX420" fmla="*/ 3546424 w 12191993"/>
              <a:gd name="connsiteY420" fmla="*/ 5940551 h 6857996"/>
              <a:gd name="connsiteX421" fmla="*/ 3546424 w 12191993"/>
              <a:gd name="connsiteY421" fmla="*/ 5965847 h 6857996"/>
              <a:gd name="connsiteX422" fmla="*/ 3567829 w 12191993"/>
              <a:gd name="connsiteY422" fmla="*/ 5965847 h 6857996"/>
              <a:gd name="connsiteX423" fmla="*/ 3567829 w 12191993"/>
              <a:gd name="connsiteY423" fmla="*/ 6042385 h 6857996"/>
              <a:gd name="connsiteX424" fmla="*/ 3630758 w 12191993"/>
              <a:gd name="connsiteY424" fmla="*/ 6103676 h 6857996"/>
              <a:gd name="connsiteX425" fmla="*/ 3641789 w 12191993"/>
              <a:gd name="connsiteY425" fmla="*/ 6103027 h 6857996"/>
              <a:gd name="connsiteX426" fmla="*/ 3641789 w 12191993"/>
              <a:gd name="connsiteY426" fmla="*/ 6075138 h 6857996"/>
              <a:gd name="connsiteX427" fmla="*/ 3634322 w 12191993"/>
              <a:gd name="connsiteY427" fmla="*/ 6075788 h 6857996"/>
              <a:gd name="connsiteX428" fmla="*/ 3599298 w 12191993"/>
              <a:gd name="connsiteY428" fmla="*/ 6038817 h 6857996"/>
              <a:gd name="connsiteX429" fmla="*/ 3599298 w 12191993"/>
              <a:gd name="connsiteY429" fmla="*/ 5965847 h 6857996"/>
              <a:gd name="connsiteX430" fmla="*/ 3638867 w 12191993"/>
              <a:gd name="connsiteY430" fmla="*/ 5965847 h 6857996"/>
              <a:gd name="connsiteX431" fmla="*/ 3638867 w 12191993"/>
              <a:gd name="connsiteY431" fmla="*/ 5940551 h 6857996"/>
              <a:gd name="connsiteX432" fmla="*/ 3599298 w 12191993"/>
              <a:gd name="connsiteY432" fmla="*/ 5940551 h 6857996"/>
              <a:gd name="connsiteX433" fmla="*/ 3599298 w 12191993"/>
              <a:gd name="connsiteY433" fmla="*/ 5893205 h 6857996"/>
              <a:gd name="connsiteX434" fmla="*/ 3055985 w 12191993"/>
              <a:gd name="connsiteY434" fmla="*/ 5893205 h 6857996"/>
              <a:gd name="connsiteX435" fmla="*/ 3055985 w 12191993"/>
              <a:gd name="connsiteY435" fmla="*/ 5940551 h 6857996"/>
              <a:gd name="connsiteX436" fmla="*/ 3033606 w 12191993"/>
              <a:gd name="connsiteY436" fmla="*/ 5940551 h 6857996"/>
              <a:gd name="connsiteX437" fmla="*/ 3033606 w 12191993"/>
              <a:gd name="connsiteY437" fmla="*/ 5965847 h 6857996"/>
              <a:gd name="connsiteX438" fmla="*/ 3055012 w 12191993"/>
              <a:gd name="connsiteY438" fmla="*/ 5965847 h 6857996"/>
              <a:gd name="connsiteX439" fmla="*/ 3055012 w 12191993"/>
              <a:gd name="connsiteY439" fmla="*/ 6042385 h 6857996"/>
              <a:gd name="connsiteX440" fmla="*/ 3117934 w 12191993"/>
              <a:gd name="connsiteY440" fmla="*/ 6103676 h 6857996"/>
              <a:gd name="connsiteX441" fmla="*/ 3128964 w 12191993"/>
              <a:gd name="connsiteY441" fmla="*/ 6103027 h 6857996"/>
              <a:gd name="connsiteX442" fmla="*/ 3128964 w 12191993"/>
              <a:gd name="connsiteY442" fmla="*/ 6075138 h 6857996"/>
              <a:gd name="connsiteX443" fmla="*/ 3121505 w 12191993"/>
              <a:gd name="connsiteY443" fmla="*/ 6075788 h 6857996"/>
              <a:gd name="connsiteX444" fmla="*/ 3086473 w 12191993"/>
              <a:gd name="connsiteY444" fmla="*/ 6038817 h 6857996"/>
              <a:gd name="connsiteX445" fmla="*/ 3086473 w 12191993"/>
              <a:gd name="connsiteY445" fmla="*/ 5965847 h 6857996"/>
              <a:gd name="connsiteX446" fmla="*/ 3126043 w 12191993"/>
              <a:gd name="connsiteY446" fmla="*/ 5965847 h 6857996"/>
              <a:gd name="connsiteX447" fmla="*/ 3126043 w 12191993"/>
              <a:gd name="connsiteY447" fmla="*/ 5940551 h 6857996"/>
              <a:gd name="connsiteX448" fmla="*/ 3086473 w 12191993"/>
              <a:gd name="connsiteY448" fmla="*/ 5940551 h 6857996"/>
              <a:gd name="connsiteX449" fmla="*/ 3086473 w 12191993"/>
              <a:gd name="connsiteY449" fmla="*/ 5893205 h 6857996"/>
              <a:gd name="connsiteX450" fmla="*/ 2318901 w 12191993"/>
              <a:gd name="connsiteY450" fmla="*/ 5875367 h 6857996"/>
              <a:gd name="connsiteX451" fmla="*/ 2318901 w 12191993"/>
              <a:gd name="connsiteY451" fmla="*/ 6102378 h 6857996"/>
              <a:gd name="connsiteX452" fmla="*/ 2332529 w 12191993"/>
              <a:gd name="connsiteY452" fmla="*/ 6102378 h 6857996"/>
              <a:gd name="connsiteX453" fmla="*/ 2332529 w 12191993"/>
              <a:gd name="connsiteY453" fmla="*/ 6083895 h 6857996"/>
              <a:gd name="connsiteX454" fmla="*/ 2331230 w 12191993"/>
              <a:gd name="connsiteY454" fmla="*/ 6069624 h 6857996"/>
              <a:gd name="connsiteX455" fmla="*/ 2331880 w 12191993"/>
              <a:gd name="connsiteY455" fmla="*/ 6069624 h 6857996"/>
              <a:gd name="connsiteX456" fmla="*/ 2387992 w 12191993"/>
              <a:gd name="connsiteY456" fmla="*/ 6106270 h 6857996"/>
              <a:gd name="connsiteX457" fmla="*/ 2460646 w 12191993"/>
              <a:gd name="connsiteY457" fmla="*/ 6021305 h 6857996"/>
              <a:gd name="connsiteX458" fmla="*/ 2390589 w 12191993"/>
              <a:gd name="connsiteY458" fmla="*/ 5936335 h 6857996"/>
              <a:gd name="connsiteX459" fmla="*/ 2331880 w 12191993"/>
              <a:gd name="connsiteY459" fmla="*/ 5972980 h 6857996"/>
              <a:gd name="connsiteX460" fmla="*/ 2331230 w 12191993"/>
              <a:gd name="connsiteY460" fmla="*/ 5972980 h 6857996"/>
              <a:gd name="connsiteX461" fmla="*/ 2332529 w 12191993"/>
              <a:gd name="connsiteY461" fmla="*/ 5959687 h 6857996"/>
              <a:gd name="connsiteX462" fmla="*/ 2332529 w 12191993"/>
              <a:gd name="connsiteY462" fmla="*/ 5875367 h 6857996"/>
              <a:gd name="connsiteX463" fmla="*/ 2171335 w 12191993"/>
              <a:gd name="connsiteY463" fmla="*/ 5875367 h 6857996"/>
              <a:gd name="connsiteX464" fmla="*/ 2171335 w 12191993"/>
              <a:gd name="connsiteY464" fmla="*/ 5959687 h 6857996"/>
              <a:gd name="connsiteX465" fmla="*/ 2172633 w 12191993"/>
              <a:gd name="connsiteY465" fmla="*/ 5972980 h 6857996"/>
              <a:gd name="connsiteX466" fmla="*/ 2171984 w 12191993"/>
              <a:gd name="connsiteY466" fmla="*/ 5972980 h 6857996"/>
              <a:gd name="connsiteX467" fmla="*/ 2115863 w 12191993"/>
              <a:gd name="connsiteY467" fmla="*/ 5936335 h 6857996"/>
              <a:gd name="connsiteX468" fmla="*/ 2043207 w 12191993"/>
              <a:gd name="connsiteY468" fmla="*/ 6021305 h 6857996"/>
              <a:gd name="connsiteX469" fmla="*/ 2113275 w 12191993"/>
              <a:gd name="connsiteY469" fmla="*/ 6106270 h 6857996"/>
              <a:gd name="connsiteX470" fmla="*/ 2171984 w 12191993"/>
              <a:gd name="connsiteY470" fmla="*/ 6069624 h 6857996"/>
              <a:gd name="connsiteX471" fmla="*/ 2172633 w 12191993"/>
              <a:gd name="connsiteY471" fmla="*/ 6069624 h 6857996"/>
              <a:gd name="connsiteX472" fmla="*/ 2171335 w 12191993"/>
              <a:gd name="connsiteY472" fmla="*/ 6081948 h 6857996"/>
              <a:gd name="connsiteX473" fmla="*/ 2171335 w 12191993"/>
              <a:gd name="connsiteY473" fmla="*/ 6102378 h 6857996"/>
              <a:gd name="connsiteX474" fmla="*/ 2184955 w 12191993"/>
              <a:gd name="connsiteY474" fmla="*/ 6102378 h 6857996"/>
              <a:gd name="connsiteX475" fmla="*/ 2184955 w 12191993"/>
              <a:gd name="connsiteY475" fmla="*/ 5875367 h 6857996"/>
              <a:gd name="connsiteX476" fmla="*/ 1743547 w 12191993"/>
              <a:gd name="connsiteY476" fmla="*/ 5875367 h 6857996"/>
              <a:gd name="connsiteX477" fmla="*/ 1743547 w 12191993"/>
              <a:gd name="connsiteY477" fmla="*/ 5899040 h 6857996"/>
              <a:gd name="connsiteX478" fmla="*/ 1759765 w 12191993"/>
              <a:gd name="connsiteY478" fmla="*/ 5899040 h 6857996"/>
              <a:gd name="connsiteX479" fmla="*/ 1759765 w 12191993"/>
              <a:gd name="connsiteY479" fmla="*/ 5875367 h 6857996"/>
              <a:gd name="connsiteX480" fmla="*/ 1209673 w 12191993"/>
              <a:gd name="connsiteY480" fmla="*/ 5875367 h 6857996"/>
              <a:gd name="connsiteX481" fmla="*/ 1209673 w 12191993"/>
              <a:gd name="connsiteY481" fmla="*/ 6102378 h 6857996"/>
              <a:gd name="connsiteX482" fmla="*/ 1223622 w 12191993"/>
              <a:gd name="connsiteY482" fmla="*/ 6102378 h 6857996"/>
              <a:gd name="connsiteX483" fmla="*/ 1223622 w 12191993"/>
              <a:gd name="connsiteY483" fmla="*/ 5875367 h 6857996"/>
              <a:gd name="connsiteX484" fmla="*/ 740045 w 12191993"/>
              <a:gd name="connsiteY484" fmla="*/ 5875367 h 6857996"/>
              <a:gd name="connsiteX485" fmla="*/ 982628 w 12191993"/>
              <a:gd name="connsiteY485" fmla="*/ 6117904 h 6857996"/>
              <a:gd name="connsiteX486" fmla="*/ 982620 w 12191993"/>
              <a:gd name="connsiteY486" fmla="*/ 5875367 h 6857996"/>
              <a:gd name="connsiteX487" fmla="*/ 407989 w 12191993"/>
              <a:gd name="connsiteY487" fmla="*/ 5875366 h 6857996"/>
              <a:gd name="connsiteX488" fmla="*/ 407989 w 12191993"/>
              <a:gd name="connsiteY488" fmla="*/ 6117901 h 6857996"/>
              <a:gd name="connsiteX489" fmla="*/ 650560 w 12191993"/>
              <a:gd name="connsiteY489" fmla="*/ 5875366 h 6857996"/>
              <a:gd name="connsiteX490" fmla="*/ 693449 w 12191993"/>
              <a:gd name="connsiteY490" fmla="*/ 5875365 h 6857996"/>
              <a:gd name="connsiteX491" fmla="*/ 693449 w 12191993"/>
              <a:gd name="connsiteY491" fmla="*/ 6106201 h 6857996"/>
              <a:gd name="connsiteX492" fmla="*/ 685251 w 12191993"/>
              <a:gd name="connsiteY492" fmla="*/ 6106201 h 6857996"/>
              <a:gd name="connsiteX493" fmla="*/ 685251 w 12191993"/>
              <a:gd name="connsiteY493" fmla="*/ 6178022 h 6857996"/>
              <a:gd name="connsiteX494" fmla="*/ 655495 w 12191993"/>
              <a:gd name="connsiteY494" fmla="*/ 6178022 h 6857996"/>
              <a:gd name="connsiteX495" fmla="*/ 655495 w 12191993"/>
              <a:gd name="connsiteY495" fmla="*/ 6106201 h 6857996"/>
              <a:gd name="connsiteX496" fmla="*/ 617524 w 12191993"/>
              <a:gd name="connsiteY496" fmla="*/ 6106201 h 6857996"/>
              <a:gd name="connsiteX497" fmla="*/ 617524 w 12191993"/>
              <a:gd name="connsiteY497" fmla="*/ 6219053 h 6857996"/>
              <a:gd name="connsiteX498" fmla="*/ 693449 w 12191993"/>
              <a:gd name="connsiteY498" fmla="*/ 6219053 h 6857996"/>
              <a:gd name="connsiteX499" fmla="*/ 693449 w 12191993"/>
              <a:gd name="connsiteY499" fmla="*/ 6449904 h 6857996"/>
              <a:gd name="connsiteX500" fmla="*/ 697158 w 12191993"/>
              <a:gd name="connsiteY500" fmla="*/ 6449904 h 6857996"/>
              <a:gd name="connsiteX501" fmla="*/ 697158 w 12191993"/>
              <a:gd name="connsiteY501" fmla="*/ 6219053 h 6857996"/>
              <a:gd name="connsiteX502" fmla="*/ 726288 w 12191993"/>
              <a:gd name="connsiteY502" fmla="*/ 6219053 h 6857996"/>
              <a:gd name="connsiteX503" fmla="*/ 726288 w 12191993"/>
              <a:gd name="connsiteY503" fmla="*/ 6106201 h 6857996"/>
              <a:gd name="connsiteX504" fmla="*/ 697158 w 12191993"/>
              <a:gd name="connsiteY504" fmla="*/ 6106201 h 6857996"/>
              <a:gd name="connsiteX505" fmla="*/ 697154 w 12191993"/>
              <a:gd name="connsiteY505" fmla="*/ 5875365 h 6857996"/>
              <a:gd name="connsiteX506" fmla="*/ 3146995 w 12191993"/>
              <a:gd name="connsiteY506" fmla="*/ 5873419 h 6857996"/>
              <a:gd name="connsiteX507" fmla="*/ 3146995 w 12191993"/>
              <a:gd name="connsiteY507" fmla="*/ 5905528 h 6857996"/>
              <a:gd name="connsiteX508" fmla="*/ 3178780 w 12191993"/>
              <a:gd name="connsiteY508" fmla="*/ 5905528 h 6857996"/>
              <a:gd name="connsiteX509" fmla="*/ 3178780 w 12191993"/>
              <a:gd name="connsiteY509" fmla="*/ 5873419 h 6857996"/>
              <a:gd name="connsiteX510" fmla="*/ 5074981 w 12191993"/>
              <a:gd name="connsiteY510" fmla="*/ 3974428 h 6857996"/>
              <a:gd name="connsiteX511" fmla="*/ 7530588 w 12191993"/>
              <a:gd name="connsiteY511" fmla="*/ 6429546 h 6857996"/>
              <a:gd name="connsiteX512" fmla="*/ 5074981 w 12191993"/>
              <a:gd name="connsiteY512" fmla="*/ 6429546 h 6857996"/>
              <a:gd name="connsiteX513" fmla="*/ 11122964 w 12191993"/>
              <a:gd name="connsiteY513" fmla="*/ 3974190 h 6857996"/>
              <a:gd name="connsiteX514" fmla="*/ 11122964 w 12191993"/>
              <a:gd name="connsiteY514" fmla="*/ 6429463 h 6857996"/>
              <a:gd name="connsiteX515" fmla="*/ 8666920 w 12191993"/>
              <a:gd name="connsiteY515" fmla="*/ 6429463 h 6857996"/>
              <a:gd name="connsiteX516" fmla="*/ 11122964 w 12191993"/>
              <a:gd name="connsiteY516" fmla="*/ 3974190 h 6857996"/>
              <a:gd name="connsiteX517" fmla="*/ 5074885 w 12191993"/>
              <a:gd name="connsiteY517" fmla="*/ 3877086 h 6857996"/>
              <a:gd name="connsiteX518" fmla="*/ 5058713 w 12191993"/>
              <a:gd name="connsiteY518" fmla="*/ 3878325 h 6857996"/>
              <a:gd name="connsiteX519" fmla="*/ 5058713 w 12191993"/>
              <a:gd name="connsiteY519" fmla="*/ 6445810 h 6857996"/>
              <a:gd name="connsiteX520" fmla="*/ 7626641 w 12191993"/>
              <a:gd name="connsiteY520" fmla="*/ 6445810 h 6857996"/>
              <a:gd name="connsiteX521" fmla="*/ 7627884 w 12191993"/>
              <a:gd name="connsiteY521" fmla="*/ 6429641 h 6857996"/>
              <a:gd name="connsiteX522" fmla="*/ 5074885 w 12191993"/>
              <a:gd name="connsiteY522" fmla="*/ 3877086 h 6857996"/>
              <a:gd name="connsiteX523" fmla="*/ 11123059 w 12191993"/>
              <a:gd name="connsiteY523" fmla="*/ 3876995 h 6857996"/>
              <a:gd name="connsiteX524" fmla="*/ 8569625 w 12191993"/>
              <a:gd name="connsiteY524" fmla="*/ 6429558 h 6857996"/>
              <a:gd name="connsiteX525" fmla="*/ 8570868 w 12191993"/>
              <a:gd name="connsiteY525" fmla="*/ 6445727 h 6857996"/>
              <a:gd name="connsiteX526" fmla="*/ 11139231 w 12191993"/>
              <a:gd name="connsiteY526" fmla="*/ 6445727 h 6857996"/>
              <a:gd name="connsiteX527" fmla="*/ 11139231 w 12191993"/>
              <a:gd name="connsiteY527" fmla="*/ 3878238 h 6857996"/>
              <a:gd name="connsiteX528" fmla="*/ 5074862 w 12191993"/>
              <a:gd name="connsiteY528" fmla="*/ 382592 h 6857996"/>
              <a:gd name="connsiteX529" fmla="*/ 7530485 w 12191993"/>
              <a:gd name="connsiteY529" fmla="*/ 382592 h 6857996"/>
              <a:gd name="connsiteX530" fmla="*/ 5074862 w 12191993"/>
              <a:gd name="connsiteY530" fmla="*/ 2838143 h 6857996"/>
              <a:gd name="connsiteX531" fmla="*/ 8666781 w 12191993"/>
              <a:gd name="connsiteY531" fmla="*/ 382485 h 6857996"/>
              <a:gd name="connsiteX532" fmla="*/ 11122821 w 12191993"/>
              <a:gd name="connsiteY532" fmla="*/ 382485 h 6857996"/>
              <a:gd name="connsiteX533" fmla="*/ 11122821 w 12191993"/>
              <a:gd name="connsiteY533" fmla="*/ 2838196 h 6857996"/>
              <a:gd name="connsiteX534" fmla="*/ 8666781 w 12191993"/>
              <a:gd name="connsiteY534" fmla="*/ 382485 h 6857996"/>
              <a:gd name="connsiteX535" fmla="*/ 5058594 w 12191993"/>
              <a:gd name="connsiteY535" fmla="*/ 366328 h 6857996"/>
              <a:gd name="connsiteX536" fmla="*/ 5058594 w 12191993"/>
              <a:gd name="connsiteY536" fmla="*/ 2934247 h 6857996"/>
              <a:gd name="connsiteX537" fmla="*/ 5074766 w 12191993"/>
              <a:gd name="connsiteY537" fmla="*/ 2935488 h 6857996"/>
              <a:gd name="connsiteX538" fmla="*/ 7627761 w 12191993"/>
              <a:gd name="connsiteY538" fmla="*/ 382497 h 6857996"/>
              <a:gd name="connsiteX539" fmla="*/ 7626518 w 12191993"/>
              <a:gd name="connsiteY539" fmla="*/ 366328 h 6857996"/>
              <a:gd name="connsiteX540" fmla="*/ 8570721 w 12191993"/>
              <a:gd name="connsiteY540" fmla="*/ 366221 h 6857996"/>
              <a:gd name="connsiteX541" fmla="*/ 8569478 w 12191993"/>
              <a:gd name="connsiteY541" fmla="*/ 382390 h 6857996"/>
              <a:gd name="connsiteX542" fmla="*/ 11122916 w 12191993"/>
              <a:gd name="connsiteY542" fmla="*/ 2935381 h 6857996"/>
              <a:gd name="connsiteX543" fmla="*/ 11139088 w 12191993"/>
              <a:gd name="connsiteY543" fmla="*/ 2934139 h 6857996"/>
              <a:gd name="connsiteX544" fmla="*/ 11139088 w 12191993"/>
              <a:gd name="connsiteY544" fmla="*/ 366221 h 6857996"/>
              <a:gd name="connsiteX545" fmla="*/ 0 w 12191993"/>
              <a:gd name="connsiteY545" fmla="*/ 0 h 6857996"/>
              <a:gd name="connsiteX546" fmla="*/ 12191993 w 12191993"/>
              <a:gd name="connsiteY546" fmla="*/ 0 h 6857996"/>
              <a:gd name="connsiteX547" fmla="*/ 12191993 w 12191993"/>
              <a:gd name="connsiteY547" fmla="*/ 6857996 h 6857996"/>
              <a:gd name="connsiteX548" fmla="*/ 0 w 12191993"/>
              <a:gd name="connsiteY548" fmla="*/ 6857996 h 68579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  <a:cxn ang="0">
                <a:pos x="connsiteX288" y="connsiteY288"/>
              </a:cxn>
              <a:cxn ang="0">
                <a:pos x="connsiteX289" y="connsiteY289"/>
              </a:cxn>
              <a:cxn ang="0">
                <a:pos x="connsiteX290" y="connsiteY290"/>
              </a:cxn>
              <a:cxn ang="0">
                <a:pos x="connsiteX291" y="connsiteY291"/>
              </a:cxn>
              <a:cxn ang="0">
                <a:pos x="connsiteX292" y="connsiteY292"/>
              </a:cxn>
              <a:cxn ang="0">
                <a:pos x="connsiteX293" y="connsiteY293"/>
              </a:cxn>
              <a:cxn ang="0">
                <a:pos x="connsiteX294" y="connsiteY294"/>
              </a:cxn>
              <a:cxn ang="0">
                <a:pos x="connsiteX295" y="connsiteY295"/>
              </a:cxn>
              <a:cxn ang="0">
                <a:pos x="connsiteX296" y="connsiteY296"/>
              </a:cxn>
              <a:cxn ang="0">
                <a:pos x="connsiteX297" y="connsiteY297"/>
              </a:cxn>
              <a:cxn ang="0">
                <a:pos x="connsiteX298" y="connsiteY298"/>
              </a:cxn>
              <a:cxn ang="0">
                <a:pos x="connsiteX299" y="connsiteY299"/>
              </a:cxn>
              <a:cxn ang="0">
                <a:pos x="connsiteX300" y="connsiteY300"/>
              </a:cxn>
              <a:cxn ang="0">
                <a:pos x="connsiteX301" y="connsiteY301"/>
              </a:cxn>
              <a:cxn ang="0">
                <a:pos x="connsiteX302" y="connsiteY302"/>
              </a:cxn>
              <a:cxn ang="0">
                <a:pos x="connsiteX303" y="connsiteY303"/>
              </a:cxn>
              <a:cxn ang="0">
                <a:pos x="connsiteX304" y="connsiteY304"/>
              </a:cxn>
              <a:cxn ang="0">
                <a:pos x="connsiteX305" y="connsiteY305"/>
              </a:cxn>
              <a:cxn ang="0">
                <a:pos x="connsiteX306" y="connsiteY306"/>
              </a:cxn>
              <a:cxn ang="0">
                <a:pos x="connsiteX307" y="connsiteY307"/>
              </a:cxn>
              <a:cxn ang="0">
                <a:pos x="connsiteX308" y="connsiteY308"/>
              </a:cxn>
              <a:cxn ang="0">
                <a:pos x="connsiteX309" y="connsiteY309"/>
              </a:cxn>
              <a:cxn ang="0">
                <a:pos x="connsiteX310" y="connsiteY310"/>
              </a:cxn>
              <a:cxn ang="0">
                <a:pos x="connsiteX311" y="connsiteY311"/>
              </a:cxn>
              <a:cxn ang="0">
                <a:pos x="connsiteX312" y="connsiteY312"/>
              </a:cxn>
              <a:cxn ang="0">
                <a:pos x="connsiteX313" y="connsiteY313"/>
              </a:cxn>
              <a:cxn ang="0">
                <a:pos x="connsiteX314" y="connsiteY314"/>
              </a:cxn>
              <a:cxn ang="0">
                <a:pos x="connsiteX315" y="connsiteY315"/>
              </a:cxn>
              <a:cxn ang="0">
                <a:pos x="connsiteX316" y="connsiteY316"/>
              </a:cxn>
              <a:cxn ang="0">
                <a:pos x="connsiteX317" y="connsiteY317"/>
              </a:cxn>
              <a:cxn ang="0">
                <a:pos x="connsiteX318" y="connsiteY318"/>
              </a:cxn>
              <a:cxn ang="0">
                <a:pos x="connsiteX319" y="connsiteY319"/>
              </a:cxn>
              <a:cxn ang="0">
                <a:pos x="connsiteX320" y="connsiteY320"/>
              </a:cxn>
              <a:cxn ang="0">
                <a:pos x="connsiteX321" y="connsiteY321"/>
              </a:cxn>
              <a:cxn ang="0">
                <a:pos x="connsiteX322" y="connsiteY322"/>
              </a:cxn>
              <a:cxn ang="0">
                <a:pos x="connsiteX323" y="connsiteY323"/>
              </a:cxn>
              <a:cxn ang="0">
                <a:pos x="connsiteX324" y="connsiteY324"/>
              </a:cxn>
              <a:cxn ang="0">
                <a:pos x="connsiteX325" y="connsiteY325"/>
              </a:cxn>
              <a:cxn ang="0">
                <a:pos x="connsiteX326" y="connsiteY326"/>
              </a:cxn>
              <a:cxn ang="0">
                <a:pos x="connsiteX327" y="connsiteY327"/>
              </a:cxn>
              <a:cxn ang="0">
                <a:pos x="connsiteX328" y="connsiteY328"/>
              </a:cxn>
              <a:cxn ang="0">
                <a:pos x="connsiteX329" y="connsiteY329"/>
              </a:cxn>
              <a:cxn ang="0">
                <a:pos x="connsiteX330" y="connsiteY330"/>
              </a:cxn>
              <a:cxn ang="0">
                <a:pos x="connsiteX331" y="connsiteY331"/>
              </a:cxn>
              <a:cxn ang="0">
                <a:pos x="connsiteX332" y="connsiteY332"/>
              </a:cxn>
              <a:cxn ang="0">
                <a:pos x="connsiteX333" y="connsiteY333"/>
              </a:cxn>
              <a:cxn ang="0">
                <a:pos x="connsiteX334" y="connsiteY334"/>
              </a:cxn>
              <a:cxn ang="0">
                <a:pos x="connsiteX335" y="connsiteY335"/>
              </a:cxn>
              <a:cxn ang="0">
                <a:pos x="connsiteX336" y="connsiteY336"/>
              </a:cxn>
              <a:cxn ang="0">
                <a:pos x="connsiteX337" y="connsiteY337"/>
              </a:cxn>
              <a:cxn ang="0">
                <a:pos x="connsiteX338" y="connsiteY338"/>
              </a:cxn>
              <a:cxn ang="0">
                <a:pos x="connsiteX339" y="connsiteY339"/>
              </a:cxn>
              <a:cxn ang="0">
                <a:pos x="connsiteX340" y="connsiteY340"/>
              </a:cxn>
              <a:cxn ang="0">
                <a:pos x="connsiteX341" y="connsiteY341"/>
              </a:cxn>
              <a:cxn ang="0">
                <a:pos x="connsiteX342" y="connsiteY342"/>
              </a:cxn>
              <a:cxn ang="0">
                <a:pos x="connsiteX343" y="connsiteY343"/>
              </a:cxn>
              <a:cxn ang="0">
                <a:pos x="connsiteX344" y="connsiteY344"/>
              </a:cxn>
              <a:cxn ang="0">
                <a:pos x="connsiteX345" y="connsiteY345"/>
              </a:cxn>
              <a:cxn ang="0">
                <a:pos x="connsiteX346" y="connsiteY346"/>
              </a:cxn>
              <a:cxn ang="0">
                <a:pos x="connsiteX347" y="connsiteY347"/>
              </a:cxn>
              <a:cxn ang="0">
                <a:pos x="connsiteX348" y="connsiteY348"/>
              </a:cxn>
              <a:cxn ang="0">
                <a:pos x="connsiteX349" y="connsiteY349"/>
              </a:cxn>
              <a:cxn ang="0">
                <a:pos x="connsiteX350" y="connsiteY350"/>
              </a:cxn>
              <a:cxn ang="0">
                <a:pos x="connsiteX351" y="connsiteY351"/>
              </a:cxn>
              <a:cxn ang="0">
                <a:pos x="connsiteX352" y="connsiteY352"/>
              </a:cxn>
              <a:cxn ang="0">
                <a:pos x="connsiteX353" y="connsiteY353"/>
              </a:cxn>
              <a:cxn ang="0">
                <a:pos x="connsiteX354" y="connsiteY354"/>
              </a:cxn>
              <a:cxn ang="0">
                <a:pos x="connsiteX355" y="connsiteY355"/>
              </a:cxn>
              <a:cxn ang="0">
                <a:pos x="connsiteX356" y="connsiteY356"/>
              </a:cxn>
              <a:cxn ang="0">
                <a:pos x="connsiteX357" y="connsiteY357"/>
              </a:cxn>
              <a:cxn ang="0">
                <a:pos x="connsiteX358" y="connsiteY358"/>
              </a:cxn>
              <a:cxn ang="0">
                <a:pos x="connsiteX359" y="connsiteY359"/>
              </a:cxn>
              <a:cxn ang="0">
                <a:pos x="connsiteX360" y="connsiteY360"/>
              </a:cxn>
              <a:cxn ang="0">
                <a:pos x="connsiteX361" y="connsiteY361"/>
              </a:cxn>
              <a:cxn ang="0">
                <a:pos x="connsiteX362" y="connsiteY362"/>
              </a:cxn>
              <a:cxn ang="0">
                <a:pos x="connsiteX363" y="connsiteY363"/>
              </a:cxn>
              <a:cxn ang="0">
                <a:pos x="connsiteX364" y="connsiteY364"/>
              </a:cxn>
              <a:cxn ang="0">
                <a:pos x="connsiteX365" y="connsiteY365"/>
              </a:cxn>
              <a:cxn ang="0">
                <a:pos x="connsiteX366" y="connsiteY366"/>
              </a:cxn>
              <a:cxn ang="0">
                <a:pos x="connsiteX367" y="connsiteY367"/>
              </a:cxn>
              <a:cxn ang="0">
                <a:pos x="connsiteX368" y="connsiteY368"/>
              </a:cxn>
              <a:cxn ang="0">
                <a:pos x="connsiteX369" y="connsiteY369"/>
              </a:cxn>
              <a:cxn ang="0">
                <a:pos x="connsiteX370" y="connsiteY370"/>
              </a:cxn>
              <a:cxn ang="0">
                <a:pos x="connsiteX371" y="connsiteY371"/>
              </a:cxn>
              <a:cxn ang="0">
                <a:pos x="connsiteX372" y="connsiteY372"/>
              </a:cxn>
              <a:cxn ang="0">
                <a:pos x="connsiteX373" y="connsiteY373"/>
              </a:cxn>
              <a:cxn ang="0">
                <a:pos x="connsiteX374" y="connsiteY374"/>
              </a:cxn>
              <a:cxn ang="0">
                <a:pos x="connsiteX375" y="connsiteY375"/>
              </a:cxn>
              <a:cxn ang="0">
                <a:pos x="connsiteX376" y="connsiteY376"/>
              </a:cxn>
              <a:cxn ang="0">
                <a:pos x="connsiteX377" y="connsiteY377"/>
              </a:cxn>
              <a:cxn ang="0">
                <a:pos x="connsiteX378" y="connsiteY378"/>
              </a:cxn>
              <a:cxn ang="0">
                <a:pos x="connsiteX379" y="connsiteY379"/>
              </a:cxn>
              <a:cxn ang="0">
                <a:pos x="connsiteX380" y="connsiteY380"/>
              </a:cxn>
              <a:cxn ang="0">
                <a:pos x="connsiteX381" y="connsiteY381"/>
              </a:cxn>
              <a:cxn ang="0">
                <a:pos x="connsiteX382" y="connsiteY382"/>
              </a:cxn>
              <a:cxn ang="0">
                <a:pos x="connsiteX383" y="connsiteY383"/>
              </a:cxn>
              <a:cxn ang="0">
                <a:pos x="connsiteX384" y="connsiteY384"/>
              </a:cxn>
              <a:cxn ang="0">
                <a:pos x="connsiteX385" y="connsiteY385"/>
              </a:cxn>
              <a:cxn ang="0">
                <a:pos x="connsiteX386" y="connsiteY386"/>
              </a:cxn>
              <a:cxn ang="0">
                <a:pos x="connsiteX387" y="connsiteY387"/>
              </a:cxn>
              <a:cxn ang="0">
                <a:pos x="connsiteX388" y="connsiteY388"/>
              </a:cxn>
              <a:cxn ang="0">
                <a:pos x="connsiteX389" y="connsiteY389"/>
              </a:cxn>
              <a:cxn ang="0">
                <a:pos x="connsiteX390" y="connsiteY390"/>
              </a:cxn>
              <a:cxn ang="0">
                <a:pos x="connsiteX391" y="connsiteY391"/>
              </a:cxn>
              <a:cxn ang="0">
                <a:pos x="connsiteX392" y="connsiteY392"/>
              </a:cxn>
              <a:cxn ang="0">
                <a:pos x="connsiteX393" y="connsiteY393"/>
              </a:cxn>
              <a:cxn ang="0">
                <a:pos x="connsiteX394" y="connsiteY394"/>
              </a:cxn>
              <a:cxn ang="0">
                <a:pos x="connsiteX395" y="connsiteY395"/>
              </a:cxn>
              <a:cxn ang="0">
                <a:pos x="connsiteX396" y="connsiteY396"/>
              </a:cxn>
              <a:cxn ang="0">
                <a:pos x="connsiteX397" y="connsiteY397"/>
              </a:cxn>
              <a:cxn ang="0">
                <a:pos x="connsiteX398" y="connsiteY398"/>
              </a:cxn>
              <a:cxn ang="0">
                <a:pos x="connsiteX399" y="connsiteY399"/>
              </a:cxn>
              <a:cxn ang="0">
                <a:pos x="connsiteX400" y="connsiteY400"/>
              </a:cxn>
              <a:cxn ang="0">
                <a:pos x="connsiteX401" y="connsiteY401"/>
              </a:cxn>
              <a:cxn ang="0">
                <a:pos x="connsiteX402" y="connsiteY402"/>
              </a:cxn>
              <a:cxn ang="0">
                <a:pos x="connsiteX403" y="connsiteY403"/>
              </a:cxn>
              <a:cxn ang="0">
                <a:pos x="connsiteX404" y="connsiteY404"/>
              </a:cxn>
              <a:cxn ang="0">
                <a:pos x="connsiteX405" y="connsiteY405"/>
              </a:cxn>
              <a:cxn ang="0">
                <a:pos x="connsiteX406" y="connsiteY406"/>
              </a:cxn>
              <a:cxn ang="0">
                <a:pos x="connsiteX407" y="connsiteY407"/>
              </a:cxn>
              <a:cxn ang="0">
                <a:pos x="connsiteX408" y="connsiteY408"/>
              </a:cxn>
              <a:cxn ang="0">
                <a:pos x="connsiteX409" y="connsiteY409"/>
              </a:cxn>
              <a:cxn ang="0">
                <a:pos x="connsiteX410" y="connsiteY410"/>
              </a:cxn>
              <a:cxn ang="0">
                <a:pos x="connsiteX411" y="connsiteY411"/>
              </a:cxn>
              <a:cxn ang="0">
                <a:pos x="connsiteX412" y="connsiteY412"/>
              </a:cxn>
              <a:cxn ang="0">
                <a:pos x="connsiteX413" y="connsiteY413"/>
              </a:cxn>
              <a:cxn ang="0">
                <a:pos x="connsiteX414" y="connsiteY414"/>
              </a:cxn>
              <a:cxn ang="0">
                <a:pos x="connsiteX415" y="connsiteY415"/>
              </a:cxn>
              <a:cxn ang="0">
                <a:pos x="connsiteX416" y="connsiteY416"/>
              </a:cxn>
              <a:cxn ang="0">
                <a:pos x="connsiteX417" y="connsiteY417"/>
              </a:cxn>
              <a:cxn ang="0">
                <a:pos x="connsiteX418" y="connsiteY418"/>
              </a:cxn>
              <a:cxn ang="0">
                <a:pos x="connsiteX419" y="connsiteY419"/>
              </a:cxn>
              <a:cxn ang="0">
                <a:pos x="connsiteX420" y="connsiteY420"/>
              </a:cxn>
              <a:cxn ang="0">
                <a:pos x="connsiteX421" y="connsiteY421"/>
              </a:cxn>
              <a:cxn ang="0">
                <a:pos x="connsiteX422" y="connsiteY422"/>
              </a:cxn>
              <a:cxn ang="0">
                <a:pos x="connsiteX423" y="connsiteY423"/>
              </a:cxn>
              <a:cxn ang="0">
                <a:pos x="connsiteX424" y="connsiteY424"/>
              </a:cxn>
              <a:cxn ang="0">
                <a:pos x="connsiteX425" y="connsiteY425"/>
              </a:cxn>
              <a:cxn ang="0">
                <a:pos x="connsiteX426" y="connsiteY426"/>
              </a:cxn>
              <a:cxn ang="0">
                <a:pos x="connsiteX427" y="connsiteY427"/>
              </a:cxn>
              <a:cxn ang="0">
                <a:pos x="connsiteX428" y="connsiteY428"/>
              </a:cxn>
              <a:cxn ang="0">
                <a:pos x="connsiteX429" y="connsiteY429"/>
              </a:cxn>
              <a:cxn ang="0">
                <a:pos x="connsiteX430" y="connsiteY430"/>
              </a:cxn>
              <a:cxn ang="0">
                <a:pos x="connsiteX431" y="connsiteY431"/>
              </a:cxn>
              <a:cxn ang="0">
                <a:pos x="connsiteX432" y="connsiteY432"/>
              </a:cxn>
              <a:cxn ang="0">
                <a:pos x="connsiteX433" y="connsiteY433"/>
              </a:cxn>
              <a:cxn ang="0">
                <a:pos x="connsiteX434" y="connsiteY434"/>
              </a:cxn>
              <a:cxn ang="0">
                <a:pos x="connsiteX435" y="connsiteY435"/>
              </a:cxn>
              <a:cxn ang="0">
                <a:pos x="connsiteX436" y="connsiteY436"/>
              </a:cxn>
              <a:cxn ang="0">
                <a:pos x="connsiteX437" y="connsiteY437"/>
              </a:cxn>
              <a:cxn ang="0">
                <a:pos x="connsiteX438" y="connsiteY438"/>
              </a:cxn>
              <a:cxn ang="0">
                <a:pos x="connsiteX439" y="connsiteY439"/>
              </a:cxn>
              <a:cxn ang="0">
                <a:pos x="connsiteX440" y="connsiteY440"/>
              </a:cxn>
              <a:cxn ang="0">
                <a:pos x="connsiteX441" y="connsiteY441"/>
              </a:cxn>
              <a:cxn ang="0">
                <a:pos x="connsiteX442" y="connsiteY442"/>
              </a:cxn>
              <a:cxn ang="0">
                <a:pos x="connsiteX443" y="connsiteY443"/>
              </a:cxn>
              <a:cxn ang="0">
                <a:pos x="connsiteX444" y="connsiteY444"/>
              </a:cxn>
              <a:cxn ang="0">
                <a:pos x="connsiteX445" y="connsiteY445"/>
              </a:cxn>
              <a:cxn ang="0">
                <a:pos x="connsiteX446" y="connsiteY446"/>
              </a:cxn>
              <a:cxn ang="0">
                <a:pos x="connsiteX447" y="connsiteY447"/>
              </a:cxn>
              <a:cxn ang="0">
                <a:pos x="connsiteX448" y="connsiteY448"/>
              </a:cxn>
              <a:cxn ang="0">
                <a:pos x="connsiteX449" y="connsiteY449"/>
              </a:cxn>
              <a:cxn ang="0">
                <a:pos x="connsiteX450" y="connsiteY450"/>
              </a:cxn>
              <a:cxn ang="0">
                <a:pos x="connsiteX451" y="connsiteY451"/>
              </a:cxn>
              <a:cxn ang="0">
                <a:pos x="connsiteX452" y="connsiteY452"/>
              </a:cxn>
              <a:cxn ang="0">
                <a:pos x="connsiteX453" y="connsiteY453"/>
              </a:cxn>
              <a:cxn ang="0">
                <a:pos x="connsiteX454" y="connsiteY454"/>
              </a:cxn>
              <a:cxn ang="0">
                <a:pos x="connsiteX455" y="connsiteY455"/>
              </a:cxn>
              <a:cxn ang="0">
                <a:pos x="connsiteX456" y="connsiteY456"/>
              </a:cxn>
              <a:cxn ang="0">
                <a:pos x="connsiteX457" y="connsiteY457"/>
              </a:cxn>
              <a:cxn ang="0">
                <a:pos x="connsiteX458" y="connsiteY458"/>
              </a:cxn>
              <a:cxn ang="0">
                <a:pos x="connsiteX459" y="connsiteY459"/>
              </a:cxn>
              <a:cxn ang="0">
                <a:pos x="connsiteX460" y="connsiteY460"/>
              </a:cxn>
              <a:cxn ang="0">
                <a:pos x="connsiteX461" y="connsiteY461"/>
              </a:cxn>
              <a:cxn ang="0">
                <a:pos x="connsiteX462" y="connsiteY462"/>
              </a:cxn>
              <a:cxn ang="0">
                <a:pos x="connsiteX463" y="connsiteY463"/>
              </a:cxn>
              <a:cxn ang="0">
                <a:pos x="connsiteX464" y="connsiteY464"/>
              </a:cxn>
              <a:cxn ang="0">
                <a:pos x="connsiteX465" y="connsiteY465"/>
              </a:cxn>
              <a:cxn ang="0">
                <a:pos x="connsiteX466" y="connsiteY466"/>
              </a:cxn>
              <a:cxn ang="0">
                <a:pos x="connsiteX467" y="connsiteY467"/>
              </a:cxn>
              <a:cxn ang="0">
                <a:pos x="connsiteX468" y="connsiteY468"/>
              </a:cxn>
              <a:cxn ang="0">
                <a:pos x="connsiteX469" y="connsiteY469"/>
              </a:cxn>
              <a:cxn ang="0">
                <a:pos x="connsiteX470" y="connsiteY470"/>
              </a:cxn>
              <a:cxn ang="0">
                <a:pos x="connsiteX471" y="connsiteY471"/>
              </a:cxn>
              <a:cxn ang="0">
                <a:pos x="connsiteX472" y="connsiteY472"/>
              </a:cxn>
              <a:cxn ang="0">
                <a:pos x="connsiteX473" y="connsiteY473"/>
              </a:cxn>
              <a:cxn ang="0">
                <a:pos x="connsiteX474" y="connsiteY474"/>
              </a:cxn>
              <a:cxn ang="0">
                <a:pos x="connsiteX475" y="connsiteY475"/>
              </a:cxn>
              <a:cxn ang="0">
                <a:pos x="connsiteX476" y="connsiteY476"/>
              </a:cxn>
              <a:cxn ang="0">
                <a:pos x="connsiteX477" y="connsiteY477"/>
              </a:cxn>
              <a:cxn ang="0">
                <a:pos x="connsiteX478" y="connsiteY478"/>
              </a:cxn>
              <a:cxn ang="0">
                <a:pos x="connsiteX479" y="connsiteY479"/>
              </a:cxn>
              <a:cxn ang="0">
                <a:pos x="connsiteX480" y="connsiteY480"/>
              </a:cxn>
              <a:cxn ang="0">
                <a:pos x="connsiteX481" y="connsiteY481"/>
              </a:cxn>
              <a:cxn ang="0">
                <a:pos x="connsiteX482" y="connsiteY482"/>
              </a:cxn>
              <a:cxn ang="0">
                <a:pos x="connsiteX483" y="connsiteY483"/>
              </a:cxn>
              <a:cxn ang="0">
                <a:pos x="connsiteX484" y="connsiteY484"/>
              </a:cxn>
              <a:cxn ang="0">
                <a:pos x="connsiteX485" y="connsiteY485"/>
              </a:cxn>
              <a:cxn ang="0">
                <a:pos x="connsiteX486" y="connsiteY486"/>
              </a:cxn>
              <a:cxn ang="0">
                <a:pos x="connsiteX487" y="connsiteY487"/>
              </a:cxn>
              <a:cxn ang="0">
                <a:pos x="connsiteX488" y="connsiteY488"/>
              </a:cxn>
              <a:cxn ang="0">
                <a:pos x="connsiteX489" y="connsiteY489"/>
              </a:cxn>
              <a:cxn ang="0">
                <a:pos x="connsiteX490" y="connsiteY490"/>
              </a:cxn>
              <a:cxn ang="0">
                <a:pos x="connsiteX491" y="connsiteY491"/>
              </a:cxn>
              <a:cxn ang="0">
                <a:pos x="connsiteX492" y="connsiteY492"/>
              </a:cxn>
              <a:cxn ang="0">
                <a:pos x="connsiteX493" y="connsiteY493"/>
              </a:cxn>
              <a:cxn ang="0">
                <a:pos x="connsiteX494" y="connsiteY494"/>
              </a:cxn>
              <a:cxn ang="0">
                <a:pos x="connsiteX495" y="connsiteY495"/>
              </a:cxn>
              <a:cxn ang="0">
                <a:pos x="connsiteX496" y="connsiteY496"/>
              </a:cxn>
              <a:cxn ang="0">
                <a:pos x="connsiteX497" y="connsiteY497"/>
              </a:cxn>
              <a:cxn ang="0">
                <a:pos x="connsiteX498" y="connsiteY498"/>
              </a:cxn>
              <a:cxn ang="0">
                <a:pos x="connsiteX499" y="connsiteY499"/>
              </a:cxn>
              <a:cxn ang="0">
                <a:pos x="connsiteX500" y="connsiteY500"/>
              </a:cxn>
              <a:cxn ang="0">
                <a:pos x="connsiteX501" y="connsiteY501"/>
              </a:cxn>
              <a:cxn ang="0">
                <a:pos x="connsiteX502" y="connsiteY502"/>
              </a:cxn>
              <a:cxn ang="0">
                <a:pos x="connsiteX503" y="connsiteY503"/>
              </a:cxn>
              <a:cxn ang="0">
                <a:pos x="connsiteX504" y="connsiteY504"/>
              </a:cxn>
              <a:cxn ang="0">
                <a:pos x="connsiteX505" y="connsiteY505"/>
              </a:cxn>
              <a:cxn ang="0">
                <a:pos x="connsiteX506" y="connsiteY506"/>
              </a:cxn>
              <a:cxn ang="0">
                <a:pos x="connsiteX507" y="connsiteY507"/>
              </a:cxn>
              <a:cxn ang="0">
                <a:pos x="connsiteX508" y="connsiteY508"/>
              </a:cxn>
              <a:cxn ang="0">
                <a:pos x="connsiteX509" y="connsiteY509"/>
              </a:cxn>
              <a:cxn ang="0">
                <a:pos x="connsiteX510" y="connsiteY510"/>
              </a:cxn>
              <a:cxn ang="0">
                <a:pos x="connsiteX511" y="connsiteY511"/>
              </a:cxn>
              <a:cxn ang="0">
                <a:pos x="connsiteX512" y="connsiteY512"/>
              </a:cxn>
              <a:cxn ang="0">
                <a:pos x="connsiteX513" y="connsiteY513"/>
              </a:cxn>
              <a:cxn ang="0">
                <a:pos x="connsiteX514" y="connsiteY514"/>
              </a:cxn>
              <a:cxn ang="0">
                <a:pos x="connsiteX515" y="connsiteY515"/>
              </a:cxn>
              <a:cxn ang="0">
                <a:pos x="connsiteX516" y="connsiteY516"/>
              </a:cxn>
              <a:cxn ang="0">
                <a:pos x="connsiteX517" y="connsiteY517"/>
              </a:cxn>
              <a:cxn ang="0">
                <a:pos x="connsiteX518" y="connsiteY518"/>
              </a:cxn>
              <a:cxn ang="0">
                <a:pos x="connsiteX519" y="connsiteY519"/>
              </a:cxn>
              <a:cxn ang="0">
                <a:pos x="connsiteX520" y="connsiteY520"/>
              </a:cxn>
              <a:cxn ang="0">
                <a:pos x="connsiteX521" y="connsiteY521"/>
              </a:cxn>
              <a:cxn ang="0">
                <a:pos x="connsiteX522" y="connsiteY522"/>
              </a:cxn>
              <a:cxn ang="0">
                <a:pos x="connsiteX523" y="connsiteY523"/>
              </a:cxn>
              <a:cxn ang="0">
                <a:pos x="connsiteX524" y="connsiteY524"/>
              </a:cxn>
              <a:cxn ang="0">
                <a:pos x="connsiteX525" y="connsiteY525"/>
              </a:cxn>
              <a:cxn ang="0">
                <a:pos x="connsiteX526" y="connsiteY526"/>
              </a:cxn>
              <a:cxn ang="0">
                <a:pos x="connsiteX527" y="connsiteY527"/>
              </a:cxn>
              <a:cxn ang="0">
                <a:pos x="connsiteX528" y="connsiteY528"/>
              </a:cxn>
              <a:cxn ang="0">
                <a:pos x="connsiteX529" y="connsiteY529"/>
              </a:cxn>
              <a:cxn ang="0">
                <a:pos x="connsiteX530" y="connsiteY530"/>
              </a:cxn>
              <a:cxn ang="0">
                <a:pos x="connsiteX531" y="connsiteY531"/>
              </a:cxn>
              <a:cxn ang="0">
                <a:pos x="connsiteX532" y="connsiteY532"/>
              </a:cxn>
              <a:cxn ang="0">
                <a:pos x="connsiteX533" y="connsiteY533"/>
              </a:cxn>
              <a:cxn ang="0">
                <a:pos x="connsiteX534" y="connsiteY534"/>
              </a:cxn>
              <a:cxn ang="0">
                <a:pos x="connsiteX535" y="connsiteY535"/>
              </a:cxn>
              <a:cxn ang="0">
                <a:pos x="connsiteX536" y="connsiteY536"/>
              </a:cxn>
              <a:cxn ang="0">
                <a:pos x="connsiteX537" y="connsiteY537"/>
              </a:cxn>
              <a:cxn ang="0">
                <a:pos x="connsiteX538" y="connsiteY538"/>
              </a:cxn>
              <a:cxn ang="0">
                <a:pos x="connsiteX539" y="connsiteY539"/>
              </a:cxn>
              <a:cxn ang="0">
                <a:pos x="connsiteX540" y="connsiteY540"/>
              </a:cxn>
              <a:cxn ang="0">
                <a:pos x="connsiteX541" y="connsiteY541"/>
              </a:cxn>
              <a:cxn ang="0">
                <a:pos x="connsiteX542" y="connsiteY542"/>
              </a:cxn>
              <a:cxn ang="0">
                <a:pos x="connsiteX543" y="connsiteY543"/>
              </a:cxn>
              <a:cxn ang="0">
                <a:pos x="connsiteX544" y="connsiteY544"/>
              </a:cxn>
              <a:cxn ang="0">
                <a:pos x="connsiteX545" y="connsiteY545"/>
              </a:cxn>
              <a:cxn ang="0">
                <a:pos x="connsiteX546" y="connsiteY546"/>
              </a:cxn>
              <a:cxn ang="0">
                <a:pos x="connsiteX547" y="connsiteY547"/>
              </a:cxn>
              <a:cxn ang="0">
                <a:pos x="connsiteX548" y="connsiteY548"/>
              </a:cxn>
            </a:cxnLst>
            <a:rect l="l" t="t" r="r" b="b"/>
            <a:pathLst>
              <a:path w="12191993" h="6857996">
                <a:moveTo>
                  <a:pt x="3578903" y="6416506"/>
                </a:moveTo>
                <a:lnTo>
                  <a:pt x="3578903" y="6449909"/>
                </a:lnTo>
                <a:lnTo>
                  <a:pt x="3611987" y="6449909"/>
                </a:lnTo>
                <a:lnTo>
                  <a:pt x="3611987" y="6416506"/>
                </a:lnTo>
                <a:close/>
                <a:moveTo>
                  <a:pt x="3481994" y="6306894"/>
                </a:moveTo>
                <a:cubicBezTo>
                  <a:pt x="3503073" y="6306894"/>
                  <a:pt x="3520589" y="6320511"/>
                  <a:pt x="3521564" y="6348729"/>
                </a:cubicBezTo>
                <a:lnTo>
                  <a:pt x="3433990" y="6348729"/>
                </a:lnTo>
                <a:cubicBezTo>
                  <a:pt x="3438527" y="6321810"/>
                  <a:pt x="3457992" y="6306894"/>
                  <a:pt x="3481994" y="6306894"/>
                </a:cubicBezTo>
                <a:close/>
                <a:moveTo>
                  <a:pt x="2971631" y="6306894"/>
                </a:moveTo>
                <a:cubicBezTo>
                  <a:pt x="2992711" y="6306894"/>
                  <a:pt x="3010227" y="6320511"/>
                  <a:pt x="3011201" y="6348729"/>
                </a:cubicBezTo>
                <a:lnTo>
                  <a:pt x="2923627" y="6348729"/>
                </a:lnTo>
                <a:cubicBezTo>
                  <a:pt x="2928165" y="6321810"/>
                  <a:pt x="2947629" y="6306894"/>
                  <a:pt x="2971631" y="6306894"/>
                </a:cubicBezTo>
                <a:close/>
                <a:moveTo>
                  <a:pt x="2218851" y="6297163"/>
                </a:moveTo>
                <a:cubicBezTo>
                  <a:pt x="2251936" y="6297163"/>
                  <a:pt x="2275288" y="6325052"/>
                  <a:pt x="2275288" y="6368835"/>
                </a:cubicBezTo>
                <a:cubicBezTo>
                  <a:pt x="2275288" y="6414238"/>
                  <a:pt x="2249338" y="6440507"/>
                  <a:pt x="2217552" y="6440507"/>
                </a:cubicBezTo>
                <a:cubicBezTo>
                  <a:pt x="2179598" y="6440507"/>
                  <a:pt x="2161116" y="6405156"/>
                  <a:pt x="2161116" y="6369160"/>
                </a:cubicBezTo>
                <a:cubicBezTo>
                  <a:pt x="2161116" y="6318243"/>
                  <a:pt x="2189006" y="6297163"/>
                  <a:pt x="2218851" y="6297163"/>
                </a:cubicBezTo>
                <a:close/>
                <a:moveTo>
                  <a:pt x="1782667" y="6296514"/>
                </a:moveTo>
                <a:cubicBezTo>
                  <a:pt x="1809586" y="6296514"/>
                  <a:pt x="1833268" y="6314352"/>
                  <a:pt x="1834887" y="6353915"/>
                </a:cubicBezTo>
                <a:lnTo>
                  <a:pt x="1719416" y="6353915"/>
                </a:lnTo>
                <a:cubicBezTo>
                  <a:pt x="1725256" y="6315975"/>
                  <a:pt x="1752825" y="6296514"/>
                  <a:pt x="1782667" y="6296514"/>
                </a:cubicBezTo>
                <a:close/>
                <a:moveTo>
                  <a:pt x="2293320" y="6287757"/>
                </a:moveTo>
                <a:lnTo>
                  <a:pt x="2360462" y="6448936"/>
                </a:lnTo>
                <a:lnTo>
                  <a:pt x="2348783" y="6475855"/>
                </a:lnTo>
                <a:cubicBezTo>
                  <a:pt x="2342297" y="6491096"/>
                  <a:pt x="2332565" y="6505042"/>
                  <a:pt x="2316996" y="6505042"/>
                </a:cubicBezTo>
                <a:cubicBezTo>
                  <a:pt x="2309639" y="6504634"/>
                  <a:pt x="2302598" y="6501910"/>
                  <a:pt x="2296883" y="6497259"/>
                </a:cubicBezTo>
                <a:lnTo>
                  <a:pt x="2290722" y="6508934"/>
                </a:lnTo>
                <a:cubicBezTo>
                  <a:pt x="2298267" y="6514722"/>
                  <a:pt x="2307487" y="6517908"/>
                  <a:pt x="2316996" y="6518015"/>
                </a:cubicBezTo>
                <a:cubicBezTo>
                  <a:pt x="2337427" y="6518015"/>
                  <a:pt x="2351055" y="6504717"/>
                  <a:pt x="2358190" y="6487853"/>
                </a:cubicBezTo>
                <a:lnTo>
                  <a:pt x="2441550" y="6287757"/>
                </a:lnTo>
                <a:lnTo>
                  <a:pt x="2426956" y="6287757"/>
                </a:lnTo>
                <a:lnTo>
                  <a:pt x="2373434" y="6417155"/>
                </a:lnTo>
                <a:cubicBezTo>
                  <a:pt x="2370187" y="6424938"/>
                  <a:pt x="2367922" y="6432396"/>
                  <a:pt x="2367922" y="6432396"/>
                </a:cubicBezTo>
                <a:lnTo>
                  <a:pt x="2367272" y="6432396"/>
                </a:lnTo>
                <a:cubicBezTo>
                  <a:pt x="2367272" y="6432396"/>
                  <a:pt x="2364675" y="6424938"/>
                  <a:pt x="2361429" y="6417155"/>
                </a:cubicBezTo>
                <a:lnTo>
                  <a:pt x="2307914" y="6287757"/>
                </a:lnTo>
                <a:close/>
                <a:moveTo>
                  <a:pt x="1560161" y="6287757"/>
                </a:moveTo>
                <a:lnTo>
                  <a:pt x="1624058" y="6449909"/>
                </a:lnTo>
                <a:lnTo>
                  <a:pt x="1637032" y="6449909"/>
                </a:lnTo>
                <a:lnTo>
                  <a:pt x="1700608" y="6287757"/>
                </a:lnTo>
                <a:lnTo>
                  <a:pt x="1686334" y="6287757"/>
                </a:lnTo>
                <a:lnTo>
                  <a:pt x="1636383" y="6414887"/>
                </a:lnTo>
                <a:cubicBezTo>
                  <a:pt x="1633465" y="6422669"/>
                  <a:pt x="1630868" y="6432396"/>
                  <a:pt x="1630868" y="6432396"/>
                </a:cubicBezTo>
                <a:lnTo>
                  <a:pt x="1630218" y="6432396"/>
                </a:lnTo>
                <a:cubicBezTo>
                  <a:pt x="1630218" y="6432396"/>
                  <a:pt x="1627629" y="6422669"/>
                  <a:pt x="1624707" y="6414887"/>
                </a:cubicBezTo>
                <a:lnTo>
                  <a:pt x="1574755" y="6287757"/>
                </a:lnTo>
                <a:close/>
                <a:moveTo>
                  <a:pt x="1526463" y="6287757"/>
                </a:moveTo>
                <a:lnTo>
                  <a:pt x="1526463" y="6449909"/>
                </a:lnTo>
                <a:lnTo>
                  <a:pt x="1540087" y="6449909"/>
                </a:lnTo>
                <a:lnTo>
                  <a:pt x="1540087" y="6287757"/>
                </a:lnTo>
                <a:close/>
                <a:moveTo>
                  <a:pt x="1496207" y="6286463"/>
                </a:moveTo>
                <a:cubicBezTo>
                  <a:pt x="1470580" y="6286463"/>
                  <a:pt x="1452419" y="6306894"/>
                  <a:pt x="1444311" y="6331866"/>
                </a:cubicBezTo>
                <a:lnTo>
                  <a:pt x="1443661" y="6331866"/>
                </a:lnTo>
                <a:cubicBezTo>
                  <a:pt x="1444529" y="6327486"/>
                  <a:pt x="1444964" y="6323032"/>
                  <a:pt x="1444960" y="6318568"/>
                </a:cubicBezTo>
                <a:lnTo>
                  <a:pt x="1444960" y="6287757"/>
                </a:lnTo>
                <a:lnTo>
                  <a:pt x="1431332" y="6287757"/>
                </a:lnTo>
                <a:lnTo>
                  <a:pt x="1431332" y="6449910"/>
                </a:lnTo>
                <a:lnTo>
                  <a:pt x="1444960" y="6449910"/>
                </a:lnTo>
                <a:lnTo>
                  <a:pt x="1444960" y="6379861"/>
                </a:lnTo>
                <a:cubicBezTo>
                  <a:pt x="1444867" y="6368331"/>
                  <a:pt x="1446506" y="6356852"/>
                  <a:pt x="1449821" y="6345808"/>
                </a:cubicBezTo>
                <a:cubicBezTo>
                  <a:pt x="1456956" y="6321810"/>
                  <a:pt x="1472850" y="6300406"/>
                  <a:pt x="1498150" y="6300406"/>
                </a:cubicBezTo>
                <a:cubicBezTo>
                  <a:pt x="1500648" y="6300445"/>
                  <a:pt x="1503141" y="6300662"/>
                  <a:pt x="1505609" y="6301055"/>
                </a:cubicBezTo>
                <a:lnTo>
                  <a:pt x="1505609" y="6287433"/>
                </a:lnTo>
                <a:cubicBezTo>
                  <a:pt x="1502511" y="6286819"/>
                  <a:pt x="1499364" y="6286494"/>
                  <a:pt x="1496207" y="6286463"/>
                </a:cubicBezTo>
                <a:close/>
                <a:moveTo>
                  <a:pt x="2833876" y="6285815"/>
                </a:moveTo>
                <a:lnTo>
                  <a:pt x="2833876" y="6449910"/>
                </a:lnTo>
                <a:lnTo>
                  <a:pt x="2865337" y="6449910"/>
                </a:lnTo>
                <a:lnTo>
                  <a:pt x="2865337" y="6285815"/>
                </a:lnTo>
                <a:close/>
                <a:moveTo>
                  <a:pt x="1962617" y="6283866"/>
                </a:moveTo>
                <a:cubicBezTo>
                  <a:pt x="1932589" y="6283915"/>
                  <a:pt x="1905505" y="6301924"/>
                  <a:pt x="1893850" y="6329593"/>
                </a:cubicBezTo>
                <a:lnTo>
                  <a:pt x="1893201" y="6329593"/>
                </a:lnTo>
                <a:cubicBezTo>
                  <a:pt x="1894069" y="6325214"/>
                  <a:pt x="1894504" y="6320760"/>
                  <a:pt x="1894499" y="6316296"/>
                </a:cubicBezTo>
                <a:lnTo>
                  <a:pt x="1894499" y="6287757"/>
                </a:lnTo>
                <a:lnTo>
                  <a:pt x="1880875" y="6287757"/>
                </a:lnTo>
                <a:lnTo>
                  <a:pt x="1880875" y="6449909"/>
                </a:lnTo>
                <a:lnTo>
                  <a:pt x="1894500" y="6449909"/>
                </a:lnTo>
                <a:lnTo>
                  <a:pt x="1894500" y="6370779"/>
                </a:lnTo>
                <a:cubicBezTo>
                  <a:pt x="1894344" y="6363345"/>
                  <a:pt x="1895217" y="6355925"/>
                  <a:pt x="1897093" y="6348730"/>
                </a:cubicBezTo>
                <a:cubicBezTo>
                  <a:pt x="1904831" y="6318751"/>
                  <a:pt x="1931655" y="6297641"/>
                  <a:pt x="1962617" y="6297163"/>
                </a:cubicBezTo>
                <a:cubicBezTo>
                  <a:pt x="1998940" y="6297163"/>
                  <a:pt x="2002511" y="6323758"/>
                  <a:pt x="2002511" y="6351972"/>
                </a:cubicBezTo>
                <a:lnTo>
                  <a:pt x="2002511" y="6449909"/>
                </a:lnTo>
                <a:lnTo>
                  <a:pt x="2016132" y="6449909"/>
                </a:lnTo>
                <a:lnTo>
                  <a:pt x="2016132" y="6347107"/>
                </a:lnTo>
                <a:cubicBezTo>
                  <a:pt x="2016132" y="6308837"/>
                  <a:pt x="2004784" y="6283866"/>
                  <a:pt x="1962617" y="6283866"/>
                </a:cubicBezTo>
                <a:close/>
                <a:moveTo>
                  <a:pt x="1782992" y="6283866"/>
                </a:moveTo>
                <a:cubicBezTo>
                  <a:pt x="1741473" y="6283866"/>
                  <a:pt x="1704172" y="6314352"/>
                  <a:pt x="1704172" y="6369160"/>
                </a:cubicBezTo>
                <a:cubicBezTo>
                  <a:pt x="1704172" y="6420722"/>
                  <a:pt x="1742119" y="6453801"/>
                  <a:pt x="1787858" y="6453801"/>
                </a:cubicBezTo>
                <a:cubicBezTo>
                  <a:pt x="1809172" y="6453549"/>
                  <a:pt x="1829677" y="6445602"/>
                  <a:pt x="1845593" y="6431427"/>
                </a:cubicBezTo>
                <a:lnTo>
                  <a:pt x="1838134" y="6420073"/>
                </a:lnTo>
                <a:cubicBezTo>
                  <a:pt x="1824600" y="6433054"/>
                  <a:pt x="1806612" y="6440366"/>
                  <a:pt x="1787858" y="6440508"/>
                </a:cubicBezTo>
                <a:cubicBezTo>
                  <a:pt x="1750232" y="6440508"/>
                  <a:pt x="1718442" y="6413589"/>
                  <a:pt x="1718442" y="6366563"/>
                </a:cubicBezTo>
                <a:lnTo>
                  <a:pt x="1848511" y="6366563"/>
                </a:lnTo>
                <a:cubicBezTo>
                  <a:pt x="1848511" y="6366563"/>
                  <a:pt x="1849161" y="6361377"/>
                  <a:pt x="1849161" y="6357807"/>
                </a:cubicBezTo>
                <a:cubicBezTo>
                  <a:pt x="1849161" y="6318568"/>
                  <a:pt x="1827103" y="6283866"/>
                  <a:pt x="1782992" y="6283866"/>
                </a:cubicBezTo>
                <a:close/>
                <a:moveTo>
                  <a:pt x="3482643" y="6281922"/>
                </a:moveTo>
                <a:cubicBezTo>
                  <a:pt x="3435929" y="6281922"/>
                  <a:pt x="3400581" y="6315650"/>
                  <a:pt x="3400581" y="6367862"/>
                </a:cubicBezTo>
                <a:cubicBezTo>
                  <a:pt x="3400581" y="6416506"/>
                  <a:pt x="3435929" y="6453801"/>
                  <a:pt x="3487504" y="6453801"/>
                </a:cubicBezTo>
                <a:cubicBezTo>
                  <a:pt x="3510804" y="6453844"/>
                  <a:pt x="3533352" y="6445564"/>
                  <a:pt x="3551085" y="6430452"/>
                </a:cubicBezTo>
                <a:lnTo>
                  <a:pt x="3538105" y="6407425"/>
                </a:lnTo>
                <a:cubicBezTo>
                  <a:pt x="3524564" y="6419193"/>
                  <a:pt x="3507385" y="6425950"/>
                  <a:pt x="3489453" y="6426561"/>
                </a:cubicBezTo>
                <a:cubicBezTo>
                  <a:pt x="3460256" y="6426561"/>
                  <a:pt x="3434638" y="6408398"/>
                  <a:pt x="3433015" y="6372402"/>
                </a:cubicBezTo>
                <a:lnTo>
                  <a:pt x="3552700" y="6372402"/>
                </a:lnTo>
                <a:cubicBezTo>
                  <a:pt x="3552700" y="6372402"/>
                  <a:pt x="3553673" y="6362996"/>
                  <a:pt x="3553673" y="6358780"/>
                </a:cubicBezTo>
                <a:cubicBezTo>
                  <a:pt x="3553673" y="6316295"/>
                  <a:pt x="3529023" y="6281922"/>
                  <a:pt x="3482643" y="6281922"/>
                </a:cubicBezTo>
                <a:close/>
                <a:moveTo>
                  <a:pt x="3328545" y="6281922"/>
                </a:moveTo>
                <a:cubicBezTo>
                  <a:pt x="3276969" y="6281922"/>
                  <a:pt x="3240639" y="6319217"/>
                  <a:pt x="3240639" y="6367862"/>
                </a:cubicBezTo>
                <a:cubicBezTo>
                  <a:pt x="3240639" y="6417155"/>
                  <a:pt x="3276969" y="6453801"/>
                  <a:pt x="3328545" y="6453801"/>
                </a:cubicBezTo>
                <a:cubicBezTo>
                  <a:pt x="3353053" y="6454342"/>
                  <a:pt x="3376720" y="6444855"/>
                  <a:pt x="3394065" y="6427535"/>
                </a:cubicBezTo>
                <a:lnTo>
                  <a:pt x="3381411" y="6404507"/>
                </a:lnTo>
                <a:cubicBezTo>
                  <a:pt x="3367999" y="6418078"/>
                  <a:pt x="3349882" y="6425974"/>
                  <a:pt x="3330810" y="6426561"/>
                </a:cubicBezTo>
                <a:cubicBezTo>
                  <a:pt x="3296751" y="6426561"/>
                  <a:pt x="3272749" y="6400940"/>
                  <a:pt x="3272749" y="6367536"/>
                </a:cubicBezTo>
                <a:cubicBezTo>
                  <a:pt x="3272749" y="6333809"/>
                  <a:pt x="3296751" y="6309162"/>
                  <a:pt x="3329836" y="6309162"/>
                </a:cubicBezTo>
                <a:cubicBezTo>
                  <a:pt x="3346822" y="6309400"/>
                  <a:pt x="3363072" y="6316132"/>
                  <a:pt x="3375250" y="6327973"/>
                </a:cubicBezTo>
                <a:lnTo>
                  <a:pt x="3390169" y="6305919"/>
                </a:lnTo>
                <a:cubicBezTo>
                  <a:pt x="3390169" y="6305919"/>
                  <a:pt x="3369738" y="6281922"/>
                  <a:pt x="3328545" y="6281922"/>
                </a:cubicBezTo>
                <a:close/>
                <a:moveTo>
                  <a:pt x="3161340" y="6281922"/>
                </a:moveTo>
                <a:cubicBezTo>
                  <a:pt x="3135204" y="6281326"/>
                  <a:pt x="3111121" y="6296026"/>
                  <a:pt x="3099708" y="6319542"/>
                </a:cubicBezTo>
                <a:lnTo>
                  <a:pt x="3099059" y="6319542"/>
                </a:lnTo>
                <a:cubicBezTo>
                  <a:pt x="3099484" y="6315556"/>
                  <a:pt x="3099701" y="6311551"/>
                  <a:pt x="3099708" y="6307543"/>
                </a:cubicBezTo>
                <a:lnTo>
                  <a:pt x="3099708" y="6285814"/>
                </a:lnTo>
                <a:lnTo>
                  <a:pt x="3069221" y="6285814"/>
                </a:lnTo>
                <a:lnTo>
                  <a:pt x="3069221" y="6449909"/>
                </a:lnTo>
                <a:lnTo>
                  <a:pt x="3100682" y="6449909"/>
                </a:lnTo>
                <a:lnTo>
                  <a:pt x="3100682" y="6373051"/>
                </a:lnTo>
                <a:cubicBezTo>
                  <a:pt x="3100487" y="6365614"/>
                  <a:pt x="3101362" y="6358186"/>
                  <a:pt x="3103280" y="6350997"/>
                </a:cubicBezTo>
                <a:cubicBezTo>
                  <a:pt x="3109426" y="6327359"/>
                  <a:pt x="3130744" y="6310840"/>
                  <a:pt x="3155171" y="6310785"/>
                </a:cubicBezTo>
                <a:cubicBezTo>
                  <a:pt x="3181446" y="6310785"/>
                  <a:pt x="3186316" y="6328944"/>
                  <a:pt x="3186316" y="6351971"/>
                </a:cubicBezTo>
                <a:lnTo>
                  <a:pt x="3186316" y="6449909"/>
                </a:lnTo>
                <a:lnTo>
                  <a:pt x="3217777" y="6449909"/>
                </a:lnTo>
                <a:lnTo>
                  <a:pt x="3217777" y="6344838"/>
                </a:lnTo>
                <a:cubicBezTo>
                  <a:pt x="3217777" y="6303003"/>
                  <a:pt x="3199936" y="6281922"/>
                  <a:pt x="3161340" y="6281922"/>
                </a:cubicBezTo>
                <a:close/>
                <a:moveTo>
                  <a:pt x="2972280" y="6281922"/>
                </a:moveTo>
                <a:cubicBezTo>
                  <a:pt x="2925568" y="6281922"/>
                  <a:pt x="2890218" y="6315650"/>
                  <a:pt x="2890218" y="6367862"/>
                </a:cubicBezTo>
                <a:cubicBezTo>
                  <a:pt x="2890218" y="6416506"/>
                  <a:pt x="2925568" y="6453801"/>
                  <a:pt x="2977142" y="6453801"/>
                </a:cubicBezTo>
                <a:cubicBezTo>
                  <a:pt x="3000442" y="6453844"/>
                  <a:pt x="3022990" y="6445564"/>
                  <a:pt x="3040722" y="6430452"/>
                </a:cubicBezTo>
                <a:lnTo>
                  <a:pt x="3027743" y="6407425"/>
                </a:lnTo>
                <a:cubicBezTo>
                  <a:pt x="3014201" y="6419193"/>
                  <a:pt x="2997023" y="6425950"/>
                  <a:pt x="2979090" y="6426561"/>
                </a:cubicBezTo>
                <a:cubicBezTo>
                  <a:pt x="2949894" y="6426561"/>
                  <a:pt x="2924277" y="6408398"/>
                  <a:pt x="2922653" y="6372402"/>
                </a:cubicBezTo>
                <a:lnTo>
                  <a:pt x="3042338" y="6372402"/>
                </a:lnTo>
                <a:cubicBezTo>
                  <a:pt x="3042338" y="6372402"/>
                  <a:pt x="3043311" y="6362996"/>
                  <a:pt x="3043311" y="6358780"/>
                </a:cubicBezTo>
                <a:cubicBezTo>
                  <a:pt x="3043311" y="6316295"/>
                  <a:pt x="3018660" y="6281922"/>
                  <a:pt x="2972280" y="6281922"/>
                </a:cubicBezTo>
                <a:close/>
                <a:moveTo>
                  <a:pt x="2748837" y="6281922"/>
                </a:moveTo>
                <a:cubicBezTo>
                  <a:pt x="2697262" y="6281922"/>
                  <a:pt x="2660931" y="6319217"/>
                  <a:pt x="2660931" y="6367862"/>
                </a:cubicBezTo>
                <a:cubicBezTo>
                  <a:pt x="2660931" y="6417155"/>
                  <a:pt x="2697262" y="6453801"/>
                  <a:pt x="2748837" y="6453801"/>
                </a:cubicBezTo>
                <a:cubicBezTo>
                  <a:pt x="2773344" y="6454342"/>
                  <a:pt x="2797011" y="6444855"/>
                  <a:pt x="2814356" y="6427535"/>
                </a:cubicBezTo>
                <a:lnTo>
                  <a:pt x="2801703" y="6404507"/>
                </a:lnTo>
                <a:cubicBezTo>
                  <a:pt x="2788291" y="6418078"/>
                  <a:pt x="2770174" y="6425974"/>
                  <a:pt x="2751101" y="6426561"/>
                </a:cubicBezTo>
                <a:cubicBezTo>
                  <a:pt x="2717043" y="6426561"/>
                  <a:pt x="2693040" y="6400940"/>
                  <a:pt x="2693040" y="6367536"/>
                </a:cubicBezTo>
                <a:cubicBezTo>
                  <a:pt x="2693040" y="6333809"/>
                  <a:pt x="2717043" y="6309162"/>
                  <a:pt x="2750128" y="6309162"/>
                </a:cubicBezTo>
                <a:cubicBezTo>
                  <a:pt x="2767113" y="6309400"/>
                  <a:pt x="2783363" y="6316132"/>
                  <a:pt x="2795541" y="6327973"/>
                </a:cubicBezTo>
                <a:lnTo>
                  <a:pt x="2810461" y="6305919"/>
                </a:lnTo>
                <a:cubicBezTo>
                  <a:pt x="2810461" y="6305919"/>
                  <a:pt x="2790029" y="6281922"/>
                  <a:pt x="2748837" y="6281922"/>
                </a:cubicBezTo>
                <a:close/>
                <a:moveTo>
                  <a:pt x="2593020" y="6281922"/>
                </a:moveTo>
                <a:cubicBezTo>
                  <a:pt x="2560260" y="6281922"/>
                  <a:pt x="2533661" y="6298787"/>
                  <a:pt x="2533661" y="6328619"/>
                </a:cubicBezTo>
                <a:cubicBezTo>
                  <a:pt x="2533661" y="6382132"/>
                  <a:pt x="2617996" y="6375969"/>
                  <a:pt x="2617996" y="6406130"/>
                </a:cubicBezTo>
                <a:cubicBezTo>
                  <a:pt x="2617996" y="6419427"/>
                  <a:pt x="2604367" y="6426561"/>
                  <a:pt x="2590747" y="6426561"/>
                </a:cubicBezTo>
                <a:cubicBezTo>
                  <a:pt x="2573236" y="6426254"/>
                  <a:pt x="2556467" y="6419431"/>
                  <a:pt x="2543718" y="6407425"/>
                </a:cubicBezTo>
                <a:lnTo>
                  <a:pt x="2528466" y="6429803"/>
                </a:lnTo>
                <a:cubicBezTo>
                  <a:pt x="2545284" y="6445645"/>
                  <a:pt x="2567645" y="6454261"/>
                  <a:pt x="2590747" y="6453801"/>
                </a:cubicBezTo>
                <a:cubicBezTo>
                  <a:pt x="2626753" y="6453801"/>
                  <a:pt x="2650106" y="6433369"/>
                  <a:pt x="2650106" y="6406130"/>
                </a:cubicBezTo>
                <a:cubicBezTo>
                  <a:pt x="2650106" y="6352295"/>
                  <a:pt x="2565771" y="6358780"/>
                  <a:pt x="2565771" y="6329268"/>
                </a:cubicBezTo>
                <a:cubicBezTo>
                  <a:pt x="2565771" y="6315001"/>
                  <a:pt x="2579067" y="6309162"/>
                  <a:pt x="2592695" y="6309162"/>
                </a:cubicBezTo>
                <a:cubicBezTo>
                  <a:pt x="2607550" y="6308844"/>
                  <a:pt x="2621996" y="6314044"/>
                  <a:pt x="2633239" y="6323757"/>
                </a:cubicBezTo>
                <a:lnTo>
                  <a:pt x="2645885" y="6300081"/>
                </a:lnTo>
                <a:cubicBezTo>
                  <a:pt x="2645885" y="6300081"/>
                  <a:pt x="2629018" y="6281922"/>
                  <a:pt x="2593020" y="6281922"/>
                </a:cubicBezTo>
                <a:close/>
                <a:moveTo>
                  <a:pt x="1223619" y="6235871"/>
                </a:moveTo>
                <a:lnTo>
                  <a:pt x="1278761" y="6235871"/>
                </a:lnTo>
                <a:cubicBezTo>
                  <a:pt x="1339094" y="6235871"/>
                  <a:pt x="1379638" y="6271542"/>
                  <a:pt x="1379638" y="6336406"/>
                </a:cubicBezTo>
                <a:cubicBezTo>
                  <a:pt x="1379638" y="6401589"/>
                  <a:pt x="1339094" y="6436937"/>
                  <a:pt x="1278761" y="6436937"/>
                </a:cubicBezTo>
                <a:lnTo>
                  <a:pt x="1223619" y="6436937"/>
                </a:lnTo>
                <a:close/>
                <a:moveTo>
                  <a:pt x="2147812" y="6222898"/>
                </a:moveTo>
                <a:lnTo>
                  <a:pt x="2147812" y="6449909"/>
                </a:lnTo>
                <a:lnTo>
                  <a:pt x="2161440" y="6449909"/>
                </a:lnTo>
                <a:lnTo>
                  <a:pt x="2161440" y="6431426"/>
                </a:lnTo>
                <a:cubicBezTo>
                  <a:pt x="2161480" y="6426638"/>
                  <a:pt x="2161045" y="6421858"/>
                  <a:pt x="2160141" y="6417155"/>
                </a:cubicBezTo>
                <a:lnTo>
                  <a:pt x="2160791" y="6417155"/>
                </a:lnTo>
                <a:cubicBezTo>
                  <a:pt x="2160791" y="6417155"/>
                  <a:pt x="2176035" y="6453801"/>
                  <a:pt x="2216903" y="6453801"/>
                </a:cubicBezTo>
                <a:cubicBezTo>
                  <a:pt x="2259395" y="6453801"/>
                  <a:pt x="2289558" y="6420397"/>
                  <a:pt x="2289558" y="6368835"/>
                </a:cubicBezTo>
                <a:cubicBezTo>
                  <a:pt x="2289558" y="6318568"/>
                  <a:pt x="2262959" y="6283866"/>
                  <a:pt x="2219501" y="6283866"/>
                </a:cubicBezTo>
                <a:cubicBezTo>
                  <a:pt x="2194302" y="6283022"/>
                  <a:pt x="2171097" y="6297505"/>
                  <a:pt x="2160791" y="6320511"/>
                </a:cubicBezTo>
                <a:lnTo>
                  <a:pt x="2160141" y="6320511"/>
                </a:lnTo>
                <a:cubicBezTo>
                  <a:pt x="2161010" y="6316134"/>
                  <a:pt x="2161445" y="6311681"/>
                  <a:pt x="2161440" y="6307218"/>
                </a:cubicBezTo>
                <a:lnTo>
                  <a:pt x="2161440" y="6222898"/>
                </a:lnTo>
                <a:close/>
                <a:moveTo>
                  <a:pt x="1525168" y="6222898"/>
                </a:moveTo>
                <a:lnTo>
                  <a:pt x="1525168" y="6246571"/>
                </a:lnTo>
                <a:lnTo>
                  <a:pt x="1541386" y="6246571"/>
                </a:lnTo>
                <a:lnTo>
                  <a:pt x="1541386" y="6222898"/>
                </a:lnTo>
                <a:close/>
                <a:moveTo>
                  <a:pt x="1209670" y="6222898"/>
                </a:moveTo>
                <a:lnTo>
                  <a:pt x="1209670" y="6449909"/>
                </a:lnTo>
                <a:lnTo>
                  <a:pt x="1281034" y="6449909"/>
                </a:lnTo>
                <a:cubicBezTo>
                  <a:pt x="1348498" y="6449909"/>
                  <a:pt x="1394232" y="6408723"/>
                  <a:pt x="1394232" y="6336406"/>
                </a:cubicBezTo>
                <a:cubicBezTo>
                  <a:pt x="1394232" y="6264409"/>
                  <a:pt x="1348498" y="6222898"/>
                  <a:pt x="1281034" y="6222898"/>
                </a:cubicBezTo>
                <a:close/>
                <a:moveTo>
                  <a:pt x="2833551" y="6220951"/>
                </a:moveTo>
                <a:lnTo>
                  <a:pt x="2833551" y="6253060"/>
                </a:lnTo>
                <a:lnTo>
                  <a:pt x="2865337" y="6253060"/>
                </a:lnTo>
                <a:lnTo>
                  <a:pt x="2865337" y="6220951"/>
                </a:lnTo>
                <a:close/>
                <a:moveTo>
                  <a:pt x="982628" y="6207360"/>
                </a:moveTo>
                <a:cubicBezTo>
                  <a:pt x="963105" y="6332337"/>
                  <a:pt x="865050" y="6430379"/>
                  <a:pt x="740053" y="6449905"/>
                </a:cubicBezTo>
                <a:lnTo>
                  <a:pt x="982628" y="6449909"/>
                </a:lnTo>
                <a:close/>
                <a:moveTo>
                  <a:pt x="407989" y="6207356"/>
                </a:moveTo>
                <a:lnTo>
                  <a:pt x="407989" y="6449905"/>
                </a:lnTo>
                <a:lnTo>
                  <a:pt x="650564" y="6449905"/>
                </a:lnTo>
                <a:cubicBezTo>
                  <a:pt x="525562" y="6430384"/>
                  <a:pt x="427505" y="6332337"/>
                  <a:pt x="407989" y="6207356"/>
                </a:cubicBezTo>
                <a:close/>
                <a:moveTo>
                  <a:pt x="883619" y="6147250"/>
                </a:moveTo>
                <a:lnTo>
                  <a:pt x="915428" y="6147250"/>
                </a:lnTo>
                <a:lnTo>
                  <a:pt x="915428" y="6178023"/>
                </a:lnTo>
                <a:lnTo>
                  <a:pt x="883619" y="6178023"/>
                </a:lnTo>
                <a:close/>
                <a:moveTo>
                  <a:pt x="739956" y="6106213"/>
                </a:moveTo>
                <a:lnTo>
                  <a:pt x="739956" y="6219065"/>
                </a:lnTo>
                <a:lnTo>
                  <a:pt x="830261" y="6219065"/>
                </a:lnTo>
                <a:lnTo>
                  <a:pt x="830261" y="6178031"/>
                </a:lnTo>
                <a:lnTo>
                  <a:pt x="781009" y="6178031"/>
                </a:lnTo>
                <a:lnTo>
                  <a:pt x="781009" y="6147251"/>
                </a:lnTo>
                <a:lnTo>
                  <a:pt x="830261" y="6147251"/>
                </a:lnTo>
                <a:lnTo>
                  <a:pt x="830261" y="6106213"/>
                </a:lnTo>
                <a:close/>
                <a:moveTo>
                  <a:pt x="3802396" y="6068975"/>
                </a:moveTo>
                <a:lnTo>
                  <a:pt x="3802396" y="6102379"/>
                </a:lnTo>
                <a:lnTo>
                  <a:pt x="3835481" y="6102379"/>
                </a:lnTo>
                <a:lnTo>
                  <a:pt x="3835481" y="6068975"/>
                </a:lnTo>
                <a:close/>
                <a:moveTo>
                  <a:pt x="842572" y="6042596"/>
                </a:moveTo>
                <a:lnTo>
                  <a:pt x="842572" y="6219054"/>
                </a:lnTo>
                <a:lnTo>
                  <a:pt x="953399" y="6219054"/>
                </a:lnTo>
                <a:lnTo>
                  <a:pt x="953399" y="6106202"/>
                </a:lnTo>
                <a:lnTo>
                  <a:pt x="883619" y="6106202"/>
                </a:lnTo>
                <a:lnTo>
                  <a:pt x="883619" y="6042596"/>
                </a:lnTo>
                <a:close/>
                <a:moveTo>
                  <a:pt x="2979149" y="6023573"/>
                </a:moveTo>
                <a:lnTo>
                  <a:pt x="2987258" y="6023573"/>
                </a:lnTo>
                <a:lnTo>
                  <a:pt x="2987258" y="6028762"/>
                </a:lnTo>
                <a:cubicBezTo>
                  <a:pt x="2987258" y="6053085"/>
                  <a:pt x="2970067" y="6080974"/>
                  <a:pt x="2943468" y="6080974"/>
                </a:cubicBezTo>
                <a:cubicBezTo>
                  <a:pt x="2923029" y="6080974"/>
                  <a:pt x="2912656" y="6068005"/>
                  <a:pt x="2912656" y="6054708"/>
                </a:cubicBezTo>
                <a:cubicBezTo>
                  <a:pt x="2912656" y="6025196"/>
                  <a:pt x="2955464" y="6023573"/>
                  <a:pt x="2979149" y="6023573"/>
                </a:cubicBezTo>
                <a:close/>
                <a:moveTo>
                  <a:pt x="2790699" y="5961955"/>
                </a:moveTo>
                <a:cubicBezTo>
                  <a:pt x="2817947" y="5961955"/>
                  <a:pt x="2837087" y="5984982"/>
                  <a:pt x="2837087" y="6020654"/>
                </a:cubicBezTo>
                <a:cubicBezTo>
                  <a:pt x="2837087" y="6057949"/>
                  <a:pt x="2815674" y="6079354"/>
                  <a:pt x="2789732" y="6079354"/>
                </a:cubicBezTo>
                <a:cubicBezTo>
                  <a:pt x="2759562" y="6079354"/>
                  <a:pt x="2743344" y="6050166"/>
                  <a:pt x="2743344" y="6020979"/>
                </a:cubicBezTo>
                <a:cubicBezTo>
                  <a:pt x="2743344" y="5979143"/>
                  <a:pt x="2766047" y="5961955"/>
                  <a:pt x="2790699" y="5961955"/>
                </a:cubicBezTo>
                <a:close/>
                <a:moveTo>
                  <a:pt x="3285066" y="5959362"/>
                </a:moveTo>
                <a:cubicBezTo>
                  <a:pt x="3306153" y="5959362"/>
                  <a:pt x="3323671" y="5972980"/>
                  <a:pt x="3324644" y="6001198"/>
                </a:cubicBezTo>
                <a:lnTo>
                  <a:pt x="3237062" y="6001198"/>
                </a:lnTo>
                <a:cubicBezTo>
                  <a:pt x="3241608" y="5974279"/>
                  <a:pt x="3261065" y="5959362"/>
                  <a:pt x="3285066" y="5959362"/>
                </a:cubicBezTo>
                <a:close/>
                <a:moveTo>
                  <a:pt x="2389939" y="5949632"/>
                </a:moveTo>
                <a:cubicBezTo>
                  <a:pt x="2423024" y="5949632"/>
                  <a:pt x="2446377" y="5977521"/>
                  <a:pt x="2446377" y="6021305"/>
                </a:cubicBezTo>
                <a:cubicBezTo>
                  <a:pt x="2446377" y="6066707"/>
                  <a:pt x="2420427" y="6092976"/>
                  <a:pt x="2388641" y="6092976"/>
                </a:cubicBezTo>
                <a:cubicBezTo>
                  <a:pt x="2350687" y="6092976"/>
                  <a:pt x="2332204" y="6057626"/>
                  <a:pt x="2332204" y="6021629"/>
                </a:cubicBezTo>
                <a:cubicBezTo>
                  <a:pt x="2332204" y="5970712"/>
                  <a:pt x="2360094" y="5949632"/>
                  <a:pt x="2389939" y="5949632"/>
                </a:cubicBezTo>
                <a:close/>
                <a:moveTo>
                  <a:pt x="2115219" y="5949632"/>
                </a:moveTo>
                <a:cubicBezTo>
                  <a:pt x="2153168" y="5949632"/>
                  <a:pt x="2171660" y="5984983"/>
                  <a:pt x="2171660" y="6020980"/>
                </a:cubicBezTo>
                <a:cubicBezTo>
                  <a:pt x="2171660" y="6071896"/>
                  <a:pt x="2143761" y="6092976"/>
                  <a:pt x="2113920" y="6092976"/>
                </a:cubicBezTo>
                <a:cubicBezTo>
                  <a:pt x="2080833" y="6092976"/>
                  <a:pt x="2057481" y="6065084"/>
                  <a:pt x="2057481" y="6021305"/>
                </a:cubicBezTo>
                <a:cubicBezTo>
                  <a:pt x="2057481" y="5975902"/>
                  <a:pt x="2083427" y="5949632"/>
                  <a:pt x="2115219" y="5949632"/>
                </a:cubicBezTo>
                <a:close/>
                <a:moveTo>
                  <a:pt x="1641577" y="5949632"/>
                </a:moveTo>
                <a:cubicBezTo>
                  <a:pt x="1674661" y="5949632"/>
                  <a:pt x="1698014" y="5977521"/>
                  <a:pt x="1698014" y="6021304"/>
                </a:cubicBezTo>
                <a:cubicBezTo>
                  <a:pt x="1698014" y="6066706"/>
                  <a:pt x="1672064" y="6092976"/>
                  <a:pt x="1640278" y="6092976"/>
                </a:cubicBezTo>
                <a:cubicBezTo>
                  <a:pt x="1603947" y="6092976"/>
                  <a:pt x="1583842" y="6057625"/>
                  <a:pt x="1583842" y="6021628"/>
                </a:cubicBezTo>
                <a:cubicBezTo>
                  <a:pt x="1583842" y="5970712"/>
                  <a:pt x="1611732" y="5949632"/>
                  <a:pt x="1641577" y="5949632"/>
                </a:cubicBezTo>
                <a:close/>
                <a:moveTo>
                  <a:pt x="1954957" y="5948983"/>
                </a:moveTo>
                <a:cubicBezTo>
                  <a:pt x="1981876" y="5948983"/>
                  <a:pt x="2005557" y="5966821"/>
                  <a:pt x="2007177" y="6006384"/>
                </a:cubicBezTo>
                <a:lnTo>
                  <a:pt x="1891706" y="6006384"/>
                </a:lnTo>
                <a:cubicBezTo>
                  <a:pt x="1897546" y="5968444"/>
                  <a:pt x="1925116" y="5948983"/>
                  <a:pt x="1954957" y="5948983"/>
                </a:cubicBezTo>
                <a:close/>
                <a:moveTo>
                  <a:pt x="2464407" y="5940226"/>
                </a:moveTo>
                <a:lnTo>
                  <a:pt x="2531550" y="6101405"/>
                </a:lnTo>
                <a:lnTo>
                  <a:pt x="2519870" y="6128324"/>
                </a:lnTo>
                <a:cubicBezTo>
                  <a:pt x="2513384" y="6143564"/>
                  <a:pt x="2503652" y="6157511"/>
                  <a:pt x="2488084" y="6157511"/>
                </a:cubicBezTo>
                <a:cubicBezTo>
                  <a:pt x="2480726" y="6157103"/>
                  <a:pt x="2473686" y="6154379"/>
                  <a:pt x="2467970" y="6149728"/>
                </a:cubicBezTo>
                <a:lnTo>
                  <a:pt x="2461809" y="6161402"/>
                </a:lnTo>
                <a:cubicBezTo>
                  <a:pt x="2469354" y="6167192"/>
                  <a:pt x="2478573" y="6170379"/>
                  <a:pt x="2488084" y="6170485"/>
                </a:cubicBezTo>
                <a:cubicBezTo>
                  <a:pt x="2508514" y="6170485"/>
                  <a:pt x="2522142" y="6157186"/>
                  <a:pt x="2529277" y="6140322"/>
                </a:cubicBezTo>
                <a:lnTo>
                  <a:pt x="2612638" y="5940226"/>
                </a:lnTo>
                <a:lnTo>
                  <a:pt x="2598044" y="5940226"/>
                </a:lnTo>
                <a:lnTo>
                  <a:pt x="2544521" y="6069624"/>
                </a:lnTo>
                <a:cubicBezTo>
                  <a:pt x="2541274" y="6077407"/>
                  <a:pt x="2539009" y="6084865"/>
                  <a:pt x="2539009" y="6084865"/>
                </a:cubicBezTo>
                <a:lnTo>
                  <a:pt x="2538360" y="6084865"/>
                </a:lnTo>
                <a:cubicBezTo>
                  <a:pt x="2538360" y="6084865"/>
                  <a:pt x="2535763" y="6077407"/>
                  <a:pt x="2532516" y="6069624"/>
                </a:cubicBezTo>
                <a:lnTo>
                  <a:pt x="2479001" y="5940226"/>
                </a:lnTo>
                <a:close/>
                <a:moveTo>
                  <a:pt x="1744846" y="5940226"/>
                </a:moveTo>
                <a:lnTo>
                  <a:pt x="1744846" y="6102378"/>
                </a:lnTo>
                <a:lnTo>
                  <a:pt x="1758470" y="6102378"/>
                </a:lnTo>
                <a:lnTo>
                  <a:pt x="1758470" y="5940226"/>
                </a:lnTo>
                <a:close/>
                <a:moveTo>
                  <a:pt x="1864854" y="5938932"/>
                </a:moveTo>
                <a:cubicBezTo>
                  <a:pt x="1839229" y="5938932"/>
                  <a:pt x="1821064" y="5959362"/>
                  <a:pt x="1812955" y="5984334"/>
                </a:cubicBezTo>
                <a:lnTo>
                  <a:pt x="1812306" y="5984334"/>
                </a:lnTo>
                <a:cubicBezTo>
                  <a:pt x="1813174" y="5979955"/>
                  <a:pt x="1813609" y="5975501"/>
                  <a:pt x="1813604" y="5971037"/>
                </a:cubicBezTo>
                <a:lnTo>
                  <a:pt x="1813604" y="5940226"/>
                </a:lnTo>
                <a:lnTo>
                  <a:pt x="1799984" y="5940226"/>
                </a:lnTo>
                <a:lnTo>
                  <a:pt x="1799984" y="6102378"/>
                </a:lnTo>
                <a:lnTo>
                  <a:pt x="1813604" y="6102378"/>
                </a:lnTo>
                <a:lnTo>
                  <a:pt x="1813604" y="6032329"/>
                </a:lnTo>
                <a:cubicBezTo>
                  <a:pt x="1813514" y="6020799"/>
                  <a:pt x="1815154" y="6009320"/>
                  <a:pt x="1818470" y="5998276"/>
                </a:cubicBezTo>
                <a:cubicBezTo>
                  <a:pt x="1825609" y="5974279"/>
                  <a:pt x="1841502" y="5952874"/>
                  <a:pt x="1866802" y="5952874"/>
                </a:cubicBezTo>
                <a:cubicBezTo>
                  <a:pt x="1869301" y="5952914"/>
                  <a:pt x="1871794" y="5953131"/>
                  <a:pt x="1874262" y="5953523"/>
                </a:cubicBezTo>
                <a:lnTo>
                  <a:pt x="1874262" y="5939902"/>
                </a:lnTo>
                <a:cubicBezTo>
                  <a:pt x="1871162" y="5939288"/>
                  <a:pt x="1868013" y="5938964"/>
                  <a:pt x="1864854" y="5938932"/>
                </a:cubicBezTo>
                <a:close/>
                <a:moveTo>
                  <a:pt x="3147319" y="5938282"/>
                </a:moveTo>
                <a:lnTo>
                  <a:pt x="3147319" y="6102378"/>
                </a:lnTo>
                <a:lnTo>
                  <a:pt x="3178780" y="6102378"/>
                </a:lnTo>
                <a:lnTo>
                  <a:pt x="3178780" y="5938282"/>
                </a:lnTo>
                <a:close/>
                <a:moveTo>
                  <a:pt x="1955281" y="5936335"/>
                </a:moveTo>
                <a:cubicBezTo>
                  <a:pt x="1913763" y="5936335"/>
                  <a:pt x="1876463" y="5966821"/>
                  <a:pt x="1876463" y="6021629"/>
                </a:cubicBezTo>
                <a:cubicBezTo>
                  <a:pt x="1876463" y="6073190"/>
                  <a:pt x="1914410" y="6106269"/>
                  <a:pt x="1960147" y="6106269"/>
                </a:cubicBezTo>
                <a:cubicBezTo>
                  <a:pt x="1981462" y="6106017"/>
                  <a:pt x="2001966" y="6098070"/>
                  <a:pt x="2017884" y="6083895"/>
                </a:cubicBezTo>
                <a:lnTo>
                  <a:pt x="2010424" y="6072541"/>
                </a:lnTo>
                <a:cubicBezTo>
                  <a:pt x="1996890" y="6085523"/>
                  <a:pt x="1978902" y="6092834"/>
                  <a:pt x="1960147" y="6092976"/>
                </a:cubicBezTo>
                <a:cubicBezTo>
                  <a:pt x="1922522" y="6092976"/>
                  <a:pt x="1890731" y="6066057"/>
                  <a:pt x="1890731" y="6019031"/>
                </a:cubicBezTo>
                <a:lnTo>
                  <a:pt x="2020802" y="6019031"/>
                </a:lnTo>
                <a:cubicBezTo>
                  <a:pt x="2020802" y="6019031"/>
                  <a:pt x="2021451" y="6013846"/>
                  <a:pt x="2021451" y="6010275"/>
                </a:cubicBezTo>
                <a:cubicBezTo>
                  <a:pt x="2021451" y="5971037"/>
                  <a:pt x="1999394" y="5936335"/>
                  <a:pt x="1955281" y="5936335"/>
                </a:cubicBezTo>
                <a:close/>
                <a:moveTo>
                  <a:pt x="1642226" y="5936335"/>
                </a:moveTo>
                <a:cubicBezTo>
                  <a:pt x="1597137" y="5936335"/>
                  <a:pt x="1583842" y="5972656"/>
                  <a:pt x="1583842" y="5972656"/>
                </a:cubicBezTo>
                <a:lnTo>
                  <a:pt x="1583192" y="5972655"/>
                </a:lnTo>
                <a:cubicBezTo>
                  <a:pt x="1583857" y="5968365"/>
                  <a:pt x="1584183" y="5964029"/>
                  <a:pt x="1584166" y="5959687"/>
                </a:cubicBezTo>
                <a:lnTo>
                  <a:pt x="1584166" y="5940226"/>
                </a:lnTo>
                <a:lnTo>
                  <a:pt x="1570538" y="5940226"/>
                </a:lnTo>
                <a:lnTo>
                  <a:pt x="1570538" y="6167243"/>
                </a:lnTo>
                <a:lnTo>
                  <a:pt x="1584166" y="6167243"/>
                </a:lnTo>
                <a:lnTo>
                  <a:pt x="1584166" y="6083895"/>
                </a:lnTo>
                <a:cubicBezTo>
                  <a:pt x="1584206" y="6079107"/>
                  <a:pt x="1583771" y="6074326"/>
                  <a:pt x="1582867" y="6069624"/>
                </a:cubicBezTo>
                <a:lnTo>
                  <a:pt x="1583517" y="6069624"/>
                </a:lnTo>
                <a:cubicBezTo>
                  <a:pt x="1593528" y="6091984"/>
                  <a:pt x="1615776" y="6106348"/>
                  <a:pt x="1640279" y="6106269"/>
                </a:cubicBezTo>
                <a:cubicBezTo>
                  <a:pt x="1682121" y="6106269"/>
                  <a:pt x="1712284" y="6072866"/>
                  <a:pt x="1712284" y="6021304"/>
                </a:cubicBezTo>
                <a:cubicBezTo>
                  <a:pt x="1712284" y="5971037"/>
                  <a:pt x="1685689" y="5936335"/>
                  <a:pt x="1642226" y="5936335"/>
                </a:cubicBezTo>
                <a:close/>
                <a:moveTo>
                  <a:pt x="1489846" y="5936335"/>
                </a:moveTo>
                <a:cubicBezTo>
                  <a:pt x="1462277" y="5936335"/>
                  <a:pt x="1437951" y="5951255"/>
                  <a:pt x="1437951" y="5980118"/>
                </a:cubicBezTo>
                <a:cubicBezTo>
                  <a:pt x="1437951" y="6032978"/>
                  <a:pt x="1527151" y="6021304"/>
                  <a:pt x="1527151" y="6062490"/>
                </a:cubicBezTo>
                <a:cubicBezTo>
                  <a:pt x="1527151" y="6082596"/>
                  <a:pt x="1509635" y="6092976"/>
                  <a:pt x="1489846" y="6092977"/>
                </a:cubicBezTo>
                <a:cubicBezTo>
                  <a:pt x="1471034" y="6093132"/>
                  <a:pt x="1452938" y="6085776"/>
                  <a:pt x="1439570" y="6072541"/>
                </a:cubicBezTo>
                <a:lnTo>
                  <a:pt x="1430812" y="6082921"/>
                </a:lnTo>
                <a:cubicBezTo>
                  <a:pt x="1430812" y="6082921"/>
                  <a:pt x="1450276" y="6106269"/>
                  <a:pt x="1489522" y="6106269"/>
                </a:cubicBezTo>
                <a:cubicBezTo>
                  <a:pt x="1519363" y="6106269"/>
                  <a:pt x="1541421" y="6088435"/>
                  <a:pt x="1541421" y="6062490"/>
                </a:cubicBezTo>
                <a:cubicBezTo>
                  <a:pt x="1541421" y="6008656"/>
                  <a:pt x="1452224" y="6021304"/>
                  <a:pt x="1452224" y="5979144"/>
                </a:cubicBezTo>
                <a:cubicBezTo>
                  <a:pt x="1452224" y="5958064"/>
                  <a:pt x="1470386" y="5949632"/>
                  <a:pt x="1488872" y="5949632"/>
                </a:cubicBezTo>
                <a:cubicBezTo>
                  <a:pt x="1516445" y="5949632"/>
                  <a:pt x="1529741" y="5964873"/>
                  <a:pt x="1529741" y="5964873"/>
                </a:cubicBezTo>
                <a:lnTo>
                  <a:pt x="1537850" y="5953848"/>
                </a:lnTo>
                <a:cubicBezTo>
                  <a:pt x="1537850" y="5953848"/>
                  <a:pt x="1522930" y="5936335"/>
                  <a:pt x="1489846" y="5936335"/>
                </a:cubicBezTo>
                <a:close/>
                <a:moveTo>
                  <a:pt x="1352909" y="5936335"/>
                </a:moveTo>
                <a:cubicBezTo>
                  <a:pt x="1322882" y="5936387"/>
                  <a:pt x="1295799" y="5954395"/>
                  <a:pt x="1284142" y="5982062"/>
                </a:cubicBezTo>
                <a:lnTo>
                  <a:pt x="1283493" y="5982062"/>
                </a:lnTo>
                <a:cubicBezTo>
                  <a:pt x="1284361" y="5977683"/>
                  <a:pt x="1284796" y="5973229"/>
                  <a:pt x="1284791" y="5968765"/>
                </a:cubicBezTo>
                <a:lnTo>
                  <a:pt x="1284791" y="5940226"/>
                </a:lnTo>
                <a:lnTo>
                  <a:pt x="1271171" y="5940226"/>
                </a:lnTo>
                <a:lnTo>
                  <a:pt x="1271171" y="6102378"/>
                </a:lnTo>
                <a:lnTo>
                  <a:pt x="1284791" y="6102378"/>
                </a:lnTo>
                <a:lnTo>
                  <a:pt x="1284791" y="6023248"/>
                </a:lnTo>
                <a:cubicBezTo>
                  <a:pt x="1284635" y="6015814"/>
                  <a:pt x="1285509" y="6008393"/>
                  <a:pt x="1287389" y="6001199"/>
                </a:cubicBezTo>
                <a:cubicBezTo>
                  <a:pt x="1295125" y="5971221"/>
                  <a:pt x="1321947" y="5950111"/>
                  <a:pt x="1352909" y="5949632"/>
                </a:cubicBezTo>
                <a:cubicBezTo>
                  <a:pt x="1389235" y="5949632"/>
                  <a:pt x="1392802" y="5976227"/>
                  <a:pt x="1392802" y="6004440"/>
                </a:cubicBezTo>
                <a:lnTo>
                  <a:pt x="1392802" y="6102379"/>
                </a:lnTo>
                <a:lnTo>
                  <a:pt x="1406426" y="6102379"/>
                </a:lnTo>
                <a:lnTo>
                  <a:pt x="1406426" y="5999575"/>
                </a:lnTo>
                <a:cubicBezTo>
                  <a:pt x="1406426" y="5961306"/>
                  <a:pt x="1395076" y="5936335"/>
                  <a:pt x="1352909" y="5936335"/>
                </a:cubicBezTo>
                <a:close/>
                <a:moveTo>
                  <a:pt x="3474783" y="5934392"/>
                </a:moveTo>
                <a:cubicBezTo>
                  <a:pt x="3448647" y="5933795"/>
                  <a:pt x="3424564" y="5948494"/>
                  <a:pt x="3413151" y="5972011"/>
                </a:cubicBezTo>
                <a:lnTo>
                  <a:pt x="3412502" y="5972011"/>
                </a:lnTo>
                <a:cubicBezTo>
                  <a:pt x="3412928" y="5968025"/>
                  <a:pt x="3413144" y="5964020"/>
                  <a:pt x="3413151" y="5960012"/>
                </a:cubicBezTo>
                <a:lnTo>
                  <a:pt x="3413151" y="5938282"/>
                </a:lnTo>
                <a:lnTo>
                  <a:pt x="3382664" y="5938282"/>
                </a:lnTo>
                <a:lnTo>
                  <a:pt x="3382664" y="6102378"/>
                </a:lnTo>
                <a:lnTo>
                  <a:pt x="3414125" y="6102378"/>
                </a:lnTo>
                <a:lnTo>
                  <a:pt x="3414125" y="6025520"/>
                </a:lnTo>
                <a:cubicBezTo>
                  <a:pt x="3413930" y="6018083"/>
                  <a:pt x="3414804" y="6010655"/>
                  <a:pt x="3416723" y="6003466"/>
                </a:cubicBezTo>
                <a:cubicBezTo>
                  <a:pt x="3422869" y="5979829"/>
                  <a:pt x="3444187" y="5963309"/>
                  <a:pt x="3468615" y="5963254"/>
                </a:cubicBezTo>
                <a:cubicBezTo>
                  <a:pt x="3494890" y="5963254"/>
                  <a:pt x="3499759" y="5981413"/>
                  <a:pt x="3499759" y="6004440"/>
                </a:cubicBezTo>
                <a:lnTo>
                  <a:pt x="3499759" y="6102378"/>
                </a:lnTo>
                <a:lnTo>
                  <a:pt x="3531220" y="6102378"/>
                </a:lnTo>
                <a:lnTo>
                  <a:pt x="3531220" y="5997307"/>
                </a:lnTo>
                <a:cubicBezTo>
                  <a:pt x="3531220" y="5955472"/>
                  <a:pt x="3513380" y="5934391"/>
                  <a:pt x="3474783" y="5934392"/>
                </a:cubicBezTo>
                <a:close/>
                <a:moveTo>
                  <a:pt x="3717650" y="5934391"/>
                </a:moveTo>
                <a:cubicBezTo>
                  <a:pt x="3684891" y="5934391"/>
                  <a:pt x="3658292" y="5951255"/>
                  <a:pt x="3658292" y="5981088"/>
                </a:cubicBezTo>
                <a:cubicBezTo>
                  <a:pt x="3658292" y="6034601"/>
                  <a:pt x="3742624" y="6028438"/>
                  <a:pt x="3742624" y="6058599"/>
                </a:cubicBezTo>
                <a:cubicBezTo>
                  <a:pt x="3742624" y="6071896"/>
                  <a:pt x="3728997" y="6079030"/>
                  <a:pt x="3715378" y="6079030"/>
                </a:cubicBezTo>
                <a:cubicBezTo>
                  <a:pt x="3697865" y="6078722"/>
                  <a:pt x="3681098" y="6071899"/>
                  <a:pt x="3668348" y="6059893"/>
                </a:cubicBezTo>
                <a:lnTo>
                  <a:pt x="3653097" y="6082272"/>
                </a:lnTo>
                <a:cubicBezTo>
                  <a:pt x="3669915" y="6098114"/>
                  <a:pt x="3692275" y="6106730"/>
                  <a:pt x="3715378" y="6106270"/>
                </a:cubicBezTo>
                <a:cubicBezTo>
                  <a:pt x="3751384" y="6106270"/>
                  <a:pt x="3774736" y="6085838"/>
                  <a:pt x="3774736" y="6058599"/>
                </a:cubicBezTo>
                <a:cubicBezTo>
                  <a:pt x="3774736" y="6004764"/>
                  <a:pt x="3690402" y="6011249"/>
                  <a:pt x="3690402" y="5981737"/>
                </a:cubicBezTo>
                <a:cubicBezTo>
                  <a:pt x="3690402" y="5967469"/>
                  <a:pt x="3703698" y="5961631"/>
                  <a:pt x="3717325" y="5961631"/>
                </a:cubicBezTo>
                <a:cubicBezTo>
                  <a:pt x="3732180" y="5961313"/>
                  <a:pt x="3746626" y="5966513"/>
                  <a:pt x="3757869" y="5976226"/>
                </a:cubicBezTo>
                <a:lnTo>
                  <a:pt x="3770514" y="5952550"/>
                </a:lnTo>
                <a:cubicBezTo>
                  <a:pt x="3770514" y="5952550"/>
                  <a:pt x="3753648" y="5934391"/>
                  <a:pt x="3717650" y="5934391"/>
                </a:cubicBezTo>
                <a:close/>
                <a:moveTo>
                  <a:pt x="3285715" y="5934391"/>
                </a:moveTo>
                <a:cubicBezTo>
                  <a:pt x="3239010" y="5934391"/>
                  <a:pt x="3203653" y="5968119"/>
                  <a:pt x="3203653" y="6020331"/>
                </a:cubicBezTo>
                <a:cubicBezTo>
                  <a:pt x="3203653" y="6068975"/>
                  <a:pt x="3239010" y="6106270"/>
                  <a:pt x="3290585" y="6106270"/>
                </a:cubicBezTo>
                <a:cubicBezTo>
                  <a:pt x="3313882" y="6106314"/>
                  <a:pt x="3336429" y="6098034"/>
                  <a:pt x="3354158" y="6082921"/>
                </a:cubicBezTo>
                <a:lnTo>
                  <a:pt x="3341187" y="6059893"/>
                </a:lnTo>
                <a:cubicBezTo>
                  <a:pt x="3327640" y="6071661"/>
                  <a:pt x="3310460" y="6078417"/>
                  <a:pt x="3292526" y="6079030"/>
                </a:cubicBezTo>
                <a:cubicBezTo>
                  <a:pt x="3263337" y="6079030"/>
                  <a:pt x="3237712" y="6060868"/>
                  <a:pt x="3236088" y="6024871"/>
                </a:cubicBezTo>
                <a:lnTo>
                  <a:pt x="3355781" y="6024871"/>
                </a:lnTo>
                <a:cubicBezTo>
                  <a:pt x="3355781" y="6024871"/>
                  <a:pt x="3356754" y="6015465"/>
                  <a:pt x="3356754" y="6011249"/>
                </a:cubicBezTo>
                <a:cubicBezTo>
                  <a:pt x="3356754" y="5968764"/>
                  <a:pt x="3332103" y="5934391"/>
                  <a:pt x="3285715" y="5934391"/>
                </a:cubicBezTo>
                <a:close/>
                <a:moveTo>
                  <a:pt x="2953524" y="5934391"/>
                </a:moveTo>
                <a:cubicBezTo>
                  <a:pt x="2931535" y="5934165"/>
                  <a:pt x="2910051" y="5940983"/>
                  <a:pt x="2892217" y="5953848"/>
                </a:cubicBezTo>
                <a:lnTo>
                  <a:pt x="2905189" y="5976872"/>
                </a:lnTo>
                <a:cubicBezTo>
                  <a:pt x="2918524" y="5967162"/>
                  <a:pt x="2934443" y="5961631"/>
                  <a:pt x="2950927" y="5960982"/>
                </a:cubicBezTo>
                <a:cubicBezTo>
                  <a:pt x="2971682" y="5960982"/>
                  <a:pt x="2986934" y="5970063"/>
                  <a:pt x="2986934" y="5996982"/>
                </a:cubicBezTo>
                <a:lnTo>
                  <a:pt x="2986934" y="5999900"/>
                </a:lnTo>
                <a:lnTo>
                  <a:pt x="2979791" y="5999900"/>
                </a:lnTo>
                <a:cubicBezTo>
                  <a:pt x="2952226" y="5999900"/>
                  <a:pt x="2880862" y="6002169"/>
                  <a:pt x="2880862" y="6056327"/>
                </a:cubicBezTo>
                <a:cubicBezTo>
                  <a:pt x="2880862" y="6089081"/>
                  <a:pt x="2908435" y="6106270"/>
                  <a:pt x="2936658" y="6106270"/>
                </a:cubicBezTo>
                <a:cubicBezTo>
                  <a:pt x="2959034" y="6106761"/>
                  <a:pt x="2979611" y="6094061"/>
                  <a:pt x="2989199" y="6073840"/>
                </a:cubicBezTo>
                <a:lnTo>
                  <a:pt x="2989847" y="6073840"/>
                </a:lnTo>
                <a:cubicBezTo>
                  <a:pt x="2989403" y="6078150"/>
                  <a:pt x="2989187" y="6082480"/>
                  <a:pt x="2989199" y="6086813"/>
                </a:cubicBezTo>
                <a:lnTo>
                  <a:pt x="2989199" y="6102379"/>
                </a:lnTo>
                <a:lnTo>
                  <a:pt x="3018394" y="6102379"/>
                </a:lnTo>
                <a:lnTo>
                  <a:pt x="3018394" y="5998601"/>
                </a:lnTo>
                <a:cubicBezTo>
                  <a:pt x="3018394" y="5957091"/>
                  <a:pt x="2995043" y="5934391"/>
                  <a:pt x="2953524" y="5934391"/>
                </a:cubicBezTo>
                <a:close/>
                <a:moveTo>
                  <a:pt x="2796867" y="5934391"/>
                </a:moveTo>
                <a:cubicBezTo>
                  <a:pt x="2755674" y="5934391"/>
                  <a:pt x="2741721" y="5964227"/>
                  <a:pt x="2741721" y="5964227"/>
                </a:cubicBezTo>
                <a:lnTo>
                  <a:pt x="2741072" y="5964227"/>
                </a:lnTo>
                <a:cubicBezTo>
                  <a:pt x="2741497" y="5960240"/>
                  <a:pt x="2741714" y="5956234"/>
                  <a:pt x="2741721" y="5952224"/>
                </a:cubicBezTo>
                <a:lnTo>
                  <a:pt x="2741721" y="5938282"/>
                </a:lnTo>
                <a:lnTo>
                  <a:pt x="2712857" y="5938282"/>
                </a:lnTo>
                <a:lnTo>
                  <a:pt x="2712857" y="6167243"/>
                </a:lnTo>
                <a:lnTo>
                  <a:pt x="2744318" y="6167243"/>
                </a:lnTo>
                <a:lnTo>
                  <a:pt x="2744318" y="6093620"/>
                </a:lnTo>
                <a:cubicBezTo>
                  <a:pt x="2744318" y="6085189"/>
                  <a:pt x="2743669" y="6079354"/>
                  <a:pt x="2743669" y="6079354"/>
                </a:cubicBezTo>
                <a:lnTo>
                  <a:pt x="2744318" y="6079354"/>
                </a:lnTo>
                <a:cubicBezTo>
                  <a:pt x="2755077" y="6096648"/>
                  <a:pt x="2774234" y="6106904"/>
                  <a:pt x="2794595" y="6106269"/>
                </a:cubicBezTo>
                <a:cubicBezTo>
                  <a:pt x="2837411" y="6106269"/>
                  <a:pt x="2868873" y="6072541"/>
                  <a:pt x="2868873" y="6020330"/>
                </a:cubicBezTo>
                <a:cubicBezTo>
                  <a:pt x="2868873" y="5969413"/>
                  <a:pt x="2840975" y="5934391"/>
                  <a:pt x="2796867" y="5934391"/>
                </a:cubicBezTo>
                <a:close/>
                <a:moveTo>
                  <a:pt x="3568802" y="5893205"/>
                </a:moveTo>
                <a:lnTo>
                  <a:pt x="3568802" y="5940551"/>
                </a:lnTo>
                <a:lnTo>
                  <a:pt x="3546424" y="5940551"/>
                </a:lnTo>
                <a:lnTo>
                  <a:pt x="3546424" y="5965847"/>
                </a:lnTo>
                <a:lnTo>
                  <a:pt x="3567829" y="5965847"/>
                </a:lnTo>
                <a:lnTo>
                  <a:pt x="3567829" y="6042385"/>
                </a:lnTo>
                <a:cubicBezTo>
                  <a:pt x="3567829" y="6097188"/>
                  <a:pt x="3609671" y="6103677"/>
                  <a:pt x="3630758" y="6103676"/>
                </a:cubicBezTo>
                <a:cubicBezTo>
                  <a:pt x="3634446" y="6103696"/>
                  <a:pt x="3638131" y="6103479"/>
                  <a:pt x="3641789" y="6103027"/>
                </a:cubicBezTo>
                <a:lnTo>
                  <a:pt x="3641789" y="6075138"/>
                </a:lnTo>
                <a:cubicBezTo>
                  <a:pt x="3639327" y="6075601"/>
                  <a:pt x="3636826" y="6075818"/>
                  <a:pt x="3634322" y="6075788"/>
                </a:cubicBezTo>
                <a:cubicBezTo>
                  <a:pt x="3622324" y="6075788"/>
                  <a:pt x="3599298" y="6071572"/>
                  <a:pt x="3599298" y="6038817"/>
                </a:cubicBezTo>
                <a:lnTo>
                  <a:pt x="3599298" y="5965847"/>
                </a:lnTo>
                <a:lnTo>
                  <a:pt x="3638867" y="5965847"/>
                </a:lnTo>
                <a:lnTo>
                  <a:pt x="3638867" y="5940551"/>
                </a:lnTo>
                <a:lnTo>
                  <a:pt x="3599298" y="5940551"/>
                </a:lnTo>
                <a:lnTo>
                  <a:pt x="3599298" y="5893205"/>
                </a:lnTo>
                <a:close/>
                <a:moveTo>
                  <a:pt x="3055985" y="5893205"/>
                </a:moveTo>
                <a:lnTo>
                  <a:pt x="3055985" y="5940551"/>
                </a:lnTo>
                <a:lnTo>
                  <a:pt x="3033606" y="5940551"/>
                </a:lnTo>
                <a:lnTo>
                  <a:pt x="3033606" y="5965847"/>
                </a:lnTo>
                <a:lnTo>
                  <a:pt x="3055012" y="5965847"/>
                </a:lnTo>
                <a:lnTo>
                  <a:pt x="3055012" y="6042385"/>
                </a:lnTo>
                <a:cubicBezTo>
                  <a:pt x="3055012" y="6097188"/>
                  <a:pt x="3096854" y="6103677"/>
                  <a:pt x="3117934" y="6103676"/>
                </a:cubicBezTo>
                <a:cubicBezTo>
                  <a:pt x="3121620" y="6103697"/>
                  <a:pt x="3125305" y="6103480"/>
                  <a:pt x="3128964" y="6103027"/>
                </a:cubicBezTo>
                <a:lnTo>
                  <a:pt x="3128964" y="6075138"/>
                </a:lnTo>
                <a:cubicBezTo>
                  <a:pt x="3126505" y="6075601"/>
                  <a:pt x="3124007" y="6075818"/>
                  <a:pt x="3121505" y="6075788"/>
                </a:cubicBezTo>
                <a:cubicBezTo>
                  <a:pt x="3109500" y="6075788"/>
                  <a:pt x="3086473" y="6071572"/>
                  <a:pt x="3086473" y="6038817"/>
                </a:cubicBezTo>
                <a:lnTo>
                  <a:pt x="3086473" y="5965847"/>
                </a:lnTo>
                <a:lnTo>
                  <a:pt x="3126043" y="5965847"/>
                </a:lnTo>
                <a:lnTo>
                  <a:pt x="3126043" y="5940551"/>
                </a:lnTo>
                <a:lnTo>
                  <a:pt x="3086473" y="5940551"/>
                </a:lnTo>
                <a:lnTo>
                  <a:pt x="3086473" y="5893205"/>
                </a:lnTo>
                <a:close/>
                <a:moveTo>
                  <a:pt x="2318901" y="5875367"/>
                </a:moveTo>
                <a:lnTo>
                  <a:pt x="2318901" y="6102378"/>
                </a:lnTo>
                <a:lnTo>
                  <a:pt x="2332529" y="6102378"/>
                </a:lnTo>
                <a:lnTo>
                  <a:pt x="2332529" y="6083895"/>
                </a:lnTo>
                <a:cubicBezTo>
                  <a:pt x="2332569" y="6079107"/>
                  <a:pt x="2332134" y="6074326"/>
                  <a:pt x="2331230" y="6069624"/>
                </a:cubicBezTo>
                <a:lnTo>
                  <a:pt x="2331880" y="6069624"/>
                </a:lnTo>
                <a:cubicBezTo>
                  <a:pt x="2331880" y="6069624"/>
                  <a:pt x="2347123" y="6106270"/>
                  <a:pt x="2387992" y="6106270"/>
                </a:cubicBezTo>
                <a:cubicBezTo>
                  <a:pt x="2430484" y="6106270"/>
                  <a:pt x="2460646" y="6072866"/>
                  <a:pt x="2460646" y="6021305"/>
                </a:cubicBezTo>
                <a:cubicBezTo>
                  <a:pt x="2460646" y="5971037"/>
                  <a:pt x="2434048" y="5936335"/>
                  <a:pt x="2390589" y="5936335"/>
                </a:cubicBezTo>
                <a:cubicBezTo>
                  <a:pt x="2365391" y="5935491"/>
                  <a:pt x="2342186" y="5949974"/>
                  <a:pt x="2331880" y="5972980"/>
                </a:cubicBezTo>
                <a:lnTo>
                  <a:pt x="2331230" y="5972980"/>
                </a:lnTo>
                <a:cubicBezTo>
                  <a:pt x="2332099" y="5968603"/>
                  <a:pt x="2332534" y="5964150"/>
                  <a:pt x="2332529" y="5959687"/>
                </a:cubicBezTo>
                <a:lnTo>
                  <a:pt x="2332529" y="5875367"/>
                </a:lnTo>
                <a:close/>
                <a:moveTo>
                  <a:pt x="2171335" y="5875367"/>
                </a:moveTo>
                <a:lnTo>
                  <a:pt x="2171335" y="5959687"/>
                </a:lnTo>
                <a:cubicBezTo>
                  <a:pt x="2171330" y="5964150"/>
                  <a:pt x="2171765" y="5968603"/>
                  <a:pt x="2172633" y="5972980"/>
                </a:cubicBezTo>
                <a:lnTo>
                  <a:pt x="2171984" y="5972980"/>
                </a:lnTo>
                <a:cubicBezTo>
                  <a:pt x="2171984" y="5972980"/>
                  <a:pt x="2156732" y="5936335"/>
                  <a:pt x="2115863" y="5936335"/>
                </a:cubicBezTo>
                <a:cubicBezTo>
                  <a:pt x="2073374" y="5936335"/>
                  <a:pt x="2043207" y="5969738"/>
                  <a:pt x="2043207" y="6021305"/>
                </a:cubicBezTo>
                <a:cubicBezTo>
                  <a:pt x="2043207" y="6071572"/>
                  <a:pt x="2069806" y="6106270"/>
                  <a:pt x="2113275" y="6106270"/>
                </a:cubicBezTo>
                <a:cubicBezTo>
                  <a:pt x="2138472" y="6107111"/>
                  <a:pt x="2161675" y="6092628"/>
                  <a:pt x="2171984" y="6069624"/>
                </a:cubicBezTo>
                <a:lnTo>
                  <a:pt x="2172633" y="6069624"/>
                </a:lnTo>
                <a:cubicBezTo>
                  <a:pt x="2171715" y="6073666"/>
                  <a:pt x="2171280" y="6077803"/>
                  <a:pt x="2171335" y="6081948"/>
                </a:cubicBezTo>
                <a:lnTo>
                  <a:pt x="2171335" y="6102378"/>
                </a:lnTo>
                <a:lnTo>
                  <a:pt x="2184955" y="6102378"/>
                </a:lnTo>
                <a:lnTo>
                  <a:pt x="2184955" y="5875367"/>
                </a:lnTo>
                <a:close/>
                <a:moveTo>
                  <a:pt x="1743547" y="5875367"/>
                </a:moveTo>
                <a:lnTo>
                  <a:pt x="1743547" y="5899040"/>
                </a:lnTo>
                <a:lnTo>
                  <a:pt x="1759765" y="5899040"/>
                </a:lnTo>
                <a:lnTo>
                  <a:pt x="1759765" y="5875367"/>
                </a:lnTo>
                <a:close/>
                <a:moveTo>
                  <a:pt x="1209673" y="5875367"/>
                </a:moveTo>
                <a:lnTo>
                  <a:pt x="1209673" y="6102378"/>
                </a:lnTo>
                <a:lnTo>
                  <a:pt x="1223622" y="6102378"/>
                </a:lnTo>
                <a:lnTo>
                  <a:pt x="1223622" y="5875367"/>
                </a:lnTo>
                <a:close/>
                <a:moveTo>
                  <a:pt x="740045" y="5875367"/>
                </a:moveTo>
                <a:cubicBezTo>
                  <a:pt x="865045" y="5894885"/>
                  <a:pt x="963105" y="5992926"/>
                  <a:pt x="982628" y="6117904"/>
                </a:cubicBezTo>
                <a:lnTo>
                  <a:pt x="982620" y="5875367"/>
                </a:lnTo>
                <a:close/>
                <a:moveTo>
                  <a:pt x="407989" y="5875366"/>
                </a:moveTo>
                <a:lnTo>
                  <a:pt x="407989" y="6117901"/>
                </a:lnTo>
                <a:cubicBezTo>
                  <a:pt x="427506" y="5992925"/>
                  <a:pt x="525563" y="5894884"/>
                  <a:pt x="650560" y="5875366"/>
                </a:cubicBezTo>
                <a:close/>
                <a:moveTo>
                  <a:pt x="693449" y="5875365"/>
                </a:moveTo>
                <a:lnTo>
                  <a:pt x="693449" y="6106201"/>
                </a:lnTo>
                <a:lnTo>
                  <a:pt x="685251" y="6106201"/>
                </a:lnTo>
                <a:lnTo>
                  <a:pt x="685251" y="6178022"/>
                </a:lnTo>
                <a:lnTo>
                  <a:pt x="655495" y="6178022"/>
                </a:lnTo>
                <a:lnTo>
                  <a:pt x="655495" y="6106201"/>
                </a:lnTo>
                <a:lnTo>
                  <a:pt x="617524" y="6106201"/>
                </a:lnTo>
                <a:lnTo>
                  <a:pt x="617524" y="6219053"/>
                </a:lnTo>
                <a:lnTo>
                  <a:pt x="693449" y="6219053"/>
                </a:lnTo>
                <a:lnTo>
                  <a:pt x="693449" y="6449904"/>
                </a:lnTo>
                <a:lnTo>
                  <a:pt x="697158" y="6449904"/>
                </a:lnTo>
                <a:lnTo>
                  <a:pt x="697158" y="6219053"/>
                </a:lnTo>
                <a:lnTo>
                  <a:pt x="726288" y="6219053"/>
                </a:lnTo>
                <a:lnTo>
                  <a:pt x="726288" y="6106201"/>
                </a:lnTo>
                <a:lnTo>
                  <a:pt x="697158" y="6106201"/>
                </a:lnTo>
                <a:lnTo>
                  <a:pt x="697154" y="5875365"/>
                </a:lnTo>
                <a:close/>
                <a:moveTo>
                  <a:pt x="3146995" y="5873419"/>
                </a:moveTo>
                <a:lnTo>
                  <a:pt x="3146995" y="5905528"/>
                </a:lnTo>
                <a:lnTo>
                  <a:pt x="3178780" y="5905528"/>
                </a:lnTo>
                <a:lnTo>
                  <a:pt x="3178780" y="5873419"/>
                </a:lnTo>
                <a:close/>
                <a:moveTo>
                  <a:pt x="5074981" y="3974428"/>
                </a:moveTo>
                <a:cubicBezTo>
                  <a:pt x="5308980" y="5220716"/>
                  <a:pt x="6284078" y="6195621"/>
                  <a:pt x="7530588" y="6429546"/>
                </a:cubicBezTo>
                <a:lnTo>
                  <a:pt x="5074981" y="6429546"/>
                </a:lnTo>
                <a:close/>
                <a:moveTo>
                  <a:pt x="11122964" y="3974190"/>
                </a:moveTo>
                <a:lnTo>
                  <a:pt x="11122964" y="6429463"/>
                </a:lnTo>
                <a:lnTo>
                  <a:pt x="8666920" y="6429463"/>
                </a:lnTo>
                <a:cubicBezTo>
                  <a:pt x="9913518" y="6195441"/>
                  <a:pt x="10888727" y="5220539"/>
                  <a:pt x="11122964" y="3974190"/>
                </a:cubicBezTo>
                <a:close/>
                <a:moveTo>
                  <a:pt x="5074885" y="3877086"/>
                </a:moveTo>
                <a:lnTo>
                  <a:pt x="5058713" y="3878325"/>
                </a:lnTo>
                <a:lnTo>
                  <a:pt x="5058713" y="6445810"/>
                </a:lnTo>
                <a:lnTo>
                  <a:pt x="7626641" y="6445810"/>
                </a:lnTo>
                <a:lnTo>
                  <a:pt x="7627884" y="6429641"/>
                </a:lnTo>
                <a:cubicBezTo>
                  <a:pt x="6311888" y="6225121"/>
                  <a:pt x="5279443" y="5192853"/>
                  <a:pt x="5074885" y="3877086"/>
                </a:cubicBezTo>
                <a:close/>
                <a:moveTo>
                  <a:pt x="11123059" y="3876995"/>
                </a:moveTo>
                <a:cubicBezTo>
                  <a:pt x="10918269" y="5192805"/>
                  <a:pt x="9885698" y="6225024"/>
                  <a:pt x="8569625" y="6429558"/>
                </a:cubicBezTo>
                <a:lnTo>
                  <a:pt x="8570868" y="6445727"/>
                </a:lnTo>
                <a:lnTo>
                  <a:pt x="11139231" y="6445727"/>
                </a:lnTo>
                <a:lnTo>
                  <a:pt x="11139231" y="3878238"/>
                </a:lnTo>
                <a:close/>
                <a:moveTo>
                  <a:pt x="5074862" y="382592"/>
                </a:moveTo>
                <a:lnTo>
                  <a:pt x="7530485" y="382592"/>
                </a:lnTo>
                <a:cubicBezTo>
                  <a:pt x="6283949" y="616774"/>
                  <a:pt x="5308909" y="1591792"/>
                  <a:pt x="5074862" y="2838143"/>
                </a:cubicBezTo>
                <a:close/>
                <a:moveTo>
                  <a:pt x="8666781" y="382485"/>
                </a:moveTo>
                <a:lnTo>
                  <a:pt x="11122821" y="382485"/>
                </a:lnTo>
                <a:lnTo>
                  <a:pt x="11122821" y="2838196"/>
                </a:lnTo>
                <a:cubicBezTo>
                  <a:pt x="10888566" y="1591774"/>
                  <a:pt x="9913411" y="616748"/>
                  <a:pt x="8666781" y="382485"/>
                </a:cubicBezTo>
                <a:close/>
                <a:moveTo>
                  <a:pt x="5058594" y="366328"/>
                </a:moveTo>
                <a:lnTo>
                  <a:pt x="5058594" y="2934247"/>
                </a:lnTo>
                <a:lnTo>
                  <a:pt x="5074766" y="2935488"/>
                </a:lnTo>
                <a:cubicBezTo>
                  <a:pt x="5279296" y="1619627"/>
                  <a:pt x="6311705" y="587215"/>
                  <a:pt x="7627761" y="382497"/>
                </a:cubicBezTo>
                <a:lnTo>
                  <a:pt x="7626518" y="366328"/>
                </a:lnTo>
                <a:close/>
                <a:moveTo>
                  <a:pt x="8570721" y="366221"/>
                </a:moveTo>
                <a:lnTo>
                  <a:pt x="8569478" y="382390"/>
                </a:lnTo>
                <a:cubicBezTo>
                  <a:pt x="9885660" y="587019"/>
                  <a:pt x="10918248" y="1619427"/>
                  <a:pt x="11122916" y="2935381"/>
                </a:cubicBezTo>
                <a:lnTo>
                  <a:pt x="11139088" y="2934139"/>
                </a:lnTo>
                <a:lnTo>
                  <a:pt x="11139088" y="366221"/>
                </a:lnTo>
                <a:close/>
                <a:moveTo>
                  <a:pt x="0" y="0"/>
                </a:moveTo>
                <a:lnTo>
                  <a:pt x="12191993" y="0"/>
                </a:lnTo>
                <a:lnTo>
                  <a:pt x="12191993" y="6857996"/>
                </a:lnTo>
                <a:lnTo>
                  <a:pt x="0" y="6857996"/>
                </a:lnTo>
                <a:close/>
              </a:path>
            </a:pathLst>
          </a:custGeom>
          <a:solidFill>
            <a:schemeClr val="tx1"/>
          </a:solidFill>
        </p:spPr>
        <p:txBody>
          <a:bodyPr wrap="square">
            <a:noAutofit/>
          </a:bodyPr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BE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1ED276C-6DB4-C248-B8F8-A80AC7FEE4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88" y="2605757"/>
            <a:ext cx="4656381" cy="898708"/>
          </a:xfrm>
        </p:spPr>
        <p:txBody>
          <a:bodyPr wrap="square" rIns="36000" anchor="b">
            <a:spAutoFit/>
          </a:bodyPr>
          <a:lstStyle>
            <a:lvl1pPr algn="l">
              <a:defRPr sz="280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3290F0-62FD-6446-BD33-1B3A80AD04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07988" y="3596539"/>
            <a:ext cx="4656381" cy="313932"/>
          </a:xfrm>
        </p:spPr>
        <p:txBody>
          <a:bodyPr wrap="square" rIns="36000">
            <a:spAutoFit/>
          </a:bodyPr>
          <a:lstStyle>
            <a:lvl1pPr marL="0" indent="0" algn="l">
              <a:buNone/>
              <a:defRPr sz="1600">
                <a:solidFill>
                  <a:schemeClr val="bg1"/>
                </a:solidFill>
                <a:latin typeface="+mn-lt"/>
              </a:defRPr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10" name="Footer Placeholder 4">
            <a:extLst>
              <a:ext uri="{FF2B5EF4-FFF2-40B4-BE49-F238E27FC236}">
                <a16:creationId xmlns:a16="http://schemas.microsoft.com/office/drawing/2014/main" id="{F3DF0697-75B6-104D-AADC-B7E50CA194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538445" y="6547007"/>
            <a:ext cx="7127920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lvl1pPr algn="ctr">
              <a:defRPr sz="800">
                <a:solidFill>
                  <a:schemeClr val="bg1"/>
                </a:solidFill>
              </a:defRPr>
            </a:lvl1pPr>
          </a:lstStyle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7320915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ullete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6027" y="259161"/>
            <a:ext cx="11339947" cy="480131"/>
          </a:xfrm>
        </p:spPr>
        <p:txBody>
          <a:bodyPr anchor="t">
            <a:sp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412877"/>
            <a:ext cx="11339947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3822783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ulleted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7" y="1412877"/>
            <a:ext cx="11339947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7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72673231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26029" y="2948088"/>
            <a:ext cx="1924897" cy="480131"/>
          </a:xfrm>
        </p:spPr>
        <p:txBody>
          <a:bodyPr wrap="square" anchor="ctr">
            <a:spAutoFit/>
          </a:bodyPr>
          <a:lstStyle/>
          <a:p>
            <a:r>
              <a:rPr lang="en-GB"/>
              <a:t>Agenda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2350925" y="1072444"/>
            <a:ext cx="9415049" cy="4231419"/>
          </a:xfrm>
        </p:spPr>
        <p:txBody>
          <a:bodyPr rIns="72000" anchor="ctr">
            <a:normAutofit/>
          </a:bodyPr>
          <a:lstStyle>
            <a:lvl1pPr marL="342891" indent="-342891">
              <a:buFont typeface="+mj-lt"/>
              <a:buAutoNum type="arabicPeriod"/>
              <a:defRPr sz="1800"/>
            </a:lvl1pPr>
            <a:lvl2pPr marL="800080" indent="-342891">
              <a:buFont typeface="+mj-lt"/>
              <a:buAutoNum type="arabicPeriod"/>
              <a:defRPr sz="1600"/>
            </a:lvl2pPr>
            <a:lvl3pPr>
              <a:buFont typeface="+mj-lt"/>
              <a:buAutoNum type="arabicPeriod"/>
              <a:defRPr sz="1400"/>
            </a:lvl3pPr>
            <a:lvl4pPr>
              <a:buFont typeface="+mj-lt"/>
              <a:buAutoNum type="arabicPeriod"/>
              <a:defRPr sz="1200"/>
            </a:lvl4pPr>
            <a:lvl5pPr>
              <a:buFont typeface="+mj-lt"/>
              <a:buAutoNum type="arabicPeriod"/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6BAC6D8C-4CD7-404E-803B-9C1856B74D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7"/>
            <a:ext cx="731603" cy="749023"/>
          </a:xfrm>
          <a:prstGeom prst="rect">
            <a:avLst/>
          </a:prstGeom>
        </p:spPr>
      </p:pic>
      <p:sp>
        <p:nvSpPr>
          <p:cNvPr id="57" name="Freeform 5">
            <a:extLst>
              <a:ext uri="{FF2B5EF4-FFF2-40B4-BE49-F238E27FC236}">
                <a16:creationId xmlns:a16="http://schemas.microsoft.com/office/drawing/2014/main" id="{34A1DC10-00A7-8F4E-B794-229E5F875B78}"/>
              </a:ext>
            </a:extLst>
          </p:cNvPr>
          <p:cNvSpPr>
            <a:spLocks/>
          </p:cNvSpPr>
          <p:nvPr/>
        </p:nvSpPr>
        <p:spPr bwMode="auto">
          <a:xfrm rot="5400000" flipH="1">
            <a:off x="414952" y="390169"/>
            <a:ext cx="737003" cy="731603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pic>
        <p:nvPicPr>
          <p:cNvPr id="9" name="Graphic 8">
            <a:extLst>
              <a:ext uri="{FF2B5EF4-FFF2-40B4-BE49-F238E27FC236}">
                <a16:creationId xmlns:a16="http://schemas.microsoft.com/office/drawing/2014/main" id="{99F642E9-70FA-1247-BA86-AF1A80340FD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7"/>
            <a:ext cx="731603" cy="749023"/>
          </a:xfrm>
          <a:prstGeom prst="rect">
            <a:avLst/>
          </a:prstGeom>
        </p:spPr>
      </p:pic>
      <p:sp>
        <p:nvSpPr>
          <p:cNvPr id="10" name="Freeform 5">
            <a:extLst>
              <a:ext uri="{FF2B5EF4-FFF2-40B4-BE49-F238E27FC236}">
                <a16:creationId xmlns:a16="http://schemas.microsoft.com/office/drawing/2014/main" id="{B9E80466-0F67-B749-B46F-1A7900249BBA}"/>
              </a:ext>
            </a:extLst>
          </p:cNvPr>
          <p:cNvSpPr>
            <a:spLocks/>
          </p:cNvSpPr>
          <p:nvPr userDrawn="1"/>
        </p:nvSpPr>
        <p:spPr bwMode="auto">
          <a:xfrm rot="5400000" flipH="1">
            <a:off x="414952" y="390169"/>
            <a:ext cx="737003" cy="731603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</p:spTree>
    <p:extLst>
      <p:ext uri="{BB962C8B-B14F-4D97-AF65-F5344CB8AC3E}">
        <p14:creationId xmlns:p14="http://schemas.microsoft.com/office/powerpoint/2010/main" val="38677556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6027" y="259161"/>
            <a:ext cx="11339947" cy="480131"/>
          </a:xfrm>
        </p:spPr>
        <p:txBody>
          <a:bodyPr anchor="t">
            <a:sp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0238048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sldNum="0"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20D01E-FCAF-40A2-86A9-675CDBC788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6B7D4D-ACEC-4632-B401-1B2AC8D99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3DFCE2-1A98-474F-9989-1137D19EB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2344F5-3A22-407C-A5C5-D4CFCB32B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017603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ub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790385"/>
            <a:ext cx="11339947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202455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Grey background">
    <p:bg>
      <p:bgPr>
        <a:solidFill>
          <a:schemeClr val="bg1">
            <a:lumMod val="95000"/>
            <a:alpha val="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7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155650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oubl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8" y="1412877"/>
            <a:ext cx="5572101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7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193875" y="1412877"/>
            <a:ext cx="5572101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5233678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ouble content w titl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8" y="1925054"/>
            <a:ext cx="5572101" cy="41836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7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193875" y="1925054"/>
            <a:ext cx="5572101" cy="41836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727D5C-5A0E-0846-8C0F-CCCCCECE26EA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25451" y="1432917"/>
            <a:ext cx="5572101" cy="369332"/>
          </a:xfrm>
        </p:spPr>
        <p:txBody>
          <a:bodyPr wrap="square" anchor="b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="1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F3272EEB-918D-1E46-8C24-CD246EDC6A16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6193872" y="1432917"/>
            <a:ext cx="5572101" cy="369332"/>
          </a:xfrm>
        </p:spPr>
        <p:txBody>
          <a:bodyPr wrap="square" anchor="b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="1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7292089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ingle content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8A45D60-3196-6042-836D-45547787D11C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6028" y="1412877"/>
            <a:ext cx="5572101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26027" y="821163"/>
            <a:ext cx="11339947" cy="369332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3633183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98247" y="264599"/>
            <a:ext cx="5399548" cy="4801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5598247" y="805774"/>
            <a:ext cx="5399548" cy="400111"/>
          </a:xfrm>
        </p:spPr>
        <p:txBody>
          <a:bodyPr wrap="square" anchor="t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Picture Placeholder 47">
            <a:extLst>
              <a:ext uri="{FF2B5EF4-FFF2-40B4-BE49-F238E27FC236}">
                <a16:creationId xmlns:a16="http://schemas.microsoft.com/office/drawing/2014/main" id="{C6681D1E-D330-9E42-B1B1-C48A4D7629F0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407988" y="336265"/>
            <a:ext cx="4980976" cy="5772435"/>
          </a:xfrm>
          <a:custGeom>
            <a:avLst/>
            <a:gdLst>
              <a:gd name="connsiteX0" fmla="*/ 195256 w 5084529"/>
              <a:gd name="connsiteY0" fmla="*/ 200195 h 5940425"/>
              <a:gd name="connsiteX1" fmla="*/ 830029 w 5084529"/>
              <a:gd name="connsiteY1" fmla="*/ 200195 h 5940425"/>
              <a:gd name="connsiteX2" fmla="*/ 422378 w 5084529"/>
              <a:gd name="connsiteY2" fmla="*/ 432030 h 5940425"/>
              <a:gd name="connsiteX3" fmla="*/ 195383 w 5084529"/>
              <a:gd name="connsiteY3" fmla="*/ 846590 h 5940425"/>
              <a:gd name="connsiteX4" fmla="*/ 182624 w 5084529"/>
              <a:gd name="connsiteY4" fmla="*/ 187362 h 5940425"/>
              <a:gd name="connsiteX5" fmla="*/ 182624 w 5084529"/>
              <a:gd name="connsiteY5" fmla="*/ 913936 h 5940425"/>
              <a:gd name="connsiteX6" fmla="*/ 195320 w 5084529"/>
              <a:gd name="connsiteY6" fmla="*/ 914889 h 5940425"/>
              <a:gd name="connsiteX7" fmla="*/ 431645 w 5084529"/>
              <a:gd name="connsiteY7" fmla="*/ 440799 h 5940425"/>
              <a:gd name="connsiteX8" fmla="*/ 896045 w 5084529"/>
              <a:gd name="connsiteY8" fmla="*/ 200068 h 5940425"/>
              <a:gd name="connsiteX9" fmla="*/ 895029 w 5084529"/>
              <a:gd name="connsiteY9" fmla="*/ 187362 h 5940425"/>
              <a:gd name="connsiteX10" fmla="*/ 0 w 5084529"/>
              <a:gd name="connsiteY10" fmla="*/ 0 h 5940425"/>
              <a:gd name="connsiteX11" fmla="*/ 5084529 w 5084529"/>
              <a:gd name="connsiteY11" fmla="*/ 0 h 5940425"/>
              <a:gd name="connsiteX12" fmla="*/ 5084529 w 5084529"/>
              <a:gd name="connsiteY12" fmla="*/ 5940425 h 5940425"/>
              <a:gd name="connsiteX13" fmla="*/ 0 w 5084529"/>
              <a:gd name="connsiteY13" fmla="*/ 5940425 h 5940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5084529" h="5940425">
                <a:moveTo>
                  <a:pt x="195256" y="200195"/>
                </a:moveTo>
                <a:lnTo>
                  <a:pt x="830029" y="200195"/>
                </a:lnTo>
                <a:cubicBezTo>
                  <a:pt x="674944" y="237256"/>
                  <a:pt x="533572" y="317656"/>
                  <a:pt x="422378" y="432030"/>
                </a:cubicBezTo>
                <a:cubicBezTo>
                  <a:pt x="309817" y="546511"/>
                  <a:pt x="231233" y="690030"/>
                  <a:pt x="195383" y="846590"/>
                </a:cubicBezTo>
                <a:close/>
                <a:moveTo>
                  <a:pt x="182624" y="187362"/>
                </a:moveTo>
                <a:lnTo>
                  <a:pt x="182624" y="913936"/>
                </a:lnTo>
                <a:lnTo>
                  <a:pt x="195320" y="914889"/>
                </a:lnTo>
                <a:cubicBezTo>
                  <a:pt x="222003" y="735815"/>
                  <a:pt x="304745" y="569827"/>
                  <a:pt x="431645" y="440799"/>
                </a:cubicBezTo>
                <a:cubicBezTo>
                  <a:pt x="556385" y="312431"/>
                  <a:pt x="719320" y="227970"/>
                  <a:pt x="896045" y="200068"/>
                </a:cubicBezTo>
                <a:lnTo>
                  <a:pt x="895029" y="187362"/>
                </a:lnTo>
                <a:close/>
                <a:moveTo>
                  <a:pt x="0" y="0"/>
                </a:moveTo>
                <a:lnTo>
                  <a:pt x="5084529" y="0"/>
                </a:lnTo>
                <a:lnTo>
                  <a:pt x="5084529" y="5940425"/>
                </a:lnTo>
                <a:lnTo>
                  <a:pt x="0" y="5940425"/>
                </a:lnTo>
                <a:close/>
              </a:path>
            </a:pathLst>
          </a:custGeom>
          <a:solidFill>
            <a:schemeClr val="bg2"/>
          </a:solidFill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en-GB"/>
          </a:p>
        </p:txBody>
      </p:sp>
      <p:sp>
        <p:nvSpPr>
          <p:cNvPr id="11" name="Freeform 5">
            <a:extLst>
              <a:ext uri="{FF2B5EF4-FFF2-40B4-BE49-F238E27FC236}">
                <a16:creationId xmlns:a16="http://schemas.microsoft.com/office/drawing/2014/main" id="{9DBD75DD-0082-5D47-BDDB-BF00387E98E6}"/>
              </a:ext>
            </a:extLst>
          </p:cNvPr>
          <p:cNvSpPr>
            <a:spLocks/>
          </p:cNvSpPr>
          <p:nvPr/>
        </p:nvSpPr>
        <p:spPr bwMode="auto">
          <a:xfrm rot="16200000" flipH="1">
            <a:off x="11248025" y="5405188"/>
            <a:ext cx="737003" cy="731603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14" name="Content Placeholder 7">
            <a:extLst>
              <a:ext uri="{FF2B5EF4-FFF2-40B4-BE49-F238E27FC236}">
                <a16:creationId xmlns:a16="http://schemas.microsoft.com/office/drawing/2014/main" id="{0190FF4E-3BF7-B64B-A048-4A7F0F929204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5580750" y="1476533"/>
            <a:ext cx="5417045" cy="4632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9" name="Freeform 5">
            <a:extLst>
              <a:ext uri="{FF2B5EF4-FFF2-40B4-BE49-F238E27FC236}">
                <a16:creationId xmlns:a16="http://schemas.microsoft.com/office/drawing/2014/main" id="{F789CB9A-7CAB-ED4F-8023-756B4C589680}"/>
              </a:ext>
            </a:extLst>
          </p:cNvPr>
          <p:cNvSpPr>
            <a:spLocks/>
          </p:cNvSpPr>
          <p:nvPr userDrawn="1"/>
        </p:nvSpPr>
        <p:spPr bwMode="auto">
          <a:xfrm rot="16200000" flipH="1">
            <a:off x="11248025" y="5405188"/>
            <a:ext cx="737003" cy="731603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</p:spTree>
    <p:extLst>
      <p:ext uri="{BB962C8B-B14F-4D97-AF65-F5344CB8AC3E}">
        <p14:creationId xmlns:p14="http://schemas.microsoft.com/office/powerpoint/2010/main" val="24124456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ouble content blue corne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6289" y="973984"/>
            <a:ext cx="5399548" cy="4801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776289" y="1521490"/>
            <a:ext cx="5399548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509971" y="973985"/>
            <a:ext cx="4939908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581192B2-F45A-B845-80ED-C263E992FB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7"/>
            <a:ext cx="731603" cy="749023"/>
          </a:xfrm>
          <a:prstGeom prst="rect">
            <a:avLst/>
          </a:prstGeom>
        </p:spPr>
      </p:pic>
      <p:sp>
        <p:nvSpPr>
          <p:cNvPr id="13" name="Freeform 5">
            <a:extLst>
              <a:ext uri="{FF2B5EF4-FFF2-40B4-BE49-F238E27FC236}">
                <a16:creationId xmlns:a16="http://schemas.microsoft.com/office/drawing/2014/main" id="{8FB8FAAA-F7C9-494E-B088-EDFF247E0C50}"/>
              </a:ext>
            </a:extLst>
          </p:cNvPr>
          <p:cNvSpPr>
            <a:spLocks/>
          </p:cNvSpPr>
          <p:nvPr/>
        </p:nvSpPr>
        <p:spPr bwMode="auto">
          <a:xfrm rot="5400000" flipH="1">
            <a:off x="414952" y="390169"/>
            <a:ext cx="737003" cy="731603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10" name="Content Placeholder 7">
            <a:extLst>
              <a:ext uri="{FF2B5EF4-FFF2-40B4-BE49-F238E27FC236}">
                <a16:creationId xmlns:a16="http://schemas.microsoft.com/office/drawing/2014/main" id="{C0F03F8C-A030-9A44-8698-81FC663C2FDD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776289" y="2040629"/>
            <a:ext cx="5399548" cy="36291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111FA9B9-CFAD-7D46-92AE-7285C14C8BC4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50725" y="5389717"/>
            <a:ext cx="731603" cy="749023"/>
          </a:xfrm>
          <a:prstGeom prst="rect">
            <a:avLst/>
          </a:prstGeom>
        </p:spPr>
      </p:pic>
      <p:sp>
        <p:nvSpPr>
          <p:cNvPr id="14" name="Freeform 5">
            <a:extLst>
              <a:ext uri="{FF2B5EF4-FFF2-40B4-BE49-F238E27FC236}">
                <a16:creationId xmlns:a16="http://schemas.microsoft.com/office/drawing/2014/main" id="{859D98E4-9191-0345-AD56-18E972C0A1F4}"/>
              </a:ext>
            </a:extLst>
          </p:cNvPr>
          <p:cNvSpPr>
            <a:spLocks/>
          </p:cNvSpPr>
          <p:nvPr userDrawn="1"/>
        </p:nvSpPr>
        <p:spPr bwMode="auto">
          <a:xfrm rot="5400000" flipH="1">
            <a:off x="414952" y="390169"/>
            <a:ext cx="737003" cy="731603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</p:spTree>
    <p:extLst>
      <p:ext uri="{BB962C8B-B14F-4D97-AF65-F5344CB8AC3E}">
        <p14:creationId xmlns:p14="http://schemas.microsoft.com/office/powerpoint/2010/main" val="15376200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Double content grey corn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Freeform 5">
            <a:extLst>
              <a:ext uri="{FF2B5EF4-FFF2-40B4-BE49-F238E27FC236}">
                <a16:creationId xmlns:a16="http://schemas.microsoft.com/office/drawing/2014/main" id="{21EFE6BB-2ABE-CD4B-8929-B51CE9BB66BF}"/>
              </a:ext>
            </a:extLst>
          </p:cNvPr>
          <p:cNvSpPr>
            <a:spLocks/>
          </p:cNvSpPr>
          <p:nvPr/>
        </p:nvSpPr>
        <p:spPr bwMode="auto">
          <a:xfrm flipH="1">
            <a:off x="1394" y="2234873"/>
            <a:ext cx="4578351" cy="4622935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6289" y="973984"/>
            <a:ext cx="5399548" cy="4801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B9E147DE-4D05-BB45-A257-0D184DBEC59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2350925" y="6406168"/>
            <a:ext cx="8829521" cy="110800"/>
          </a:xfrm>
        </p:spPr>
        <p:txBody>
          <a:bodyPr vert="horz" wrap="square" lIns="0" tIns="0" rIns="91440" bIns="0" rtlCol="0" anchor="b">
            <a:spAutoFit/>
          </a:bodyPr>
          <a:lstStyle>
            <a:lvl1pPr marL="0" indent="0">
              <a:buNone/>
              <a:defRPr lang="en-BE" sz="800" dirty="0"/>
            </a:lvl1pPr>
          </a:lstStyle>
          <a:p>
            <a:pPr marL="0" lvl="0"/>
            <a:r>
              <a:rPr lang="en-GB"/>
              <a:t>References</a:t>
            </a:r>
            <a:endParaRPr lang="en-BE"/>
          </a:p>
        </p:txBody>
      </p:sp>
      <p:sp>
        <p:nvSpPr>
          <p:cNvPr id="7" name="Text Placeholder 5">
            <a:extLst>
              <a:ext uri="{FF2B5EF4-FFF2-40B4-BE49-F238E27FC236}">
                <a16:creationId xmlns:a16="http://schemas.microsoft.com/office/drawing/2014/main" id="{B60528AF-2E04-7C46-A0A8-47B612A1F78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776289" y="1521490"/>
            <a:ext cx="5399548" cy="400110"/>
          </a:xfrm>
        </p:spPr>
        <p:txBody>
          <a:bodyPr wrap="square" anchor="t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00">
                <a:solidFill>
                  <a:schemeClr val="accent1"/>
                </a:solidFill>
              </a:defRPr>
            </a:lvl1pPr>
            <a:lvl2pPr marL="457189" indent="0">
              <a:buNone/>
              <a:defRPr/>
            </a:lvl2pPr>
            <a:lvl3pPr marL="914377" indent="0">
              <a:buNone/>
              <a:defRPr/>
            </a:lvl3pPr>
            <a:lvl4pPr marL="1371566" indent="0">
              <a:buNone/>
              <a:defRPr/>
            </a:lvl4pPr>
            <a:lvl5pPr marL="1828754" indent="0">
              <a:buNone/>
              <a:defRPr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7">
            <a:extLst>
              <a:ext uri="{FF2B5EF4-FFF2-40B4-BE49-F238E27FC236}">
                <a16:creationId xmlns:a16="http://schemas.microsoft.com/office/drawing/2014/main" id="{968D5CD7-2281-7A4C-9CD7-49CD36C9E00E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509971" y="973985"/>
            <a:ext cx="4939908" cy="46958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854BDDB-5BC7-D04A-8AD4-10F6106E5870}"/>
              </a:ext>
            </a:extLst>
          </p:cNvPr>
          <p:cNvSpPr txBox="1"/>
          <p:nvPr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6AF053E2-0ACA-F648-9DD6-CF48A635D4F8}"/>
              </a:ext>
            </a:extLst>
          </p:cNvPr>
          <p:cNvGrpSpPr/>
          <p:nvPr/>
        </p:nvGrpSpPr>
        <p:grpSpPr>
          <a:xfrm>
            <a:off x="417651" y="6383294"/>
            <a:ext cx="1579563" cy="304767"/>
            <a:chOff x="769938" y="419101"/>
            <a:chExt cx="12193588" cy="2352675"/>
          </a:xfrm>
          <a:solidFill>
            <a:schemeClr val="accent1"/>
          </a:solidFill>
        </p:grpSpPr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8877EFD0-1E53-4A47-80F7-A926D2F1CA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6276" y="419101"/>
              <a:ext cx="858838" cy="889000"/>
            </a:xfrm>
            <a:custGeom>
              <a:avLst/>
              <a:gdLst>
                <a:gd name="T0" fmla="*/ 452 w 452"/>
                <a:gd name="T1" fmla="*/ 467 h 467"/>
                <a:gd name="T2" fmla="*/ 452 w 452"/>
                <a:gd name="T3" fmla="*/ 0 h 467"/>
                <a:gd name="T4" fmla="*/ 0 w 452"/>
                <a:gd name="T5" fmla="*/ 0 h 467"/>
                <a:gd name="T6" fmla="*/ 452 w 452"/>
                <a:gd name="T7" fmla="*/ 467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452" y="467"/>
                  </a:moveTo>
                  <a:cubicBezTo>
                    <a:pt x="452" y="0"/>
                    <a:pt x="452" y="0"/>
                    <a:pt x="45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233" y="37"/>
                    <a:pt x="416" y="227"/>
                    <a:pt x="452" y="467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05B94AA3-7F1D-AA44-9A34-46345ACC0575}"/>
                </a:ext>
              </a:extLst>
            </p:cNvPr>
            <p:cNvSpPr>
              <a:spLocks/>
            </p:cNvSpPr>
            <p:nvPr/>
          </p:nvSpPr>
          <p:spPr bwMode="auto">
            <a:xfrm>
              <a:off x="769938" y="419101"/>
              <a:ext cx="858838" cy="889000"/>
            </a:xfrm>
            <a:custGeom>
              <a:avLst/>
              <a:gdLst>
                <a:gd name="T0" fmla="*/ 452 w 452"/>
                <a:gd name="T1" fmla="*/ 0 h 467"/>
                <a:gd name="T2" fmla="*/ 0 w 452"/>
                <a:gd name="T3" fmla="*/ 0 h 467"/>
                <a:gd name="T4" fmla="*/ 0 w 452"/>
                <a:gd name="T5" fmla="*/ 467 h 467"/>
                <a:gd name="T6" fmla="*/ 452 w 452"/>
                <a:gd name="T7" fmla="*/ 0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452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467"/>
                    <a:pt x="0" y="467"/>
                    <a:pt x="0" y="467"/>
                  </a:cubicBezTo>
                  <a:cubicBezTo>
                    <a:pt x="36" y="227"/>
                    <a:pt x="220" y="37"/>
                    <a:pt x="452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60433023-A4F2-924A-890E-B0DF6E382DBD}"/>
                </a:ext>
              </a:extLst>
            </p:cNvPr>
            <p:cNvSpPr>
              <a:spLocks/>
            </p:cNvSpPr>
            <p:nvPr/>
          </p:nvSpPr>
          <p:spPr bwMode="auto">
            <a:xfrm>
              <a:off x="769938" y="1635126"/>
              <a:ext cx="858838" cy="890588"/>
            </a:xfrm>
            <a:custGeom>
              <a:avLst/>
              <a:gdLst>
                <a:gd name="T0" fmla="*/ 0 w 452"/>
                <a:gd name="T1" fmla="*/ 0 h 467"/>
                <a:gd name="T2" fmla="*/ 0 w 452"/>
                <a:gd name="T3" fmla="*/ 467 h 467"/>
                <a:gd name="T4" fmla="*/ 452 w 452"/>
                <a:gd name="T5" fmla="*/ 467 h 467"/>
                <a:gd name="T6" fmla="*/ 0 w 452"/>
                <a:gd name="T7" fmla="*/ 0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0" y="0"/>
                  </a:moveTo>
                  <a:cubicBezTo>
                    <a:pt x="0" y="467"/>
                    <a:pt x="0" y="467"/>
                    <a:pt x="0" y="467"/>
                  </a:cubicBezTo>
                  <a:cubicBezTo>
                    <a:pt x="452" y="467"/>
                    <a:pt x="452" y="467"/>
                    <a:pt x="452" y="467"/>
                  </a:cubicBezTo>
                  <a:cubicBezTo>
                    <a:pt x="220" y="430"/>
                    <a:pt x="36" y="240"/>
                    <a:pt x="0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19B12731-D2DD-1E44-937C-7C9945B25F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6276" y="1635126"/>
              <a:ext cx="858838" cy="890588"/>
            </a:xfrm>
            <a:custGeom>
              <a:avLst/>
              <a:gdLst>
                <a:gd name="T0" fmla="*/ 0 w 452"/>
                <a:gd name="T1" fmla="*/ 467 h 467"/>
                <a:gd name="T2" fmla="*/ 452 w 452"/>
                <a:gd name="T3" fmla="*/ 467 h 467"/>
                <a:gd name="T4" fmla="*/ 452 w 452"/>
                <a:gd name="T5" fmla="*/ 0 h 467"/>
                <a:gd name="T6" fmla="*/ 0 w 452"/>
                <a:gd name="T7" fmla="*/ 467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2" h="467">
                  <a:moveTo>
                    <a:pt x="0" y="467"/>
                  </a:moveTo>
                  <a:cubicBezTo>
                    <a:pt x="452" y="467"/>
                    <a:pt x="452" y="467"/>
                    <a:pt x="452" y="467"/>
                  </a:cubicBezTo>
                  <a:cubicBezTo>
                    <a:pt x="452" y="0"/>
                    <a:pt x="452" y="0"/>
                    <a:pt x="452" y="0"/>
                  </a:cubicBezTo>
                  <a:cubicBezTo>
                    <a:pt x="416" y="240"/>
                    <a:pt x="233" y="430"/>
                    <a:pt x="0" y="467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35105EED-6F42-6D4A-A12A-2F6B7FB8E4C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6276" y="1265238"/>
              <a:ext cx="319088" cy="414338"/>
            </a:xfrm>
            <a:custGeom>
              <a:avLst/>
              <a:gdLst>
                <a:gd name="T0" fmla="*/ 201 w 201"/>
                <a:gd name="T1" fmla="*/ 166 h 261"/>
                <a:gd name="T2" fmla="*/ 91 w 201"/>
                <a:gd name="T3" fmla="*/ 166 h 261"/>
                <a:gd name="T4" fmla="*/ 91 w 201"/>
                <a:gd name="T5" fmla="*/ 94 h 261"/>
                <a:gd name="T6" fmla="*/ 201 w 201"/>
                <a:gd name="T7" fmla="*/ 94 h 261"/>
                <a:gd name="T8" fmla="*/ 201 w 201"/>
                <a:gd name="T9" fmla="*/ 0 h 261"/>
                <a:gd name="T10" fmla="*/ 0 w 201"/>
                <a:gd name="T11" fmla="*/ 0 h 261"/>
                <a:gd name="T12" fmla="*/ 0 w 201"/>
                <a:gd name="T13" fmla="*/ 261 h 261"/>
                <a:gd name="T14" fmla="*/ 201 w 201"/>
                <a:gd name="T15" fmla="*/ 261 h 261"/>
                <a:gd name="T16" fmla="*/ 201 w 201"/>
                <a:gd name="T17" fmla="*/ 166 h 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01" h="261">
                  <a:moveTo>
                    <a:pt x="201" y="166"/>
                  </a:moveTo>
                  <a:lnTo>
                    <a:pt x="91" y="166"/>
                  </a:lnTo>
                  <a:lnTo>
                    <a:pt x="91" y="94"/>
                  </a:lnTo>
                  <a:lnTo>
                    <a:pt x="201" y="94"/>
                  </a:lnTo>
                  <a:lnTo>
                    <a:pt x="201" y="0"/>
                  </a:lnTo>
                  <a:lnTo>
                    <a:pt x="0" y="0"/>
                  </a:lnTo>
                  <a:lnTo>
                    <a:pt x="0" y="261"/>
                  </a:lnTo>
                  <a:lnTo>
                    <a:pt x="201" y="261"/>
                  </a:lnTo>
                  <a:lnTo>
                    <a:pt x="201" y="166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B39AC0C7-99C2-9D4C-9756-78218D32D52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08226" y="1031876"/>
              <a:ext cx="393700" cy="647700"/>
            </a:xfrm>
            <a:custGeom>
              <a:avLst/>
              <a:gdLst>
                <a:gd name="T0" fmla="*/ 163 w 248"/>
                <a:gd name="T1" fmla="*/ 313 h 408"/>
                <a:gd name="T2" fmla="*/ 93 w 248"/>
                <a:gd name="T3" fmla="*/ 313 h 408"/>
                <a:gd name="T4" fmla="*/ 93 w 248"/>
                <a:gd name="T5" fmla="*/ 241 h 408"/>
                <a:gd name="T6" fmla="*/ 163 w 248"/>
                <a:gd name="T7" fmla="*/ 241 h 408"/>
                <a:gd name="T8" fmla="*/ 163 w 248"/>
                <a:gd name="T9" fmla="*/ 313 h 408"/>
                <a:gd name="T10" fmla="*/ 0 w 248"/>
                <a:gd name="T11" fmla="*/ 0 h 408"/>
                <a:gd name="T12" fmla="*/ 0 w 248"/>
                <a:gd name="T13" fmla="*/ 408 h 408"/>
                <a:gd name="T14" fmla="*/ 248 w 248"/>
                <a:gd name="T15" fmla="*/ 408 h 408"/>
                <a:gd name="T16" fmla="*/ 248 w 248"/>
                <a:gd name="T17" fmla="*/ 147 h 408"/>
                <a:gd name="T18" fmla="*/ 93 w 248"/>
                <a:gd name="T19" fmla="*/ 147 h 408"/>
                <a:gd name="T20" fmla="*/ 93 w 248"/>
                <a:gd name="T21" fmla="*/ 0 h 408"/>
                <a:gd name="T22" fmla="*/ 0 w 248"/>
                <a:gd name="T23" fmla="*/ 0 h 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8" h="408">
                  <a:moveTo>
                    <a:pt x="163" y="313"/>
                  </a:moveTo>
                  <a:lnTo>
                    <a:pt x="93" y="313"/>
                  </a:lnTo>
                  <a:lnTo>
                    <a:pt x="93" y="241"/>
                  </a:lnTo>
                  <a:lnTo>
                    <a:pt x="163" y="241"/>
                  </a:lnTo>
                  <a:lnTo>
                    <a:pt x="163" y="313"/>
                  </a:lnTo>
                  <a:close/>
                  <a:moveTo>
                    <a:pt x="0" y="0"/>
                  </a:moveTo>
                  <a:lnTo>
                    <a:pt x="0" y="408"/>
                  </a:lnTo>
                  <a:lnTo>
                    <a:pt x="248" y="408"/>
                  </a:lnTo>
                  <a:lnTo>
                    <a:pt x="248" y="147"/>
                  </a:lnTo>
                  <a:lnTo>
                    <a:pt x="93" y="147"/>
                  </a:lnTo>
                  <a:lnTo>
                    <a:pt x="93" y="0"/>
                  </a:ln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8D02B1E5-C05E-9844-BA33-9CB1289A79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12888" y="419101"/>
              <a:ext cx="384175" cy="2106613"/>
            </a:xfrm>
            <a:custGeom>
              <a:avLst/>
              <a:gdLst>
                <a:gd name="T0" fmla="*/ 177 w 242"/>
                <a:gd name="T1" fmla="*/ 0 h 1327"/>
                <a:gd name="T2" fmla="*/ 169 w 242"/>
                <a:gd name="T3" fmla="*/ 0 h 1327"/>
                <a:gd name="T4" fmla="*/ 169 w 242"/>
                <a:gd name="T5" fmla="*/ 533 h 1327"/>
                <a:gd name="T6" fmla="*/ 151 w 242"/>
                <a:gd name="T7" fmla="*/ 533 h 1327"/>
                <a:gd name="T8" fmla="*/ 151 w 242"/>
                <a:gd name="T9" fmla="*/ 699 h 1327"/>
                <a:gd name="T10" fmla="*/ 85 w 242"/>
                <a:gd name="T11" fmla="*/ 699 h 1327"/>
                <a:gd name="T12" fmla="*/ 85 w 242"/>
                <a:gd name="T13" fmla="*/ 533 h 1327"/>
                <a:gd name="T14" fmla="*/ 0 w 242"/>
                <a:gd name="T15" fmla="*/ 533 h 1327"/>
                <a:gd name="T16" fmla="*/ 0 w 242"/>
                <a:gd name="T17" fmla="*/ 794 h 1327"/>
                <a:gd name="T18" fmla="*/ 169 w 242"/>
                <a:gd name="T19" fmla="*/ 794 h 1327"/>
                <a:gd name="T20" fmla="*/ 169 w 242"/>
                <a:gd name="T21" fmla="*/ 1327 h 1327"/>
                <a:gd name="T22" fmla="*/ 177 w 242"/>
                <a:gd name="T23" fmla="*/ 1327 h 1327"/>
                <a:gd name="T24" fmla="*/ 177 w 242"/>
                <a:gd name="T25" fmla="*/ 794 h 1327"/>
                <a:gd name="T26" fmla="*/ 242 w 242"/>
                <a:gd name="T27" fmla="*/ 794 h 1327"/>
                <a:gd name="T28" fmla="*/ 242 w 242"/>
                <a:gd name="T29" fmla="*/ 533 h 1327"/>
                <a:gd name="T30" fmla="*/ 177 w 242"/>
                <a:gd name="T31" fmla="*/ 533 h 1327"/>
                <a:gd name="T32" fmla="*/ 177 w 242"/>
                <a:gd name="T33" fmla="*/ 0 h 1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2" h="1327">
                  <a:moveTo>
                    <a:pt x="177" y="0"/>
                  </a:moveTo>
                  <a:lnTo>
                    <a:pt x="169" y="0"/>
                  </a:lnTo>
                  <a:lnTo>
                    <a:pt x="169" y="533"/>
                  </a:lnTo>
                  <a:lnTo>
                    <a:pt x="151" y="533"/>
                  </a:lnTo>
                  <a:lnTo>
                    <a:pt x="151" y="699"/>
                  </a:lnTo>
                  <a:lnTo>
                    <a:pt x="85" y="699"/>
                  </a:lnTo>
                  <a:lnTo>
                    <a:pt x="85" y="533"/>
                  </a:lnTo>
                  <a:lnTo>
                    <a:pt x="0" y="533"/>
                  </a:lnTo>
                  <a:lnTo>
                    <a:pt x="0" y="794"/>
                  </a:lnTo>
                  <a:lnTo>
                    <a:pt x="169" y="794"/>
                  </a:lnTo>
                  <a:lnTo>
                    <a:pt x="169" y="1327"/>
                  </a:lnTo>
                  <a:lnTo>
                    <a:pt x="177" y="1327"/>
                  </a:lnTo>
                  <a:lnTo>
                    <a:pt x="177" y="794"/>
                  </a:lnTo>
                  <a:lnTo>
                    <a:pt x="242" y="794"/>
                  </a:lnTo>
                  <a:lnTo>
                    <a:pt x="242" y="533"/>
                  </a:lnTo>
                  <a:lnTo>
                    <a:pt x="177" y="533"/>
                  </a:lnTo>
                  <a:lnTo>
                    <a:pt x="177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34331F41-0221-F24B-884E-C791B382D8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9976" y="427038"/>
              <a:ext cx="49213" cy="833438"/>
            </a:xfrm>
            <a:prstGeom prst="rect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44110B3C-1344-D044-AD41-560B8A2B1DC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0638" y="649288"/>
              <a:ext cx="481013" cy="611188"/>
            </a:xfrm>
            <a:custGeom>
              <a:avLst/>
              <a:gdLst>
                <a:gd name="T0" fmla="*/ 0 w 253"/>
                <a:gd name="T1" fmla="*/ 8 h 321"/>
                <a:gd name="T2" fmla="*/ 26 w 253"/>
                <a:gd name="T3" fmla="*/ 8 h 321"/>
                <a:gd name="T4" fmla="*/ 26 w 253"/>
                <a:gd name="T5" fmla="*/ 63 h 321"/>
                <a:gd name="T6" fmla="*/ 23 w 253"/>
                <a:gd name="T7" fmla="*/ 89 h 321"/>
                <a:gd name="T8" fmla="*/ 24 w 253"/>
                <a:gd name="T9" fmla="*/ 89 h 321"/>
                <a:gd name="T10" fmla="*/ 153 w 253"/>
                <a:gd name="T11" fmla="*/ 0 h 321"/>
                <a:gd name="T12" fmla="*/ 253 w 253"/>
                <a:gd name="T13" fmla="*/ 122 h 321"/>
                <a:gd name="T14" fmla="*/ 253 w 253"/>
                <a:gd name="T15" fmla="*/ 321 h 321"/>
                <a:gd name="T16" fmla="*/ 227 w 253"/>
                <a:gd name="T17" fmla="*/ 321 h 321"/>
                <a:gd name="T18" fmla="*/ 227 w 253"/>
                <a:gd name="T19" fmla="*/ 132 h 321"/>
                <a:gd name="T20" fmla="*/ 153 w 253"/>
                <a:gd name="T21" fmla="*/ 26 h 321"/>
                <a:gd name="T22" fmla="*/ 30 w 253"/>
                <a:gd name="T23" fmla="*/ 126 h 321"/>
                <a:gd name="T24" fmla="*/ 26 w 253"/>
                <a:gd name="T25" fmla="*/ 168 h 321"/>
                <a:gd name="T26" fmla="*/ 26 w 253"/>
                <a:gd name="T27" fmla="*/ 321 h 321"/>
                <a:gd name="T28" fmla="*/ 0 w 253"/>
                <a:gd name="T29" fmla="*/ 321 h 321"/>
                <a:gd name="T30" fmla="*/ 0 w 253"/>
                <a:gd name="T31" fmla="*/ 8 h 3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53" h="321">
                  <a:moveTo>
                    <a:pt x="0" y="8"/>
                  </a:moveTo>
                  <a:cubicBezTo>
                    <a:pt x="26" y="8"/>
                    <a:pt x="26" y="8"/>
                    <a:pt x="26" y="8"/>
                  </a:cubicBezTo>
                  <a:cubicBezTo>
                    <a:pt x="26" y="63"/>
                    <a:pt x="26" y="63"/>
                    <a:pt x="26" y="63"/>
                  </a:cubicBezTo>
                  <a:cubicBezTo>
                    <a:pt x="26" y="77"/>
                    <a:pt x="23" y="89"/>
                    <a:pt x="23" y="89"/>
                  </a:cubicBezTo>
                  <a:cubicBezTo>
                    <a:pt x="24" y="89"/>
                    <a:pt x="24" y="89"/>
                    <a:pt x="24" y="89"/>
                  </a:cubicBezTo>
                  <a:cubicBezTo>
                    <a:pt x="35" y="59"/>
                    <a:pt x="77" y="0"/>
                    <a:pt x="153" y="0"/>
                  </a:cubicBezTo>
                  <a:cubicBezTo>
                    <a:pt x="231" y="0"/>
                    <a:pt x="253" y="49"/>
                    <a:pt x="253" y="122"/>
                  </a:cubicBezTo>
                  <a:cubicBezTo>
                    <a:pt x="253" y="321"/>
                    <a:pt x="253" y="321"/>
                    <a:pt x="253" y="321"/>
                  </a:cubicBezTo>
                  <a:cubicBezTo>
                    <a:pt x="227" y="321"/>
                    <a:pt x="227" y="321"/>
                    <a:pt x="227" y="321"/>
                  </a:cubicBezTo>
                  <a:cubicBezTo>
                    <a:pt x="227" y="132"/>
                    <a:pt x="227" y="132"/>
                    <a:pt x="227" y="132"/>
                  </a:cubicBezTo>
                  <a:cubicBezTo>
                    <a:pt x="227" y="77"/>
                    <a:pt x="220" y="26"/>
                    <a:pt x="153" y="26"/>
                  </a:cubicBezTo>
                  <a:cubicBezTo>
                    <a:pt x="96" y="26"/>
                    <a:pt x="46" y="67"/>
                    <a:pt x="30" y="126"/>
                  </a:cubicBezTo>
                  <a:cubicBezTo>
                    <a:pt x="27" y="139"/>
                    <a:pt x="26" y="153"/>
                    <a:pt x="26" y="168"/>
                  </a:cubicBezTo>
                  <a:cubicBezTo>
                    <a:pt x="26" y="321"/>
                    <a:pt x="26" y="321"/>
                    <a:pt x="26" y="321"/>
                  </a:cubicBezTo>
                  <a:cubicBezTo>
                    <a:pt x="0" y="321"/>
                    <a:pt x="0" y="321"/>
                    <a:pt x="0" y="321"/>
                  </a:cubicBezTo>
                  <a:lnTo>
                    <a:pt x="0" y="8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6A976845-9570-C140-AEEF-0DBD4AA9CD8B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0551" y="652463"/>
              <a:ext cx="392113" cy="622300"/>
            </a:xfrm>
            <a:custGeom>
              <a:avLst/>
              <a:gdLst>
                <a:gd name="T0" fmla="*/ 16 w 206"/>
                <a:gd name="T1" fmla="*/ 262 h 327"/>
                <a:gd name="T2" fmla="*/ 110 w 206"/>
                <a:gd name="T3" fmla="*/ 302 h 327"/>
                <a:gd name="T4" fmla="*/ 179 w 206"/>
                <a:gd name="T5" fmla="*/ 243 h 327"/>
                <a:gd name="T6" fmla="*/ 13 w 206"/>
                <a:gd name="T7" fmla="*/ 84 h 327"/>
                <a:gd name="T8" fmla="*/ 110 w 206"/>
                <a:gd name="T9" fmla="*/ 0 h 327"/>
                <a:gd name="T10" fmla="*/ 199 w 206"/>
                <a:gd name="T11" fmla="*/ 33 h 327"/>
                <a:gd name="T12" fmla="*/ 184 w 206"/>
                <a:gd name="T13" fmla="*/ 55 h 327"/>
                <a:gd name="T14" fmla="*/ 108 w 206"/>
                <a:gd name="T15" fmla="*/ 25 h 327"/>
                <a:gd name="T16" fmla="*/ 40 w 206"/>
                <a:gd name="T17" fmla="*/ 82 h 327"/>
                <a:gd name="T18" fmla="*/ 206 w 206"/>
                <a:gd name="T19" fmla="*/ 243 h 327"/>
                <a:gd name="T20" fmla="*/ 109 w 206"/>
                <a:gd name="T21" fmla="*/ 327 h 327"/>
                <a:gd name="T22" fmla="*/ 0 w 206"/>
                <a:gd name="T23" fmla="*/ 282 h 327"/>
                <a:gd name="T24" fmla="*/ 16 w 206"/>
                <a:gd name="T25" fmla="*/ 262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06" h="327">
                  <a:moveTo>
                    <a:pt x="16" y="262"/>
                  </a:moveTo>
                  <a:cubicBezTo>
                    <a:pt x="16" y="262"/>
                    <a:pt x="50" y="302"/>
                    <a:pt x="110" y="302"/>
                  </a:cubicBezTo>
                  <a:cubicBezTo>
                    <a:pt x="147" y="302"/>
                    <a:pt x="179" y="281"/>
                    <a:pt x="179" y="243"/>
                  </a:cubicBezTo>
                  <a:cubicBezTo>
                    <a:pt x="179" y="163"/>
                    <a:pt x="13" y="186"/>
                    <a:pt x="13" y="84"/>
                  </a:cubicBezTo>
                  <a:cubicBezTo>
                    <a:pt x="13" y="28"/>
                    <a:pt x="58" y="0"/>
                    <a:pt x="110" y="0"/>
                  </a:cubicBezTo>
                  <a:cubicBezTo>
                    <a:pt x="171" y="0"/>
                    <a:pt x="199" y="33"/>
                    <a:pt x="199" y="33"/>
                  </a:cubicBezTo>
                  <a:cubicBezTo>
                    <a:pt x="184" y="55"/>
                    <a:pt x="184" y="55"/>
                    <a:pt x="184" y="55"/>
                  </a:cubicBezTo>
                  <a:cubicBezTo>
                    <a:pt x="184" y="55"/>
                    <a:pt x="159" y="25"/>
                    <a:pt x="108" y="25"/>
                  </a:cubicBezTo>
                  <a:cubicBezTo>
                    <a:pt x="73" y="25"/>
                    <a:pt x="40" y="41"/>
                    <a:pt x="40" y="82"/>
                  </a:cubicBezTo>
                  <a:cubicBezTo>
                    <a:pt x="40" y="163"/>
                    <a:pt x="206" y="139"/>
                    <a:pt x="206" y="243"/>
                  </a:cubicBezTo>
                  <a:cubicBezTo>
                    <a:pt x="206" y="293"/>
                    <a:pt x="165" y="327"/>
                    <a:pt x="109" y="327"/>
                  </a:cubicBezTo>
                  <a:cubicBezTo>
                    <a:pt x="36" y="327"/>
                    <a:pt x="0" y="282"/>
                    <a:pt x="0" y="282"/>
                  </a:cubicBezTo>
                  <a:lnTo>
                    <a:pt x="16" y="26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37E0DA62-90B9-7842-AB64-75D0584A67F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99026" y="649288"/>
              <a:ext cx="501650" cy="849313"/>
            </a:xfrm>
            <a:custGeom>
              <a:avLst/>
              <a:gdLst>
                <a:gd name="T0" fmla="*/ 130 w 264"/>
                <a:gd name="T1" fmla="*/ 303 h 446"/>
                <a:gd name="T2" fmla="*/ 238 w 264"/>
                <a:gd name="T3" fmla="*/ 164 h 446"/>
                <a:gd name="T4" fmla="*/ 132 w 264"/>
                <a:gd name="T5" fmla="*/ 26 h 446"/>
                <a:gd name="T6" fmla="*/ 25 w 264"/>
                <a:gd name="T7" fmla="*/ 165 h 446"/>
                <a:gd name="T8" fmla="*/ 130 w 264"/>
                <a:gd name="T9" fmla="*/ 303 h 446"/>
                <a:gd name="T10" fmla="*/ 0 w 264"/>
                <a:gd name="T11" fmla="*/ 8 h 446"/>
                <a:gd name="T12" fmla="*/ 25 w 264"/>
                <a:gd name="T13" fmla="*/ 8 h 446"/>
                <a:gd name="T14" fmla="*/ 25 w 264"/>
                <a:gd name="T15" fmla="*/ 46 h 446"/>
                <a:gd name="T16" fmla="*/ 23 w 264"/>
                <a:gd name="T17" fmla="*/ 71 h 446"/>
                <a:gd name="T18" fmla="*/ 25 w 264"/>
                <a:gd name="T19" fmla="*/ 71 h 446"/>
                <a:gd name="T20" fmla="*/ 134 w 264"/>
                <a:gd name="T21" fmla="*/ 0 h 446"/>
                <a:gd name="T22" fmla="*/ 264 w 264"/>
                <a:gd name="T23" fmla="*/ 164 h 446"/>
                <a:gd name="T24" fmla="*/ 130 w 264"/>
                <a:gd name="T25" fmla="*/ 328 h 446"/>
                <a:gd name="T26" fmla="*/ 24 w 264"/>
                <a:gd name="T27" fmla="*/ 257 h 446"/>
                <a:gd name="T28" fmla="*/ 23 w 264"/>
                <a:gd name="T29" fmla="*/ 257 h 446"/>
                <a:gd name="T30" fmla="*/ 25 w 264"/>
                <a:gd name="T31" fmla="*/ 285 h 446"/>
                <a:gd name="T32" fmla="*/ 25 w 264"/>
                <a:gd name="T33" fmla="*/ 446 h 446"/>
                <a:gd name="T34" fmla="*/ 0 w 264"/>
                <a:gd name="T35" fmla="*/ 446 h 446"/>
                <a:gd name="T36" fmla="*/ 0 w 264"/>
                <a:gd name="T37" fmla="*/ 8 h 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4" h="446">
                  <a:moveTo>
                    <a:pt x="130" y="303"/>
                  </a:moveTo>
                  <a:cubicBezTo>
                    <a:pt x="189" y="303"/>
                    <a:pt x="238" y="252"/>
                    <a:pt x="238" y="164"/>
                  </a:cubicBezTo>
                  <a:cubicBezTo>
                    <a:pt x="238" y="80"/>
                    <a:pt x="194" y="26"/>
                    <a:pt x="132" y="26"/>
                  </a:cubicBezTo>
                  <a:cubicBezTo>
                    <a:pt x="77" y="26"/>
                    <a:pt x="25" y="67"/>
                    <a:pt x="25" y="165"/>
                  </a:cubicBezTo>
                  <a:cubicBezTo>
                    <a:pt x="25" y="234"/>
                    <a:pt x="62" y="303"/>
                    <a:pt x="130" y="303"/>
                  </a:cubicBezTo>
                  <a:moveTo>
                    <a:pt x="0" y="8"/>
                  </a:moveTo>
                  <a:cubicBezTo>
                    <a:pt x="25" y="8"/>
                    <a:pt x="25" y="8"/>
                    <a:pt x="25" y="8"/>
                  </a:cubicBezTo>
                  <a:cubicBezTo>
                    <a:pt x="25" y="46"/>
                    <a:pt x="25" y="46"/>
                    <a:pt x="25" y="46"/>
                  </a:cubicBezTo>
                  <a:cubicBezTo>
                    <a:pt x="25" y="60"/>
                    <a:pt x="23" y="71"/>
                    <a:pt x="23" y="71"/>
                  </a:cubicBezTo>
                  <a:cubicBezTo>
                    <a:pt x="25" y="71"/>
                    <a:pt x="25" y="71"/>
                    <a:pt x="25" y="71"/>
                  </a:cubicBezTo>
                  <a:cubicBezTo>
                    <a:pt x="25" y="71"/>
                    <a:pt x="49" y="0"/>
                    <a:pt x="134" y="0"/>
                  </a:cubicBezTo>
                  <a:cubicBezTo>
                    <a:pt x="215" y="0"/>
                    <a:pt x="264" y="67"/>
                    <a:pt x="264" y="164"/>
                  </a:cubicBezTo>
                  <a:cubicBezTo>
                    <a:pt x="264" y="264"/>
                    <a:pt x="208" y="328"/>
                    <a:pt x="130" y="328"/>
                  </a:cubicBezTo>
                  <a:cubicBezTo>
                    <a:pt x="51" y="328"/>
                    <a:pt x="24" y="257"/>
                    <a:pt x="24" y="257"/>
                  </a:cubicBezTo>
                  <a:cubicBezTo>
                    <a:pt x="23" y="257"/>
                    <a:pt x="23" y="257"/>
                    <a:pt x="23" y="257"/>
                  </a:cubicBezTo>
                  <a:cubicBezTo>
                    <a:pt x="23" y="257"/>
                    <a:pt x="25" y="269"/>
                    <a:pt x="25" y="285"/>
                  </a:cubicBezTo>
                  <a:cubicBezTo>
                    <a:pt x="25" y="446"/>
                    <a:pt x="25" y="446"/>
                    <a:pt x="25" y="446"/>
                  </a:cubicBezTo>
                  <a:cubicBezTo>
                    <a:pt x="0" y="446"/>
                    <a:pt x="0" y="446"/>
                    <a:pt x="0" y="446"/>
                  </a:cubicBezTo>
                  <a:lnTo>
                    <a:pt x="0" y="8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id="{400545EC-F504-0541-A316-C3189AA9609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13388" y="427038"/>
              <a:ext cx="57150" cy="833438"/>
            </a:xfrm>
            <a:custGeom>
              <a:avLst/>
              <a:gdLst>
                <a:gd name="T0" fmla="*/ 3 w 36"/>
                <a:gd name="T1" fmla="*/ 525 h 525"/>
                <a:gd name="T2" fmla="*/ 34 w 36"/>
                <a:gd name="T3" fmla="*/ 525 h 525"/>
                <a:gd name="T4" fmla="*/ 34 w 36"/>
                <a:gd name="T5" fmla="*/ 150 h 525"/>
                <a:gd name="T6" fmla="*/ 3 w 36"/>
                <a:gd name="T7" fmla="*/ 150 h 525"/>
                <a:gd name="T8" fmla="*/ 3 w 36"/>
                <a:gd name="T9" fmla="*/ 525 h 525"/>
                <a:gd name="T10" fmla="*/ 0 w 36"/>
                <a:gd name="T11" fmla="*/ 55 h 525"/>
                <a:gd name="T12" fmla="*/ 36 w 36"/>
                <a:gd name="T13" fmla="*/ 55 h 525"/>
                <a:gd name="T14" fmla="*/ 36 w 36"/>
                <a:gd name="T15" fmla="*/ 0 h 525"/>
                <a:gd name="T16" fmla="*/ 0 w 36"/>
                <a:gd name="T17" fmla="*/ 0 h 525"/>
                <a:gd name="T18" fmla="*/ 0 w 36"/>
                <a:gd name="T19" fmla="*/ 55 h 5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525">
                  <a:moveTo>
                    <a:pt x="3" y="525"/>
                  </a:moveTo>
                  <a:lnTo>
                    <a:pt x="34" y="525"/>
                  </a:lnTo>
                  <a:lnTo>
                    <a:pt x="34" y="150"/>
                  </a:lnTo>
                  <a:lnTo>
                    <a:pt x="3" y="150"/>
                  </a:lnTo>
                  <a:lnTo>
                    <a:pt x="3" y="525"/>
                  </a:lnTo>
                  <a:close/>
                  <a:moveTo>
                    <a:pt x="0" y="55"/>
                  </a:moveTo>
                  <a:lnTo>
                    <a:pt x="36" y="55"/>
                  </a:lnTo>
                  <a:lnTo>
                    <a:pt x="36" y="0"/>
                  </a:lnTo>
                  <a:lnTo>
                    <a:pt x="0" y="0"/>
                  </a:lnTo>
                  <a:lnTo>
                    <a:pt x="0" y="55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D7613BB2-5704-A544-845A-5EE91F5F60E8}"/>
                </a:ext>
              </a:extLst>
            </p:cNvPr>
            <p:cNvSpPr>
              <a:spLocks/>
            </p:cNvSpPr>
            <p:nvPr/>
          </p:nvSpPr>
          <p:spPr bwMode="auto">
            <a:xfrm>
              <a:off x="5716588" y="660401"/>
              <a:ext cx="263525" cy="600075"/>
            </a:xfrm>
            <a:custGeom>
              <a:avLst/>
              <a:gdLst>
                <a:gd name="T0" fmla="*/ 0 w 138"/>
                <a:gd name="T1" fmla="*/ 2 h 315"/>
                <a:gd name="T2" fmla="*/ 25 w 138"/>
                <a:gd name="T3" fmla="*/ 2 h 315"/>
                <a:gd name="T4" fmla="*/ 25 w 138"/>
                <a:gd name="T5" fmla="*/ 61 h 315"/>
                <a:gd name="T6" fmla="*/ 23 w 138"/>
                <a:gd name="T7" fmla="*/ 87 h 315"/>
                <a:gd name="T8" fmla="*/ 24 w 138"/>
                <a:gd name="T9" fmla="*/ 87 h 315"/>
                <a:gd name="T10" fmla="*/ 121 w 138"/>
                <a:gd name="T11" fmla="*/ 0 h 315"/>
                <a:gd name="T12" fmla="*/ 138 w 138"/>
                <a:gd name="T13" fmla="*/ 1 h 315"/>
                <a:gd name="T14" fmla="*/ 138 w 138"/>
                <a:gd name="T15" fmla="*/ 28 h 315"/>
                <a:gd name="T16" fmla="*/ 125 w 138"/>
                <a:gd name="T17" fmla="*/ 26 h 315"/>
                <a:gd name="T18" fmla="*/ 34 w 138"/>
                <a:gd name="T19" fmla="*/ 114 h 315"/>
                <a:gd name="T20" fmla="*/ 25 w 138"/>
                <a:gd name="T21" fmla="*/ 180 h 315"/>
                <a:gd name="T22" fmla="*/ 25 w 138"/>
                <a:gd name="T23" fmla="*/ 315 h 315"/>
                <a:gd name="T24" fmla="*/ 0 w 138"/>
                <a:gd name="T25" fmla="*/ 315 h 315"/>
                <a:gd name="T26" fmla="*/ 0 w 138"/>
                <a:gd name="T27" fmla="*/ 2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38" h="315">
                  <a:moveTo>
                    <a:pt x="0" y="2"/>
                  </a:moveTo>
                  <a:cubicBezTo>
                    <a:pt x="25" y="2"/>
                    <a:pt x="25" y="2"/>
                    <a:pt x="25" y="2"/>
                  </a:cubicBezTo>
                  <a:cubicBezTo>
                    <a:pt x="25" y="61"/>
                    <a:pt x="25" y="61"/>
                    <a:pt x="25" y="61"/>
                  </a:cubicBezTo>
                  <a:cubicBezTo>
                    <a:pt x="25" y="76"/>
                    <a:pt x="23" y="87"/>
                    <a:pt x="23" y="87"/>
                  </a:cubicBezTo>
                  <a:cubicBezTo>
                    <a:pt x="24" y="87"/>
                    <a:pt x="24" y="87"/>
                    <a:pt x="24" y="87"/>
                  </a:cubicBezTo>
                  <a:cubicBezTo>
                    <a:pt x="39" y="39"/>
                    <a:pt x="73" y="0"/>
                    <a:pt x="121" y="0"/>
                  </a:cubicBezTo>
                  <a:cubicBezTo>
                    <a:pt x="130" y="0"/>
                    <a:pt x="138" y="1"/>
                    <a:pt x="138" y="1"/>
                  </a:cubicBezTo>
                  <a:cubicBezTo>
                    <a:pt x="138" y="28"/>
                    <a:pt x="138" y="28"/>
                    <a:pt x="138" y="28"/>
                  </a:cubicBezTo>
                  <a:cubicBezTo>
                    <a:pt x="138" y="28"/>
                    <a:pt x="131" y="26"/>
                    <a:pt x="125" y="26"/>
                  </a:cubicBezTo>
                  <a:cubicBezTo>
                    <a:pt x="77" y="26"/>
                    <a:pt x="48" y="68"/>
                    <a:pt x="34" y="114"/>
                  </a:cubicBezTo>
                  <a:cubicBezTo>
                    <a:pt x="28" y="136"/>
                    <a:pt x="25" y="159"/>
                    <a:pt x="25" y="180"/>
                  </a:cubicBezTo>
                  <a:cubicBezTo>
                    <a:pt x="25" y="315"/>
                    <a:pt x="25" y="315"/>
                    <a:pt x="25" y="315"/>
                  </a:cubicBezTo>
                  <a:cubicBezTo>
                    <a:pt x="0" y="315"/>
                    <a:pt x="0" y="315"/>
                    <a:pt x="0" y="315"/>
                  </a:cubicBezTo>
                  <a:lnTo>
                    <a:pt x="0" y="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F36C59A9-C00C-D440-A9AF-693C1680A10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991226" y="649288"/>
              <a:ext cx="514350" cy="625475"/>
            </a:xfrm>
            <a:custGeom>
              <a:avLst/>
              <a:gdLst>
                <a:gd name="T0" fmla="*/ 244 w 271"/>
                <a:gd name="T1" fmla="*/ 136 h 328"/>
                <a:gd name="T2" fmla="*/ 147 w 271"/>
                <a:gd name="T3" fmla="*/ 25 h 328"/>
                <a:gd name="T4" fmla="*/ 29 w 271"/>
                <a:gd name="T5" fmla="*/ 136 h 328"/>
                <a:gd name="T6" fmla="*/ 244 w 271"/>
                <a:gd name="T7" fmla="*/ 136 h 328"/>
                <a:gd name="T8" fmla="*/ 147 w 271"/>
                <a:gd name="T9" fmla="*/ 0 h 328"/>
                <a:gd name="T10" fmla="*/ 271 w 271"/>
                <a:gd name="T11" fmla="*/ 143 h 328"/>
                <a:gd name="T12" fmla="*/ 270 w 271"/>
                <a:gd name="T13" fmla="*/ 160 h 328"/>
                <a:gd name="T14" fmla="*/ 27 w 271"/>
                <a:gd name="T15" fmla="*/ 160 h 328"/>
                <a:gd name="T16" fmla="*/ 156 w 271"/>
                <a:gd name="T17" fmla="*/ 303 h 328"/>
                <a:gd name="T18" fmla="*/ 250 w 271"/>
                <a:gd name="T19" fmla="*/ 263 h 328"/>
                <a:gd name="T20" fmla="*/ 264 w 271"/>
                <a:gd name="T21" fmla="*/ 285 h 328"/>
                <a:gd name="T22" fmla="*/ 156 w 271"/>
                <a:gd name="T23" fmla="*/ 328 h 328"/>
                <a:gd name="T24" fmla="*/ 0 w 271"/>
                <a:gd name="T25" fmla="*/ 165 h 328"/>
                <a:gd name="T26" fmla="*/ 147 w 271"/>
                <a:gd name="T27" fmla="*/ 0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71" h="328">
                  <a:moveTo>
                    <a:pt x="244" y="136"/>
                  </a:moveTo>
                  <a:cubicBezTo>
                    <a:pt x="241" y="59"/>
                    <a:pt x="197" y="25"/>
                    <a:pt x="147" y="25"/>
                  </a:cubicBezTo>
                  <a:cubicBezTo>
                    <a:pt x="91" y="25"/>
                    <a:pt x="39" y="62"/>
                    <a:pt x="29" y="136"/>
                  </a:cubicBezTo>
                  <a:lnTo>
                    <a:pt x="244" y="136"/>
                  </a:lnTo>
                  <a:close/>
                  <a:moveTo>
                    <a:pt x="147" y="0"/>
                  </a:moveTo>
                  <a:cubicBezTo>
                    <a:pt x="230" y="0"/>
                    <a:pt x="271" y="67"/>
                    <a:pt x="271" y="143"/>
                  </a:cubicBezTo>
                  <a:cubicBezTo>
                    <a:pt x="271" y="150"/>
                    <a:pt x="270" y="160"/>
                    <a:pt x="270" y="160"/>
                  </a:cubicBezTo>
                  <a:cubicBezTo>
                    <a:pt x="27" y="160"/>
                    <a:pt x="27" y="160"/>
                    <a:pt x="27" y="160"/>
                  </a:cubicBezTo>
                  <a:cubicBezTo>
                    <a:pt x="27" y="251"/>
                    <a:pt x="86" y="303"/>
                    <a:pt x="156" y="303"/>
                  </a:cubicBezTo>
                  <a:cubicBezTo>
                    <a:pt x="214" y="303"/>
                    <a:pt x="250" y="263"/>
                    <a:pt x="250" y="263"/>
                  </a:cubicBezTo>
                  <a:cubicBezTo>
                    <a:pt x="264" y="285"/>
                    <a:pt x="264" y="285"/>
                    <a:pt x="264" y="285"/>
                  </a:cubicBezTo>
                  <a:cubicBezTo>
                    <a:pt x="264" y="285"/>
                    <a:pt x="222" y="328"/>
                    <a:pt x="156" y="328"/>
                  </a:cubicBezTo>
                  <a:cubicBezTo>
                    <a:pt x="71" y="328"/>
                    <a:pt x="0" y="264"/>
                    <a:pt x="0" y="165"/>
                  </a:cubicBezTo>
                  <a:cubicBezTo>
                    <a:pt x="0" y="59"/>
                    <a:pt x="70" y="0"/>
                    <a:pt x="147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FC901860-399C-AE4A-9485-33C49C83BDB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584951" y="427038"/>
              <a:ext cx="501650" cy="847725"/>
            </a:xfrm>
            <a:custGeom>
              <a:avLst/>
              <a:gdLst>
                <a:gd name="T0" fmla="*/ 132 w 264"/>
                <a:gd name="T1" fmla="*/ 420 h 445"/>
                <a:gd name="T2" fmla="*/ 239 w 264"/>
                <a:gd name="T3" fmla="*/ 281 h 445"/>
                <a:gd name="T4" fmla="*/ 134 w 264"/>
                <a:gd name="T5" fmla="*/ 143 h 445"/>
                <a:gd name="T6" fmla="*/ 26 w 264"/>
                <a:gd name="T7" fmla="*/ 281 h 445"/>
                <a:gd name="T8" fmla="*/ 132 w 264"/>
                <a:gd name="T9" fmla="*/ 420 h 445"/>
                <a:gd name="T10" fmla="*/ 135 w 264"/>
                <a:gd name="T11" fmla="*/ 117 h 445"/>
                <a:gd name="T12" fmla="*/ 240 w 264"/>
                <a:gd name="T13" fmla="*/ 188 h 445"/>
                <a:gd name="T14" fmla="*/ 241 w 264"/>
                <a:gd name="T15" fmla="*/ 188 h 445"/>
                <a:gd name="T16" fmla="*/ 239 w 264"/>
                <a:gd name="T17" fmla="*/ 162 h 445"/>
                <a:gd name="T18" fmla="*/ 239 w 264"/>
                <a:gd name="T19" fmla="*/ 0 h 445"/>
                <a:gd name="T20" fmla="*/ 264 w 264"/>
                <a:gd name="T21" fmla="*/ 0 h 445"/>
                <a:gd name="T22" fmla="*/ 264 w 264"/>
                <a:gd name="T23" fmla="*/ 438 h 445"/>
                <a:gd name="T24" fmla="*/ 239 w 264"/>
                <a:gd name="T25" fmla="*/ 438 h 445"/>
                <a:gd name="T26" fmla="*/ 239 w 264"/>
                <a:gd name="T27" fmla="*/ 398 h 445"/>
                <a:gd name="T28" fmla="*/ 241 w 264"/>
                <a:gd name="T29" fmla="*/ 374 h 445"/>
                <a:gd name="T30" fmla="*/ 240 w 264"/>
                <a:gd name="T31" fmla="*/ 374 h 445"/>
                <a:gd name="T32" fmla="*/ 131 w 264"/>
                <a:gd name="T33" fmla="*/ 445 h 445"/>
                <a:gd name="T34" fmla="*/ 0 w 264"/>
                <a:gd name="T35" fmla="*/ 281 h 445"/>
                <a:gd name="T36" fmla="*/ 135 w 264"/>
                <a:gd name="T37" fmla="*/ 117 h 4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4" h="445">
                  <a:moveTo>
                    <a:pt x="132" y="420"/>
                  </a:moveTo>
                  <a:cubicBezTo>
                    <a:pt x="187" y="420"/>
                    <a:pt x="239" y="379"/>
                    <a:pt x="239" y="281"/>
                  </a:cubicBezTo>
                  <a:cubicBezTo>
                    <a:pt x="239" y="211"/>
                    <a:pt x="205" y="143"/>
                    <a:pt x="134" y="143"/>
                  </a:cubicBezTo>
                  <a:cubicBezTo>
                    <a:pt x="75" y="143"/>
                    <a:pt x="26" y="194"/>
                    <a:pt x="26" y="281"/>
                  </a:cubicBezTo>
                  <a:cubicBezTo>
                    <a:pt x="26" y="366"/>
                    <a:pt x="70" y="420"/>
                    <a:pt x="132" y="420"/>
                  </a:cubicBezTo>
                  <a:moveTo>
                    <a:pt x="135" y="117"/>
                  </a:moveTo>
                  <a:cubicBezTo>
                    <a:pt x="212" y="117"/>
                    <a:pt x="240" y="188"/>
                    <a:pt x="240" y="188"/>
                  </a:cubicBezTo>
                  <a:cubicBezTo>
                    <a:pt x="241" y="188"/>
                    <a:pt x="241" y="188"/>
                    <a:pt x="241" y="188"/>
                  </a:cubicBezTo>
                  <a:cubicBezTo>
                    <a:pt x="241" y="188"/>
                    <a:pt x="239" y="177"/>
                    <a:pt x="239" y="162"/>
                  </a:cubicBezTo>
                  <a:cubicBezTo>
                    <a:pt x="239" y="0"/>
                    <a:pt x="239" y="0"/>
                    <a:pt x="239" y="0"/>
                  </a:cubicBezTo>
                  <a:cubicBezTo>
                    <a:pt x="264" y="0"/>
                    <a:pt x="264" y="0"/>
                    <a:pt x="264" y="0"/>
                  </a:cubicBezTo>
                  <a:cubicBezTo>
                    <a:pt x="264" y="438"/>
                    <a:pt x="264" y="438"/>
                    <a:pt x="264" y="438"/>
                  </a:cubicBezTo>
                  <a:cubicBezTo>
                    <a:pt x="239" y="438"/>
                    <a:pt x="239" y="438"/>
                    <a:pt x="239" y="438"/>
                  </a:cubicBezTo>
                  <a:cubicBezTo>
                    <a:pt x="239" y="398"/>
                    <a:pt x="239" y="398"/>
                    <a:pt x="239" y="398"/>
                  </a:cubicBezTo>
                  <a:cubicBezTo>
                    <a:pt x="239" y="384"/>
                    <a:pt x="241" y="374"/>
                    <a:pt x="241" y="374"/>
                  </a:cubicBezTo>
                  <a:cubicBezTo>
                    <a:pt x="240" y="374"/>
                    <a:pt x="240" y="374"/>
                    <a:pt x="240" y="374"/>
                  </a:cubicBezTo>
                  <a:cubicBezTo>
                    <a:pt x="240" y="374"/>
                    <a:pt x="214" y="445"/>
                    <a:pt x="131" y="445"/>
                  </a:cubicBezTo>
                  <a:cubicBezTo>
                    <a:pt x="49" y="445"/>
                    <a:pt x="0" y="378"/>
                    <a:pt x="0" y="281"/>
                  </a:cubicBezTo>
                  <a:cubicBezTo>
                    <a:pt x="0" y="182"/>
                    <a:pt x="56" y="117"/>
                    <a:pt x="135" y="117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1275DDBF-B86F-B045-BE1F-01830C38DCC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562851" y="427038"/>
              <a:ext cx="503238" cy="847725"/>
            </a:xfrm>
            <a:custGeom>
              <a:avLst/>
              <a:gdLst>
                <a:gd name="T0" fmla="*/ 130 w 265"/>
                <a:gd name="T1" fmla="*/ 420 h 445"/>
                <a:gd name="T2" fmla="*/ 238 w 265"/>
                <a:gd name="T3" fmla="*/ 281 h 445"/>
                <a:gd name="T4" fmla="*/ 133 w 265"/>
                <a:gd name="T5" fmla="*/ 143 h 445"/>
                <a:gd name="T6" fmla="*/ 25 w 265"/>
                <a:gd name="T7" fmla="*/ 282 h 445"/>
                <a:gd name="T8" fmla="*/ 130 w 265"/>
                <a:gd name="T9" fmla="*/ 420 h 445"/>
                <a:gd name="T10" fmla="*/ 0 w 265"/>
                <a:gd name="T11" fmla="*/ 0 h 445"/>
                <a:gd name="T12" fmla="*/ 26 w 265"/>
                <a:gd name="T13" fmla="*/ 0 h 445"/>
                <a:gd name="T14" fmla="*/ 26 w 265"/>
                <a:gd name="T15" fmla="*/ 163 h 445"/>
                <a:gd name="T16" fmla="*/ 23 w 265"/>
                <a:gd name="T17" fmla="*/ 188 h 445"/>
                <a:gd name="T18" fmla="*/ 24 w 265"/>
                <a:gd name="T19" fmla="*/ 188 h 445"/>
                <a:gd name="T20" fmla="*/ 134 w 265"/>
                <a:gd name="T21" fmla="*/ 117 h 445"/>
                <a:gd name="T22" fmla="*/ 265 w 265"/>
                <a:gd name="T23" fmla="*/ 281 h 445"/>
                <a:gd name="T24" fmla="*/ 129 w 265"/>
                <a:gd name="T25" fmla="*/ 445 h 445"/>
                <a:gd name="T26" fmla="*/ 24 w 265"/>
                <a:gd name="T27" fmla="*/ 374 h 445"/>
                <a:gd name="T28" fmla="*/ 23 w 265"/>
                <a:gd name="T29" fmla="*/ 374 h 445"/>
                <a:gd name="T30" fmla="*/ 26 w 265"/>
                <a:gd name="T31" fmla="*/ 402 h 445"/>
                <a:gd name="T32" fmla="*/ 26 w 265"/>
                <a:gd name="T33" fmla="*/ 438 h 445"/>
                <a:gd name="T34" fmla="*/ 0 w 265"/>
                <a:gd name="T35" fmla="*/ 438 h 445"/>
                <a:gd name="T36" fmla="*/ 0 w 265"/>
                <a:gd name="T37" fmla="*/ 0 h 4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5" h="445">
                  <a:moveTo>
                    <a:pt x="130" y="420"/>
                  </a:moveTo>
                  <a:cubicBezTo>
                    <a:pt x="190" y="420"/>
                    <a:pt x="238" y="369"/>
                    <a:pt x="238" y="281"/>
                  </a:cubicBezTo>
                  <a:cubicBezTo>
                    <a:pt x="238" y="197"/>
                    <a:pt x="194" y="143"/>
                    <a:pt x="133" y="143"/>
                  </a:cubicBezTo>
                  <a:cubicBezTo>
                    <a:pt x="77" y="143"/>
                    <a:pt x="25" y="184"/>
                    <a:pt x="25" y="282"/>
                  </a:cubicBezTo>
                  <a:cubicBezTo>
                    <a:pt x="25" y="351"/>
                    <a:pt x="59" y="420"/>
                    <a:pt x="130" y="420"/>
                  </a:cubicBezTo>
                  <a:moveTo>
                    <a:pt x="0" y="0"/>
                  </a:moveTo>
                  <a:cubicBezTo>
                    <a:pt x="26" y="0"/>
                    <a:pt x="26" y="0"/>
                    <a:pt x="26" y="0"/>
                  </a:cubicBezTo>
                  <a:cubicBezTo>
                    <a:pt x="26" y="163"/>
                    <a:pt x="26" y="163"/>
                    <a:pt x="26" y="163"/>
                  </a:cubicBezTo>
                  <a:cubicBezTo>
                    <a:pt x="26" y="177"/>
                    <a:pt x="23" y="188"/>
                    <a:pt x="23" y="188"/>
                  </a:cubicBezTo>
                  <a:cubicBezTo>
                    <a:pt x="24" y="188"/>
                    <a:pt x="24" y="188"/>
                    <a:pt x="24" y="188"/>
                  </a:cubicBezTo>
                  <a:cubicBezTo>
                    <a:pt x="24" y="188"/>
                    <a:pt x="50" y="117"/>
                    <a:pt x="134" y="117"/>
                  </a:cubicBezTo>
                  <a:cubicBezTo>
                    <a:pt x="215" y="117"/>
                    <a:pt x="265" y="185"/>
                    <a:pt x="265" y="281"/>
                  </a:cubicBezTo>
                  <a:cubicBezTo>
                    <a:pt x="265" y="381"/>
                    <a:pt x="208" y="445"/>
                    <a:pt x="129" y="445"/>
                  </a:cubicBezTo>
                  <a:cubicBezTo>
                    <a:pt x="53" y="445"/>
                    <a:pt x="24" y="374"/>
                    <a:pt x="24" y="374"/>
                  </a:cubicBezTo>
                  <a:cubicBezTo>
                    <a:pt x="23" y="374"/>
                    <a:pt x="23" y="374"/>
                    <a:pt x="23" y="374"/>
                  </a:cubicBezTo>
                  <a:cubicBezTo>
                    <a:pt x="23" y="374"/>
                    <a:pt x="26" y="386"/>
                    <a:pt x="26" y="402"/>
                  </a:cubicBezTo>
                  <a:cubicBezTo>
                    <a:pt x="26" y="438"/>
                    <a:pt x="26" y="438"/>
                    <a:pt x="26" y="438"/>
                  </a:cubicBezTo>
                  <a:cubicBezTo>
                    <a:pt x="0" y="438"/>
                    <a:pt x="0" y="438"/>
                    <a:pt x="0" y="438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8E6B1AD7-A0D0-5C48-BCEF-3DBAD8894A28}"/>
                </a:ext>
              </a:extLst>
            </p:cNvPr>
            <p:cNvSpPr>
              <a:spLocks/>
            </p:cNvSpPr>
            <p:nvPr/>
          </p:nvSpPr>
          <p:spPr bwMode="auto">
            <a:xfrm>
              <a:off x="8070851" y="665163"/>
              <a:ext cx="536575" cy="844550"/>
            </a:xfrm>
            <a:custGeom>
              <a:avLst/>
              <a:gdLst>
                <a:gd name="T0" fmla="*/ 12 w 282"/>
                <a:gd name="T1" fmla="*/ 404 h 444"/>
                <a:gd name="T2" fmla="*/ 49 w 282"/>
                <a:gd name="T3" fmla="*/ 419 h 444"/>
                <a:gd name="T4" fmla="*/ 109 w 282"/>
                <a:gd name="T5" fmla="*/ 363 h 444"/>
                <a:gd name="T6" fmla="*/ 131 w 282"/>
                <a:gd name="T7" fmla="*/ 311 h 444"/>
                <a:gd name="T8" fmla="*/ 5 w 282"/>
                <a:gd name="T9" fmla="*/ 0 h 444"/>
                <a:gd name="T10" fmla="*/ 32 w 282"/>
                <a:gd name="T11" fmla="*/ 0 h 444"/>
                <a:gd name="T12" fmla="*/ 132 w 282"/>
                <a:gd name="T13" fmla="*/ 250 h 444"/>
                <a:gd name="T14" fmla="*/ 143 w 282"/>
                <a:gd name="T15" fmla="*/ 279 h 444"/>
                <a:gd name="T16" fmla="*/ 144 w 282"/>
                <a:gd name="T17" fmla="*/ 279 h 444"/>
                <a:gd name="T18" fmla="*/ 155 w 282"/>
                <a:gd name="T19" fmla="*/ 250 h 444"/>
                <a:gd name="T20" fmla="*/ 255 w 282"/>
                <a:gd name="T21" fmla="*/ 0 h 444"/>
                <a:gd name="T22" fmla="*/ 282 w 282"/>
                <a:gd name="T23" fmla="*/ 0 h 444"/>
                <a:gd name="T24" fmla="*/ 126 w 282"/>
                <a:gd name="T25" fmla="*/ 386 h 444"/>
                <a:gd name="T26" fmla="*/ 49 w 282"/>
                <a:gd name="T27" fmla="*/ 444 h 444"/>
                <a:gd name="T28" fmla="*/ 0 w 282"/>
                <a:gd name="T29" fmla="*/ 426 h 444"/>
                <a:gd name="T30" fmla="*/ 12 w 282"/>
                <a:gd name="T31" fmla="*/ 404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82" h="444">
                  <a:moveTo>
                    <a:pt x="12" y="404"/>
                  </a:moveTo>
                  <a:cubicBezTo>
                    <a:pt x="12" y="404"/>
                    <a:pt x="29" y="419"/>
                    <a:pt x="49" y="419"/>
                  </a:cubicBezTo>
                  <a:cubicBezTo>
                    <a:pt x="78" y="419"/>
                    <a:pt x="97" y="392"/>
                    <a:pt x="109" y="363"/>
                  </a:cubicBezTo>
                  <a:cubicBezTo>
                    <a:pt x="131" y="311"/>
                    <a:pt x="131" y="311"/>
                    <a:pt x="131" y="311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2" y="0"/>
                    <a:pt x="32" y="0"/>
                    <a:pt x="32" y="0"/>
                  </a:cubicBezTo>
                  <a:cubicBezTo>
                    <a:pt x="132" y="250"/>
                    <a:pt x="132" y="250"/>
                    <a:pt x="132" y="250"/>
                  </a:cubicBezTo>
                  <a:cubicBezTo>
                    <a:pt x="138" y="264"/>
                    <a:pt x="143" y="279"/>
                    <a:pt x="143" y="279"/>
                  </a:cubicBezTo>
                  <a:cubicBezTo>
                    <a:pt x="144" y="279"/>
                    <a:pt x="144" y="279"/>
                    <a:pt x="144" y="279"/>
                  </a:cubicBezTo>
                  <a:cubicBezTo>
                    <a:pt x="144" y="279"/>
                    <a:pt x="149" y="264"/>
                    <a:pt x="155" y="25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82" y="0"/>
                    <a:pt x="282" y="0"/>
                    <a:pt x="282" y="0"/>
                  </a:cubicBezTo>
                  <a:cubicBezTo>
                    <a:pt x="126" y="386"/>
                    <a:pt x="126" y="386"/>
                    <a:pt x="126" y="386"/>
                  </a:cubicBezTo>
                  <a:cubicBezTo>
                    <a:pt x="113" y="418"/>
                    <a:pt x="88" y="444"/>
                    <a:pt x="49" y="444"/>
                  </a:cubicBezTo>
                  <a:cubicBezTo>
                    <a:pt x="20" y="444"/>
                    <a:pt x="0" y="426"/>
                    <a:pt x="0" y="426"/>
                  </a:cubicBezTo>
                  <a:lnTo>
                    <a:pt x="12" y="404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F91B1662-560F-784A-9FD6-EEEF6D1BDF4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963026" y="644526"/>
              <a:ext cx="552450" cy="854075"/>
            </a:xfrm>
            <a:custGeom>
              <a:avLst/>
              <a:gdLst>
                <a:gd name="T0" fmla="*/ 143 w 291"/>
                <a:gd name="T1" fmla="*/ 279 h 449"/>
                <a:gd name="T2" fmla="*/ 231 w 291"/>
                <a:gd name="T3" fmla="*/ 166 h 449"/>
                <a:gd name="T4" fmla="*/ 145 w 291"/>
                <a:gd name="T5" fmla="*/ 53 h 449"/>
                <a:gd name="T6" fmla="*/ 57 w 291"/>
                <a:gd name="T7" fmla="*/ 167 h 449"/>
                <a:gd name="T8" fmla="*/ 143 w 291"/>
                <a:gd name="T9" fmla="*/ 279 h 449"/>
                <a:gd name="T10" fmla="*/ 0 w 291"/>
                <a:gd name="T11" fmla="*/ 7 h 449"/>
                <a:gd name="T12" fmla="*/ 54 w 291"/>
                <a:gd name="T13" fmla="*/ 7 h 449"/>
                <a:gd name="T14" fmla="*/ 54 w 291"/>
                <a:gd name="T15" fmla="*/ 34 h 449"/>
                <a:gd name="T16" fmla="*/ 52 w 291"/>
                <a:gd name="T17" fmla="*/ 57 h 449"/>
                <a:gd name="T18" fmla="*/ 54 w 291"/>
                <a:gd name="T19" fmla="*/ 57 h 449"/>
                <a:gd name="T20" fmla="*/ 156 w 291"/>
                <a:gd name="T21" fmla="*/ 0 h 449"/>
                <a:gd name="T22" fmla="*/ 291 w 291"/>
                <a:gd name="T23" fmla="*/ 165 h 449"/>
                <a:gd name="T24" fmla="*/ 152 w 291"/>
                <a:gd name="T25" fmla="*/ 331 h 449"/>
                <a:gd name="T26" fmla="*/ 58 w 291"/>
                <a:gd name="T27" fmla="*/ 279 h 449"/>
                <a:gd name="T28" fmla="*/ 57 w 291"/>
                <a:gd name="T29" fmla="*/ 279 h 449"/>
                <a:gd name="T30" fmla="*/ 58 w 291"/>
                <a:gd name="T31" fmla="*/ 307 h 449"/>
                <a:gd name="T32" fmla="*/ 58 w 291"/>
                <a:gd name="T33" fmla="*/ 449 h 449"/>
                <a:gd name="T34" fmla="*/ 0 w 291"/>
                <a:gd name="T35" fmla="*/ 449 h 449"/>
                <a:gd name="T36" fmla="*/ 0 w 291"/>
                <a:gd name="T37" fmla="*/ 7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91" h="449">
                  <a:moveTo>
                    <a:pt x="143" y="279"/>
                  </a:moveTo>
                  <a:cubicBezTo>
                    <a:pt x="192" y="279"/>
                    <a:pt x="231" y="238"/>
                    <a:pt x="231" y="166"/>
                  </a:cubicBezTo>
                  <a:cubicBezTo>
                    <a:pt x="231" y="97"/>
                    <a:pt x="196" y="53"/>
                    <a:pt x="145" y="53"/>
                  </a:cubicBezTo>
                  <a:cubicBezTo>
                    <a:pt x="99" y="53"/>
                    <a:pt x="57" y="86"/>
                    <a:pt x="57" y="167"/>
                  </a:cubicBezTo>
                  <a:cubicBezTo>
                    <a:pt x="57" y="223"/>
                    <a:pt x="87" y="279"/>
                    <a:pt x="143" y="279"/>
                  </a:cubicBezTo>
                  <a:moveTo>
                    <a:pt x="0" y="7"/>
                  </a:moveTo>
                  <a:cubicBezTo>
                    <a:pt x="54" y="7"/>
                    <a:pt x="54" y="7"/>
                    <a:pt x="54" y="7"/>
                  </a:cubicBezTo>
                  <a:cubicBezTo>
                    <a:pt x="54" y="34"/>
                    <a:pt x="54" y="34"/>
                    <a:pt x="54" y="34"/>
                  </a:cubicBezTo>
                  <a:cubicBezTo>
                    <a:pt x="54" y="47"/>
                    <a:pt x="52" y="57"/>
                    <a:pt x="52" y="57"/>
                  </a:cubicBezTo>
                  <a:cubicBezTo>
                    <a:pt x="54" y="57"/>
                    <a:pt x="54" y="57"/>
                    <a:pt x="54" y="57"/>
                  </a:cubicBezTo>
                  <a:cubicBezTo>
                    <a:pt x="54" y="57"/>
                    <a:pt x="80" y="0"/>
                    <a:pt x="156" y="0"/>
                  </a:cubicBezTo>
                  <a:cubicBezTo>
                    <a:pt x="239" y="0"/>
                    <a:pt x="291" y="67"/>
                    <a:pt x="291" y="165"/>
                  </a:cubicBezTo>
                  <a:cubicBezTo>
                    <a:pt x="291" y="266"/>
                    <a:pt x="232" y="331"/>
                    <a:pt x="152" y="331"/>
                  </a:cubicBezTo>
                  <a:cubicBezTo>
                    <a:pt x="85" y="331"/>
                    <a:pt x="58" y="279"/>
                    <a:pt x="58" y="279"/>
                  </a:cubicBezTo>
                  <a:cubicBezTo>
                    <a:pt x="57" y="279"/>
                    <a:pt x="57" y="279"/>
                    <a:pt x="57" y="279"/>
                  </a:cubicBezTo>
                  <a:cubicBezTo>
                    <a:pt x="57" y="279"/>
                    <a:pt x="58" y="290"/>
                    <a:pt x="58" y="307"/>
                  </a:cubicBezTo>
                  <a:cubicBezTo>
                    <a:pt x="58" y="449"/>
                    <a:pt x="58" y="449"/>
                    <a:pt x="58" y="449"/>
                  </a:cubicBezTo>
                  <a:cubicBezTo>
                    <a:pt x="0" y="449"/>
                    <a:pt x="0" y="449"/>
                    <a:pt x="0" y="449"/>
                  </a:cubicBezTo>
                  <a:lnTo>
                    <a:pt x="0" y="7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731D26DC-F3E8-9E45-B015-D6F78AE1DF1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561513" y="644526"/>
              <a:ext cx="485775" cy="630238"/>
            </a:xfrm>
            <a:custGeom>
              <a:avLst/>
              <a:gdLst>
                <a:gd name="T0" fmla="*/ 116 w 256"/>
                <a:gd name="T1" fmla="*/ 282 h 331"/>
                <a:gd name="T2" fmla="*/ 198 w 256"/>
                <a:gd name="T3" fmla="*/ 182 h 331"/>
                <a:gd name="T4" fmla="*/ 198 w 256"/>
                <a:gd name="T5" fmla="*/ 172 h 331"/>
                <a:gd name="T6" fmla="*/ 183 w 256"/>
                <a:gd name="T7" fmla="*/ 172 h 331"/>
                <a:gd name="T8" fmla="*/ 59 w 256"/>
                <a:gd name="T9" fmla="*/ 232 h 331"/>
                <a:gd name="T10" fmla="*/ 116 w 256"/>
                <a:gd name="T11" fmla="*/ 282 h 331"/>
                <a:gd name="T12" fmla="*/ 184 w 256"/>
                <a:gd name="T13" fmla="*/ 126 h 331"/>
                <a:gd name="T14" fmla="*/ 198 w 256"/>
                <a:gd name="T15" fmla="*/ 126 h 331"/>
                <a:gd name="T16" fmla="*/ 198 w 256"/>
                <a:gd name="T17" fmla="*/ 120 h 331"/>
                <a:gd name="T18" fmla="*/ 130 w 256"/>
                <a:gd name="T19" fmla="*/ 51 h 331"/>
                <a:gd name="T20" fmla="*/ 45 w 256"/>
                <a:gd name="T21" fmla="*/ 82 h 331"/>
                <a:gd name="T22" fmla="*/ 21 w 256"/>
                <a:gd name="T23" fmla="*/ 37 h 331"/>
                <a:gd name="T24" fmla="*/ 135 w 256"/>
                <a:gd name="T25" fmla="*/ 0 h 331"/>
                <a:gd name="T26" fmla="*/ 256 w 256"/>
                <a:gd name="T27" fmla="*/ 124 h 331"/>
                <a:gd name="T28" fmla="*/ 256 w 256"/>
                <a:gd name="T29" fmla="*/ 324 h 331"/>
                <a:gd name="T30" fmla="*/ 202 w 256"/>
                <a:gd name="T31" fmla="*/ 324 h 331"/>
                <a:gd name="T32" fmla="*/ 202 w 256"/>
                <a:gd name="T33" fmla="*/ 294 h 331"/>
                <a:gd name="T34" fmla="*/ 203 w 256"/>
                <a:gd name="T35" fmla="*/ 269 h 331"/>
                <a:gd name="T36" fmla="*/ 202 w 256"/>
                <a:gd name="T37" fmla="*/ 269 h 331"/>
                <a:gd name="T38" fmla="*/ 104 w 256"/>
                <a:gd name="T39" fmla="*/ 331 h 331"/>
                <a:gd name="T40" fmla="*/ 0 w 256"/>
                <a:gd name="T41" fmla="*/ 235 h 331"/>
                <a:gd name="T42" fmla="*/ 184 w 256"/>
                <a:gd name="T43" fmla="*/ 126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56" h="331">
                  <a:moveTo>
                    <a:pt x="116" y="282"/>
                  </a:moveTo>
                  <a:cubicBezTo>
                    <a:pt x="166" y="282"/>
                    <a:pt x="198" y="229"/>
                    <a:pt x="198" y="182"/>
                  </a:cubicBezTo>
                  <a:cubicBezTo>
                    <a:pt x="198" y="172"/>
                    <a:pt x="198" y="172"/>
                    <a:pt x="198" y="172"/>
                  </a:cubicBezTo>
                  <a:cubicBezTo>
                    <a:pt x="183" y="172"/>
                    <a:pt x="183" y="172"/>
                    <a:pt x="183" y="172"/>
                  </a:cubicBezTo>
                  <a:cubicBezTo>
                    <a:pt x="139" y="172"/>
                    <a:pt x="59" y="175"/>
                    <a:pt x="59" y="232"/>
                  </a:cubicBezTo>
                  <a:cubicBezTo>
                    <a:pt x="59" y="257"/>
                    <a:pt x="78" y="282"/>
                    <a:pt x="116" y="282"/>
                  </a:cubicBezTo>
                  <a:moveTo>
                    <a:pt x="184" y="126"/>
                  </a:moveTo>
                  <a:cubicBezTo>
                    <a:pt x="198" y="126"/>
                    <a:pt x="198" y="126"/>
                    <a:pt x="198" y="126"/>
                  </a:cubicBezTo>
                  <a:cubicBezTo>
                    <a:pt x="198" y="120"/>
                    <a:pt x="198" y="120"/>
                    <a:pt x="198" y="120"/>
                  </a:cubicBezTo>
                  <a:cubicBezTo>
                    <a:pt x="198" y="68"/>
                    <a:pt x="169" y="51"/>
                    <a:pt x="130" y="51"/>
                  </a:cubicBezTo>
                  <a:cubicBezTo>
                    <a:pt x="83" y="51"/>
                    <a:pt x="45" y="82"/>
                    <a:pt x="45" y="82"/>
                  </a:cubicBezTo>
                  <a:cubicBezTo>
                    <a:pt x="21" y="37"/>
                    <a:pt x="21" y="37"/>
                    <a:pt x="21" y="37"/>
                  </a:cubicBezTo>
                  <a:cubicBezTo>
                    <a:pt x="21" y="37"/>
                    <a:pt x="65" y="0"/>
                    <a:pt x="135" y="0"/>
                  </a:cubicBezTo>
                  <a:cubicBezTo>
                    <a:pt x="213" y="0"/>
                    <a:pt x="256" y="44"/>
                    <a:pt x="256" y="124"/>
                  </a:cubicBezTo>
                  <a:cubicBezTo>
                    <a:pt x="256" y="324"/>
                    <a:pt x="256" y="324"/>
                    <a:pt x="256" y="324"/>
                  </a:cubicBezTo>
                  <a:cubicBezTo>
                    <a:pt x="202" y="324"/>
                    <a:pt x="202" y="324"/>
                    <a:pt x="202" y="324"/>
                  </a:cubicBezTo>
                  <a:cubicBezTo>
                    <a:pt x="202" y="294"/>
                    <a:pt x="202" y="294"/>
                    <a:pt x="202" y="294"/>
                  </a:cubicBezTo>
                  <a:cubicBezTo>
                    <a:pt x="202" y="279"/>
                    <a:pt x="203" y="269"/>
                    <a:pt x="203" y="269"/>
                  </a:cubicBezTo>
                  <a:cubicBezTo>
                    <a:pt x="202" y="269"/>
                    <a:pt x="202" y="269"/>
                    <a:pt x="202" y="269"/>
                  </a:cubicBezTo>
                  <a:cubicBezTo>
                    <a:pt x="202" y="269"/>
                    <a:pt x="177" y="331"/>
                    <a:pt x="104" y="331"/>
                  </a:cubicBezTo>
                  <a:cubicBezTo>
                    <a:pt x="51" y="331"/>
                    <a:pt x="0" y="298"/>
                    <a:pt x="0" y="235"/>
                  </a:cubicBezTo>
                  <a:cubicBezTo>
                    <a:pt x="0" y="130"/>
                    <a:pt x="133" y="126"/>
                    <a:pt x="184" y="126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8FAA521A-968C-CD4B-8A59-CAF7F55FA21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04438" y="492126"/>
              <a:ext cx="338138" cy="773113"/>
            </a:xfrm>
            <a:custGeom>
              <a:avLst/>
              <a:gdLst>
                <a:gd name="T0" fmla="*/ 40 w 178"/>
                <a:gd name="T1" fmla="*/ 140 h 406"/>
                <a:gd name="T2" fmla="*/ 0 w 178"/>
                <a:gd name="T3" fmla="*/ 140 h 406"/>
                <a:gd name="T4" fmla="*/ 0 w 178"/>
                <a:gd name="T5" fmla="*/ 92 h 406"/>
                <a:gd name="T6" fmla="*/ 42 w 178"/>
                <a:gd name="T7" fmla="*/ 92 h 406"/>
                <a:gd name="T8" fmla="*/ 42 w 178"/>
                <a:gd name="T9" fmla="*/ 0 h 406"/>
                <a:gd name="T10" fmla="*/ 99 w 178"/>
                <a:gd name="T11" fmla="*/ 0 h 406"/>
                <a:gd name="T12" fmla="*/ 99 w 178"/>
                <a:gd name="T13" fmla="*/ 92 h 406"/>
                <a:gd name="T14" fmla="*/ 173 w 178"/>
                <a:gd name="T15" fmla="*/ 92 h 406"/>
                <a:gd name="T16" fmla="*/ 173 w 178"/>
                <a:gd name="T17" fmla="*/ 140 h 406"/>
                <a:gd name="T18" fmla="*/ 99 w 178"/>
                <a:gd name="T19" fmla="*/ 140 h 406"/>
                <a:gd name="T20" fmla="*/ 99 w 178"/>
                <a:gd name="T21" fmla="*/ 281 h 406"/>
                <a:gd name="T22" fmla="*/ 164 w 178"/>
                <a:gd name="T23" fmla="*/ 352 h 406"/>
                <a:gd name="T24" fmla="*/ 178 w 178"/>
                <a:gd name="T25" fmla="*/ 351 h 406"/>
                <a:gd name="T26" fmla="*/ 178 w 178"/>
                <a:gd name="T27" fmla="*/ 405 h 406"/>
                <a:gd name="T28" fmla="*/ 158 w 178"/>
                <a:gd name="T29" fmla="*/ 406 h 406"/>
                <a:gd name="T30" fmla="*/ 40 w 178"/>
                <a:gd name="T31" fmla="*/ 288 h 406"/>
                <a:gd name="T32" fmla="*/ 40 w 178"/>
                <a:gd name="T33" fmla="*/ 140 h 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8" h="406">
                  <a:moveTo>
                    <a:pt x="40" y="140"/>
                  </a:moveTo>
                  <a:cubicBezTo>
                    <a:pt x="0" y="140"/>
                    <a:pt x="0" y="140"/>
                    <a:pt x="0" y="140"/>
                  </a:cubicBezTo>
                  <a:cubicBezTo>
                    <a:pt x="0" y="92"/>
                    <a:pt x="0" y="92"/>
                    <a:pt x="0" y="92"/>
                  </a:cubicBezTo>
                  <a:cubicBezTo>
                    <a:pt x="42" y="92"/>
                    <a:pt x="42" y="92"/>
                    <a:pt x="42" y="92"/>
                  </a:cubicBezTo>
                  <a:cubicBezTo>
                    <a:pt x="42" y="0"/>
                    <a:pt x="42" y="0"/>
                    <a:pt x="42" y="0"/>
                  </a:cubicBezTo>
                  <a:cubicBezTo>
                    <a:pt x="99" y="0"/>
                    <a:pt x="99" y="0"/>
                    <a:pt x="99" y="0"/>
                  </a:cubicBezTo>
                  <a:cubicBezTo>
                    <a:pt x="99" y="92"/>
                    <a:pt x="99" y="92"/>
                    <a:pt x="99" y="92"/>
                  </a:cubicBezTo>
                  <a:cubicBezTo>
                    <a:pt x="173" y="92"/>
                    <a:pt x="173" y="92"/>
                    <a:pt x="173" y="92"/>
                  </a:cubicBezTo>
                  <a:cubicBezTo>
                    <a:pt x="173" y="140"/>
                    <a:pt x="173" y="140"/>
                    <a:pt x="173" y="140"/>
                  </a:cubicBezTo>
                  <a:cubicBezTo>
                    <a:pt x="99" y="140"/>
                    <a:pt x="99" y="140"/>
                    <a:pt x="99" y="140"/>
                  </a:cubicBezTo>
                  <a:cubicBezTo>
                    <a:pt x="99" y="281"/>
                    <a:pt x="99" y="281"/>
                    <a:pt x="99" y="281"/>
                  </a:cubicBezTo>
                  <a:cubicBezTo>
                    <a:pt x="99" y="344"/>
                    <a:pt x="142" y="352"/>
                    <a:pt x="164" y="352"/>
                  </a:cubicBezTo>
                  <a:cubicBezTo>
                    <a:pt x="173" y="352"/>
                    <a:pt x="178" y="351"/>
                    <a:pt x="178" y="351"/>
                  </a:cubicBezTo>
                  <a:cubicBezTo>
                    <a:pt x="178" y="405"/>
                    <a:pt x="178" y="405"/>
                    <a:pt x="178" y="405"/>
                  </a:cubicBezTo>
                  <a:cubicBezTo>
                    <a:pt x="178" y="405"/>
                    <a:pt x="170" y="406"/>
                    <a:pt x="158" y="406"/>
                  </a:cubicBezTo>
                  <a:cubicBezTo>
                    <a:pt x="118" y="406"/>
                    <a:pt x="40" y="394"/>
                    <a:pt x="40" y="288"/>
                  </a:cubicBezTo>
                  <a:lnTo>
                    <a:pt x="40" y="14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13ED5A3D-4D5E-7346-8599-9BFFDD3FA12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509251" y="419101"/>
              <a:ext cx="111125" cy="841375"/>
            </a:xfrm>
            <a:custGeom>
              <a:avLst/>
              <a:gdLst>
                <a:gd name="T0" fmla="*/ 1 w 70"/>
                <a:gd name="T1" fmla="*/ 150 h 530"/>
                <a:gd name="T2" fmla="*/ 70 w 70"/>
                <a:gd name="T3" fmla="*/ 150 h 530"/>
                <a:gd name="T4" fmla="*/ 70 w 70"/>
                <a:gd name="T5" fmla="*/ 530 h 530"/>
                <a:gd name="T6" fmla="*/ 1 w 70"/>
                <a:gd name="T7" fmla="*/ 530 h 530"/>
                <a:gd name="T8" fmla="*/ 1 w 70"/>
                <a:gd name="T9" fmla="*/ 150 h 530"/>
                <a:gd name="T10" fmla="*/ 0 w 70"/>
                <a:gd name="T11" fmla="*/ 0 h 530"/>
                <a:gd name="T12" fmla="*/ 70 w 70"/>
                <a:gd name="T13" fmla="*/ 0 h 530"/>
                <a:gd name="T14" fmla="*/ 70 w 70"/>
                <a:gd name="T15" fmla="*/ 75 h 530"/>
                <a:gd name="T16" fmla="*/ 0 w 70"/>
                <a:gd name="T17" fmla="*/ 75 h 530"/>
                <a:gd name="T18" fmla="*/ 0 w 70"/>
                <a:gd name="T19" fmla="*/ 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70" h="530">
                  <a:moveTo>
                    <a:pt x="1" y="150"/>
                  </a:moveTo>
                  <a:lnTo>
                    <a:pt x="70" y="150"/>
                  </a:lnTo>
                  <a:lnTo>
                    <a:pt x="70" y="530"/>
                  </a:lnTo>
                  <a:lnTo>
                    <a:pt x="1" y="530"/>
                  </a:lnTo>
                  <a:lnTo>
                    <a:pt x="1" y="150"/>
                  </a:lnTo>
                  <a:close/>
                  <a:moveTo>
                    <a:pt x="0" y="0"/>
                  </a:moveTo>
                  <a:lnTo>
                    <a:pt x="70" y="0"/>
                  </a:lnTo>
                  <a:lnTo>
                    <a:pt x="70" y="75"/>
                  </a:lnTo>
                  <a:lnTo>
                    <a:pt x="0" y="75"/>
                  </a:ln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8C3D4942-1EFE-9541-BB74-62E866748C5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712451" y="644526"/>
              <a:ext cx="542925" cy="630238"/>
            </a:xfrm>
            <a:custGeom>
              <a:avLst/>
              <a:gdLst>
                <a:gd name="T0" fmla="*/ 226 w 286"/>
                <a:gd name="T1" fmla="*/ 129 h 331"/>
                <a:gd name="T2" fmla="*/ 152 w 286"/>
                <a:gd name="T3" fmla="*/ 48 h 331"/>
                <a:gd name="T4" fmla="*/ 63 w 286"/>
                <a:gd name="T5" fmla="*/ 129 h 331"/>
                <a:gd name="T6" fmla="*/ 226 w 286"/>
                <a:gd name="T7" fmla="*/ 129 h 331"/>
                <a:gd name="T8" fmla="*/ 153 w 286"/>
                <a:gd name="T9" fmla="*/ 0 h 331"/>
                <a:gd name="T10" fmla="*/ 286 w 286"/>
                <a:gd name="T11" fmla="*/ 148 h 331"/>
                <a:gd name="T12" fmla="*/ 284 w 286"/>
                <a:gd name="T13" fmla="*/ 174 h 331"/>
                <a:gd name="T14" fmla="*/ 61 w 286"/>
                <a:gd name="T15" fmla="*/ 174 h 331"/>
                <a:gd name="T16" fmla="*/ 166 w 286"/>
                <a:gd name="T17" fmla="*/ 279 h 331"/>
                <a:gd name="T18" fmla="*/ 257 w 286"/>
                <a:gd name="T19" fmla="*/ 242 h 331"/>
                <a:gd name="T20" fmla="*/ 281 w 286"/>
                <a:gd name="T21" fmla="*/ 286 h 331"/>
                <a:gd name="T22" fmla="*/ 162 w 286"/>
                <a:gd name="T23" fmla="*/ 331 h 331"/>
                <a:gd name="T24" fmla="*/ 0 w 286"/>
                <a:gd name="T25" fmla="*/ 165 h 331"/>
                <a:gd name="T26" fmla="*/ 153 w 286"/>
                <a:gd name="T27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86" h="331">
                  <a:moveTo>
                    <a:pt x="226" y="129"/>
                  </a:moveTo>
                  <a:cubicBezTo>
                    <a:pt x="224" y="74"/>
                    <a:pt x="192" y="48"/>
                    <a:pt x="152" y="48"/>
                  </a:cubicBezTo>
                  <a:cubicBezTo>
                    <a:pt x="107" y="48"/>
                    <a:pt x="71" y="77"/>
                    <a:pt x="63" y="129"/>
                  </a:cubicBezTo>
                  <a:lnTo>
                    <a:pt x="226" y="129"/>
                  </a:lnTo>
                  <a:close/>
                  <a:moveTo>
                    <a:pt x="153" y="0"/>
                  </a:moveTo>
                  <a:cubicBezTo>
                    <a:pt x="240" y="0"/>
                    <a:pt x="286" y="66"/>
                    <a:pt x="286" y="148"/>
                  </a:cubicBezTo>
                  <a:cubicBezTo>
                    <a:pt x="286" y="156"/>
                    <a:pt x="284" y="174"/>
                    <a:pt x="284" y="174"/>
                  </a:cubicBezTo>
                  <a:cubicBezTo>
                    <a:pt x="61" y="174"/>
                    <a:pt x="61" y="174"/>
                    <a:pt x="61" y="174"/>
                  </a:cubicBezTo>
                  <a:cubicBezTo>
                    <a:pt x="64" y="244"/>
                    <a:pt x="112" y="279"/>
                    <a:pt x="166" y="279"/>
                  </a:cubicBezTo>
                  <a:cubicBezTo>
                    <a:pt x="219" y="279"/>
                    <a:pt x="257" y="242"/>
                    <a:pt x="257" y="242"/>
                  </a:cubicBezTo>
                  <a:cubicBezTo>
                    <a:pt x="281" y="286"/>
                    <a:pt x="281" y="286"/>
                    <a:pt x="281" y="286"/>
                  </a:cubicBezTo>
                  <a:cubicBezTo>
                    <a:pt x="281" y="286"/>
                    <a:pt x="236" y="331"/>
                    <a:pt x="162" y="331"/>
                  </a:cubicBezTo>
                  <a:cubicBezTo>
                    <a:pt x="66" y="331"/>
                    <a:pt x="0" y="259"/>
                    <a:pt x="0" y="165"/>
                  </a:cubicBezTo>
                  <a:cubicBezTo>
                    <a:pt x="0" y="65"/>
                    <a:pt x="66" y="0"/>
                    <a:pt x="153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08097239-3B22-A84D-A6DF-2CD8DE9C63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0626" y="644526"/>
              <a:ext cx="527050" cy="615950"/>
            </a:xfrm>
            <a:custGeom>
              <a:avLst/>
              <a:gdLst>
                <a:gd name="T0" fmla="*/ 0 w 277"/>
                <a:gd name="T1" fmla="*/ 7 h 324"/>
                <a:gd name="T2" fmla="*/ 56 w 277"/>
                <a:gd name="T3" fmla="*/ 7 h 324"/>
                <a:gd name="T4" fmla="*/ 56 w 277"/>
                <a:gd name="T5" fmla="*/ 49 h 324"/>
                <a:gd name="T6" fmla="*/ 55 w 277"/>
                <a:gd name="T7" fmla="*/ 72 h 324"/>
                <a:gd name="T8" fmla="*/ 56 w 277"/>
                <a:gd name="T9" fmla="*/ 72 h 324"/>
                <a:gd name="T10" fmla="*/ 171 w 277"/>
                <a:gd name="T11" fmla="*/ 0 h 324"/>
                <a:gd name="T12" fmla="*/ 277 w 277"/>
                <a:gd name="T13" fmla="*/ 121 h 324"/>
                <a:gd name="T14" fmla="*/ 277 w 277"/>
                <a:gd name="T15" fmla="*/ 324 h 324"/>
                <a:gd name="T16" fmla="*/ 218 w 277"/>
                <a:gd name="T17" fmla="*/ 324 h 324"/>
                <a:gd name="T18" fmla="*/ 218 w 277"/>
                <a:gd name="T19" fmla="*/ 135 h 324"/>
                <a:gd name="T20" fmla="*/ 160 w 277"/>
                <a:gd name="T21" fmla="*/ 55 h 324"/>
                <a:gd name="T22" fmla="*/ 63 w 277"/>
                <a:gd name="T23" fmla="*/ 133 h 324"/>
                <a:gd name="T24" fmla="*/ 58 w 277"/>
                <a:gd name="T25" fmla="*/ 175 h 324"/>
                <a:gd name="T26" fmla="*/ 58 w 277"/>
                <a:gd name="T27" fmla="*/ 324 h 324"/>
                <a:gd name="T28" fmla="*/ 0 w 277"/>
                <a:gd name="T29" fmla="*/ 324 h 324"/>
                <a:gd name="T30" fmla="*/ 0 w 277"/>
                <a:gd name="T31" fmla="*/ 7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77" h="324">
                  <a:moveTo>
                    <a:pt x="0" y="7"/>
                  </a:moveTo>
                  <a:cubicBezTo>
                    <a:pt x="56" y="7"/>
                    <a:pt x="56" y="7"/>
                    <a:pt x="56" y="7"/>
                  </a:cubicBezTo>
                  <a:cubicBezTo>
                    <a:pt x="56" y="49"/>
                    <a:pt x="56" y="49"/>
                    <a:pt x="56" y="49"/>
                  </a:cubicBezTo>
                  <a:cubicBezTo>
                    <a:pt x="56" y="62"/>
                    <a:pt x="55" y="72"/>
                    <a:pt x="55" y="72"/>
                  </a:cubicBezTo>
                  <a:cubicBezTo>
                    <a:pt x="56" y="72"/>
                    <a:pt x="56" y="72"/>
                    <a:pt x="56" y="72"/>
                  </a:cubicBezTo>
                  <a:cubicBezTo>
                    <a:pt x="69" y="45"/>
                    <a:pt x="105" y="0"/>
                    <a:pt x="171" y="0"/>
                  </a:cubicBezTo>
                  <a:cubicBezTo>
                    <a:pt x="243" y="0"/>
                    <a:pt x="277" y="40"/>
                    <a:pt x="277" y="121"/>
                  </a:cubicBezTo>
                  <a:cubicBezTo>
                    <a:pt x="277" y="324"/>
                    <a:pt x="277" y="324"/>
                    <a:pt x="277" y="324"/>
                  </a:cubicBezTo>
                  <a:cubicBezTo>
                    <a:pt x="218" y="324"/>
                    <a:pt x="218" y="324"/>
                    <a:pt x="218" y="324"/>
                  </a:cubicBezTo>
                  <a:cubicBezTo>
                    <a:pt x="218" y="135"/>
                    <a:pt x="218" y="135"/>
                    <a:pt x="218" y="135"/>
                  </a:cubicBezTo>
                  <a:cubicBezTo>
                    <a:pt x="218" y="90"/>
                    <a:pt x="209" y="55"/>
                    <a:pt x="160" y="55"/>
                  </a:cubicBezTo>
                  <a:cubicBezTo>
                    <a:pt x="113" y="55"/>
                    <a:pt x="76" y="87"/>
                    <a:pt x="63" y="133"/>
                  </a:cubicBezTo>
                  <a:cubicBezTo>
                    <a:pt x="59" y="145"/>
                    <a:pt x="58" y="160"/>
                    <a:pt x="58" y="175"/>
                  </a:cubicBezTo>
                  <a:cubicBezTo>
                    <a:pt x="58" y="324"/>
                    <a:pt x="58" y="324"/>
                    <a:pt x="58" y="324"/>
                  </a:cubicBezTo>
                  <a:cubicBezTo>
                    <a:pt x="0" y="324"/>
                    <a:pt x="0" y="324"/>
                    <a:pt x="0" y="324"/>
                  </a:cubicBezTo>
                  <a:lnTo>
                    <a:pt x="0" y="7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BC1B8998-5FD2-5747-8943-5A87313043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33238" y="492126"/>
              <a:ext cx="339725" cy="773113"/>
            </a:xfrm>
            <a:custGeom>
              <a:avLst/>
              <a:gdLst>
                <a:gd name="T0" fmla="*/ 40 w 178"/>
                <a:gd name="T1" fmla="*/ 140 h 406"/>
                <a:gd name="T2" fmla="*/ 0 w 178"/>
                <a:gd name="T3" fmla="*/ 140 h 406"/>
                <a:gd name="T4" fmla="*/ 0 w 178"/>
                <a:gd name="T5" fmla="*/ 92 h 406"/>
                <a:gd name="T6" fmla="*/ 41 w 178"/>
                <a:gd name="T7" fmla="*/ 92 h 406"/>
                <a:gd name="T8" fmla="*/ 41 w 178"/>
                <a:gd name="T9" fmla="*/ 0 h 406"/>
                <a:gd name="T10" fmla="*/ 98 w 178"/>
                <a:gd name="T11" fmla="*/ 0 h 406"/>
                <a:gd name="T12" fmla="*/ 98 w 178"/>
                <a:gd name="T13" fmla="*/ 92 h 406"/>
                <a:gd name="T14" fmla="*/ 172 w 178"/>
                <a:gd name="T15" fmla="*/ 92 h 406"/>
                <a:gd name="T16" fmla="*/ 172 w 178"/>
                <a:gd name="T17" fmla="*/ 140 h 406"/>
                <a:gd name="T18" fmla="*/ 98 w 178"/>
                <a:gd name="T19" fmla="*/ 140 h 406"/>
                <a:gd name="T20" fmla="*/ 98 w 178"/>
                <a:gd name="T21" fmla="*/ 281 h 406"/>
                <a:gd name="T22" fmla="*/ 164 w 178"/>
                <a:gd name="T23" fmla="*/ 352 h 406"/>
                <a:gd name="T24" fmla="*/ 178 w 178"/>
                <a:gd name="T25" fmla="*/ 351 h 406"/>
                <a:gd name="T26" fmla="*/ 178 w 178"/>
                <a:gd name="T27" fmla="*/ 405 h 406"/>
                <a:gd name="T28" fmla="*/ 157 w 178"/>
                <a:gd name="T29" fmla="*/ 406 h 406"/>
                <a:gd name="T30" fmla="*/ 40 w 178"/>
                <a:gd name="T31" fmla="*/ 288 h 406"/>
                <a:gd name="T32" fmla="*/ 40 w 178"/>
                <a:gd name="T33" fmla="*/ 140 h 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8" h="406">
                  <a:moveTo>
                    <a:pt x="40" y="140"/>
                  </a:moveTo>
                  <a:cubicBezTo>
                    <a:pt x="0" y="140"/>
                    <a:pt x="0" y="140"/>
                    <a:pt x="0" y="140"/>
                  </a:cubicBezTo>
                  <a:cubicBezTo>
                    <a:pt x="0" y="92"/>
                    <a:pt x="0" y="92"/>
                    <a:pt x="0" y="92"/>
                  </a:cubicBezTo>
                  <a:cubicBezTo>
                    <a:pt x="41" y="92"/>
                    <a:pt x="41" y="92"/>
                    <a:pt x="41" y="92"/>
                  </a:cubicBezTo>
                  <a:cubicBezTo>
                    <a:pt x="41" y="0"/>
                    <a:pt x="41" y="0"/>
                    <a:pt x="41" y="0"/>
                  </a:cubicBezTo>
                  <a:cubicBezTo>
                    <a:pt x="98" y="0"/>
                    <a:pt x="98" y="0"/>
                    <a:pt x="98" y="0"/>
                  </a:cubicBezTo>
                  <a:cubicBezTo>
                    <a:pt x="98" y="92"/>
                    <a:pt x="98" y="92"/>
                    <a:pt x="98" y="92"/>
                  </a:cubicBezTo>
                  <a:cubicBezTo>
                    <a:pt x="172" y="92"/>
                    <a:pt x="172" y="92"/>
                    <a:pt x="172" y="92"/>
                  </a:cubicBezTo>
                  <a:cubicBezTo>
                    <a:pt x="172" y="140"/>
                    <a:pt x="172" y="140"/>
                    <a:pt x="172" y="140"/>
                  </a:cubicBezTo>
                  <a:cubicBezTo>
                    <a:pt x="98" y="140"/>
                    <a:pt x="98" y="140"/>
                    <a:pt x="98" y="140"/>
                  </a:cubicBezTo>
                  <a:cubicBezTo>
                    <a:pt x="98" y="281"/>
                    <a:pt x="98" y="281"/>
                    <a:pt x="98" y="281"/>
                  </a:cubicBezTo>
                  <a:cubicBezTo>
                    <a:pt x="98" y="344"/>
                    <a:pt x="141" y="352"/>
                    <a:pt x="164" y="352"/>
                  </a:cubicBezTo>
                  <a:cubicBezTo>
                    <a:pt x="172" y="352"/>
                    <a:pt x="178" y="351"/>
                    <a:pt x="178" y="351"/>
                  </a:cubicBezTo>
                  <a:cubicBezTo>
                    <a:pt x="178" y="405"/>
                    <a:pt x="178" y="405"/>
                    <a:pt x="178" y="405"/>
                  </a:cubicBezTo>
                  <a:cubicBezTo>
                    <a:pt x="178" y="405"/>
                    <a:pt x="169" y="406"/>
                    <a:pt x="157" y="406"/>
                  </a:cubicBezTo>
                  <a:cubicBezTo>
                    <a:pt x="118" y="406"/>
                    <a:pt x="40" y="394"/>
                    <a:pt x="40" y="288"/>
                  </a:cubicBezTo>
                  <a:lnTo>
                    <a:pt x="40" y="14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EAA25A28-653C-D14E-8678-1E37A45867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14238" y="644526"/>
              <a:ext cx="431800" cy="630238"/>
            </a:xfrm>
            <a:custGeom>
              <a:avLst/>
              <a:gdLst>
                <a:gd name="T0" fmla="*/ 28 w 227"/>
                <a:gd name="T1" fmla="*/ 242 h 331"/>
                <a:gd name="T2" fmla="*/ 116 w 227"/>
                <a:gd name="T3" fmla="*/ 279 h 331"/>
                <a:gd name="T4" fmla="*/ 167 w 227"/>
                <a:gd name="T5" fmla="*/ 239 h 331"/>
                <a:gd name="T6" fmla="*/ 10 w 227"/>
                <a:gd name="T7" fmla="*/ 90 h 331"/>
                <a:gd name="T8" fmla="*/ 120 w 227"/>
                <a:gd name="T9" fmla="*/ 0 h 331"/>
                <a:gd name="T10" fmla="*/ 219 w 227"/>
                <a:gd name="T11" fmla="*/ 35 h 331"/>
                <a:gd name="T12" fmla="*/ 195 w 227"/>
                <a:gd name="T13" fmla="*/ 80 h 331"/>
                <a:gd name="T14" fmla="*/ 120 w 227"/>
                <a:gd name="T15" fmla="*/ 52 h 331"/>
                <a:gd name="T16" fmla="*/ 70 w 227"/>
                <a:gd name="T17" fmla="*/ 91 h 331"/>
                <a:gd name="T18" fmla="*/ 227 w 227"/>
                <a:gd name="T19" fmla="*/ 239 h 331"/>
                <a:gd name="T20" fmla="*/ 116 w 227"/>
                <a:gd name="T21" fmla="*/ 331 h 331"/>
                <a:gd name="T22" fmla="*/ 0 w 227"/>
                <a:gd name="T23" fmla="*/ 285 h 331"/>
                <a:gd name="T24" fmla="*/ 28 w 227"/>
                <a:gd name="T25" fmla="*/ 242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27" h="331">
                  <a:moveTo>
                    <a:pt x="28" y="242"/>
                  </a:moveTo>
                  <a:cubicBezTo>
                    <a:pt x="28" y="242"/>
                    <a:pt x="63" y="279"/>
                    <a:pt x="116" y="279"/>
                  </a:cubicBezTo>
                  <a:cubicBezTo>
                    <a:pt x="142" y="279"/>
                    <a:pt x="167" y="265"/>
                    <a:pt x="167" y="239"/>
                  </a:cubicBezTo>
                  <a:cubicBezTo>
                    <a:pt x="167" y="181"/>
                    <a:pt x="10" y="193"/>
                    <a:pt x="10" y="90"/>
                  </a:cubicBezTo>
                  <a:cubicBezTo>
                    <a:pt x="10" y="32"/>
                    <a:pt x="59" y="0"/>
                    <a:pt x="120" y="0"/>
                  </a:cubicBezTo>
                  <a:cubicBezTo>
                    <a:pt x="188" y="0"/>
                    <a:pt x="219" y="35"/>
                    <a:pt x="219" y="35"/>
                  </a:cubicBezTo>
                  <a:cubicBezTo>
                    <a:pt x="195" y="80"/>
                    <a:pt x="195" y="80"/>
                    <a:pt x="195" y="80"/>
                  </a:cubicBezTo>
                  <a:cubicBezTo>
                    <a:pt x="195" y="80"/>
                    <a:pt x="168" y="52"/>
                    <a:pt x="120" y="52"/>
                  </a:cubicBezTo>
                  <a:cubicBezTo>
                    <a:pt x="94" y="52"/>
                    <a:pt x="70" y="63"/>
                    <a:pt x="70" y="91"/>
                  </a:cubicBezTo>
                  <a:cubicBezTo>
                    <a:pt x="70" y="148"/>
                    <a:pt x="227" y="135"/>
                    <a:pt x="227" y="239"/>
                  </a:cubicBezTo>
                  <a:cubicBezTo>
                    <a:pt x="227" y="292"/>
                    <a:pt x="183" y="331"/>
                    <a:pt x="116" y="331"/>
                  </a:cubicBezTo>
                  <a:cubicBezTo>
                    <a:pt x="41" y="331"/>
                    <a:pt x="0" y="285"/>
                    <a:pt x="0" y="285"/>
                  </a:cubicBezTo>
                  <a:lnTo>
                    <a:pt x="28" y="24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0537320-0AA8-104B-8445-D90BE3E22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46051" y="1136651"/>
              <a:ext cx="117475" cy="123825"/>
            </a:xfrm>
            <a:prstGeom prst="rect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EF1D6FE9-AA4A-BB4A-90A6-F37E2B7785D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609976" y="1689101"/>
              <a:ext cx="654050" cy="833438"/>
            </a:xfrm>
            <a:custGeom>
              <a:avLst/>
              <a:gdLst>
                <a:gd name="T0" fmla="*/ 129 w 344"/>
                <a:gd name="T1" fmla="*/ 413 h 438"/>
                <a:gd name="T2" fmla="*/ 317 w 344"/>
                <a:gd name="T3" fmla="*/ 219 h 438"/>
                <a:gd name="T4" fmla="*/ 129 w 344"/>
                <a:gd name="T5" fmla="*/ 25 h 438"/>
                <a:gd name="T6" fmla="*/ 26 w 344"/>
                <a:gd name="T7" fmla="*/ 25 h 438"/>
                <a:gd name="T8" fmla="*/ 26 w 344"/>
                <a:gd name="T9" fmla="*/ 413 h 438"/>
                <a:gd name="T10" fmla="*/ 129 w 344"/>
                <a:gd name="T11" fmla="*/ 413 h 438"/>
                <a:gd name="T12" fmla="*/ 0 w 344"/>
                <a:gd name="T13" fmla="*/ 0 h 438"/>
                <a:gd name="T14" fmla="*/ 133 w 344"/>
                <a:gd name="T15" fmla="*/ 0 h 438"/>
                <a:gd name="T16" fmla="*/ 344 w 344"/>
                <a:gd name="T17" fmla="*/ 219 h 438"/>
                <a:gd name="T18" fmla="*/ 133 w 344"/>
                <a:gd name="T19" fmla="*/ 438 h 438"/>
                <a:gd name="T20" fmla="*/ 0 w 344"/>
                <a:gd name="T21" fmla="*/ 438 h 438"/>
                <a:gd name="T22" fmla="*/ 0 w 344"/>
                <a:gd name="T23" fmla="*/ 0 h 4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44" h="438">
                  <a:moveTo>
                    <a:pt x="129" y="413"/>
                  </a:moveTo>
                  <a:cubicBezTo>
                    <a:pt x="241" y="413"/>
                    <a:pt x="317" y="345"/>
                    <a:pt x="317" y="219"/>
                  </a:cubicBezTo>
                  <a:cubicBezTo>
                    <a:pt x="317" y="94"/>
                    <a:pt x="241" y="25"/>
                    <a:pt x="129" y="25"/>
                  </a:cubicBezTo>
                  <a:cubicBezTo>
                    <a:pt x="26" y="25"/>
                    <a:pt x="26" y="25"/>
                    <a:pt x="26" y="25"/>
                  </a:cubicBezTo>
                  <a:cubicBezTo>
                    <a:pt x="26" y="413"/>
                    <a:pt x="26" y="413"/>
                    <a:pt x="26" y="413"/>
                  </a:cubicBezTo>
                  <a:lnTo>
                    <a:pt x="129" y="413"/>
                  </a:lnTo>
                  <a:close/>
                  <a:moveTo>
                    <a:pt x="0" y="0"/>
                  </a:moveTo>
                  <a:cubicBezTo>
                    <a:pt x="133" y="0"/>
                    <a:pt x="133" y="0"/>
                    <a:pt x="133" y="0"/>
                  </a:cubicBezTo>
                  <a:cubicBezTo>
                    <a:pt x="259" y="0"/>
                    <a:pt x="344" y="80"/>
                    <a:pt x="344" y="219"/>
                  </a:cubicBezTo>
                  <a:cubicBezTo>
                    <a:pt x="344" y="359"/>
                    <a:pt x="259" y="438"/>
                    <a:pt x="133" y="438"/>
                  </a:cubicBezTo>
                  <a:cubicBezTo>
                    <a:pt x="0" y="438"/>
                    <a:pt x="0" y="438"/>
                    <a:pt x="0" y="438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E0EEE209-5D15-4E41-BBED-CDEB11240C8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8963" y="1924051"/>
              <a:ext cx="263525" cy="598488"/>
            </a:xfrm>
            <a:custGeom>
              <a:avLst/>
              <a:gdLst>
                <a:gd name="T0" fmla="*/ 0 w 139"/>
                <a:gd name="T1" fmla="*/ 2 h 315"/>
                <a:gd name="T2" fmla="*/ 25 w 139"/>
                <a:gd name="T3" fmla="*/ 2 h 315"/>
                <a:gd name="T4" fmla="*/ 25 w 139"/>
                <a:gd name="T5" fmla="*/ 62 h 315"/>
                <a:gd name="T6" fmla="*/ 23 w 139"/>
                <a:gd name="T7" fmla="*/ 87 h 315"/>
                <a:gd name="T8" fmla="*/ 24 w 139"/>
                <a:gd name="T9" fmla="*/ 87 h 315"/>
                <a:gd name="T10" fmla="*/ 121 w 139"/>
                <a:gd name="T11" fmla="*/ 0 h 315"/>
                <a:gd name="T12" fmla="*/ 139 w 139"/>
                <a:gd name="T13" fmla="*/ 2 h 315"/>
                <a:gd name="T14" fmla="*/ 139 w 139"/>
                <a:gd name="T15" fmla="*/ 28 h 315"/>
                <a:gd name="T16" fmla="*/ 125 w 139"/>
                <a:gd name="T17" fmla="*/ 27 h 315"/>
                <a:gd name="T18" fmla="*/ 34 w 139"/>
                <a:gd name="T19" fmla="*/ 114 h 315"/>
                <a:gd name="T20" fmla="*/ 25 w 139"/>
                <a:gd name="T21" fmla="*/ 180 h 315"/>
                <a:gd name="T22" fmla="*/ 25 w 139"/>
                <a:gd name="T23" fmla="*/ 315 h 315"/>
                <a:gd name="T24" fmla="*/ 0 w 139"/>
                <a:gd name="T25" fmla="*/ 315 h 315"/>
                <a:gd name="T26" fmla="*/ 0 w 139"/>
                <a:gd name="T27" fmla="*/ 2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39" h="315">
                  <a:moveTo>
                    <a:pt x="0" y="2"/>
                  </a:moveTo>
                  <a:cubicBezTo>
                    <a:pt x="25" y="2"/>
                    <a:pt x="25" y="2"/>
                    <a:pt x="25" y="2"/>
                  </a:cubicBezTo>
                  <a:cubicBezTo>
                    <a:pt x="25" y="62"/>
                    <a:pt x="25" y="62"/>
                    <a:pt x="25" y="62"/>
                  </a:cubicBezTo>
                  <a:cubicBezTo>
                    <a:pt x="25" y="76"/>
                    <a:pt x="23" y="87"/>
                    <a:pt x="23" y="87"/>
                  </a:cubicBezTo>
                  <a:cubicBezTo>
                    <a:pt x="24" y="87"/>
                    <a:pt x="24" y="87"/>
                    <a:pt x="24" y="87"/>
                  </a:cubicBezTo>
                  <a:cubicBezTo>
                    <a:pt x="39" y="39"/>
                    <a:pt x="73" y="0"/>
                    <a:pt x="121" y="0"/>
                  </a:cubicBezTo>
                  <a:cubicBezTo>
                    <a:pt x="130" y="0"/>
                    <a:pt x="139" y="2"/>
                    <a:pt x="139" y="2"/>
                  </a:cubicBezTo>
                  <a:cubicBezTo>
                    <a:pt x="139" y="28"/>
                    <a:pt x="139" y="28"/>
                    <a:pt x="139" y="28"/>
                  </a:cubicBezTo>
                  <a:cubicBezTo>
                    <a:pt x="139" y="28"/>
                    <a:pt x="131" y="27"/>
                    <a:pt x="125" y="27"/>
                  </a:cubicBezTo>
                  <a:cubicBezTo>
                    <a:pt x="77" y="27"/>
                    <a:pt x="48" y="68"/>
                    <a:pt x="34" y="114"/>
                  </a:cubicBezTo>
                  <a:cubicBezTo>
                    <a:pt x="28" y="136"/>
                    <a:pt x="25" y="159"/>
                    <a:pt x="25" y="180"/>
                  </a:cubicBezTo>
                  <a:cubicBezTo>
                    <a:pt x="25" y="315"/>
                    <a:pt x="25" y="315"/>
                    <a:pt x="25" y="315"/>
                  </a:cubicBezTo>
                  <a:cubicBezTo>
                    <a:pt x="0" y="315"/>
                    <a:pt x="0" y="315"/>
                    <a:pt x="0" y="315"/>
                  </a:cubicBezTo>
                  <a:lnTo>
                    <a:pt x="0" y="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5FDFCE35-BE30-5A48-A449-F6BC896187D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735513" y="1689101"/>
              <a:ext cx="57150" cy="833438"/>
            </a:xfrm>
            <a:custGeom>
              <a:avLst/>
              <a:gdLst>
                <a:gd name="T0" fmla="*/ 2 w 36"/>
                <a:gd name="T1" fmla="*/ 525 h 525"/>
                <a:gd name="T2" fmla="*/ 32 w 36"/>
                <a:gd name="T3" fmla="*/ 525 h 525"/>
                <a:gd name="T4" fmla="*/ 32 w 36"/>
                <a:gd name="T5" fmla="*/ 150 h 525"/>
                <a:gd name="T6" fmla="*/ 2 w 36"/>
                <a:gd name="T7" fmla="*/ 150 h 525"/>
                <a:gd name="T8" fmla="*/ 2 w 36"/>
                <a:gd name="T9" fmla="*/ 525 h 525"/>
                <a:gd name="T10" fmla="*/ 0 w 36"/>
                <a:gd name="T11" fmla="*/ 55 h 525"/>
                <a:gd name="T12" fmla="*/ 36 w 36"/>
                <a:gd name="T13" fmla="*/ 55 h 525"/>
                <a:gd name="T14" fmla="*/ 36 w 36"/>
                <a:gd name="T15" fmla="*/ 0 h 525"/>
                <a:gd name="T16" fmla="*/ 0 w 36"/>
                <a:gd name="T17" fmla="*/ 0 h 525"/>
                <a:gd name="T18" fmla="*/ 0 w 36"/>
                <a:gd name="T19" fmla="*/ 55 h 5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525">
                  <a:moveTo>
                    <a:pt x="2" y="525"/>
                  </a:moveTo>
                  <a:lnTo>
                    <a:pt x="32" y="525"/>
                  </a:lnTo>
                  <a:lnTo>
                    <a:pt x="32" y="150"/>
                  </a:lnTo>
                  <a:lnTo>
                    <a:pt x="2" y="150"/>
                  </a:lnTo>
                  <a:lnTo>
                    <a:pt x="2" y="525"/>
                  </a:lnTo>
                  <a:close/>
                  <a:moveTo>
                    <a:pt x="0" y="55"/>
                  </a:moveTo>
                  <a:lnTo>
                    <a:pt x="36" y="55"/>
                  </a:lnTo>
                  <a:lnTo>
                    <a:pt x="36" y="0"/>
                  </a:lnTo>
                  <a:lnTo>
                    <a:pt x="0" y="0"/>
                  </a:lnTo>
                  <a:lnTo>
                    <a:pt x="0" y="55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A601DC36-C1A5-7A4E-BCBF-00813474D07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60926" y="1927226"/>
              <a:ext cx="496888" cy="595313"/>
            </a:xfrm>
            <a:custGeom>
              <a:avLst/>
              <a:gdLst>
                <a:gd name="T0" fmla="*/ 0 w 262"/>
                <a:gd name="T1" fmla="*/ 0 h 313"/>
                <a:gd name="T2" fmla="*/ 28 w 262"/>
                <a:gd name="T3" fmla="*/ 0 h 313"/>
                <a:gd name="T4" fmla="*/ 121 w 262"/>
                <a:gd name="T5" fmla="*/ 246 h 313"/>
                <a:gd name="T6" fmla="*/ 131 w 262"/>
                <a:gd name="T7" fmla="*/ 279 h 313"/>
                <a:gd name="T8" fmla="*/ 132 w 262"/>
                <a:gd name="T9" fmla="*/ 279 h 313"/>
                <a:gd name="T10" fmla="*/ 143 w 262"/>
                <a:gd name="T11" fmla="*/ 246 h 313"/>
                <a:gd name="T12" fmla="*/ 236 w 262"/>
                <a:gd name="T13" fmla="*/ 0 h 313"/>
                <a:gd name="T14" fmla="*/ 262 w 262"/>
                <a:gd name="T15" fmla="*/ 0 h 313"/>
                <a:gd name="T16" fmla="*/ 144 w 262"/>
                <a:gd name="T17" fmla="*/ 313 h 313"/>
                <a:gd name="T18" fmla="*/ 120 w 262"/>
                <a:gd name="T19" fmla="*/ 313 h 313"/>
                <a:gd name="T20" fmla="*/ 0 w 262"/>
                <a:gd name="T21" fmla="*/ 0 h 3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262" h="313">
                  <a:moveTo>
                    <a:pt x="0" y="0"/>
                  </a:moveTo>
                  <a:cubicBezTo>
                    <a:pt x="28" y="0"/>
                    <a:pt x="28" y="0"/>
                    <a:pt x="28" y="0"/>
                  </a:cubicBezTo>
                  <a:cubicBezTo>
                    <a:pt x="121" y="246"/>
                    <a:pt x="121" y="246"/>
                    <a:pt x="121" y="246"/>
                  </a:cubicBezTo>
                  <a:cubicBezTo>
                    <a:pt x="126" y="260"/>
                    <a:pt x="131" y="279"/>
                    <a:pt x="131" y="279"/>
                  </a:cubicBezTo>
                  <a:cubicBezTo>
                    <a:pt x="132" y="279"/>
                    <a:pt x="132" y="279"/>
                    <a:pt x="132" y="279"/>
                  </a:cubicBezTo>
                  <a:cubicBezTo>
                    <a:pt x="132" y="279"/>
                    <a:pt x="137" y="260"/>
                    <a:pt x="143" y="246"/>
                  </a:cubicBezTo>
                  <a:cubicBezTo>
                    <a:pt x="236" y="0"/>
                    <a:pt x="236" y="0"/>
                    <a:pt x="236" y="0"/>
                  </a:cubicBezTo>
                  <a:cubicBezTo>
                    <a:pt x="262" y="0"/>
                    <a:pt x="262" y="0"/>
                    <a:pt x="262" y="0"/>
                  </a:cubicBezTo>
                  <a:cubicBezTo>
                    <a:pt x="144" y="313"/>
                    <a:pt x="144" y="313"/>
                    <a:pt x="144" y="313"/>
                  </a:cubicBezTo>
                  <a:cubicBezTo>
                    <a:pt x="120" y="313"/>
                    <a:pt x="120" y="313"/>
                    <a:pt x="120" y="313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D54C74C1-1A4D-0746-9D8A-0C56B6D1687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75276" y="1914526"/>
              <a:ext cx="512763" cy="623888"/>
            </a:xfrm>
            <a:custGeom>
              <a:avLst/>
              <a:gdLst>
                <a:gd name="T0" fmla="*/ 243 w 270"/>
                <a:gd name="T1" fmla="*/ 135 h 328"/>
                <a:gd name="T2" fmla="*/ 146 w 270"/>
                <a:gd name="T3" fmla="*/ 24 h 328"/>
                <a:gd name="T4" fmla="*/ 28 w 270"/>
                <a:gd name="T5" fmla="*/ 135 h 328"/>
                <a:gd name="T6" fmla="*/ 243 w 270"/>
                <a:gd name="T7" fmla="*/ 135 h 328"/>
                <a:gd name="T8" fmla="*/ 147 w 270"/>
                <a:gd name="T9" fmla="*/ 0 h 328"/>
                <a:gd name="T10" fmla="*/ 270 w 270"/>
                <a:gd name="T11" fmla="*/ 142 h 328"/>
                <a:gd name="T12" fmla="*/ 269 w 270"/>
                <a:gd name="T13" fmla="*/ 159 h 328"/>
                <a:gd name="T14" fmla="*/ 26 w 270"/>
                <a:gd name="T15" fmla="*/ 159 h 328"/>
                <a:gd name="T16" fmla="*/ 156 w 270"/>
                <a:gd name="T17" fmla="*/ 302 h 328"/>
                <a:gd name="T18" fmla="*/ 249 w 270"/>
                <a:gd name="T19" fmla="*/ 263 h 328"/>
                <a:gd name="T20" fmla="*/ 263 w 270"/>
                <a:gd name="T21" fmla="*/ 284 h 328"/>
                <a:gd name="T22" fmla="*/ 156 w 270"/>
                <a:gd name="T23" fmla="*/ 328 h 328"/>
                <a:gd name="T24" fmla="*/ 0 w 270"/>
                <a:gd name="T25" fmla="*/ 164 h 328"/>
                <a:gd name="T26" fmla="*/ 147 w 270"/>
                <a:gd name="T27" fmla="*/ 0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70" h="328">
                  <a:moveTo>
                    <a:pt x="243" y="135"/>
                  </a:moveTo>
                  <a:cubicBezTo>
                    <a:pt x="240" y="59"/>
                    <a:pt x="196" y="24"/>
                    <a:pt x="146" y="24"/>
                  </a:cubicBezTo>
                  <a:cubicBezTo>
                    <a:pt x="90" y="24"/>
                    <a:pt x="39" y="62"/>
                    <a:pt x="28" y="135"/>
                  </a:cubicBezTo>
                  <a:lnTo>
                    <a:pt x="243" y="135"/>
                  </a:lnTo>
                  <a:close/>
                  <a:moveTo>
                    <a:pt x="147" y="0"/>
                  </a:moveTo>
                  <a:cubicBezTo>
                    <a:pt x="229" y="0"/>
                    <a:pt x="270" y="67"/>
                    <a:pt x="270" y="142"/>
                  </a:cubicBezTo>
                  <a:cubicBezTo>
                    <a:pt x="270" y="149"/>
                    <a:pt x="269" y="159"/>
                    <a:pt x="269" y="159"/>
                  </a:cubicBezTo>
                  <a:cubicBezTo>
                    <a:pt x="26" y="159"/>
                    <a:pt x="26" y="159"/>
                    <a:pt x="26" y="159"/>
                  </a:cubicBezTo>
                  <a:cubicBezTo>
                    <a:pt x="26" y="250"/>
                    <a:pt x="85" y="302"/>
                    <a:pt x="156" y="302"/>
                  </a:cubicBezTo>
                  <a:cubicBezTo>
                    <a:pt x="214" y="302"/>
                    <a:pt x="249" y="263"/>
                    <a:pt x="249" y="263"/>
                  </a:cubicBezTo>
                  <a:cubicBezTo>
                    <a:pt x="263" y="284"/>
                    <a:pt x="263" y="284"/>
                    <a:pt x="263" y="284"/>
                  </a:cubicBezTo>
                  <a:cubicBezTo>
                    <a:pt x="263" y="284"/>
                    <a:pt x="221" y="328"/>
                    <a:pt x="156" y="328"/>
                  </a:cubicBezTo>
                  <a:cubicBezTo>
                    <a:pt x="70" y="328"/>
                    <a:pt x="0" y="264"/>
                    <a:pt x="0" y="164"/>
                  </a:cubicBezTo>
                  <a:cubicBezTo>
                    <a:pt x="0" y="59"/>
                    <a:pt x="69" y="0"/>
                    <a:pt x="147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30FA9AF8-C3B9-E741-BC05-3856E817A1AC}"/>
                </a:ext>
              </a:extLst>
            </p:cNvPr>
            <p:cNvSpPr>
              <a:spLocks/>
            </p:cNvSpPr>
            <p:nvPr/>
          </p:nvSpPr>
          <p:spPr bwMode="auto">
            <a:xfrm>
              <a:off x="6003926" y="1914526"/>
              <a:ext cx="479425" cy="608013"/>
            </a:xfrm>
            <a:custGeom>
              <a:avLst/>
              <a:gdLst>
                <a:gd name="T0" fmla="*/ 0 w 252"/>
                <a:gd name="T1" fmla="*/ 7 h 320"/>
                <a:gd name="T2" fmla="*/ 25 w 252"/>
                <a:gd name="T3" fmla="*/ 7 h 320"/>
                <a:gd name="T4" fmla="*/ 25 w 252"/>
                <a:gd name="T5" fmla="*/ 62 h 320"/>
                <a:gd name="T6" fmla="*/ 23 w 252"/>
                <a:gd name="T7" fmla="*/ 88 h 320"/>
                <a:gd name="T8" fmla="*/ 24 w 252"/>
                <a:gd name="T9" fmla="*/ 88 h 320"/>
                <a:gd name="T10" fmla="*/ 152 w 252"/>
                <a:gd name="T11" fmla="*/ 0 h 320"/>
                <a:gd name="T12" fmla="*/ 252 w 252"/>
                <a:gd name="T13" fmla="*/ 122 h 320"/>
                <a:gd name="T14" fmla="*/ 252 w 252"/>
                <a:gd name="T15" fmla="*/ 320 h 320"/>
                <a:gd name="T16" fmla="*/ 227 w 252"/>
                <a:gd name="T17" fmla="*/ 320 h 320"/>
                <a:gd name="T18" fmla="*/ 227 w 252"/>
                <a:gd name="T19" fmla="*/ 131 h 320"/>
                <a:gd name="T20" fmla="*/ 152 w 252"/>
                <a:gd name="T21" fmla="*/ 26 h 320"/>
                <a:gd name="T22" fmla="*/ 30 w 252"/>
                <a:gd name="T23" fmla="*/ 125 h 320"/>
                <a:gd name="T24" fmla="*/ 25 w 252"/>
                <a:gd name="T25" fmla="*/ 168 h 320"/>
                <a:gd name="T26" fmla="*/ 25 w 252"/>
                <a:gd name="T27" fmla="*/ 320 h 320"/>
                <a:gd name="T28" fmla="*/ 0 w 252"/>
                <a:gd name="T29" fmla="*/ 320 h 320"/>
                <a:gd name="T30" fmla="*/ 0 w 252"/>
                <a:gd name="T31" fmla="*/ 7 h 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52" h="320">
                  <a:moveTo>
                    <a:pt x="0" y="7"/>
                  </a:moveTo>
                  <a:cubicBezTo>
                    <a:pt x="25" y="7"/>
                    <a:pt x="25" y="7"/>
                    <a:pt x="25" y="7"/>
                  </a:cubicBezTo>
                  <a:cubicBezTo>
                    <a:pt x="25" y="62"/>
                    <a:pt x="25" y="62"/>
                    <a:pt x="25" y="62"/>
                  </a:cubicBezTo>
                  <a:cubicBezTo>
                    <a:pt x="25" y="77"/>
                    <a:pt x="23" y="88"/>
                    <a:pt x="23" y="88"/>
                  </a:cubicBezTo>
                  <a:cubicBezTo>
                    <a:pt x="24" y="88"/>
                    <a:pt x="24" y="88"/>
                    <a:pt x="24" y="88"/>
                  </a:cubicBezTo>
                  <a:cubicBezTo>
                    <a:pt x="34" y="59"/>
                    <a:pt x="77" y="0"/>
                    <a:pt x="152" y="0"/>
                  </a:cubicBezTo>
                  <a:cubicBezTo>
                    <a:pt x="231" y="0"/>
                    <a:pt x="252" y="48"/>
                    <a:pt x="252" y="122"/>
                  </a:cubicBezTo>
                  <a:cubicBezTo>
                    <a:pt x="252" y="320"/>
                    <a:pt x="252" y="320"/>
                    <a:pt x="252" y="320"/>
                  </a:cubicBezTo>
                  <a:cubicBezTo>
                    <a:pt x="227" y="320"/>
                    <a:pt x="227" y="320"/>
                    <a:pt x="227" y="320"/>
                  </a:cubicBezTo>
                  <a:cubicBezTo>
                    <a:pt x="227" y="131"/>
                    <a:pt x="227" y="131"/>
                    <a:pt x="227" y="131"/>
                  </a:cubicBezTo>
                  <a:cubicBezTo>
                    <a:pt x="227" y="77"/>
                    <a:pt x="220" y="26"/>
                    <a:pt x="152" y="26"/>
                  </a:cubicBezTo>
                  <a:cubicBezTo>
                    <a:pt x="95" y="26"/>
                    <a:pt x="45" y="67"/>
                    <a:pt x="30" y="125"/>
                  </a:cubicBezTo>
                  <a:cubicBezTo>
                    <a:pt x="26" y="138"/>
                    <a:pt x="25" y="153"/>
                    <a:pt x="25" y="168"/>
                  </a:cubicBezTo>
                  <a:cubicBezTo>
                    <a:pt x="25" y="320"/>
                    <a:pt x="25" y="320"/>
                    <a:pt x="25" y="320"/>
                  </a:cubicBezTo>
                  <a:cubicBezTo>
                    <a:pt x="0" y="320"/>
                    <a:pt x="0" y="320"/>
                    <a:pt x="0" y="320"/>
                  </a:cubicBezTo>
                  <a:lnTo>
                    <a:pt x="0" y="7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04DD23BB-B2D3-A944-81B8-A2956E26363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50076" y="1689101"/>
              <a:ext cx="501650" cy="849313"/>
            </a:xfrm>
            <a:custGeom>
              <a:avLst/>
              <a:gdLst>
                <a:gd name="T0" fmla="*/ 130 w 264"/>
                <a:gd name="T1" fmla="*/ 420 h 446"/>
                <a:gd name="T2" fmla="*/ 237 w 264"/>
                <a:gd name="T3" fmla="*/ 282 h 446"/>
                <a:gd name="T4" fmla="*/ 132 w 264"/>
                <a:gd name="T5" fmla="*/ 144 h 446"/>
                <a:gd name="T6" fmla="*/ 24 w 264"/>
                <a:gd name="T7" fmla="*/ 282 h 446"/>
                <a:gd name="T8" fmla="*/ 130 w 264"/>
                <a:gd name="T9" fmla="*/ 420 h 446"/>
                <a:gd name="T10" fmla="*/ 0 w 264"/>
                <a:gd name="T11" fmla="*/ 0 h 446"/>
                <a:gd name="T12" fmla="*/ 25 w 264"/>
                <a:gd name="T13" fmla="*/ 0 h 446"/>
                <a:gd name="T14" fmla="*/ 25 w 264"/>
                <a:gd name="T15" fmla="*/ 163 h 446"/>
                <a:gd name="T16" fmla="*/ 23 w 264"/>
                <a:gd name="T17" fmla="*/ 189 h 446"/>
                <a:gd name="T18" fmla="*/ 24 w 264"/>
                <a:gd name="T19" fmla="*/ 189 h 446"/>
                <a:gd name="T20" fmla="*/ 133 w 264"/>
                <a:gd name="T21" fmla="*/ 118 h 446"/>
                <a:gd name="T22" fmla="*/ 264 w 264"/>
                <a:gd name="T23" fmla="*/ 282 h 446"/>
                <a:gd name="T24" fmla="*/ 129 w 264"/>
                <a:gd name="T25" fmla="*/ 446 h 446"/>
                <a:gd name="T26" fmla="*/ 24 w 264"/>
                <a:gd name="T27" fmla="*/ 375 h 446"/>
                <a:gd name="T28" fmla="*/ 23 w 264"/>
                <a:gd name="T29" fmla="*/ 375 h 446"/>
                <a:gd name="T30" fmla="*/ 25 w 264"/>
                <a:gd name="T31" fmla="*/ 402 h 446"/>
                <a:gd name="T32" fmla="*/ 25 w 264"/>
                <a:gd name="T33" fmla="*/ 438 h 446"/>
                <a:gd name="T34" fmla="*/ 0 w 264"/>
                <a:gd name="T35" fmla="*/ 438 h 446"/>
                <a:gd name="T36" fmla="*/ 0 w 264"/>
                <a:gd name="T37" fmla="*/ 0 h 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264" h="446">
                  <a:moveTo>
                    <a:pt x="130" y="420"/>
                  </a:moveTo>
                  <a:cubicBezTo>
                    <a:pt x="189" y="420"/>
                    <a:pt x="237" y="369"/>
                    <a:pt x="237" y="282"/>
                  </a:cubicBezTo>
                  <a:cubicBezTo>
                    <a:pt x="237" y="197"/>
                    <a:pt x="194" y="144"/>
                    <a:pt x="132" y="144"/>
                  </a:cubicBezTo>
                  <a:cubicBezTo>
                    <a:pt x="77" y="144"/>
                    <a:pt x="24" y="184"/>
                    <a:pt x="24" y="282"/>
                  </a:cubicBezTo>
                  <a:cubicBezTo>
                    <a:pt x="24" y="352"/>
                    <a:pt x="59" y="420"/>
                    <a:pt x="130" y="420"/>
                  </a:cubicBezTo>
                  <a:moveTo>
                    <a:pt x="0" y="0"/>
                  </a:moveTo>
                  <a:cubicBezTo>
                    <a:pt x="25" y="0"/>
                    <a:pt x="25" y="0"/>
                    <a:pt x="25" y="0"/>
                  </a:cubicBezTo>
                  <a:cubicBezTo>
                    <a:pt x="25" y="163"/>
                    <a:pt x="25" y="163"/>
                    <a:pt x="25" y="163"/>
                  </a:cubicBezTo>
                  <a:cubicBezTo>
                    <a:pt x="25" y="177"/>
                    <a:pt x="23" y="189"/>
                    <a:pt x="23" y="189"/>
                  </a:cubicBezTo>
                  <a:cubicBezTo>
                    <a:pt x="24" y="189"/>
                    <a:pt x="24" y="189"/>
                    <a:pt x="24" y="189"/>
                  </a:cubicBezTo>
                  <a:cubicBezTo>
                    <a:pt x="24" y="189"/>
                    <a:pt x="50" y="118"/>
                    <a:pt x="133" y="118"/>
                  </a:cubicBezTo>
                  <a:cubicBezTo>
                    <a:pt x="215" y="118"/>
                    <a:pt x="264" y="185"/>
                    <a:pt x="264" y="282"/>
                  </a:cubicBezTo>
                  <a:cubicBezTo>
                    <a:pt x="264" y="381"/>
                    <a:pt x="208" y="446"/>
                    <a:pt x="129" y="446"/>
                  </a:cubicBezTo>
                  <a:cubicBezTo>
                    <a:pt x="52" y="446"/>
                    <a:pt x="24" y="375"/>
                    <a:pt x="24" y="375"/>
                  </a:cubicBezTo>
                  <a:cubicBezTo>
                    <a:pt x="23" y="375"/>
                    <a:pt x="23" y="375"/>
                    <a:pt x="23" y="375"/>
                  </a:cubicBezTo>
                  <a:cubicBezTo>
                    <a:pt x="23" y="375"/>
                    <a:pt x="25" y="386"/>
                    <a:pt x="25" y="402"/>
                  </a:cubicBezTo>
                  <a:cubicBezTo>
                    <a:pt x="25" y="438"/>
                    <a:pt x="25" y="438"/>
                    <a:pt x="25" y="438"/>
                  </a:cubicBezTo>
                  <a:cubicBezTo>
                    <a:pt x="0" y="438"/>
                    <a:pt x="0" y="438"/>
                    <a:pt x="0" y="438"/>
                  </a:cubicBez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87BB2AA8-3A1B-3644-8599-4B7092E5E8AC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9663" y="1927226"/>
              <a:ext cx="533400" cy="844550"/>
            </a:xfrm>
            <a:custGeom>
              <a:avLst/>
              <a:gdLst>
                <a:gd name="T0" fmla="*/ 11 w 281"/>
                <a:gd name="T1" fmla="*/ 404 h 444"/>
                <a:gd name="T2" fmla="*/ 49 w 281"/>
                <a:gd name="T3" fmla="*/ 419 h 444"/>
                <a:gd name="T4" fmla="*/ 108 w 281"/>
                <a:gd name="T5" fmla="*/ 363 h 444"/>
                <a:gd name="T6" fmla="*/ 130 w 281"/>
                <a:gd name="T7" fmla="*/ 311 h 444"/>
                <a:gd name="T8" fmla="*/ 5 w 281"/>
                <a:gd name="T9" fmla="*/ 0 h 444"/>
                <a:gd name="T10" fmla="*/ 32 w 281"/>
                <a:gd name="T11" fmla="*/ 0 h 444"/>
                <a:gd name="T12" fmla="*/ 132 w 281"/>
                <a:gd name="T13" fmla="*/ 250 h 444"/>
                <a:gd name="T14" fmla="*/ 143 w 281"/>
                <a:gd name="T15" fmla="*/ 279 h 444"/>
                <a:gd name="T16" fmla="*/ 144 w 281"/>
                <a:gd name="T17" fmla="*/ 279 h 444"/>
                <a:gd name="T18" fmla="*/ 154 w 281"/>
                <a:gd name="T19" fmla="*/ 250 h 444"/>
                <a:gd name="T20" fmla="*/ 254 w 281"/>
                <a:gd name="T21" fmla="*/ 0 h 444"/>
                <a:gd name="T22" fmla="*/ 281 w 281"/>
                <a:gd name="T23" fmla="*/ 0 h 444"/>
                <a:gd name="T24" fmla="*/ 126 w 281"/>
                <a:gd name="T25" fmla="*/ 386 h 444"/>
                <a:gd name="T26" fmla="*/ 49 w 281"/>
                <a:gd name="T27" fmla="*/ 444 h 444"/>
                <a:gd name="T28" fmla="*/ 0 w 281"/>
                <a:gd name="T29" fmla="*/ 427 h 444"/>
                <a:gd name="T30" fmla="*/ 11 w 281"/>
                <a:gd name="T31" fmla="*/ 404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81" h="444">
                  <a:moveTo>
                    <a:pt x="11" y="404"/>
                  </a:moveTo>
                  <a:cubicBezTo>
                    <a:pt x="11" y="404"/>
                    <a:pt x="28" y="419"/>
                    <a:pt x="49" y="419"/>
                  </a:cubicBezTo>
                  <a:cubicBezTo>
                    <a:pt x="78" y="419"/>
                    <a:pt x="96" y="392"/>
                    <a:pt x="108" y="363"/>
                  </a:cubicBezTo>
                  <a:cubicBezTo>
                    <a:pt x="130" y="311"/>
                    <a:pt x="130" y="311"/>
                    <a:pt x="130" y="311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2" y="0"/>
                    <a:pt x="32" y="0"/>
                    <a:pt x="32" y="0"/>
                  </a:cubicBezTo>
                  <a:cubicBezTo>
                    <a:pt x="132" y="250"/>
                    <a:pt x="132" y="250"/>
                    <a:pt x="132" y="250"/>
                  </a:cubicBezTo>
                  <a:cubicBezTo>
                    <a:pt x="138" y="265"/>
                    <a:pt x="143" y="279"/>
                    <a:pt x="143" y="279"/>
                  </a:cubicBezTo>
                  <a:cubicBezTo>
                    <a:pt x="144" y="279"/>
                    <a:pt x="144" y="279"/>
                    <a:pt x="144" y="279"/>
                  </a:cubicBezTo>
                  <a:cubicBezTo>
                    <a:pt x="144" y="279"/>
                    <a:pt x="148" y="265"/>
                    <a:pt x="154" y="250"/>
                  </a:cubicBezTo>
                  <a:cubicBezTo>
                    <a:pt x="254" y="0"/>
                    <a:pt x="254" y="0"/>
                    <a:pt x="254" y="0"/>
                  </a:cubicBezTo>
                  <a:cubicBezTo>
                    <a:pt x="281" y="0"/>
                    <a:pt x="281" y="0"/>
                    <a:pt x="281" y="0"/>
                  </a:cubicBezTo>
                  <a:cubicBezTo>
                    <a:pt x="126" y="386"/>
                    <a:pt x="126" y="386"/>
                    <a:pt x="126" y="386"/>
                  </a:cubicBezTo>
                  <a:cubicBezTo>
                    <a:pt x="112" y="419"/>
                    <a:pt x="87" y="444"/>
                    <a:pt x="49" y="444"/>
                  </a:cubicBezTo>
                  <a:cubicBezTo>
                    <a:pt x="20" y="444"/>
                    <a:pt x="0" y="427"/>
                    <a:pt x="0" y="427"/>
                  </a:cubicBezTo>
                  <a:lnTo>
                    <a:pt x="11" y="404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8948E296-0FF2-F642-B3D1-B4ADCA612AC7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1038" y="1906588"/>
              <a:ext cx="431800" cy="631825"/>
            </a:xfrm>
            <a:custGeom>
              <a:avLst/>
              <a:gdLst>
                <a:gd name="T0" fmla="*/ 29 w 227"/>
                <a:gd name="T1" fmla="*/ 242 h 332"/>
                <a:gd name="T2" fmla="*/ 117 w 227"/>
                <a:gd name="T3" fmla="*/ 279 h 332"/>
                <a:gd name="T4" fmla="*/ 167 w 227"/>
                <a:gd name="T5" fmla="*/ 240 h 332"/>
                <a:gd name="T6" fmla="*/ 10 w 227"/>
                <a:gd name="T7" fmla="*/ 90 h 332"/>
                <a:gd name="T8" fmla="*/ 121 w 227"/>
                <a:gd name="T9" fmla="*/ 0 h 332"/>
                <a:gd name="T10" fmla="*/ 220 w 227"/>
                <a:gd name="T11" fmla="*/ 35 h 332"/>
                <a:gd name="T12" fmla="*/ 196 w 227"/>
                <a:gd name="T13" fmla="*/ 81 h 332"/>
                <a:gd name="T14" fmla="*/ 120 w 227"/>
                <a:gd name="T15" fmla="*/ 53 h 332"/>
                <a:gd name="T16" fmla="*/ 70 w 227"/>
                <a:gd name="T17" fmla="*/ 91 h 332"/>
                <a:gd name="T18" fmla="*/ 227 w 227"/>
                <a:gd name="T19" fmla="*/ 240 h 332"/>
                <a:gd name="T20" fmla="*/ 117 w 227"/>
                <a:gd name="T21" fmla="*/ 332 h 332"/>
                <a:gd name="T22" fmla="*/ 0 w 227"/>
                <a:gd name="T23" fmla="*/ 285 h 332"/>
                <a:gd name="T24" fmla="*/ 29 w 227"/>
                <a:gd name="T25" fmla="*/ 242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27" h="332">
                  <a:moveTo>
                    <a:pt x="29" y="242"/>
                  </a:moveTo>
                  <a:cubicBezTo>
                    <a:pt x="29" y="242"/>
                    <a:pt x="63" y="279"/>
                    <a:pt x="117" y="279"/>
                  </a:cubicBezTo>
                  <a:cubicBezTo>
                    <a:pt x="142" y="279"/>
                    <a:pt x="167" y="265"/>
                    <a:pt x="167" y="240"/>
                  </a:cubicBezTo>
                  <a:cubicBezTo>
                    <a:pt x="167" y="181"/>
                    <a:pt x="10" y="193"/>
                    <a:pt x="10" y="90"/>
                  </a:cubicBezTo>
                  <a:cubicBezTo>
                    <a:pt x="10" y="33"/>
                    <a:pt x="60" y="0"/>
                    <a:pt x="121" y="0"/>
                  </a:cubicBezTo>
                  <a:cubicBezTo>
                    <a:pt x="188" y="0"/>
                    <a:pt x="220" y="35"/>
                    <a:pt x="220" y="35"/>
                  </a:cubicBezTo>
                  <a:cubicBezTo>
                    <a:pt x="196" y="81"/>
                    <a:pt x="196" y="81"/>
                    <a:pt x="196" y="81"/>
                  </a:cubicBezTo>
                  <a:cubicBezTo>
                    <a:pt x="196" y="81"/>
                    <a:pt x="169" y="53"/>
                    <a:pt x="120" y="53"/>
                  </a:cubicBezTo>
                  <a:cubicBezTo>
                    <a:pt x="95" y="53"/>
                    <a:pt x="70" y="64"/>
                    <a:pt x="70" y="91"/>
                  </a:cubicBezTo>
                  <a:cubicBezTo>
                    <a:pt x="70" y="148"/>
                    <a:pt x="227" y="136"/>
                    <a:pt x="227" y="240"/>
                  </a:cubicBezTo>
                  <a:cubicBezTo>
                    <a:pt x="227" y="292"/>
                    <a:pt x="184" y="332"/>
                    <a:pt x="117" y="332"/>
                  </a:cubicBezTo>
                  <a:cubicBezTo>
                    <a:pt x="42" y="332"/>
                    <a:pt x="0" y="285"/>
                    <a:pt x="0" y="285"/>
                  </a:cubicBezTo>
                  <a:lnTo>
                    <a:pt x="29" y="242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7857EA7D-91C5-B24F-8F50-251B29756864}"/>
                </a:ext>
              </a:extLst>
            </p:cNvPr>
            <p:cNvSpPr>
              <a:spLocks/>
            </p:cNvSpPr>
            <p:nvPr/>
          </p:nvSpPr>
          <p:spPr bwMode="auto">
            <a:xfrm>
              <a:off x="8774113" y="1906588"/>
              <a:ext cx="542925" cy="631825"/>
            </a:xfrm>
            <a:custGeom>
              <a:avLst/>
              <a:gdLst>
                <a:gd name="T0" fmla="*/ 164 w 286"/>
                <a:gd name="T1" fmla="*/ 0 h 332"/>
                <a:gd name="T2" fmla="*/ 279 w 286"/>
                <a:gd name="T3" fmla="*/ 46 h 332"/>
                <a:gd name="T4" fmla="*/ 251 w 286"/>
                <a:gd name="T5" fmla="*/ 89 h 332"/>
                <a:gd name="T6" fmla="*/ 166 w 286"/>
                <a:gd name="T7" fmla="*/ 53 h 332"/>
                <a:gd name="T8" fmla="*/ 60 w 286"/>
                <a:gd name="T9" fmla="*/ 165 h 332"/>
                <a:gd name="T10" fmla="*/ 168 w 286"/>
                <a:gd name="T11" fmla="*/ 279 h 332"/>
                <a:gd name="T12" fmla="*/ 263 w 286"/>
                <a:gd name="T13" fmla="*/ 237 h 332"/>
                <a:gd name="T14" fmla="*/ 286 w 286"/>
                <a:gd name="T15" fmla="*/ 281 h 332"/>
                <a:gd name="T16" fmla="*/ 164 w 286"/>
                <a:gd name="T17" fmla="*/ 332 h 332"/>
                <a:gd name="T18" fmla="*/ 0 w 286"/>
                <a:gd name="T19" fmla="*/ 166 h 332"/>
                <a:gd name="T20" fmla="*/ 164 w 286"/>
                <a:gd name="T21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286" h="332">
                  <a:moveTo>
                    <a:pt x="164" y="0"/>
                  </a:moveTo>
                  <a:cubicBezTo>
                    <a:pt x="241" y="0"/>
                    <a:pt x="279" y="46"/>
                    <a:pt x="279" y="46"/>
                  </a:cubicBezTo>
                  <a:cubicBezTo>
                    <a:pt x="251" y="89"/>
                    <a:pt x="251" y="89"/>
                    <a:pt x="251" y="89"/>
                  </a:cubicBezTo>
                  <a:cubicBezTo>
                    <a:pt x="251" y="89"/>
                    <a:pt x="218" y="53"/>
                    <a:pt x="166" y="53"/>
                  </a:cubicBezTo>
                  <a:cubicBezTo>
                    <a:pt x="105" y="53"/>
                    <a:pt x="60" y="100"/>
                    <a:pt x="60" y="165"/>
                  </a:cubicBezTo>
                  <a:cubicBezTo>
                    <a:pt x="60" y="230"/>
                    <a:pt x="105" y="279"/>
                    <a:pt x="168" y="279"/>
                  </a:cubicBezTo>
                  <a:cubicBezTo>
                    <a:pt x="225" y="279"/>
                    <a:pt x="263" y="237"/>
                    <a:pt x="263" y="237"/>
                  </a:cubicBezTo>
                  <a:cubicBezTo>
                    <a:pt x="286" y="281"/>
                    <a:pt x="286" y="281"/>
                    <a:pt x="286" y="281"/>
                  </a:cubicBezTo>
                  <a:cubicBezTo>
                    <a:pt x="286" y="281"/>
                    <a:pt x="244" y="332"/>
                    <a:pt x="164" y="332"/>
                  </a:cubicBezTo>
                  <a:cubicBezTo>
                    <a:pt x="68" y="332"/>
                    <a:pt x="0" y="261"/>
                    <a:pt x="0" y="166"/>
                  </a:cubicBezTo>
                  <a:cubicBezTo>
                    <a:pt x="0" y="72"/>
                    <a:pt x="68" y="0"/>
                    <a:pt x="164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EA56B0C7-278A-A549-84B8-864480E9940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388476" y="1682751"/>
              <a:ext cx="114300" cy="839788"/>
            </a:xfrm>
            <a:custGeom>
              <a:avLst/>
              <a:gdLst>
                <a:gd name="T0" fmla="*/ 1 w 72"/>
                <a:gd name="T1" fmla="*/ 150 h 529"/>
                <a:gd name="T2" fmla="*/ 72 w 72"/>
                <a:gd name="T3" fmla="*/ 150 h 529"/>
                <a:gd name="T4" fmla="*/ 72 w 72"/>
                <a:gd name="T5" fmla="*/ 529 h 529"/>
                <a:gd name="T6" fmla="*/ 1 w 72"/>
                <a:gd name="T7" fmla="*/ 529 h 529"/>
                <a:gd name="T8" fmla="*/ 1 w 72"/>
                <a:gd name="T9" fmla="*/ 150 h 529"/>
                <a:gd name="T10" fmla="*/ 0 w 72"/>
                <a:gd name="T11" fmla="*/ 0 h 529"/>
                <a:gd name="T12" fmla="*/ 72 w 72"/>
                <a:gd name="T13" fmla="*/ 0 h 529"/>
                <a:gd name="T14" fmla="*/ 72 w 72"/>
                <a:gd name="T15" fmla="*/ 74 h 529"/>
                <a:gd name="T16" fmla="*/ 0 w 72"/>
                <a:gd name="T17" fmla="*/ 74 h 529"/>
                <a:gd name="T18" fmla="*/ 0 w 72"/>
                <a:gd name="T19" fmla="*/ 0 h 5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72" h="529">
                  <a:moveTo>
                    <a:pt x="1" y="150"/>
                  </a:moveTo>
                  <a:lnTo>
                    <a:pt x="72" y="150"/>
                  </a:lnTo>
                  <a:lnTo>
                    <a:pt x="72" y="529"/>
                  </a:lnTo>
                  <a:lnTo>
                    <a:pt x="1" y="529"/>
                  </a:lnTo>
                  <a:lnTo>
                    <a:pt x="1" y="150"/>
                  </a:lnTo>
                  <a:close/>
                  <a:moveTo>
                    <a:pt x="0" y="0"/>
                  </a:moveTo>
                  <a:lnTo>
                    <a:pt x="72" y="0"/>
                  </a:lnTo>
                  <a:lnTo>
                    <a:pt x="72" y="74"/>
                  </a:lnTo>
                  <a:lnTo>
                    <a:pt x="0" y="74"/>
                  </a:lnTo>
                  <a:lnTo>
                    <a:pt x="0" y="0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22F1BCF1-82B8-AA4A-8EEA-4982D0AB57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593263" y="1906588"/>
              <a:ext cx="541338" cy="631825"/>
            </a:xfrm>
            <a:custGeom>
              <a:avLst/>
              <a:gdLst>
                <a:gd name="T0" fmla="*/ 225 w 285"/>
                <a:gd name="T1" fmla="*/ 129 h 332"/>
                <a:gd name="T2" fmla="*/ 151 w 285"/>
                <a:gd name="T3" fmla="*/ 48 h 332"/>
                <a:gd name="T4" fmla="*/ 62 w 285"/>
                <a:gd name="T5" fmla="*/ 129 h 332"/>
                <a:gd name="T6" fmla="*/ 225 w 285"/>
                <a:gd name="T7" fmla="*/ 129 h 332"/>
                <a:gd name="T8" fmla="*/ 153 w 285"/>
                <a:gd name="T9" fmla="*/ 0 h 332"/>
                <a:gd name="T10" fmla="*/ 285 w 285"/>
                <a:gd name="T11" fmla="*/ 148 h 332"/>
                <a:gd name="T12" fmla="*/ 283 w 285"/>
                <a:gd name="T13" fmla="*/ 175 h 332"/>
                <a:gd name="T14" fmla="*/ 60 w 285"/>
                <a:gd name="T15" fmla="*/ 175 h 332"/>
                <a:gd name="T16" fmla="*/ 165 w 285"/>
                <a:gd name="T17" fmla="*/ 279 h 332"/>
                <a:gd name="T18" fmla="*/ 256 w 285"/>
                <a:gd name="T19" fmla="*/ 242 h 332"/>
                <a:gd name="T20" fmla="*/ 280 w 285"/>
                <a:gd name="T21" fmla="*/ 287 h 332"/>
                <a:gd name="T22" fmla="*/ 162 w 285"/>
                <a:gd name="T23" fmla="*/ 332 h 332"/>
                <a:gd name="T24" fmla="*/ 0 w 285"/>
                <a:gd name="T25" fmla="*/ 166 h 332"/>
                <a:gd name="T26" fmla="*/ 153 w 285"/>
                <a:gd name="T27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85" h="332">
                  <a:moveTo>
                    <a:pt x="225" y="129"/>
                  </a:moveTo>
                  <a:cubicBezTo>
                    <a:pt x="223" y="75"/>
                    <a:pt x="191" y="48"/>
                    <a:pt x="151" y="48"/>
                  </a:cubicBezTo>
                  <a:cubicBezTo>
                    <a:pt x="107" y="48"/>
                    <a:pt x="70" y="77"/>
                    <a:pt x="62" y="129"/>
                  </a:cubicBezTo>
                  <a:lnTo>
                    <a:pt x="225" y="129"/>
                  </a:lnTo>
                  <a:close/>
                  <a:moveTo>
                    <a:pt x="153" y="0"/>
                  </a:moveTo>
                  <a:cubicBezTo>
                    <a:pt x="239" y="0"/>
                    <a:pt x="285" y="66"/>
                    <a:pt x="285" y="148"/>
                  </a:cubicBezTo>
                  <a:cubicBezTo>
                    <a:pt x="285" y="156"/>
                    <a:pt x="283" y="175"/>
                    <a:pt x="283" y="175"/>
                  </a:cubicBezTo>
                  <a:cubicBezTo>
                    <a:pt x="60" y="175"/>
                    <a:pt x="60" y="175"/>
                    <a:pt x="60" y="175"/>
                  </a:cubicBezTo>
                  <a:cubicBezTo>
                    <a:pt x="63" y="244"/>
                    <a:pt x="111" y="279"/>
                    <a:pt x="165" y="279"/>
                  </a:cubicBezTo>
                  <a:cubicBezTo>
                    <a:pt x="218" y="279"/>
                    <a:pt x="256" y="242"/>
                    <a:pt x="256" y="242"/>
                  </a:cubicBezTo>
                  <a:cubicBezTo>
                    <a:pt x="280" y="287"/>
                    <a:pt x="280" y="287"/>
                    <a:pt x="280" y="287"/>
                  </a:cubicBezTo>
                  <a:cubicBezTo>
                    <a:pt x="280" y="287"/>
                    <a:pt x="235" y="332"/>
                    <a:pt x="162" y="332"/>
                  </a:cubicBezTo>
                  <a:cubicBezTo>
                    <a:pt x="65" y="332"/>
                    <a:pt x="0" y="260"/>
                    <a:pt x="0" y="166"/>
                  </a:cubicBezTo>
                  <a:cubicBezTo>
                    <a:pt x="0" y="65"/>
                    <a:pt x="65" y="0"/>
                    <a:pt x="153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50173989-5FDB-634F-A96D-F08DD912D7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29851" y="1906588"/>
              <a:ext cx="525463" cy="615950"/>
            </a:xfrm>
            <a:custGeom>
              <a:avLst/>
              <a:gdLst>
                <a:gd name="T0" fmla="*/ 0 w 277"/>
                <a:gd name="T1" fmla="*/ 8 h 324"/>
                <a:gd name="T2" fmla="*/ 57 w 277"/>
                <a:gd name="T3" fmla="*/ 8 h 324"/>
                <a:gd name="T4" fmla="*/ 57 w 277"/>
                <a:gd name="T5" fmla="*/ 50 h 324"/>
                <a:gd name="T6" fmla="*/ 56 w 277"/>
                <a:gd name="T7" fmla="*/ 73 h 324"/>
                <a:gd name="T8" fmla="*/ 57 w 277"/>
                <a:gd name="T9" fmla="*/ 73 h 324"/>
                <a:gd name="T10" fmla="*/ 172 w 277"/>
                <a:gd name="T11" fmla="*/ 0 h 324"/>
                <a:gd name="T12" fmla="*/ 277 w 277"/>
                <a:gd name="T13" fmla="*/ 122 h 324"/>
                <a:gd name="T14" fmla="*/ 277 w 277"/>
                <a:gd name="T15" fmla="*/ 324 h 324"/>
                <a:gd name="T16" fmla="*/ 218 w 277"/>
                <a:gd name="T17" fmla="*/ 324 h 324"/>
                <a:gd name="T18" fmla="*/ 218 w 277"/>
                <a:gd name="T19" fmla="*/ 135 h 324"/>
                <a:gd name="T20" fmla="*/ 160 w 277"/>
                <a:gd name="T21" fmla="*/ 56 h 324"/>
                <a:gd name="T22" fmla="*/ 63 w 277"/>
                <a:gd name="T23" fmla="*/ 133 h 324"/>
                <a:gd name="T24" fmla="*/ 59 w 277"/>
                <a:gd name="T25" fmla="*/ 176 h 324"/>
                <a:gd name="T26" fmla="*/ 59 w 277"/>
                <a:gd name="T27" fmla="*/ 324 h 324"/>
                <a:gd name="T28" fmla="*/ 0 w 277"/>
                <a:gd name="T29" fmla="*/ 324 h 324"/>
                <a:gd name="T30" fmla="*/ 0 w 277"/>
                <a:gd name="T31" fmla="*/ 8 h 3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77" h="324">
                  <a:moveTo>
                    <a:pt x="0" y="8"/>
                  </a:moveTo>
                  <a:cubicBezTo>
                    <a:pt x="57" y="8"/>
                    <a:pt x="57" y="8"/>
                    <a:pt x="57" y="8"/>
                  </a:cubicBezTo>
                  <a:cubicBezTo>
                    <a:pt x="57" y="50"/>
                    <a:pt x="57" y="50"/>
                    <a:pt x="57" y="50"/>
                  </a:cubicBezTo>
                  <a:cubicBezTo>
                    <a:pt x="57" y="62"/>
                    <a:pt x="56" y="73"/>
                    <a:pt x="56" y="73"/>
                  </a:cubicBezTo>
                  <a:cubicBezTo>
                    <a:pt x="57" y="73"/>
                    <a:pt x="57" y="73"/>
                    <a:pt x="57" y="73"/>
                  </a:cubicBezTo>
                  <a:cubicBezTo>
                    <a:pt x="69" y="45"/>
                    <a:pt x="105" y="0"/>
                    <a:pt x="172" y="0"/>
                  </a:cubicBezTo>
                  <a:cubicBezTo>
                    <a:pt x="244" y="0"/>
                    <a:pt x="277" y="41"/>
                    <a:pt x="277" y="122"/>
                  </a:cubicBezTo>
                  <a:cubicBezTo>
                    <a:pt x="277" y="324"/>
                    <a:pt x="277" y="324"/>
                    <a:pt x="277" y="324"/>
                  </a:cubicBezTo>
                  <a:cubicBezTo>
                    <a:pt x="218" y="324"/>
                    <a:pt x="218" y="324"/>
                    <a:pt x="218" y="324"/>
                  </a:cubicBezTo>
                  <a:cubicBezTo>
                    <a:pt x="218" y="135"/>
                    <a:pt x="218" y="135"/>
                    <a:pt x="218" y="135"/>
                  </a:cubicBezTo>
                  <a:cubicBezTo>
                    <a:pt x="218" y="91"/>
                    <a:pt x="209" y="56"/>
                    <a:pt x="160" y="56"/>
                  </a:cubicBezTo>
                  <a:cubicBezTo>
                    <a:pt x="114" y="56"/>
                    <a:pt x="76" y="88"/>
                    <a:pt x="63" y="133"/>
                  </a:cubicBezTo>
                  <a:cubicBezTo>
                    <a:pt x="60" y="146"/>
                    <a:pt x="59" y="160"/>
                    <a:pt x="59" y="176"/>
                  </a:cubicBezTo>
                  <a:cubicBezTo>
                    <a:pt x="59" y="324"/>
                    <a:pt x="59" y="324"/>
                    <a:pt x="59" y="324"/>
                  </a:cubicBezTo>
                  <a:cubicBezTo>
                    <a:pt x="0" y="324"/>
                    <a:pt x="0" y="324"/>
                    <a:pt x="0" y="324"/>
                  </a:cubicBezTo>
                  <a:lnTo>
                    <a:pt x="0" y="8"/>
                  </a:lnTo>
                  <a:close/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4CC31D51-26ED-D741-B326-C6F6C4B537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39451" y="1906588"/>
              <a:ext cx="542925" cy="631825"/>
            </a:xfrm>
            <a:custGeom>
              <a:avLst/>
              <a:gdLst>
                <a:gd name="T0" fmla="*/ 164 w 286"/>
                <a:gd name="T1" fmla="*/ 0 h 332"/>
                <a:gd name="T2" fmla="*/ 279 w 286"/>
                <a:gd name="T3" fmla="*/ 46 h 332"/>
                <a:gd name="T4" fmla="*/ 251 w 286"/>
                <a:gd name="T5" fmla="*/ 89 h 332"/>
                <a:gd name="T6" fmla="*/ 166 w 286"/>
                <a:gd name="T7" fmla="*/ 53 h 332"/>
                <a:gd name="T8" fmla="*/ 60 w 286"/>
                <a:gd name="T9" fmla="*/ 165 h 332"/>
                <a:gd name="T10" fmla="*/ 168 w 286"/>
                <a:gd name="T11" fmla="*/ 279 h 332"/>
                <a:gd name="T12" fmla="*/ 263 w 286"/>
                <a:gd name="T13" fmla="*/ 237 h 332"/>
                <a:gd name="T14" fmla="*/ 286 w 286"/>
                <a:gd name="T15" fmla="*/ 281 h 332"/>
                <a:gd name="T16" fmla="*/ 164 w 286"/>
                <a:gd name="T17" fmla="*/ 332 h 332"/>
                <a:gd name="T18" fmla="*/ 0 w 286"/>
                <a:gd name="T19" fmla="*/ 166 h 332"/>
                <a:gd name="T20" fmla="*/ 164 w 286"/>
                <a:gd name="T21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286" h="332">
                  <a:moveTo>
                    <a:pt x="164" y="0"/>
                  </a:moveTo>
                  <a:cubicBezTo>
                    <a:pt x="241" y="0"/>
                    <a:pt x="279" y="46"/>
                    <a:pt x="279" y="46"/>
                  </a:cubicBezTo>
                  <a:cubicBezTo>
                    <a:pt x="251" y="89"/>
                    <a:pt x="251" y="89"/>
                    <a:pt x="251" y="89"/>
                  </a:cubicBezTo>
                  <a:cubicBezTo>
                    <a:pt x="251" y="89"/>
                    <a:pt x="218" y="53"/>
                    <a:pt x="166" y="53"/>
                  </a:cubicBezTo>
                  <a:cubicBezTo>
                    <a:pt x="105" y="53"/>
                    <a:pt x="60" y="100"/>
                    <a:pt x="60" y="165"/>
                  </a:cubicBezTo>
                  <a:cubicBezTo>
                    <a:pt x="60" y="230"/>
                    <a:pt x="105" y="279"/>
                    <a:pt x="168" y="279"/>
                  </a:cubicBezTo>
                  <a:cubicBezTo>
                    <a:pt x="225" y="279"/>
                    <a:pt x="263" y="237"/>
                    <a:pt x="263" y="237"/>
                  </a:cubicBezTo>
                  <a:cubicBezTo>
                    <a:pt x="286" y="281"/>
                    <a:pt x="286" y="281"/>
                    <a:pt x="286" y="281"/>
                  </a:cubicBezTo>
                  <a:cubicBezTo>
                    <a:pt x="286" y="281"/>
                    <a:pt x="244" y="332"/>
                    <a:pt x="164" y="332"/>
                  </a:cubicBezTo>
                  <a:cubicBezTo>
                    <a:pt x="68" y="332"/>
                    <a:pt x="0" y="261"/>
                    <a:pt x="0" y="166"/>
                  </a:cubicBezTo>
                  <a:cubicBezTo>
                    <a:pt x="0" y="72"/>
                    <a:pt x="68" y="0"/>
                    <a:pt x="164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3E0F7171-006D-8341-8A15-A0D155D4DB2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1409363" y="1906588"/>
              <a:ext cx="541338" cy="631825"/>
            </a:xfrm>
            <a:custGeom>
              <a:avLst/>
              <a:gdLst>
                <a:gd name="T0" fmla="*/ 225 w 285"/>
                <a:gd name="T1" fmla="*/ 129 h 332"/>
                <a:gd name="T2" fmla="*/ 152 w 285"/>
                <a:gd name="T3" fmla="*/ 48 h 332"/>
                <a:gd name="T4" fmla="*/ 62 w 285"/>
                <a:gd name="T5" fmla="*/ 129 h 332"/>
                <a:gd name="T6" fmla="*/ 225 w 285"/>
                <a:gd name="T7" fmla="*/ 129 h 332"/>
                <a:gd name="T8" fmla="*/ 153 w 285"/>
                <a:gd name="T9" fmla="*/ 0 h 332"/>
                <a:gd name="T10" fmla="*/ 285 w 285"/>
                <a:gd name="T11" fmla="*/ 148 h 332"/>
                <a:gd name="T12" fmla="*/ 284 w 285"/>
                <a:gd name="T13" fmla="*/ 175 h 332"/>
                <a:gd name="T14" fmla="*/ 60 w 285"/>
                <a:gd name="T15" fmla="*/ 175 h 332"/>
                <a:gd name="T16" fmla="*/ 166 w 285"/>
                <a:gd name="T17" fmla="*/ 279 h 332"/>
                <a:gd name="T18" fmla="*/ 256 w 285"/>
                <a:gd name="T19" fmla="*/ 242 h 332"/>
                <a:gd name="T20" fmla="*/ 281 w 285"/>
                <a:gd name="T21" fmla="*/ 287 h 332"/>
                <a:gd name="T22" fmla="*/ 162 w 285"/>
                <a:gd name="T23" fmla="*/ 332 h 332"/>
                <a:gd name="T24" fmla="*/ 0 w 285"/>
                <a:gd name="T25" fmla="*/ 166 h 332"/>
                <a:gd name="T26" fmla="*/ 153 w 285"/>
                <a:gd name="T27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85" h="332">
                  <a:moveTo>
                    <a:pt x="225" y="129"/>
                  </a:moveTo>
                  <a:cubicBezTo>
                    <a:pt x="224" y="75"/>
                    <a:pt x="191" y="48"/>
                    <a:pt x="152" y="48"/>
                  </a:cubicBezTo>
                  <a:cubicBezTo>
                    <a:pt x="107" y="48"/>
                    <a:pt x="71" y="77"/>
                    <a:pt x="62" y="129"/>
                  </a:cubicBezTo>
                  <a:lnTo>
                    <a:pt x="225" y="129"/>
                  </a:lnTo>
                  <a:close/>
                  <a:moveTo>
                    <a:pt x="153" y="0"/>
                  </a:moveTo>
                  <a:cubicBezTo>
                    <a:pt x="239" y="0"/>
                    <a:pt x="285" y="66"/>
                    <a:pt x="285" y="148"/>
                  </a:cubicBezTo>
                  <a:cubicBezTo>
                    <a:pt x="285" y="156"/>
                    <a:pt x="284" y="175"/>
                    <a:pt x="284" y="175"/>
                  </a:cubicBezTo>
                  <a:cubicBezTo>
                    <a:pt x="60" y="175"/>
                    <a:pt x="60" y="175"/>
                    <a:pt x="60" y="175"/>
                  </a:cubicBezTo>
                  <a:cubicBezTo>
                    <a:pt x="63" y="244"/>
                    <a:pt x="111" y="279"/>
                    <a:pt x="166" y="279"/>
                  </a:cubicBezTo>
                  <a:cubicBezTo>
                    <a:pt x="218" y="279"/>
                    <a:pt x="256" y="242"/>
                    <a:pt x="256" y="242"/>
                  </a:cubicBezTo>
                  <a:cubicBezTo>
                    <a:pt x="281" y="287"/>
                    <a:pt x="281" y="287"/>
                    <a:pt x="281" y="287"/>
                  </a:cubicBezTo>
                  <a:cubicBezTo>
                    <a:pt x="281" y="287"/>
                    <a:pt x="235" y="332"/>
                    <a:pt x="162" y="332"/>
                  </a:cubicBezTo>
                  <a:cubicBezTo>
                    <a:pt x="66" y="332"/>
                    <a:pt x="0" y="260"/>
                    <a:pt x="0" y="166"/>
                  </a:cubicBezTo>
                  <a:cubicBezTo>
                    <a:pt x="0" y="65"/>
                    <a:pt x="66" y="0"/>
                    <a:pt x="153" y="0"/>
                  </a:cubicBezTo>
                </a:path>
              </a:pathLst>
            </a:cu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A0F74615-2584-7846-9F1F-D25B1552C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44363" y="2401888"/>
              <a:ext cx="117475" cy="120650"/>
            </a:xfrm>
            <a:prstGeom prst="rect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 baseline="0"/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5CAA4F8F-E996-B147-87AD-875344BC224A}"/>
              </a:ext>
            </a:extLst>
          </p:cNvPr>
          <p:cNvGrpSpPr/>
          <p:nvPr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4BD0580-69B4-F34E-8311-1911C864A523}"/>
                </a:ext>
              </a:extLst>
            </p:cNvPr>
            <p:cNvSpPr txBox="1"/>
            <p:nvPr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5DC71938-0B18-FF49-AB6E-0A1E9E1936D2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E581B04C-6E0C-7646-907B-615E7E17093A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" name="Freeform 5">
            <a:extLst>
              <a:ext uri="{FF2B5EF4-FFF2-40B4-BE49-F238E27FC236}">
                <a16:creationId xmlns:a16="http://schemas.microsoft.com/office/drawing/2014/main" id="{D35013EA-8F1C-B648-8834-E618C821201D}"/>
              </a:ext>
            </a:extLst>
          </p:cNvPr>
          <p:cNvSpPr>
            <a:spLocks/>
          </p:cNvSpPr>
          <p:nvPr userDrawn="1"/>
        </p:nvSpPr>
        <p:spPr bwMode="auto">
          <a:xfrm flipH="1">
            <a:off x="1394" y="2234873"/>
            <a:ext cx="4578351" cy="4622935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C9B1E07-5CFC-E84C-BF61-CAD19D8A0185}"/>
              </a:ext>
            </a:extLst>
          </p:cNvPr>
          <p:cNvSpPr txBox="1"/>
          <p:nvPr userDrawn="1"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145A7A15-11D8-D142-A180-53697E13CFA8}"/>
              </a:ext>
            </a:extLst>
          </p:cNvPr>
          <p:cNvGrpSpPr/>
          <p:nvPr userDrawn="1"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617D4F3D-B2C7-4A45-A62F-012D39F40B45}"/>
                </a:ext>
              </a:extLst>
            </p:cNvPr>
            <p:cNvSpPr txBox="1"/>
            <p:nvPr userDrawn="1"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7C83294B-A11A-7D4D-9E0E-B05053C63C00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A3B427D0-EA25-0F41-862E-0E2FB898A5EF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2" name="Graphic 111">
            <a:extLst>
              <a:ext uri="{FF2B5EF4-FFF2-40B4-BE49-F238E27FC236}">
                <a16:creationId xmlns:a16="http://schemas.microsoft.com/office/drawing/2014/main" id="{27785070-3913-2E47-A65B-E287C1C09763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70163" y="6213912"/>
            <a:ext cx="1996068" cy="644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30559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vider w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4D3F-14BD-1040-8A81-A75FE65A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50988" y="1635462"/>
            <a:ext cx="5114597" cy="898708"/>
          </a:xfrm>
        </p:spPr>
        <p:txBody>
          <a:bodyPr wrap="square" anchor="b">
            <a:sp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9EA25FCE-E0FB-6746-8D6E-F7317D200228}"/>
              </a:ext>
            </a:extLst>
          </p:cNvPr>
          <p:cNvGrpSpPr/>
          <p:nvPr/>
        </p:nvGrpSpPr>
        <p:grpSpPr>
          <a:xfrm>
            <a:off x="6057785" y="3509737"/>
            <a:ext cx="593203" cy="975172"/>
            <a:chOff x="6110794" y="3712667"/>
            <a:chExt cx="604094" cy="1022367"/>
          </a:xfrm>
        </p:grpSpPr>
        <p:sp>
          <p:nvSpPr>
            <p:cNvPr id="9" name="Freeform 5">
              <a:extLst>
                <a:ext uri="{FF2B5EF4-FFF2-40B4-BE49-F238E27FC236}">
                  <a16:creationId xmlns:a16="http://schemas.microsoft.com/office/drawing/2014/main" id="{C1D28AFC-691E-A84B-B253-C2E6EBA96530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0" name="Freeform 6">
              <a:extLst>
                <a:ext uri="{FF2B5EF4-FFF2-40B4-BE49-F238E27FC236}">
                  <a16:creationId xmlns:a16="http://schemas.microsoft.com/office/drawing/2014/main" id="{1E53D310-7F49-8844-B536-B5E23035A4A3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1" name="Freeform 7">
              <a:extLst>
                <a:ext uri="{FF2B5EF4-FFF2-40B4-BE49-F238E27FC236}">
                  <a16:creationId xmlns:a16="http://schemas.microsoft.com/office/drawing/2014/main" id="{B948D674-5FC9-6A41-9EBC-CBD09BFC8C4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2" name="Freeform 10">
              <a:extLst>
                <a:ext uri="{FF2B5EF4-FFF2-40B4-BE49-F238E27FC236}">
                  <a16:creationId xmlns:a16="http://schemas.microsoft.com/office/drawing/2014/main" id="{1E5203ED-D85F-4F49-9880-D662420577BD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3" name="Freeform 11">
              <a:extLst>
                <a:ext uri="{FF2B5EF4-FFF2-40B4-BE49-F238E27FC236}">
                  <a16:creationId xmlns:a16="http://schemas.microsoft.com/office/drawing/2014/main" id="{7C4A71DB-93FE-B249-B34A-606A82475D3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4" name="Freeform 12">
              <a:extLst>
                <a:ext uri="{FF2B5EF4-FFF2-40B4-BE49-F238E27FC236}">
                  <a16:creationId xmlns:a16="http://schemas.microsoft.com/office/drawing/2014/main" id="{2AE16C31-BDC5-E344-9877-FCA28EF4F5E3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5" name="Freeform 15">
              <a:extLst>
                <a:ext uri="{FF2B5EF4-FFF2-40B4-BE49-F238E27FC236}">
                  <a16:creationId xmlns:a16="http://schemas.microsoft.com/office/drawing/2014/main" id="{66503F38-0FFA-A04B-922D-26BE538F6E02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id="{DEA12EF2-91CC-8D42-9823-B16D528E2A03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F2D2D9EB-7B28-FF47-A08A-0B38EE5FA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8" name="Freeform 20">
              <a:extLst>
                <a:ext uri="{FF2B5EF4-FFF2-40B4-BE49-F238E27FC236}">
                  <a16:creationId xmlns:a16="http://schemas.microsoft.com/office/drawing/2014/main" id="{12031F8B-BF64-2B49-9A2C-56AC025F4A21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9" name="Freeform 21">
              <a:extLst>
                <a:ext uri="{FF2B5EF4-FFF2-40B4-BE49-F238E27FC236}">
                  <a16:creationId xmlns:a16="http://schemas.microsoft.com/office/drawing/2014/main" id="{6B3B3596-2B68-104A-B352-2C13698369CF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0" name="Freeform 22">
              <a:extLst>
                <a:ext uri="{FF2B5EF4-FFF2-40B4-BE49-F238E27FC236}">
                  <a16:creationId xmlns:a16="http://schemas.microsoft.com/office/drawing/2014/main" id="{869C5B73-3D9B-8347-8913-120A3BA9937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1" name="Freeform 25">
              <a:extLst>
                <a:ext uri="{FF2B5EF4-FFF2-40B4-BE49-F238E27FC236}">
                  <a16:creationId xmlns:a16="http://schemas.microsoft.com/office/drawing/2014/main" id="{31B97D44-E645-4647-9566-C5212128CF97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2" name="Freeform 26">
              <a:extLst>
                <a:ext uri="{FF2B5EF4-FFF2-40B4-BE49-F238E27FC236}">
                  <a16:creationId xmlns:a16="http://schemas.microsoft.com/office/drawing/2014/main" id="{2F2EA29D-1801-4B4D-9110-F5D4C9514F35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3" name="Freeform 27">
              <a:extLst>
                <a:ext uri="{FF2B5EF4-FFF2-40B4-BE49-F238E27FC236}">
                  <a16:creationId xmlns:a16="http://schemas.microsoft.com/office/drawing/2014/main" id="{4D01950D-2B09-2945-80E1-9A85F78BDE5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</p:grpSp>
      <p:sp>
        <p:nvSpPr>
          <p:cNvPr id="24" name="Picture Placeholder 38">
            <a:extLst>
              <a:ext uri="{FF2B5EF4-FFF2-40B4-BE49-F238E27FC236}">
                <a16:creationId xmlns:a16="http://schemas.microsoft.com/office/drawing/2014/main" id="{3AD6F89A-BE59-3D46-8D99-972CD940DFD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07988" y="341033"/>
            <a:ext cx="5640448" cy="5761039"/>
          </a:xfrm>
          <a:custGeom>
            <a:avLst/>
            <a:gdLst>
              <a:gd name="connsiteX0" fmla="*/ 5334786 w 5723503"/>
              <a:gd name="connsiteY0" fmla="*/ 4202324 h 6079105"/>
              <a:gd name="connsiteX1" fmla="*/ 5477176 w 5723503"/>
              <a:gd name="connsiteY1" fmla="*/ 4202324 h 6079105"/>
              <a:gd name="connsiteX2" fmla="*/ 5477176 w 5723503"/>
              <a:gd name="connsiteY2" fmla="*/ 4342372 h 6079105"/>
              <a:gd name="connsiteX3" fmla="*/ 5334786 w 5723503"/>
              <a:gd name="connsiteY3" fmla="*/ 4202324 h 6079105"/>
              <a:gd name="connsiteX4" fmla="*/ 5549767 w 5723503"/>
              <a:gd name="connsiteY4" fmla="*/ 4201562 h 6079105"/>
              <a:gd name="connsiteX5" fmla="*/ 5692157 w 5723503"/>
              <a:gd name="connsiteY5" fmla="*/ 4201562 h 6079105"/>
              <a:gd name="connsiteX6" fmla="*/ 5692157 w 5723503"/>
              <a:gd name="connsiteY6" fmla="*/ 4341546 h 6079105"/>
              <a:gd name="connsiteX7" fmla="*/ 5549767 w 5723503"/>
              <a:gd name="connsiteY7" fmla="*/ 4201562 h 6079105"/>
              <a:gd name="connsiteX8" fmla="*/ 5305408 w 5723503"/>
              <a:gd name="connsiteY8" fmla="*/ 4195979 h 6079105"/>
              <a:gd name="connsiteX9" fmla="*/ 5304901 w 5723503"/>
              <a:gd name="connsiteY9" fmla="*/ 4202324 h 6079105"/>
              <a:gd name="connsiteX10" fmla="*/ 5476923 w 5723503"/>
              <a:gd name="connsiteY10" fmla="*/ 4370991 h 6079105"/>
              <a:gd name="connsiteX11" fmla="*/ 5483269 w 5723503"/>
              <a:gd name="connsiteY11" fmla="*/ 4370483 h 6079105"/>
              <a:gd name="connsiteX12" fmla="*/ 5483078 w 5723503"/>
              <a:gd name="connsiteY12" fmla="*/ 4195979 h 6079105"/>
              <a:gd name="connsiteX13" fmla="*/ 5520960 w 5723503"/>
              <a:gd name="connsiteY13" fmla="*/ 4195154 h 6079105"/>
              <a:gd name="connsiteX14" fmla="*/ 5520452 w 5723503"/>
              <a:gd name="connsiteY14" fmla="*/ 4201499 h 6079105"/>
              <a:gd name="connsiteX15" fmla="*/ 5691904 w 5723503"/>
              <a:gd name="connsiteY15" fmla="*/ 4370230 h 6079105"/>
              <a:gd name="connsiteX16" fmla="*/ 5698249 w 5723503"/>
              <a:gd name="connsiteY16" fmla="*/ 4369785 h 6079105"/>
              <a:gd name="connsiteX17" fmla="*/ 5698630 w 5723503"/>
              <a:gd name="connsiteY17" fmla="*/ 4195154 h 6079105"/>
              <a:gd name="connsiteX18" fmla="*/ 5333264 w 5723503"/>
              <a:gd name="connsiteY18" fmla="*/ 3985811 h 6079105"/>
              <a:gd name="connsiteX19" fmla="*/ 5475654 w 5723503"/>
              <a:gd name="connsiteY19" fmla="*/ 3985811 h 6079105"/>
              <a:gd name="connsiteX20" fmla="*/ 5475654 w 5723503"/>
              <a:gd name="connsiteY20" fmla="*/ 4125795 h 6079105"/>
              <a:gd name="connsiteX21" fmla="*/ 5333264 w 5723503"/>
              <a:gd name="connsiteY21" fmla="*/ 3985811 h 6079105"/>
              <a:gd name="connsiteX22" fmla="*/ 5548181 w 5723503"/>
              <a:gd name="connsiteY22" fmla="*/ 3985050 h 6079105"/>
              <a:gd name="connsiteX23" fmla="*/ 5690571 w 5723503"/>
              <a:gd name="connsiteY23" fmla="*/ 3985050 h 6079105"/>
              <a:gd name="connsiteX24" fmla="*/ 5690571 w 5723503"/>
              <a:gd name="connsiteY24" fmla="*/ 4124971 h 6079105"/>
              <a:gd name="connsiteX25" fmla="*/ 5548181 w 5723503"/>
              <a:gd name="connsiteY25" fmla="*/ 3985050 h 6079105"/>
              <a:gd name="connsiteX26" fmla="*/ 5303885 w 5723503"/>
              <a:gd name="connsiteY26" fmla="*/ 3979466 h 6079105"/>
              <a:gd name="connsiteX27" fmla="*/ 5303251 w 5723503"/>
              <a:gd name="connsiteY27" fmla="*/ 3985748 h 6079105"/>
              <a:gd name="connsiteX28" fmla="*/ 5475210 w 5723503"/>
              <a:gd name="connsiteY28" fmla="*/ 4154415 h 6079105"/>
              <a:gd name="connsiteX29" fmla="*/ 5481555 w 5723503"/>
              <a:gd name="connsiteY29" fmla="*/ 4153971 h 6079105"/>
              <a:gd name="connsiteX30" fmla="*/ 5481555 w 5723503"/>
              <a:gd name="connsiteY30" fmla="*/ 3979466 h 6079105"/>
              <a:gd name="connsiteX31" fmla="*/ 5518866 w 5723503"/>
              <a:gd name="connsiteY31" fmla="*/ 3978705 h 6079105"/>
              <a:gd name="connsiteX32" fmla="*/ 5518612 w 5723503"/>
              <a:gd name="connsiteY32" fmla="*/ 3985050 h 6079105"/>
              <a:gd name="connsiteX33" fmla="*/ 5690190 w 5723503"/>
              <a:gd name="connsiteY33" fmla="*/ 4153717 h 6079105"/>
              <a:gd name="connsiteX34" fmla="*/ 5696536 w 5723503"/>
              <a:gd name="connsiteY34" fmla="*/ 4153209 h 6079105"/>
              <a:gd name="connsiteX35" fmla="*/ 5696536 w 5723503"/>
              <a:gd name="connsiteY35" fmla="*/ 3978705 h 6079105"/>
              <a:gd name="connsiteX36" fmla="*/ 5336436 w 5723503"/>
              <a:gd name="connsiteY36" fmla="*/ 3771646 h 6079105"/>
              <a:gd name="connsiteX37" fmla="*/ 5478762 w 5723503"/>
              <a:gd name="connsiteY37" fmla="*/ 3771646 h 6079105"/>
              <a:gd name="connsiteX38" fmla="*/ 5478762 w 5723503"/>
              <a:gd name="connsiteY38" fmla="*/ 3911694 h 6079105"/>
              <a:gd name="connsiteX39" fmla="*/ 5336436 w 5723503"/>
              <a:gd name="connsiteY39" fmla="*/ 3771646 h 6079105"/>
              <a:gd name="connsiteX40" fmla="*/ 5551353 w 5723503"/>
              <a:gd name="connsiteY40" fmla="*/ 3770821 h 6079105"/>
              <a:gd name="connsiteX41" fmla="*/ 5693743 w 5723503"/>
              <a:gd name="connsiteY41" fmla="*/ 3770821 h 6079105"/>
              <a:gd name="connsiteX42" fmla="*/ 5693743 w 5723503"/>
              <a:gd name="connsiteY42" fmla="*/ 3910869 h 6079105"/>
              <a:gd name="connsiteX43" fmla="*/ 5551353 w 5723503"/>
              <a:gd name="connsiteY43" fmla="*/ 3770821 h 6079105"/>
              <a:gd name="connsiteX44" fmla="*/ 5306995 w 5723503"/>
              <a:gd name="connsiteY44" fmla="*/ 3765301 h 6079105"/>
              <a:gd name="connsiteX45" fmla="*/ 5306487 w 5723503"/>
              <a:gd name="connsiteY45" fmla="*/ 3771647 h 6079105"/>
              <a:gd name="connsiteX46" fmla="*/ 5478509 w 5723503"/>
              <a:gd name="connsiteY46" fmla="*/ 3940314 h 6079105"/>
              <a:gd name="connsiteX47" fmla="*/ 5484855 w 5723503"/>
              <a:gd name="connsiteY47" fmla="*/ 3939806 h 6079105"/>
              <a:gd name="connsiteX48" fmla="*/ 5484664 w 5723503"/>
              <a:gd name="connsiteY48" fmla="*/ 3765301 h 6079105"/>
              <a:gd name="connsiteX49" fmla="*/ 5521975 w 5723503"/>
              <a:gd name="connsiteY49" fmla="*/ 3764540 h 6079105"/>
              <a:gd name="connsiteX50" fmla="*/ 5521531 w 5723503"/>
              <a:gd name="connsiteY50" fmla="*/ 3770885 h 6079105"/>
              <a:gd name="connsiteX51" fmla="*/ 5693490 w 5723503"/>
              <a:gd name="connsiteY51" fmla="*/ 3939552 h 6079105"/>
              <a:gd name="connsiteX52" fmla="*/ 5699835 w 5723503"/>
              <a:gd name="connsiteY52" fmla="*/ 3939044 h 6079105"/>
              <a:gd name="connsiteX53" fmla="*/ 5699645 w 5723503"/>
              <a:gd name="connsiteY53" fmla="*/ 3764540 h 6079105"/>
              <a:gd name="connsiteX54" fmla="*/ 5334786 w 5723503"/>
              <a:gd name="connsiteY54" fmla="*/ 3555070 h 6079105"/>
              <a:gd name="connsiteX55" fmla="*/ 5477176 w 5723503"/>
              <a:gd name="connsiteY55" fmla="*/ 3555070 h 6079105"/>
              <a:gd name="connsiteX56" fmla="*/ 5477176 w 5723503"/>
              <a:gd name="connsiteY56" fmla="*/ 3695118 h 6079105"/>
              <a:gd name="connsiteX57" fmla="*/ 5334786 w 5723503"/>
              <a:gd name="connsiteY57" fmla="*/ 3555070 h 6079105"/>
              <a:gd name="connsiteX58" fmla="*/ 5549767 w 5723503"/>
              <a:gd name="connsiteY58" fmla="*/ 3554309 h 6079105"/>
              <a:gd name="connsiteX59" fmla="*/ 5692157 w 5723503"/>
              <a:gd name="connsiteY59" fmla="*/ 3554309 h 6079105"/>
              <a:gd name="connsiteX60" fmla="*/ 5692157 w 5723503"/>
              <a:gd name="connsiteY60" fmla="*/ 3694293 h 6079105"/>
              <a:gd name="connsiteX61" fmla="*/ 5549767 w 5723503"/>
              <a:gd name="connsiteY61" fmla="*/ 3554309 h 6079105"/>
              <a:gd name="connsiteX62" fmla="*/ 5305472 w 5723503"/>
              <a:gd name="connsiteY62" fmla="*/ 3548725 h 6079105"/>
              <a:gd name="connsiteX63" fmla="*/ 5304774 w 5723503"/>
              <a:gd name="connsiteY63" fmla="*/ 3555071 h 6079105"/>
              <a:gd name="connsiteX64" fmla="*/ 5476796 w 5723503"/>
              <a:gd name="connsiteY64" fmla="*/ 3723738 h 6079105"/>
              <a:gd name="connsiteX65" fmla="*/ 5483141 w 5723503"/>
              <a:gd name="connsiteY65" fmla="*/ 3723230 h 6079105"/>
              <a:gd name="connsiteX66" fmla="*/ 5483141 w 5723503"/>
              <a:gd name="connsiteY66" fmla="*/ 3548725 h 6079105"/>
              <a:gd name="connsiteX67" fmla="*/ 5520452 w 5723503"/>
              <a:gd name="connsiteY67" fmla="*/ 3547964 h 6079105"/>
              <a:gd name="connsiteX68" fmla="*/ 5520452 w 5723503"/>
              <a:gd name="connsiteY68" fmla="*/ 3554246 h 6079105"/>
              <a:gd name="connsiteX69" fmla="*/ 5691777 w 5723503"/>
              <a:gd name="connsiteY69" fmla="*/ 3722913 h 6079105"/>
              <a:gd name="connsiteX70" fmla="*/ 5698122 w 5723503"/>
              <a:gd name="connsiteY70" fmla="*/ 3722468 h 6079105"/>
              <a:gd name="connsiteX71" fmla="*/ 5698122 w 5723503"/>
              <a:gd name="connsiteY71" fmla="*/ 3547964 h 6079105"/>
              <a:gd name="connsiteX72" fmla="*/ 5337959 w 5723503"/>
              <a:gd name="connsiteY72" fmla="*/ 3340969 h 6079105"/>
              <a:gd name="connsiteX73" fmla="*/ 5480349 w 5723503"/>
              <a:gd name="connsiteY73" fmla="*/ 3340969 h 6079105"/>
              <a:gd name="connsiteX74" fmla="*/ 5480349 w 5723503"/>
              <a:gd name="connsiteY74" fmla="*/ 3480953 h 6079105"/>
              <a:gd name="connsiteX75" fmla="*/ 5337959 w 5723503"/>
              <a:gd name="connsiteY75" fmla="*/ 3340969 h 6079105"/>
              <a:gd name="connsiteX76" fmla="*/ 5552876 w 5723503"/>
              <a:gd name="connsiteY76" fmla="*/ 3340144 h 6079105"/>
              <a:gd name="connsiteX77" fmla="*/ 5695266 w 5723503"/>
              <a:gd name="connsiteY77" fmla="*/ 3340144 h 6079105"/>
              <a:gd name="connsiteX78" fmla="*/ 5695266 w 5723503"/>
              <a:gd name="connsiteY78" fmla="*/ 3480192 h 6079105"/>
              <a:gd name="connsiteX79" fmla="*/ 5552876 w 5723503"/>
              <a:gd name="connsiteY79" fmla="*/ 3340144 h 6079105"/>
              <a:gd name="connsiteX80" fmla="*/ 5308581 w 5723503"/>
              <a:gd name="connsiteY80" fmla="*/ 3334560 h 6079105"/>
              <a:gd name="connsiteX81" fmla="*/ 5308137 w 5723503"/>
              <a:gd name="connsiteY81" fmla="*/ 3340906 h 6079105"/>
              <a:gd name="connsiteX82" fmla="*/ 5480096 w 5723503"/>
              <a:gd name="connsiteY82" fmla="*/ 3509636 h 6079105"/>
              <a:gd name="connsiteX83" fmla="*/ 5486441 w 5723503"/>
              <a:gd name="connsiteY83" fmla="*/ 3509129 h 6079105"/>
              <a:gd name="connsiteX84" fmla="*/ 5486251 w 5723503"/>
              <a:gd name="connsiteY84" fmla="*/ 3334560 h 6079105"/>
              <a:gd name="connsiteX85" fmla="*/ 5523498 w 5723503"/>
              <a:gd name="connsiteY85" fmla="*/ 3333863 h 6079105"/>
              <a:gd name="connsiteX86" fmla="*/ 5522990 w 5723503"/>
              <a:gd name="connsiteY86" fmla="*/ 3340208 h 6079105"/>
              <a:gd name="connsiteX87" fmla="*/ 5695013 w 5723503"/>
              <a:gd name="connsiteY87" fmla="*/ 3508875 h 6079105"/>
              <a:gd name="connsiteX88" fmla="*/ 5701358 w 5723503"/>
              <a:gd name="connsiteY88" fmla="*/ 3508367 h 6079105"/>
              <a:gd name="connsiteX89" fmla="*/ 5701168 w 5723503"/>
              <a:gd name="connsiteY89" fmla="*/ 3333863 h 6079105"/>
              <a:gd name="connsiteX90" fmla="*/ 0 w 5723503"/>
              <a:gd name="connsiteY90" fmla="*/ 0 h 6079105"/>
              <a:gd name="connsiteX91" fmla="*/ 5723503 w 5723503"/>
              <a:gd name="connsiteY91" fmla="*/ 0 h 6079105"/>
              <a:gd name="connsiteX92" fmla="*/ 5723503 w 5723503"/>
              <a:gd name="connsiteY92" fmla="*/ 6079105 h 6079105"/>
              <a:gd name="connsiteX93" fmla="*/ 0 w 5723503"/>
              <a:gd name="connsiteY93" fmla="*/ 6079105 h 60791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</a:cxnLst>
            <a:rect l="l" t="t" r="r" b="b"/>
            <a:pathLst>
              <a:path w="5723503" h="6079105">
                <a:moveTo>
                  <a:pt x="5334786" y="4202324"/>
                </a:moveTo>
                <a:lnTo>
                  <a:pt x="5477176" y="4202324"/>
                </a:lnTo>
                <a:lnTo>
                  <a:pt x="5477176" y="4342372"/>
                </a:lnTo>
                <a:cubicBezTo>
                  <a:pt x="5456465" y="4274603"/>
                  <a:pt x="5402887" y="4221906"/>
                  <a:pt x="5334786" y="4202324"/>
                </a:cubicBezTo>
                <a:close/>
                <a:moveTo>
                  <a:pt x="5549767" y="4201562"/>
                </a:moveTo>
                <a:lnTo>
                  <a:pt x="5692157" y="4201562"/>
                </a:lnTo>
                <a:lnTo>
                  <a:pt x="5692157" y="4341546"/>
                </a:lnTo>
                <a:cubicBezTo>
                  <a:pt x="5671489" y="4273764"/>
                  <a:pt x="5617889" y="4221069"/>
                  <a:pt x="5549767" y="4201562"/>
                </a:cubicBezTo>
                <a:close/>
                <a:moveTo>
                  <a:pt x="5305408" y="4195979"/>
                </a:moveTo>
                <a:lnTo>
                  <a:pt x="5304901" y="4202324"/>
                </a:lnTo>
                <a:cubicBezTo>
                  <a:pt x="5393001" y="4214782"/>
                  <a:pt x="5462729" y="4283150"/>
                  <a:pt x="5476923" y="4370991"/>
                </a:cubicBezTo>
                <a:lnTo>
                  <a:pt x="5483269" y="4370483"/>
                </a:lnTo>
                <a:lnTo>
                  <a:pt x="5483078" y="4195979"/>
                </a:lnTo>
                <a:close/>
                <a:moveTo>
                  <a:pt x="5520960" y="4195154"/>
                </a:moveTo>
                <a:lnTo>
                  <a:pt x="5520452" y="4201499"/>
                </a:lnTo>
                <a:cubicBezTo>
                  <a:pt x="5608351" y="4214194"/>
                  <a:pt x="5677801" y="4282542"/>
                  <a:pt x="5691904" y="4370230"/>
                </a:cubicBezTo>
                <a:lnTo>
                  <a:pt x="5698249" y="4369785"/>
                </a:lnTo>
                <a:lnTo>
                  <a:pt x="5698630" y="4195154"/>
                </a:lnTo>
                <a:close/>
                <a:moveTo>
                  <a:pt x="5333264" y="3985811"/>
                </a:moveTo>
                <a:lnTo>
                  <a:pt x="5475654" y="3985811"/>
                </a:lnTo>
                <a:lnTo>
                  <a:pt x="5475654" y="4125795"/>
                </a:lnTo>
                <a:cubicBezTo>
                  <a:pt x="5454986" y="4058013"/>
                  <a:pt x="5401386" y="4005318"/>
                  <a:pt x="5333264" y="3985811"/>
                </a:cubicBezTo>
                <a:close/>
                <a:moveTo>
                  <a:pt x="5548181" y="3985050"/>
                </a:moveTo>
                <a:lnTo>
                  <a:pt x="5690571" y="3985050"/>
                </a:lnTo>
                <a:lnTo>
                  <a:pt x="5690571" y="4124971"/>
                </a:lnTo>
                <a:cubicBezTo>
                  <a:pt x="5669824" y="4057251"/>
                  <a:pt x="5616252" y="4004608"/>
                  <a:pt x="5548181" y="3985050"/>
                </a:cubicBezTo>
                <a:close/>
                <a:moveTo>
                  <a:pt x="5303885" y="3979466"/>
                </a:moveTo>
                <a:lnTo>
                  <a:pt x="5303251" y="3985748"/>
                </a:lnTo>
                <a:cubicBezTo>
                  <a:pt x="5391327" y="3998232"/>
                  <a:pt x="5461023" y="4066593"/>
                  <a:pt x="5475210" y="4154415"/>
                </a:cubicBezTo>
                <a:lnTo>
                  <a:pt x="5481555" y="4153971"/>
                </a:lnTo>
                <a:lnTo>
                  <a:pt x="5481555" y="3979466"/>
                </a:lnTo>
                <a:close/>
                <a:moveTo>
                  <a:pt x="5518866" y="3978705"/>
                </a:moveTo>
                <a:lnTo>
                  <a:pt x="5518612" y="3985050"/>
                </a:lnTo>
                <a:cubicBezTo>
                  <a:pt x="5606540" y="3997687"/>
                  <a:pt x="5676048" y="4066015"/>
                  <a:pt x="5690190" y="4153717"/>
                </a:cubicBezTo>
                <a:lnTo>
                  <a:pt x="5696536" y="4153209"/>
                </a:lnTo>
                <a:lnTo>
                  <a:pt x="5696536" y="3978705"/>
                </a:lnTo>
                <a:close/>
                <a:moveTo>
                  <a:pt x="5336436" y="3771646"/>
                </a:moveTo>
                <a:lnTo>
                  <a:pt x="5478762" y="3771646"/>
                </a:lnTo>
                <a:lnTo>
                  <a:pt x="5478762" y="3911694"/>
                </a:lnTo>
                <a:cubicBezTo>
                  <a:pt x="5458064" y="3843940"/>
                  <a:pt x="5404513" y="3791246"/>
                  <a:pt x="5336436" y="3771646"/>
                </a:cubicBezTo>
                <a:close/>
                <a:moveTo>
                  <a:pt x="5551353" y="3770821"/>
                </a:moveTo>
                <a:lnTo>
                  <a:pt x="5693743" y="3770821"/>
                </a:lnTo>
                <a:lnTo>
                  <a:pt x="5693743" y="3910869"/>
                </a:lnTo>
                <a:cubicBezTo>
                  <a:pt x="5673032" y="3843100"/>
                  <a:pt x="5619454" y="3790403"/>
                  <a:pt x="5551353" y="3770821"/>
                </a:cubicBezTo>
                <a:close/>
                <a:moveTo>
                  <a:pt x="5306995" y="3765301"/>
                </a:moveTo>
                <a:lnTo>
                  <a:pt x="5306487" y="3771647"/>
                </a:lnTo>
                <a:cubicBezTo>
                  <a:pt x="5394588" y="3784105"/>
                  <a:pt x="5464315" y="3852472"/>
                  <a:pt x="5478509" y="3940314"/>
                </a:cubicBezTo>
                <a:lnTo>
                  <a:pt x="5484855" y="3939806"/>
                </a:lnTo>
                <a:lnTo>
                  <a:pt x="5484664" y="3765301"/>
                </a:lnTo>
                <a:close/>
                <a:moveTo>
                  <a:pt x="5521975" y="3764540"/>
                </a:moveTo>
                <a:lnTo>
                  <a:pt x="5521531" y="3770885"/>
                </a:lnTo>
                <a:cubicBezTo>
                  <a:pt x="5609607" y="3783369"/>
                  <a:pt x="5679303" y="3851731"/>
                  <a:pt x="5693490" y="3939552"/>
                </a:cubicBezTo>
                <a:lnTo>
                  <a:pt x="5699835" y="3939044"/>
                </a:lnTo>
                <a:lnTo>
                  <a:pt x="5699645" y="3764540"/>
                </a:lnTo>
                <a:close/>
                <a:moveTo>
                  <a:pt x="5334786" y="3555070"/>
                </a:moveTo>
                <a:lnTo>
                  <a:pt x="5477176" y="3555070"/>
                </a:lnTo>
                <a:lnTo>
                  <a:pt x="5477176" y="3695118"/>
                </a:lnTo>
                <a:cubicBezTo>
                  <a:pt x="5456465" y="3627349"/>
                  <a:pt x="5402887" y="3574652"/>
                  <a:pt x="5334786" y="3555070"/>
                </a:cubicBezTo>
                <a:close/>
                <a:moveTo>
                  <a:pt x="5549767" y="3554309"/>
                </a:moveTo>
                <a:lnTo>
                  <a:pt x="5692157" y="3554309"/>
                </a:lnTo>
                <a:lnTo>
                  <a:pt x="5692157" y="3694293"/>
                </a:lnTo>
                <a:cubicBezTo>
                  <a:pt x="5671489" y="3626511"/>
                  <a:pt x="5617889" y="3573816"/>
                  <a:pt x="5549767" y="3554309"/>
                </a:cubicBezTo>
                <a:close/>
                <a:moveTo>
                  <a:pt x="5305472" y="3548725"/>
                </a:moveTo>
                <a:lnTo>
                  <a:pt x="5304774" y="3555071"/>
                </a:lnTo>
                <a:cubicBezTo>
                  <a:pt x="5392874" y="3567529"/>
                  <a:pt x="5462602" y="3635896"/>
                  <a:pt x="5476796" y="3723738"/>
                </a:cubicBezTo>
                <a:lnTo>
                  <a:pt x="5483141" y="3723230"/>
                </a:lnTo>
                <a:lnTo>
                  <a:pt x="5483141" y="3548725"/>
                </a:lnTo>
                <a:close/>
                <a:moveTo>
                  <a:pt x="5520452" y="3547964"/>
                </a:moveTo>
                <a:lnTo>
                  <a:pt x="5520452" y="3554246"/>
                </a:lnTo>
                <a:cubicBezTo>
                  <a:pt x="5608282" y="3566984"/>
                  <a:pt x="5677664" y="3635289"/>
                  <a:pt x="5691777" y="3722913"/>
                </a:cubicBezTo>
                <a:lnTo>
                  <a:pt x="5698122" y="3722468"/>
                </a:lnTo>
                <a:lnTo>
                  <a:pt x="5698122" y="3547964"/>
                </a:lnTo>
                <a:close/>
                <a:moveTo>
                  <a:pt x="5337959" y="3340969"/>
                </a:moveTo>
                <a:lnTo>
                  <a:pt x="5480349" y="3340969"/>
                </a:lnTo>
                <a:lnTo>
                  <a:pt x="5480349" y="3480953"/>
                </a:lnTo>
                <a:cubicBezTo>
                  <a:pt x="5459620" y="3413209"/>
                  <a:pt x="5406045" y="3360539"/>
                  <a:pt x="5337959" y="3340969"/>
                </a:cubicBezTo>
                <a:close/>
                <a:moveTo>
                  <a:pt x="5552876" y="3340144"/>
                </a:moveTo>
                <a:lnTo>
                  <a:pt x="5695266" y="3340144"/>
                </a:lnTo>
                <a:lnTo>
                  <a:pt x="5695266" y="3480192"/>
                </a:lnTo>
                <a:cubicBezTo>
                  <a:pt x="5674555" y="3412423"/>
                  <a:pt x="5620977" y="3359726"/>
                  <a:pt x="5552876" y="3340144"/>
                </a:cubicBezTo>
                <a:close/>
                <a:moveTo>
                  <a:pt x="5308581" y="3334560"/>
                </a:moveTo>
                <a:lnTo>
                  <a:pt x="5308137" y="3340906"/>
                </a:lnTo>
                <a:cubicBezTo>
                  <a:pt x="5396233" y="3353397"/>
                  <a:pt x="5465934" y="3421790"/>
                  <a:pt x="5480096" y="3509636"/>
                </a:cubicBezTo>
                <a:lnTo>
                  <a:pt x="5486441" y="3509129"/>
                </a:lnTo>
                <a:lnTo>
                  <a:pt x="5486251" y="3334560"/>
                </a:lnTo>
                <a:close/>
                <a:moveTo>
                  <a:pt x="5523498" y="3333863"/>
                </a:moveTo>
                <a:lnTo>
                  <a:pt x="5522990" y="3340208"/>
                </a:lnTo>
                <a:cubicBezTo>
                  <a:pt x="5611091" y="3352666"/>
                  <a:pt x="5680819" y="3421034"/>
                  <a:pt x="5695013" y="3508875"/>
                </a:cubicBezTo>
                <a:lnTo>
                  <a:pt x="5701358" y="3508367"/>
                </a:lnTo>
                <a:lnTo>
                  <a:pt x="5701168" y="3333863"/>
                </a:lnTo>
                <a:close/>
                <a:moveTo>
                  <a:pt x="0" y="0"/>
                </a:moveTo>
                <a:lnTo>
                  <a:pt x="5723503" y="0"/>
                </a:lnTo>
                <a:lnTo>
                  <a:pt x="5723503" y="6079105"/>
                </a:lnTo>
                <a:lnTo>
                  <a:pt x="0" y="6079105"/>
                </a:lnTo>
                <a:close/>
              </a:path>
            </a:pathLst>
          </a:custGeom>
          <a:solidFill>
            <a:schemeClr val="bg2"/>
          </a:solidFill>
        </p:spPr>
        <p:txBody>
          <a:bodyPr wrap="square">
            <a:noAutofit/>
          </a:bodyPr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en-GB"/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8E0DD39-24FC-AE4A-B94A-C42AB36CC1B7}"/>
              </a:ext>
            </a:extLst>
          </p:cNvPr>
          <p:cNvGrpSpPr/>
          <p:nvPr userDrawn="1"/>
        </p:nvGrpSpPr>
        <p:grpSpPr>
          <a:xfrm>
            <a:off x="6057785" y="3509737"/>
            <a:ext cx="593203" cy="975172"/>
            <a:chOff x="6110794" y="3712667"/>
            <a:chExt cx="604094" cy="1022367"/>
          </a:xfrm>
        </p:grpSpPr>
        <p:sp>
          <p:nvSpPr>
            <p:cNvPr id="26" name="Freeform 5">
              <a:extLst>
                <a:ext uri="{FF2B5EF4-FFF2-40B4-BE49-F238E27FC236}">
                  <a16:creationId xmlns:a16="http://schemas.microsoft.com/office/drawing/2014/main" id="{49978BDD-C6D6-E346-A9BF-0B2D9F39C175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7" name="Freeform 6">
              <a:extLst>
                <a:ext uri="{FF2B5EF4-FFF2-40B4-BE49-F238E27FC236}">
                  <a16:creationId xmlns:a16="http://schemas.microsoft.com/office/drawing/2014/main" id="{A96E66DD-FA9B-E349-A02B-B02BD88A5B71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8" name="Freeform 7">
              <a:extLst>
                <a:ext uri="{FF2B5EF4-FFF2-40B4-BE49-F238E27FC236}">
                  <a16:creationId xmlns:a16="http://schemas.microsoft.com/office/drawing/2014/main" id="{0BED5851-F849-E24E-95C6-51A56A1EAAE1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71266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29" name="Freeform 10">
              <a:extLst>
                <a:ext uri="{FF2B5EF4-FFF2-40B4-BE49-F238E27FC236}">
                  <a16:creationId xmlns:a16="http://schemas.microsoft.com/office/drawing/2014/main" id="{4E532B9F-6985-4441-A777-C3F92A34A1C6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0" name="Freeform 11">
              <a:extLst>
                <a:ext uri="{FF2B5EF4-FFF2-40B4-BE49-F238E27FC236}">
                  <a16:creationId xmlns:a16="http://schemas.microsoft.com/office/drawing/2014/main" id="{D0FECB11-A712-D749-8E29-7C09F9ABC2AC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1" name="Freeform 12">
              <a:extLst>
                <a:ext uri="{FF2B5EF4-FFF2-40B4-BE49-F238E27FC236}">
                  <a16:creationId xmlns:a16="http://schemas.microsoft.com/office/drawing/2014/main" id="{7AFEB51D-BF86-0246-A2F2-F5C22BB18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3926040"/>
              <a:ext cx="173765" cy="170014"/>
            </a:xfrm>
            <a:custGeom>
              <a:avLst/>
              <a:gdLst>
                <a:gd name="T0" fmla="*/ 361 w 361"/>
                <a:gd name="T1" fmla="*/ 362 h 362"/>
                <a:gd name="T2" fmla="*/ 0 w 361"/>
                <a:gd name="T3" fmla="*/ 0 h 362"/>
                <a:gd name="T4" fmla="*/ 361 w 361"/>
                <a:gd name="T5" fmla="*/ 0 h 362"/>
                <a:gd name="T6" fmla="*/ 361 w 361"/>
                <a:gd name="T7" fmla="*/ 362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2">
                  <a:moveTo>
                    <a:pt x="361" y="362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2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2" name="Freeform 15">
              <a:extLst>
                <a:ext uri="{FF2B5EF4-FFF2-40B4-BE49-F238E27FC236}">
                  <a16:creationId xmlns:a16="http://schemas.microsoft.com/office/drawing/2014/main" id="{3D1B6517-4291-0D49-865E-755AA0F3D0A0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59B0FCA4-8AFD-B642-906B-F5222B92BE36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EBDD0B13-0DE3-7146-98EA-91D20B7A1FBC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139414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8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5" name="Freeform 20">
              <a:extLst>
                <a:ext uri="{FF2B5EF4-FFF2-40B4-BE49-F238E27FC236}">
                  <a16:creationId xmlns:a16="http://schemas.microsoft.com/office/drawing/2014/main" id="{9496EABF-F658-AC4D-AE40-621EDD04F1BC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6" name="Freeform 21">
              <a:extLst>
                <a:ext uri="{FF2B5EF4-FFF2-40B4-BE49-F238E27FC236}">
                  <a16:creationId xmlns:a16="http://schemas.microsoft.com/office/drawing/2014/main" id="{41EEB260-02BE-7F4E-B46B-04B5A9453900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7" name="Freeform 22">
              <a:extLst>
                <a:ext uri="{FF2B5EF4-FFF2-40B4-BE49-F238E27FC236}">
                  <a16:creationId xmlns:a16="http://schemas.microsoft.com/office/drawing/2014/main" id="{95BDCD68-13DD-4649-9A16-558E7BD975C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566161"/>
              <a:ext cx="173765" cy="168873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6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8" name="Freeform 25">
              <a:extLst>
                <a:ext uri="{FF2B5EF4-FFF2-40B4-BE49-F238E27FC236}">
                  <a16:creationId xmlns:a16="http://schemas.microsoft.com/office/drawing/2014/main" id="{9AC229A1-06B0-4846-ACB3-26E7B3FF7EE5}"/>
                </a:ext>
              </a:extLst>
            </p:cNvPr>
            <p:cNvSpPr>
              <a:spLocks/>
            </p:cNvSpPr>
            <p:nvPr/>
          </p:nvSpPr>
          <p:spPr bwMode="auto">
            <a:xfrm>
              <a:off x="6541123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5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39" name="Freeform 26">
              <a:extLst>
                <a:ext uri="{FF2B5EF4-FFF2-40B4-BE49-F238E27FC236}">
                  <a16:creationId xmlns:a16="http://schemas.microsoft.com/office/drawing/2014/main" id="{CE8EB986-BC20-D74F-A600-F58016D26EF7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6542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40" name="Freeform 27">
              <a:extLst>
                <a:ext uri="{FF2B5EF4-FFF2-40B4-BE49-F238E27FC236}">
                  <a16:creationId xmlns:a16="http://schemas.microsoft.com/office/drawing/2014/main" id="{E8904A61-0677-0E46-A571-C96981D7255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0794" y="4352787"/>
              <a:ext cx="173765" cy="170014"/>
            </a:xfrm>
            <a:custGeom>
              <a:avLst/>
              <a:gdLst>
                <a:gd name="T0" fmla="*/ 361 w 361"/>
                <a:gd name="T1" fmla="*/ 361 h 361"/>
                <a:gd name="T2" fmla="*/ 0 w 361"/>
                <a:gd name="T3" fmla="*/ 0 h 361"/>
                <a:gd name="T4" fmla="*/ 361 w 361"/>
                <a:gd name="T5" fmla="*/ 0 h 361"/>
                <a:gd name="T6" fmla="*/ 361 w 361"/>
                <a:gd name="T7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1" h="361">
                  <a:moveTo>
                    <a:pt x="361" y="361"/>
                  </a:moveTo>
                  <a:cubicBezTo>
                    <a:pt x="332" y="175"/>
                    <a:pt x="186" y="29"/>
                    <a:pt x="0" y="0"/>
                  </a:cubicBezTo>
                  <a:cubicBezTo>
                    <a:pt x="361" y="0"/>
                    <a:pt x="361" y="0"/>
                    <a:pt x="361" y="0"/>
                  </a:cubicBezTo>
                  <a:lnTo>
                    <a:pt x="361" y="361"/>
                  </a:lnTo>
                  <a:close/>
                </a:path>
              </a:pathLst>
            </a:custGeom>
            <a:solidFill>
              <a:srgbClr val="E3E3E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</p:grpSp>
    </p:spTree>
    <p:extLst>
      <p:ext uri="{BB962C8B-B14F-4D97-AF65-F5344CB8AC3E}">
        <p14:creationId xmlns:p14="http://schemas.microsoft.com/office/powerpoint/2010/main" val="2561787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vider w/o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95B85C-4BCC-D949-9DC0-F6A10AAB5AE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24" name="Title 1">
            <a:extLst>
              <a:ext uri="{FF2B5EF4-FFF2-40B4-BE49-F238E27FC236}">
                <a16:creationId xmlns:a16="http://schemas.microsoft.com/office/drawing/2014/main" id="{81B0651E-9135-824D-AF58-78D139479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41621" y="2907463"/>
            <a:ext cx="9512652" cy="480131"/>
          </a:xfrm>
        </p:spPr>
        <p:txBody>
          <a:bodyPr wrap="square" anchor="ctr">
            <a:spAutoFit/>
          </a:bodyPr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1" name="Freeform 5">
            <a:extLst>
              <a:ext uri="{FF2B5EF4-FFF2-40B4-BE49-F238E27FC236}">
                <a16:creationId xmlns:a16="http://schemas.microsoft.com/office/drawing/2014/main" id="{611D4F9B-925D-BC43-8260-F404EAE16834}"/>
              </a:ext>
            </a:extLst>
          </p:cNvPr>
          <p:cNvSpPr>
            <a:spLocks noChangeAspect="1"/>
          </p:cNvSpPr>
          <p:nvPr/>
        </p:nvSpPr>
        <p:spPr bwMode="auto">
          <a:xfrm rot="16200000" flipH="1">
            <a:off x="10176100" y="4530825"/>
            <a:ext cx="1613827" cy="1602000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noFill/>
          <a:ln w="12700" cap="flat">
            <a:solidFill>
              <a:schemeClr val="bg2"/>
            </a:solidFill>
            <a:prstDash val="solid"/>
            <a:miter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33" name="Freeform 5">
            <a:extLst>
              <a:ext uri="{FF2B5EF4-FFF2-40B4-BE49-F238E27FC236}">
                <a16:creationId xmlns:a16="http://schemas.microsoft.com/office/drawing/2014/main" id="{F92E0807-C455-0743-B8C5-86D84226E6F7}"/>
              </a:ext>
            </a:extLst>
          </p:cNvPr>
          <p:cNvSpPr>
            <a:spLocks/>
          </p:cNvSpPr>
          <p:nvPr/>
        </p:nvSpPr>
        <p:spPr bwMode="auto">
          <a:xfrm rot="5400000" flipH="1">
            <a:off x="411760" y="393359"/>
            <a:ext cx="1608013" cy="1596229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8A9B772A-1FCC-5840-8809-70296571989A}"/>
              </a:ext>
            </a:extLst>
          </p:cNvPr>
          <p:cNvSpPr>
            <a:spLocks noChangeAspect="1"/>
          </p:cNvSpPr>
          <p:nvPr userDrawn="1"/>
        </p:nvSpPr>
        <p:spPr bwMode="auto">
          <a:xfrm rot="16200000" flipH="1">
            <a:off x="10176100" y="4530825"/>
            <a:ext cx="1613827" cy="1602000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noFill/>
          <a:ln w="12700" cap="flat">
            <a:solidFill>
              <a:schemeClr val="bg2"/>
            </a:solidFill>
            <a:prstDash val="solid"/>
            <a:miter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  <p:sp>
        <p:nvSpPr>
          <p:cNvPr id="7" name="Freeform 5">
            <a:extLst>
              <a:ext uri="{FF2B5EF4-FFF2-40B4-BE49-F238E27FC236}">
                <a16:creationId xmlns:a16="http://schemas.microsoft.com/office/drawing/2014/main" id="{916ADB33-3EE3-BC40-B2BB-6240F9D25656}"/>
              </a:ext>
            </a:extLst>
          </p:cNvPr>
          <p:cNvSpPr>
            <a:spLocks/>
          </p:cNvSpPr>
          <p:nvPr userDrawn="1"/>
        </p:nvSpPr>
        <p:spPr bwMode="auto">
          <a:xfrm rot="5400000" flipH="1">
            <a:off x="411760" y="393359"/>
            <a:ext cx="1608013" cy="1596229"/>
          </a:xfrm>
          <a:custGeom>
            <a:avLst/>
            <a:gdLst>
              <a:gd name="T0" fmla="*/ 2544 w 2544"/>
              <a:gd name="T1" fmla="*/ 0 h 2569"/>
              <a:gd name="T2" fmla="*/ 2544 w 2544"/>
              <a:gd name="T3" fmla="*/ 2569 h 2569"/>
              <a:gd name="T4" fmla="*/ 0 w 2544"/>
              <a:gd name="T5" fmla="*/ 2569 h 2569"/>
              <a:gd name="T6" fmla="*/ 2544 w 2544"/>
              <a:gd name="T7" fmla="*/ 0 h 2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544" h="2569">
                <a:moveTo>
                  <a:pt x="2544" y="0"/>
                </a:moveTo>
                <a:cubicBezTo>
                  <a:pt x="2544" y="2569"/>
                  <a:pt x="2544" y="2569"/>
                  <a:pt x="2544" y="2569"/>
                </a:cubicBezTo>
                <a:cubicBezTo>
                  <a:pt x="0" y="2569"/>
                  <a:pt x="0" y="2569"/>
                  <a:pt x="0" y="2569"/>
                </a:cubicBezTo>
                <a:cubicBezTo>
                  <a:pt x="1308" y="2365"/>
                  <a:pt x="2342" y="1321"/>
                  <a:pt x="2544" y="0"/>
                </a:cubicBezTo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800"/>
          </a:p>
        </p:txBody>
      </p:sp>
    </p:spTree>
    <p:extLst>
      <p:ext uri="{BB962C8B-B14F-4D97-AF65-F5344CB8AC3E}">
        <p14:creationId xmlns:p14="http://schemas.microsoft.com/office/powerpoint/2010/main" val="34111652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B43997-CCE5-4F54-8524-0C8821F8C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1817AB-EFFA-4353-9DDD-18537A84A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57A3D5-FC3A-4DD2-B79A-1D0C9B67D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633578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tatement 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 6">
            <a:extLst>
              <a:ext uri="{FF2B5EF4-FFF2-40B4-BE49-F238E27FC236}">
                <a16:creationId xmlns:a16="http://schemas.microsoft.com/office/drawing/2014/main" id="{9BE75F46-D81E-5447-B33A-EACD35F4465F}"/>
              </a:ext>
            </a:extLst>
          </p:cNvPr>
          <p:cNvSpPr/>
          <p:nvPr/>
        </p:nvSpPr>
        <p:spPr>
          <a:xfrm>
            <a:off x="2754754" y="0"/>
            <a:ext cx="9437247" cy="6858000"/>
          </a:xfrm>
          <a:custGeom>
            <a:avLst/>
            <a:gdLst>
              <a:gd name="connsiteX0" fmla="*/ 0 w 9437246"/>
              <a:gd name="connsiteY0" fmla="*/ 0 h 6833052"/>
              <a:gd name="connsiteX1" fmla="*/ 9437246 w 9437246"/>
              <a:gd name="connsiteY1" fmla="*/ 0 h 6833052"/>
              <a:gd name="connsiteX2" fmla="*/ 9437246 w 9437246"/>
              <a:gd name="connsiteY2" fmla="*/ 6833052 h 6833052"/>
              <a:gd name="connsiteX3" fmla="*/ 9221785 w 9437246"/>
              <a:gd name="connsiteY3" fmla="*/ 6819662 h 6833052"/>
              <a:gd name="connsiteX4" fmla="*/ 78869 w 9437246"/>
              <a:gd name="connsiteY4" fmla="*/ 252510 h 68330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437246" h="6833052">
                <a:moveTo>
                  <a:pt x="0" y="0"/>
                </a:moveTo>
                <a:lnTo>
                  <a:pt x="9437246" y="0"/>
                </a:lnTo>
                <a:lnTo>
                  <a:pt x="9437246" y="6833052"/>
                </a:lnTo>
                <a:lnTo>
                  <a:pt x="9221785" y="6819662"/>
                </a:lnTo>
                <a:cubicBezTo>
                  <a:pt x="4879604" y="6473211"/>
                  <a:pt x="1296735" y="3813340"/>
                  <a:pt x="78869" y="25251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BE" sz="1400">
              <a:solidFill>
                <a:schemeClr val="accent1"/>
              </a:solidFill>
            </a:endParaRPr>
          </a:p>
        </p:txBody>
      </p:sp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90" y="3530923"/>
            <a:ext cx="4401079" cy="898708"/>
          </a:xfrm>
        </p:spPr>
        <p:txBody>
          <a:bodyPr wrap="square" rIns="36000" anchor="b">
            <a:spAutoFit/>
          </a:bodyPr>
          <a:lstStyle>
            <a:lvl1pPr algn="l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03A404-0F09-EF45-8852-06F3E2AD4882}"/>
              </a:ext>
            </a:extLst>
          </p:cNvPr>
          <p:cNvSpPr txBox="1"/>
          <p:nvPr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FC533E8-0B08-D64D-8FCE-2D0B39A69DEC}"/>
              </a:ext>
            </a:extLst>
          </p:cNvPr>
          <p:cNvGrpSpPr/>
          <p:nvPr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3CA3DE5-6942-A749-A150-0E5FC8B1F6D8}"/>
                </a:ext>
              </a:extLst>
            </p:cNvPr>
            <p:cNvSpPr txBox="1"/>
            <p:nvPr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5BFB9D5E-1F4F-BD43-96B2-14BE29E6ACAB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24F16A9-2DDD-E64B-AEDC-9D691F0A36EC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Freeform 12">
            <a:extLst>
              <a:ext uri="{FF2B5EF4-FFF2-40B4-BE49-F238E27FC236}">
                <a16:creationId xmlns:a16="http://schemas.microsoft.com/office/drawing/2014/main" id="{7405B570-EC49-2E40-BBA3-BB0B3B4A3C3D}"/>
              </a:ext>
            </a:extLst>
          </p:cNvPr>
          <p:cNvSpPr/>
          <p:nvPr userDrawn="1"/>
        </p:nvSpPr>
        <p:spPr>
          <a:xfrm>
            <a:off x="2754754" y="0"/>
            <a:ext cx="9437247" cy="6858000"/>
          </a:xfrm>
          <a:custGeom>
            <a:avLst/>
            <a:gdLst>
              <a:gd name="connsiteX0" fmla="*/ 0 w 9437246"/>
              <a:gd name="connsiteY0" fmla="*/ 0 h 6833052"/>
              <a:gd name="connsiteX1" fmla="*/ 9437246 w 9437246"/>
              <a:gd name="connsiteY1" fmla="*/ 0 h 6833052"/>
              <a:gd name="connsiteX2" fmla="*/ 9437246 w 9437246"/>
              <a:gd name="connsiteY2" fmla="*/ 6833052 h 6833052"/>
              <a:gd name="connsiteX3" fmla="*/ 9221785 w 9437246"/>
              <a:gd name="connsiteY3" fmla="*/ 6819662 h 6833052"/>
              <a:gd name="connsiteX4" fmla="*/ 78869 w 9437246"/>
              <a:gd name="connsiteY4" fmla="*/ 252510 h 68330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437246" h="6833052">
                <a:moveTo>
                  <a:pt x="0" y="0"/>
                </a:moveTo>
                <a:lnTo>
                  <a:pt x="9437246" y="0"/>
                </a:lnTo>
                <a:lnTo>
                  <a:pt x="9437246" y="6833052"/>
                </a:lnTo>
                <a:lnTo>
                  <a:pt x="9221785" y="6819662"/>
                </a:lnTo>
                <a:cubicBezTo>
                  <a:pt x="4879604" y="6473211"/>
                  <a:pt x="1296735" y="3813340"/>
                  <a:pt x="78869" y="25251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BE" sz="1400">
              <a:solidFill>
                <a:schemeClr val="accent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6D093DF-9983-5846-8381-21EFC2ED42C0}"/>
              </a:ext>
            </a:extLst>
          </p:cNvPr>
          <p:cNvSpPr txBox="1"/>
          <p:nvPr userDrawn="1"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04A1A51-9814-4F49-9090-80D63DD82094}"/>
              </a:ext>
            </a:extLst>
          </p:cNvPr>
          <p:cNvGrpSpPr/>
          <p:nvPr userDrawn="1"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5E9D15B-3E97-FA45-B6C2-2EAAB2887DDB}"/>
                </a:ext>
              </a:extLst>
            </p:cNvPr>
            <p:cNvSpPr txBox="1"/>
            <p:nvPr userDrawn="1"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A1D66FE1-B512-FC44-B5CE-F154EBDED2C7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C0966C4C-B1F3-B24B-B96E-580B2F4F0468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48858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tatement 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4">
            <a:extLst>
              <a:ext uri="{FF2B5EF4-FFF2-40B4-BE49-F238E27FC236}">
                <a16:creationId xmlns:a16="http://schemas.microsoft.com/office/drawing/2014/main" id="{0E266A10-7698-4D46-92BA-27C0C79F17B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406018" y="0"/>
            <a:ext cx="6792335" cy="6856413"/>
            <a:chOff x="4398" y="1002"/>
            <a:chExt cx="3286" cy="3317"/>
          </a:xfrm>
        </p:grpSpPr>
        <p:sp>
          <p:nvSpPr>
            <p:cNvPr id="11" name="AutoShape 3">
              <a:extLst>
                <a:ext uri="{FF2B5EF4-FFF2-40B4-BE49-F238E27FC236}">
                  <a16:creationId xmlns:a16="http://schemas.microsoft.com/office/drawing/2014/main" id="{0BE617A9-07A3-CC4C-9365-E1631F85F9F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4398" y="1002"/>
              <a:ext cx="3286" cy="3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2" name="Freeform 5">
              <a:extLst>
                <a:ext uri="{FF2B5EF4-FFF2-40B4-BE49-F238E27FC236}">
                  <a16:creationId xmlns:a16="http://schemas.microsoft.com/office/drawing/2014/main" id="{38728E5D-8F91-E54F-A979-AD7FAF48DD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7" y="1002"/>
              <a:ext cx="3286" cy="3318"/>
            </a:xfrm>
            <a:custGeom>
              <a:avLst/>
              <a:gdLst>
                <a:gd name="T0" fmla="*/ 2544 w 2544"/>
                <a:gd name="T1" fmla="*/ 0 h 2569"/>
                <a:gd name="T2" fmla="*/ 2544 w 2544"/>
                <a:gd name="T3" fmla="*/ 2569 h 2569"/>
                <a:gd name="T4" fmla="*/ 0 w 2544"/>
                <a:gd name="T5" fmla="*/ 2569 h 2569"/>
                <a:gd name="T6" fmla="*/ 2544 w 2544"/>
                <a:gd name="T7" fmla="*/ 0 h 25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44" h="2569">
                  <a:moveTo>
                    <a:pt x="2544" y="0"/>
                  </a:moveTo>
                  <a:cubicBezTo>
                    <a:pt x="2544" y="2569"/>
                    <a:pt x="2544" y="2569"/>
                    <a:pt x="2544" y="2569"/>
                  </a:cubicBezTo>
                  <a:cubicBezTo>
                    <a:pt x="0" y="2569"/>
                    <a:pt x="0" y="2569"/>
                    <a:pt x="0" y="2569"/>
                  </a:cubicBezTo>
                  <a:cubicBezTo>
                    <a:pt x="1308" y="2365"/>
                    <a:pt x="2342" y="1321"/>
                    <a:pt x="2544" y="0"/>
                  </a:cubicBezTo>
                </a:path>
              </a:pathLst>
            </a:custGeom>
            <a:solidFill>
              <a:schemeClr val="accent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</p:grpSp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89" y="3188936"/>
            <a:ext cx="8110369" cy="480131"/>
          </a:xfrm>
        </p:spPr>
        <p:txBody>
          <a:bodyPr wrap="square" rIns="36000" anchor="ctr">
            <a:spAutoFit/>
          </a:bodyPr>
          <a:lstStyle>
            <a:lvl1pPr algn="l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5F6C02A-E300-8E44-8EC3-A6F88D9E23D8}"/>
              </a:ext>
            </a:extLst>
          </p:cNvPr>
          <p:cNvSpPr txBox="1"/>
          <p:nvPr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bg1"/>
                </a:solidFill>
              </a:rPr>
              <a:pPr lvl="0" algn="ctr"/>
              <a:t>‹#›</a:t>
            </a:fld>
            <a:endParaRPr lang="en-US" sz="800">
              <a:solidFill>
                <a:schemeClr val="bg1"/>
              </a:solidFill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80B588B-769A-964C-B04A-A0A39F4A1B54}"/>
              </a:ext>
            </a:extLst>
          </p:cNvPr>
          <p:cNvGrpSpPr/>
          <p:nvPr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64AEB60-2887-4E4F-BABA-6F7DA040CBD2}"/>
                </a:ext>
              </a:extLst>
            </p:cNvPr>
            <p:cNvSpPr txBox="1"/>
            <p:nvPr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bg1"/>
                  </a:solidFill>
                </a:rPr>
                <a:t>Proprietary and Confidential Property of UCB</a:t>
              </a:r>
              <a:endParaRPr lang="en-BE" sz="900">
                <a:solidFill>
                  <a:schemeClr val="bg1"/>
                </a:solidFill>
              </a:endParaRP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EE612709-CECD-664B-BF5B-67A0B0C29783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2285A0B-2510-8548-8DA1-BF2F0AAAE870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4">
            <a:extLst>
              <a:ext uri="{FF2B5EF4-FFF2-40B4-BE49-F238E27FC236}">
                <a16:creationId xmlns:a16="http://schemas.microsoft.com/office/drawing/2014/main" id="{802F1EE5-42E6-5746-B0CD-42F46A5A0611}"/>
              </a:ext>
            </a:extLst>
          </p:cNvPr>
          <p:cNvGrpSpPr>
            <a:grpSpLocks noChangeAspect="1"/>
          </p:cNvGrpSpPr>
          <p:nvPr userDrawn="1"/>
        </p:nvGrpSpPr>
        <p:grpSpPr bwMode="auto">
          <a:xfrm>
            <a:off x="5406018" y="0"/>
            <a:ext cx="6792335" cy="6856413"/>
            <a:chOff x="4398" y="1002"/>
            <a:chExt cx="3286" cy="3317"/>
          </a:xfrm>
        </p:grpSpPr>
        <p:sp>
          <p:nvSpPr>
            <p:cNvPr id="14" name="AutoShape 3">
              <a:extLst>
                <a:ext uri="{FF2B5EF4-FFF2-40B4-BE49-F238E27FC236}">
                  <a16:creationId xmlns:a16="http://schemas.microsoft.com/office/drawing/2014/main" id="{8B80C5A6-2526-5249-97C0-C743314F8488}"/>
                </a:ext>
              </a:extLst>
            </p:cNvPr>
            <p:cNvSpPr>
              <a:spLocks noChangeAspect="1" noChangeArrowheads="1" noTextEdit="1"/>
            </p:cNvSpPr>
            <p:nvPr userDrawn="1"/>
          </p:nvSpPr>
          <p:spPr bwMode="auto">
            <a:xfrm>
              <a:off x="4398" y="1002"/>
              <a:ext cx="3286" cy="33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  <p:sp>
          <p:nvSpPr>
            <p:cNvPr id="15" name="Freeform 5">
              <a:extLst>
                <a:ext uri="{FF2B5EF4-FFF2-40B4-BE49-F238E27FC236}">
                  <a16:creationId xmlns:a16="http://schemas.microsoft.com/office/drawing/2014/main" id="{0DFC4E2F-F685-F34F-97B1-6ABAA001EAE8}"/>
                </a:ext>
              </a:extLst>
            </p:cNvPr>
            <p:cNvSpPr>
              <a:spLocks/>
            </p:cNvSpPr>
            <p:nvPr userDrawn="1"/>
          </p:nvSpPr>
          <p:spPr bwMode="auto">
            <a:xfrm>
              <a:off x="4397" y="1002"/>
              <a:ext cx="3286" cy="3318"/>
            </a:xfrm>
            <a:custGeom>
              <a:avLst/>
              <a:gdLst>
                <a:gd name="T0" fmla="*/ 2544 w 2544"/>
                <a:gd name="T1" fmla="*/ 0 h 2569"/>
                <a:gd name="T2" fmla="*/ 2544 w 2544"/>
                <a:gd name="T3" fmla="*/ 2569 h 2569"/>
                <a:gd name="T4" fmla="*/ 0 w 2544"/>
                <a:gd name="T5" fmla="*/ 2569 h 2569"/>
                <a:gd name="T6" fmla="*/ 2544 w 2544"/>
                <a:gd name="T7" fmla="*/ 0 h 25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44" h="2569">
                  <a:moveTo>
                    <a:pt x="2544" y="0"/>
                  </a:moveTo>
                  <a:cubicBezTo>
                    <a:pt x="2544" y="2569"/>
                    <a:pt x="2544" y="2569"/>
                    <a:pt x="2544" y="2569"/>
                  </a:cubicBezTo>
                  <a:cubicBezTo>
                    <a:pt x="0" y="2569"/>
                    <a:pt x="0" y="2569"/>
                    <a:pt x="0" y="2569"/>
                  </a:cubicBezTo>
                  <a:cubicBezTo>
                    <a:pt x="1308" y="2365"/>
                    <a:pt x="2342" y="1321"/>
                    <a:pt x="2544" y="0"/>
                  </a:cubicBezTo>
                </a:path>
              </a:pathLst>
            </a:custGeom>
            <a:solidFill>
              <a:schemeClr val="accent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800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879C9E3-8642-7E41-B078-9D6810971079}"/>
              </a:ext>
            </a:extLst>
          </p:cNvPr>
          <p:cNvSpPr txBox="1"/>
          <p:nvPr userDrawn="1"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bg1"/>
                </a:solidFill>
              </a:rPr>
              <a:pPr lvl="0" algn="ctr"/>
              <a:t>‹#›</a:t>
            </a:fld>
            <a:endParaRPr lang="en-US" sz="800">
              <a:solidFill>
                <a:schemeClr val="bg1"/>
              </a:solidFill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4D28F05-7DD6-5641-A261-DA047E7E96FC}"/>
              </a:ext>
            </a:extLst>
          </p:cNvPr>
          <p:cNvGrpSpPr/>
          <p:nvPr userDrawn="1"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17DD44-1000-FB4A-8A5B-548BF0709366}"/>
                </a:ext>
              </a:extLst>
            </p:cNvPr>
            <p:cNvSpPr txBox="1"/>
            <p:nvPr userDrawn="1"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bg1"/>
                  </a:solidFill>
                </a:rPr>
                <a:t>Proprietary and Confidential Property of UCB</a:t>
              </a:r>
              <a:endParaRPr lang="en-BE" sz="900">
                <a:solidFill>
                  <a:schemeClr val="bg1"/>
                </a:solidFill>
              </a:endParaRP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79DE366-DE1A-3D4A-9169-7A39E1393D4B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70298EF5-07A8-0246-9E7D-DBA68C87E479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737061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End slide w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07990" y="4027881"/>
            <a:ext cx="4401079" cy="898708"/>
          </a:xfrm>
        </p:spPr>
        <p:txBody>
          <a:bodyPr wrap="square" rIns="36000" anchor="b">
            <a:spAutoFit/>
          </a:bodyPr>
          <a:lstStyle>
            <a:lvl1pPr algn="l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59" name="Subtitle 2">
            <a:extLst>
              <a:ext uri="{FF2B5EF4-FFF2-40B4-BE49-F238E27FC236}">
                <a16:creationId xmlns:a16="http://schemas.microsoft.com/office/drawing/2014/main" id="{2182F8AD-1FB7-254D-B9E0-A4E8BB5B9E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07990" y="5018662"/>
            <a:ext cx="4401079" cy="338554"/>
          </a:xfrm>
        </p:spPr>
        <p:txBody>
          <a:bodyPr wrap="square" rIns="36000">
            <a:sp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600">
                <a:solidFill>
                  <a:schemeClr val="accent1"/>
                </a:solidFill>
                <a:latin typeface="+mn-lt"/>
              </a:defRPr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14" name="Picture Placeholder 13">
            <a:extLst>
              <a:ext uri="{FF2B5EF4-FFF2-40B4-BE49-F238E27FC236}">
                <a16:creationId xmlns:a16="http://schemas.microsoft.com/office/drawing/2014/main" id="{6AE4611C-9F5D-A942-8DF3-4440110899E0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2754754" y="0"/>
            <a:ext cx="9437247" cy="6858000"/>
          </a:xfrm>
          <a:custGeom>
            <a:avLst/>
            <a:gdLst>
              <a:gd name="connsiteX0" fmla="*/ 0 w 9437246"/>
              <a:gd name="connsiteY0" fmla="*/ 0 h 6833052"/>
              <a:gd name="connsiteX1" fmla="*/ 9437246 w 9437246"/>
              <a:gd name="connsiteY1" fmla="*/ 0 h 6833052"/>
              <a:gd name="connsiteX2" fmla="*/ 9437246 w 9437246"/>
              <a:gd name="connsiteY2" fmla="*/ 6833052 h 6833052"/>
              <a:gd name="connsiteX3" fmla="*/ 9221785 w 9437246"/>
              <a:gd name="connsiteY3" fmla="*/ 6819662 h 6833052"/>
              <a:gd name="connsiteX4" fmla="*/ 78869 w 9437246"/>
              <a:gd name="connsiteY4" fmla="*/ 252510 h 68330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437246" h="6833052">
                <a:moveTo>
                  <a:pt x="0" y="0"/>
                </a:moveTo>
                <a:lnTo>
                  <a:pt x="9437246" y="0"/>
                </a:lnTo>
                <a:lnTo>
                  <a:pt x="9437246" y="6833052"/>
                </a:lnTo>
                <a:lnTo>
                  <a:pt x="9221785" y="6819662"/>
                </a:lnTo>
                <a:cubicBezTo>
                  <a:pt x="4879604" y="6473211"/>
                  <a:pt x="1296735" y="3813340"/>
                  <a:pt x="78869" y="25251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</p:spPr>
        <p:txBody>
          <a:bodyPr wrap="square" rIns="180000" anchor="ctr">
            <a:noAutofit/>
          </a:bodyPr>
          <a:lstStyle>
            <a:lvl1pPr algn="r">
              <a:defRPr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BE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AC7B90F-A1C3-0C45-8761-4AC75DE2D92E}"/>
              </a:ext>
            </a:extLst>
          </p:cNvPr>
          <p:cNvGrpSpPr/>
          <p:nvPr userDrawn="1"/>
        </p:nvGrpSpPr>
        <p:grpSpPr>
          <a:xfrm rot="5400000">
            <a:off x="5980585" y="4768554"/>
            <a:ext cx="230832" cy="3501855"/>
            <a:chOff x="1" y="1980381"/>
            <a:chExt cx="230832" cy="350185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2ABC181-BB9B-8443-AFB9-3CEAF9B2A04E}"/>
                </a:ext>
              </a:extLst>
            </p:cNvPr>
            <p:cNvSpPr txBox="1"/>
            <p:nvPr/>
          </p:nvSpPr>
          <p:spPr>
            <a:xfrm rot="16200000">
              <a:off x="-1394244" y="3615891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F6005F7B-9433-394D-8C2A-9AE3DB8C4A3C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79B9F0A8-3F16-874D-ACFB-DF31876D8D97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273BA04-2628-DF4D-925E-D3A419BC9379}"/>
              </a:ext>
            </a:extLst>
          </p:cNvPr>
          <p:cNvGrpSpPr/>
          <p:nvPr userDrawn="1"/>
        </p:nvGrpSpPr>
        <p:grpSpPr>
          <a:xfrm rot="5400000">
            <a:off x="5980585" y="4768554"/>
            <a:ext cx="230832" cy="3501855"/>
            <a:chOff x="1" y="1980381"/>
            <a:chExt cx="230832" cy="3501854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C8F8A42-3A50-064F-B98A-A1873E2098B4}"/>
                </a:ext>
              </a:extLst>
            </p:cNvPr>
            <p:cNvSpPr txBox="1"/>
            <p:nvPr userDrawn="1"/>
          </p:nvSpPr>
          <p:spPr>
            <a:xfrm rot="16200000">
              <a:off x="-1394244" y="3615891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63CFF3F5-2232-9A41-BBA6-953E941A00F6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7303C5E9-A81C-9441-8561-447FAE9A9500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525677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End slide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itle 1">
            <a:extLst>
              <a:ext uri="{FF2B5EF4-FFF2-40B4-BE49-F238E27FC236}">
                <a16:creationId xmlns:a16="http://schemas.microsoft.com/office/drawing/2014/main" id="{DC9685A4-CF88-564B-925B-AF0FD83F6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95231" y="4370049"/>
            <a:ext cx="9401540" cy="480131"/>
          </a:xfrm>
        </p:spPr>
        <p:txBody>
          <a:bodyPr wrap="square" rIns="36000" anchor="b">
            <a:normAutofit/>
          </a:bodyPr>
          <a:lstStyle>
            <a:lvl1pPr algn="ctr">
              <a:defRPr sz="2800">
                <a:solidFill>
                  <a:schemeClr val="accent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59" name="Subtitle 2">
            <a:extLst>
              <a:ext uri="{FF2B5EF4-FFF2-40B4-BE49-F238E27FC236}">
                <a16:creationId xmlns:a16="http://schemas.microsoft.com/office/drawing/2014/main" id="{2182F8AD-1FB7-254D-B9E0-A4E8BB5B9E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95231" y="4942254"/>
            <a:ext cx="9401540" cy="338554"/>
          </a:xfrm>
        </p:spPr>
        <p:txBody>
          <a:bodyPr wrap="square" rIns="36000" anchor="t">
            <a:sp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600">
                <a:solidFill>
                  <a:schemeClr val="accent1"/>
                </a:solidFill>
                <a:latin typeface="+mn-lt"/>
              </a:defRPr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551F790-BC07-EE40-85F4-EFC68DCF6426}"/>
              </a:ext>
            </a:extLst>
          </p:cNvPr>
          <p:cNvGrpSpPr/>
          <p:nvPr/>
        </p:nvGrpSpPr>
        <p:grpSpPr>
          <a:xfrm rot="5400000">
            <a:off x="5980585" y="4768554"/>
            <a:ext cx="230832" cy="3501855"/>
            <a:chOff x="1" y="1980381"/>
            <a:chExt cx="230832" cy="3501854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C170B76-1B60-8A47-8BF2-13B1F51C9FBB}"/>
                </a:ext>
              </a:extLst>
            </p:cNvPr>
            <p:cNvSpPr txBox="1"/>
            <p:nvPr/>
          </p:nvSpPr>
          <p:spPr>
            <a:xfrm rot="16200000">
              <a:off x="-1394244" y="3615891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000FD983-1E0D-674B-B17D-0D7B767052EA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943A570F-F968-D440-962C-BE1ABFFB5395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280C577B-C23B-4044-9AF1-0EC1B899CAA0}"/>
              </a:ext>
            </a:extLst>
          </p:cNvPr>
          <p:cNvGrpSpPr/>
          <p:nvPr userDrawn="1"/>
        </p:nvGrpSpPr>
        <p:grpSpPr>
          <a:xfrm rot="5400000">
            <a:off x="5980585" y="4768554"/>
            <a:ext cx="230832" cy="3501855"/>
            <a:chOff x="1" y="1980381"/>
            <a:chExt cx="230832" cy="3501854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FD82AFBA-CE0D-8C43-A515-0029F8453B96}"/>
                </a:ext>
              </a:extLst>
            </p:cNvPr>
            <p:cNvSpPr txBox="1"/>
            <p:nvPr userDrawn="1"/>
          </p:nvSpPr>
          <p:spPr>
            <a:xfrm rot="16200000">
              <a:off x="-1394244" y="3615891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643DD8CF-C116-E147-AC11-19A2AE974BE9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A3304225-C86A-D543-9594-11E50E87A943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6" name="Graphic 105">
            <a:extLst>
              <a:ext uri="{FF2B5EF4-FFF2-40B4-BE49-F238E27FC236}">
                <a16:creationId xmlns:a16="http://schemas.microsoft.com/office/drawing/2014/main" id="{0741A49E-26E7-0344-ABB9-6BCB6B3ED9D6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395231" y="1043298"/>
            <a:ext cx="9401540" cy="3033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76160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5C3C7-0774-48BC-8BE9-CEEB823C1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5637B2-AEDD-480E-80F1-DB7DD4632C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A73D8F-73EA-48B6-AE0E-92859D35C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677D6-F509-48C9-8563-6D5849865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9584AC-B10F-4E3F-9B5F-FE4C3EE41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A63105-812A-45E9-8D75-10AAB2E12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50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A11B4D-D197-41BF-89CF-2FF24910F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A25774-8E30-41C1-B0BD-4310D74CFC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FD2572-88E0-4170-AAD7-A6BCB7C690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0A150C-B684-4DE7-A70B-75D372672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87BF1C-3EB6-475D-89E9-6370E7F24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9680FF-149A-425E-9971-8F2FBCB2D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84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1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15.xml"/><Relationship Id="rId21" Type="http://schemas.openxmlformats.org/officeDocument/2006/relationships/slideLayout" Target="../slideLayouts/slideLayout33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17" Type="http://schemas.openxmlformats.org/officeDocument/2006/relationships/slideLayout" Target="../slideLayouts/slideLayout29.xml"/><Relationship Id="rId25" Type="http://schemas.openxmlformats.org/officeDocument/2006/relationships/image" Target="../media/image1.jpeg"/><Relationship Id="rId2" Type="http://schemas.openxmlformats.org/officeDocument/2006/relationships/slideLayout" Target="../slideLayouts/slideLayout14.xml"/><Relationship Id="rId16" Type="http://schemas.openxmlformats.org/officeDocument/2006/relationships/slideLayout" Target="../slideLayouts/slideLayout28.xml"/><Relationship Id="rId20" Type="http://schemas.openxmlformats.org/officeDocument/2006/relationships/slideLayout" Target="../slideLayouts/slideLayout3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24" Type="http://schemas.openxmlformats.org/officeDocument/2006/relationships/theme" Target="../theme/theme2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23" Type="http://schemas.openxmlformats.org/officeDocument/2006/relationships/slideLayout" Target="../slideLayouts/slideLayout35.xml"/><Relationship Id="rId10" Type="http://schemas.openxmlformats.org/officeDocument/2006/relationships/slideLayout" Target="../slideLayouts/slideLayout22.xml"/><Relationship Id="rId19" Type="http://schemas.openxmlformats.org/officeDocument/2006/relationships/slideLayout" Target="../slideLayouts/slideLayout31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Relationship Id="rId22" Type="http://schemas.openxmlformats.org/officeDocument/2006/relationships/slideLayout" Target="../slideLayouts/slideLayout34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3.xml"/><Relationship Id="rId13" Type="http://schemas.openxmlformats.org/officeDocument/2006/relationships/slideLayout" Target="../slideLayouts/slideLayout48.xml"/><Relationship Id="rId18" Type="http://schemas.openxmlformats.org/officeDocument/2006/relationships/slideLayout" Target="../slideLayouts/slideLayout53.xml"/><Relationship Id="rId3" Type="http://schemas.openxmlformats.org/officeDocument/2006/relationships/slideLayout" Target="../slideLayouts/slideLayout38.xml"/><Relationship Id="rId21" Type="http://schemas.openxmlformats.org/officeDocument/2006/relationships/image" Target="../media/image3.png"/><Relationship Id="rId7" Type="http://schemas.openxmlformats.org/officeDocument/2006/relationships/slideLayout" Target="../slideLayouts/slideLayout42.xml"/><Relationship Id="rId12" Type="http://schemas.openxmlformats.org/officeDocument/2006/relationships/slideLayout" Target="../slideLayouts/slideLayout47.xml"/><Relationship Id="rId17" Type="http://schemas.openxmlformats.org/officeDocument/2006/relationships/slideLayout" Target="../slideLayouts/slideLayout52.xml"/><Relationship Id="rId2" Type="http://schemas.openxmlformats.org/officeDocument/2006/relationships/slideLayout" Target="../slideLayouts/slideLayout37.xml"/><Relationship Id="rId16" Type="http://schemas.openxmlformats.org/officeDocument/2006/relationships/slideLayout" Target="../slideLayouts/slideLayout51.xml"/><Relationship Id="rId20" Type="http://schemas.openxmlformats.org/officeDocument/2006/relationships/theme" Target="../theme/theme3.xml"/><Relationship Id="rId1" Type="http://schemas.openxmlformats.org/officeDocument/2006/relationships/slideLayout" Target="../slideLayouts/slideLayout36.xml"/><Relationship Id="rId6" Type="http://schemas.openxmlformats.org/officeDocument/2006/relationships/slideLayout" Target="../slideLayouts/slideLayout41.xml"/><Relationship Id="rId11" Type="http://schemas.openxmlformats.org/officeDocument/2006/relationships/slideLayout" Target="../slideLayouts/slideLayout46.xml"/><Relationship Id="rId5" Type="http://schemas.openxmlformats.org/officeDocument/2006/relationships/slideLayout" Target="../slideLayouts/slideLayout40.xml"/><Relationship Id="rId15" Type="http://schemas.openxmlformats.org/officeDocument/2006/relationships/slideLayout" Target="../slideLayouts/slideLayout50.xml"/><Relationship Id="rId10" Type="http://schemas.openxmlformats.org/officeDocument/2006/relationships/slideLayout" Target="../slideLayouts/slideLayout45.xml"/><Relationship Id="rId19" Type="http://schemas.openxmlformats.org/officeDocument/2006/relationships/slideLayout" Target="../slideLayouts/slideLayout54.xml"/><Relationship Id="rId4" Type="http://schemas.openxmlformats.org/officeDocument/2006/relationships/slideLayout" Target="../slideLayouts/slideLayout39.xml"/><Relationship Id="rId9" Type="http://schemas.openxmlformats.org/officeDocument/2006/relationships/slideLayout" Target="../slideLayouts/slideLayout44.xml"/><Relationship Id="rId14" Type="http://schemas.openxmlformats.org/officeDocument/2006/relationships/slideLayout" Target="../slideLayouts/slideLayout49.xml"/><Relationship Id="rId22" Type="http://schemas.openxmlformats.org/officeDocument/2006/relationships/image" Target="../media/image4.svg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2.xml"/><Relationship Id="rId13" Type="http://schemas.openxmlformats.org/officeDocument/2006/relationships/slideLayout" Target="../slideLayouts/slideLayout67.xml"/><Relationship Id="rId18" Type="http://schemas.openxmlformats.org/officeDocument/2006/relationships/slideLayout" Target="../slideLayouts/slideLayout72.xml"/><Relationship Id="rId3" Type="http://schemas.openxmlformats.org/officeDocument/2006/relationships/slideLayout" Target="../slideLayouts/slideLayout57.xml"/><Relationship Id="rId21" Type="http://schemas.openxmlformats.org/officeDocument/2006/relationships/image" Target="../media/image3.png"/><Relationship Id="rId7" Type="http://schemas.openxmlformats.org/officeDocument/2006/relationships/slideLayout" Target="../slideLayouts/slideLayout61.xml"/><Relationship Id="rId12" Type="http://schemas.openxmlformats.org/officeDocument/2006/relationships/slideLayout" Target="../slideLayouts/slideLayout66.xml"/><Relationship Id="rId17" Type="http://schemas.openxmlformats.org/officeDocument/2006/relationships/slideLayout" Target="../slideLayouts/slideLayout71.xml"/><Relationship Id="rId2" Type="http://schemas.openxmlformats.org/officeDocument/2006/relationships/slideLayout" Target="../slideLayouts/slideLayout56.xml"/><Relationship Id="rId16" Type="http://schemas.openxmlformats.org/officeDocument/2006/relationships/slideLayout" Target="../slideLayouts/slideLayout70.xml"/><Relationship Id="rId20" Type="http://schemas.openxmlformats.org/officeDocument/2006/relationships/theme" Target="../theme/theme4.xml"/><Relationship Id="rId1" Type="http://schemas.openxmlformats.org/officeDocument/2006/relationships/slideLayout" Target="../slideLayouts/slideLayout55.xml"/><Relationship Id="rId6" Type="http://schemas.openxmlformats.org/officeDocument/2006/relationships/slideLayout" Target="../slideLayouts/slideLayout60.xml"/><Relationship Id="rId11" Type="http://schemas.openxmlformats.org/officeDocument/2006/relationships/slideLayout" Target="../slideLayouts/slideLayout65.xml"/><Relationship Id="rId5" Type="http://schemas.openxmlformats.org/officeDocument/2006/relationships/slideLayout" Target="../slideLayouts/slideLayout59.xml"/><Relationship Id="rId15" Type="http://schemas.openxmlformats.org/officeDocument/2006/relationships/slideLayout" Target="../slideLayouts/slideLayout69.xml"/><Relationship Id="rId10" Type="http://schemas.openxmlformats.org/officeDocument/2006/relationships/slideLayout" Target="../slideLayouts/slideLayout64.xml"/><Relationship Id="rId19" Type="http://schemas.openxmlformats.org/officeDocument/2006/relationships/slideLayout" Target="../slideLayouts/slideLayout73.xml"/><Relationship Id="rId4" Type="http://schemas.openxmlformats.org/officeDocument/2006/relationships/slideLayout" Target="../slideLayouts/slideLayout58.xml"/><Relationship Id="rId9" Type="http://schemas.openxmlformats.org/officeDocument/2006/relationships/slideLayout" Target="../slideLayouts/slideLayout63.xml"/><Relationship Id="rId14" Type="http://schemas.openxmlformats.org/officeDocument/2006/relationships/slideLayout" Target="../slideLayouts/slideLayout68.xml"/><Relationship Id="rId22" Type="http://schemas.openxmlformats.org/officeDocument/2006/relationships/image" Target="../media/image4.sv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8E43B8-12CB-41D9-9CAA-C274CEBF5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750825-7899-43AF-929C-A9DAB7EF9C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88B50E-4772-4D2D-8F86-BDD74AD517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CFA7B-C51F-4F36-949E-68621D6316CB}" type="datetimeFigureOut">
              <a:rPr lang="en-US" smtClean="0"/>
              <a:t>8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E69130-0407-4364-AF6A-27AE23A0EF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B702ED-B90E-4606-9674-B2C326E421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A60BF6-0225-4FDF-AE63-914DDCD9AE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723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739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561601" y="188642"/>
            <a:ext cx="10651591" cy="488692"/>
          </a:xfrm>
          <a:prstGeom prst="rect">
            <a:avLst/>
          </a:prstGeom>
        </p:spPr>
        <p:txBody>
          <a:bodyPr vert="horz" wrap="square" lIns="0" tIns="0" rIns="0" bIns="0" rtlCol="0" anchor="t" anchorCtr="0">
            <a:noAutofit/>
          </a:bodyPr>
          <a:lstStyle/>
          <a:p>
            <a:r>
              <a:rPr lang="en-US" noProof="0"/>
              <a:t>Click to add titl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71502" y="1653976"/>
            <a:ext cx="10641340" cy="4299149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lvl="0"/>
            <a:r>
              <a:rPr lang="en-US" noProof="0"/>
              <a:t>First level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1415454" y="188642"/>
            <a:ext cx="537197" cy="164148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>
            <a:lvl1pPr algn="r">
              <a:defRPr sz="1067">
                <a:solidFill>
                  <a:schemeClr val="tx1"/>
                </a:solidFill>
              </a:defRPr>
            </a:lvl1pPr>
          </a:lstStyle>
          <a:p>
            <a:fld id="{CE9E02B7-A5A9-47B3-8EC6-9026BB62DA25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9" name="Connecteur droit 8"/>
          <p:cNvCxnSpPr/>
          <p:nvPr/>
        </p:nvCxnSpPr>
        <p:spPr>
          <a:xfrm>
            <a:off x="562573" y="6260339"/>
            <a:ext cx="3501427" cy="0"/>
          </a:xfrm>
          <a:prstGeom prst="line">
            <a:avLst/>
          </a:prstGeom>
          <a:ln w="38100">
            <a:solidFill>
              <a:srgbClr val="5E36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4036876" y="6260339"/>
            <a:ext cx="420824" cy="0"/>
          </a:xfrm>
          <a:prstGeom prst="line">
            <a:avLst/>
          </a:prstGeom>
          <a:ln w="38100">
            <a:solidFill>
              <a:srgbClr val="512C7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Image 12"/>
          <p:cNvPicPr>
            <a:picLocks/>
          </p:cNvPicPr>
          <p:nvPr/>
        </p:nvPicPr>
        <p:blipFill>
          <a:blip r:embed="rId2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2575" y="6412641"/>
            <a:ext cx="297484" cy="295875"/>
          </a:xfrm>
          <a:prstGeom prst="rect">
            <a:avLst/>
          </a:prstGeom>
        </p:spPr>
      </p:pic>
      <p:cxnSp>
        <p:nvCxnSpPr>
          <p:cNvPr id="14" name="Connecteur droit 13"/>
          <p:cNvCxnSpPr/>
          <p:nvPr/>
        </p:nvCxnSpPr>
        <p:spPr>
          <a:xfrm>
            <a:off x="9701619" y="6260339"/>
            <a:ext cx="42646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6199761" y="6260339"/>
            <a:ext cx="3501856" cy="0"/>
          </a:xfrm>
          <a:prstGeom prst="line">
            <a:avLst/>
          </a:prstGeom>
          <a:ln w="38100">
            <a:solidFill>
              <a:srgbClr val="ECECE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10128077" y="6260339"/>
            <a:ext cx="2063923" cy="0"/>
          </a:xfrm>
          <a:prstGeom prst="line">
            <a:avLst/>
          </a:prstGeom>
          <a:ln w="38100">
            <a:solidFill>
              <a:srgbClr val="D9D9D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4322064" y="6260339"/>
            <a:ext cx="1342136" cy="0"/>
          </a:xfrm>
          <a:prstGeom prst="line">
            <a:avLst/>
          </a:prstGeom>
          <a:ln w="38100">
            <a:solidFill>
              <a:srgbClr val="8760A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9"/>
          <p:cNvCxnSpPr/>
          <p:nvPr/>
        </p:nvCxnSpPr>
        <p:spPr>
          <a:xfrm>
            <a:off x="5616002" y="6260339"/>
            <a:ext cx="426460" cy="0"/>
          </a:xfrm>
          <a:prstGeom prst="line">
            <a:avLst/>
          </a:prstGeom>
          <a:ln w="38100">
            <a:solidFill>
              <a:srgbClr val="512C7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47287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  <p:sldLayoutId id="2147483681" r:id="rId21"/>
    <p:sldLayoutId id="2147483683" r:id="rId22"/>
    <p:sldLayoutId id="2147483684" r:id="rId23"/>
  </p:sldLayoutIdLst>
  <p:hf hdr="0" dt="0"/>
  <p:txStyles>
    <p:titleStyle>
      <a:lvl1pPr algn="l" defTabSz="1219170" rtl="0" eaLnBrk="1" latinLnBrk="0" hangingPunct="1">
        <a:spcBef>
          <a:spcPct val="0"/>
        </a:spcBef>
        <a:buNone/>
        <a:defRPr sz="32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0" indent="0" algn="l" defTabSz="1219170" rtl="0" eaLnBrk="1" latinLnBrk="0" hangingPunct="1">
        <a:lnSpc>
          <a:spcPct val="100000"/>
        </a:lnSpc>
        <a:spcBef>
          <a:spcPts val="1333"/>
        </a:spcBef>
        <a:buFontTx/>
        <a:buNone/>
        <a:defRPr sz="2133" b="1" kern="1200" baseline="0">
          <a:solidFill>
            <a:schemeClr val="tx2"/>
          </a:solidFill>
          <a:latin typeface="+mn-lt"/>
          <a:ea typeface="+mn-ea"/>
          <a:cs typeface="+mn-cs"/>
        </a:defRPr>
      </a:lvl1pPr>
      <a:lvl2pPr marL="0" indent="0" algn="l" defTabSz="1219170" rtl="0" eaLnBrk="1" latinLnBrk="0" hangingPunct="1">
        <a:lnSpc>
          <a:spcPct val="100000"/>
        </a:lnSpc>
        <a:spcBef>
          <a:spcPts val="1200"/>
        </a:spcBef>
        <a:buClr>
          <a:schemeClr val="tx2"/>
        </a:buClr>
        <a:buFont typeface="Wingdings" pitchFamily="2" charset="2"/>
        <a:buNone/>
        <a:defRPr sz="1867" b="0" kern="1200">
          <a:solidFill>
            <a:schemeClr val="tx1"/>
          </a:solidFill>
          <a:latin typeface="+mn-lt"/>
          <a:ea typeface="+mn-ea"/>
          <a:cs typeface="+mn-cs"/>
        </a:defRPr>
      </a:lvl2pPr>
      <a:lvl3pPr marL="270927" indent="-270927" algn="l" defTabSz="1219170" rtl="0" eaLnBrk="1" latinLnBrk="0" hangingPunct="1">
        <a:lnSpc>
          <a:spcPct val="100000"/>
        </a:lnSpc>
        <a:spcBef>
          <a:spcPts val="1600"/>
        </a:spcBef>
        <a:buClr>
          <a:schemeClr val="tx2"/>
        </a:buClr>
        <a:buFont typeface="Arial" pitchFamily="34" charset="0"/>
        <a:buChar char="■"/>
        <a:defRPr sz="1867" kern="1200">
          <a:solidFill>
            <a:schemeClr val="tx1"/>
          </a:solidFill>
          <a:latin typeface="+mn-lt"/>
          <a:ea typeface="+mn-ea"/>
          <a:cs typeface="+mn-cs"/>
        </a:defRPr>
      </a:lvl3pPr>
      <a:lvl4pPr marL="503754" indent="-239178" algn="l" defTabSz="1219170" rtl="0" eaLnBrk="1" latinLnBrk="0" hangingPunct="1">
        <a:lnSpc>
          <a:spcPct val="100000"/>
        </a:lnSpc>
        <a:spcBef>
          <a:spcPts val="800"/>
        </a:spcBef>
        <a:buClrTx/>
        <a:buSzPct val="100000"/>
        <a:buFont typeface="Arial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4pPr>
      <a:lvl5pPr marL="742932" indent="-226478" algn="l" defTabSz="1219170" rtl="0" eaLnBrk="1" latinLnBrk="0" hangingPunct="1">
        <a:lnSpc>
          <a:spcPct val="100000"/>
        </a:lnSpc>
        <a:spcBef>
          <a:spcPts val="800"/>
        </a:spcBef>
        <a:buFont typeface="Arial" pitchFamily="34" charset="0"/>
        <a:buChar char="-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61D29F-3B63-0C41-9005-5CD01A30BB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6027" y="259160"/>
            <a:ext cx="11339946" cy="480131"/>
          </a:xfrm>
          <a:prstGeom prst="rect">
            <a:avLst/>
          </a:prstGeom>
        </p:spPr>
        <p:txBody>
          <a:bodyPr vert="horz" wrap="square" lIns="0" tIns="45720" rIns="3600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0B2A77-002E-F246-BF88-39274714E8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6027" y="1412874"/>
            <a:ext cx="11339946" cy="4688421"/>
          </a:xfrm>
          <a:prstGeom prst="rect">
            <a:avLst/>
          </a:prstGeom>
        </p:spPr>
        <p:txBody>
          <a:bodyPr vert="horz" lIns="0" tIns="45720" rIns="3600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95B075-55E6-E84E-866C-52BE981149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50924" y="6547006"/>
            <a:ext cx="8829521" cy="123111"/>
          </a:xfrm>
          <a:prstGeom prst="rect">
            <a:avLst/>
          </a:prstGeom>
        </p:spPr>
        <p:txBody>
          <a:bodyPr vert="horz" wrap="square" lIns="0" tIns="0" rIns="91440" bIns="0" rtlCol="0" anchor="b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ADD386-04E8-1E4B-B741-6C4A31F96C0D}"/>
              </a:ext>
            </a:extLst>
          </p:cNvPr>
          <p:cNvSpPr txBox="1"/>
          <p:nvPr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09175B6F-439F-1744-95F7-CD02CF2ECF7A}"/>
              </a:ext>
            </a:extLst>
          </p:cNvPr>
          <p:cNvGrpSpPr/>
          <p:nvPr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8D38C8F-6981-7742-9398-45A51A6305C7}"/>
                </a:ext>
              </a:extLst>
            </p:cNvPr>
            <p:cNvSpPr txBox="1"/>
            <p:nvPr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5C49AAAB-10A4-B24C-B52C-AEC6C9A74BC7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18162C43-4515-4348-91AC-1440902B3ADA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1F6D23D7-DF21-ED46-A74A-06BF057117C1}"/>
              </a:ext>
            </a:extLst>
          </p:cNvPr>
          <p:cNvSpPr txBox="1"/>
          <p:nvPr userDrawn="1"/>
        </p:nvSpPr>
        <p:spPr bwMode="gray">
          <a:xfrm>
            <a:off x="11765972" y="6547006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43" name="Group 142">
            <a:extLst>
              <a:ext uri="{FF2B5EF4-FFF2-40B4-BE49-F238E27FC236}">
                <a16:creationId xmlns:a16="http://schemas.microsoft.com/office/drawing/2014/main" id="{F1226624-0BF6-5646-8268-049F9725E9FB}"/>
              </a:ext>
            </a:extLst>
          </p:cNvPr>
          <p:cNvGrpSpPr/>
          <p:nvPr userDrawn="1"/>
        </p:nvGrpSpPr>
        <p:grpSpPr>
          <a:xfrm>
            <a:off x="11862848" y="1678073"/>
            <a:ext cx="230832" cy="3501854"/>
            <a:chOff x="0" y="1980381"/>
            <a:chExt cx="230832" cy="3501854"/>
          </a:xfrm>
        </p:grpSpPr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9CBFD0D5-8BAC-F143-BD99-103B596181A0}"/>
                </a:ext>
              </a:extLst>
            </p:cNvPr>
            <p:cNvSpPr txBox="1"/>
            <p:nvPr userDrawn="1"/>
          </p:nvSpPr>
          <p:spPr>
            <a:xfrm rot="16200000">
              <a:off x="-1394245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5E70CA2F-4C7B-8545-9BBA-F31243FB3A34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A1146C6E-3373-9848-9D55-1E36AD9CF8CC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49" name="Graphic 148">
            <a:extLst>
              <a:ext uri="{FF2B5EF4-FFF2-40B4-BE49-F238E27FC236}">
                <a16:creationId xmlns:a16="http://schemas.microsoft.com/office/drawing/2014/main" id="{DC6B50E3-022A-B04F-AB85-9FFB8229D599}"/>
              </a:ext>
            </a:extLst>
          </p:cNvPr>
          <p:cNvPicPr>
            <a:picLocks noChangeAspect="1"/>
          </p:cNvPicPr>
          <p:nvPr userDrawn="1"/>
        </p:nvPicPr>
        <p:blipFill>
          <a:blip r:embed="rId21" cstate="email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270163" y="6213912"/>
            <a:ext cx="1996068" cy="644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9816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  <p:sldLayoutId id="2147483698" r:id="rId13"/>
    <p:sldLayoutId id="2147483699" r:id="rId14"/>
    <p:sldLayoutId id="2147483700" r:id="rId15"/>
    <p:sldLayoutId id="2147483701" r:id="rId16"/>
    <p:sldLayoutId id="2147483702" r:id="rId17"/>
    <p:sldLayoutId id="2147483703" r:id="rId18"/>
    <p:sldLayoutId id="2147483704" r:id="rId19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2800" b="1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Clr>
          <a:schemeClr val="accent1"/>
        </a:buClr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F26B43"/>
          </p15:clr>
        </p15:guide>
      </p15:sldGuideLst>
    </p:ext>
  </p:extLst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61D29F-3B63-0C41-9005-5CD01A30BB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6027" y="259161"/>
            <a:ext cx="11339947" cy="480131"/>
          </a:xfrm>
          <a:prstGeom prst="rect">
            <a:avLst/>
          </a:prstGeom>
        </p:spPr>
        <p:txBody>
          <a:bodyPr vert="horz" wrap="square" lIns="0" tIns="45720" rIns="3600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0B2A77-002E-F246-BF88-39274714E8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6027" y="1412875"/>
            <a:ext cx="11339947" cy="4688421"/>
          </a:xfrm>
          <a:prstGeom prst="rect">
            <a:avLst/>
          </a:prstGeom>
        </p:spPr>
        <p:txBody>
          <a:bodyPr vert="horz" lIns="0" tIns="45720" rIns="3600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95B075-55E6-E84E-866C-52BE981149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50925" y="6547007"/>
            <a:ext cx="8829521" cy="123111"/>
          </a:xfrm>
          <a:prstGeom prst="rect">
            <a:avLst/>
          </a:prstGeom>
        </p:spPr>
        <p:txBody>
          <a:bodyPr vert="horz" wrap="square" lIns="0" tIns="0" rIns="91440" bIns="0" rtlCol="0" anchor="b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GB"/>
              <a:t>UCB Team Name [XXXXXXX] - UCB - Approval [XX-XX-XXX] - Approval date [XX Month XXXX] ! GO TO INSERT&gt;HEADER FOOTER to change. </a:t>
            </a:r>
            <a:endParaRPr lang="en-B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ADD386-04E8-1E4B-B741-6C4A31F96C0D}"/>
              </a:ext>
            </a:extLst>
          </p:cNvPr>
          <p:cNvSpPr txBox="1"/>
          <p:nvPr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09175B6F-439F-1744-95F7-CD02CF2ECF7A}"/>
              </a:ext>
            </a:extLst>
          </p:cNvPr>
          <p:cNvGrpSpPr/>
          <p:nvPr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8D38C8F-6981-7742-9398-45A51A6305C7}"/>
                </a:ext>
              </a:extLst>
            </p:cNvPr>
            <p:cNvSpPr txBox="1"/>
            <p:nvPr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5C49AAAB-10A4-B24C-B52C-AEC6C9A74BC7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18162C43-4515-4348-91AC-1440902B3ADA}"/>
                </a:ext>
              </a:extLst>
            </p:cNvPr>
            <p:cNvCxnSpPr>
              <a:cxnSpLocks/>
            </p:cNvCxnSpPr>
            <p:nvPr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1F6D23D7-DF21-ED46-A74A-06BF057117C1}"/>
              </a:ext>
            </a:extLst>
          </p:cNvPr>
          <p:cNvSpPr txBox="1"/>
          <p:nvPr userDrawn="1"/>
        </p:nvSpPr>
        <p:spPr bwMode="gray">
          <a:xfrm>
            <a:off x="11765973" y="6547007"/>
            <a:ext cx="426027" cy="123111"/>
          </a:xfrm>
          <a:prstGeom prst="rect">
            <a:avLst/>
          </a:prstGeom>
        </p:spPr>
        <p:txBody>
          <a:bodyPr vert="horz" wrap="square" lIns="0" tIns="0" rIns="0" bIns="0" rtlCol="0" anchor="b">
            <a:spAutoFit/>
          </a:bodyPr>
          <a:lstStyle>
            <a:defPPr>
              <a:defRPr lang="en-BE"/>
            </a:defPPr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ctr"/>
            <a:fld id="{6C5AF65D-6854-49AF-ABC5-48B5BA0EA842}" type="slidenum">
              <a:rPr lang="en-US" sz="800" smtClean="0">
                <a:solidFill>
                  <a:schemeClr val="tx1"/>
                </a:solidFill>
              </a:rPr>
              <a:pPr lvl="0" algn="ctr"/>
              <a:t>‹#›</a:t>
            </a:fld>
            <a:endParaRPr lang="en-US" sz="800">
              <a:solidFill>
                <a:schemeClr val="tx1"/>
              </a:solidFill>
            </a:endParaRPr>
          </a:p>
        </p:txBody>
      </p:sp>
      <p:grpSp>
        <p:nvGrpSpPr>
          <p:cNvPr id="143" name="Group 142">
            <a:extLst>
              <a:ext uri="{FF2B5EF4-FFF2-40B4-BE49-F238E27FC236}">
                <a16:creationId xmlns:a16="http://schemas.microsoft.com/office/drawing/2014/main" id="{F1226624-0BF6-5646-8268-049F9725E9FB}"/>
              </a:ext>
            </a:extLst>
          </p:cNvPr>
          <p:cNvGrpSpPr/>
          <p:nvPr userDrawn="1"/>
        </p:nvGrpSpPr>
        <p:grpSpPr>
          <a:xfrm>
            <a:off x="11862847" y="1678074"/>
            <a:ext cx="230832" cy="3501855"/>
            <a:chOff x="-1" y="1980381"/>
            <a:chExt cx="230832" cy="3501854"/>
          </a:xfrm>
        </p:grpSpPr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9CBFD0D5-8BAC-F143-BD99-103B596181A0}"/>
                </a:ext>
              </a:extLst>
            </p:cNvPr>
            <p:cNvSpPr txBox="1"/>
            <p:nvPr userDrawn="1"/>
          </p:nvSpPr>
          <p:spPr>
            <a:xfrm rot="16200000">
              <a:off x="-1394246" y="3615892"/>
              <a:ext cx="3019322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900">
                  <a:solidFill>
                    <a:schemeClr val="tx1"/>
                  </a:solidFill>
                </a:rPr>
                <a:t>Proprietary and Confidential Property of UCB</a:t>
              </a:r>
              <a:endParaRPr lang="en-BE" sz="900">
                <a:solidFill>
                  <a:schemeClr val="tx1"/>
                </a:solidFill>
              </a:endParaRPr>
            </a:p>
          </p:txBody>
        </p: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5E70CA2F-4C7B-8545-9BBA-F31243FB3A34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1980381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A1146C6E-3373-9848-9D55-1E36AD9CF8CC}"/>
                </a:ext>
              </a:extLst>
            </p:cNvPr>
            <p:cNvCxnSpPr>
              <a:cxnSpLocks/>
            </p:cNvCxnSpPr>
            <p:nvPr userDrawn="1"/>
          </p:nvCxnSpPr>
          <p:spPr>
            <a:xfrm>
              <a:off x="115416" y="5008716"/>
              <a:ext cx="0" cy="4735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49" name="Graphic 148">
            <a:extLst>
              <a:ext uri="{FF2B5EF4-FFF2-40B4-BE49-F238E27FC236}">
                <a16:creationId xmlns:a16="http://schemas.microsoft.com/office/drawing/2014/main" id="{DC6B50E3-022A-B04F-AB85-9FFB8229D599}"/>
              </a:ext>
            </a:extLst>
          </p:cNvPr>
          <p:cNvPicPr>
            <a:picLocks noChangeAspect="1"/>
          </p:cNvPicPr>
          <p:nvPr userDrawn="1"/>
        </p:nvPicPr>
        <p:blipFill>
          <a:blip r:embed="rId21" cstate="email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270163" y="6213912"/>
            <a:ext cx="1996068" cy="644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0426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7" r:id="rId1"/>
    <p:sldLayoutId id="2147483708" r:id="rId2"/>
    <p:sldLayoutId id="2147483709" r:id="rId3"/>
    <p:sldLayoutId id="2147483710" r:id="rId4"/>
    <p:sldLayoutId id="2147483711" r:id="rId5"/>
    <p:sldLayoutId id="2147483712" r:id="rId6"/>
    <p:sldLayoutId id="2147483713" r:id="rId7"/>
    <p:sldLayoutId id="2147483714" r:id="rId8"/>
    <p:sldLayoutId id="2147483715" r:id="rId9"/>
    <p:sldLayoutId id="2147483716" r:id="rId10"/>
    <p:sldLayoutId id="2147483717" r:id="rId11"/>
    <p:sldLayoutId id="2147483718" r:id="rId12"/>
    <p:sldLayoutId id="2147483719" r:id="rId13"/>
    <p:sldLayoutId id="2147483720" r:id="rId14"/>
    <p:sldLayoutId id="2147483721" r:id="rId15"/>
    <p:sldLayoutId id="2147483722" r:id="rId16"/>
    <p:sldLayoutId id="2147483723" r:id="rId17"/>
    <p:sldLayoutId id="2147483724" r:id="rId18"/>
    <p:sldLayoutId id="2147483725" r:id="rId19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sldNum="0" hdr="0" dt="0"/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2800" b="1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Clr>
          <a:schemeClr val="accent1"/>
        </a:buClr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Clr>
          <a:schemeClr val="accent1"/>
        </a:buClr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57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microsoft.com/office/2007/relationships/hdphoto" Target="../media/hdphoto6.wdp"/><Relationship Id="rId18" Type="http://schemas.openxmlformats.org/officeDocument/2006/relationships/image" Target="../media/image16.tiff"/><Relationship Id="rId3" Type="http://schemas.microsoft.com/office/2007/relationships/hdphoto" Target="../media/hdphoto1.wdp"/><Relationship Id="rId21" Type="http://schemas.openxmlformats.org/officeDocument/2006/relationships/image" Target="../media/image18.png"/><Relationship Id="rId7" Type="http://schemas.microsoft.com/office/2007/relationships/hdphoto" Target="../media/hdphoto3.wdp"/><Relationship Id="rId12" Type="http://schemas.openxmlformats.org/officeDocument/2006/relationships/image" Target="../media/image13.png"/><Relationship Id="rId17" Type="http://schemas.microsoft.com/office/2007/relationships/hdphoto" Target="../media/hdphoto8.wdp"/><Relationship Id="rId2" Type="http://schemas.openxmlformats.org/officeDocument/2006/relationships/image" Target="../media/image8.png"/><Relationship Id="rId16" Type="http://schemas.openxmlformats.org/officeDocument/2006/relationships/image" Target="../media/image15.png"/><Relationship Id="rId20" Type="http://schemas.microsoft.com/office/2007/relationships/hdphoto" Target="../media/hdphoto9.wdp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0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image" Target="../media/image19.png"/><Relationship Id="rId10" Type="http://schemas.openxmlformats.org/officeDocument/2006/relationships/image" Target="../media/image12.png"/><Relationship Id="rId19" Type="http://schemas.openxmlformats.org/officeDocument/2006/relationships/image" Target="../media/image17.png"/><Relationship Id="rId4" Type="http://schemas.openxmlformats.org/officeDocument/2006/relationships/image" Target="../media/image9.png"/><Relationship Id="rId9" Type="http://schemas.microsoft.com/office/2007/relationships/hdphoto" Target="../media/hdphoto4.wdp"/><Relationship Id="rId14" Type="http://schemas.openxmlformats.org/officeDocument/2006/relationships/image" Target="../media/image14.png"/><Relationship Id="rId22" Type="http://schemas.microsoft.com/office/2007/relationships/hdphoto" Target="../media/hdphoto10.wdp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2.wmv"/><Relationship Id="rId7" Type="http://schemas.openxmlformats.org/officeDocument/2006/relationships/image" Target="../media/image21.png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20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wmv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media" Target="../media/media4.wmv"/><Relationship Id="rId7" Type="http://schemas.openxmlformats.org/officeDocument/2006/relationships/image" Target="../media/image23.png"/><Relationship Id="rId2" Type="http://schemas.openxmlformats.org/officeDocument/2006/relationships/video" Target="../media/media3.wmv"/><Relationship Id="rId1" Type="http://schemas.microsoft.com/office/2007/relationships/media" Target="../media/media3.wmv"/><Relationship Id="rId6" Type="http://schemas.openxmlformats.org/officeDocument/2006/relationships/image" Target="../media/image22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4.wmv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26" Type="http://schemas.openxmlformats.org/officeDocument/2006/relationships/image" Target="../media/image48.png"/><Relationship Id="rId3" Type="http://schemas.openxmlformats.org/officeDocument/2006/relationships/image" Target="../media/image25.png"/><Relationship Id="rId21" Type="http://schemas.openxmlformats.org/officeDocument/2006/relationships/image" Target="../media/image43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5" Type="http://schemas.openxmlformats.org/officeDocument/2006/relationships/image" Target="../media/image47.png"/><Relationship Id="rId2" Type="http://schemas.openxmlformats.org/officeDocument/2006/relationships/image" Target="../media/image24.png"/><Relationship Id="rId16" Type="http://schemas.openxmlformats.org/officeDocument/2006/relationships/image" Target="../media/image38.png"/><Relationship Id="rId20" Type="http://schemas.openxmlformats.org/officeDocument/2006/relationships/image" Target="../media/image42.png"/><Relationship Id="rId29" Type="http://schemas.openxmlformats.org/officeDocument/2006/relationships/image" Target="../media/image51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24" Type="http://schemas.openxmlformats.org/officeDocument/2006/relationships/image" Target="../media/image46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23" Type="http://schemas.openxmlformats.org/officeDocument/2006/relationships/image" Target="../media/image45.png"/><Relationship Id="rId28" Type="http://schemas.openxmlformats.org/officeDocument/2006/relationships/image" Target="../media/image50.png"/><Relationship Id="rId10" Type="http://schemas.openxmlformats.org/officeDocument/2006/relationships/image" Target="../media/image32.png"/><Relationship Id="rId19" Type="http://schemas.openxmlformats.org/officeDocument/2006/relationships/image" Target="../media/image41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Relationship Id="rId22" Type="http://schemas.openxmlformats.org/officeDocument/2006/relationships/image" Target="../media/image44.png"/><Relationship Id="rId27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181DCD-285C-4010-9CF7-4D01AA52D38A}"/>
              </a:ext>
            </a:extLst>
          </p:cNvPr>
          <p:cNvSpPr txBox="1"/>
          <p:nvPr/>
        </p:nvSpPr>
        <p:spPr>
          <a:xfrm>
            <a:off x="278674" y="172196"/>
            <a:ext cx="11634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Supplementary Figure 1. Differentiation of the iPSC-derived MN Spheroids</a:t>
            </a:r>
          </a:p>
        </p:txBody>
      </p:sp>
      <p:sp>
        <p:nvSpPr>
          <p:cNvPr id="2" name="Text Placeholder 25">
            <a:extLst>
              <a:ext uri="{FF2B5EF4-FFF2-40B4-BE49-F238E27FC236}">
                <a16:creationId xmlns:a16="http://schemas.microsoft.com/office/drawing/2014/main" id="{41AC0983-7E63-339D-93E7-CCA4721E5038}"/>
              </a:ext>
            </a:extLst>
          </p:cNvPr>
          <p:cNvSpPr txBox="1">
            <a:spLocks/>
          </p:cNvSpPr>
          <p:nvPr/>
        </p:nvSpPr>
        <p:spPr>
          <a:xfrm>
            <a:off x="392719" y="6285694"/>
            <a:ext cx="10985469" cy="400110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BMP, bone morphogenetic protein; iPSC, induced pluripotent stem cell; GSK-3, glycogen synthase kinase-3; MN, motor neuron; TGF-</a:t>
            </a:r>
            <a:r>
              <a:rPr lang="el-GR" sz="90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 R1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, transforming growth factor beta receptor 1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291E2F9-13DF-C445-ED78-CEFA07324E21}"/>
              </a:ext>
            </a:extLst>
          </p:cNvPr>
          <p:cNvSpPr txBox="1"/>
          <p:nvPr/>
        </p:nvSpPr>
        <p:spPr>
          <a:xfrm>
            <a:off x="822866" y="2375989"/>
            <a:ext cx="2273936" cy="307777"/>
          </a:xfrm>
          <a:prstGeom prst="rect">
            <a:avLst/>
          </a:prstGeom>
          <a:solidFill>
            <a:srgbClr val="224E73">
              <a:hueOff val="0"/>
              <a:satOff val="0"/>
              <a:lumOff val="0"/>
            </a:srgb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SK-3 inhibitor XV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DD6577-1B04-E2BF-567E-EB2818B0FAA1}"/>
              </a:ext>
            </a:extLst>
          </p:cNvPr>
          <p:cNvSpPr txBox="1"/>
          <p:nvPr/>
        </p:nvSpPr>
        <p:spPr>
          <a:xfrm rot="16200000">
            <a:off x="-175534" y="2944242"/>
            <a:ext cx="1475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agen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749E6E-BB97-265D-DB7C-51032C975D05}"/>
              </a:ext>
            </a:extLst>
          </p:cNvPr>
          <p:cNvSpPr txBox="1"/>
          <p:nvPr/>
        </p:nvSpPr>
        <p:spPr>
          <a:xfrm>
            <a:off x="3096803" y="3535242"/>
            <a:ext cx="2805540" cy="307777"/>
          </a:xfrm>
          <a:prstGeom prst="rect">
            <a:avLst/>
          </a:prstGeom>
          <a:solidFill>
            <a:srgbClr val="224E73">
              <a:hueOff val="0"/>
              <a:satOff val="0"/>
              <a:lumOff val="0"/>
            </a:srgb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moothened agonis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21E3BA-5B81-59CD-E87C-1AD1752F6F86}"/>
              </a:ext>
            </a:extLst>
          </p:cNvPr>
          <p:cNvSpPr txBox="1"/>
          <p:nvPr/>
        </p:nvSpPr>
        <p:spPr>
          <a:xfrm>
            <a:off x="7060916" y="3146147"/>
            <a:ext cx="2261789" cy="696871"/>
          </a:xfrm>
          <a:prstGeom prst="rect">
            <a:avLst/>
          </a:prstGeom>
          <a:solidFill>
            <a:srgbClr val="224E73">
              <a:hueOff val="0"/>
              <a:satOff val="0"/>
              <a:lumOff val="0"/>
            </a:srgbClr>
          </a:solidFill>
        </p:spPr>
        <p:txBody>
          <a:bodyPr wrap="square"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eurotrophic factors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7D38AA1-639B-CDE6-D987-C97483775F8B}"/>
              </a:ext>
            </a:extLst>
          </p:cNvPr>
          <p:cNvCxnSpPr>
            <a:cxnSpLocks/>
          </p:cNvCxnSpPr>
          <p:nvPr/>
        </p:nvCxnSpPr>
        <p:spPr>
          <a:xfrm>
            <a:off x="784763" y="2375990"/>
            <a:ext cx="0" cy="1475058"/>
          </a:xfrm>
          <a:prstGeom prst="line">
            <a:avLst/>
          </a:prstGeom>
          <a:noFill/>
          <a:ln w="15875" cap="flat" cmpd="sng" algn="ctr">
            <a:solidFill>
              <a:srgbClr val="224E73"/>
            </a:solidFill>
            <a:prstDash val="solid"/>
            <a:miter lim="800000"/>
          </a:ln>
          <a:effectLst/>
        </p:spPr>
      </p:cxnSp>
      <p:grpSp>
        <p:nvGrpSpPr>
          <p:cNvPr id="9" name="Group 8">
            <a:extLst>
              <a:ext uri="{FF2B5EF4-FFF2-40B4-BE49-F238E27FC236}">
                <a16:creationId xmlns:a16="http://schemas.microsoft.com/office/drawing/2014/main" id="{5A255A37-F02A-ECAE-ECAF-5F7960983A29}"/>
              </a:ext>
            </a:extLst>
          </p:cNvPr>
          <p:cNvGrpSpPr/>
          <p:nvPr/>
        </p:nvGrpSpPr>
        <p:grpSpPr>
          <a:xfrm>
            <a:off x="2754314" y="1379791"/>
            <a:ext cx="1685033" cy="685800"/>
            <a:chOff x="2234570" y="1779479"/>
            <a:chExt cx="1685033" cy="685800"/>
          </a:xfrm>
        </p:grpSpPr>
        <p:sp>
          <p:nvSpPr>
            <p:cNvPr id="10" name="Donut 57">
              <a:extLst>
                <a:ext uri="{FF2B5EF4-FFF2-40B4-BE49-F238E27FC236}">
                  <a16:creationId xmlns:a16="http://schemas.microsoft.com/office/drawing/2014/main" id="{9B97037C-32FE-8B08-9076-4D3EA47B8534}"/>
                </a:ext>
              </a:extLst>
            </p:cNvPr>
            <p:cNvSpPr/>
            <p:nvPr/>
          </p:nvSpPr>
          <p:spPr>
            <a:xfrm>
              <a:off x="2234570" y="1779479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11" name="Right Arrow 58">
              <a:extLst>
                <a:ext uri="{FF2B5EF4-FFF2-40B4-BE49-F238E27FC236}">
                  <a16:creationId xmlns:a16="http://schemas.microsoft.com/office/drawing/2014/main" id="{33F6309E-4F6A-CCAC-FB6E-93796DD903D9}"/>
                </a:ext>
              </a:extLst>
            </p:cNvPr>
            <p:cNvSpPr/>
            <p:nvPr/>
          </p:nvSpPr>
          <p:spPr>
            <a:xfrm>
              <a:off x="2883929" y="1937822"/>
              <a:ext cx="1035674" cy="35440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CC43439-B4CE-92FE-BDE3-99CB8EE74C72}"/>
                </a:ext>
              </a:extLst>
            </p:cNvPr>
            <p:cNvSpPr txBox="1"/>
            <p:nvPr/>
          </p:nvSpPr>
          <p:spPr>
            <a:xfrm>
              <a:off x="2234570" y="1922324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4 </a:t>
              </a:r>
            </a:p>
          </p:txBody>
        </p:sp>
      </p:grpSp>
      <p:sp>
        <p:nvSpPr>
          <p:cNvPr id="13" name="Right Arrow 66">
            <a:extLst>
              <a:ext uri="{FF2B5EF4-FFF2-40B4-BE49-F238E27FC236}">
                <a16:creationId xmlns:a16="http://schemas.microsoft.com/office/drawing/2014/main" id="{B0A41DC6-D4FC-A77A-0045-5D69F0E638F7}"/>
              </a:ext>
            </a:extLst>
          </p:cNvPr>
          <p:cNvSpPr/>
          <p:nvPr/>
        </p:nvSpPr>
        <p:spPr>
          <a:xfrm>
            <a:off x="7332509" y="1538134"/>
            <a:ext cx="1643982" cy="354409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224E73">
              <a:hueOff val="0"/>
              <a:satOff val="0"/>
              <a:lumOff val="0"/>
              <a:alphaOff val="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/>
          <a:lstStyle/>
          <a:p>
            <a:endParaRPr lang="en-US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9AA7742-9291-1ADE-165E-770735A8B425}"/>
              </a:ext>
            </a:extLst>
          </p:cNvPr>
          <p:cNvGrpSpPr/>
          <p:nvPr/>
        </p:nvGrpSpPr>
        <p:grpSpPr>
          <a:xfrm>
            <a:off x="8976490" y="1379791"/>
            <a:ext cx="685800" cy="685800"/>
            <a:chOff x="8484746" y="1796985"/>
            <a:chExt cx="685800" cy="685800"/>
          </a:xfrm>
        </p:grpSpPr>
        <p:sp>
          <p:nvSpPr>
            <p:cNvPr id="15" name="Donut 69">
              <a:extLst>
                <a:ext uri="{FF2B5EF4-FFF2-40B4-BE49-F238E27FC236}">
                  <a16:creationId xmlns:a16="http://schemas.microsoft.com/office/drawing/2014/main" id="{59F355E0-A3ED-0BE1-0E08-DAD241634AAB}"/>
                </a:ext>
              </a:extLst>
            </p:cNvPr>
            <p:cNvSpPr/>
            <p:nvPr/>
          </p:nvSpPr>
          <p:spPr>
            <a:xfrm>
              <a:off x="8484746" y="1796985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3E09747-FA36-FABA-CC34-C204CBE255B6}"/>
                </a:ext>
              </a:extLst>
            </p:cNvPr>
            <p:cNvSpPr txBox="1"/>
            <p:nvPr/>
          </p:nvSpPr>
          <p:spPr>
            <a:xfrm>
              <a:off x="8484746" y="1939830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14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8D19F2B3-AB60-09CA-C41D-2584C88C486F}"/>
              </a:ext>
            </a:extLst>
          </p:cNvPr>
          <p:cNvSpPr txBox="1"/>
          <p:nvPr/>
        </p:nvSpPr>
        <p:spPr>
          <a:xfrm>
            <a:off x="1972456" y="3146148"/>
            <a:ext cx="3929886" cy="307777"/>
          </a:xfrm>
          <a:prstGeom prst="rect">
            <a:avLst/>
          </a:prstGeom>
          <a:solidFill>
            <a:srgbClr val="224E73">
              <a:hueOff val="0"/>
              <a:satOff val="0"/>
              <a:lumOff val="0"/>
            </a:srgb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tinoic acid</a:t>
            </a:r>
          </a:p>
        </p:txBody>
      </p:sp>
      <p:sp>
        <p:nvSpPr>
          <p:cNvPr id="18" name="Right Bracket 17">
            <a:extLst>
              <a:ext uri="{FF2B5EF4-FFF2-40B4-BE49-F238E27FC236}">
                <a16:creationId xmlns:a16="http://schemas.microsoft.com/office/drawing/2014/main" id="{243B93FC-364B-1C8F-FEB1-7F5EBE95FF3B}"/>
              </a:ext>
            </a:extLst>
          </p:cNvPr>
          <p:cNvSpPr/>
          <p:nvPr/>
        </p:nvSpPr>
        <p:spPr>
          <a:xfrm rot="16200000">
            <a:off x="3872598" y="-1878462"/>
            <a:ext cx="97878" cy="6148329"/>
          </a:xfrm>
          <a:prstGeom prst="rightBracket">
            <a:avLst/>
          </a:prstGeom>
          <a:noFill/>
          <a:ln w="15875" cap="flat" cmpd="sng" algn="ctr">
            <a:solidFill>
              <a:srgbClr val="224E7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D93497-A3BA-BA10-FA3C-13F9779B1745}"/>
              </a:ext>
            </a:extLst>
          </p:cNvPr>
          <p:cNvSpPr txBox="1"/>
          <p:nvPr/>
        </p:nvSpPr>
        <p:spPr>
          <a:xfrm>
            <a:off x="847372" y="738977"/>
            <a:ext cx="61483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ral induction &amp; MN patterning</a:t>
            </a:r>
          </a:p>
        </p:txBody>
      </p:sp>
      <p:sp>
        <p:nvSpPr>
          <p:cNvPr id="20" name="Right Bracket 19">
            <a:extLst>
              <a:ext uri="{FF2B5EF4-FFF2-40B4-BE49-F238E27FC236}">
                <a16:creationId xmlns:a16="http://schemas.microsoft.com/office/drawing/2014/main" id="{FB1288A7-1E76-CA6F-19E1-0D84B8F0B3E9}"/>
              </a:ext>
            </a:extLst>
          </p:cNvPr>
          <p:cNvSpPr/>
          <p:nvPr/>
        </p:nvSpPr>
        <p:spPr>
          <a:xfrm rot="16200000">
            <a:off x="8122061" y="43990"/>
            <a:ext cx="97878" cy="2303425"/>
          </a:xfrm>
          <a:prstGeom prst="rightBracket">
            <a:avLst/>
          </a:prstGeom>
          <a:noFill/>
          <a:ln w="15875" cap="flat" cmpd="sng" algn="ctr">
            <a:solidFill>
              <a:srgbClr val="224E73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58D4F1E-A401-CF21-0086-174487865EC7}"/>
              </a:ext>
            </a:extLst>
          </p:cNvPr>
          <p:cNvSpPr txBox="1"/>
          <p:nvPr/>
        </p:nvSpPr>
        <p:spPr>
          <a:xfrm>
            <a:off x="7019282" y="738977"/>
            <a:ext cx="23034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ral maturation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5CC31E3A-DC76-2194-291C-62FE982BB8BC}"/>
              </a:ext>
            </a:extLst>
          </p:cNvPr>
          <p:cNvGrpSpPr/>
          <p:nvPr/>
        </p:nvGrpSpPr>
        <p:grpSpPr>
          <a:xfrm>
            <a:off x="4445698" y="1379791"/>
            <a:ext cx="1110369" cy="685800"/>
            <a:chOff x="4676296" y="2598991"/>
            <a:chExt cx="1110369" cy="685800"/>
          </a:xfrm>
        </p:grpSpPr>
        <p:sp>
          <p:nvSpPr>
            <p:cNvPr id="23" name="Donut 61">
              <a:extLst>
                <a:ext uri="{FF2B5EF4-FFF2-40B4-BE49-F238E27FC236}">
                  <a16:creationId xmlns:a16="http://schemas.microsoft.com/office/drawing/2014/main" id="{BFD15A04-59C7-4C03-C218-705D8F7B8908}"/>
                </a:ext>
              </a:extLst>
            </p:cNvPr>
            <p:cNvSpPr/>
            <p:nvPr/>
          </p:nvSpPr>
          <p:spPr>
            <a:xfrm>
              <a:off x="4676296" y="2598991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0C42880-465D-D0D7-9DF9-0526EC62E99B}"/>
                </a:ext>
              </a:extLst>
            </p:cNvPr>
            <p:cNvSpPr txBox="1"/>
            <p:nvPr/>
          </p:nvSpPr>
          <p:spPr>
            <a:xfrm>
              <a:off x="4676296" y="274183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7</a:t>
              </a:r>
            </a:p>
          </p:txBody>
        </p:sp>
        <p:sp>
          <p:nvSpPr>
            <p:cNvPr id="25" name="Right Arrow 7">
              <a:extLst>
                <a:ext uri="{FF2B5EF4-FFF2-40B4-BE49-F238E27FC236}">
                  <a16:creationId xmlns:a16="http://schemas.microsoft.com/office/drawing/2014/main" id="{BD2E7A0F-976D-092E-FD96-E514994D5413}"/>
                </a:ext>
              </a:extLst>
            </p:cNvPr>
            <p:cNvSpPr/>
            <p:nvPr/>
          </p:nvSpPr>
          <p:spPr>
            <a:xfrm>
              <a:off x="5338989" y="2757334"/>
              <a:ext cx="447676" cy="35440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1BB47662-B80C-880F-A741-30BA73820224}"/>
              </a:ext>
            </a:extLst>
          </p:cNvPr>
          <p:cNvGrpSpPr/>
          <p:nvPr/>
        </p:nvGrpSpPr>
        <p:grpSpPr>
          <a:xfrm>
            <a:off x="1629555" y="1386637"/>
            <a:ext cx="1110369" cy="685800"/>
            <a:chOff x="4676296" y="2598991"/>
            <a:chExt cx="1110369" cy="685800"/>
          </a:xfrm>
        </p:grpSpPr>
        <p:sp>
          <p:nvSpPr>
            <p:cNvPr id="27" name="Donut 61">
              <a:extLst>
                <a:ext uri="{FF2B5EF4-FFF2-40B4-BE49-F238E27FC236}">
                  <a16:creationId xmlns:a16="http://schemas.microsoft.com/office/drawing/2014/main" id="{A1A16939-CF97-E4AC-067A-0B73BF6FC7B2}"/>
                </a:ext>
              </a:extLst>
            </p:cNvPr>
            <p:cNvSpPr/>
            <p:nvPr/>
          </p:nvSpPr>
          <p:spPr>
            <a:xfrm>
              <a:off x="4676296" y="2598991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B042616-1741-7E75-75F1-331D0C2AE27C}"/>
                </a:ext>
              </a:extLst>
            </p:cNvPr>
            <p:cNvSpPr txBox="1"/>
            <p:nvPr/>
          </p:nvSpPr>
          <p:spPr>
            <a:xfrm>
              <a:off x="4676296" y="274183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2</a:t>
              </a:r>
            </a:p>
          </p:txBody>
        </p:sp>
        <p:sp>
          <p:nvSpPr>
            <p:cNvPr id="29" name="Right Arrow 7">
              <a:extLst>
                <a:ext uri="{FF2B5EF4-FFF2-40B4-BE49-F238E27FC236}">
                  <a16:creationId xmlns:a16="http://schemas.microsoft.com/office/drawing/2014/main" id="{CA7D891F-8427-795E-8A10-73C071D49860}"/>
                </a:ext>
              </a:extLst>
            </p:cNvPr>
            <p:cNvSpPr/>
            <p:nvPr/>
          </p:nvSpPr>
          <p:spPr>
            <a:xfrm>
              <a:off x="5338989" y="2757334"/>
              <a:ext cx="447676" cy="35440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90412822-341C-A2BE-75B5-A7FE329D9905}"/>
              </a:ext>
            </a:extLst>
          </p:cNvPr>
          <p:cNvGrpSpPr/>
          <p:nvPr/>
        </p:nvGrpSpPr>
        <p:grpSpPr>
          <a:xfrm>
            <a:off x="509227" y="1378342"/>
            <a:ext cx="1112059" cy="685800"/>
            <a:chOff x="4676296" y="2598991"/>
            <a:chExt cx="1112059" cy="685800"/>
          </a:xfrm>
        </p:grpSpPr>
        <p:sp>
          <p:nvSpPr>
            <p:cNvPr id="31" name="Donut 61">
              <a:extLst>
                <a:ext uri="{FF2B5EF4-FFF2-40B4-BE49-F238E27FC236}">
                  <a16:creationId xmlns:a16="http://schemas.microsoft.com/office/drawing/2014/main" id="{04258900-040B-B12B-A1C6-4D841266617F}"/>
                </a:ext>
              </a:extLst>
            </p:cNvPr>
            <p:cNvSpPr/>
            <p:nvPr/>
          </p:nvSpPr>
          <p:spPr>
            <a:xfrm>
              <a:off x="4676296" y="2598991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B238CC9-1067-5A20-8032-2C94075F4D74}"/>
                </a:ext>
              </a:extLst>
            </p:cNvPr>
            <p:cNvSpPr txBox="1"/>
            <p:nvPr/>
          </p:nvSpPr>
          <p:spPr>
            <a:xfrm>
              <a:off x="4676296" y="274183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</a:p>
          </p:txBody>
        </p:sp>
        <p:sp>
          <p:nvSpPr>
            <p:cNvPr id="33" name="Right Arrow 7">
              <a:extLst>
                <a:ext uri="{FF2B5EF4-FFF2-40B4-BE49-F238E27FC236}">
                  <a16:creationId xmlns:a16="http://schemas.microsoft.com/office/drawing/2014/main" id="{7FD9C9F8-1925-9BDB-985B-B3A058FF0675}"/>
                </a:ext>
              </a:extLst>
            </p:cNvPr>
            <p:cNvSpPr/>
            <p:nvPr/>
          </p:nvSpPr>
          <p:spPr>
            <a:xfrm>
              <a:off x="5338989" y="2757334"/>
              <a:ext cx="449366" cy="35440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6699B4D9-1921-FB8F-F591-A817719A85DA}"/>
              </a:ext>
            </a:extLst>
          </p:cNvPr>
          <p:cNvGrpSpPr/>
          <p:nvPr/>
        </p:nvGrpSpPr>
        <p:grpSpPr>
          <a:xfrm>
            <a:off x="5559446" y="1386637"/>
            <a:ext cx="1110369" cy="685800"/>
            <a:chOff x="4676296" y="2598991"/>
            <a:chExt cx="1110369" cy="685800"/>
          </a:xfrm>
        </p:grpSpPr>
        <p:sp>
          <p:nvSpPr>
            <p:cNvPr id="35" name="Donut 61">
              <a:extLst>
                <a:ext uri="{FF2B5EF4-FFF2-40B4-BE49-F238E27FC236}">
                  <a16:creationId xmlns:a16="http://schemas.microsoft.com/office/drawing/2014/main" id="{5E34CAC4-BCE9-D905-8508-A546F5C995D6}"/>
                </a:ext>
              </a:extLst>
            </p:cNvPr>
            <p:cNvSpPr/>
            <p:nvPr/>
          </p:nvSpPr>
          <p:spPr>
            <a:xfrm>
              <a:off x="4676296" y="2598991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7491AAE-C789-0DA4-CC6B-A2B12F104D77}"/>
                </a:ext>
              </a:extLst>
            </p:cNvPr>
            <p:cNvSpPr txBox="1"/>
            <p:nvPr/>
          </p:nvSpPr>
          <p:spPr>
            <a:xfrm>
              <a:off x="4676296" y="2741836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9</a:t>
              </a:r>
            </a:p>
          </p:txBody>
        </p:sp>
        <p:sp>
          <p:nvSpPr>
            <p:cNvPr id="37" name="Right Arrow 7">
              <a:extLst>
                <a:ext uri="{FF2B5EF4-FFF2-40B4-BE49-F238E27FC236}">
                  <a16:creationId xmlns:a16="http://schemas.microsoft.com/office/drawing/2014/main" id="{FA9B4466-CDA4-34F9-38A6-F36D71E533B8}"/>
                </a:ext>
              </a:extLst>
            </p:cNvPr>
            <p:cNvSpPr/>
            <p:nvPr/>
          </p:nvSpPr>
          <p:spPr>
            <a:xfrm>
              <a:off x="5338989" y="2757334"/>
              <a:ext cx="447676" cy="354409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46A73167-992C-B174-2FB9-259D135ABE57}"/>
              </a:ext>
            </a:extLst>
          </p:cNvPr>
          <p:cNvGrpSpPr/>
          <p:nvPr/>
        </p:nvGrpSpPr>
        <p:grpSpPr>
          <a:xfrm>
            <a:off x="6678468" y="1390015"/>
            <a:ext cx="685800" cy="685800"/>
            <a:chOff x="8484746" y="1796985"/>
            <a:chExt cx="685800" cy="685800"/>
          </a:xfrm>
        </p:grpSpPr>
        <p:sp>
          <p:nvSpPr>
            <p:cNvPr id="39" name="Donut 69">
              <a:extLst>
                <a:ext uri="{FF2B5EF4-FFF2-40B4-BE49-F238E27FC236}">
                  <a16:creationId xmlns:a16="http://schemas.microsoft.com/office/drawing/2014/main" id="{C2165A8D-F7DC-686F-6C56-1FEB19E36A62}"/>
                </a:ext>
              </a:extLst>
            </p:cNvPr>
            <p:cNvSpPr/>
            <p:nvPr/>
          </p:nvSpPr>
          <p:spPr>
            <a:xfrm>
              <a:off x="8484746" y="1796985"/>
              <a:ext cx="685800" cy="685800"/>
            </a:xfrm>
            <a:prstGeom prst="donut">
              <a:avLst>
                <a:gd name="adj" fmla="val 20000"/>
              </a:avLst>
            </a:prstGeom>
            <a:solidFill>
              <a:srgbClr val="224E73">
                <a:hueOff val="0"/>
                <a:satOff val="0"/>
                <a:lumOff val="0"/>
                <a:alphaOff val="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CDCA7AE-216B-00AF-97F3-A3DCE1BAFA17}"/>
                </a:ext>
              </a:extLst>
            </p:cNvPr>
            <p:cNvSpPr txBox="1"/>
            <p:nvPr/>
          </p:nvSpPr>
          <p:spPr>
            <a:xfrm>
              <a:off x="8484746" y="1939830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11 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0C4454B3-0A7B-3F4E-2C2E-EE791BC1F7DA}"/>
              </a:ext>
            </a:extLst>
          </p:cNvPr>
          <p:cNvSpPr txBox="1"/>
          <p:nvPr/>
        </p:nvSpPr>
        <p:spPr>
          <a:xfrm>
            <a:off x="822866" y="2756344"/>
            <a:ext cx="4013057" cy="307777"/>
          </a:xfrm>
          <a:prstGeom prst="rect">
            <a:avLst/>
          </a:prstGeom>
          <a:solidFill>
            <a:srgbClr val="224E73">
              <a:hueOff val="0"/>
              <a:satOff val="0"/>
              <a:lumOff val="0"/>
            </a:srgb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kumimoji="0" lang="el-G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I kinase &amp; BMP inhibitor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D1D3AF2-8323-2804-3404-787E21FBB1D1}"/>
              </a:ext>
            </a:extLst>
          </p:cNvPr>
          <p:cNvSpPr txBox="1"/>
          <p:nvPr/>
        </p:nvSpPr>
        <p:spPr>
          <a:xfrm>
            <a:off x="5943973" y="3146147"/>
            <a:ext cx="1075314" cy="696737"/>
          </a:xfrm>
          <a:prstGeom prst="rect">
            <a:avLst/>
          </a:prstGeom>
          <a:solidFill>
            <a:srgbClr val="224E73">
              <a:hueOff val="0"/>
              <a:satOff val="0"/>
              <a:lumOff val="0"/>
            </a:srgbClr>
          </a:solidFill>
        </p:spPr>
        <p:txBody>
          <a:bodyPr wrap="square"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kumimoji="0" lang="en-US" sz="14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cretase inhibitor</a:t>
            </a:r>
          </a:p>
        </p:txBody>
      </p:sp>
    </p:spTree>
    <p:extLst>
      <p:ext uri="{BB962C8B-B14F-4D97-AF65-F5344CB8AC3E}">
        <p14:creationId xmlns:p14="http://schemas.microsoft.com/office/powerpoint/2010/main" val="32989654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animBg="1"/>
      <p:bldP spid="5" grpId="0"/>
      <p:bldP spid="6" grpId="0" animBg="1"/>
      <p:bldP spid="7" grpId="0" animBg="1"/>
      <p:bldP spid="17" grpId="0" animBg="1"/>
      <p:bldP spid="41" grpId="0" animBg="1"/>
      <p:bldP spid="42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 descr="A green glowing cell with many strands of fibers&#10;&#10;Description automatically generated with medium confidence">
            <a:extLst>
              <a:ext uri="{FF2B5EF4-FFF2-40B4-BE49-F238E27FC236}">
                <a16:creationId xmlns:a16="http://schemas.microsoft.com/office/drawing/2014/main" id="{B83ECB79-44DA-0496-D19B-6ADFE38C8FDD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13472" y="621116"/>
            <a:ext cx="2016229" cy="1489951"/>
          </a:xfrm>
          <a:prstGeom prst="rect">
            <a:avLst/>
          </a:prstGeom>
        </p:spPr>
      </p:pic>
      <p:pic>
        <p:nvPicPr>
          <p:cNvPr id="37" name="Picture 36" descr="A red glowing object with black background&#10;&#10;Description automatically generated">
            <a:extLst>
              <a:ext uri="{FF2B5EF4-FFF2-40B4-BE49-F238E27FC236}">
                <a16:creationId xmlns:a16="http://schemas.microsoft.com/office/drawing/2014/main" id="{E38EAC7E-AA53-D2FB-CA45-BE4369D99D2D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73501" y="621116"/>
            <a:ext cx="2016229" cy="1489951"/>
          </a:xfrm>
          <a:prstGeom prst="rect">
            <a:avLst/>
          </a:prstGeom>
        </p:spPr>
      </p:pic>
      <p:pic>
        <p:nvPicPr>
          <p:cNvPr id="41" name="Picture 40" descr="A close up of a cell&#10;&#10;Description automatically generated">
            <a:extLst>
              <a:ext uri="{FF2B5EF4-FFF2-40B4-BE49-F238E27FC236}">
                <a16:creationId xmlns:a16="http://schemas.microsoft.com/office/drawing/2014/main" id="{5A638436-AC42-5306-B102-DFCA54EA4BF1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44040" y="622484"/>
            <a:ext cx="2016229" cy="1489951"/>
          </a:xfrm>
          <a:prstGeom prst="rect">
            <a:avLst/>
          </a:prstGeom>
        </p:spPr>
      </p:pic>
      <p:pic>
        <p:nvPicPr>
          <p:cNvPr id="45" name="Picture 44" descr="Red glowing spheres on a black background&#10;&#10;Description automatically generated">
            <a:extLst>
              <a:ext uri="{FF2B5EF4-FFF2-40B4-BE49-F238E27FC236}">
                <a16:creationId xmlns:a16="http://schemas.microsoft.com/office/drawing/2014/main" id="{11953E45-54CD-C78F-A3B1-FE5C44B849F2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73500" y="2143622"/>
            <a:ext cx="2016229" cy="1489951"/>
          </a:xfrm>
          <a:prstGeom prst="rect">
            <a:avLst/>
          </a:prstGeom>
        </p:spPr>
      </p:pic>
      <p:pic>
        <p:nvPicPr>
          <p:cNvPr id="51" name="Picture 50" descr="A green glowing sphere with many strands of threads&#10;&#10;Description automatically generated with medium confidence">
            <a:extLst>
              <a:ext uri="{FF2B5EF4-FFF2-40B4-BE49-F238E27FC236}">
                <a16:creationId xmlns:a16="http://schemas.microsoft.com/office/drawing/2014/main" id="{407C02E3-483D-F916-CC29-81DF622D35D6}"/>
              </a:ext>
            </a:extLst>
          </p:cNvPr>
          <p:cNvPicPr>
            <a:picLocks noChangeAspect="1"/>
          </p:cNvPicPr>
          <p:nvPr/>
        </p:nvPicPr>
        <p:blipFill>
          <a:blip r:embed="rId10" cstate="email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13472" y="3664170"/>
            <a:ext cx="2016229" cy="1489951"/>
          </a:xfrm>
          <a:prstGeom prst="rect">
            <a:avLst/>
          </a:prstGeom>
        </p:spPr>
      </p:pic>
      <p:pic>
        <p:nvPicPr>
          <p:cNvPr id="53" name="Picture 52" descr="A red round object with white spikes&#10;&#10;Description automatically generated">
            <a:extLst>
              <a:ext uri="{FF2B5EF4-FFF2-40B4-BE49-F238E27FC236}">
                <a16:creationId xmlns:a16="http://schemas.microsoft.com/office/drawing/2014/main" id="{F5A173CC-3C59-557F-AD02-75E0E3A48F6D}"/>
              </a:ext>
            </a:extLst>
          </p:cNvPr>
          <p:cNvPicPr>
            <a:picLocks noChangeAspect="1"/>
          </p:cNvPicPr>
          <p:nvPr/>
        </p:nvPicPr>
        <p:blipFill>
          <a:blip r:embed="rId12" cstate="email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73500" y="3666128"/>
            <a:ext cx="2016229" cy="1489951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CC7694FD-296C-0C02-362C-A2DB728276DD}"/>
              </a:ext>
            </a:extLst>
          </p:cNvPr>
          <p:cNvPicPr>
            <a:picLocks noChangeAspect="1"/>
          </p:cNvPicPr>
          <p:nvPr/>
        </p:nvPicPr>
        <p:blipFill>
          <a:blip r:embed="rId14" cstate="email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47433" y="3669250"/>
            <a:ext cx="2016229" cy="1489951"/>
          </a:xfrm>
          <a:prstGeom prst="rect">
            <a:avLst/>
          </a:prstGeom>
        </p:spPr>
      </p:pic>
      <p:pic>
        <p:nvPicPr>
          <p:cNvPr id="57" name="Picture 56" descr="A green glowing cell in a dark background&#10;&#10;Description automatically generated">
            <a:extLst>
              <a:ext uri="{FF2B5EF4-FFF2-40B4-BE49-F238E27FC236}">
                <a16:creationId xmlns:a16="http://schemas.microsoft.com/office/drawing/2014/main" id="{293DFE52-78ED-7247-EF56-69FDA1FE1A0F}"/>
              </a:ext>
            </a:extLst>
          </p:cNvPr>
          <p:cNvPicPr>
            <a:picLocks noChangeAspect="1"/>
          </p:cNvPicPr>
          <p:nvPr/>
        </p:nvPicPr>
        <p:blipFill>
          <a:blip r:embed="rId16" cstate="email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13472" y="5190731"/>
            <a:ext cx="2016229" cy="1489951"/>
          </a:xfrm>
          <a:prstGeom prst="rect">
            <a:avLst/>
          </a:prstGeom>
        </p:spPr>
      </p:pic>
      <p:pic>
        <p:nvPicPr>
          <p:cNvPr id="59" name="Picture 58" descr="A red circle with black background&#10;&#10;Description automatically generated">
            <a:extLst>
              <a:ext uri="{FF2B5EF4-FFF2-40B4-BE49-F238E27FC236}">
                <a16:creationId xmlns:a16="http://schemas.microsoft.com/office/drawing/2014/main" id="{D0241891-D6B3-9CBC-EC86-88AFDC5B4D9F}"/>
              </a:ext>
            </a:extLst>
          </p:cNvPr>
          <p:cNvPicPr>
            <a:picLocks noChangeAspect="1"/>
          </p:cNvPicPr>
          <p:nvPr/>
        </p:nvPicPr>
        <p:blipFill>
          <a:blip r:embed="rId1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73502" y="5188785"/>
            <a:ext cx="2016228" cy="1489950"/>
          </a:xfrm>
          <a:prstGeom prst="rect">
            <a:avLst/>
          </a:prstGeom>
        </p:spPr>
      </p:pic>
      <p:pic>
        <p:nvPicPr>
          <p:cNvPr id="61" name="Picture 60" descr="A green and purple glowing object&#10;&#10;Description automatically generated with medium confidence">
            <a:extLst>
              <a:ext uri="{FF2B5EF4-FFF2-40B4-BE49-F238E27FC236}">
                <a16:creationId xmlns:a16="http://schemas.microsoft.com/office/drawing/2014/main" id="{CD602623-8466-DA9E-A071-CE89BBFB7056}"/>
              </a:ext>
            </a:extLst>
          </p:cNvPr>
          <p:cNvPicPr>
            <a:picLocks noChangeAspect="1"/>
          </p:cNvPicPr>
          <p:nvPr/>
        </p:nvPicPr>
        <p:blipFill>
          <a:blip r:embed="rId19" cstate="email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43156" y="5195853"/>
            <a:ext cx="2016229" cy="1489951"/>
          </a:xfrm>
          <a:prstGeom prst="rect">
            <a:avLst/>
          </a:prstGeom>
        </p:spPr>
      </p:pic>
      <p:pic>
        <p:nvPicPr>
          <p:cNvPr id="64" name="Picture 63" descr="A close-up of a green cell&#10;&#10;Description automatically generated">
            <a:extLst>
              <a:ext uri="{FF2B5EF4-FFF2-40B4-BE49-F238E27FC236}">
                <a16:creationId xmlns:a16="http://schemas.microsoft.com/office/drawing/2014/main" id="{8D815E1B-D906-DAB0-DA8F-73EA08AB7A5A}"/>
              </a:ext>
            </a:extLst>
          </p:cNvPr>
          <p:cNvPicPr>
            <a:picLocks noChangeAspect="1"/>
          </p:cNvPicPr>
          <p:nvPr/>
        </p:nvPicPr>
        <p:blipFill>
          <a:blip r:embed="rId21" cstate="email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13471" y="2139892"/>
            <a:ext cx="2016229" cy="1480769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A9D03A58-AC82-D293-5FA0-DEF148F765E4}"/>
              </a:ext>
            </a:extLst>
          </p:cNvPr>
          <p:cNvSpPr txBox="1"/>
          <p:nvPr/>
        </p:nvSpPr>
        <p:spPr>
          <a:xfrm>
            <a:off x="3081235" y="618791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BC0B7B3-7CCE-6B45-EB28-38AF2F8945A7}"/>
              </a:ext>
            </a:extLst>
          </p:cNvPr>
          <p:cNvSpPr txBox="1"/>
          <p:nvPr/>
        </p:nvSpPr>
        <p:spPr>
          <a:xfrm>
            <a:off x="5152270" y="621115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P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934A0E7-F8DA-86DF-5608-F754D408EFD9}"/>
              </a:ext>
            </a:extLst>
          </p:cNvPr>
          <p:cNvSpPr txBox="1"/>
          <p:nvPr/>
        </p:nvSpPr>
        <p:spPr>
          <a:xfrm>
            <a:off x="7217756" y="624282"/>
            <a:ext cx="53251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P2</a:t>
            </a:r>
          </a:p>
          <a:p>
            <a:pPr algn="l"/>
            <a:r>
              <a:rPr lang="en-US" sz="100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AC68A11-7A70-C5F0-D134-BF6A3A683255}"/>
              </a:ext>
            </a:extLst>
          </p:cNvPr>
          <p:cNvSpPr txBox="1"/>
          <p:nvPr/>
        </p:nvSpPr>
        <p:spPr>
          <a:xfrm>
            <a:off x="3086315" y="2141691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C17B72E-2812-9F56-01ED-0D3A0FE6C492}"/>
              </a:ext>
            </a:extLst>
          </p:cNvPr>
          <p:cNvSpPr txBox="1"/>
          <p:nvPr/>
        </p:nvSpPr>
        <p:spPr>
          <a:xfrm>
            <a:off x="5168420" y="214362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I-3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89345AB-692E-93C2-C937-4ECA5F3E32FC}"/>
              </a:ext>
            </a:extLst>
          </p:cNvPr>
          <p:cNvSpPr txBox="1"/>
          <p:nvPr/>
        </p:nvSpPr>
        <p:spPr>
          <a:xfrm>
            <a:off x="3103869" y="3659349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1B3ECE2-5B8E-B6C1-CB67-48B18D5DA257}"/>
              </a:ext>
            </a:extLst>
          </p:cNvPr>
          <p:cNvSpPr txBox="1"/>
          <p:nvPr/>
        </p:nvSpPr>
        <p:spPr>
          <a:xfrm>
            <a:off x="3103869" y="5195853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I-3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EA47473-55A9-3A7B-53AD-297E6820770D}"/>
              </a:ext>
            </a:extLst>
          </p:cNvPr>
          <p:cNvSpPr txBox="1"/>
          <p:nvPr/>
        </p:nvSpPr>
        <p:spPr>
          <a:xfrm>
            <a:off x="5152270" y="3664170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9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AB563D8-8E2D-4B0B-0611-638E9E11BF77}"/>
              </a:ext>
            </a:extLst>
          </p:cNvPr>
          <p:cNvSpPr txBox="1"/>
          <p:nvPr/>
        </p:nvSpPr>
        <p:spPr>
          <a:xfrm>
            <a:off x="7222034" y="3680515"/>
            <a:ext cx="48282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9</a:t>
            </a:r>
          </a:p>
          <a:p>
            <a:pPr algn="l"/>
            <a:r>
              <a:rPr lang="en-US" sz="100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721CC1D-30F8-2F27-E125-52FA0AB4B2EF}"/>
              </a:ext>
            </a:extLst>
          </p:cNvPr>
          <p:cNvSpPr txBox="1"/>
          <p:nvPr/>
        </p:nvSpPr>
        <p:spPr>
          <a:xfrm>
            <a:off x="5159224" y="5194364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GLUT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D0DDCEA-6BB3-0129-972D-5C79563C59B5}"/>
              </a:ext>
            </a:extLst>
          </p:cNvPr>
          <p:cNvSpPr txBox="1"/>
          <p:nvPr/>
        </p:nvSpPr>
        <p:spPr>
          <a:xfrm>
            <a:off x="7220222" y="5195814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I-32</a:t>
            </a:r>
          </a:p>
          <a:p>
            <a:pPr algn="l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GLUT1</a:t>
            </a:r>
          </a:p>
          <a:p>
            <a:pPr algn="l"/>
            <a:r>
              <a:rPr lang="en-US" sz="1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7A88871-D205-2B6E-328F-C49506FC44B5}"/>
              </a:ext>
            </a:extLst>
          </p:cNvPr>
          <p:cNvPicPr>
            <a:picLocks noChangeAspect="1"/>
          </p:cNvPicPr>
          <p:nvPr/>
        </p:nvPicPr>
        <p:blipFill>
          <a:blip r:embed="rId2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30382" y="2137783"/>
            <a:ext cx="2024044" cy="14899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58A01F0-137A-ECD7-9181-F99D917FB249}"/>
              </a:ext>
            </a:extLst>
          </p:cNvPr>
          <p:cNvSpPr txBox="1"/>
          <p:nvPr/>
        </p:nvSpPr>
        <p:spPr>
          <a:xfrm>
            <a:off x="7194809" y="2141691"/>
            <a:ext cx="59663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  <a:p>
            <a:pPr algn="l"/>
            <a:r>
              <a:rPr 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I-32</a:t>
            </a:r>
          </a:p>
          <a:p>
            <a:pPr algn="l"/>
            <a:r>
              <a:rPr lang="en-US" sz="100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CA2F70-F425-204C-E96A-284FF8B01418}"/>
              </a:ext>
            </a:extLst>
          </p:cNvPr>
          <p:cNvSpPr txBox="1"/>
          <p:nvPr/>
        </p:nvSpPr>
        <p:spPr>
          <a:xfrm>
            <a:off x="278674" y="172196"/>
            <a:ext cx="11634652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000" dirty="0">
                <a:latin typeface="Arial"/>
                <a:cs typeface="Arial"/>
              </a:rPr>
              <a:t>Supplementary Figure 2. Characterization of Mature MNs Stained by MN Markers</a:t>
            </a:r>
          </a:p>
        </p:txBody>
      </p:sp>
      <p:sp>
        <p:nvSpPr>
          <p:cNvPr id="3" name="Text Placeholder 25">
            <a:extLst>
              <a:ext uri="{FF2B5EF4-FFF2-40B4-BE49-F238E27FC236}">
                <a16:creationId xmlns:a16="http://schemas.microsoft.com/office/drawing/2014/main" id="{37D1CA25-27D0-6C7D-D3A6-5981AFB8168A}"/>
              </a:ext>
            </a:extLst>
          </p:cNvPr>
          <p:cNvSpPr txBox="1">
            <a:spLocks/>
          </p:cNvSpPr>
          <p:nvPr/>
        </p:nvSpPr>
        <p:spPr>
          <a:xfrm>
            <a:off x="118971" y="6088541"/>
            <a:ext cx="2809367" cy="28119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MAP2, microtubule-associated protein 2; MN, motor neuron; SMI-32, neurofilament heavy chain; Tuj1, class III beta-tubulin; VGLUT1, vesicular glutamate transporter 1.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E2A55C3-CB0A-CAB9-2BD3-9403AE256478}"/>
              </a:ext>
            </a:extLst>
          </p:cNvPr>
          <p:cNvGrpSpPr/>
          <p:nvPr/>
        </p:nvGrpSpPr>
        <p:grpSpPr>
          <a:xfrm>
            <a:off x="8639175" y="6409671"/>
            <a:ext cx="533400" cy="215444"/>
            <a:chOff x="8639175" y="6409671"/>
            <a:chExt cx="533400" cy="215444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FBA4904A-51C1-EF08-1761-03DBA789D074}"/>
                </a:ext>
              </a:extLst>
            </p:cNvPr>
            <p:cNvCxnSpPr>
              <a:cxnSpLocks/>
            </p:cNvCxnSpPr>
            <p:nvPr/>
          </p:nvCxnSpPr>
          <p:spPr>
            <a:xfrm>
              <a:off x="8639175" y="6596540"/>
              <a:ext cx="533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D148564-9427-1115-D0A7-919F525359B1}"/>
                </a:ext>
              </a:extLst>
            </p:cNvPr>
            <p:cNvSpPr txBox="1"/>
            <p:nvPr/>
          </p:nvSpPr>
          <p:spPr>
            <a:xfrm>
              <a:off x="8639175" y="6409671"/>
              <a:ext cx="533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702674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1">
            <a:hlinkClick r:id="" action="ppaction://media"/>
            <a:extLst>
              <a:ext uri="{FF2B5EF4-FFF2-40B4-BE49-F238E27FC236}">
                <a16:creationId xmlns:a16="http://schemas.microsoft.com/office/drawing/2014/main" id="{69145626-8CCF-46AC-DAE8-9DACE97C38D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>
            <a:lum bright="20000" contrast="20000"/>
          </a:blip>
          <a:stretch>
            <a:fillRect/>
          </a:stretch>
        </p:blipFill>
        <p:spPr>
          <a:xfrm>
            <a:off x="556207" y="2218783"/>
            <a:ext cx="2958912" cy="2185416"/>
          </a:xfrm>
          <a:prstGeom prst="rect">
            <a:avLst/>
          </a:prstGeom>
        </p:spPr>
      </p:pic>
      <p:pic>
        <p:nvPicPr>
          <p:cNvPr id="10" name="1">
            <a:hlinkClick r:id="" action="ppaction://media"/>
            <a:extLst>
              <a:ext uri="{FF2B5EF4-FFF2-40B4-BE49-F238E27FC236}">
                <a16:creationId xmlns:a16="http://schemas.microsoft.com/office/drawing/2014/main" id="{FE019B01-088A-0F58-72AB-8F381BEBCB9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lum bright="20000" contrast="20000"/>
          </a:blip>
          <a:stretch>
            <a:fillRect/>
          </a:stretch>
        </p:blipFill>
        <p:spPr>
          <a:xfrm>
            <a:off x="3734340" y="2210182"/>
            <a:ext cx="2958911" cy="218541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C181DCD-285C-4010-9CF7-4D01AA52D38A}"/>
              </a:ext>
            </a:extLst>
          </p:cNvPr>
          <p:cNvSpPr txBox="1"/>
          <p:nvPr/>
        </p:nvSpPr>
        <p:spPr>
          <a:xfrm>
            <a:off x="278674" y="172196"/>
            <a:ext cx="11634652" cy="978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Video 1. MG-sera-induced Impaired Neuromuscular Transmission</a:t>
            </a:r>
          </a:p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228600" algn="l"/>
              </a:tabLst>
            </a:pP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Representative epifluorescence time-lapse video in which GCaMP6-expressing skeletal muscle tissues co-cultured with motor neuron spheroids for 14 days were stimulated with L-glutamate (</a:t>
            </a:r>
            <a:r>
              <a:rPr lang="en-US" sz="12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50 </a:t>
            </a:r>
            <a:r>
              <a:rPr lang="en-US" sz="12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µM)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to assess neuromuscular junction transmission. (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T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me-lapse video showing neuromuscular transmission in which</a:t>
            </a:r>
            <a:r>
              <a:rPr lang="en-US" sz="12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sz="1200" b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 vitro 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MJ units were incubated with anti-</a:t>
            </a:r>
            <a:r>
              <a:rPr lang="en-US" sz="1200" b="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ChR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tibody-positive MG patient sera for 24 hours. </a:t>
            </a:r>
            <a:r>
              <a:rPr lang="en-US" sz="1200" dirty="0">
                <a:latin typeface="Arial"/>
                <a:ea typeface="PMingLiU"/>
                <a:cs typeface="Arial"/>
              </a:rPr>
              <a:t>Scale bars, 1 mm. </a:t>
            </a:r>
            <a:endParaRPr lang="en-US" sz="12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3F5FA2-A6A8-B339-0BE5-05770F26A38D}"/>
              </a:ext>
            </a:extLst>
          </p:cNvPr>
          <p:cNvSpPr txBox="1"/>
          <p:nvPr/>
        </p:nvSpPr>
        <p:spPr>
          <a:xfrm>
            <a:off x="556208" y="4403952"/>
            <a:ext cx="2958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A999D5-5263-663F-5803-8E2FC431CEBE}"/>
              </a:ext>
            </a:extLst>
          </p:cNvPr>
          <p:cNvSpPr txBox="1"/>
          <p:nvPr/>
        </p:nvSpPr>
        <p:spPr>
          <a:xfrm>
            <a:off x="3734339" y="4403952"/>
            <a:ext cx="2958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h in gMG ser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795E2B2-A8C5-D6B6-A88B-6F7C3D1D55FE}"/>
              </a:ext>
            </a:extLst>
          </p:cNvPr>
          <p:cNvSpPr txBox="1"/>
          <p:nvPr/>
        </p:nvSpPr>
        <p:spPr>
          <a:xfrm>
            <a:off x="336652" y="1818673"/>
            <a:ext cx="4391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EAF90F7-342A-D2C5-A631-D150DF549E7D}"/>
              </a:ext>
            </a:extLst>
          </p:cNvPr>
          <p:cNvSpPr txBox="1"/>
          <p:nvPr/>
        </p:nvSpPr>
        <p:spPr>
          <a:xfrm>
            <a:off x="3514786" y="1818673"/>
            <a:ext cx="4391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 Placeholder 25">
            <a:extLst>
              <a:ext uri="{FF2B5EF4-FFF2-40B4-BE49-F238E27FC236}">
                <a16:creationId xmlns:a16="http://schemas.microsoft.com/office/drawing/2014/main" id="{65F8EC73-455B-9B5A-CCD4-D811D742398B}"/>
              </a:ext>
            </a:extLst>
          </p:cNvPr>
          <p:cNvSpPr txBox="1">
            <a:spLocks/>
          </p:cNvSpPr>
          <p:nvPr/>
        </p:nvSpPr>
        <p:spPr>
          <a:xfrm>
            <a:off x="392719" y="6285694"/>
            <a:ext cx="10985469" cy="400110"/>
          </a:xfrm>
          <a:prstGeom prst="rect">
            <a:avLst/>
          </a:prstGeom>
        </p:spPr>
        <p:txBody>
          <a:bodyPr lIns="91440" tIns="45720" rIns="91440" bIns="45720" anchor="t"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900" dirty="0">
                <a:latin typeface="Arial"/>
                <a:cs typeface="Arial"/>
              </a:rPr>
              <a:t>AChR, acetylcholine receptor; h, hours; </a:t>
            </a:r>
            <a:r>
              <a:rPr lang="en-US" sz="900" dirty="0" err="1">
                <a:latin typeface="Arial"/>
                <a:cs typeface="Arial"/>
              </a:rPr>
              <a:t>gMG</a:t>
            </a:r>
            <a:r>
              <a:rPr lang="en-US" sz="900" dirty="0">
                <a:latin typeface="Arial"/>
                <a:cs typeface="Arial"/>
              </a:rPr>
              <a:t>, </a:t>
            </a:r>
            <a:r>
              <a:rPr lang="en-US" sz="900" dirty="0" err="1">
                <a:latin typeface="Arial"/>
                <a:cs typeface="Arial"/>
              </a:rPr>
              <a:t>generalised</a:t>
            </a:r>
            <a:r>
              <a:rPr lang="en-US" sz="900" dirty="0">
                <a:latin typeface="Arial"/>
                <a:cs typeface="Arial"/>
              </a:rPr>
              <a:t> myasthenia gravis; MG, myasthenia gravis; NMJ, neuromuscular junction. </a:t>
            </a:r>
          </a:p>
        </p:txBody>
      </p:sp>
    </p:spTree>
    <p:extLst>
      <p:ext uri="{BB962C8B-B14F-4D97-AF65-F5344CB8AC3E}">
        <p14:creationId xmlns:p14="http://schemas.microsoft.com/office/powerpoint/2010/main" val="2145099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017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1017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10888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7">
            <a:hlinkClick r:id="" action="ppaction://media"/>
            <a:extLst>
              <a:ext uri="{FF2B5EF4-FFF2-40B4-BE49-F238E27FC236}">
                <a16:creationId xmlns:a16="http://schemas.microsoft.com/office/drawing/2014/main" id="{68A9BBBA-4663-C8EE-0F08-60E59BA359C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>
            <a:lum bright="20000" contrast="20000"/>
          </a:blip>
          <a:stretch>
            <a:fillRect/>
          </a:stretch>
        </p:blipFill>
        <p:spPr>
          <a:xfrm>
            <a:off x="556207" y="2218783"/>
            <a:ext cx="2958912" cy="2185416"/>
          </a:xfrm>
          <a:prstGeom prst="rect">
            <a:avLst/>
          </a:prstGeom>
        </p:spPr>
      </p:pic>
      <p:pic>
        <p:nvPicPr>
          <p:cNvPr id="7" name="7">
            <a:hlinkClick r:id="" action="ppaction://media"/>
            <a:extLst>
              <a:ext uri="{FF2B5EF4-FFF2-40B4-BE49-F238E27FC236}">
                <a16:creationId xmlns:a16="http://schemas.microsoft.com/office/drawing/2014/main" id="{FABE7557-2EE2-1FF6-F29D-C3EC6B57007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lum bright="20000" contrast="20000"/>
          </a:blip>
          <a:stretch>
            <a:fillRect/>
          </a:stretch>
        </p:blipFill>
        <p:spPr>
          <a:xfrm>
            <a:off x="3734337" y="2218783"/>
            <a:ext cx="2958912" cy="218541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C181DCD-285C-4010-9CF7-4D01AA52D38A}"/>
              </a:ext>
            </a:extLst>
          </p:cNvPr>
          <p:cNvSpPr txBox="1"/>
          <p:nvPr/>
        </p:nvSpPr>
        <p:spPr>
          <a:xfrm>
            <a:off x="278674" y="172196"/>
            <a:ext cx="11634652" cy="1286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Video 2.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Zilucoplan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Prevented MG-serum-induced Neuromuscular Transmission Impairment</a:t>
            </a:r>
          </a:p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228600" algn="l"/>
              </a:tabLst>
            </a:pP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Representative epifluorescence time-lapse video in which GCaMP6-expressing skeletal muscle tissues co-cultured with motor neuron spheroids for 14 days are stimulated with L-glutamate (</a:t>
            </a:r>
            <a:r>
              <a:rPr lang="en-US" sz="12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50 </a:t>
            </a:r>
            <a:r>
              <a:rPr lang="en-US" sz="1200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µM)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to assess neuromuscular junction transmission. (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T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me-lapse video showing neuromuscular transmission in which</a:t>
            </a:r>
            <a:r>
              <a:rPr lang="en-US" sz="12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sz="1200" b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 vitro 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MJ units were incubated with anti-</a:t>
            </a:r>
            <a:r>
              <a:rPr lang="en-US" sz="1200" b="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ChR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ntibody-positive MG patient sera in the presence of </a:t>
            </a:r>
            <a:r>
              <a:rPr lang="en-US" sz="1200" b="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zilucoplan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for 24 hours. </a:t>
            </a:r>
            <a:r>
              <a:rPr lang="en-US" sz="1200" dirty="0">
                <a:latin typeface="Arial"/>
                <a:ea typeface="PMingLiU"/>
                <a:cs typeface="Arial"/>
              </a:rPr>
              <a:t>Scale bars, 1 mm. </a:t>
            </a:r>
            <a:endParaRPr lang="en-US" sz="12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B933BF-FACD-D8EC-6681-EEF7E0E603CC}"/>
              </a:ext>
            </a:extLst>
          </p:cNvPr>
          <p:cNvSpPr txBox="1"/>
          <p:nvPr/>
        </p:nvSpPr>
        <p:spPr>
          <a:xfrm>
            <a:off x="556208" y="4403952"/>
            <a:ext cx="2958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6813C07-562B-947F-47FB-343229C4596D}"/>
              </a:ext>
            </a:extLst>
          </p:cNvPr>
          <p:cNvSpPr txBox="1"/>
          <p:nvPr/>
        </p:nvSpPr>
        <p:spPr>
          <a:xfrm>
            <a:off x="3734339" y="4403952"/>
            <a:ext cx="2958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h in gMG ser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6F8017-C0E4-0867-E10B-E943D0706831}"/>
              </a:ext>
            </a:extLst>
          </p:cNvPr>
          <p:cNvSpPr txBox="1"/>
          <p:nvPr/>
        </p:nvSpPr>
        <p:spPr>
          <a:xfrm>
            <a:off x="336652" y="1818673"/>
            <a:ext cx="4391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95E8D54-91FF-348B-3ADA-BA5BCD57AA30}"/>
              </a:ext>
            </a:extLst>
          </p:cNvPr>
          <p:cNvSpPr txBox="1"/>
          <p:nvPr/>
        </p:nvSpPr>
        <p:spPr>
          <a:xfrm>
            <a:off x="3514786" y="1818673"/>
            <a:ext cx="4391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 Placeholder 25">
            <a:extLst>
              <a:ext uri="{FF2B5EF4-FFF2-40B4-BE49-F238E27FC236}">
                <a16:creationId xmlns:a16="http://schemas.microsoft.com/office/drawing/2014/main" id="{85BCA832-FD2A-82FA-42F0-6E8529289588}"/>
              </a:ext>
            </a:extLst>
          </p:cNvPr>
          <p:cNvSpPr txBox="1">
            <a:spLocks/>
          </p:cNvSpPr>
          <p:nvPr/>
        </p:nvSpPr>
        <p:spPr>
          <a:xfrm>
            <a:off x="392719" y="6285694"/>
            <a:ext cx="10985469" cy="400110"/>
          </a:xfrm>
          <a:prstGeom prst="rect">
            <a:avLst/>
          </a:prstGeom>
        </p:spPr>
        <p:txBody>
          <a:bodyPr lIns="91440" tIns="45720" rIns="91440" bIns="45720" anchor="t"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900" dirty="0">
                <a:latin typeface="Arial"/>
                <a:cs typeface="Arial"/>
              </a:rPr>
              <a:t>AChR, acetylcholine receptor; h, hours; </a:t>
            </a:r>
            <a:r>
              <a:rPr lang="en-US" sz="900" dirty="0" err="1">
                <a:latin typeface="Arial"/>
                <a:cs typeface="Arial"/>
              </a:rPr>
              <a:t>gMG</a:t>
            </a:r>
            <a:r>
              <a:rPr lang="en-US" sz="900" dirty="0">
                <a:latin typeface="Arial"/>
                <a:cs typeface="Arial"/>
              </a:rPr>
              <a:t>, </a:t>
            </a:r>
            <a:r>
              <a:rPr lang="en-US" sz="900" dirty="0" err="1">
                <a:latin typeface="Arial"/>
                <a:cs typeface="Arial"/>
              </a:rPr>
              <a:t>generalised</a:t>
            </a:r>
            <a:r>
              <a:rPr lang="en-US" sz="900" dirty="0">
                <a:latin typeface="Arial"/>
                <a:cs typeface="Arial"/>
              </a:rPr>
              <a:t> myasthenia gravis; MG, myasthenia gravis; NMJ, neuromuscular junction. </a:t>
            </a:r>
          </a:p>
        </p:txBody>
      </p:sp>
    </p:spTree>
    <p:extLst>
      <p:ext uri="{BB962C8B-B14F-4D97-AF65-F5344CB8AC3E}">
        <p14:creationId xmlns:p14="http://schemas.microsoft.com/office/powerpoint/2010/main" val="17085870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04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1040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1111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>
            <a:extLst>
              <a:ext uri="{FF2B5EF4-FFF2-40B4-BE49-F238E27FC236}">
                <a16:creationId xmlns:a16="http://schemas.microsoft.com/office/drawing/2014/main" id="{9FF1CEC1-25A4-62C2-8626-57CFFEA177D5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19672" y="2173454"/>
            <a:ext cx="1621677" cy="786452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CF6EA4CA-190C-9728-1A6D-95168B86B528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8673" y="2173454"/>
            <a:ext cx="1627773" cy="79254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7E3A1F4-3053-E0B9-83E4-1165C846F11D}"/>
              </a:ext>
            </a:extLst>
          </p:cNvPr>
          <p:cNvPicPr>
            <a:picLocks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675" y="1356520"/>
            <a:ext cx="1618488" cy="7772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D25AE48-849E-3133-AEDB-BD5F07D2FC55}"/>
              </a:ext>
            </a:extLst>
          </p:cNvPr>
          <p:cNvPicPr>
            <a:picLocks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96150" y="1356520"/>
            <a:ext cx="1618488" cy="7772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72E044C-8A69-D542-DD27-EC1B44219C08}"/>
              </a:ext>
            </a:extLst>
          </p:cNvPr>
          <p:cNvPicPr>
            <a:picLocks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5625" y="1356520"/>
            <a:ext cx="1618488" cy="7772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818F639-5469-DC92-BE41-BEEDA2461DF8}"/>
              </a:ext>
            </a:extLst>
          </p:cNvPr>
          <p:cNvPicPr>
            <a:picLocks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15100" y="1356520"/>
            <a:ext cx="1618488" cy="7772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364551F-F7D2-3DCA-AA9D-B8D6D3EB5944}"/>
              </a:ext>
            </a:extLst>
          </p:cNvPr>
          <p:cNvPicPr>
            <a:picLocks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74575" y="1356520"/>
            <a:ext cx="1618488" cy="7772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B211A53-3195-B551-165F-CCD23103E295}"/>
              </a:ext>
            </a:extLst>
          </p:cNvPr>
          <p:cNvPicPr>
            <a:picLocks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34050" y="1356520"/>
            <a:ext cx="1618488" cy="77724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ED59C43-35B8-54B2-E469-3602B04A7D4E}"/>
              </a:ext>
            </a:extLst>
          </p:cNvPr>
          <p:cNvPicPr>
            <a:picLocks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675" y="2173454"/>
            <a:ext cx="1618488" cy="77724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8710DA9-2B4E-9A71-6DD9-DFE25CAC9AFF}"/>
              </a:ext>
            </a:extLst>
          </p:cNvPr>
          <p:cNvPicPr>
            <a:picLocks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97674" y="2173454"/>
            <a:ext cx="1618488" cy="77724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438D58D-8A33-B649-A87A-990FEC949794}"/>
              </a:ext>
            </a:extLst>
          </p:cNvPr>
          <p:cNvPicPr>
            <a:picLocks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74575" y="2173454"/>
            <a:ext cx="1618488" cy="77724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FE7C6559-70E2-EE28-9989-A233B9E18E70}"/>
              </a:ext>
            </a:extLst>
          </p:cNvPr>
          <p:cNvPicPr>
            <a:picLocks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675" y="2990389"/>
            <a:ext cx="1618488" cy="77724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2AE1C487-E4FC-99FA-D611-A22E82FCD2C3}"/>
              </a:ext>
            </a:extLst>
          </p:cNvPr>
          <p:cNvPicPr>
            <a:picLocks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94626" y="2990389"/>
            <a:ext cx="1618488" cy="77724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72B73713-1210-B2AC-F70E-3776B0AD97DE}"/>
              </a:ext>
            </a:extLst>
          </p:cNvPr>
          <p:cNvPicPr>
            <a:picLocks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8673" y="2984293"/>
            <a:ext cx="1618488" cy="7772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CA2F70-F425-204C-E96A-284FF8B01418}"/>
              </a:ext>
            </a:extLst>
          </p:cNvPr>
          <p:cNvSpPr txBox="1"/>
          <p:nvPr/>
        </p:nvSpPr>
        <p:spPr>
          <a:xfrm>
            <a:off x="278674" y="121057"/>
            <a:ext cx="1163465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Complement</a:t>
            </a:r>
            <a:r>
              <a:rPr lang="en-US" sz="20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Deposition of 3D Muscle Tissues Incubated with</a:t>
            </a:r>
            <a:r>
              <a:rPr lang="en-US" sz="2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HC and MG Patient </a:t>
            </a:r>
            <a:r>
              <a:rPr lang="en-US" sz="20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</a:t>
            </a:r>
            <a:r>
              <a:rPr lang="en-US" sz="2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era </a:t>
            </a:r>
            <a:r>
              <a:rPr lang="en-US" sz="20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in the Presence or Absence of </a:t>
            </a:r>
            <a:r>
              <a:rPr lang="en-US" sz="2000" dirty="0" err="1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Z</a:t>
            </a:r>
            <a:r>
              <a:rPr lang="en-US" sz="2000" dirty="0" err="1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ilucoplan</a:t>
            </a:r>
            <a:r>
              <a:rPr lang="en-US" sz="20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.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3FDABD-B10B-2A6E-60C9-C6FE1200AA60}"/>
              </a:ext>
            </a:extLst>
          </p:cNvPr>
          <p:cNvSpPr txBox="1"/>
          <p:nvPr/>
        </p:nvSpPr>
        <p:spPr>
          <a:xfrm>
            <a:off x="5712889" y="992757"/>
            <a:ext cx="1624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/>
                <a:cs typeface="Arial" panose="020B0604020202020204" pitchFamily="34" charset="0"/>
              </a:rPr>
              <a:t>MG-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CCEA64F-E790-0745-A8CA-EA80B810774E}"/>
              </a:ext>
            </a:extLst>
          </p:cNvPr>
          <p:cNvSpPr txBox="1"/>
          <p:nvPr/>
        </p:nvSpPr>
        <p:spPr>
          <a:xfrm>
            <a:off x="7370003" y="992757"/>
            <a:ext cx="1624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/>
                <a:cs typeface="Arial" panose="020B0604020202020204" pitchFamily="34" charset="0"/>
              </a:rPr>
              <a:t>MG-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426E311-C10B-B23F-1F41-6EFE3B870395}"/>
              </a:ext>
            </a:extLst>
          </p:cNvPr>
          <p:cNvSpPr txBox="1"/>
          <p:nvPr/>
        </p:nvSpPr>
        <p:spPr>
          <a:xfrm>
            <a:off x="9027117" y="992757"/>
            <a:ext cx="1624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/>
                <a:cs typeface="Arial" panose="020B0604020202020204" pitchFamily="34" charset="0"/>
              </a:rPr>
              <a:t>MG-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74A59F-A601-196C-CB96-2CD32DA8D071}"/>
              </a:ext>
            </a:extLst>
          </p:cNvPr>
          <p:cNvSpPr txBox="1"/>
          <p:nvPr/>
        </p:nvSpPr>
        <p:spPr>
          <a:xfrm>
            <a:off x="2398661" y="992757"/>
            <a:ext cx="1624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/>
                <a:cs typeface="Arial" panose="020B0604020202020204" pitchFamily="34" charset="0"/>
              </a:rPr>
              <a:t>MG-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AAEFBB5-6EDE-1AF0-C280-FB470AB3868B}"/>
              </a:ext>
            </a:extLst>
          </p:cNvPr>
          <p:cNvSpPr txBox="1"/>
          <p:nvPr/>
        </p:nvSpPr>
        <p:spPr>
          <a:xfrm>
            <a:off x="693836" y="1329114"/>
            <a:ext cx="11311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solidFill>
                  <a:srgbClr val="0070C0"/>
                </a:solidFill>
                <a:latin typeface="Arial"/>
                <a:cs typeface="Arial" panose="020B0604020202020204" pitchFamily="34" charset="0"/>
              </a:rPr>
              <a:t>DAPI</a:t>
            </a:r>
            <a:r>
              <a:rPr lang="en-US" sz="1300" dirty="0">
                <a:solidFill>
                  <a:prstClr val="white"/>
                </a:solidFill>
                <a:latin typeface="Arial"/>
                <a:cs typeface="Arial" panose="020B0604020202020204" pitchFamily="34" charset="0"/>
              </a:rPr>
              <a:t>/</a:t>
            </a:r>
            <a:r>
              <a:rPr lang="en-US" sz="1300" dirty="0">
                <a:solidFill>
                  <a:srgbClr val="FF0000"/>
                </a:solidFill>
                <a:latin typeface="Arial"/>
                <a:cs typeface="Arial" panose="020B0604020202020204" pitchFamily="34" charset="0"/>
              </a:rPr>
              <a:t>C5b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8E27941-E105-BC8A-F6BB-AB6840ABBB2F}"/>
              </a:ext>
            </a:extLst>
          </p:cNvPr>
          <p:cNvSpPr txBox="1"/>
          <p:nvPr/>
        </p:nvSpPr>
        <p:spPr>
          <a:xfrm rot="16200000" flipH="1">
            <a:off x="-743043" y="2379696"/>
            <a:ext cx="2412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450FA18-40D3-D5A0-AEDD-9EE60F3F34FD}"/>
              </a:ext>
            </a:extLst>
          </p:cNvPr>
          <p:cNvSpPr txBox="1"/>
          <p:nvPr/>
        </p:nvSpPr>
        <p:spPr>
          <a:xfrm rot="16200000" flipH="1">
            <a:off x="-743044" y="5000032"/>
            <a:ext cx="24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ilucoplan</a:t>
            </a:r>
            <a:endParaRPr lang="en-US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7071CF1-1B4A-7433-7C6F-9A800BD14243}"/>
              </a:ext>
            </a:extLst>
          </p:cNvPr>
          <p:cNvSpPr txBox="1"/>
          <p:nvPr/>
        </p:nvSpPr>
        <p:spPr>
          <a:xfrm>
            <a:off x="4055775" y="992757"/>
            <a:ext cx="1624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/>
                <a:cs typeface="Arial" panose="020B0604020202020204" pitchFamily="34" charset="0"/>
              </a:rPr>
              <a:t>MG-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DD4E17-FE1E-DA79-8C5D-0E7026410AA7}"/>
              </a:ext>
            </a:extLst>
          </p:cNvPr>
          <p:cNvSpPr txBox="1"/>
          <p:nvPr/>
        </p:nvSpPr>
        <p:spPr>
          <a:xfrm>
            <a:off x="730858" y="992757"/>
            <a:ext cx="1624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solidFill>
                  <a:prstClr val="black"/>
                </a:solidFill>
                <a:latin typeface="Arial"/>
                <a:cs typeface="Arial" panose="020B0604020202020204" pitchFamily="34" charset="0"/>
              </a:rPr>
              <a:t>HC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EF3D647-37CF-F6EC-DB04-37726643CDBF}"/>
              </a:ext>
            </a:extLst>
          </p:cNvPr>
          <p:cNvCxnSpPr>
            <a:cxnSpLocks/>
          </p:cNvCxnSpPr>
          <p:nvPr/>
        </p:nvCxnSpPr>
        <p:spPr>
          <a:xfrm flipH="1">
            <a:off x="676581" y="1362089"/>
            <a:ext cx="1" cy="2408656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1CA75854-B083-1E5B-D48E-0D5E59278BD7}"/>
              </a:ext>
            </a:extLst>
          </p:cNvPr>
          <p:cNvCxnSpPr>
            <a:cxnSpLocks/>
          </p:cNvCxnSpPr>
          <p:nvPr/>
        </p:nvCxnSpPr>
        <p:spPr>
          <a:xfrm flipH="1">
            <a:off x="676580" y="3978313"/>
            <a:ext cx="1" cy="2408656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Picture 40">
            <a:extLst>
              <a:ext uri="{FF2B5EF4-FFF2-40B4-BE49-F238E27FC236}">
                <a16:creationId xmlns:a16="http://schemas.microsoft.com/office/drawing/2014/main" id="{98277642-2A29-BF4F-F4FE-464FB19D9D50}"/>
              </a:ext>
            </a:extLst>
          </p:cNvPr>
          <p:cNvPicPr>
            <a:picLocks noChangeAspect="1"/>
          </p:cNvPicPr>
          <p:nvPr/>
        </p:nvPicPr>
        <p:blipFill>
          <a:blip r:embed="rId1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2826" y="3972744"/>
            <a:ext cx="1615580" cy="774259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4D957F18-CF70-58A2-7BAD-4A5B0124EABB}"/>
              </a:ext>
            </a:extLst>
          </p:cNvPr>
          <p:cNvPicPr>
            <a:picLocks noChangeAspect="1"/>
          </p:cNvPicPr>
          <p:nvPr/>
        </p:nvPicPr>
        <p:blipFill>
          <a:blip r:embed="rId1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9862" y="3972744"/>
            <a:ext cx="1615580" cy="774259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F8052A9B-3719-B970-CE8F-2BA9155BC7E2}"/>
              </a:ext>
            </a:extLst>
          </p:cNvPr>
          <p:cNvPicPr>
            <a:picLocks noChangeAspect="1"/>
          </p:cNvPicPr>
          <p:nvPr/>
        </p:nvPicPr>
        <p:blipFill>
          <a:blip r:embed="rId1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6898" y="3972744"/>
            <a:ext cx="1615580" cy="774259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F854CF3B-C703-3553-951D-60CB9A19D3CD}"/>
              </a:ext>
            </a:extLst>
          </p:cNvPr>
          <p:cNvPicPr>
            <a:picLocks noChangeAspect="1"/>
          </p:cNvPicPr>
          <p:nvPr/>
        </p:nvPicPr>
        <p:blipFill>
          <a:blip r:embed="rId1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03934" y="3972744"/>
            <a:ext cx="1621677" cy="774259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7DF9A6F5-85A7-1944-4CCA-33524CFF39E1}"/>
              </a:ext>
            </a:extLst>
          </p:cNvPr>
          <p:cNvPicPr>
            <a:picLocks noChangeAspect="1"/>
          </p:cNvPicPr>
          <p:nvPr/>
        </p:nvPicPr>
        <p:blipFill>
          <a:blip r:embed="rId2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7067" y="3972744"/>
            <a:ext cx="1621677" cy="774259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B1136199-E202-8358-6A3B-300585DDEE15}"/>
              </a:ext>
            </a:extLst>
          </p:cNvPr>
          <p:cNvPicPr>
            <a:picLocks noChangeAspect="1"/>
          </p:cNvPicPr>
          <p:nvPr/>
        </p:nvPicPr>
        <p:blipFill>
          <a:blip r:embed="rId2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30201" y="3972744"/>
            <a:ext cx="1621677" cy="774259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7ACE6EAD-3353-6381-8894-EB20CD4BC764}"/>
              </a:ext>
            </a:extLst>
          </p:cNvPr>
          <p:cNvPicPr>
            <a:picLocks noChangeAspect="1"/>
          </p:cNvPicPr>
          <p:nvPr/>
        </p:nvPicPr>
        <p:blipFill>
          <a:blip r:embed="rId2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675" y="4790205"/>
            <a:ext cx="1615580" cy="780356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379EE19A-2186-9629-3B0D-A5A82AE5AD2F}"/>
              </a:ext>
            </a:extLst>
          </p:cNvPr>
          <p:cNvPicPr>
            <a:picLocks noChangeAspect="1"/>
          </p:cNvPicPr>
          <p:nvPr/>
        </p:nvPicPr>
        <p:blipFill>
          <a:blip r:embed="rId2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93828" y="4790205"/>
            <a:ext cx="1615580" cy="780356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A53457DC-202E-AD8D-80DC-F61C69E51FFE}"/>
              </a:ext>
            </a:extLst>
          </p:cNvPr>
          <p:cNvPicPr>
            <a:picLocks noChangeAspect="1"/>
          </p:cNvPicPr>
          <p:nvPr/>
        </p:nvPicPr>
        <p:blipFill>
          <a:blip r:embed="rId2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0981" y="4790205"/>
            <a:ext cx="1621677" cy="780356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6B234CB5-8FAB-6058-A324-AC02B8A6615C}"/>
              </a:ext>
            </a:extLst>
          </p:cNvPr>
          <p:cNvPicPr>
            <a:picLocks noChangeAspect="1"/>
          </p:cNvPicPr>
          <p:nvPr/>
        </p:nvPicPr>
        <p:blipFill>
          <a:blip r:embed="rId2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14231" y="4790205"/>
            <a:ext cx="1615580" cy="780356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DD90A527-7B64-4D38-5728-33A4313C6917}"/>
              </a:ext>
            </a:extLst>
          </p:cNvPr>
          <p:cNvPicPr>
            <a:picLocks noChangeAspect="1"/>
          </p:cNvPicPr>
          <p:nvPr/>
        </p:nvPicPr>
        <p:blipFill>
          <a:blip r:embed="rId2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71386" y="4790205"/>
            <a:ext cx="1621677" cy="780356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546C8A0C-47C1-C6C1-35AA-9E49EC2DCD93}"/>
              </a:ext>
            </a:extLst>
          </p:cNvPr>
          <p:cNvPicPr>
            <a:picLocks noChangeAspect="1"/>
          </p:cNvPicPr>
          <p:nvPr/>
        </p:nvPicPr>
        <p:blipFill>
          <a:blip r:embed="rId2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675" y="5606613"/>
            <a:ext cx="1615580" cy="780356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840534A2-E548-6206-0C11-92B3DD5D9A93}"/>
              </a:ext>
            </a:extLst>
          </p:cNvPr>
          <p:cNvPicPr>
            <a:picLocks noChangeAspect="1"/>
          </p:cNvPicPr>
          <p:nvPr/>
        </p:nvPicPr>
        <p:blipFill>
          <a:blip r:embed="rId2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97674" y="5606613"/>
            <a:ext cx="1615580" cy="780356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4E626D52-920F-AACF-F528-2C3EEF5003AB}"/>
              </a:ext>
            </a:extLst>
          </p:cNvPr>
          <p:cNvPicPr>
            <a:picLocks noChangeAspect="1"/>
          </p:cNvPicPr>
          <p:nvPr/>
        </p:nvPicPr>
        <p:blipFill>
          <a:blip r:embed="rId2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8673" y="5606613"/>
            <a:ext cx="1621677" cy="780356"/>
          </a:xfrm>
          <a:prstGeom prst="rect">
            <a:avLst/>
          </a:prstGeom>
        </p:spPr>
      </p:pic>
      <p:sp>
        <p:nvSpPr>
          <p:cNvPr id="5" name="Text Placeholder 25">
            <a:extLst>
              <a:ext uri="{FF2B5EF4-FFF2-40B4-BE49-F238E27FC236}">
                <a16:creationId xmlns:a16="http://schemas.microsoft.com/office/drawing/2014/main" id="{8067C193-DFAF-B466-E0BD-0092534ABC45}"/>
              </a:ext>
            </a:extLst>
          </p:cNvPr>
          <p:cNvSpPr txBox="1">
            <a:spLocks/>
          </p:cNvSpPr>
          <p:nvPr/>
        </p:nvSpPr>
        <p:spPr>
          <a:xfrm>
            <a:off x="6435739" y="6239449"/>
            <a:ext cx="4371463" cy="28119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5b9, component 5b9; DMSO, dimethyl sulfoxide; HC, healthy control; MG, myasthenia gravis.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9B603B3-FE2B-B525-8834-209067A094DD}"/>
              </a:ext>
            </a:extLst>
          </p:cNvPr>
          <p:cNvCxnSpPr>
            <a:cxnSpLocks/>
          </p:cNvCxnSpPr>
          <p:nvPr/>
        </p:nvCxnSpPr>
        <p:spPr>
          <a:xfrm>
            <a:off x="5004055" y="6315649"/>
            <a:ext cx="61079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6646C55-FB4E-B8AE-061B-93B7A07090E8}"/>
              </a:ext>
            </a:extLst>
          </p:cNvPr>
          <p:cNvSpPr txBox="1"/>
          <p:nvPr/>
        </p:nvSpPr>
        <p:spPr>
          <a:xfrm>
            <a:off x="5042754" y="6110188"/>
            <a:ext cx="533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µm</a:t>
            </a:r>
          </a:p>
        </p:txBody>
      </p:sp>
    </p:spTree>
    <p:extLst>
      <p:ext uri="{BB962C8B-B14F-4D97-AF65-F5344CB8AC3E}">
        <p14:creationId xmlns:p14="http://schemas.microsoft.com/office/powerpoint/2010/main" val="21215383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Purple_16-9">
  <a:themeElements>
    <a:clrScheme name="Personnalisée 4">
      <a:dk1>
        <a:srgbClr val="636363"/>
      </a:dk1>
      <a:lt1>
        <a:sysClr val="window" lastClr="FFFFFF"/>
      </a:lt1>
      <a:dk2>
        <a:srgbClr val="5E366E"/>
      </a:dk2>
      <a:lt2>
        <a:srgbClr val="ECECEC"/>
      </a:lt2>
      <a:accent1>
        <a:srgbClr val="5E366E"/>
      </a:accent1>
      <a:accent2>
        <a:srgbClr val="BC204B"/>
      </a:accent2>
      <a:accent3>
        <a:srgbClr val="D57800"/>
      </a:accent3>
      <a:accent4>
        <a:srgbClr val="354B96"/>
      </a:accent4>
      <a:accent5>
        <a:srgbClr val="4FAED1"/>
      </a:accent5>
      <a:accent6>
        <a:srgbClr val="97BB3A"/>
      </a:accent6>
      <a:hlink>
        <a:srgbClr val="4771B4"/>
      </a:hlink>
      <a:folHlink>
        <a:srgbClr val="001489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chemeClr val="tx2"/>
          </a:solidFill>
        </a:ln>
      </a:spPr>
      <a:bodyPr rtlCol="0" anchor="ctr"/>
      <a:lstStyle>
        <a:defPPr algn="ctr">
          <a:defRPr sz="1400" dirty="0" smtClean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/>
      <a:bodyPr vert="horz" wrap="square" lIns="0" tIns="0" rIns="0" bIns="0" rtlCol="0">
        <a:spAutoFit/>
      </a:bodyPr>
      <a:lstStyle>
        <a:defPPr>
          <a:defRPr sz="1400" dirty="0" smtClean="0"/>
        </a:defPPr>
      </a:lstStyle>
    </a:txDef>
  </a:objectDefaults>
  <a:extraClrSchemeLst/>
</a:theme>
</file>

<file path=ppt/theme/theme3.xml><?xml version="1.0" encoding="utf-8"?>
<a:theme xmlns:a="http://schemas.openxmlformats.org/drawingml/2006/main" name="UCB 2022">
  <a:themeElements>
    <a:clrScheme name="UCB 2022">
      <a:dk1>
        <a:srgbClr val="4B4F54"/>
      </a:dk1>
      <a:lt1>
        <a:srgbClr val="FFFFFF"/>
      </a:lt1>
      <a:dk2>
        <a:srgbClr val="4B4F54"/>
      </a:dk2>
      <a:lt2>
        <a:srgbClr val="CFD3D3"/>
      </a:lt2>
      <a:accent1>
        <a:srgbClr val="001489"/>
      </a:accent1>
      <a:accent2>
        <a:srgbClr val="F07F7F"/>
      </a:accent2>
      <a:accent3>
        <a:srgbClr val="FFC557"/>
      </a:accent3>
      <a:accent4>
        <a:srgbClr val="D3C0CC"/>
      </a:accent4>
      <a:accent5>
        <a:srgbClr val="71C5E8"/>
      </a:accent5>
      <a:accent6>
        <a:srgbClr val="6BCABA"/>
      </a:accent6>
      <a:hlink>
        <a:srgbClr val="001489"/>
      </a:hlink>
      <a:folHlink>
        <a:srgbClr val="3F4443"/>
      </a:folHlink>
    </a:clrScheme>
    <a:fontScheme name="UCB2022">
      <a:majorFont>
        <a:latin typeface="Tahoma"/>
        <a:ea typeface=""/>
        <a:cs typeface=""/>
      </a:majorFont>
      <a:minorFont>
        <a:latin typeface="Tahom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bg1"/>
        </a:solidFill>
        <a:ln w="9525">
          <a:solidFill>
            <a:schemeClr val="accent1"/>
          </a:solidFill>
        </a:ln>
      </a:spPr>
      <a:bodyPr rtlCol="0" anchor="ctr"/>
      <a:lstStyle>
        <a:defPPr algn="ctr">
          <a:defRPr sz="1400" dirty="0" smtClean="0">
            <a:solidFill>
              <a:schemeClr val="accent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rtlCol="0">
        <a:spAutoFit/>
      </a:bodyPr>
      <a:lstStyle>
        <a:defPPr algn="l">
          <a:defRPr sz="1400" dirty="0" smtClean="0"/>
        </a:defPPr>
      </a:lstStyle>
    </a:txDef>
  </a:objectDefaults>
  <a:extraClrSchemeLst/>
  <a:custClrLst>
    <a:custClr name="Deep Salmon">
      <a:srgbClr val="A84544"/>
    </a:custClr>
    <a:custClr name="Deep Marigold">
      <a:srgbClr val="996017"/>
    </a:custClr>
    <a:custClr name="Deep Lavender">
      <a:srgbClr val="784E90"/>
    </a:custClr>
    <a:custClr name="Light Lavender">
      <a:srgbClr val="D3C0CD"/>
    </a:custClr>
    <a:custClr name="Deep Teal">
      <a:srgbClr val="005683"/>
    </a:custClr>
    <a:custClr name="Teal">
      <a:srgbClr val="387F97"/>
    </a:custClr>
  </a:custClrLst>
  <a:extLst>
    <a:ext uri="{05A4C25C-085E-4340-85A3-A5531E510DB2}">
      <thm15:themeFamily xmlns:thm15="http://schemas.microsoft.com/office/thememl/2012/main" name="UCB_PPT_Template_202201.pptx" id="{D462D9BB-1786-4CEE-9DC0-ABB648E352E0}" vid="{893DAD37-C3F6-4F2A-9685-C86A5F230D52}"/>
    </a:ext>
  </a:extLst>
</a:theme>
</file>

<file path=ppt/theme/theme4.xml><?xml version="1.0" encoding="utf-8"?>
<a:theme xmlns:a="http://schemas.openxmlformats.org/drawingml/2006/main" name="1_UCB 2022">
  <a:themeElements>
    <a:clrScheme name="UCB 2022">
      <a:dk1>
        <a:srgbClr val="4B4F54"/>
      </a:dk1>
      <a:lt1>
        <a:srgbClr val="FFFFFF"/>
      </a:lt1>
      <a:dk2>
        <a:srgbClr val="4B4F54"/>
      </a:dk2>
      <a:lt2>
        <a:srgbClr val="CFD3D3"/>
      </a:lt2>
      <a:accent1>
        <a:srgbClr val="001489"/>
      </a:accent1>
      <a:accent2>
        <a:srgbClr val="F07F7F"/>
      </a:accent2>
      <a:accent3>
        <a:srgbClr val="FFC557"/>
      </a:accent3>
      <a:accent4>
        <a:srgbClr val="D3C0CC"/>
      </a:accent4>
      <a:accent5>
        <a:srgbClr val="71C5E8"/>
      </a:accent5>
      <a:accent6>
        <a:srgbClr val="6BCABA"/>
      </a:accent6>
      <a:hlink>
        <a:srgbClr val="001489"/>
      </a:hlink>
      <a:folHlink>
        <a:srgbClr val="3F4443"/>
      </a:folHlink>
    </a:clrScheme>
    <a:fontScheme name="UCB2022">
      <a:majorFont>
        <a:latin typeface="Tahoma"/>
        <a:ea typeface=""/>
        <a:cs typeface=""/>
      </a:majorFont>
      <a:minorFont>
        <a:latin typeface="Tahom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bg1"/>
        </a:solidFill>
        <a:ln w="9525">
          <a:solidFill>
            <a:schemeClr val="accent1"/>
          </a:solidFill>
        </a:ln>
      </a:spPr>
      <a:bodyPr rtlCol="0" anchor="ctr"/>
      <a:lstStyle>
        <a:defPPr algn="ctr">
          <a:defRPr sz="1400" dirty="0" smtClean="0">
            <a:solidFill>
              <a:schemeClr val="accent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rtlCol="0">
        <a:spAutoFit/>
      </a:bodyPr>
      <a:lstStyle>
        <a:defPPr algn="l">
          <a:defRPr sz="1400" dirty="0" smtClean="0"/>
        </a:defPPr>
      </a:lstStyle>
    </a:txDef>
  </a:objectDefaults>
  <a:extraClrSchemeLst/>
  <a:custClrLst>
    <a:custClr name="Deep Salmon">
      <a:srgbClr val="A84544"/>
    </a:custClr>
    <a:custClr name="Deep Marigold">
      <a:srgbClr val="996017"/>
    </a:custClr>
    <a:custClr name="Deep Lavender">
      <a:srgbClr val="784E90"/>
    </a:custClr>
    <a:custClr name="Light Lavender">
      <a:srgbClr val="D3C0CD"/>
    </a:custClr>
    <a:custClr name="Deep Teal">
      <a:srgbClr val="005683"/>
    </a:custClr>
    <a:custClr name="Teal">
      <a:srgbClr val="387F97"/>
    </a:custClr>
  </a:custClrLst>
  <a:extLst>
    <a:ext uri="{05A4C25C-085E-4340-85A3-A5531E510DB2}">
      <thm15:themeFamily xmlns:thm15="http://schemas.microsoft.com/office/thememl/2012/main" name="UCB_PPT_Template_202201.pptx" id="{D462D9BB-1786-4CEE-9DC0-ABB648E352E0}" vid="{893DAD37-C3F6-4F2A-9685-C86A5F230D52}"/>
    </a:ext>
  </a:extLst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c4b2c68f-b55b-444b-8812-a8bfd78cf6e5" xsi:nil="true"/>
    <_ip_UnifiedCompliancePolicyUIAction xmlns="http://schemas.microsoft.com/sharepoint/v3" xsi:nil="true"/>
    <ArchiverLinkFileType xmlns="b608349c-9cc0-4a85-a854-a2df3763e08d" xsi:nil="true"/>
    <lcf76f155ced4ddcb4097134ff3c332f xmlns="b608349c-9cc0-4a85-a854-a2df3763e08d">
      <Terms xmlns="http://schemas.microsoft.com/office/infopath/2007/PartnerControls"/>
    </lcf76f155ced4ddcb4097134ff3c332f>
    <_ip_UnifiedCompliancePolicyProperties xmlns="http://schemas.microsoft.com/sharepoint/v3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92BE17D22885469402D857D48D66D2" ma:contentTypeVersion="716" ma:contentTypeDescription="Create a new document." ma:contentTypeScope="" ma:versionID="e4e7b6d9fae7bd6fe47cabf5151575b3">
  <xsd:schema xmlns:xsd="http://www.w3.org/2001/XMLSchema" xmlns:xs="http://www.w3.org/2001/XMLSchema" xmlns:p="http://schemas.microsoft.com/office/2006/metadata/properties" xmlns:ns1="http://schemas.microsoft.com/sharepoint/v3" xmlns:ns2="b608349c-9cc0-4a85-a854-a2df3763e08d" xmlns:ns3="3fbd8b50-f070-4c2b-80c8-1a954da54ccc" xmlns:ns4="c4b2c68f-b55b-444b-8812-a8bfd78cf6e5" targetNamespace="http://schemas.microsoft.com/office/2006/metadata/properties" ma:root="true" ma:fieldsID="9996a5cbb7e617cfe71b84438074c045" ns1:_="" ns2:_="" ns3:_="" ns4:_="">
    <xsd:import namespace="http://schemas.microsoft.com/sharepoint/v3"/>
    <xsd:import namespace="b608349c-9cc0-4a85-a854-a2df3763e08d"/>
    <xsd:import namespace="3fbd8b50-f070-4c2b-80c8-1a954da54ccc"/>
    <xsd:import namespace="c4b2c68f-b55b-444b-8812-a8bfd78cf6e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2:MediaLengthInSeconds" minOccurs="0"/>
                <xsd:element ref="ns1:_ip_UnifiedCompliancePolicyProperties" minOccurs="0"/>
                <xsd:element ref="ns1:_ip_UnifiedCompliancePolicyUIAction" minOccurs="0"/>
                <xsd:element ref="ns2:lcf76f155ced4ddcb4097134ff3c332f" minOccurs="0"/>
                <xsd:element ref="ns4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  <xsd:element ref="ns2:ArchiverLinkFileTyp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608349c-9cc0-4a85-a854-a2df3763e08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3" nillable="true" ma:taxonomy="true" ma:internalName="lcf76f155ced4ddcb4097134ff3c332f" ma:taxonomyFieldName="MediaServiceImageTags" ma:displayName="Image Tags" ma:readOnly="false" ma:fieldId="{5cf76f15-5ced-4ddc-b409-7134ff3c332f}" ma:taxonomyMulti="true" ma:sspId="423d344c-9e5d-4dd2-9612-f746068d8c5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5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6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ArchiverLinkFileType" ma:index="28" nillable="true" ma:displayName="ArchiverLinkFileType" ma:hidden="true" ma:internalName="ArchiverLinkFileType" ma:readOnly="fals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bd8b50-f070-4c2b-80c8-1a954da54cc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4b2c68f-b55b-444b-8812-a8bfd78cf6e5" elementFormDefault="qualified">
    <xsd:import namespace="http://schemas.microsoft.com/office/2006/documentManagement/types"/>
    <xsd:import namespace="http://schemas.microsoft.com/office/infopath/2007/PartnerControls"/>
    <xsd:element name="TaxCatchAll" ma:index="24" nillable="true" ma:displayName="Taxonomy Catch All Column" ma:hidden="true" ma:list="{dfe424b5-ddfd-4d50-97dc-5b7caf473280}" ma:internalName="TaxCatchAll" ma:showField="CatchAllData" ma:web="3fbd8b50-f070-4c2b-80c8-1a954da54cc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D26129D-6415-4172-83BD-917A6CB6A4A7}">
  <ds:schemaRefs>
    <ds:schemaRef ds:uri="http://schemas.microsoft.com/office/2006/metadata/properties"/>
    <ds:schemaRef ds:uri="http://purl.org/dc/terms/"/>
    <ds:schemaRef ds:uri="http://purl.org/dc/elements/1.1/"/>
    <ds:schemaRef ds:uri="c4b2c68f-b55b-444b-8812-a8bfd78cf6e5"/>
    <ds:schemaRef ds:uri="http://schemas.microsoft.com/sharepoint/v3"/>
    <ds:schemaRef ds:uri="http://purl.org/dc/dcmitype/"/>
    <ds:schemaRef ds:uri="http://schemas.microsoft.com/office/2006/documentManagement/types"/>
    <ds:schemaRef ds:uri="http://schemas.microsoft.com/office/infopath/2007/PartnerControls"/>
    <ds:schemaRef ds:uri="3fbd8b50-f070-4c2b-80c8-1a954da54ccc"/>
    <ds:schemaRef ds:uri="http://schemas.openxmlformats.org/package/2006/metadata/core-properties"/>
    <ds:schemaRef ds:uri="b608349c-9cc0-4a85-a854-a2df3763e08d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7259ADA9-1127-4397-B4C8-2949F1F5DBF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b608349c-9cc0-4a85-a854-a2df3763e08d"/>
    <ds:schemaRef ds:uri="3fbd8b50-f070-4c2b-80c8-1a954da54ccc"/>
    <ds:schemaRef ds:uri="c4b2c68f-b55b-444b-8812-a8bfd78cf6e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54E2E91-2F12-4FD3-AAC4-DC7FB6B9070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24</Words>
  <Application>Microsoft Office PowerPoint</Application>
  <PresentationFormat>Widescreen</PresentationFormat>
  <Paragraphs>67</Paragraphs>
  <Slides>5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5</vt:i4>
      </vt:variant>
    </vt:vector>
  </HeadingPairs>
  <TitlesOfParts>
    <vt:vector size="15" baseType="lpstr">
      <vt:lpstr>Arial</vt:lpstr>
      <vt:lpstr>ArialMT</vt:lpstr>
      <vt:lpstr>Calibri</vt:lpstr>
      <vt:lpstr>Calibri Light</vt:lpstr>
      <vt:lpstr>Tahoma</vt:lpstr>
      <vt:lpstr>Wingdings</vt:lpstr>
      <vt:lpstr>Office Theme</vt:lpstr>
      <vt:lpstr>Purple_16-9</vt:lpstr>
      <vt:lpstr>UCB 2022</vt:lpstr>
      <vt:lpstr>1_UCB 2022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n Baehyun</dc:creator>
  <cp:lastModifiedBy>Qudsia Ehsan</cp:lastModifiedBy>
  <cp:revision>6</cp:revision>
  <dcterms:created xsi:type="dcterms:W3CDTF">2023-05-02T20:09:01Z</dcterms:created>
  <dcterms:modified xsi:type="dcterms:W3CDTF">2025-08-21T13:55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92BE17D22885469402D857D48D66D2</vt:lpwstr>
  </property>
  <property fmtid="{D5CDD505-2E9C-101B-9397-08002B2CF9AE}" pid="3" name="MediaServiceImageTags">
    <vt:lpwstr/>
  </property>
</Properties>
</file>